
<file path=[Content_Types].xml><?xml version="1.0" encoding="utf-8"?>
<Types xmlns="http://schemas.openxmlformats.org/package/2006/content-types">
  <Default Extension="png" ContentType="image/png"/>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wdp" ContentType="image/vnd.ms-photo"/>
  <Default Extension="tiff" ContentType="image/tiff"/>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14"/>
  </p:notesMasterIdLst>
  <p:handoutMasterIdLst>
    <p:handoutMasterId r:id="rId15"/>
  </p:handoutMasterIdLst>
  <p:sldIdLst>
    <p:sldId id="284" r:id="rId2"/>
    <p:sldId id="287" r:id="rId3"/>
    <p:sldId id="285" r:id="rId4"/>
    <p:sldId id="276" r:id="rId5"/>
    <p:sldId id="279" r:id="rId6"/>
    <p:sldId id="281" r:id="rId7"/>
    <p:sldId id="282" r:id="rId8"/>
    <p:sldId id="275" r:id="rId9"/>
    <p:sldId id="256" r:id="rId10"/>
    <p:sldId id="278" r:id="rId11"/>
    <p:sldId id="286" r:id="rId12"/>
    <p:sldId id="283" r:id="rId13"/>
  </p:sldIdLst>
  <p:sldSz cx="6119813" cy="8280400"/>
  <p:notesSz cx="9623425" cy="6888163"/>
  <p:defaultText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608" userDrawn="1">
          <p15:clr>
            <a:srgbClr val="A4A3A4"/>
          </p15:clr>
        </p15:guide>
        <p15:guide id="2" pos="1927"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8882" autoAdjust="0"/>
    <p:restoredTop sz="94660"/>
  </p:normalViewPr>
  <p:slideViewPr>
    <p:cSldViewPr>
      <p:cViewPr varScale="1">
        <p:scale>
          <a:sx n="96" d="100"/>
          <a:sy n="96" d="100"/>
        </p:scale>
        <p:origin x="3336" y="72"/>
      </p:cViewPr>
      <p:guideLst>
        <p:guide orient="horz" pos="2608"/>
        <p:guide pos="1927"/>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handoutMaster" Target="handoutMasters/handoutMaster1.xml"/><Relationship Id="rId10" Type="http://schemas.openxmlformats.org/officeDocument/2006/relationships/slide" Target="slides/slide9.xml"/><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76.emf"/></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egnaposto intestazione 1"/>
          <p:cNvSpPr>
            <a:spLocks noGrp="1"/>
          </p:cNvSpPr>
          <p:nvPr>
            <p:ph type="hdr" sz="quarter"/>
          </p:nvPr>
        </p:nvSpPr>
        <p:spPr>
          <a:xfrm>
            <a:off x="0" y="0"/>
            <a:ext cx="4169633" cy="345431"/>
          </a:xfrm>
          <a:prstGeom prst="rect">
            <a:avLst/>
          </a:prstGeom>
        </p:spPr>
        <p:txBody>
          <a:bodyPr vert="horz" lIns="91440" tIns="45720" rIns="91440" bIns="45720" rtlCol="0"/>
          <a:lstStyle>
            <a:lvl1pPr algn="l">
              <a:defRPr sz="1200"/>
            </a:lvl1pPr>
          </a:lstStyle>
          <a:p>
            <a:endParaRPr lang="it-IT"/>
          </a:p>
        </p:txBody>
      </p:sp>
      <p:sp>
        <p:nvSpPr>
          <p:cNvPr id="3" name="Segnaposto data 2"/>
          <p:cNvSpPr>
            <a:spLocks noGrp="1"/>
          </p:cNvSpPr>
          <p:nvPr>
            <p:ph type="dt" sz="quarter" idx="1"/>
          </p:nvPr>
        </p:nvSpPr>
        <p:spPr>
          <a:xfrm>
            <a:off x="5451573" y="0"/>
            <a:ext cx="4169633" cy="345431"/>
          </a:xfrm>
          <a:prstGeom prst="rect">
            <a:avLst/>
          </a:prstGeom>
        </p:spPr>
        <p:txBody>
          <a:bodyPr vert="horz" lIns="91440" tIns="45720" rIns="91440" bIns="45720" rtlCol="0"/>
          <a:lstStyle>
            <a:lvl1pPr algn="r">
              <a:defRPr sz="1200"/>
            </a:lvl1pPr>
          </a:lstStyle>
          <a:p>
            <a:fld id="{C2B602C2-4D7F-46ED-8370-C7B1D6E37427}" type="datetimeFigureOut">
              <a:rPr lang="it-IT" smtClean="0"/>
              <a:t>24/09/2019</a:t>
            </a:fld>
            <a:endParaRPr lang="it-IT"/>
          </a:p>
        </p:txBody>
      </p:sp>
      <p:sp>
        <p:nvSpPr>
          <p:cNvPr id="4" name="Segnaposto piè di pagina 3"/>
          <p:cNvSpPr>
            <a:spLocks noGrp="1"/>
          </p:cNvSpPr>
          <p:nvPr>
            <p:ph type="ftr" sz="quarter" idx="2"/>
          </p:nvPr>
        </p:nvSpPr>
        <p:spPr>
          <a:xfrm>
            <a:off x="0" y="6542732"/>
            <a:ext cx="4169633" cy="345431"/>
          </a:xfrm>
          <a:prstGeom prst="rect">
            <a:avLst/>
          </a:prstGeom>
        </p:spPr>
        <p:txBody>
          <a:bodyPr vert="horz" lIns="91440" tIns="45720" rIns="91440" bIns="45720" rtlCol="0" anchor="b"/>
          <a:lstStyle>
            <a:lvl1pPr algn="l">
              <a:defRPr sz="1200"/>
            </a:lvl1pPr>
          </a:lstStyle>
          <a:p>
            <a:endParaRPr lang="it-IT"/>
          </a:p>
        </p:txBody>
      </p:sp>
      <p:sp>
        <p:nvSpPr>
          <p:cNvPr id="5" name="Segnaposto numero diapositiva 4"/>
          <p:cNvSpPr>
            <a:spLocks noGrp="1"/>
          </p:cNvSpPr>
          <p:nvPr>
            <p:ph type="sldNum" sz="quarter" idx="3"/>
          </p:nvPr>
        </p:nvSpPr>
        <p:spPr>
          <a:xfrm>
            <a:off x="5451573" y="6542732"/>
            <a:ext cx="4169633" cy="345431"/>
          </a:xfrm>
          <a:prstGeom prst="rect">
            <a:avLst/>
          </a:prstGeom>
        </p:spPr>
        <p:txBody>
          <a:bodyPr vert="horz" lIns="91440" tIns="45720" rIns="91440" bIns="45720" rtlCol="0" anchor="b"/>
          <a:lstStyle>
            <a:lvl1pPr algn="r">
              <a:defRPr sz="1200"/>
            </a:lvl1pPr>
          </a:lstStyle>
          <a:p>
            <a:fld id="{2ACA39B7-86E6-4AAA-9543-4681C3CA7306}" type="slidenum">
              <a:rPr lang="it-IT" smtClean="0"/>
              <a:t>‹N›</a:t>
            </a:fld>
            <a:endParaRPr lang="it-IT"/>
          </a:p>
        </p:txBody>
      </p:sp>
    </p:spTree>
    <p:extLst>
      <p:ext uri="{BB962C8B-B14F-4D97-AF65-F5344CB8AC3E}">
        <p14:creationId xmlns:p14="http://schemas.microsoft.com/office/powerpoint/2010/main" val="2938371715"/>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egnaposto intestazione 1"/>
          <p:cNvSpPr>
            <a:spLocks noGrp="1"/>
          </p:cNvSpPr>
          <p:nvPr>
            <p:ph type="hdr" sz="quarter"/>
          </p:nvPr>
        </p:nvSpPr>
        <p:spPr>
          <a:xfrm>
            <a:off x="1" y="0"/>
            <a:ext cx="4170151" cy="345605"/>
          </a:xfrm>
          <a:prstGeom prst="rect">
            <a:avLst/>
          </a:prstGeom>
        </p:spPr>
        <p:txBody>
          <a:bodyPr vert="horz" lIns="94348" tIns="47174" rIns="94348" bIns="47174" rtlCol="0"/>
          <a:lstStyle>
            <a:lvl1pPr algn="l">
              <a:defRPr sz="1200"/>
            </a:lvl1pPr>
          </a:lstStyle>
          <a:p>
            <a:endParaRPr lang="it-IT"/>
          </a:p>
        </p:txBody>
      </p:sp>
      <p:sp>
        <p:nvSpPr>
          <p:cNvPr id="3" name="Segnaposto data 2"/>
          <p:cNvSpPr>
            <a:spLocks noGrp="1"/>
          </p:cNvSpPr>
          <p:nvPr>
            <p:ph type="dt" idx="1"/>
          </p:nvPr>
        </p:nvSpPr>
        <p:spPr>
          <a:xfrm>
            <a:off x="5451048" y="0"/>
            <a:ext cx="4170151" cy="345605"/>
          </a:xfrm>
          <a:prstGeom prst="rect">
            <a:avLst/>
          </a:prstGeom>
        </p:spPr>
        <p:txBody>
          <a:bodyPr vert="horz" lIns="94348" tIns="47174" rIns="94348" bIns="47174" rtlCol="0"/>
          <a:lstStyle>
            <a:lvl1pPr algn="r">
              <a:defRPr sz="1200"/>
            </a:lvl1pPr>
          </a:lstStyle>
          <a:p>
            <a:fld id="{CD96D599-C4A9-42E8-B80A-F398C3A65BB5}" type="datetimeFigureOut">
              <a:rPr lang="it-IT" smtClean="0"/>
              <a:t>24/09/2019</a:t>
            </a:fld>
            <a:endParaRPr lang="it-IT"/>
          </a:p>
        </p:txBody>
      </p:sp>
      <p:sp>
        <p:nvSpPr>
          <p:cNvPr id="4" name="Segnaposto immagine diapositiva 3"/>
          <p:cNvSpPr>
            <a:spLocks noGrp="1" noRot="1" noChangeAspect="1"/>
          </p:cNvSpPr>
          <p:nvPr>
            <p:ph type="sldImg" idx="2"/>
          </p:nvPr>
        </p:nvSpPr>
        <p:spPr>
          <a:xfrm>
            <a:off x="3952875" y="862013"/>
            <a:ext cx="1717675" cy="2324100"/>
          </a:xfrm>
          <a:prstGeom prst="rect">
            <a:avLst/>
          </a:prstGeom>
          <a:noFill/>
          <a:ln w="12700">
            <a:solidFill>
              <a:prstClr val="black"/>
            </a:solidFill>
          </a:ln>
        </p:spPr>
        <p:txBody>
          <a:bodyPr vert="horz" lIns="94348" tIns="47174" rIns="94348" bIns="47174" rtlCol="0" anchor="ctr"/>
          <a:lstStyle/>
          <a:p>
            <a:endParaRPr lang="it-IT"/>
          </a:p>
        </p:txBody>
      </p:sp>
      <p:sp>
        <p:nvSpPr>
          <p:cNvPr id="5" name="Segnaposto note 4"/>
          <p:cNvSpPr>
            <a:spLocks noGrp="1"/>
          </p:cNvSpPr>
          <p:nvPr>
            <p:ph type="body" sz="quarter" idx="3"/>
          </p:nvPr>
        </p:nvSpPr>
        <p:spPr>
          <a:xfrm>
            <a:off x="962344" y="3314928"/>
            <a:ext cx="7698739" cy="2712214"/>
          </a:xfrm>
          <a:prstGeom prst="rect">
            <a:avLst/>
          </a:prstGeom>
        </p:spPr>
        <p:txBody>
          <a:bodyPr vert="horz" lIns="94348" tIns="47174" rIns="94348" bIns="47174" rtlCol="0"/>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6" name="Segnaposto piè di pagina 5"/>
          <p:cNvSpPr>
            <a:spLocks noGrp="1"/>
          </p:cNvSpPr>
          <p:nvPr>
            <p:ph type="ftr" sz="quarter" idx="4"/>
          </p:nvPr>
        </p:nvSpPr>
        <p:spPr>
          <a:xfrm>
            <a:off x="1" y="6542560"/>
            <a:ext cx="4170151" cy="345603"/>
          </a:xfrm>
          <a:prstGeom prst="rect">
            <a:avLst/>
          </a:prstGeom>
        </p:spPr>
        <p:txBody>
          <a:bodyPr vert="horz" lIns="94348" tIns="47174" rIns="94348" bIns="47174" rtlCol="0" anchor="b"/>
          <a:lstStyle>
            <a:lvl1pPr algn="l">
              <a:defRPr sz="1200"/>
            </a:lvl1pPr>
          </a:lstStyle>
          <a:p>
            <a:endParaRPr lang="it-IT"/>
          </a:p>
        </p:txBody>
      </p:sp>
      <p:sp>
        <p:nvSpPr>
          <p:cNvPr id="7" name="Segnaposto numero diapositiva 6"/>
          <p:cNvSpPr>
            <a:spLocks noGrp="1"/>
          </p:cNvSpPr>
          <p:nvPr>
            <p:ph type="sldNum" sz="quarter" idx="5"/>
          </p:nvPr>
        </p:nvSpPr>
        <p:spPr>
          <a:xfrm>
            <a:off x="5451048" y="6542560"/>
            <a:ext cx="4170151" cy="345603"/>
          </a:xfrm>
          <a:prstGeom prst="rect">
            <a:avLst/>
          </a:prstGeom>
        </p:spPr>
        <p:txBody>
          <a:bodyPr vert="horz" lIns="94348" tIns="47174" rIns="94348" bIns="47174" rtlCol="0" anchor="b"/>
          <a:lstStyle>
            <a:lvl1pPr algn="r">
              <a:defRPr sz="1200"/>
            </a:lvl1pPr>
          </a:lstStyle>
          <a:p>
            <a:fld id="{5EFEA032-0E95-4D29-BF39-F543451FF4F5}" type="slidenum">
              <a:rPr lang="it-IT" smtClean="0"/>
              <a:t>‹N›</a:t>
            </a:fld>
            <a:endParaRPr lang="it-IT"/>
          </a:p>
        </p:txBody>
      </p:sp>
    </p:spTree>
    <p:extLst>
      <p:ext uri="{BB962C8B-B14F-4D97-AF65-F5344CB8AC3E}">
        <p14:creationId xmlns:p14="http://schemas.microsoft.com/office/powerpoint/2010/main" val="329892224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egnaposto immagine diapositiva 1"/>
          <p:cNvSpPr>
            <a:spLocks noGrp="1" noRot="1" noChangeAspect="1"/>
          </p:cNvSpPr>
          <p:nvPr>
            <p:ph type="sldImg"/>
          </p:nvPr>
        </p:nvSpPr>
        <p:spPr/>
      </p:sp>
      <p:sp>
        <p:nvSpPr>
          <p:cNvPr id="3" name="Segnaposto note 2"/>
          <p:cNvSpPr>
            <a:spLocks noGrp="1"/>
          </p:cNvSpPr>
          <p:nvPr>
            <p:ph type="body" idx="1"/>
          </p:nvPr>
        </p:nvSpPr>
        <p:spPr/>
        <p:txBody>
          <a:bodyPr/>
          <a:lstStyle/>
          <a:p>
            <a:endParaRPr lang="it-IT"/>
          </a:p>
        </p:txBody>
      </p:sp>
      <p:sp>
        <p:nvSpPr>
          <p:cNvPr id="4" name="Segnaposto numero diapositiva 3"/>
          <p:cNvSpPr>
            <a:spLocks noGrp="1"/>
          </p:cNvSpPr>
          <p:nvPr>
            <p:ph type="sldNum" sz="quarter" idx="10"/>
          </p:nvPr>
        </p:nvSpPr>
        <p:spPr/>
        <p:txBody>
          <a:bodyPr/>
          <a:lstStyle/>
          <a:p>
            <a:fld id="{5EFEA032-0E95-4D29-BF39-F543451FF4F5}" type="slidenum">
              <a:rPr lang="it-IT" smtClean="0"/>
              <a:t>4</a:t>
            </a:fld>
            <a:endParaRPr lang="it-IT"/>
          </a:p>
        </p:txBody>
      </p:sp>
    </p:spTree>
    <p:extLst>
      <p:ext uri="{BB962C8B-B14F-4D97-AF65-F5344CB8AC3E}">
        <p14:creationId xmlns:p14="http://schemas.microsoft.com/office/powerpoint/2010/main" val="166292458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egnaposto immagine diapositiva 1"/>
          <p:cNvSpPr>
            <a:spLocks noGrp="1" noRot="1" noChangeAspect="1"/>
          </p:cNvSpPr>
          <p:nvPr>
            <p:ph type="sldImg"/>
          </p:nvPr>
        </p:nvSpPr>
        <p:spPr/>
      </p:sp>
      <p:sp>
        <p:nvSpPr>
          <p:cNvPr id="3" name="Segnaposto note 2"/>
          <p:cNvSpPr>
            <a:spLocks noGrp="1"/>
          </p:cNvSpPr>
          <p:nvPr>
            <p:ph type="body" idx="1"/>
          </p:nvPr>
        </p:nvSpPr>
        <p:spPr/>
        <p:txBody>
          <a:bodyPr/>
          <a:lstStyle/>
          <a:p>
            <a:endParaRPr lang="it-IT"/>
          </a:p>
        </p:txBody>
      </p:sp>
      <p:sp>
        <p:nvSpPr>
          <p:cNvPr id="4" name="Segnaposto numero diapositiva 3"/>
          <p:cNvSpPr>
            <a:spLocks noGrp="1"/>
          </p:cNvSpPr>
          <p:nvPr>
            <p:ph type="sldNum" sz="quarter" idx="10"/>
          </p:nvPr>
        </p:nvSpPr>
        <p:spPr/>
        <p:txBody>
          <a:bodyPr/>
          <a:lstStyle/>
          <a:p>
            <a:fld id="{5EFEA032-0E95-4D29-BF39-F543451FF4F5}" type="slidenum">
              <a:rPr lang="it-IT" smtClean="0"/>
              <a:t>5</a:t>
            </a:fld>
            <a:endParaRPr lang="it-IT"/>
          </a:p>
        </p:txBody>
      </p:sp>
    </p:spTree>
    <p:extLst>
      <p:ext uri="{BB962C8B-B14F-4D97-AF65-F5344CB8AC3E}">
        <p14:creationId xmlns:p14="http://schemas.microsoft.com/office/powerpoint/2010/main" val="190952004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egnaposto immagine diapositiva 1"/>
          <p:cNvSpPr>
            <a:spLocks noGrp="1" noRot="1" noChangeAspect="1"/>
          </p:cNvSpPr>
          <p:nvPr>
            <p:ph type="sldImg"/>
          </p:nvPr>
        </p:nvSpPr>
        <p:spPr/>
      </p:sp>
      <p:sp>
        <p:nvSpPr>
          <p:cNvPr id="3" name="Segnaposto note 2"/>
          <p:cNvSpPr>
            <a:spLocks noGrp="1"/>
          </p:cNvSpPr>
          <p:nvPr>
            <p:ph type="body" idx="1"/>
          </p:nvPr>
        </p:nvSpPr>
        <p:spPr/>
        <p:txBody>
          <a:bodyPr/>
          <a:lstStyle/>
          <a:p>
            <a:endParaRPr lang="it-IT"/>
          </a:p>
        </p:txBody>
      </p:sp>
      <p:sp>
        <p:nvSpPr>
          <p:cNvPr id="4" name="Segnaposto numero diapositiva 3"/>
          <p:cNvSpPr>
            <a:spLocks noGrp="1"/>
          </p:cNvSpPr>
          <p:nvPr>
            <p:ph type="sldNum" sz="quarter" idx="10"/>
          </p:nvPr>
        </p:nvSpPr>
        <p:spPr/>
        <p:txBody>
          <a:bodyPr/>
          <a:lstStyle/>
          <a:p>
            <a:fld id="{5EFEA032-0E95-4D29-BF39-F543451FF4F5}" type="slidenum">
              <a:rPr lang="it-IT" smtClean="0"/>
              <a:t>6</a:t>
            </a:fld>
            <a:endParaRPr lang="it-IT"/>
          </a:p>
        </p:txBody>
      </p:sp>
    </p:spTree>
    <p:extLst>
      <p:ext uri="{BB962C8B-B14F-4D97-AF65-F5344CB8AC3E}">
        <p14:creationId xmlns:p14="http://schemas.microsoft.com/office/powerpoint/2010/main" val="82614764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egnaposto immagine diapositiva 1"/>
          <p:cNvSpPr>
            <a:spLocks noGrp="1" noRot="1" noChangeAspect="1"/>
          </p:cNvSpPr>
          <p:nvPr>
            <p:ph type="sldImg"/>
          </p:nvPr>
        </p:nvSpPr>
        <p:spPr/>
      </p:sp>
      <p:sp>
        <p:nvSpPr>
          <p:cNvPr id="3" name="Segnaposto note 2"/>
          <p:cNvSpPr>
            <a:spLocks noGrp="1"/>
          </p:cNvSpPr>
          <p:nvPr>
            <p:ph type="body" idx="1"/>
          </p:nvPr>
        </p:nvSpPr>
        <p:spPr/>
        <p:txBody>
          <a:bodyPr/>
          <a:lstStyle/>
          <a:p>
            <a:endParaRPr lang="it-IT"/>
          </a:p>
        </p:txBody>
      </p:sp>
      <p:sp>
        <p:nvSpPr>
          <p:cNvPr id="4" name="Segnaposto numero diapositiva 3"/>
          <p:cNvSpPr>
            <a:spLocks noGrp="1"/>
          </p:cNvSpPr>
          <p:nvPr>
            <p:ph type="sldNum" sz="quarter" idx="10"/>
          </p:nvPr>
        </p:nvSpPr>
        <p:spPr/>
        <p:txBody>
          <a:bodyPr/>
          <a:lstStyle/>
          <a:p>
            <a:fld id="{5EFEA032-0E95-4D29-BF39-F543451FF4F5}" type="slidenum">
              <a:rPr lang="it-IT" smtClean="0"/>
              <a:t>7</a:t>
            </a:fld>
            <a:endParaRPr lang="it-IT"/>
          </a:p>
        </p:txBody>
      </p:sp>
    </p:spTree>
    <p:extLst>
      <p:ext uri="{BB962C8B-B14F-4D97-AF65-F5344CB8AC3E}">
        <p14:creationId xmlns:p14="http://schemas.microsoft.com/office/powerpoint/2010/main" val="324437585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egnaposto immagine diapositiva 1"/>
          <p:cNvSpPr>
            <a:spLocks noGrp="1" noRot="1" noChangeAspect="1"/>
          </p:cNvSpPr>
          <p:nvPr>
            <p:ph type="sldImg"/>
          </p:nvPr>
        </p:nvSpPr>
        <p:spPr/>
      </p:sp>
      <p:sp>
        <p:nvSpPr>
          <p:cNvPr id="3" name="Segnaposto note 2"/>
          <p:cNvSpPr>
            <a:spLocks noGrp="1"/>
          </p:cNvSpPr>
          <p:nvPr>
            <p:ph type="body" idx="1"/>
          </p:nvPr>
        </p:nvSpPr>
        <p:spPr/>
        <p:txBody>
          <a:bodyPr/>
          <a:lstStyle/>
          <a:p>
            <a:endParaRPr lang="it-IT"/>
          </a:p>
        </p:txBody>
      </p:sp>
      <p:sp>
        <p:nvSpPr>
          <p:cNvPr id="4" name="Segnaposto numero diapositiva 3"/>
          <p:cNvSpPr>
            <a:spLocks noGrp="1"/>
          </p:cNvSpPr>
          <p:nvPr>
            <p:ph type="sldNum" sz="quarter" idx="10"/>
          </p:nvPr>
        </p:nvSpPr>
        <p:spPr/>
        <p:txBody>
          <a:bodyPr/>
          <a:lstStyle/>
          <a:p>
            <a:fld id="{5EFEA032-0E95-4D29-BF39-F543451FF4F5}" type="slidenum">
              <a:rPr lang="it-IT" smtClean="0"/>
              <a:t>8</a:t>
            </a:fld>
            <a:endParaRPr lang="it-IT"/>
          </a:p>
        </p:txBody>
      </p:sp>
    </p:spTree>
    <p:extLst>
      <p:ext uri="{BB962C8B-B14F-4D97-AF65-F5344CB8AC3E}">
        <p14:creationId xmlns:p14="http://schemas.microsoft.com/office/powerpoint/2010/main" val="263599901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egnaposto immagine diapositiva 1"/>
          <p:cNvSpPr>
            <a:spLocks noGrp="1" noRot="1" noChangeAspect="1"/>
          </p:cNvSpPr>
          <p:nvPr>
            <p:ph type="sldImg"/>
          </p:nvPr>
        </p:nvSpPr>
        <p:spPr/>
      </p:sp>
      <p:sp>
        <p:nvSpPr>
          <p:cNvPr id="3" name="Segnaposto note 2"/>
          <p:cNvSpPr>
            <a:spLocks noGrp="1"/>
          </p:cNvSpPr>
          <p:nvPr>
            <p:ph type="body" idx="1"/>
          </p:nvPr>
        </p:nvSpPr>
        <p:spPr/>
        <p:txBody>
          <a:bodyPr/>
          <a:lstStyle/>
          <a:p>
            <a:endParaRPr lang="it-IT"/>
          </a:p>
        </p:txBody>
      </p:sp>
      <p:sp>
        <p:nvSpPr>
          <p:cNvPr id="4" name="Segnaposto numero diapositiva 3"/>
          <p:cNvSpPr>
            <a:spLocks noGrp="1"/>
          </p:cNvSpPr>
          <p:nvPr>
            <p:ph type="sldNum" sz="quarter" idx="10"/>
          </p:nvPr>
        </p:nvSpPr>
        <p:spPr/>
        <p:txBody>
          <a:bodyPr/>
          <a:lstStyle/>
          <a:p>
            <a:fld id="{5EFEA032-0E95-4D29-BF39-F543451FF4F5}" type="slidenum">
              <a:rPr lang="it-IT" smtClean="0"/>
              <a:t>9</a:t>
            </a:fld>
            <a:endParaRPr lang="it-IT"/>
          </a:p>
        </p:txBody>
      </p:sp>
    </p:spTree>
    <p:extLst>
      <p:ext uri="{BB962C8B-B14F-4D97-AF65-F5344CB8AC3E}">
        <p14:creationId xmlns:p14="http://schemas.microsoft.com/office/powerpoint/2010/main" val="35238229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egnaposto immagine diapositiva 1"/>
          <p:cNvSpPr>
            <a:spLocks noGrp="1" noRot="1" noChangeAspect="1"/>
          </p:cNvSpPr>
          <p:nvPr>
            <p:ph type="sldImg"/>
          </p:nvPr>
        </p:nvSpPr>
        <p:spPr/>
      </p:sp>
      <p:sp>
        <p:nvSpPr>
          <p:cNvPr id="3" name="Segnaposto note 2"/>
          <p:cNvSpPr>
            <a:spLocks noGrp="1"/>
          </p:cNvSpPr>
          <p:nvPr>
            <p:ph type="body" idx="1"/>
          </p:nvPr>
        </p:nvSpPr>
        <p:spPr/>
        <p:txBody>
          <a:bodyPr/>
          <a:lstStyle/>
          <a:p>
            <a:endParaRPr lang="it-IT"/>
          </a:p>
        </p:txBody>
      </p:sp>
      <p:sp>
        <p:nvSpPr>
          <p:cNvPr id="4" name="Segnaposto numero diapositiva 3"/>
          <p:cNvSpPr>
            <a:spLocks noGrp="1"/>
          </p:cNvSpPr>
          <p:nvPr>
            <p:ph type="sldNum" sz="quarter" idx="10"/>
          </p:nvPr>
        </p:nvSpPr>
        <p:spPr/>
        <p:txBody>
          <a:bodyPr/>
          <a:lstStyle/>
          <a:p>
            <a:fld id="{5EFEA032-0E95-4D29-BF39-F543451FF4F5}" type="slidenum">
              <a:rPr lang="it-IT" smtClean="0"/>
              <a:t>10</a:t>
            </a:fld>
            <a:endParaRPr lang="it-IT"/>
          </a:p>
        </p:txBody>
      </p:sp>
    </p:spTree>
    <p:extLst>
      <p:ext uri="{BB962C8B-B14F-4D97-AF65-F5344CB8AC3E}">
        <p14:creationId xmlns:p14="http://schemas.microsoft.com/office/powerpoint/2010/main" val="243793641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titolo">
    <p:spTree>
      <p:nvGrpSpPr>
        <p:cNvPr id="1" name=""/>
        <p:cNvGrpSpPr/>
        <p:nvPr/>
      </p:nvGrpSpPr>
      <p:grpSpPr>
        <a:xfrm>
          <a:off x="0" y="0"/>
          <a:ext cx="0" cy="0"/>
          <a:chOff x="0" y="0"/>
          <a:chExt cx="0" cy="0"/>
        </a:xfrm>
      </p:grpSpPr>
      <p:sp>
        <p:nvSpPr>
          <p:cNvPr id="2" name="Title 1"/>
          <p:cNvSpPr>
            <a:spLocks noGrp="1"/>
          </p:cNvSpPr>
          <p:nvPr>
            <p:ph type="ctrTitle"/>
          </p:nvPr>
        </p:nvSpPr>
        <p:spPr>
          <a:xfrm>
            <a:off x="458986" y="1355149"/>
            <a:ext cx="5201841" cy="2882806"/>
          </a:xfrm>
        </p:spPr>
        <p:txBody>
          <a:bodyPr anchor="b"/>
          <a:lstStyle>
            <a:lvl1pPr algn="ctr">
              <a:defRPr sz="4016"/>
            </a:lvl1pPr>
          </a:lstStyle>
          <a:p>
            <a:r>
              <a:rPr lang="it-IT" smtClean="0"/>
              <a:t>Fare clic per modificare lo stile del titolo</a:t>
            </a:r>
            <a:endParaRPr lang="en-US" dirty="0"/>
          </a:p>
        </p:txBody>
      </p:sp>
      <p:sp>
        <p:nvSpPr>
          <p:cNvPr id="3" name="Subtitle 2"/>
          <p:cNvSpPr>
            <a:spLocks noGrp="1"/>
          </p:cNvSpPr>
          <p:nvPr>
            <p:ph type="subTitle" idx="1"/>
          </p:nvPr>
        </p:nvSpPr>
        <p:spPr>
          <a:xfrm>
            <a:off x="764977" y="4349128"/>
            <a:ext cx="4589860" cy="1999179"/>
          </a:xfrm>
        </p:spPr>
        <p:txBody>
          <a:bodyPr/>
          <a:lstStyle>
            <a:lvl1pPr marL="0" indent="0" algn="ctr">
              <a:buNone/>
              <a:defRPr sz="1606"/>
            </a:lvl1pPr>
            <a:lvl2pPr marL="306004" indent="0" algn="ctr">
              <a:buNone/>
              <a:defRPr sz="1339"/>
            </a:lvl2pPr>
            <a:lvl3pPr marL="612008" indent="0" algn="ctr">
              <a:buNone/>
              <a:defRPr sz="1205"/>
            </a:lvl3pPr>
            <a:lvl4pPr marL="918012" indent="0" algn="ctr">
              <a:buNone/>
              <a:defRPr sz="1071"/>
            </a:lvl4pPr>
            <a:lvl5pPr marL="1224016" indent="0" algn="ctr">
              <a:buNone/>
              <a:defRPr sz="1071"/>
            </a:lvl5pPr>
            <a:lvl6pPr marL="1530020" indent="0" algn="ctr">
              <a:buNone/>
              <a:defRPr sz="1071"/>
            </a:lvl6pPr>
            <a:lvl7pPr marL="1836024" indent="0" algn="ctr">
              <a:buNone/>
              <a:defRPr sz="1071"/>
            </a:lvl7pPr>
            <a:lvl8pPr marL="2142028" indent="0" algn="ctr">
              <a:buNone/>
              <a:defRPr sz="1071"/>
            </a:lvl8pPr>
            <a:lvl9pPr marL="2448032" indent="0" algn="ctr">
              <a:buNone/>
              <a:defRPr sz="1071"/>
            </a:lvl9pPr>
          </a:lstStyle>
          <a:p>
            <a:r>
              <a:rPr lang="it-IT" smtClean="0"/>
              <a:t>Fare clic per modificare lo stile del sottotitolo dello schema</a:t>
            </a:r>
            <a:endParaRPr lang="en-US" dirty="0"/>
          </a:p>
        </p:txBody>
      </p:sp>
      <p:sp>
        <p:nvSpPr>
          <p:cNvPr id="4" name="Date Placeholder 3"/>
          <p:cNvSpPr>
            <a:spLocks noGrp="1"/>
          </p:cNvSpPr>
          <p:nvPr>
            <p:ph type="dt" sz="half" idx="10"/>
          </p:nvPr>
        </p:nvSpPr>
        <p:spPr/>
        <p:txBody>
          <a:bodyPr/>
          <a:lstStyle/>
          <a:p>
            <a:fld id="{B7B91465-30FC-4E8F-80E6-3CF7A5F6A40B}" type="datetimeFigureOut">
              <a:rPr lang="it-IT" smtClean="0"/>
              <a:t>24/09/2019</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4149000F-F82E-4420-9A61-A4705004E9FD}" type="slidenum">
              <a:rPr lang="it-IT" smtClean="0"/>
              <a:t>‹N›</a:t>
            </a:fld>
            <a:endParaRPr lang="it-IT"/>
          </a:p>
        </p:txBody>
      </p:sp>
    </p:spTree>
    <p:extLst>
      <p:ext uri="{BB962C8B-B14F-4D97-AF65-F5344CB8AC3E}">
        <p14:creationId xmlns:p14="http://schemas.microsoft.com/office/powerpoint/2010/main" val="411524886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olo e testo vertical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it-IT" smtClean="0"/>
              <a:t>Fare clic per modificare lo stile del titolo</a:t>
            </a:r>
            <a:endParaRPr lang="en-US" dirty="0"/>
          </a:p>
        </p:txBody>
      </p:sp>
      <p:sp>
        <p:nvSpPr>
          <p:cNvPr id="3" name="Vertical Text Placeholder 2"/>
          <p:cNvSpPr>
            <a:spLocks noGrp="1"/>
          </p:cNvSpPr>
          <p:nvPr>
            <p:ph type="body" orient="vert" idx="1"/>
          </p:nvPr>
        </p:nvSpPr>
        <p:spPr/>
        <p:txBody>
          <a:bodyPr vert="eaVert"/>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en-US" dirty="0"/>
          </a:p>
        </p:txBody>
      </p:sp>
      <p:sp>
        <p:nvSpPr>
          <p:cNvPr id="4" name="Date Placeholder 3"/>
          <p:cNvSpPr>
            <a:spLocks noGrp="1"/>
          </p:cNvSpPr>
          <p:nvPr>
            <p:ph type="dt" sz="half" idx="10"/>
          </p:nvPr>
        </p:nvSpPr>
        <p:spPr/>
        <p:txBody>
          <a:bodyPr/>
          <a:lstStyle/>
          <a:p>
            <a:fld id="{B7B91465-30FC-4E8F-80E6-3CF7A5F6A40B}" type="datetimeFigureOut">
              <a:rPr lang="it-IT" smtClean="0"/>
              <a:t>24/09/2019</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4149000F-F82E-4420-9A61-A4705004E9FD}" type="slidenum">
              <a:rPr lang="it-IT" smtClean="0"/>
              <a:t>‹N›</a:t>
            </a:fld>
            <a:endParaRPr lang="it-IT"/>
          </a:p>
        </p:txBody>
      </p:sp>
    </p:spTree>
    <p:extLst>
      <p:ext uri="{BB962C8B-B14F-4D97-AF65-F5344CB8AC3E}">
        <p14:creationId xmlns:p14="http://schemas.microsoft.com/office/powerpoint/2010/main" val="259733990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1_Titolo e testo vertical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379491" y="440855"/>
            <a:ext cx="1319585" cy="7017256"/>
          </a:xfrm>
        </p:spPr>
        <p:txBody>
          <a:bodyPr vert="eaVert"/>
          <a:lstStyle/>
          <a:p>
            <a:r>
              <a:rPr lang="it-IT" smtClean="0"/>
              <a:t>Fare clic per modificare lo stile del titolo</a:t>
            </a:r>
            <a:endParaRPr lang="en-US" dirty="0"/>
          </a:p>
        </p:txBody>
      </p:sp>
      <p:sp>
        <p:nvSpPr>
          <p:cNvPr id="3" name="Vertical Text Placeholder 2"/>
          <p:cNvSpPr>
            <a:spLocks noGrp="1"/>
          </p:cNvSpPr>
          <p:nvPr>
            <p:ph type="body" orient="vert" idx="1"/>
          </p:nvPr>
        </p:nvSpPr>
        <p:spPr>
          <a:xfrm>
            <a:off x="420738" y="440855"/>
            <a:ext cx="3882256" cy="7017256"/>
          </a:xfrm>
        </p:spPr>
        <p:txBody>
          <a:bodyPr vert="eaVert"/>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en-US" dirty="0"/>
          </a:p>
        </p:txBody>
      </p:sp>
      <p:sp>
        <p:nvSpPr>
          <p:cNvPr id="4" name="Date Placeholder 3"/>
          <p:cNvSpPr>
            <a:spLocks noGrp="1"/>
          </p:cNvSpPr>
          <p:nvPr>
            <p:ph type="dt" sz="half" idx="10"/>
          </p:nvPr>
        </p:nvSpPr>
        <p:spPr/>
        <p:txBody>
          <a:bodyPr/>
          <a:lstStyle/>
          <a:p>
            <a:fld id="{B7B91465-30FC-4E8F-80E6-3CF7A5F6A40B}" type="datetimeFigureOut">
              <a:rPr lang="it-IT" smtClean="0"/>
              <a:t>24/09/2019</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4149000F-F82E-4420-9A61-A4705004E9FD}" type="slidenum">
              <a:rPr lang="it-IT" smtClean="0"/>
              <a:t>‹N›</a:t>
            </a:fld>
            <a:endParaRPr lang="it-IT"/>
          </a:p>
        </p:txBody>
      </p:sp>
    </p:spTree>
    <p:extLst>
      <p:ext uri="{BB962C8B-B14F-4D97-AF65-F5344CB8AC3E}">
        <p14:creationId xmlns:p14="http://schemas.microsoft.com/office/powerpoint/2010/main" val="133266967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olo e contenut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it-IT" smtClean="0"/>
              <a:t>Fare clic per modificare lo stile del titolo</a:t>
            </a:r>
            <a:endParaRPr lang="en-US" dirty="0"/>
          </a:p>
        </p:txBody>
      </p:sp>
      <p:sp>
        <p:nvSpPr>
          <p:cNvPr id="3" name="Content Placeholder 2"/>
          <p:cNvSpPr>
            <a:spLocks noGrp="1"/>
          </p:cNvSpPr>
          <p:nvPr>
            <p:ph idx="1"/>
          </p:nvPr>
        </p:nvSpPr>
        <p:spPr/>
        <p:txBody>
          <a:body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en-US" dirty="0"/>
          </a:p>
        </p:txBody>
      </p:sp>
      <p:sp>
        <p:nvSpPr>
          <p:cNvPr id="4" name="Date Placeholder 3"/>
          <p:cNvSpPr>
            <a:spLocks noGrp="1"/>
          </p:cNvSpPr>
          <p:nvPr>
            <p:ph type="dt" sz="half" idx="10"/>
          </p:nvPr>
        </p:nvSpPr>
        <p:spPr/>
        <p:txBody>
          <a:bodyPr/>
          <a:lstStyle/>
          <a:p>
            <a:fld id="{B7B91465-30FC-4E8F-80E6-3CF7A5F6A40B}" type="datetimeFigureOut">
              <a:rPr lang="it-IT" smtClean="0"/>
              <a:t>24/09/2019</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4149000F-F82E-4420-9A61-A4705004E9FD}" type="slidenum">
              <a:rPr lang="it-IT" smtClean="0"/>
              <a:t>‹N›</a:t>
            </a:fld>
            <a:endParaRPr lang="it-IT"/>
          </a:p>
        </p:txBody>
      </p:sp>
    </p:spTree>
    <p:extLst>
      <p:ext uri="{BB962C8B-B14F-4D97-AF65-F5344CB8AC3E}">
        <p14:creationId xmlns:p14="http://schemas.microsoft.com/office/powerpoint/2010/main" val="349173236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Intestazione sezione">
    <p:spTree>
      <p:nvGrpSpPr>
        <p:cNvPr id="1" name=""/>
        <p:cNvGrpSpPr/>
        <p:nvPr/>
      </p:nvGrpSpPr>
      <p:grpSpPr>
        <a:xfrm>
          <a:off x="0" y="0"/>
          <a:ext cx="0" cy="0"/>
          <a:chOff x="0" y="0"/>
          <a:chExt cx="0" cy="0"/>
        </a:xfrm>
      </p:grpSpPr>
      <p:sp>
        <p:nvSpPr>
          <p:cNvPr id="2" name="Title 1"/>
          <p:cNvSpPr>
            <a:spLocks noGrp="1"/>
          </p:cNvSpPr>
          <p:nvPr>
            <p:ph type="title"/>
          </p:nvPr>
        </p:nvSpPr>
        <p:spPr>
          <a:xfrm>
            <a:off x="417550" y="2064352"/>
            <a:ext cx="5278339" cy="3444416"/>
          </a:xfrm>
        </p:spPr>
        <p:txBody>
          <a:bodyPr anchor="b"/>
          <a:lstStyle>
            <a:lvl1pPr>
              <a:defRPr sz="4016"/>
            </a:lvl1pPr>
          </a:lstStyle>
          <a:p>
            <a:r>
              <a:rPr lang="it-IT" smtClean="0"/>
              <a:t>Fare clic per modificare lo stile del titolo</a:t>
            </a:r>
            <a:endParaRPr lang="en-US" dirty="0"/>
          </a:p>
        </p:txBody>
      </p:sp>
      <p:sp>
        <p:nvSpPr>
          <p:cNvPr id="3" name="Text Placeholder 2"/>
          <p:cNvSpPr>
            <a:spLocks noGrp="1"/>
          </p:cNvSpPr>
          <p:nvPr>
            <p:ph type="body" idx="1"/>
          </p:nvPr>
        </p:nvSpPr>
        <p:spPr>
          <a:xfrm>
            <a:off x="417550" y="5541353"/>
            <a:ext cx="5278339" cy="1811337"/>
          </a:xfrm>
        </p:spPr>
        <p:txBody>
          <a:bodyPr/>
          <a:lstStyle>
            <a:lvl1pPr marL="0" indent="0">
              <a:buNone/>
              <a:defRPr sz="1606">
                <a:solidFill>
                  <a:schemeClr val="tx1"/>
                </a:solidFill>
              </a:defRPr>
            </a:lvl1pPr>
            <a:lvl2pPr marL="306004" indent="0">
              <a:buNone/>
              <a:defRPr sz="1339">
                <a:solidFill>
                  <a:schemeClr val="tx1">
                    <a:tint val="75000"/>
                  </a:schemeClr>
                </a:solidFill>
              </a:defRPr>
            </a:lvl2pPr>
            <a:lvl3pPr marL="612008" indent="0">
              <a:buNone/>
              <a:defRPr sz="1205">
                <a:solidFill>
                  <a:schemeClr val="tx1">
                    <a:tint val="75000"/>
                  </a:schemeClr>
                </a:solidFill>
              </a:defRPr>
            </a:lvl3pPr>
            <a:lvl4pPr marL="918012" indent="0">
              <a:buNone/>
              <a:defRPr sz="1071">
                <a:solidFill>
                  <a:schemeClr val="tx1">
                    <a:tint val="75000"/>
                  </a:schemeClr>
                </a:solidFill>
              </a:defRPr>
            </a:lvl4pPr>
            <a:lvl5pPr marL="1224016" indent="0">
              <a:buNone/>
              <a:defRPr sz="1071">
                <a:solidFill>
                  <a:schemeClr val="tx1">
                    <a:tint val="75000"/>
                  </a:schemeClr>
                </a:solidFill>
              </a:defRPr>
            </a:lvl5pPr>
            <a:lvl6pPr marL="1530020" indent="0">
              <a:buNone/>
              <a:defRPr sz="1071">
                <a:solidFill>
                  <a:schemeClr val="tx1">
                    <a:tint val="75000"/>
                  </a:schemeClr>
                </a:solidFill>
              </a:defRPr>
            </a:lvl6pPr>
            <a:lvl7pPr marL="1836024" indent="0">
              <a:buNone/>
              <a:defRPr sz="1071">
                <a:solidFill>
                  <a:schemeClr val="tx1">
                    <a:tint val="75000"/>
                  </a:schemeClr>
                </a:solidFill>
              </a:defRPr>
            </a:lvl7pPr>
            <a:lvl8pPr marL="2142028" indent="0">
              <a:buNone/>
              <a:defRPr sz="1071">
                <a:solidFill>
                  <a:schemeClr val="tx1">
                    <a:tint val="75000"/>
                  </a:schemeClr>
                </a:solidFill>
              </a:defRPr>
            </a:lvl8pPr>
            <a:lvl9pPr marL="2448032" indent="0">
              <a:buNone/>
              <a:defRPr sz="1071">
                <a:solidFill>
                  <a:schemeClr val="tx1">
                    <a:tint val="75000"/>
                  </a:schemeClr>
                </a:solidFill>
              </a:defRPr>
            </a:lvl9pPr>
          </a:lstStyle>
          <a:p>
            <a:pPr lvl="0"/>
            <a:r>
              <a:rPr lang="it-IT" smtClean="0"/>
              <a:t>Fare clic per modificare stili del testo dello schema</a:t>
            </a:r>
          </a:p>
        </p:txBody>
      </p:sp>
      <p:sp>
        <p:nvSpPr>
          <p:cNvPr id="4" name="Date Placeholder 3"/>
          <p:cNvSpPr>
            <a:spLocks noGrp="1"/>
          </p:cNvSpPr>
          <p:nvPr>
            <p:ph type="dt" sz="half" idx="10"/>
          </p:nvPr>
        </p:nvSpPr>
        <p:spPr/>
        <p:txBody>
          <a:bodyPr/>
          <a:lstStyle/>
          <a:p>
            <a:fld id="{B7B91465-30FC-4E8F-80E6-3CF7A5F6A40B}" type="datetimeFigureOut">
              <a:rPr lang="it-IT" smtClean="0"/>
              <a:t>24/09/2019</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4149000F-F82E-4420-9A61-A4705004E9FD}" type="slidenum">
              <a:rPr lang="it-IT" smtClean="0"/>
              <a:t>‹N›</a:t>
            </a:fld>
            <a:endParaRPr lang="it-IT"/>
          </a:p>
        </p:txBody>
      </p:sp>
    </p:spTree>
    <p:extLst>
      <p:ext uri="{BB962C8B-B14F-4D97-AF65-F5344CB8AC3E}">
        <p14:creationId xmlns:p14="http://schemas.microsoft.com/office/powerpoint/2010/main" val="270260278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ue contenuti">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it-IT" smtClean="0"/>
              <a:t>Fare clic per modificare lo stile del titolo</a:t>
            </a:r>
            <a:endParaRPr lang="en-US" dirty="0"/>
          </a:p>
        </p:txBody>
      </p:sp>
      <p:sp>
        <p:nvSpPr>
          <p:cNvPr id="3" name="Content Placeholder 2"/>
          <p:cNvSpPr>
            <a:spLocks noGrp="1"/>
          </p:cNvSpPr>
          <p:nvPr>
            <p:ph sz="half" idx="1"/>
          </p:nvPr>
        </p:nvSpPr>
        <p:spPr>
          <a:xfrm>
            <a:off x="420737" y="2204273"/>
            <a:ext cx="2600921" cy="5253838"/>
          </a:xfrm>
        </p:spPr>
        <p:txBody>
          <a:body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en-US" dirty="0"/>
          </a:p>
        </p:txBody>
      </p:sp>
      <p:sp>
        <p:nvSpPr>
          <p:cNvPr id="4" name="Content Placeholder 3"/>
          <p:cNvSpPr>
            <a:spLocks noGrp="1"/>
          </p:cNvSpPr>
          <p:nvPr>
            <p:ph sz="half" idx="2"/>
          </p:nvPr>
        </p:nvSpPr>
        <p:spPr>
          <a:xfrm>
            <a:off x="3098155" y="2204273"/>
            <a:ext cx="2600921" cy="5253838"/>
          </a:xfrm>
        </p:spPr>
        <p:txBody>
          <a:body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en-US" dirty="0"/>
          </a:p>
        </p:txBody>
      </p:sp>
      <p:sp>
        <p:nvSpPr>
          <p:cNvPr id="5" name="Date Placeholder 4"/>
          <p:cNvSpPr>
            <a:spLocks noGrp="1"/>
          </p:cNvSpPr>
          <p:nvPr>
            <p:ph type="dt" sz="half" idx="10"/>
          </p:nvPr>
        </p:nvSpPr>
        <p:spPr/>
        <p:txBody>
          <a:bodyPr/>
          <a:lstStyle/>
          <a:p>
            <a:fld id="{B7B91465-30FC-4E8F-80E6-3CF7A5F6A40B}" type="datetimeFigureOut">
              <a:rPr lang="it-IT" smtClean="0"/>
              <a:t>24/09/2019</a:t>
            </a:fld>
            <a:endParaRPr lang="it-IT"/>
          </a:p>
        </p:txBody>
      </p:sp>
      <p:sp>
        <p:nvSpPr>
          <p:cNvPr id="6" name="Footer Placeholder 5"/>
          <p:cNvSpPr>
            <a:spLocks noGrp="1"/>
          </p:cNvSpPr>
          <p:nvPr>
            <p:ph type="ftr" sz="quarter" idx="11"/>
          </p:nvPr>
        </p:nvSpPr>
        <p:spPr/>
        <p:txBody>
          <a:bodyPr/>
          <a:lstStyle/>
          <a:p>
            <a:endParaRPr lang="it-IT"/>
          </a:p>
        </p:txBody>
      </p:sp>
      <p:sp>
        <p:nvSpPr>
          <p:cNvPr id="7" name="Slide Number Placeholder 6"/>
          <p:cNvSpPr>
            <a:spLocks noGrp="1"/>
          </p:cNvSpPr>
          <p:nvPr>
            <p:ph type="sldNum" sz="quarter" idx="12"/>
          </p:nvPr>
        </p:nvSpPr>
        <p:spPr/>
        <p:txBody>
          <a:bodyPr/>
          <a:lstStyle/>
          <a:p>
            <a:fld id="{4149000F-F82E-4420-9A61-A4705004E9FD}" type="slidenum">
              <a:rPr lang="it-IT" smtClean="0"/>
              <a:t>‹N›</a:t>
            </a:fld>
            <a:endParaRPr lang="it-IT"/>
          </a:p>
        </p:txBody>
      </p:sp>
    </p:spTree>
    <p:extLst>
      <p:ext uri="{BB962C8B-B14F-4D97-AF65-F5344CB8AC3E}">
        <p14:creationId xmlns:p14="http://schemas.microsoft.com/office/powerpoint/2010/main" val="424813376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nfronto">
    <p:spTree>
      <p:nvGrpSpPr>
        <p:cNvPr id="1" name=""/>
        <p:cNvGrpSpPr/>
        <p:nvPr/>
      </p:nvGrpSpPr>
      <p:grpSpPr>
        <a:xfrm>
          <a:off x="0" y="0"/>
          <a:ext cx="0" cy="0"/>
          <a:chOff x="0" y="0"/>
          <a:chExt cx="0" cy="0"/>
        </a:xfrm>
      </p:grpSpPr>
      <p:sp>
        <p:nvSpPr>
          <p:cNvPr id="2" name="Title 1"/>
          <p:cNvSpPr>
            <a:spLocks noGrp="1"/>
          </p:cNvSpPr>
          <p:nvPr>
            <p:ph type="title"/>
          </p:nvPr>
        </p:nvSpPr>
        <p:spPr>
          <a:xfrm>
            <a:off x="421534" y="440856"/>
            <a:ext cx="5278339" cy="1600495"/>
          </a:xfrm>
        </p:spPr>
        <p:txBody>
          <a:bodyPr/>
          <a:lstStyle/>
          <a:p>
            <a:r>
              <a:rPr lang="it-IT" smtClean="0"/>
              <a:t>Fare clic per modificare lo stile del titolo</a:t>
            </a:r>
            <a:endParaRPr lang="en-US" dirty="0"/>
          </a:p>
        </p:txBody>
      </p:sp>
      <p:sp>
        <p:nvSpPr>
          <p:cNvPr id="3" name="Text Placeholder 2"/>
          <p:cNvSpPr>
            <a:spLocks noGrp="1"/>
          </p:cNvSpPr>
          <p:nvPr>
            <p:ph type="body" idx="1"/>
          </p:nvPr>
        </p:nvSpPr>
        <p:spPr>
          <a:xfrm>
            <a:off x="421535" y="2029849"/>
            <a:ext cx="2588967" cy="994797"/>
          </a:xfrm>
        </p:spPr>
        <p:txBody>
          <a:bodyPr anchor="b"/>
          <a:lstStyle>
            <a:lvl1pPr marL="0" indent="0">
              <a:buNone/>
              <a:defRPr sz="1606" b="1"/>
            </a:lvl1pPr>
            <a:lvl2pPr marL="306004" indent="0">
              <a:buNone/>
              <a:defRPr sz="1339" b="1"/>
            </a:lvl2pPr>
            <a:lvl3pPr marL="612008" indent="0">
              <a:buNone/>
              <a:defRPr sz="1205" b="1"/>
            </a:lvl3pPr>
            <a:lvl4pPr marL="918012" indent="0">
              <a:buNone/>
              <a:defRPr sz="1071" b="1"/>
            </a:lvl4pPr>
            <a:lvl5pPr marL="1224016" indent="0">
              <a:buNone/>
              <a:defRPr sz="1071" b="1"/>
            </a:lvl5pPr>
            <a:lvl6pPr marL="1530020" indent="0">
              <a:buNone/>
              <a:defRPr sz="1071" b="1"/>
            </a:lvl6pPr>
            <a:lvl7pPr marL="1836024" indent="0">
              <a:buNone/>
              <a:defRPr sz="1071" b="1"/>
            </a:lvl7pPr>
            <a:lvl8pPr marL="2142028" indent="0">
              <a:buNone/>
              <a:defRPr sz="1071" b="1"/>
            </a:lvl8pPr>
            <a:lvl9pPr marL="2448032" indent="0">
              <a:buNone/>
              <a:defRPr sz="1071" b="1"/>
            </a:lvl9pPr>
          </a:lstStyle>
          <a:p>
            <a:pPr lvl="0"/>
            <a:r>
              <a:rPr lang="it-IT" smtClean="0"/>
              <a:t>Fare clic per modificare stili del testo dello schema</a:t>
            </a:r>
          </a:p>
        </p:txBody>
      </p:sp>
      <p:sp>
        <p:nvSpPr>
          <p:cNvPr id="4" name="Content Placeholder 3"/>
          <p:cNvSpPr>
            <a:spLocks noGrp="1"/>
          </p:cNvSpPr>
          <p:nvPr>
            <p:ph sz="half" idx="2"/>
          </p:nvPr>
        </p:nvSpPr>
        <p:spPr>
          <a:xfrm>
            <a:off x="421535" y="3024646"/>
            <a:ext cx="2588967" cy="4448799"/>
          </a:xfrm>
        </p:spPr>
        <p:txBody>
          <a:body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en-US" dirty="0"/>
          </a:p>
        </p:txBody>
      </p:sp>
      <p:sp>
        <p:nvSpPr>
          <p:cNvPr id="5" name="Text Placeholder 4"/>
          <p:cNvSpPr>
            <a:spLocks noGrp="1"/>
          </p:cNvSpPr>
          <p:nvPr>
            <p:ph type="body" sz="quarter" idx="3"/>
          </p:nvPr>
        </p:nvSpPr>
        <p:spPr>
          <a:xfrm>
            <a:off x="3098155" y="2029849"/>
            <a:ext cx="2601718" cy="994797"/>
          </a:xfrm>
        </p:spPr>
        <p:txBody>
          <a:bodyPr anchor="b"/>
          <a:lstStyle>
            <a:lvl1pPr marL="0" indent="0">
              <a:buNone/>
              <a:defRPr sz="1606" b="1"/>
            </a:lvl1pPr>
            <a:lvl2pPr marL="306004" indent="0">
              <a:buNone/>
              <a:defRPr sz="1339" b="1"/>
            </a:lvl2pPr>
            <a:lvl3pPr marL="612008" indent="0">
              <a:buNone/>
              <a:defRPr sz="1205" b="1"/>
            </a:lvl3pPr>
            <a:lvl4pPr marL="918012" indent="0">
              <a:buNone/>
              <a:defRPr sz="1071" b="1"/>
            </a:lvl4pPr>
            <a:lvl5pPr marL="1224016" indent="0">
              <a:buNone/>
              <a:defRPr sz="1071" b="1"/>
            </a:lvl5pPr>
            <a:lvl6pPr marL="1530020" indent="0">
              <a:buNone/>
              <a:defRPr sz="1071" b="1"/>
            </a:lvl6pPr>
            <a:lvl7pPr marL="1836024" indent="0">
              <a:buNone/>
              <a:defRPr sz="1071" b="1"/>
            </a:lvl7pPr>
            <a:lvl8pPr marL="2142028" indent="0">
              <a:buNone/>
              <a:defRPr sz="1071" b="1"/>
            </a:lvl8pPr>
            <a:lvl9pPr marL="2448032" indent="0">
              <a:buNone/>
              <a:defRPr sz="1071" b="1"/>
            </a:lvl9pPr>
          </a:lstStyle>
          <a:p>
            <a:pPr lvl="0"/>
            <a:r>
              <a:rPr lang="it-IT" smtClean="0"/>
              <a:t>Fare clic per modificare stili del testo dello schema</a:t>
            </a:r>
          </a:p>
        </p:txBody>
      </p:sp>
      <p:sp>
        <p:nvSpPr>
          <p:cNvPr id="6" name="Content Placeholder 5"/>
          <p:cNvSpPr>
            <a:spLocks noGrp="1"/>
          </p:cNvSpPr>
          <p:nvPr>
            <p:ph sz="quarter" idx="4"/>
          </p:nvPr>
        </p:nvSpPr>
        <p:spPr>
          <a:xfrm>
            <a:off x="3098155" y="3024646"/>
            <a:ext cx="2601718" cy="4448799"/>
          </a:xfrm>
        </p:spPr>
        <p:txBody>
          <a:body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en-US" dirty="0"/>
          </a:p>
        </p:txBody>
      </p:sp>
      <p:sp>
        <p:nvSpPr>
          <p:cNvPr id="7" name="Date Placeholder 6"/>
          <p:cNvSpPr>
            <a:spLocks noGrp="1"/>
          </p:cNvSpPr>
          <p:nvPr>
            <p:ph type="dt" sz="half" idx="10"/>
          </p:nvPr>
        </p:nvSpPr>
        <p:spPr/>
        <p:txBody>
          <a:bodyPr/>
          <a:lstStyle/>
          <a:p>
            <a:fld id="{B7B91465-30FC-4E8F-80E6-3CF7A5F6A40B}" type="datetimeFigureOut">
              <a:rPr lang="it-IT" smtClean="0"/>
              <a:t>24/09/2019</a:t>
            </a:fld>
            <a:endParaRPr lang="it-IT"/>
          </a:p>
        </p:txBody>
      </p:sp>
      <p:sp>
        <p:nvSpPr>
          <p:cNvPr id="8" name="Footer Placeholder 7"/>
          <p:cNvSpPr>
            <a:spLocks noGrp="1"/>
          </p:cNvSpPr>
          <p:nvPr>
            <p:ph type="ftr" sz="quarter" idx="11"/>
          </p:nvPr>
        </p:nvSpPr>
        <p:spPr/>
        <p:txBody>
          <a:bodyPr/>
          <a:lstStyle/>
          <a:p>
            <a:endParaRPr lang="it-IT"/>
          </a:p>
        </p:txBody>
      </p:sp>
      <p:sp>
        <p:nvSpPr>
          <p:cNvPr id="9" name="Slide Number Placeholder 8"/>
          <p:cNvSpPr>
            <a:spLocks noGrp="1"/>
          </p:cNvSpPr>
          <p:nvPr>
            <p:ph type="sldNum" sz="quarter" idx="12"/>
          </p:nvPr>
        </p:nvSpPr>
        <p:spPr/>
        <p:txBody>
          <a:bodyPr/>
          <a:lstStyle/>
          <a:p>
            <a:fld id="{4149000F-F82E-4420-9A61-A4705004E9FD}" type="slidenum">
              <a:rPr lang="it-IT" smtClean="0"/>
              <a:t>‹N›</a:t>
            </a:fld>
            <a:endParaRPr lang="it-IT"/>
          </a:p>
        </p:txBody>
      </p:sp>
    </p:spTree>
    <p:extLst>
      <p:ext uri="{BB962C8B-B14F-4D97-AF65-F5344CB8AC3E}">
        <p14:creationId xmlns:p14="http://schemas.microsoft.com/office/powerpoint/2010/main" val="35399078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tito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it-IT" smtClean="0"/>
              <a:t>Fare clic per modificare lo stile del titolo</a:t>
            </a:r>
            <a:endParaRPr lang="en-US" dirty="0"/>
          </a:p>
        </p:txBody>
      </p:sp>
      <p:sp>
        <p:nvSpPr>
          <p:cNvPr id="3" name="Date Placeholder 2"/>
          <p:cNvSpPr>
            <a:spLocks noGrp="1"/>
          </p:cNvSpPr>
          <p:nvPr>
            <p:ph type="dt" sz="half" idx="10"/>
          </p:nvPr>
        </p:nvSpPr>
        <p:spPr/>
        <p:txBody>
          <a:bodyPr/>
          <a:lstStyle/>
          <a:p>
            <a:fld id="{B7B91465-30FC-4E8F-80E6-3CF7A5F6A40B}" type="datetimeFigureOut">
              <a:rPr lang="it-IT" smtClean="0"/>
              <a:t>24/09/2019</a:t>
            </a:fld>
            <a:endParaRPr lang="it-IT"/>
          </a:p>
        </p:txBody>
      </p:sp>
      <p:sp>
        <p:nvSpPr>
          <p:cNvPr id="4" name="Footer Placeholder 3"/>
          <p:cNvSpPr>
            <a:spLocks noGrp="1"/>
          </p:cNvSpPr>
          <p:nvPr>
            <p:ph type="ftr" sz="quarter" idx="11"/>
          </p:nvPr>
        </p:nvSpPr>
        <p:spPr/>
        <p:txBody>
          <a:bodyPr/>
          <a:lstStyle/>
          <a:p>
            <a:endParaRPr lang="it-IT"/>
          </a:p>
        </p:txBody>
      </p:sp>
      <p:sp>
        <p:nvSpPr>
          <p:cNvPr id="5" name="Slide Number Placeholder 4"/>
          <p:cNvSpPr>
            <a:spLocks noGrp="1"/>
          </p:cNvSpPr>
          <p:nvPr>
            <p:ph type="sldNum" sz="quarter" idx="12"/>
          </p:nvPr>
        </p:nvSpPr>
        <p:spPr/>
        <p:txBody>
          <a:bodyPr/>
          <a:lstStyle/>
          <a:p>
            <a:fld id="{4149000F-F82E-4420-9A61-A4705004E9FD}" type="slidenum">
              <a:rPr lang="it-IT" smtClean="0"/>
              <a:t>‹N›</a:t>
            </a:fld>
            <a:endParaRPr lang="it-IT"/>
          </a:p>
        </p:txBody>
      </p:sp>
    </p:spTree>
    <p:extLst>
      <p:ext uri="{BB962C8B-B14F-4D97-AF65-F5344CB8AC3E}">
        <p14:creationId xmlns:p14="http://schemas.microsoft.com/office/powerpoint/2010/main" val="76751140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uota">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7B91465-30FC-4E8F-80E6-3CF7A5F6A40B}" type="datetimeFigureOut">
              <a:rPr lang="it-IT" smtClean="0"/>
              <a:t>24/09/2019</a:t>
            </a:fld>
            <a:endParaRPr lang="it-IT"/>
          </a:p>
        </p:txBody>
      </p:sp>
      <p:sp>
        <p:nvSpPr>
          <p:cNvPr id="3" name="Footer Placeholder 2"/>
          <p:cNvSpPr>
            <a:spLocks noGrp="1"/>
          </p:cNvSpPr>
          <p:nvPr>
            <p:ph type="ftr" sz="quarter" idx="11"/>
          </p:nvPr>
        </p:nvSpPr>
        <p:spPr/>
        <p:txBody>
          <a:bodyPr/>
          <a:lstStyle/>
          <a:p>
            <a:endParaRPr lang="it-IT"/>
          </a:p>
        </p:txBody>
      </p:sp>
      <p:sp>
        <p:nvSpPr>
          <p:cNvPr id="4" name="Slide Number Placeholder 3"/>
          <p:cNvSpPr>
            <a:spLocks noGrp="1"/>
          </p:cNvSpPr>
          <p:nvPr>
            <p:ph type="sldNum" sz="quarter" idx="12"/>
          </p:nvPr>
        </p:nvSpPr>
        <p:spPr/>
        <p:txBody>
          <a:bodyPr/>
          <a:lstStyle/>
          <a:p>
            <a:fld id="{4149000F-F82E-4420-9A61-A4705004E9FD}" type="slidenum">
              <a:rPr lang="it-IT" smtClean="0"/>
              <a:t>‹N›</a:t>
            </a:fld>
            <a:endParaRPr lang="it-IT"/>
          </a:p>
        </p:txBody>
      </p:sp>
    </p:spTree>
    <p:extLst>
      <p:ext uri="{BB962C8B-B14F-4D97-AF65-F5344CB8AC3E}">
        <p14:creationId xmlns:p14="http://schemas.microsoft.com/office/powerpoint/2010/main" val="190132620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to con didascalia">
    <p:spTree>
      <p:nvGrpSpPr>
        <p:cNvPr id="1" name=""/>
        <p:cNvGrpSpPr/>
        <p:nvPr/>
      </p:nvGrpSpPr>
      <p:grpSpPr>
        <a:xfrm>
          <a:off x="0" y="0"/>
          <a:ext cx="0" cy="0"/>
          <a:chOff x="0" y="0"/>
          <a:chExt cx="0" cy="0"/>
        </a:xfrm>
      </p:grpSpPr>
      <p:sp>
        <p:nvSpPr>
          <p:cNvPr id="2" name="Title 1"/>
          <p:cNvSpPr>
            <a:spLocks noGrp="1"/>
          </p:cNvSpPr>
          <p:nvPr>
            <p:ph type="title"/>
          </p:nvPr>
        </p:nvSpPr>
        <p:spPr>
          <a:xfrm>
            <a:off x="421534" y="552027"/>
            <a:ext cx="1973799" cy="1932093"/>
          </a:xfrm>
        </p:spPr>
        <p:txBody>
          <a:bodyPr anchor="b"/>
          <a:lstStyle>
            <a:lvl1pPr>
              <a:defRPr sz="2142"/>
            </a:lvl1pPr>
          </a:lstStyle>
          <a:p>
            <a:r>
              <a:rPr lang="it-IT" smtClean="0"/>
              <a:t>Fare clic per modificare lo stile del titolo</a:t>
            </a:r>
            <a:endParaRPr lang="en-US" dirty="0"/>
          </a:p>
        </p:txBody>
      </p:sp>
      <p:sp>
        <p:nvSpPr>
          <p:cNvPr id="3" name="Content Placeholder 2"/>
          <p:cNvSpPr>
            <a:spLocks noGrp="1"/>
          </p:cNvSpPr>
          <p:nvPr>
            <p:ph idx="1"/>
          </p:nvPr>
        </p:nvSpPr>
        <p:spPr>
          <a:xfrm>
            <a:off x="2601718" y="1192226"/>
            <a:ext cx="3098155" cy="5884451"/>
          </a:xfrm>
        </p:spPr>
        <p:txBody>
          <a:bodyPr/>
          <a:lstStyle>
            <a:lvl1pPr>
              <a:defRPr sz="2142"/>
            </a:lvl1pPr>
            <a:lvl2pPr>
              <a:defRPr sz="1874"/>
            </a:lvl2pPr>
            <a:lvl3pPr>
              <a:defRPr sz="1606"/>
            </a:lvl3pPr>
            <a:lvl4pPr>
              <a:defRPr sz="1339"/>
            </a:lvl4pPr>
            <a:lvl5pPr>
              <a:defRPr sz="1339"/>
            </a:lvl5pPr>
            <a:lvl6pPr>
              <a:defRPr sz="1339"/>
            </a:lvl6pPr>
            <a:lvl7pPr>
              <a:defRPr sz="1339"/>
            </a:lvl7pPr>
            <a:lvl8pPr>
              <a:defRPr sz="1339"/>
            </a:lvl8pPr>
            <a:lvl9pPr>
              <a:defRPr sz="1339"/>
            </a:lvl9p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en-US" dirty="0"/>
          </a:p>
        </p:txBody>
      </p:sp>
      <p:sp>
        <p:nvSpPr>
          <p:cNvPr id="4" name="Text Placeholder 3"/>
          <p:cNvSpPr>
            <a:spLocks noGrp="1"/>
          </p:cNvSpPr>
          <p:nvPr>
            <p:ph type="body" sz="half" idx="2"/>
          </p:nvPr>
        </p:nvSpPr>
        <p:spPr>
          <a:xfrm>
            <a:off x="421534" y="2484120"/>
            <a:ext cx="1973799" cy="4602140"/>
          </a:xfrm>
        </p:spPr>
        <p:txBody>
          <a:bodyPr/>
          <a:lstStyle>
            <a:lvl1pPr marL="0" indent="0">
              <a:buNone/>
              <a:defRPr sz="1071"/>
            </a:lvl1pPr>
            <a:lvl2pPr marL="306004" indent="0">
              <a:buNone/>
              <a:defRPr sz="937"/>
            </a:lvl2pPr>
            <a:lvl3pPr marL="612008" indent="0">
              <a:buNone/>
              <a:defRPr sz="803"/>
            </a:lvl3pPr>
            <a:lvl4pPr marL="918012" indent="0">
              <a:buNone/>
              <a:defRPr sz="669"/>
            </a:lvl4pPr>
            <a:lvl5pPr marL="1224016" indent="0">
              <a:buNone/>
              <a:defRPr sz="669"/>
            </a:lvl5pPr>
            <a:lvl6pPr marL="1530020" indent="0">
              <a:buNone/>
              <a:defRPr sz="669"/>
            </a:lvl6pPr>
            <a:lvl7pPr marL="1836024" indent="0">
              <a:buNone/>
              <a:defRPr sz="669"/>
            </a:lvl7pPr>
            <a:lvl8pPr marL="2142028" indent="0">
              <a:buNone/>
              <a:defRPr sz="669"/>
            </a:lvl8pPr>
            <a:lvl9pPr marL="2448032" indent="0">
              <a:buNone/>
              <a:defRPr sz="669"/>
            </a:lvl9pPr>
          </a:lstStyle>
          <a:p>
            <a:pPr lvl="0"/>
            <a:r>
              <a:rPr lang="it-IT" smtClean="0"/>
              <a:t>Fare clic per modificare stili del testo dello schema</a:t>
            </a:r>
          </a:p>
        </p:txBody>
      </p:sp>
      <p:sp>
        <p:nvSpPr>
          <p:cNvPr id="5" name="Date Placeholder 4"/>
          <p:cNvSpPr>
            <a:spLocks noGrp="1"/>
          </p:cNvSpPr>
          <p:nvPr>
            <p:ph type="dt" sz="half" idx="10"/>
          </p:nvPr>
        </p:nvSpPr>
        <p:spPr/>
        <p:txBody>
          <a:bodyPr/>
          <a:lstStyle/>
          <a:p>
            <a:fld id="{B7B91465-30FC-4E8F-80E6-3CF7A5F6A40B}" type="datetimeFigureOut">
              <a:rPr lang="it-IT" smtClean="0"/>
              <a:t>24/09/2019</a:t>
            </a:fld>
            <a:endParaRPr lang="it-IT"/>
          </a:p>
        </p:txBody>
      </p:sp>
      <p:sp>
        <p:nvSpPr>
          <p:cNvPr id="6" name="Footer Placeholder 5"/>
          <p:cNvSpPr>
            <a:spLocks noGrp="1"/>
          </p:cNvSpPr>
          <p:nvPr>
            <p:ph type="ftr" sz="quarter" idx="11"/>
          </p:nvPr>
        </p:nvSpPr>
        <p:spPr/>
        <p:txBody>
          <a:bodyPr/>
          <a:lstStyle/>
          <a:p>
            <a:endParaRPr lang="it-IT"/>
          </a:p>
        </p:txBody>
      </p:sp>
      <p:sp>
        <p:nvSpPr>
          <p:cNvPr id="7" name="Slide Number Placeholder 6"/>
          <p:cNvSpPr>
            <a:spLocks noGrp="1"/>
          </p:cNvSpPr>
          <p:nvPr>
            <p:ph type="sldNum" sz="quarter" idx="12"/>
          </p:nvPr>
        </p:nvSpPr>
        <p:spPr/>
        <p:txBody>
          <a:bodyPr/>
          <a:lstStyle/>
          <a:p>
            <a:fld id="{4149000F-F82E-4420-9A61-A4705004E9FD}" type="slidenum">
              <a:rPr lang="it-IT" smtClean="0"/>
              <a:t>‹N›</a:t>
            </a:fld>
            <a:endParaRPr lang="it-IT"/>
          </a:p>
        </p:txBody>
      </p:sp>
    </p:spTree>
    <p:extLst>
      <p:ext uri="{BB962C8B-B14F-4D97-AF65-F5344CB8AC3E}">
        <p14:creationId xmlns:p14="http://schemas.microsoft.com/office/powerpoint/2010/main" val="108730802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magine con didascalia">
    <p:spTree>
      <p:nvGrpSpPr>
        <p:cNvPr id="1" name=""/>
        <p:cNvGrpSpPr/>
        <p:nvPr/>
      </p:nvGrpSpPr>
      <p:grpSpPr>
        <a:xfrm>
          <a:off x="0" y="0"/>
          <a:ext cx="0" cy="0"/>
          <a:chOff x="0" y="0"/>
          <a:chExt cx="0" cy="0"/>
        </a:xfrm>
      </p:grpSpPr>
      <p:sp>
        <p:nvSpPr>
          <p:cNvPr id="2" name="Title 1"/>
          <p:cNvSpPr>
            <a:spLocks noGrp="1"/>
          </p:cNvSpPr>
          <p:nvPr>
            <p:ph type="title"/>
          </p:nvPr>
        </p:nvSpPr>
        <p:spPr>
          <a:xfrm>
            <a:off x="421534" y="552027"/>
            <a:ext cx="1973799" cy="1932093"/>
          </a:xfrm>
        </p:spPr>
        <p:txBody>
          <a:bodyPr anchor="b"/>
          <a:lstStyle>
            <a:lvl1pPr>
              <a:defRPr sz="2142"/>
            </a:lvl1pPr>
          </a:lstStyle>
          <a:p>
            <a:r>
              <a:rPr lang="it-IT" smtClean="0"/>
              <a:t>Fare clic per modificare lo stile del titolo</a:t>
            </a:r>
            <a:endParaRPr lang="en-US" dirty="0"/>
          </a:p>
        </p:txBody>
      </p:sp>
      <p:sp>
        <p:nvSpPr>
          <p:cNvPr id="3" name="Picture Placeholder 2"/>
          <p:cNvSpPr>
            <a:spLocks noGrp="1" noChangeAspect="1"/>
          </p:cNvSpPr>
          <p:nvPr>
            <p:ph type="pic" idx="1"/>
          </p:nvPr>
        </p:nvSpPr>
        <p:spPr>
          <a:xfrm>
            <a:off x="2601718" y="1192226"/>
            <a:ext cx="3098155" cy="5884451"/>
          </a:xfrm>
        </p:spPr>
        <p:txBody>
          <a:bodyPr anchor="t"/>
          <a:lstStyle>
            <a:lvl1pPr marL="0" indent="0">
              <a:buNone/>
              <a:defRPr sz="2142"/>
            </a:lvl1pPr>
            <a:lvl2pPr marL="306004" indent="0">
              <a:buNone/>
              <a:defRPr sz="1874"/>
            </a:lvl2pPr>
            <a:lvl3pPr marL="612008" indent="0">
              <a:buNone/>
              <a:defRPr sz="1606"/>
            </a:lvl3pPr>
            <a:lvl4pPr marL="918012" indent="0">
              <a:buNone/>
              <a:defRPr sz="1339"/>
            </a:lvl4pPr>
            <a:lvl5pPr marL="1224016" indent="0">
              <a:buNone/>
              <a:defRPr sz="1339"/>
            </a:lvl5pPr>
            <a:lvl6pPr marL="1530020" indent="0">
              <a:buNone/>
              <a:defRPr sz="1339"/>
            </a:lvl6pPr>
            <a:lvl7pPr marL="1836024" indent="0">
              <a:buNone/>
              <a:defRPr sz="1339"/>
            </a:lvl7pPr>
            <a:lvl8pPr marL="2142028" indent="0">
              <a:buNone/>
              <a:defRPr sz="1339"/>
            </a:lvl8pPr>
            <a:lvl9pPr marL="2448032" indent="0">
              <a:buNone/>
              <a:defRPr sz="1339"/>
            </a:lvl9pPr>
          </a:lstStyle>
          <a:p>
            <a:r>
              <a:rPr lang="it-IT" smtClean="0"/>
              <a:t>Fare clic sull'icona per inserire un'immagine</a:t>
            </a:r>
            <a:endParaRPr lang="en-US" dirty="0"/>
          </a:p>
        </p:txBody>
      </p:sp>
      <p:sp>
        <p:nvSpPr>
          <p:cNvPr id="4" name="Text Placeholder 3"/>
          <p:cNvSpPr>
            <a:spLocks noGrp="1"/>
          </p:cNvSpPr>
          <p:nvPr>
            <p:ph type="body" sz="half" idx="2"/>
          </p:nvPr>
        </p:nvSpPr>
        <p:spPr>
          <a:xfrm>
            <a:off x="421534" y="2484120"/>
            <a:ext cx="1973799" cy="4602140"/>
          </a:xfrm>
        </p:spPr>
        <p:txBody>
          <a:bodyPr/>
          <a:lstStyle>
            <a:lvl1pPr marL="0" indent="0">
              <a:buNone/>
              <a:defRPr sz="1071"/>
            </a:lvl1pPr>
            <a:lvl2pPr marL="306004" indent="0">
              <a:buNone/>
              <a:defRPr sz="937"/>
            </a:lvl2pPr>
            <a:lvl3pPr marL="612008" indent="0">
              <a:buNone/>
              <a:defRPr sz="803"/>
            </a:lvl3pPr>
            <a:lvl4pPr marL="918012" indent="0">
              <a:buNone/>
              <a:defRPr sz="669"/>
            </a:lvl4pPr>
            <a:lvl5pPr marL="1224016" indent="0">
              <a:buNone/>
              <a:defRPr sz="669"/>
            </a:lvl5pPr>
            <a:lvl6pPr marL="1530020" indent="0">
              <a:buNone/>
              <a:defRPr sz="669"/>
            </a:lvl6pPr>
            <a:lvl7pPr marL="1836024" indent="0">
              <a:buNone/>
              <a:defRPr sz="669"/>
            </a:lvl7pPr>
            <a:lvl8pPr marL="2142028" indent="0">
              <a:buNone/>
              <a:defRPr sz="669"/>
            </a:lvl8pPr>
            <a:lvl9pPr marL="2448032" indent="0">
              <a:buNone/>
              <a:defRPr sz="669"/>
            </a:lvl9pPr>
          </a:lstStyle>
          <a:p>
            <a:pPr lvl="0"/>
            <a:r>
              <a:rPr lang="it-IT" smtClean="0"/>
              <a:t>Fare clic per modificare stili del testo dello schema</a:t>
            </a:r>
          </a:p>
        </p:txBody>
      </p:sp>
      <p:sp>
        <p:nvSpPr>
          <p:cNvPr id="5" name="Date Placeholder 4"/>
          <p:cNvSpPr>
            <a:spLocks noGrp="1"/>
          </p:cNvSpPr>
          <p:nvPr>
            <p:ph type="dt" sz="half" idx="10"/>
          </p:nvPr>
        </p:nvSpPr>
        <p:spPr/>
        <p:txBody>
          <a:bodyPr/>
          <a:lstStyle/>
          <a:p>
            <a:fld id="{B7B91465-30FC-4E8F-80E6-3CF7A5F6A40B}" type="datetimeFigureOut">
              <a:rPr lang="it-IT" smtClean="0"/>
              <a:t>24/09/2019</a:t>
            </a:fld>
            <a:endParaRPr lang="it-IT"/>
          </a:p>
        </p:txBody>
      </p:sp>
      <p:sp>
        <p:nvSpPr>
          <p:cNvPr id="6" name="Footer Placeholder 5"/>
          <p:cNvSpPr>
            <a:spLocks noGrp="1"/>
          </p:cNvSpPr>
          <p:nvPr>
            <p:ph type="ftr" sz="quarter" idx="11"/>
          </p:nvPr>
        </p:nvSpPr>
        <p:spPr/>
        <p:txBody>
          <a:bodyPr/>
          <a:lstStyle/>
          <a:p>
            <a:endParaRPr lang="it-IT"/>
          </a:p>
        </p:txBody>
      </p:sp>
      <p:sp>
        <p:nvSpPr>
          <p:cNvPr id="7" name="Slide Number Placeholder 6"/>
          <p:cNvSpPr>
            <a:spLocks noGrp="1"/>
          </p:cNvSpPr>
          <p:nvPr>
            <p:ph type="sldNum" sz="quarter" idx="12"/>
          </p:nvPr>
        </p:nvSpPr>
        <p:spPr/>
        <p:txBody>
          <a:bodyPr/>
          <a:lstStyle/>
          <a:p>
            <a:fld id="{4149000F-F82E-4420-9A61-A4705004E9FD}" type="slidenum">
              <a:rPr lang="it-IT" smtClean="0"/>
              <a:t>‹N›</a:t>
            </a:fld>
            <a:endParaRPr lang="it-IT"/>
          </a:p>
        </p:txBody>
      </p:sp>
    </p:spTree>
    <p:extLst>
      <p:ext uri="{BB962C8B-B14F-4D97-AF65-F5344CB8AC3E}">
        <p14:creationId xmlns:p14="http://schemas.microsoft.com/office/powerpoint/2010/main" val="105733997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20737" y="440856"/>
            <a:ext cx="5278339" cy="1600495"/>
          </a:xfrm>
          <a:prstGeom prst="rect">
            <a:avLst/>
          </a:prstGeom>
        </p:spPr>
        <p:txBody>
          <a:bodyPr vert="horz" lIns="91440" tIns="45720" rIns="91440" bIns="45720" rtlCol="0" anchor="ctr">
            <a:normAutofit/>
          </a:bodyPr>
          <a:lstStyle/>
          <a:p>
            <a:r>
              <a:rPr lang="it-IT" smtClean="0"/>
              <a:t>Fare clic per modificare lo stile del titolo</a:t>
            </a:r>
            <a:endParaRPr lang="en-US" dirty="0"/>
          </a:p>
        </p:txBody>
      </p:sp>
      <p:sp>
        <p:nvSpPr>
          <p:cNvPr id="3" name="Text Placeholder 2"/>
          <p:cNvSpPr>
            <a:spLocks noGrp="1"/>
          </p:cNvSpPr>
          <p:nvPr>
            <p:ph type="body" idx="1"/>
          </p:nvPr>
        </p:nvSpPr>
        <p:spPr>
          <a:xfrm>
            <a:off x="420737" y="2204273"/>
            <a:ext cx="5278339" cy="5253838"/>
          </a:xfrm>
          <a:prstGeom prst="rect">
            <a:avLst/>
          </a:prstGeom>
        </p:spPr>
        <p:txBody>
          <a:bodyPr vert="horz" lIns="91440" tIns="45720" rIns="91440" bIns="45720" rtlCol="0">
            <a:normAutofit/>
          </a:body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en-US" dirty="0"/>
          </a:p>
        </p:txBody>
      </p:sp>
      <p:sp>
        <p:nvSpPr>
          <p:cNvPr id="4" name="Date Placeholder 3"/>
          <p:cNvSpPr>
            <a:spLocks noGrp="1"/>
          </p:cNvSpPr>
          <p:nvPr>
            <p:ph type="dt" sz="half" idx="2"/>
          </p:nvPr>
        </p:nvSpPr>
        <p:spPr>
          <a:xfrm>
            <a:off x="420737" y="7674706"/>
            <a:ext cx="1376958" cy="440855"/>
          </a:xfrm>
          <a:prstGeom prst="rect">
            <a:avLst/>
          </a:prstGeom>
        </p:spPr>
        <p:txBody>
          <a:bodyPr vert="horz" lIns="91440" tIns="45720" rIns="91440" bIns="45720" rtlCol="0" anchor="ctr"/>
          <a:lstStyle>
            <a:lvl1pPr algn="l">
              <a:defRPr sz="803">
                <a:solidFill>
                  <a:schemeClr val="tx1">
                    <a:tint val="75000"/>
                  </a:schemeClr>
                </a:solidFill>
              </a:defRPr>
            </a:lvl1pPr>
          </a:lstStyle>
          <a:p>
            <a:fld id="{B7B91465-30FC-4E8F-80E6-3CF7A5F6A40B}" type="datetimeFigureOut">
              <a:rPr lang="it-IT" smtClean="0"/>
              <a:t>24/09/2019</a:t>
            </a:fld>
            <a:endParaRPr lang="it-IT"/>
          </a:p>
        </p:txBody>
      </p:sp>
      <p:sp>
        <p:nvSpPr>
          <p:cNvPr id="5" name="Footer Placeholder 4"/>
          <p:cNvSpPr>
            <a:spLocks noGrp="1"/>
          </p:cNvSpPr>
          <p:nvPr>
            <p:ph type="ftr" sz="quarter" idx="3"/>
          </p:nvPr>
        </p:nvSpPr>
        <p:spPr>
          <a:xfrm>
            <a:off x="2027188" y="7674706"/>
            <a:ext cx="2065437" cy="440855"/>
          </a:xfrm>
          <a:prstGeom prst="rect">
            <a:avLst/>
          </a:prstGeom>
        </p:spPr>
        <p:txBody>
          <a:bodyPr vert="horz" lIns="91440" tIns="45720" rIns="91440" bIns="45720" rtlCol="0" anchor="ctr"/>
          <a:lstStyle>
            <a:lvl1pPr algn="ctr">
              <a:defRPr sz="803">
                <a:solidFill>
                  <a:schemeClr val="tx1">
                    <a:tint val="75000"/>
                  </a:schemeClr>
                </a:solidFill>
              </a:defRPr>
            </a:lvl1pPr>
          </a:lstStyle>
          <a:p>
            <a:endParaRPr lang="it-IT"/>
          </a:p>
        </p:txBody>
      </p:sp>
      <p:sp>
        <p:nvSpPr>
          <p:cNvPr id="6" name="Slide Number Placeholder 5"/>
          <p:cNvSpPr>
            <a:spLocks noGrp="1"/>
          </p:cNvSpPr>
          <p:nvPr>
            <p:ph type="sldNum" sz="quarter" idx="4"/>
          </p:nvPr>
        </p:nvSpPr>
        <p:spPr>
          <a:xfrm>
            <a:off x="4322118" y="7674706"/>
            <a:ext cx="1376958" cy="440855"/>
          </a:xfrm>
          <a:prstGeom prst="rect">
            <a:avLst/>
          </a:prstGeom>
        </p:spPr>
        <p:txBody>
          <a:bodyPr vert="horz" lIns="91440" tIns="45720" rIns="91440" bIns="45720" rtlCol="0" anchor="ctr"/>
          <a:lstStyle>
            <a:lvl1pPr algn="r">
              <a:defRPr sz="803">
                <a:solidFill>
                  <a:schemeClr val="tx1">
                    <a:tint val="75000"/>
                  </a:schemeClr>
                </a:solidFill>
              </a:defRPr>
            </a:lvl1pPr>
          </a:lstStyle>
          <a:p>
            <a:fld id="{4149000F-F82E-4420-9A61-A4705004E9FD}" type="slidenum">
              <a:rPr lang="it-IT" smtClean="0"/>
              <a:t>‹N›</a:t>
            </a:fld>
            <a:endParaRPr lang="it-IT"/>
          </a:p>
        </p:txBody>
      </p:sp>
    </p:spTree>
    <p:extLst>
      <p:ext uri="{BB962C8B-B14F-4D97-AF65-F5344CB8AC3E}">
        <p14:creationId xmlns:p14="http://schemas.microsoft.com/office/powerpoint/2010/main" val="113679973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12008" rtl="0" eaLnBrk="1" latinLnBrk="0" hangingPunct="1">
        <a:lnSpc>
          <a:spcPct val="90000"/>
        </a:lnSpc>
        <a:spcBef>
          <a:spcPct val="0"/>
        </a:spcBef>
        <a:buNone/>
        <a:defRPr sz="2945" kern="1200">
          <a:solidFill>
            <a:schemeClr val="tx1"/>
          </a:solidFill>
          <a:latin typeface="+mj-lt"/>
          <a:ea typeface="+mj-ea"/>
          <a:cs typeface="+mj-cs"/>
        </a:defRPr>
      </a:lvl1pPr>
    </p:titleStyle>
    <p:bodyStyle>
      <a:lvl1pPr marL="153002" indent="-153002" algn="l" defTabSz="612008" rtl="0" eaLnBrk="1" latinLnBrk="0" hangingPunct="1">
        <a:lnSpc>
          <a:spcPct val="90000"/>
        </a:lnSpc>
        <a:spcBef>
          <a:spcPts val="669"/>
        </a:spcBef>
        <a:buFont typeface="Arial" panose="020B0604020202020204" pitchFamily="34" charset="0"/>
        <a:buChar char="•"/>
        <a:defRPr sz="1874" kern="1200">
          <a:solidFill>
            <a:schemeClr val="tx1"/>
          </a:solidFill>
          <a:latin typeface="+mn-lt"/>
          <a:ea typeface="+mn-ea"/>
          <a:cs typeface="+mn-cs"/>
        </a:defRPr>
      </a:lvl1pPr>
      <a:lvl2pPr marL="459006" indent="-153002" algn="l" defTabSz="612008" rtl="0" eaLnBrk="1" latinLnBrk="0" hangingPunct="1">
        <a:lnSpc>
          <a:spcPct val="90000"/>
        </a:lnSpc>
        <a:spcBef>
          <a:spcPts val="335"/>
        </a:spcBef>
        <a:buFont typeface="Arial" panose="020B0604020202020204" pitchFamily="34" charset="0"/>
        <a:buChar char="•"/>
        <a:defRPr sz="1606" kern="1200">
          <a:solidFill>
            <a:schemeClr val="tx1"/>
          </a:solidFill>
          <a:latin typeface="+mn-lt"/>
          <a:ea typeface="+mn-ea"/>
          <a:cs typeface="+mn-cs"/>
        </a:defRPr>
      </a:lvl2pPr>
      <a:lvl3pPr marL="765010" indent="-153002" algn="l" defTabSz="612008" rtl="0" eaLnBrk="1" latinLnBrk="0" hangingPunct="1">
        <a:lnSpc>
          <a:spcPct val="90000"/>
        </a:lnSpc>
        <a:spcBef>
          <a:spcPts val="335"/>
        </a:spcBef>
        <a:buFont typeface="Arial" panose="020B0604020202020204" pitchFamily="34" charset="0"/>
        <a:buChar char="•"/>
        <a:defRPr sz="1339" kern="1200">
          <a:solidFill>
            <a:schemeClr val="tx1"/>
          </a:solidFill>
          <a:latin typeface="+mn-lt"/>
          <a:ea typeface="+mn-ea"/>
          <a:cs typeface="+mn-cs"/>
        </a:defRPr>
      </a:lvl3pPr>
      <a:lvl4pPr marL="1071014" indent="-153002" algn="l" defTabSz="612008" rtl="0" eaLnBrk="1" latinLnBrk="0" hangingPunct="1">
        <a:lnSpc>
          <a:spcPct val="90000"/>
        </a:lnSpc>
        <a:spcBef>
          <a:spcPts val="335"/>
        </a:spcBef>
        <a:buFont typeface="Arial" panose="020B0604020202020204" pitchFamily="34" charset="0"/>
        <a:buChar char="•"/>
        <a:defRPr sz="1205" kern="1200">
          <a:solidFill>
            <a:schemeClr val="tx1"/>
          </a:solidFill>
          <a:latin typeface="+mn-lt"/>
          <a:ea typeface="+mn-ea"/>
          <a:cs typeface="+mn-cs"/>
        </a:defRPr>
      </a:lvl4pPr>
      <a:lvl5pPr marL="1377018" indent="-153002" algn="l" defTabSz="612008" rtl="0" eaLnBrk="1" latinLnBrk="0" hangingPunct="1">
        <a:lnSpc>
          <a:spcPct val="90000"/>
        </a:lnSpc>
        <a:spcBef>
          <a:spcPts val="335"/>
        </a:spcBef>
        <a:buFont typeface="Arial" panose="020B0604020202020204" pitchFamily="34" charset="0"/>
        <a:buChar char="•"/>
        <a:defRPr sz="1205" kern="1200">
          <a:solidFill>
            <a:schemeClr val="tx1"/>
          </a:solidFill>
          <a:latin typeface="+mn-lt"/>
          <a:ea typeface="+mn-ea"/>
          <a:cs typeface="+mn-cs"/>
        </a:defRPr>
      </a:lvl5pPr>
      <a:lvl6pPr marL="1683022" indent="-153002" algn="l" defTabSz="612008" rtl="0" eaLnBrk="1" latinLnBrk="0" hangingPunct="1">
        <a:lnSpc>
          <a:spcPct val="90000"/>
        </a:lnSpc>
        <a:spcBef>
          <a:spcPts val="335"/>
        </a:spcBef>
        <a:buFont typeface="Arial" panose="020B0604020202020204" pitchFamily="34" charset="0"/>
        <a:buChar char="•"/>
        <a:defRPr sz="1205" kern="1200">
          <a:solidFill>
            <a:schemeClr val="tx1"/>
          </a:solidFill>
          <a:latin typeface="+mn-lt"/>
          <a:ea typeface="+mn-ea"/>
          <a:cs typeface="+mn-cs"/>
        </a:defRPr>
      </a:lvl6pPr>
      <a:lvl7pPr marL="1989026" indent="-153002" algn="l" defTabSz="612008" rtl="0" eaLnBrk="1" latinLnBrk="0" hangingPunct="1">
        <a:lnSpc>
          <a:spcPct val="90000"/>
        </a:lnSpc>
        <a:spcBef>
          <a:spcPts val="335"/>
        </a:spcBef>
        <a:buFont typeface="Arial" panose="020B0604020202020204" pitchFamily="34" charset="0"/>
        <a:buChar char="•"/>
        <a:defRPr sz="1205" kern="1200">
          <a:solidFill>
            <a:schemeClr val="tx1"/>
          </a:solidFill>
          <a:latin typeface="+mn-lt"/>
          <a:ea typeface="+mn-ea"/>
          <a:cs typeface="+mn-cs"/>
        </a:defRPr>
      </a:lvl7pPr>
      <a:lvl8pPr marL="2295030" indent="-153002" algn="l" defTabSz="612008" rtl="0" eaLnBrk="1" latinLnBrk="0" hangingPunct="1">
        <a:lnSpc>
          <a:spcPct val="90000"/>
        </a:lnSpc>
        <a:spcBef>
          <a:spcPts val="335"/>
        </a:spcBef>
        <a:buFont typeface="Arial" panose="020B0604020202020204" pitchFamily="34" charset="0"/>
        <a:buChar char="•"/>
        <a:defRPr sz="1205" kern="1200">
          <a:solidFill>
            <a:schemeClr val="tx1"/>
          </a:solidFill>
          <a:latin typeface="+mn-lt"/>
          <a:ea typeface="+mn-ea"/>
          <a:cs typeface="+mn-cs"/>
        </a:defRPr>
      </a:lvl8pPr>
      <a:lvl9pPr marL="2601034" indent="-153002" algn="l" defTabSz="612008" rtl="0" eaLnBrk="1" latinLnBrk="0" hangingPunct="1">
        <a:lnSpc>
          <a:spcPct val="90000"/>
        </a:lnSpc>
        <a:spcBef>
          <a:spcPts val="335"/>
        </a:spcBef>
        <a:buFont typeface="Arial" panose="020B0604020202020204" pitchFamily="34" charset="0"/>
        <a:buChar char="•"/>
        <a:defRPr sz="1205" kern="1200">
          <a:solidFill>
            <a:schemeClr val="tx1"/>
          </a:solidFill>
          <a:latin typeface="+mn-lt"/>
          <a:ea typeface="+mn-ea"/>
          <a:cs typeface="+mn-cs"/>
        </a:defRPr>
      </a:lvl9pPr>
    </p:bodyStyle>
    <p:otherStyle>
      <a:defPPr>
        <a:defRPr lang="en-US"/>
      </a:defPPr>
      <a:lvl1pPr marL="0" algn="l" defTabSz="612008" rtl="0" eaLnBrk="1" latinLnBrk="0" hangingPunct="1">
        <a:defRPr sz="1205" kern="1200">
          <a:solidFill>
            <a:schemeClr val="tx1"/>
          </a:solidFill>
          <a:latin typeface="+mn-lt"/>
          <a:ea typeface="+mn-ea"/>
          <a:cs typeface="+mn-cs"/>
        </a:defRPr>
      </a:lvl1pPr>
      <a:lvl2pPr marL="306004" algn="l" defTabSz="612008" rtl="0" eaLnBrk="1" latinLnBrk="0" hangingPunct="1">
        <a:defRPr sz="1205" kern="1200">
          <a:solidFill>
            <a:schemeClr val="tx1"/>
          </a:solidFill>
          <a:latin typeface="+mn-lt"/>
          <a:ea typeface="+mn-ea"/>
          <a:cs typeface="+mn-cs"/>
        </a:defRPr>
      </a:lvl2pPr>
      <a:lvl3pPr marL="612008" algn="l" defTabSz="612008" rtl="0" eaLnBrk="1" latinLnBrk="0" hangingPunct="1">
        <a:defRPr sz="1205" kern="1200">
          <a:solidFill>
            <a:schemeClr val="tx1"/>
          </a:solidFill>
          <a:latin typeface="+mn-lt"/>
          <a:ea typeface="+mn-ea"/>
          <a:cs typeface="+mn-cs"/>
        </a:defRPr>
      </a:lvl3pPr>
      <a:lvl4pPr marL="918012" algn="l" defTabSz="612008" rtl="0" eaLnBrk="1" latinLnBrk="0" hangingPunct="1">
        <a:defRPr sz="1205" kern="1200">
          <a:solidFill>
            <a:schemeClr val="tx1"/>
          </a:solidFill>
          <a:latin typeface="+mn-lt"/>
          <a:ea typeface="+mn-ea"/>
          <a:cs typeface="+mn-cs"/>
        </a:defRPr>
      </a:lvl4pPr>
      <a:lvl5pPr marL="1224016" algn="l" defTabSz="612008" rtl="0" eaLnBrk="1" latinLnBrk="0" hangingPunct="1">
        <a:defRPr sz="1205" kern="1200">
          <a:solidFill>
            <a:schemeClr val="tx1"/>
          </a:solidFill>
          <a:latin typeface="+mn-lt"/>
          <a:ea typeface="+mn-ea"/>
          <a:cs typeface="+mn-cs"/>
        </a:defRPr>
      </a:lvl5pPr>
      <a:lvl6pPr marL="1530020" algn="l" defTabSz="612008" rtl="0" eaLnBrk="1" latinLnBrk="0" hangingPunct="1">
        <a:defRPr sz="1205" kern="1200">
          <a:solidFill>
            <a:schemeClr val="tx1"/>
          </a:solidFill>
          <a:latin typeface="+mn-lt"/>
          <a:ea typeface="+mn-ea"/>
          <a:cs typeface="+mn-cs"/>
        </a:defRPr>
      </a:lvl6pPr>
      <a:lvl7pPr marL="1836024" algn="l" defTabSz="612008" rtl="0" eaLnBrk="1" latinLnBrk="0" hangingPunct="1">
        <a:defRPr sz="1205" kern="1200">
          <a:solidFill>
            <a:schemeClr val="tx1"/>
          </a:solidFill>
          <a:latin typeface="+mn-lt"/>
          <a:ea typeface="+mn-ea"/>
          <a:cs typeface="+mn-cs"/>
        </a:defRPr>
      </a:lvl7pPr>
      <a:lvl8pPr marL="2142028" algn="l" defTabSz="612008" rtl="0" eaLnBrk="1" latinLnBrk="0" hangingPunct="1">
        <a:defRPr sz="1205" kern="1200">
          <a:solidFill>
            <a:schemeClr val="tx1"/>
          </a:solidFill>
          <a:latin typeface="+mn-lt"/>
          <a:ea typeface="+mn-ea"/>
          <a:cs typeface="+mn-cs"/>
        </a:defRPr>
      </a:lvl8pPr>
      <a:lvl9pPr marL="2448032" algn="l" defTabSz="612008" rtl="0" eaLnBrk="1" latinLnBrk="0" hangingPunct="1">
        <a:defRPr sz="1205"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8" Type="http://schemas.openxmlformats.org/officeDocument/2006/relationships/oleObject" Target="../embeddings/oleObject1.bin"/><Relationship Id="rId3" Type="http://schemas.openxmlformats.org/officeDocument/2006/relationships/notesSlide" Target="../notesSlides/notesSlide7.xml"/><Relationship Id="rId7" Type="http://schemas.openxmlformats.org/officeDocument/2006/relationships/image" Target="../media/image80.tiff"/><Relationship Id="rId2" Type="http://schemas.openxmlformats.org/officeDocument/2006/relationships/slideLayout" Target="../slideLayouts/slideLayout2.xml"/><Relationship Id="rId1" Type="http://schemas.openxmlformats.org/officeDocument/2006/relationships/vmlDrawing" Target="../drawings/vmlDrawing1.vml"/><Relationship Id="rId6" Type="http://schemas.openxmlformats.org/officeDocument/2006/relationships/image" Target="../media/image79.tiff"/><Relationship Id="rId5" Type="http://schemas.openxmlformats.org/officeDocument/2006/relationships/image" Target="../media/image78.tiff"/><Relationship Id="rId4" Type="http://schemas.openxmlformats.org/officeDocument/2006/relationships/image" Target="../media/image77.tiff"/><Relationship Id="rId9" Type="http://schemas.openxmlformats.org/officeDocument/2006/relationships/image" Target="../media/image76.emf"/></Relationships>
</file>

<file path=ppt/slides/_rels/slide11.xml.rels><?xml version="1.0" encoding="UTF-8" standalone="yes"?>
<Relationships xmlns="http://schemas.openxmlformats.org/package/2006/relationships"><Relationship Id="rId8" Type="http://schemas.openxmlformats.org/officeDocument/2006/relationships/image" Target="../media/image86.tiff"/><Relationship Id="rId3" Type="http://schemas.openxmlformats.org/officeDocument/2006/relationships/image" Target="../media/image82.tiff"/><Relationship Id="rId7" Type="http://schemas.openxmlformats.org/officeDocument/2006/relationships/image" Target="../media/image85.tiff"/><Relationship Id="rId2" Type="http://schemas.openxmlformats.org/officeDocument/2006/relationships/image" Target="../media/image81.tiff"/><Relationship Id="rId1" Type="http://schemas.openxmlformats.org/officeDocument/2006/relationships/slideLayout" Target="../slideLayouts/slideLayout2.xml"/><Relationship Id="rId6" Type="http://schemas.openxmlformats.org/officeDocument/2006/relationships/image" Target="../media/image84.tiff"/><Relationship Id="rId11" Type="http://schemas.openxmlformats.org/officeDocument/2006/relationships/image" Target="../media/image88.tiff"/><Relationship Id="rId5" Type="http://schemas.microsoft.com/office/2007/relationships/hdphoto" Target="../media/hdphoto34.wdp"/><Relationship Id="rId10" Type="http://schemas.microsoft.com/office/2007/relationships/hdphoto" Target="../media/hdphoto35.wdp"/><Relationship Id="rId4" Type="http://schemas.openxmlformats.org/officeDocument/2006/relationships/image" Target="../media/image83.png"/><Relationship Id="rId9" Type="http://schemas.openxmlformats.org/officeDocument/2006/relationships/image" Target="../media/image87.png"/></Relationships>
</file>

<file path=ppt/slides/_rels/slide12.xml.rels><?xml version="1.0" encoding="UTF-8" standalone="yes"?>
<Relationships xmlns="http://schemas.openxmlformats.org/package/2006/relationships"><Relationship Id="rId8" Type="http://schemas.openxmlformats.org/officeDocument/2006/relationships/image" Target="../media/image95.emf"/><Relationship Id="rId13" Type="http://schemas.openxmlformats.org/officeDocument/2006/relationships/image" Target="../media/image100.png"/><Relationship Id="rId3" Type="http://schemas.openxmlformats.org/officeDocument/2006/relationships/image" Target="../media/image90.emf"/><Relationship Id="rId7" Type="http://schemas.openxmlformats.org/officeDocument/2006/relationships/image" Target="../media/image94.emf"/><Relationship Id="rId12" Type="http://schemas.openxmlformats.org/officeDocument/2006/relationships/image" Target="../media/image99.png"/><Relationship Id="rId2" Type="http://schemas.openxmlformats.org/officeDocument/2006/relationships/image" Target="../media/image89.emf"/><Relationship Id="rId16" Type="http://schemas.openxmlformats.org/officeDocument/2006/relationships/image" Target="../media/image150.png"/><Relationship Id="rId1" Type="http://schemas.openxmlformats.org/officeDocument/2006/relationships/slideLayout" Target="../slideLayouts/slideLayout1.xml"/><Relationship Id="rId6" Type="http://schemas.openxmlformats.org/officeDocument/2006/relationships/image" Target="../media/image93.emf"/><Relationship Id="rId11" Type="http://schemas.openxmlformats.org/officeDocument/2006/relationships/image" Target="../media/image98.png"/><Relationship Id="rId5" Type="http://schemas.openxmlformats.org/officeDocument/2006/relationships/image" Target="../media/image92.emf"/><Relationship Id="rId15" Type="http://schemas.openxmlformats.org/officeDocument/2006/relationships/image" Target="../media/image102.emf"/><Relationship Id="rId10" Type="http://schemas.openxmlformats.org/officeDocument/2006/relationships/image" Target="../media/image97.png"/><Relationship Id="rId4" Type="http://schemas.openxmlformats.org/officeDocument/2006/relationships/image" Target="../media/image91.emf"/><Relationship Id="rId9" Type="http://schemas.openxmlformats.org/officeDocument/2006/relationships/image" Target="../media/image96.png"/><Relationship Id="rId14" Type="http://schemas.openxmlformats.org/officeDocument/2006/relationships/image" Target="../media/image101.png"/></Relationships>
</file>

<file path=ppt/slides/_rels/slide2.xml.rels><?xml version="1.0" encoding="UTF-8" standalone="yes"?>
<Relationships xmlns="http://schemas.openxmlformats.org/package/2006/relationships"><Relationship Id="rId8" Type="http://schemas.openxmlformats.org/officeDocument/2006/relationships/image" Target="../media/image8.png"/><Relationship Id="rId13" Type="http://schemas.openxmlformats.org/officeDocument/2006/relationships/image" Target="../media/image13.png"/><Relationship Id="rId18" Type="http://schemas.openxmlformats.org/officeDocument/2006/relationships/image" Target="../media/image18.png"/><Relationship Id="rId3" Type="http://schemas.openxmlformats.org/officeDocument/2006/relationships/image" Target="../media/image3.png"/><Relationship Id="rId7" Type="http://schemas.openxmlformats.org/officeDocument/2006/relationships/image" Target="../media/image7.png"/><Relationship Id="rId12" Type="http://schemas.openxmlformats.org/officeDocument/2006/relationships/image" Target="../media/image12.png"/><Relationship Id="rId17" Type="http://schemas.openxmlformats.org/officeDocument/2006/relationships/image" Target="../media/image17.png"/><Relationship Id="rId2" Type="http://schemas.openxmlformats.org/officeDocument/2006/relationships/image" Target="../media/image2.png"/><Relationship Id="rId16" Type="http://schemas.openxmlformats.org/officeDocument/2006/relationships/image" Target="../media/image16.png"/><Relationship Id="rId1" Type="http://schemas.openxmlformats.org/officeDocument/2006/relationships/slideLayout" Target="../slideLayouts/slideLayout2.xml"/><Relationship Id="rId6" Type="http://schemas.openxmlformats.org/officeDocument/2006/relationships/image" Target="../media/image6.png"/><Relationship Id="rId11" Type="http://schemas.openxmlformats.org/officeDocument/2006/relationships/image" Target="../media/image11.png"/><Relationship Id="rId5" Type="http://schemas.openxmlformats.org/officeDocument/2006/relationships/image" Target="../media/image5.png"/><Relationship Id="rId15" Type="http://schemas.openxmlformats.org/officeDocument/2006/relationships/image" Target="../media/image15.png"/><Relationship Id="rId10" Type="http://schemas.openxmlformats.org/officeDocument/2006/relationships/image" Target="../media/image10.png"/><Relationship Id="rId19" Type="http://schemas.openxmlformats.org/officeDocument/2006/relationships/image" Target="../media/image19.png"/><Relationship Id="rId4" Type="http://schemas.openxmlformats.org/officeDocument/2006/relationships/image" Target="../media/image4.png"/><Relationship Id="rId9" Type="http://schemas.openxmlformats.org/officeDocument/2006/relationships/image" Target="../media/image9.png"/><Relationship Id="rId14" Type="http://schemas.openxmlformats.org/officeDocument/2006/relationships/image" Target="../media/image14.png"/></Relationships>
</file>

<file path=ppt/slides/_rels/slide3.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image" Target="../media/image20.png"/><Relationship Id="rId1" Type="http://schemas.openxmlformats.org/officeDocument/2006/relationships/slideLayout" Target="../slideLayouts/slideLayout2.xml"/><Relationship Id="rId4" Type="http://schemas.openxmlformats.org/officeDocument/2006/relationships/image" Target="../media/image22.png"/></Relationships>
</file>

<file path=ppt/slides/_rels/slide4.xml.rels><?xml version="1.0" encoding="UTF-8" standalone="yes"?>
<Relationships xmlns="http://schemas.openxmlformats.org/package/2006/relationships"><Relationship Id="rId8" Type="http://schemas.microsoft.com/office/2007/relationships/hdphoto" Target="../media/hdphoto3.wdp"/><Relationship Id="rId13" Type="http://schemas.openxmlformats.org/officeDocument/2006/relationships/image" Target="../media/image28.png"/><Relationship Id="rId18" Type="http://schemas.microsoft.com/office/2007/relationships/hdphoto" Target="../media/hdphoto8.wdp"/><Relationship Id="rId26" Type="http://schemas.microsoft.com/office/2007/relationships/hdphoto" Target="../media/hdphoto12.wdp"/><Relationship Id="rId3" Type="http://schemas.openxmlformats.org/officeDocument/2006/relationships/image" Target="../media/image23.png"/><Relationship Id="rId21" Type="http://schemas.openxmlformats.org/officeDocument/2006/relationships/image" Target="../media/image32.png"/><Relationship Id="rId7" Type="http://schemas.openxmlformats.org/officeDocument/2006/relationships/image" Target="../media/image25.png"/><Relationship Id="rId12" Type="http://schemas.microsoft.com/office/2007/relationships/hdphoto" Target="../media/hdphoto5.wdp"/><Relationship Id="rId17" Type="http://schemas.openxmlformats.org/officeDocument/2006/relationships/image" Target="../media/image30.png"/><Relationship Id="rId25" Type="http://schemas.openxmlformats.org/officeDocument/2006/relationships/image" Target="../media/image34.png"/><Relationship Id="rId2" Type="http://schemas.openxmlformats.org/officeDocument/2006/relationships/notesSlide" Target="../notesSlides/notesSlide1.xml"/><Relationship Id="rId16" Type="http://schemas.microsoft.com/office/2007/relationships/hdphoto" Target="../media/hdphoto7.wdp"/><Relationship Id="rId20" Type="http://schemas.microsoft.com/office/2007/relationships/hdphoto" Target="../media/hdphoto9.wdp"/><Relationship Id="rId1" Type="http://schemas.openxmlformats.org/officeDocument/2006/relationships/slideLayout" Target="../slideLayouts/slideLayout1.xml"/><Relationship Id="rId6" Type="http://schemas.microsoft.com/office/2007/relationships/hdphoto" Target="../media/hdphoto2.wdp"/><Relationship Id="rId11" Type="http://schemas.openxmlformats.org/officeDocument/2006/relationships/image" Target="../media/image27.png"/><Relationship Id="rId24" Type="http://schemas.microsoft.com/office/2007/relationships/hdphoto" Target="../media/hdphoto11.wdp"/><Relationship Id="rId5" Type="http://schemas.openxmlformats.org/officeDocument/2006/relationships/image" Target="../media/image24.png"/><Relationship Id="rId15" Type="http://schemas.openxmlformats.org/officeDocument/2006/relationships/image" Target="../media/image29.png"/><Relationship Id="rId23" Type="http://schemas.openxmlformats.org/officeDocument/2006/relationships/image" Target="../media/image33.png"/><Relationship Id="rId10" Type="http://schemas.microsoft.com/office/2007/relationships/hdphoto" Target="../media/hdphoto4.wdp"/><Relationship Id="rId19" Type="http://schemas.openxmlformats.org/officeDocument/2006/relationships/image" Target="../media/image31.png"/><Relationship Id="rId4" Type="http://schemas.microsoft.com/office/2007/relationships/hdphoto" Target="../media/hdphoto1.wdp"/><Relationship Id="rId9" Type="http://schemas.openxmlformats.org/officeDocument/2006/relationships/image" Target="../media/image26.png"/><Relationship Id="rId14" Type="http://schemas.microsoft.com/office/2007/relationships/hdphoto" Target="../media/hdphoto6.wdp"/><Relationship Id="rId22" Type="http://schemas.microsoft.com/office/2007/relationships/hdphoto" Target="../media/hdphoto10.wdp"/></Relationships>
</file>

<file path=ppt/slides/_rels/slide5.xml.rels><?xml version="1.0" encoding="UTF-8" standalone="yes"?>
<Relationships xmlns="http://schemas.openxmlformats.org/package/2006/relationships"><Relationship Id="rId3" Type="http://schemas.openxmlformats.org/officeDocument/2006/relationships/image" Target="../media/image35.emf"/><Relationship Id="rId2" Type="http://schemas.openxmlformats.org/officeDocument/2006/relationships/notesSlide" Target="../notesSlides/notesSlide2.xml"/><Relationship Id="rId1" Type="http://schemas.openxmlformats.org/officeDocument/2006/relationships/slideLayout" Target="../slideLayouts/slideLayout2.xml"/><Relationship Id="rId5" Type="http://schemas.openxmlformats.org/officeDocument/2006/relationships/image" Target="../media/image37.png"/><Relationship Id="rId4" Type="http://schemas.openxmlformats.org/officeDocument/2006/relationships/image" Target="../media/image36.png"/></Relationships>
</file>

<file path=ppt/slides/_rels/slide6.xml.rels><?xml version="1.0" encoding="UTF-8" standalone="yes"?>
<Relationships xmlns="http://schemas.openxmlformats.org/package/2006/relationships"><Relationship Id="rId8" Type="http://schemas.microsoft.com/office/2007/relationships/hdphoto" Target="../media/hdphoto15.wdp"/><Relationship Id="rId13" Type="http://schemas.openxmlformats.org/officeDocument/2006/relationships/image" Target="../media/image44.tiff"/><Relationship Id="rId18" Type="http://schemas.openxmlformats.org/officeDocument/2006/relationships/image" Target="../media/image49.tiff"/><Relationship Id="rId3" Type="http://schemas.openxmlformats.org/officeDocument/2006/relationships/image" Target="../media/image38.png"/><Relationship Id="rId7" Type="http://schemas.openxmlformats.org/officeDocument/2006/relationships/image" Target="../media/image40.png"/><Relationship Id="rId12" Type="http://schemas.openxmlformats.org/officeDocument/2006/relationships/image" Target="../media/image43.tiff"/><Relationship Id="rId17" Type="http://schemas.openxmlformats.org/officeDocument/2006/relationships/image" Target="../media/image48.tiff"/><Relationship Id="rId2" Type="http://schemas.openxmlformats.org/officeDocument/2006/relationships/notesSlide" Target="../notesSlides/notesSlide3.xml"/><Relationship Id="rId16" Type="http://schemas.openxmlformats.org/officeDocument/2006/relationships/image" Target="../media/image47.tiff"/><Relationship Id="rId1" Type="http://schemas.openxmlformats.org/officeDocument/2006/relationships/slideLayout" Target="../slideLayouts/slideLayout1.xml"/><Relationship Id="rId6" Type="http://schemas.microsoft.com/office/2007/relationships/hdphoto" Target="../media/hdphoto14.wdp"/><Relationship Id="rId11" Type="http://schemas.openxmlformats.org/officeDocument/2006/relationships/image" Target="../media/image42.tiff"/><Relationship Id="rId5" Type="http://schemas.openxmlformats.org/officeDocument/2006/relationships/image" Target="../media/image39.png"/><Relationship Id="rId15" Type="http://schemas.openxmlformats.org/officeDocument/2006/relationships/image" Target="../media/image46.tiff"/><Relationship Id="rId10" Type="http://schemas.microsoft.com/office/2007/relationships/hdphoto" Target="../media/hdphoto16.wdp"/><Relationship Id="rId4" Type="http://schemas.microsoft.com/office/2007/relationships/hdphoto" Target="../media/hdphoto13.wdp"/><Relationship Id="rId9" Type="http://schemas.openxmlformats.org/officeDocument/2006/relationships/image" Target="../media/image41.png"/><Relationship Id="rId14" Type="http://schemas.openxmlformats.org/officeDocument/2006/relationships/image" Target="../media/image45.tiff"/></Relationships>
</file>

<file path=ppt/slides/_rels/slide7.xml.rels><?xml version="1.0" encoding="UTF-8" standalone="yes"?>
<Relationships xmlns="http://schemas.openxmlformats.org/package/2006/relationships"><Relationship Id="rId8" Type="http://schemas.microsoft.com/office/2007/relationships/hdphoto" Target="../media/hdphoto19.wdp"/><Relationship Id="rId13" Type="http://schemas.openxmlformats.org/officeDocument/2006/relationships/image" Target="../media/image55.png"/><Relationship Id="rId18" Type="http://schemas.microsoft.com/office/2007/relationships/hdphoto" Target="../media/hdphoto23.wdp"/><Relationship Id="rId3" Type="http://schemas.openxmlformats.org/officeDocument/2006/relationships/image" Target="../media/image50.png"/><Relationship Id="rId21" Type="http://schemas.openxmlformats.org/officeDocument/2006/relationships/image" Target="../media/image60.png"/><Relationship Id="rId7" Type="http://schemas.openxmlformats.org/officeDocument/2006/relationships/image" Target="../media/image52.png"/><Relationship Id="rId12" Type="http://schemas.microsoft.com/office/2007/relationships/hdphoto" Target="../media/hdphoto21.wdp"/><Relationship Id="rId17" Type="http://schemas.openxmlformats.org/officeDocument/2006/relationships/image" Target="../media/image58.png"/><Relationship Id="rId2" Type="http://schemas.openxmlformats.org/officeDocument/2006/relationships/notesSlide" Target="../notesSlides/notesSlide4.xml"/><Relationship Id="rId16" Type="http://schemas.openxmlformats.org/officeDocument/2006/relationships/image" Target="../media/image57.tiff"/><Relationship Id="rId20" Type="http://schemas.microsoft.com/office/2007/relationships/hdphoto" Target="../media/hdphoto24.wdp"/><Relationship Id="rId1" Type="http://schemas.openxmlformats.org/officeDocument/2006/relationships/slideLayout" Target="../slideLayouts/slideLayout1.xml"/><Relationship Id="rId6" Type="http://schemas.microsoft.com/office/2007/relationships/hdphoto" Target="../media/hdphoto18.wdp"/><Relationship Id="rId11" Type="http://schemas.openxmlformats.org/officeDocument/2006/relationships/image" Target="../media/image54.png"/><Relationship Id="rId5" Type="http://schemas.openxmlformats.org/officeDocument/2006/relationships/image" Target="../media/image51.png"/><Relationship Id="rId15" Type="http://schemas.openxmlformats.org/officeDocument/2006/relationships/image" Target="../media/image56.tiff"/><Relationship Id="rId23" Type="http://schemas.openxmlformats.org/officeDocument/2006/relationships/image" Target="../media/image61.tiff"/><Relationship Id="rId10" Type="http://schemas.microsoft.com/office/2007/relationships/hdphoto" Target="../media/hdphoto20.wdp"/><Relationship Id="rId19" Type="http://schemas.openxmlformats.org/officeDocument/2006/relationships/image" Target="../media/image59.png"/><Relationship Id="rId4" Type="http://schemas.microsoft.com/office/2007/relationships/hdphoto" Target="../media/hdphoto17.wdp"/><Relationship Id="rId9" Type="http://schemas.openxmlformats.org/officeDocument/2006/relationships/image" Target="../media/image53.png"/><Relationship Id="rId14" Type="http://schemas.microsoft.com/office/2007/relationships/hdphoto" Target="../media/hdphoto22.wdp"/><Relationship Id="rId22" Type="http://schemas.microsoft.com/office/2007/relationships/hdphoto" Target="../media/hdphoto25.wdp"/></Relationships>
</file>

<file path=ppt/slides/_rels/slide8.xml.rels><?xml version="1.0" encoding="UTF-8" standalone="yes"?>
<Relationships xmlns="http://schemas.openxmlformats.org/package/2006/relationships"><Relationship Id="rId8" Type="http://schemas.microsoft.com/office/2007/relationships/hdphoto" Target="../media/hdphoto27.wdp"/><Relationship Id="rId13" Type="http://schemas.openxmlformats.org/officeDocument/2006/relationships/image" Target="../media/image69.png"/><Relationship Id="rId3" Type="http://schemas.openxmlformats.org/officeDocument/2006/relationships/image" Target="../media/image62.tiff"/><Relationship Id="rId7" Type="http://schemas.openxmlformats.org/officeDocument/2006/relationships/image" Target="../media/image65.png"/><Relationship Id="rId12" Type="http://schemas.microsoft.com/office/2007/relationships/hdphoto" Target="../media/hdphoto28.wdp"/><Relationship Id="rId2" Type="http://schemas.openxmlformats.org/officeDocument/2006/relationships/notesSlide" Target="../notesSlides/notesSlide5.xml"/><Relationship Id="rId1" Type="http://schemas.openxmlformats.org/officeDocument/2006/relationships/slideLayout" Target="../slideLayouts/slideLayout1.xml"/><Relationship Id="rId6" Type="http://schemas.microsoft.com/office/2007/relationships/hdphoto" Target="../media/hdphoto26.wdp"/><Relationship Id="rId11" Type="http://schemas.openxmlformats.org/officeDocument/2006/relationships/image" Target="../media/image68.png"/><Relationship Id="rId5" Type="http://schemas.openxmlformats.org/officeDocument/2006/relationships/image" Target="../media/image64.png"/><Relationship Id="rId10" Type="http://schemas.openxmlformats.org/officeDocument/2006/relationships/image" Target="../media/image67.tiff"/><Relationship Id="rId4" Type="http://schemas.openxmlformats.org/officeDocument/2006/relationships/image" Target="../media/image63.tiff"/><Relationship Id="rId9" Type="http://schemas.openxmlformats.org/officeDocument/2006/relationships/image" Target="../media/image66.tiff"/><Relationship Id="rId14" Type="http://schemas.microsoft.com/office/2007/relationships/hdphoto" Target="../media/hdphoto29.wdp"/></Relationships>
</file>

<file path=ppt/slides/_rels/slide9.xml.rels><?xml version="1.0" encoding="UTF-8" standalone="yes"?>
<Relationships xmlns="http://schemas.openxmlformats.org/package/2006/relationships"><Relationship Id="rId8" Type="http://schemas.openxmlformats.org/officeDocument/2006/relationships/image" Target="../media/image73.png"/><Relationship Id="rId3" Type="http://schemas.openxmlformats.org/officeDocument/2006/relationships/image" Target="../media/image70.tiff"/><Relationship Id="rId7" Type="http://schemas.microsoft.com/office/2007/relationships/hdphoto" Target="../media/hdphoto31.wdp"/><Relationship Id="rId12" Type="http://schemas.microsoft.com/office/2007/relationships/hdphoto" Target="../media/hdphoto33.wdp"/><Relationship Id="rId2" Type="http://schemas.openxmlformats.org/officeDocument/2006/relationships/notesSlide" Target="../notesSlides/notesSlide6.xml"/><Relationship Id="rId1" Type="http://schemas.openxmlformats.org/officeDocument/2006/relationships/slideLayout" Target="../slideLayouts/slideLayout1.xml"/><Relationship Id="rId6" Type="http://schemas.openxmlformats.org/officeDocument/2006/relationships/image" Target="../media/image72.png"/><Relationship Id="rId11" Type="http://schemas.openxmlformats.org/officeDocument/2006/relationships/image" Target="../media/image75.png"/><Relationship Id="rId5" Type="http://schemas.microsoft.com/office/2007/relationships/hdphoto" Target="../media/hdphoto30.wdp"/><Relationship Id="rId10" Type="http://schemas.openxmlformats.org/officeDocument/2006/relationships/image" Target="../media/image74.tiff"/><Relationship Id="rId4" Type="http://schemas.openxmlformats.org/officeDocument/2006/relationships/image" Target="../media/image71.png"/><Relationship Id="rId9" Type="http://schemas.microsoft.com/office/2007/relationships/hdphoto" Target="../media/hdphoto32.wdp"/></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2" name="Rettangolo 31"/>
          <p:cNvSpPr/>
          <p:nvPr/>
        </p:nvSpPr>
        <p:spPr>
          <a:xfrm>
            <a:off x="29923" y="5080924"/>
            <a:ext cx="6063569" cy="707886"/>
          </a:xfrm>
          <a:prstGeom prst="rect">
            <a:avLst/>
          </a:prstGeom>
        </p:spPr>
        <p:txBody>
          <a:bodyPr wrap="square">
            <a:spAutoFit/>
          </a:bodyPr>
          <a:lstStyle/>
          <a:p>
            <a:pPr algn="just"/>
            <a:r>
              <a:rPr lang="en-US" sz="1000" b="1" dirty="0" smtClean="0">
                <a:latin typeface="Arial" panose="020B0604020202020204" pitchFamily="34" charset="0"/>
                <a:cs typeface="Arial" panose="020B0604020202020204" pitchFamily="34" charset="0"/>
              </a:rPr>
              <a:t>Figure S1</a:t>
            </a:r>
            <a:r>
              <a:rPr lang="en-US" sz="1000" b="1" dirty="0" smtClean="0">
                <a:latin typeface="Arial" panose="020B0604020202020204" pitchFamily="34" charset="0"/>
                <a:cs typeface="Arial" panose="020B0604020202020204" pitchFamily="34" charset="0"/>
              </a:rPr>
              <a:t>. Tumor cell death after co-culture with IL-5 or IL-33 EO.</a:t>
            </a:r>
            <a:r>
              <a:rPr lang="en-US" sz="1000" dirty="0" smtClean="0">
                <a:latin typeface="Arial" panose="020B0604020202020204" pitchFamily="34" charset="0"/>
                <a:cs typeface="Arial" panose="020B0604020202020204" pitchFamily="34" charset="0"/>
              </a:rPr>
              <a:t> </a:t>
            </a:r>
            <a:r>
              <a:rPr lang="en-US" sz="1000" dirty="0">
                <a:latin typeface="Arial" panose="020B0604020202020204" pitchFamily="34" charset="0"/>
                <a:cs typeface="Arial" panose="020B0604020202020204" pitchFamily="34" charset="0"/>
              </a:rPr>
              <a:t>IL-5 EO and IL-33 EO </a:t>
            </a:r>
            <a:r>
              <a:rPr lang="en-US" sz="1000" dirty="0" smtClean="0">
                <a:latin typeface="Arial" panose="020B0604020202020204" pitchFamily="34" charset="0"/>
                <a:cs typeface="Arial" panose="020B0604020202020204" pitchFamily="34" charset="0"/>
              </a:rPr>
              <a:t>were </a:t>
            </a:r>
            <a:r>
              <a:rPr lang="en-US" sz="1000" dirty="0">
                <a:latin typeface="Arial" panose="020B0604020202020204" pitchFamily="34" charset="0"/>
                <a:cs typeface="Arial" panose="020B0604020202020204" pitchFamily="34" charset="0"/>
              </a:rPr>
              <a:t>co-cultured with </a:t>
            </a:r>
            <a:r>
              <a:rPr lang="en-US" sz="1000" dirty="0" smtClean="0">
                <a:latin typeface="Arial" panose="020B0604020202020204" pitchFamily="34" charset="0"/>
                <a:cs typeface="Arial" panose="020B0604020202020204" pitchFamily="34" charset="0"/>
              </a:rPr>
              <a:t>TC-1, B16, MCA205 or MC38 tumor </a:t>
            </a:r>
            <a:r>
              <a:rPr lang="en-US" sz="1000" dirty="0">
                <a:latin typeface="Arial" panose="020B0604020202020204" pitchFamily="34" charset="0"/>
                <a:cs typeface="Arial" panose="020B0604020202020204" pitchFamily="34" charset="0"/>
              </a:rPr>
              <a:t>cells </a:t>
            </a:r>
            <a:r>
              <a:rPr lang="en-US" sz="1000" dirty="0" smtClean="0">
                <a:latin typeface="Arial" panose="020B0604020202020204" pitchFamily="34" charset="0"/>
                <a:cs typeface="Arial" panose="020B0604020202020204" pitchFamily="34" charset="0"/>
              </a:rPr>
              <a:t>for </a:t>
            </a:r>
            <a:r>
              <a:rPr lang="en-US" sz="1000" dirty="0">
                <a:latin typeface="Arial" panose="020B0604020202020204" pitchFamily="34" charset="0"/>
                <a:cs typeface="Arial" panose="020B0604020202020204" pitchFamily="34" charset="0"/>
              </a:rPr>
              <a:t>24 </a:t>
            </a:r>
            <a:r>
              <a:rPr lang="en-US" sz="1000" dirty="0" smtClean="0">
                <a:latin typeface="Arial" panose="020B0604020202020204" pitchFamily="34" charset="0"/>
                <a:cs typeface="Arial" panose="020B0604020202020204" pitchFamily="34" charset="0"/>
              </a:rPr>
              <a:t>h then washed out and adherent tumor cells were stained with Crystal Violet. Representative microphotographs </a:t>
            </a:r>
            <a:r>
              <a:rPr lang="en-US" sz="1000" dirty="0">
                <a:latin typeface="Arial" panose="020B0604020202020204" pitchFamily="34" charset="0"/>
                <a:cs typeface="Arial" panose="020B0604020202020204" pitchFamily="34" charset="0"/>
              </a:rPr>
              <a:t>of TC1 tumor cells </a:t>
            </a:r>
            <a:r>
              <a:rPr lang="en-US" sz="1000" dirty="0" smtClean="0">
                <a:latin typeface="Arial" panose="020B0604020202020204" pitchFamily="34" charset="0"/>
                <a:cs typeface="Arial" panose="020B0604020202020204" pitchFamily="34" charset="0"/>
              </a:rPr>
              <a:t>after 24 h culture alone (-) or with </a:t>
            </a:r>
            <a:r>
              <a:rPr lang="en-US" sz="1000" dirty="0">
                <a:latin typeface="Arial" panose="020B0604020202020204" pitchFamily="34" charset="0"/>
                <a:cs typeface="Arial" panose="020B0604020202020204" pitchFamily="34" charset="0"/>
              </a:rPr>
              <a:t>the indicated </a:t>
            </a:r>
            <a:r>
              <a:rPr lang="en-US" sz="1000" dirty="0" smtClean="0">
                <a:latin typeface="Arial" panose="020B0604020202020204" pitchFamily="34" charset="0"/>
                <a:cs typeface="Arial" panose="020B0604020202020204" pitchFamily="34" charset="0"/>
              </a:rPr>
              <a:t>eosinophils. Scale bars, 100 </a:t>
            </a:r>
            <a:r>
              <a:rPr lang="en-US" sz="1000" dirty="0" smtClean="0">
                <a:latin typeface="Arial" panose="020B0604020202020204" pitchFamily="34" charset="0"/>
                <a:cs typeface="Arial" panose="020B0604020202020204" pitchFamily="34" charset="0"/>
                <a:sym typeface="Symbol" panose="05050102010706020507" pitchFamily="18" charset="2"/>
              </a:rPr>
              <a:t>m.</a:t>
            </a:r>
            <a:endParaRPr lang="en-US" sz="1000" dirty="0">
              <a:latin typeface="Arial" panose="020B0604020202020204" pitchFamily="34" charset="0"/>
              <a:cs typeface="Arial" panose="020B0604020202020204" pitchFamily="34" charset="0"/>
            </a:endParaRPr>
          </a:p>
        </p:txBody>
      </p:sp>
      <p:sp>
        <p:nvSpPr>
          <p:cNvPr id="42" name="CasellaDiTesto 41"/>
          <p:cNvSpPr txBox="1"/>
          <p:nvPr/>
        </p:nvSpPr>
        <p:spPr>
          <a:xfrm>
            <a:off x="5580186" y="3492128"/>
            <a:ext cx="589193" cy="461665"/>
          </a:xfrm>
          <a:prstGeom prst="rect">
            <a:avLst/>
          </a:prstGeom>
          <a:noFill/>
        </p:spPr>
        <p:txBody>
          <a:bodyPr wrap="square" rtlCol="0">
            <a:spAutoFit/>
          </a:bodyPr>
          <a:lstStyle/>
          <a:p>
            <a:pPr algn="ctr"/>
            <a:r>
              <a:rPr lang="it-IT" sz="1200" dirty="0" smtClean="0">
                <a:latin typeface="Arial" panose="020B0604020202020204" pitchFamily="34" charset="0"/>
                <a:cs typeface="Arial" panose="020B0604020202020204" pitchFamily="34" charset="0"/>
              </a:rPr>
              <a:t>IL-33</a:t>
            </a:r>
          </a:p>
          <a:p>
            <a:pPr algn="ctr"/>
            <a:r>
              <a:rPr lang="it-IT" sz="1200" dirty="0" smtClean="0">
                <a:latin typeface="Arial" panose="020B0604020202020204" pitchFamily="34" charset="0"/>
                <a:cs typeface="Arial" panose="020B0604020202020204" pitchFamily="34" charset="0"/>
              </a:rPr>
              <a:t>EO</a:t>
            </a:r>
            <a:endParaRPr lang="it-IT" sz="1200" dirty="0">
              <a:latin typeface="Arial" panose="020B0604020202020204" pitchFamily="34" charset="0"/>
              <a:cs typeface="Arial" panose="020B0604020202020204" pitchFamily="34" charset="0"/>
            </a:endParaRPr>
          </a:p>
        </p:txBody>
      </p:sp>
      <p:sp>
        <p:nvSpPr>
          <p:cNvPr id="41" name="CasellaDiTesto 40"/>
          <p:cNvSpPr txBox="1"/>
          <p:nvPr/>
        </p:nvSpPr>
        <p:spPr>
          <a:xfrm>
            <a:off x="5616027" y="2323817"/>
            <a:ext cx="517511" cy="461665"/>
          </a:xfrm>
          <a:prstGeom prst="rect">
            <a:avLst/>
          </a:prstGeom>
          <a:noFill/>
        </p:spPr>
        <p:txBody>
          <a:bodyPr wrap="square" rtlCol="0">
            <a:spAutoFit/>
          </a:bodyPr>
          <a:lstStyle/>
          <a:p>
            <a:pPr algn="ctr"/>
            <a:r>
              <a:rPr lang="it-IT" sz="1200" dirty="0" smtClean="0">
                <a:latin typeface="Arial" panose="020B0604020202020204" pitchFamily="34" charset="0"/>
                <a:cs typeface="Arial" panose="020B0604020202020204" pitchFamily="34" charset="0"/>
              </a:rPr>
              <a:t>IL-5</a:t>
            </a:r>
          </a:p>
          <a:p>
            <a:pPr algn="ctr"/>
            <a:r>
              <a:rPr lang="it-IT" sz="1200" dirty="0" smtClean="0">
                <a:latin typeface="Arial" panose="020B0604020202020204" pitchFamily="34" charset="0"/>
                <a:cs typeface="Arial" panose="020B0604020202020204" pitchFamily="34" charset="0"/>
              </a:rPr>
              <a:t>EO</a:t>
            </a:r>
            <a:endParaRPr lang="it-IT" sz="1200" dirty="0">
              <a:latin typeface="Arial" panose="020B0604020202020204" pitchFamily="34" charset="0"/>
              <a:cs typeface="Arial" panose="020B0604020202020204" pitchFamily="34" charset="0"/>
            </a:endParaRPr>
          </a:p>
        </p:txBody>
      </p:sp>
      <p:sp>
        <p:nvSpPr>
          <p:cNvPr id="27" name="CasellaDiTesto 26"/>
          <p:cNvSpPr txBox="1"/>
          <p:nvPr/>
        </p:nvSpPr>
        <p:spPr>
          <a:xfrm>
            <a:off x="5666273" y="1229683"/>
            <a:ext cx="417019" cy="276999"/>
          </a:xfrm>
          <a:prstGeom prst="rect">
            <a:avLst/>
          </a:prstGeom>
          <a:noFill/>
        </p:spPr>
        <p:txBody>
          <a:bodyPr wrap="square" rtlCol="0">
            <a:spAutoFit/>
          </a:bodyPr>
          <a:lstStyle>
            <a:defPPr>
              <a:defRPr lang="it-IT"/>
            </a:defPPr>
            <a:lvl1pPr algn="ctr">
              <a:defRPr sz="1000">
                <a:latin typeface="Arial" panose="020B0604020202020204" pitchFamily="34" charset="0"/>
                <a:cs typeface="Arial" panose="020B0604020202020204" pitchFamily="34" charset="0"/>
              </a:defRPr>
            </a:lvl1pPr>
          </a:lstStyle>
          <a:p>
            <a:r>
              <a:rPr lang="it-IT" sz="1200" dirty="0"/>
              <a:t>_</a:t>
            </a:r>
          </a:p>
        </p:txBody>
      </p:sp>
      <p:sp>
        <p:nvSpPr>
          <p:cNvPr id="17" name="CasellaDiTesto 16"/>
          <p:cNvSpPr txBox="1"/>
          <p:nvPr/>
        </p:nvSpPr>
        <p:spPr>
          <a:xfrm>
            <a:off x="589585" y="470279"/>
            <a:ext cx="526105" cy="276999"/>
          </a:xfrm>
          <a:prstGeom prst="rect">
            <a:avLst/>
          </a:prstGeom>
          <a:noFill/>
        </p:spPr>
        <p:txBody>
          <a:bodyPr wrap="none" rtlCol="0">
            <a:spAutoFit/>
          </a:bodyPr>
          <a:lstStyle/>
          <a:p>
            <a:pPr algn="ctr"/>
            <a:r>
              <a:rPr lang="it-IT" sz="1200" dirty="0" smtClean="0">
                <a:latin typeface="Arial" panose="020B0604020202020204" pitchFamily="34" charset="0"/>
                <a:cs typeface="Arial" panose="020B0604020202020204" pitchFamily="34" charset="0"/>
              </a:rPr>
              <a:t>TC-1</a:t>
            </a:r>
            <a:endParaRPr lang="it-IT" sz="1200" dirty="0">
              <a:latin typeface="Arial" panose="020B0604020202020204" pitchFamily="34" charset="0"/>
              <a:cs typeface="Arial" panose="020B0604020202020204" pitchFamily="34" charset="0"/>
            </a:endParaRPr>
          </a:p>
        </p:txBody>
      </p:sp>
      <p:sp>
        <p:nvSpPr>
          <p:cNvPr id="18" name="CasellaDiTesto 17"/>
          <p:cNvSpPr txBox="1"/>
          <p:nvPr/>
        </p:nvSpPr>
        <p:spPr>
          <a:xfrm>
            <a:off x="4698723" y="478825"/>
            <a:ext cx="593431" cy="276999"/>
          </a:xfrm>
          <a:prstGeom prst="rect">
            <a:avLst/>
          </a:prstGeom>
          <a:noFill/>
        </p:spPr>
        <p:txBody>
          <a:bodyPr wrap="none" rtlCol="0">
            <a:spAutoFit/>
          </a:bodyPr>
          <a:lstStyle/>
          <a:p>
            <a:pPr algn="ctr"/>
            <a:r>
              <a:rPr lang="it-IT" sz="1200" dirty="0" smtClean="0">
                <a:latin typeface="Arial" panose="020B0604020202020204" pitchFamily="34" charset="0"/>
                <a:cs typeface="Arial" panose="020B0604020202020204" pitchFamily="34" charset="0"/>
              </a:rPr>
              <a:t>MC38</a:t>
            </a:r>
            <a:endParaRPr lang="it-IT" sz="1200" dirty="0">
              <a:latin typeface="Arial" panose="020B0604020202020204" pitchFamily="34" charset="0"/>
              <a:cs typeface="Arial" panose="020B0604020202020204" pitchFamily="34" charset="0"/>
            </a:endParaRPr>
          </a:p>
        </p:txBody>
      </p:sp>
      <p:sp>
        <p:nvSpPr>
          <p:cNvPr id="19" name="CasellaDiTesto 18"/>
          <p:cNvSpPr txBox="1"/>
          <p:nvPr/>
        </p:nvSpPr>
        <p:spPr>
          <a:xfrm>
            <a:off x="3215027" y="478825"/>
            <a:ext cx="780983" cy="276999"/>
          </a:xfrm>
          <a:prstGeom prst="rect">
            <a:avLst/>
          </a:prstGeom>
          <a:noFill/>
        </p:spPr>
        <p:txBody>
          <a:bodyPr wrap="none" rtlCol="0">
            <a:spAutoFit/>
          </a:bodyPr>
          <a:lstStyle/>
          <a:p>
            <a:pPr algn="ctr"/>
            <a:r>
              <a:rPr lang="it-IT" sz="1200" dirty="0" smtClean="0">
                <a:latin typeface="Arial" panose="020B0604020202020204" pitchFamily="34" charset="0"/>
                <a:cs typeface="Arial" panose="020B0604020202020204" pitchFamily="34" charset="0"/>
              </a:rPr>
              <a:t>MCA205</a:t>
            </a:r>
            <a:endParaRPr lang="it-IT" sz="1200" dirty="0">
              <a:latin typeface="Arial" panose="020B0604020202020204" pitchFamily="34" charset="0"/>
              <a:cs typeface="Arial" panose="020B0604020202020204" pitchFamily="34" charset="0"/>
            </a:endParaRPr>
          </a:p>
        </p:txBody>
      </p:sp>
      <p:sp>
        <p:nvSpPr>
          <p:cNvPr id="20" name="CasellaDiTesto 19"/>
          <p:cNvSpPr txBox="1"/>
          <p:nvPr/>
        </p:nvSpPr>
        <p:spPr>
          <a:xfrm>
            <a:off x="2026666" y="478825"/>
            <a:ext cx="457176" cy="276999"/>
          </a:xfrm>
          <a:prstGeom prst="rect">
            <a:avLst/>
          </a:prstGeom>
          <a:noFill/>
        </p:spPr>
        <p:txBody>
          <a:bodyPr wrap="none" rtlCol="0">
            <a:spAutoFit/>
          </a:bodyPr>
          <a:lstStyle/>
          <a:p>
            <a:pPr algn="ctr"/>
            <a:r>
              <a:rPr lang="it-IT" sz="1200" dirty="0" smtClean="0">
                <a:latin typeface="Arial" panose="020B0604020202020204" pitchFamily="34" charset="0"/>
                <a:cs typeface="Arial" panose="020B0604020202020204" pitchFamily="34" charset="0"/>
              </a:rPr>
              <a:t>B16</a:t>
            </a:r>
            <a:endParaRPr lang="it-IT" sz="1200" dirty="0">
              <a:latin typeface="Arial" panose="020B0604020202020204" pitchFamily="34" charset="0"/>
              <a:cs typeface="Arial" panose="020B0604020202020204" pitchFamily="34" charset="0"/>
            </a:endParaRPr>
          </a:p>
        </p:txBody>
      </p:sp>
      <p:pic>
        <p:nvPicPr>
          <p:cNvPr id="11" name="Immagine 10"/>
          <p:cNvPicPr>
            <a:picLocks noChangeAspect="1"/>
          </p:cNvPicPr>
          <p:nvPr/>
        </p:nvPicPr>
        <p:blipFill>
          <a:blip r:embed="rId2"/>
          <a:stretch>
            <a:fillRect/>
          </a:stretch>
        </p:blipFill>
        <p:spPr>
          <a:xfrm>
            <a:off x="155414" y="770815"/>
            <a:ext cx="5497849" cy="3506114"/>
          </a:xfrm>
          <a:prstGeom prst="rect">
            <a:avLst/>
          </a:prstGeom>
        </p:spPr>
      </p:pic>
    </p:spTree>
    <p:extLst>
      <p:ext uri="{BB962C8B-B14F-4D97-AF65-F5344CB8AC3E}">
        <p14:creationId xmlns:p14="http://schemas.microsoft.com/office/powerpoint/2010/main" val="3615169344"/>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0" name="Immagine 69"/>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2959027" y="2281396"/>
            <a:ext cx="1284281" cy="1292656"/>
          </a:xfrm>
          <a:prstGeom prst="rect">
            <a:avLst/>
          </a:prstGeom>
        </p:spPr>
      </p:pic>
      <p:pic>
        <p:nvPicPr>
          <p:cNvPr id="71" name="Immagine 70"/>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2960510" y="937791"/>
            <a:ext cx="1275941" cy="1292656"/>
          </a:xfrm>
          <a:prstGeom prst="rect">
            <a:avLst/>
          </a:prstGeom>
        </p:spPr>
      </p:pic>
      <p:cxnSp>
        <p:nvCxnSpPr>
          <p:cNvPr id="72" name="Connettore 2 71"/>
          <p:cNvCxnSpPr/>
          <p:nvPr/>
        </p:nvCxnSpPr>
        <p:spPr>
          <a:xfrm flipH="1">
            <a:off x="3845889" y="1580713"/>
            <a:ext cx="140645" cy="216225"/>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73" name="Connettore 2 72"/>
          <p:cNvCxnSpPr/>
          <p:nvPr/>
        </p:nvCxnSpPr>
        <p:spPr>
          <a:xfrm flipV="1">
            <a:off x="3176684" y="1431731"/>
            <a:ext cx="253383" cy="152388"/>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74" name="Connettore 2 73"/>
          <p:cNvCxnSpPr/>
          <p:nvPr/>
        </p:nvCxnSpPr>
        <p:spPr>
          <a:xfrm flipH="1" flipV="1">
            <a:off x="3914853" y="3339256"/>
            <a:ext cx="241454" cy="88174"/>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75" name="Connettore 2 74"/>
          <p:cNvCxnSpPr/>
          <p:nvPr/>
        </p:nvCxnSpPr>
        <p:spPr>
          <a:xfrm>
            <a:off x="3459873" y="995343"/>
            <a:ext cx="296306" cy="55014"/>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76" name="Connettore 2 75"/>
          <p:cNvCxnSpPr/>
          <p:nvPr/>
        </p:nvCxnSpPr>
        <p:spPr>
          <a:xfrm flipH="1" flipV="1">
            <a:off x="3184230" y="2136118"/>
            <a:ext cx="275642" cy="36708"/>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77" name="Connettore 2 76"/>
          <p:cNvCxnSpPr/>
          <p:nvPr/>
        </p:nvCxnSpPr>
        <p:spPr>
          <a:xfrm flipV="1">
            <a:off x="3754681" y="2634444"/>
            <a:ext cx="131760" cy="205265"/>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grpSp>
        <p:nvGrpSpPr>
          <p:cNvPr id="28" name="Gruppo 27"/>
          <p:cNvGrpSpPr/>
          <p:nvPr/>
        </p:nvGrpSpPr>
        <p:grpSpPr>
          <a:xfrm>
            <a:off x="1667347" y="937795"/>
            <a:ext cx="1235314" cy="1282271"/>
            <a:chOff x="1429248" y="905396"/>
            <a:chExt cx="1681013" cy="1692000"/>
          </a:xfrm>
        </p:grpSpPr>
        <p:pic>
          <p:nvPicPr>
            <p:cNvPr id="6" name="Immagine 5"/>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1429248" y="905396"/>
              <a:ext cx="1681013" cy="1692000"/>
            </a:xfrm>
            <a:prstGeom prst="rect">
              <a:avLst/>
            </a:prstGeom>
          </p:spPr>
        </p:pic>
        <p:cxnSp>
          <p:nvCxnSpPr>
            <p:cNvPr id="8" name="Connettore 2 7"/>
            <p:cNvCxnSpPr/>
            <p:nvPr/>
          </p:nvCxnSpPr>
          <p:spPr>
            <a:xfrm flipV="1">
              <a:off x="2281453" y="1304622"/>
              <a:ext cx="280828" cy="144015"/>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grpSp>
      <p:grpSp>
        <p:nvGrpSpPr>
          <p:cNvPr id="30" name="Gruppo 29"/>
          <p:cNvGrpSpPr/>
          <p:nvPr/>
        </p:nvGrpSpPr>
        <p:grpSpPr>
          <a:xfrm>
            <a:off x="1667347" y="2283218"/>
            <a:ext cx="1232669" cy="1282271"/>
            <a:chOff x="1442746" y="2708143"/>
            <a:chExt cx="1677414" cy="1692000"/>
          </a:xfrm>
        </p:grpSpPr>
        <p:pic>
          <p:nvPicPr>
            <p:cNvPr id="16" name="Immagine 15"/>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1442746" y="2708143"/>
              <a:ext cx="1677414" cy="1692000"/>
            </a:xfrm>
            <a:prstGeom prst="rect">
              <a:avLst/>
            </a:prstGeom>
          </p:spPr>
        </p:pic>
        <p:cxnSp>
          <p:nvCxnSpPr>
            <p:cNvPr id="18" name="Connettore 2 17"/>
            <p:cNvCxnSpPr/>
            <p:nvPr/>
          </p:nvCxnSpPr>
          <p:spPr>
            <a:xfrm>
              <a:off x="2204557" y="3776468"/>
              <a:ext cx="309372" cy="144017"/>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19" name="Connettore 2 18"/>
            <p:cNvCxnSpPr/>
            <p:nvPr/>
          </p:nvCxnSpPr>
          <p:spPr>
            <a:xfrm flipH="1" flipV="1">
              <a:off x="2810184" y="4151085"/>
              <a:ext cx="236271" cy="230831"/>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grpSp>
      <p:sp>
        <p:nvSpPr>
          <p:cNvPr id="23" name="CasellaDiTesto 22"/>
          <p:cNvSpPr txBox="1"/>
          <p:nvPr/>
        </p:nvSpPr>
        <p:spPr>
          <a:xfrm>
            <a:off x="1228505" y="1453677"/>
            <a:ext cx="449162"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defPPr>
              <a:defRPr lang="it-IT"/>
            </a:defPPr>
            <a:lvl1pPr algn="ctr">
              <a:spcBef>
                <a:spcPct val="0"/>
              </a:spcBef>
              <a:buFontTx/>
              <a:buNone/>
              <a:defRPr sz="1000">
                <a:latin typeface="Arial" panose="020B0604020202020204" pitchFamily="34" charset="0"/>
                <a:cs typeface="Arial" panose="020B0604020202020204" pitchFamily="34" charset="0"/>
              </a:defRPr>
            </a:lvl1pPr>
            <a:lvl2pPr marL="742950" indent="-285750">
              <a:spcBef>
                <a:spcPct val="20000"/>
              </a:spcBef>
              <a:buChar char="–"/>
              <a:defRPr sz="2800">
                <a:latin typeface="Arial" panose="020B0604020202020204" pitchFamily="34" charset="0"/>
              </a:defRPr>
            </a:lvl2pPr>
            <a:lvl3pPr marL="1143000" indent="-228600">
              <a:spcBef>
                <a:spcPct val="20000"/>
              </a:spcBef>
              <a:buChar char="•"/>
              <a:defRPr sz="2400">
                <a:latin typeface="Arial" panose="020B0604020202020204" pitchFamily="34" charset="0"/>
              </a:defRPr>
            </a:lvl3pPr>
            <a:lvl4pPr marL="1600200" indent="-228600">
              <a:spcBef>
                <a:spcPct val="20000"/>
              </a:spcBef>
              <a:buChar char="–"/>
              <a:defRPr sz="2000">
                <a:latin typeface="Arial" panose="020B0604020202020204" pitchFamily="34" charset="0"/>
              </a:defRPr>
            </a:lvl4pPr>
            <a:lvl5pPr marL="2057400" indent="-228600">
              <a:spcBef>
                <a:spcPct val="20000"/>
              </a:spcBef>
              <a:buChar char="»"/>
              <a:defRPr sz="2000">
                <a:latin typeface="Arial" panose="020B0604020202020204" pitchFamily="34" charset="0"/>
              </a:defRPr>
            </a:lvl5pPr>
            <a:lvl6pPr marL="2514600" indent="-228600" eaLnBrk="0" fontAlgn="base" hangingPunct="0">
              <a:spcBef>
                <a:spcPct val="20000"/>
              </a:spcBef>
              <a:spcAft>
                <a:spcPct val="0"/>
              </a:spcAft>
              <a:buChar char="»"/>
              <a:defRPr sz="2000">
                <a:latin typeface="Arial" panose="020B0604020202020204" pitchFamily="34" charset="0"/>
              </a:defRPr>
            </a:lvl6pPr>
            <a:lvl7pPr marL="2971800" indent="-228600" eaLnBrk="0" fontAlgn="base" hangingPunct="0">
              <a:spcBef>
                <a:spcPct val="20000"/>
              </a:spcBef>
              <a:spcAft>
                <a:spcPct val="0"/>
              </a:spcAft>
              <a:buChar char="»"/>
              <a:defRPr sz="2000">
                <a:latin typeface="Arial" panose="020B0604020202020204" pitchFamily="34" charset="0"/>
              </a:defRPr>
            </a:lvl7pPr>
            <a:lvl8pPr marL="3429000" indent="-228600" eaLnBrk="0" fontAlgn="base" hangingPunct="0">
              <a:spcBef>
                <a:spcPct val="20000"/>
              </a:spcBef>
              <a:spcAft>
                <a:spcPct val="0"/>
              </a:spcAft>
              <a:buChar char="»"/>
              <a:defRPr sz="2000">
                <a:latin typeface="Arial" panose="020B0604020202020204" pitchFamily="34" charset="0"/>
              </a:defRPr>
            </a:lvl8pPr>
            <a:lvl9pPr marL="3886200" indent="-228600" eaLnBrk="0" fontAlgn="base" hangingPunct="0">
              <a:spcBef>
                <a:spcPct val="20000"/>
              </a:spcBef>
              <a:spcAft>
                <a:spcPct val="0"/>
              </a:spcAft>
              <a:buChar char="»"/>
              <a:defRPr sz="2000">
                <a:latin typeface="Arial" panose="020B0604020202020204" pitchFamily="34" charset="0"/>
              </a:defRPr>
            </a:lvl9pPr>
          </a:lstStyle>
          <a:p>
            <a:r>
              <a:rPr lang="it-IT" dirty="0"/>
              <a:t>CTR</a:t>
            </a:r>
          </a:p>
        </p:txBody>
      </p:sp>
      <p:sp>
        <p:nvSpPr>
          <p:cNvPr id="24" name="CasellaDiTesto 23"/>
          <p:cNvSpPr txBox="1"/>
          <p:nvPr/>
        </p:nvSpPr>
        <p:spPr>
          <a:xfrm>
            <a:off x="757222" y="2801241"/>
            <a:ext cx="920445"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defPPr>
              <a:defRPr lang="it-IT"/>
            </a:defPPr>
            <a:lvl1pPr algn="ctr">
              <a:spcBef>
                <a:spcPct val="0"/>
              </a:spcBef>
              <a:buFontTx/>
              <a:buNone/>
              <a:defRPr sz="1000">
                <a:latin typeface="Arial" panose="020B0604020202020204" pitchFamily="34" charset="0"/>
                <a:cs typeface="Arial" panose="020B0604020202020204" pitchFamily="34" charset="0"/>
              </a:defRPr>
            </a:lvl1pPr>
            <a:lvl2pPr marL="742950" indent="-285750">
              <a:spcBef>
                <a:spcPct val="20000"/>
              </a:spcBef>
              <a:buChar char="–"/>
              <a:defRPr sz="2800">
                <a:latin typeface="Arial" panose="020B0604020202020204" pitchFamily="34" charset="0"/>
              </a:defRPr>
            </a:lvl2pPr>
            <a:lvl3pPr marL="1143000" indent="-228600">
              <a:spcBef>
                <a:spcPct val="20000"/>
              </a:spcBef>
              <a:buChar char="•"/>
              <a:defRPr sz="2400">
                <a:latin typeface="Arial" panose="020B0604020202020204" pitchFamily="34" charset="0"/>
              </a:defRPr>
            </a:lvl3pPr>
            <a:lvl4pPr marL="1600200" indent="-228600">
              <a:spcBef>
                <a:spcPct val="20000"/>
              </a:spcBef>
              <a:buChar char="–"/>
              <a:defRPr sz="2000">
                <a:latin typeface="Arial" panose="020B0604020202020204" pitchFamily="34" charset="0"/>
              </a:defRPr>
            </a:lvl4pPr>
            <a:lvl5pPr marL="2057400" indent="-228600">
              <a:spcBef>
                <a:spcPct val="20000"/>
              </a:spcBef>
              <a:buChar char="»"/>
              <a:defRPr sz="2000">
                <a:latin typeface="Arial" panose="020B0604020202020204" pitchFamily="34" charset="0"/>
              </a:defRPr>
            </a:lvl5pPr>
            <a:lvl6pPr marL="2514600" indent="-228600" eaLnBrk="0" fontAlgn="base" hangingPunct="0">
              <a:spcBef>
                <a:spcPct val="20000"/>
              </a:spcBef>
              <a:spcAft>
                <a:spcPct val="0"/>
              </a:spcAft>
              <a:buChar char="»"/>
              <a:defRPr sz="2000">
                <a:latin typeface="Arial" panose="020B0604020202020204" pitchFamily="34" charset="0"/>
              </a:defRPr>
            </a:lvl6pPr>
            <a:lvl7pPr marL="2971800" indent="-228600" eaLnBrk="0" fontAlgn="base" hangingPunct="0">
              <a:spcBef>
                <a:spcPct val="20000"/>
              </a:spcBef>
              <a:spcAft>
                <a:spcPct val="0"/>
              </a:spcAft>
              <a:buChar char="»"/>
              <a:defRPr sz="2000">
                <a:latin typeface="Arial" panose="020B0604020202020204" pitchFamily="34" charset="0"/>
              </a:defRPr>
            </a:lvl7pPr>
            <a:lvl8pPr marL="3429000" indent="-228600" eaLnBrk="0" fontAlgn="base" hangingPunct="0">
              <a:spcBef>
                <a:spcPct val="20000"/>
              </a:spcBef>
              <a:spcAft>
                <a:spcPct val="0"/>
              </a:spcAft>
              <a:buChar char="»"/>
              <a:defRPr sz="2000">
                <a:latin typeface="Arial" panose="020B0604020202020204" pitchFamily="34" charset="0"/>
              </a:defRPr>
            </a:lvl8pPr>
            <a:lvl9pPr marL="3886200" indent="-228600" eaLnBrk="0" fontAlgn="base" hangingPunct="0">
              <a:spcBef>
                <a:spcPct val="20000"/>
              </a:spcBef>
              <a:spcAft>
                <a:spcPct val="0"/>
              </a:spcAft>
              <a:buChar char="»"/>
              <a:defRPr sz="2000">
                <a:latin typeface="Arial" panose="020B0604020202020204" pitchFamily="34" charset="0"/>
              </a:defRPr>
            </a:lvl9pPr>
          </a:lstStyle>
          <a:p>
            <a:r>
              <a:rPr lang="it-IT" dirty="0"/>
              <a:t>+ CD18 </a:t>
            </a:r>
            <a:r>
              <a:rPr lang="it-IT" dirty="0" err="1"/>
              <a:t>mAb</a:t>
            </a:r>
            <a:endParaRPr lang="it-IT" dirty="0"/>
          </a:p>
        </p:txBody>
      </p:sp>
      <p:graphicFrame>
        <p:nvGraphicFramePr>
          <p:cNvPr id="25" name="Oggetto 24"/>
          <p:cNvGraphicFramePr>
            <a:graphicFrameLocks noChangeAspect="1"/>
          </p:cNvGraphicFramePr>
          <p:nvPr>
            <p:extLst>
              <p:ext uri="{D42A27DB-BD31-4B8C-83A1-F6EECF244321}">
                <p14:modId xmlns:p14="http://schemas.microsoft.com/office/powerpoint/2010/main" val="3819162606"/>
              </p:ext>
            </p:extLst>
          </p:nvPr>
        </p:nvGraphicFramePr>
        <p:xfrm>
          <a:off x="1843698" y="3958438"/>
          <a:ext cx="2004310" cy="1666234"/>
        </p:xfrm>
        <a:graphic>
          <a:graphicData uri="http://schemas.openxmlformats.org/presentationml/2006/ole">
            <mc:AlternateContent xmlns:mc="http://schemas.openxmlformats.org/markup-compatibility/2006">
              <mc:Choice xmlns:v="urn:schemas-microsoft-com:vml" Requires="v">
                <p:oleObj spid="_x0000_s1245" name="Prism Project" r:id="rId8" imgW="2988000" imgH="2484000" progId="Prism5.Document">
                  <p:embed/>
                </p:oleObj>
              </mc:Choice>
              <mc:Fallback>
                <p:oleObj name="Prism Project" r:id="rId8" imgW="2988000" imgH="2484000" progId="Prism5.Document">
                  <p:embed/>
                  <p:pic>
                    <p:nvPicPr>
                      <p:cNvPr id="0" name=""/>
                      <p:cNvPicPr/>
                      <p:nvPr/>
                    </p:nvPicPr>
                    <p:blipFill>
                      <a:blip r:embed="rId9"/>
                      <a:stretch>
                        <a:fillRect/>
                      </a:stretch>
                    </p:blipFill>
                    <p:spPr>
                      <a:xfrm>
                        <a:off x="1843698" y="3958438"/>
                        <a:ext cx="2004310" cy="1666234"/>
                      </a:xfrm>
                      <a:prstGeom prst="rect">
                        <a:avLst/>
                      </a:prstGeom>
                    </p:spPr>
                  </p:pic>
                </p:oleObj>
              </mc:Fallback>
            </mc:AlternateContent>
          </a:graphicData>
        </a:graphic>
      </p:graphicFrame>
      <p:sp>
        <p:nvSpPr>
          <p:cNvPr id="26" name="Text Box 20"/>
          <p:cNvSpPr txBox="1">
            <a:spLocks noChangeArrowheads="1"/>
          </p:cNvSpPr>
          <p:nvPr/>
        </p:nvSpPr>
        <p:spPr bwMode="auto">
          <a:xfrm>
            <a:off x="3102833" y="716182"/>
            <a:ext cx="955711"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it-IT" altLang="it-IT" sz="1000" dirty="0">
                <a:cs typeface="Arial" panose="020B0604020202020204" pitchFamily="34" charset="0"/>
              </a:rPr>
              <a:t>IL-33 </a:t>
            </a:r>
            <a:r>
              <a:rPr lang="it-IT" altLang="it-IT" sz="1000" dirty="0" smtClean="0">
                <a:cs typeface="Arial" panose="020B0604020202020204" pitchFamily="34" charset="0"/>
              </a:rPr>
              <a:t>EO:B16</a:t>
            </a:r>
            <a:endParaRPr lang="it-IT" altLang="it-IT" sz="1000" dirty="0">
              <a:cs typeface="Arial" panose="020B0604020202020204" pitchFamily="34" charset="0"/>
            </a:endParaRPr>
          </a:p>
        </p:txBody>
      </p:sp>
      <p:sp>
        <p:nvSpPr>
          <p:cNvPr id="27" name="Text Box 28"/>
          <p:cNvSpPr txBox="1">
            <a:spLocks noChangeArrowheads="1"/>
          </p:cNvSpPr>
          <p:nvPr/>
        </p:nvSpPr>
        <p:spPr bwMode="auto">
          <a:xfrm>
            <a:off x="1841091" y="719739"/>
            <a:ext cx="885179"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it-IT" altLang="it-IT" sz="1000" dirty="0" smtClean="0">
                <a:cs typeface="Arial" panose="020B0604020202020204" pitchFamily="34" charset="0"/>
              </a:rPr>
              <a:t>IL-5 EO:B16</a:t>
            </a:r>
            <a:endParaRPr lang="it-IT" altLang="it-IT" sz="1000" dirty="0">
              <a:cs typeface="Arial" panose="020B0604020202020204" pitchFamily="34" charset="0"/>
            </a:endParaRPr>
          </a:p>
        </p:txBody>
      </p:sp>
      <p:sp>
        <p:nvSpPr>
          <p:cNvPr id="5" name="CasellaDiTesto 4"/>
          <p:cNvSpPr txBox="1"/>
          <p:nvPr/>
        </p:nvSpPr>
        <p:spPr>
          <a:xfrm>
            <a:off x="1587355" y="889814"/>
            <a:ext cx="715260" cy="215444"/>
          </a:xfrm>
          <a:prstGeom prst="rect">
            <a:avLst/>
          </a:prstGeom>
          <a:noFill/>
        </p:spPr>
        <p:txBody>
          <a:bodyPr wrap="none" rtlCol="0">
            <a:spAutoFit/>
          </a:bodyPr>
          <a:lstStyle/>
          <a:p>
            <a:pPr algn="ctr"/>
            <a:r>
              <a:rPr lang="it-IT" sz="800" b="1" dirty="0" smtClean="0">
                <a:solidFill>
                  <a:srgbClr val="0070C0"/>
                </a:solidFill>
                <a:latin typeface="Arial" panose="020B0604020202020204" pitchFamily="34" charset="0"/>
                <a:cs typeface="Arial" panose="020B0604020202020204" pitchFamily="34" charset="0"/>
              </a:rPr>
              <a:t>DAPI/</a:t>
            </a:r>
            <a:r>
              <a:rPr lang="it-IT" sz="800" b="1" dirty="0" err="1" smtClean="0">
                <a:solidFill>
                  <a:srgbClr val="00B050"/>
                </a:solidFill>
                <a:latin typeface="Arial" panose="020B0604020202020204" pitchFamily="34" charset="0"/>
                <a:cs typeface="Arial" panose="020B0604020202020204" pitchFamily="34" charset="0"/>
              </a:rPr>
              <a:t>Actin</a:t>
            </a:r>
            <a:endParaRPr lang="it-IT" sz="800" b="1" dirty="0">
              <a:solidFill>
                <a:srgbClr val="00B050"/>
              </a:solidFill>
              <a:latin typeface="Arial" panose="020B0604020202020204" pitchFamily="34" charset="0"/>
              <a:cs typeface="Arial" panose="020B0604020202020204" pitchFamily="34" charset="0"/>
            </a:endParaRPr>
          </a:p>
        </p:txBody>
      </p:sp>
      <p:sp>
        <p:nvSpPr>
          <p:cNvPr id="32" name="CasellaDiTesto 31"/>
          <p:cNvSpPr txBox="1"/>
          <p:nvPr/>
        </p:nvSpPr>
        <p:spPr>
          <a:xfrm>
            <a:off x="1588908" y="2247402"/>
            <a:ext cx="715260" cy="215444"/>
          </a:xfrm>
          <a:prstGeom prst="rect">
            <a:avLst/>
          </a:prstGeom>
          <a:noFill/>
        </p:spPr>
        <p:txBody>
          <a:bodyPr wrap="none" rtlCol="0">
            <a:spAutoFit/>
          </a:bodyPr>
          <a:lstStyle/>
          <a:p>
            <a:pPr algn="ctr"/>
            <a:r>
              <a:rPr lang="it-IT" sz="800" b="1" dirty="0" smtClean="0">
                <a:solidFill>
                  <a:srgbClr val="0070C0"/>
                </a:solidFill>
                <a:latin typeface="Arial" panose="020B0604020202020204" pitchFamily="34" charset="0"/>
                <a:cs typeface="Arial" panose="020B0604020202020204" pitchFamily="34" charset="0"/>
              </a:rPr>
              <a:t>DAPI/</a:t>
            </a:r>
            <a:r>
              <a:rPr lang="it-IT" sz="800" b="1" dirty="0" err="1" smtClean="0">
                <a:solidFill>
                  <a:srgbClr val="00B050"/>
                </a:solidFill>
                <a:latin typeface="Arial" panose="020B0604020202020204" pitchFamily="34" charset="0"/>
                <a:cs typeface="Arial" panose="020B0604020202020204" pitchFamily="34" charset="0"/>
              </a:rPr>
              <a:t>Actin</a:t>
            </a:r>
            <a:endParaRPr lang="it-IT" sz="800" b="1" dirty="0">
              <a:solidFill>
                <a:srgbClr val="00B050"/>
              </a:solidFill>
              <a:latin typeface="Arial" panose="020B0604020202020204" pitchFamily="34" charset="0"/>
              <a:cs typeface="Arial" panose="020B0604020202020204" pitchFamily="34" charset="0"/>
            </a:endParaRPr>
          </a:p>
        </p:txBody>
      </p:sp>
      <p:graphicFrame>
        <p:nvGraphicFramePr>
          <p:cNvPr id="33" name="Tabella 32"/>
          <p:cNvGraphicFramePr>
            <a:graphicFrameLocks noGrp="1"/>
          </p:cNvGraphicFramePr>
          <p:nvPr>
            <p:extLst>
              <p:ext uri="{D42A27DB-BD31-4B8C-83A1-F6EECF244321}">
                <p14:modId xmlns:p14="http://schemas.microsoft.com/office/powerpoint/2010/main" val="1946349584"/>
              </p:ext>
            </p:extLst>
          </p:nvPr>
        </p:nvGraphicFramePr>
        <p:xfrm>
          <a:off x="1461030" y="5576861"/>
          <a:ext cx="2356795" cy="311042"/>
        </p:xfrm>
        <a:graphic>
          <a:graphicData uri="http://schemas.openxmlformats.org/drawingml/2006/table">
            <a:tbl>
              <a:tblPr firstRow="1" bandRow="1">
                <a:tableStyleId>{5C22544A-7EE6-4342-B048-85BDC9FD1C3A}</a:tableStyleId>
              </a:tblPr>
              <a:tblGrid>
                <a:gridCol w="836811">
                  <a:extLst>
                    <a:ext uri="{9D8B030D-6E8A-4147-A177-3AD203B41FA5}">
                      <a16:colId xmlns:a16="http://schemas.microsoft.com/office/drawing/2014/main" val="2310994437"/>
                    </a:ext>
                  </a:extLst>
                </a:gridCol>
                <a:gridCol w="344983">
                  <a:extLst>
                    <a:ext uri="{9D8B030D-6E8A-4147-A177-3AD203B41FA5}">
                      <a16:colId xmlns:a16="http://schemas.microsoft.com/office/drawing/2014/main" val="159794670"/>
                    </a:ext>
                  </a:extLst>
                </a:gridCol>
                <a:gridCol w="344983">
                  <a:extLst>
                    <a:ext uri="{9D8B030D-6E8A-4147-A177-3AD203B41FA5}">
                      <a16:colId xmlns:a16="http://schemas.microsoft.com/office/drawing/2014/main" val="2462323845"/>
                    </a:ext>
                  </a:extLst>
                </a:gridCol>
                <a:gridCol w="415009">
                  <a:extLst>
                    <a:ext uri="{9D8B030D-6E8A-4147-A177-3AD203B41FA5}">
                      <a16:colId xmlns:a16="http://schemas.microsoft.com/office/drawing/2014/main" val="805787681"/>
                    </a:ext>
                  </a:extLst>
                </a:gridCol>
                <a:gridCol w="415009">
                  <a:extLst>
                    <a:ext uri="{9D8B030D-6E8A-4147-A177-3AD203B41FA5}">
                      <a16:colId xmlns:a16="http://schemas.microsoft.com/office/drawing/2014/main" val="3837519943"/>
                    </a:ext>
                  </a:extLst>
                </a:gridCol>
              </a:tblGrid>
              <a:tr h="155521">
                <a:tc>
                  <a:txBody>
                    <a:bodyPr/>
                    <a:lstStyle/>
                    <a:p>
                      <a:pPr algn="ctr"/>
                      <a:r>
                        <a:rPr lang="it-IT" sz="1000" b="0" dirty="0" err="1" smtClean="0">
                          <a:solidFill>
                            <a:sysClr val="windowText" lastClr="000000"/>
                          </a:solidFill>
                          <a:latin typeface="Arial" panose="020B0604020202020204" pitchFamily="34" charset="0"/>
                          <a:cs typeface="Arial" panose="020B0604020202020204" pitchFamily="34" charset="0"/>
                        </a:rPr>
                        <a:t>EOs</a:t>
                      </a:r>
                      <a:endParaRPr lang="it-IT" sz="1000" b="0" dirty="0">
                        <a:solidFill>
                          <a:sysClr val="windowText" lastClr="000000"/>
                        </a:solidFill>
                        <a:latin typeface="Arial" panose="020B0604020202020204" pitchFamily="34" charset="0"/>
                        <a:cs typeface="Arial" panose="020B0604020202020204" pitchFamily="34" charset="0"/>
                      </a:endParaRPr>
                    </a:p>
                  </a:txBody>
                  <a:tcPr marL="36000" marR="36000" marT="0" marB="0">
                    <a:noFill/>
                  </a:tcPr>
                </a:tc>
                <a:tc>
                  <a:txBody>
                    <a:bodyPr/>
                    <a:lstStyle/>
                    <a:p>
                      <a:pPr algn="ctr"/>
                      <a:r>
                        <a:rPr lang="it-IT" sz="1000" b="0" dirty="0" smtClean="0">
                          <a:solidFill>
                            <a:sysClr val="windowText" lastClr="000000"/>
                          </a:solidFill>
                          <a:latin typeface="Arial" panose="020B0604020202020204" pitchFamily="34" charset="0"/>
                          <a:cs typeface="Arial" panose="020B0604020202020204" pitchFamily="34" charset="0"/>
                        </a:rPr>
                        <a:t>IL-5</a:t>
                      </a:r>
                      <a:endParaRPr lang="it-IT" sz="1000" b="0" dirty="0">
                        <a:solidFill>
                          <a:sysClr val="windowText" lastClr="000000"/>
                        </a:solidFill>
                        <a:latin typeface="Arial" panose="020B0604020202020204" pitchFamily="34" charset="0"/>
                        <a:cs typeface="Arial" panose="020B0604020202020204" pitchFamily="34" charset="0"/>
                      </a:endParaRPr>
                    </a:p>
                  </a:txBody>
                  <a:tcPr marL="36000" marR="36000" marT="0" marB="0" anchor="ctr" anchorCtr="1">
                    <a:noFill/>
                  </a:tcPr>
                </a:tc>
                <a:tc>
                  <a:txBody>
                    <a:bodyPr/>
                    <a:lstStyle/>
                    <a:p>
                      <a:pPr algn="ctr"/>
                      <a:r>
                        <a:rPr lang="it-IT" sz="1000" b="0" dirty="0" smtClean="0">
                          <a:solidFill>
                            <a:sysClr val="windowText" lastClr="000000"/>
                          </a:solidFill>
                          <a:latin typeface="Arial" panose="020B0604020202020204" pitchFamily="34" charset="0"/>
                          <a:cs typeface="Arial" panose="020B0604020202020204" pitchFamily="34" charset="0"/>
                        </a:rPr>
                        <a:t>IL-5</a:t>
                      </a:r>
                      <a:endParaRPr lang="it-IT" sz="1000" b="0" dirty="0">
                        <a:solidFill>
                          <a:sysClr val="windowText" lastClr="000000"/>
                        </a:solidFill>
                        <a:latin typeface="Arial" panose="020B0604020202020204" pitchFamily="34" charset="0"/>
                        <a:cs typeface="Arial" panose="020B0604020202020204" pitchFamily="34" charset="0"/>
                      </a:endParaRPr>
                    </a:p>
                  </a:txBody>
                  <a:tcPr marL="36000" marR="36000" marT="0" marB="0" anchor="ctr" anchorCtr="1">
                    <a:noFill/>
                  </a:tcPr>
                </a:tc>
                <a:tc>
                  <a:txBody>
                    <a:bodyPr/>
                    <a:lstStyle/>
                    <a:p>
                      <a:pPr algn="ctr"/>
                      <a:r>
                        <a:rPr lang="it-IT" sz="1000" b="0" dirty="0" smtClean="0">
                          <a:solidFill>
                            <a:sysClr val="windowText" lastClr="000000"/>
                          </a:solidFill>
                          <a:latin typeface="Arial" panose="020B0604020202020204" pitchFamily="34" charset="0"/>
                          <a:cs typeface="Arial" panose="020B0604020202020204" pitchFamily="34" charset="0"/>
                        </a:rPr>
                        <a:t>IL-33</a:t>
                      </a:r>
                      <a:endParaRPr lang="it-IT" sz="1000" b="0" dirty="0">
                        <a:solidFill>
                          <a:sysClr val="windowText" lastClr="000000"/>
                        </a:solidFill>
                        <a:latin typeface="Arial" panose="020B0604020202020204" pitchFamily="34" charset="0"/>
                        <a:cs typeface="Arial" panose="020B0604020202020204" pitchFamily="34" charset="0"/>
                      </a:endParaRPr>
                    </a:p>
                  </a:txBody>
                  <a:tcPr marL="36000" marR="36000" marT="0" marB="0" anchor="ctr" anchorCtr="1">
                    <a:noFill/>
                  </a:tcPr>
                </a:tc>
                <a:tc>
                  <a:txBody>
                    <a:bodyPr/>
                    <a:lstStyle/>
                    <a:p>
                      <a:pPr algn="ctr"/>
                      <a:r>
                        <a:rPr lang="it-IT" sz="1000" b="0" dirty="0" smtClean="0">
                          <a:solidFill>
                            <a:sysClr val="windowText" lastClr="000000"/>
                          </a:solidFill>
                          <a:latin typeface="Arial" panose="020B0604020202020204" pitchFamily="34" charset="0"/>
                          <a:cs typeface="Arial" panose="020B0604020202020204" pitchFamily="34" charset="0"/>
                        </a:rPr>
                        <a:t>IL-33</a:t>
                      </a:r>
                      <a:endParaRPr lang="it-IT" sz="1000" b="0" dirty="0">
                        <a:solidFill>
                          <a:sysClr val="windowText" lastClr="000000"/>
                        </a:solidFill>
                        <a:latin typeface="Arial" panose="020B0604020202020204" pitchFamily="34" charset="0"/>
                        <a:cs typeface="Arial" panose="020B0604020202020204" pitchFamily="34" charset="0"/>
                      </a:endParaRPr>
                    </a:p>
                  </a:txBody>
                  <a:tcPr marL="36000" marR="36000" marT="0" marB="0" anchor="ctr" anchorCtr="1">
                    <a:noFill/>
                  </a:tcPr>
                </a:tc>
                <a:extLst>
                  <a:ext uri="{0D108BD9-81ED-4DB2-BD59-A6C34878D82A}">
                    <a16:rowId xmlns:a16="http://schemas.microsoft.com/office/drawing/2014/main" val="571905873"/>
                  </a:ext>
                </a:extLst>
              </a:tr>
              <a:tr h="155521">
                <a:tc>
                  <a:txBody>
                    <a:bodyPr/>
                    <a:lstStyle/>
                    <a:p>
                      <a:pPr algn="ctr"/>
                      <a:r>
                        <a:rPr lang="it-IT" sz="1000" b="0" dirty="0" smtClean="0">
                          <a:solidFill>
                            <a:sysClr val="windowText" lastClr="000000"/>
                          </a:solidFill>
                          <a:latin typeface="Arial" panose="020B0604020202020204" pitchFamily="34" charset="0"/>
                          <a:cs typeface="Arial" panose="020B0604020202020204" pitchFamily="34" charset="0"/>
                        </a:rPr>
                        <a:t>CD18 </a:t>
                      </a:r>
                      <a:r>
                        <a:rPr lang="it-IT" sz="1000" b="0" dirty="0" err="1" smtClean="0">
                          <a:solidFill>
                            <a:sysClr val="windowText" lastClr="000000"/>
                          </a:solidFill>
                          <a:latin typeface="Arial" panose="020B0604020202020204" pitchFamily="34" charset="0"/>
                          <a:cs typeface="Arial" panose="020B0604020202020204" pitchFamily="34" charset="0"/>
                        </a:rPr>
                        <a:t>mAb</a:t>
                      </a:r>
                      <a:endParaRPr lang="it-IT" sz="1000" b="0" dirty="0">
                        <a:solidFill>
                          <a:sysClr val="windowText" lastClr="000000"/>
                        </a:solidFill>
                        <a:latin typeface="Arial" panose="020B0604020202020204" pitchFamily="34" charset="0"/>
                        <a:cs typeface="Arial" panose="020B0604020202020204" pitchFamily="34" charset="0"/>
                      </a:endParaRPr>
                    </a:p>
                  </a:txBody>
                  <a:tcPr marL="36000" marR="36000" marT="0" marB="0">
                    <a:noFill/>
                  </a:tcPr>
                </a:tc>
                <a:tc>
                  <a:txBody>
                    <a:bodyPr/>
                    <a:lstStyle/>
                    <a:p>
                      <a:pPr algn="ctr"/>
                      <a:r>
                        <a:rPr lang="it-IT" sz="1000" b="0" dirty="0" smtClean="0">
                          <a:solidFill>
                            <a:sysClr val="windowText" lastClr="000000"/>
                          </a:solidFill>
                          <a:latin typeface="Arial" panose="020B0604020202020204" pitchFamily="34" charset="0"/>
                          <a:cs typeface="Arial" panose="020B0604020202020204" pitchFamily="34" charset="0"/>
                        </a:rPr>
                        <a:t>-</a:t>
                      </a:r>
                      <a:endParaRPr lang="it-IT" sz="1000" b="0" dirty="0">
                        <a:solidFill>
                          <a:sysClr val="windowText" lastClr="000000"/>
                        </a:solidFill>
                        <a:latin typeface="Arial" panose="020B0604020202020204" pitchFamily="34" charset="0"/>
                        <a:cs typeface="Arial" panose="020B0604020202020204" pitchFamily="34" charset="0"/>
                      </a:endParaRPr>
                    </a:p>
                  </a:txBody>
                  <a:tcPr marL="36000" marR="36000" marT="0" marB="0" anchor="ctr" anchorCtr="1">
                    <a:noFill/>
                  </a:tcPr>
                </a:tc>
                <a:tc>
                  <a:txBody>
                    <a:bodyPr/>
                    <a:lstStyle/>
                    <a:p>
                      <a:pPr algn="ctr"/>
                      <a:r>
                        <a:rPr lang="it-IT" sz="1000" b="0" dirty="0" smtClean="0">
                          <a:solidFill>
                            <a:sysClr val="windowText" lastClr="000000"/>
                          </a:solidFill>
                          <a:latin typeface="Arial" panose="020B0604020202020204" pitchFamily="34" charset="0"/>
                          <a:cs typeface="Arial" panose="020B0604020202020204" pitchFamily="34" charset="0"/>
                        </a:rPr>
                        <a:t>+</a:t>
                      </a:r>
                      <a:endParaRPr lang="it-IT" sz="1000" b="0" dirty="0">
                        <a:solidFill>
                          <a:sysClr val="windowText" lastClr="000000"/>
                        </a:solidFill>
                        <a:latin typeface="Arial" panose="020B0604020202020204" pitchFamily="34" charset="0"/>
                        <a:cs typeface="Arial" panose="020B0604020202020204" pitchFamily="34" charset="0"/>
                      </a:endParaRPr>
                    </a:p>
                  </a:txBody>
                  <a:tcPr marL="36000" marR="36000" marT="0" marB="0" anchor="ctr" anchorCtr="1">
                    <a:noFill/>
                  </a:tcPr>
                </a:tc>
                <a:tc>
                  <a:txBody>
                    <a:bodyPr/>
                    <a:lstStyle/>
                    <a:p>
                      <a:pPr algn="ctr"/>
                      <a:r>
                        <a:rPr lang="it-IT" sz="1000" b="0" dirty="0" smtClean="0">
                          <a:solidFill>
                            <a:sysClr val="windowText" lastClr="000000"/>
                          </a:solidFill>
                          <a:latin typeface="Arial" panose="020B0604020202020204" pitchFamily="34" charset="0"/>
                          <a:cs typeface="Arial" panose="020B0604020202020204" pitchFamily="34" charset="0"/>
                        </a:rPr>
                        <a:t>-</a:t>
                      </a:r>
                      <a:endParaRPr lang="it-IT" sz="1000" b="0" dirty="0">
                        <a:solidFill>
                          <a:sysClr val="windowText" lastClr="000000"/>
                        </a:solidFill>
                        <a:latin typeface="Arial" panose="020B0604020202020204" pitchFamily="34" charset="0"/>
                        <a:cs typeface="Arial" panose="020B0604020202020204" pitchFamily="34" charset="0"/>
                      </a:endParaRPr>
                    </a:p>
                  </a:txBody>
                  <a:tcPr marL="36000" marR="36000" marT="0" marB="0" anchor="ctr" anchorCtr="1">
                    <a:noFill/>
                  </a:tcPr>
                </a:tc>
                <a:tc>
                  <a:txBody>
                    <a:bodyPr/>
                    <a:lstStyle/>
                    <a:p>
                      <a:pPr algn="ctr"/>
                      <a:r>
                        <a:rPr lang="it-IT" sz="1000" b="0" dirty="0" smtClean="0">
                          <a:solidFill>
                            <a:sysClr val="windowText" lastClr="000000"/>
                          </a:solidFill>
                          <a:latin typeface="Arial" panose="020B0604020202020204" pitchFamily="34" charset="0"/>
                          <a:cs typeface="Arial" panose="020B0604020202020204" pitchFamily="34" charset="0"/>
                        </a:rPr>
                        <a:t>+</a:t>
                      </a:r>
                      <a:endParaRPr lang="it-IT" sz="1000" b="0" dirty="0">
                        <a:solidFill>
                          <a:sysClr val="windowText" lastClr="000000"/>
                        </a:solidFill>
                        <a:latin typeface="Arial" panose="020B0604020202020204" pitchFamily="34" charset="0"/>
                        <a:cs typeface="Arial" panose="020B0604020202020204" pitchFamily="34" charset="0"/>
                      </a:endParaRPr>
                    </a:p>
                  </a:txBody>
                  <a:tcPr marL="36000" marR="36000" marT="0" marB="0" anchor="ctr" anchorCtr="1">
                    <a:noFill/>
                  </a:tcPr>
                </a:tc>
                <a:extLst>
                  <a:ext uri="{0D108BD9-81ED-4DB2-BD59-A6C34878D82A}">
                    <a16:rowId xmlns:a16="http://schemas.microsoft.com/office/drawing/2014/main" val="2362623594"/>
                  </a:ext>
                </a:extLst>
              </a:tr>
            </a:tbl>
          </a:graphicData>
        </a:graphic>
      </p:graphicFrame>
      <p:grpSp>
        <p:nvGrpSpPr>
          <p:cNvPr id="50" name="Gruppo 49"/>
          <p:cNvGrpSpPr/>
          <p:nvPr/>
        </p:nvGrpSpPr>
        <p:grpSpPr>
          <a:xfrm>
            <a:off x="2463325" y="4086141"/>
            <a:ext cx="769944" cy="230832"/>
            <a:chOff x="2463325" y="4086141"/>
            <a:chExt cx="769944" cy="230832"/>
          </a:xfrm>
        </p:grpSpPr>
        <p:cxnSp>
          <p:nvCxnSpPr>
            <p:cNvPr id="42" name="Connettore diritto 41"/>
            <p:cNvCxnSpPr/>
            <p:nvPr/>
          </p:nvCxnSpPr>
          <p:spPr bwMode="auto">
            <a:xfrm>
              <a:off x="2463325" y="4239846"/>
              <a:ext cx="769944" cy="0"/>
            </a:xfrm>
            <a:prstGeom prst="line">
              <a:avLst/>
            </a:prstGeom>
          </p:spPr>
          <p:style>
            <a:lnRef idx="1">
              <a:schemeClr val="dk1"/>
            </a:lnRef>
            <a:fillRef idx="0">
              <a:schemeClr val="dk1"/>
            </a:fillRef>
            <a:effectRef idx="0">
              <a:schemeClr val="dk1"/>
            </a:effectRef>
            <a:fontRef idx="minor">
              <a:schemeClr val="tx1"/>
            </a:fontRef>
          </p:style>
        </p:cxnSp>
        <p:sp>
          <p:nvSpPr>
            <p:cNvPr id="43" name="CasellaDiTesto 9"/>
            <p:cNvSpPr txBox="1">
              <a:spLocks noChangeArrowheads="1"/>
            </p:cNvSpPr>
            <p:nvPr/>
          </p:nvSpPr>
          <p:spPr bwMode="auto">
            <a:xfrm>
              <a:off x="2733324" y="4086141"/>
              <a:ext cx="229550" cy="2308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it-IT" altLang="it-IT" sz="900" dirty="0" smtClean="0">
                  <a:cs typeface="Arial" panose="020B0604020202020204" pitchFamily="34" charset="0"/>
                </a:rPr>
                <a:t>*</a:t>
              </a:r>
              <a:endParaRPr lang="it-IT" altLang="it-IT" sz="900" dirty="0">
                <a:cs typeface="Arial" panose="020B0604020202020204" pitchFamily="34" charset="0"/>
              </a:endParaRPr>
            </a:p>
          </p:txBody>
        </p:sp>
      </p:grpSp>
      <p:grpSp>
        <p:nvGrpSpPr>
          <p:cNvPr id="51" name="Gruppo 50"/>
          <p:cNvGrpSpPr/>
          <p:nvPr/>
        </p:nvGrpSpPr>
        <p:grpSpPr>
          <a:xfrm>
            <a:off x="3207386" y="4190733"/>
            <a:ext cx="420503" cy="230832"/>
            <a:chOff x="2463325" y="4086141"/>
            <a:chExt cx="769944" cy="230832"/>
          </a:xfrm>
        </p:grpSpPr>
        <p:cxnSp>
          <p:nvCxnSpPr>
            <p:cNvPr id="52" name="Connettore diritto 51"/>
            <p:cNvCxnSpPr/>
            <p:nvPr/>
          </p:nvCxnSpPr>
          <p:spPr bwMode="auto">
            <a:xfrm>
              <a:off x="2463325" y="4239846"/>
              <a:ext cx="769944" cy="0"/>
            </a:xfrm>
            <a:prstGeom prst="line">
              <a:avLst/>
            </a:prstGeom>
          </p:spPr>
          <p:style>
            <a:lnRef idx="1">
              <a:schemeClr val="dk1"/>
            </a:lnRef>
            <a:fillRef idx="0">
              <a:schemeClr val="dk1"/>
            </a:fillRef>
            <a:effectRef idx="0">
              <a:schemeClr val="dk1"/>
            </a:effectRef>
            <a:fontRef idx="minor">
              <a:schemeClr val="tx1"/>
            </a:fontRef>
          </p:style>
        </p:cxnSp>
        <p:sp>
          <p:nvSpPr>
            <p:cNvPr id="53" name="CasellaDiTesto 9"/>
            <p:cNvSpPr txBox="1">
              <a:spLocks noChangeArrowheads="1"/>
            </p:cNvSpPr>
            <p:nvPr/>
          </p:nvSpPr>
          <p:spPr bwMode="auto">
            <a:xfrm>
              <a:off x="2733324" y="4086141"/>
              <a:ext cx="229550" cy="2308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it-IT" altLang="it-IT" sz="900" dirty="0" smtClean="0">
                  <a:cs typeface="Arial" panose="020B0604020202020204" pitchFamily="34" charset="0"/>
                </a:rPr>
                <a:t>*</a:t>
              </a:r>
              <a:endParaRPr lang="it-IT" altLang="it-IT" sz="900" dirty="0">
                <a:cs typeface="Arial" panose="020B0604020202020204" pitchFamily="34" charset="0"/>
              </a:endParaRPr>
            </a:p>
          </p:txBody>
        </p:sp>
      </p:grpSp>
      <p:grpSp>
        <p:nvGrpSpPr>
          <p:cNvPr id="57" name="Gruppo 56"/>
          <p:cNvGrpSpPr/>
          <p:nvPr/>
        </p:nvGrpSpPr>
        <p:grpSpPr>
          <a:xfrm>
            <a:off x="2457342" y="4570233"/>
            <a:ext cx="420503" cy="230832"/>
            <a:chOff x="2457342" y="4570233"/>
            <a:chExt cx="420503" cy="230832"/>
          </a:xfrm>
        </p:grpSpPr>
        <p:cxnSp>
          <p:nvCxnSpPr>
            <p:cNvPr id="55" name="Connettore diritto 54"/>
            <p:cNvCxnSpPr/>
            <p:nvPr/>
          </p:nvCxnSpPr>
          <p:spPr bwMode="auto">
            <a:xfrm>
              <a:off x="2457342" y="4759794"/>
              <a:ext cx="420503" cy="0"/>
            </a:xfrm>
            <a:prstGeom prst="line">
              <a:avLst/>
            </a:prstGeom>
          </p:spPr>
          <p:style>
            <a:lnRef idx="1">
              <a:schemeClr val="dk1"/>
            </a:lnRef>
            <a:fillRef idx="0">
              <a:schemeClr val="dk1"/>
            </a:fillRef>
            <a:effectRef idx="0">
              <a:schemeClr val="dk1"/>
            </a:effectRef>
            <a:fontRef idx="minor">
              <a:schemeClr val="tx1"/>
            </a:fontRef>
          </p:style>
        </p:cxnSp>
        <p:sp>
          <p:nvSpPr>
            <p:cNvPr id="56" name="CasellaDiTesto 9"/>
            <p:cNvSpPr txBox="1">
              <a:spLocks noChangeArrowheads="1"/>
            </p:cNvSpPr>
            <p:nvPr/>
          </p:nvSpPr>
          <p:spPr bwMode="auto">
            <a:xfrm>
              <a:off x="2514238" y="4570233"/>
              <a:ext cx="306495" cy="2308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it-IT" altLang="it-IT" sz="900" dirty="0" smtClean="0">
                  <a:cs typeface="Arial" panose="020B0604020202020204" pitchFamily="34" charset="0"/>
                </a:rPr>
                <a:t>ns</a:t>
              </a:r>
              <a:endParaRPr lang="it-IT" altLang="it-IT" sz="900" dirty="0">
                <a:cs typeface="Arial" panose="020B0604020202020204" pitchFamily="34" charset="0"/>
              </a:endParaRPr>
            </a:p>
          </p:txBody>
        </p:sp>
      </p:grpSp>
      <p:sp>
        <p:nvSpPr>
          <p:cNvPr id="38" name="CasellaDiTesto 165"/>
          <p:cNvSpPr txBox="1">
            <a:spLocks noChangeArrowheads="1"/>
          </p:cNvSpPr>
          <p:nvPr/>
        </p:nvSpPr>
        <p:spPr bwMode="auto">
          <a:xfrm>
            <a:off x="626422" y="437729"/>
            <a:ext cx="332142"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defRPr/>
            </a:pPr>
            <a:r>
              <a:rPr lang="it-IT" altLang="it-IT" sz="1600" b="1" dirty="0">
                <a:cs typeface="Arial" panose="020B0604020202020204" pitchFamily="34" charset="0"/>
              </a:rPr>
              <a:t>A</a:t>
            </a:r>
            <a:endParaRPr lang="it-IT" altLang="it-IT" sz="1600" b="1" dirty="0" smtClean="0">
              <a:cs typeface="Arial" panose="020B0604020202020204" pitchFamily="34" charset="0"/>
            </a:endParaRPr>
          </a:p>
        </p:txBody>
      </p:sp>
      <p:sp>
        <p:nvSpPr>
          <p:cNvPr id="39" name="CasellaDiTesto 165"/>
          <p:cNvSpPr txBox="1">
            <a:spLocks noChangeArrowheads="1"/>
          </p:cNvSpPr>
          <p:nvPr/>
        </p:nvSpPr>
        <p:spPr bwMode="auto">
          <a:xfrm>
            <a:off x="1074097" y="3944636"/>
            <a:ext cx="332142"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spcBef>
                <a:spcPct val="0"/>
              </a:spcBef>
              <a:buFontTx/>
              <a:buNone/>
              <a:defRPr/>
            </a:pPr>
            <a:r>
              <a:rPr lang="it-IT" altLang="it-IT" sz="1600" b="1" dirty="0">
                <a:cs typeface="Arial" panose="020B0604020202020204" pitchFamily="34" charset="0"/>
              </a:rPr>
              <a:t>B</a:t>
            </a:r>
            <a:endParaRPr lang="it-IT" altLang="it-IT" sz="1600" b="1" dirty="0" smtClean="0">
              <a:cs typeface="Arial" panose="020B0604020202020204" pitchFamily="34" charset="0"/>
            </a:endParaRPr>
          </a:p>
        </p:txBody>
      </p:sp>
      <p:cxnSp>
        <p:nvCxnSpPr>
          <p:cNvPr id="40" name="Connettore 1 39"/>
          <p:cNvCxnSpPr/>
          <p:nvPr/>
        </p:nvCxnSpPr>
        <p:spPr>
          <a:xfrm>
            <a:off x="1715068" y="2177653"/>
            <a:ext cx="277200"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41" name="Connettore 1 40"/>
          <p:cNvCxnSpPr/>
          <p:nvPr/>
        </p:nvCxnSpPr>
        <p:spPr>
          <a:xfrm>
            <a:off x="3900774" y="2177653"/>
            <a:ext cx="277200"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44" name="Connettore 1 43"/>
          <p:cNvCxnSpPr/>
          <p:nvPr/>
        </p:nvCxnSpPr>
        <p:spPr>
          <a:xfrm>
            <a:off x="1715068" y="3516314"/>
            <a:ext cx="277200"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45" name="Connettore 1 44"/>
          <p:cNvCxnSpPr/>
          <p:nvPr/>
        </p:nvCxnSpPr>
        <p:spPr>
          <a:xfrm>
            <a:off x="3031957" y="3516314"/>
            <a:ext cx="277200"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sp>
        <p:nvSpPr>
          <p:cNvPr id="46" name="Rettangolo 45"/>
          <p:cNvSpPr/>
          <p:nvPr/>
        </p:nvSpPr>
        <p:spPr>
          <a:xfrm>
            <a:off x="39448" y="6141856"/>
            <a:ext cx="6063569" cy="1477328"/>
          </a:xfrm>
          <a:prstGeom prst="rect">
            <a:avLst/>
          </a:prstGeom>
        </p:spPr>
        <p:txBody>
          <a:bodyPr wrap="square">
            <a:spAutoFit/>
          </a:bodyPr>
          <a:lstStyle/>
          <a:p>
            <a:pPr algn="just"/>
            <a:r>
              <a:rPr lang="en-US" sz="1000" b="1" dirty="0" smtClean="0">
                <a:latin typeface="Arial" panose="020B0604020202020204" pitchFamily="34" charset="0"/>
                <a:cs typeface="Arial" panose="020B0604020202020204" pitchFamily="34" charset="0"/>
              </a:rPr>
              <a:t>Figure S10</a:t>
            </a:r>
            <a:r>
              <a:rPr lang="en-US" sz="1000" b="1" dirty="0" smtClean="0">
                <a:latin typeface="Arial" panose="020B0604020202020204" pitchFamily="34" charset="0"/>
                <a:cs typeface="Arial" panose="020B0604020202020204" pitchFamily="34" charset="0"/>
              </a:rPr>
              <a:t>.</a:t>
            </a:r>
            <a:r>
              <a:rPr lang="en-US" sz="1000" dirty="0" smtClean="0">
                <a:latin typeface="Arial" panose="020B0604020202020204" pitchFamily="34" charset="0"/>
                <a:cs typeface="Arial" panose="020B0604020202020204" pitchFamily="34" charset="0"/>
              </a:rPr>
              <a:t> </a:t>
            </a:r>
            <a:r>
              <a:rPr lang="en-US" sz="1000" b="1" dirty="0" smtClean="0">
                <a:latin typeface="Arial" panose="020B0604020202020204" pitchFamily="34" charset="0"/>
                <a:cs typeface="Arial" panose="020B0604020202020204" pitchFamily="34" charset="0"/>
              </a:rPr>
              <a:t>Inhibition of EO/tumor </a:t>
            </a:r>
            <a:r>
              <a:rPr lang="en-US" sz="1000" b="1" dirty="0">
                <a:latin typeface="Arial" panose="020B0604020202020204" pitchFamily="34" charset="0"/>
                <a:cs typeface="Arial" panose="020B0604020202020204" pitchFamily="34" charset="0"/>
              </a:rPr>
              <a:t>cell conjugates </a:t>
            </a:r>
            <a:r>
              <a:rPr lang="en-US" sz="1000" b="1" dirty="0" smtClean="0">
                <a:latin typeface="Arial" panose="020B0604020202020204" pitchFamily="34" charset="0"/>
                <a:cs typeface="Arial" panose="020B0604020202020204" pitchFamily="34" charset="0"/>
              </a:rPr>
              <a:t>by </a:t>
            </a:r>
            <a:r>
              <a:rPr lang="en-US" sz="1000" b="1" dirty="0">
                <a:latin typeface="Arial" panose="020B0604020202020204" pitchFamily="34" charset="0"/>
                <a:cs typeface="Arial" panose="020B0604020202020204" pitchFamily="34" charset="0"/>
              </a:rPr>
              <a:t>CD11b/CD18 </a:t>
            </a:r>
            <a:r>
              <a:rPr lang="en-US" sz="1000" b="1" dirty="0" smtClean="0">
                <a:latin typeface="Arial" panose="020B0604020202020204" pitchFamily="34" charset="0"/>
                <a:cs typeface="Arial" panose="020B0604020202020204" pitchFamily="34" charset="0"/>
              </a:rPr>
              <a:t>blockade by CLSM.</a:t>
            </a:r>
            <a:r>
              <a:rPr lang="en-US" sz="1000" dirty="0" smtClean="0">
                <a:latin typeface="Arial" panose="020B0604020202020204" pitchFamily="34" charset="0"/>
                <a:cs typeface="Arial" panose="020B0604020202020204" pitchFamily="34" charset="0"/>
              </a:rPr>
              <a:t> </a:t>
            </a:r>
            <a:r>
              <a:rPr lang="en-US" sz="1000" b="1" dirty="0" smtClean="0">
                <a:latin typeface="Arial" panose="020B0604020202020204" pitchFamily="34" charset="0"/>
                <a:cs typeface="Arial" panose="020B0604020202020204" pitchFamily="34" charset="0"/>
              </a:rPr>
              <a:t>(A)</a:t>
            </a:r>
            <a:r>
              <a:rPr lang="en-US" sz="1000" dirty="0" smtClean="0">
                <a:latin typeface="Arial" panose="020B0604020202020204" pitchFamily="34" charset="0"/>
                <a:cs typeface="Arial" panose="020B0604020202020204" pitchFamily="34" charset="0"/>
              </a:rPr>
              <a:t> IL-5 EO and IL-33 EO </a:t>
            </a:r>
            <a:r>
              <a:rPr lang="en-US" sz="1000" dirty="0">
                <a:latin typeface="Arial" panose="020B0604020202020204" pitchFamily="34" charset="0"/>
                <a:cs typeface="Arial" panose="020B0604020202020204" pitchFamily="34" charset="0"/>
              </a:rPr>
              <a:t>were </a:t>
            </a:r>
            <a:r>
              <a:rPr lang="en-US" sz="1000" dirty="0" smtClean="0">
                <a:latin typeface="Arial" panose="020B0604020202020204" pitchFamily="34" charset="0"/>
                <a:cs typeface="Arial" panose="020B0604020202020204" pitchFamily="34" charset="0"/>
              </a:rPr>
              <a:t>incubated with or without anti-CD18 mAb </a:t>
            </a:r>
            <a:r>
              <a:rPr lang="en-US" sz="1000" dirty="0">
                <a:latin typeface="Arial" panose="020B0604020202020204" pitchFamily="34" charset="0"/>
                <a:cs typeface="Arial" panose="020B0604020202020204" pitchFamily="34" charset="0"/>
              </a:rPr>
              <a:t>(10 µg/ml) for 20 min at 4°C, then mixed </a:t>
            </a:r>
            <a:r>
              <a:rPr lang="en-US" sz="1000" dirty="0" smtClean="0">
                <a:latin typeface="Arial" panose="020B0604020202020204" pitchFamily="34" charset="0"/>
                <a:cs typeface="Arial" panose="020B0604020202020204" pitchFamily="34" charset="0"/>
              </a:rPr>
              <a:t>with B16.F10 melanoma </a:t>
            </a:r>
            <a:r>
              <a:rPr lang="en-US" sz="1000" dirty="0">
                <a:latin typeface="Arial" panose="020B0604020202020204" pitchFamily="34" charset="0"/>
                <a:cs typeface="Arial" panose="020B0604020202020204" pitchFamily="34" charset="0"/>
              </a:rPr>
              <a:t>cells (5:1 ratio</a:t>
            </a:r>
            <a:r>
              <a:rPr lang="en-US" sz="1000" dirty="0" smtClean="0">
                <a:latin typeface="Arial" panose="020B0604020202020204" pitchFamily="34" charset="0"/>
                <a:cs typeface="Arial" panose="020B0604020202020204" pitchFamily="34" charset="0"/>
              </a:rPr>
              <a:t>) and </a:t>
            </a:r>
            <a:r>
              <a:rPr lang="en-US" sz="1000" dirty="0">
                <a:latin typeface="Arial" panose="020B0604020202020204" pitchFamily="34" charset="0"/>
                <a:cs typeface="Arial" panose="020B0604020202020204" pitchFamily="34" charset="0"/>
              </a:rPr>
              <a:t>allowed to conjugate for 60 min at </a:t>
            </a:r>
            <a:r>
              <a:rPr lang="en-US" sz="1000" dirty="0" smtClean="0">
                <a:latin typeface="Arial" panose="020B0604020202020204" pitchFamily="34" charset="0"/>
                <a:cs typeface="Arial" panose="020B0604020202020204" pitchFamily="34" charset="0"/>
              </a:rPr>
              <a:t>37°C. Cell </a:t>
            </a:r>
            <a:r>
              <a:rPr lang="en-US" sz="1000" dirty="0">
                <a:latin typeface="Arial" panose="020B0604020202020204" pitchFamily="34" charset="0"/>
                <a:cs typeface="Arial" panose="020B0604020202020204" pitchFamily="34" charset="0"/>
              </a:rPr>
              <a:t>conjugates were </a:t>
            </a:r>
            <a:r>
              <a:rPr lang="en-US" sz="1000" dirty="0" smtClean="0">
                <a:latin typeface="Arial" panose="020B0604020202020204" pitchFamily="34" charset="0"/>
                <a:cs typeface="Arial" panose="020B0604020202020204" pitchFamily="34" charset="0"/>
              </a:rPr>
              <a:t>then transferred </a:t>
            </a:r>
            <a:r>
              <a:rPr lang="en-US" sz="1000" dirty="0">
                <a:latin typeface="Arial" panose="020B0604020202020204" pitchFamily="34" charset="0"/>
                <a:cs typeface="Arial" panose="020B0604020202020204" pitchFamily="34" charset="0"/>
              </a:rPr>
              <a:t>onto poly-L-lysine-coated coverslips, fixed, </a:t>
            </a:r>
            <a:r>
              <a:rPr lang="en-US" sz="1000" dirty="0" err="1">
                <a:latin typeface="Arial" panose="020B0604020202020204" pitchFamily="34" charset="0"/>
                <a:cs typeface="Arial" panose="020B0604020202020204" pitchFamily="34" charset="0"/>
              </a:rPr>
              <a:t>permeabilized</a:t>
            </a:r>
            <a:r>
              <a:rPr lang="en-US" sz="1000" dirty="0">
                <a:latin typeface="Arial" panose="020B0604020202020204" pitchFamily="34" charset="0"/>
                <a:cs typeface="Arial" panose="020B0604020202020204" pitchFamily="34" charset="0"/>
              </a:rPr>
              <a:t> and labelled with Alexa Fluor®-488 </a:t>
            </a:r>
            <a:r>
              <a:rPr lang="en-US" sz="1000" dirty="0" err="1">
                <a:latin typeface="Arial" panose="020B0604020202020204" pitchFamily="34" charset="0"/>
                <a:cs typeface="Arial" panose="020B0604020202020204" pitchFamily="34" charset="0"/>
              </a:rPr>
              <a:t>phalloidin</a:t>
            </a:r>
            <a:r>
              <a:rPr lang="en-US" sz="1000" dirty="0">
                <a:latin typeface="Arial" panose="020B0604020202020204" pitchFamily="34" charset="0"/>
                <a:cs typeface="Arial" panose="020B0604020202020204" pitchFamily="34" charset="0"/>
              </a:rPr>
              <a:t> for actin staining (detected in green). Nuclei </a:t>
            </a:r>
            <a:r>
              <a:rPr lang="en-US" sz="1000" dirty="0" smtClean="0">
                <a:latin typeface="Arial" panose="020B0604020202020204" pitchFamily="34" charset="0"/>
                <a:cs typeface="Arial" panose="020B0604020202020204" pitchFamily="34" charset="0"/>
              </a:rPr>
              <a:t>were stained with DAPI (blue). </a:t>
            </a:r>
            <a:r>
              <a:rPr lang="en-US" sz="1000" dirty="0">
                <a:latin typeface="Arial" panose="020B0604020202020204" pitchFamily="34" charset="0"/>
                <a:cs typeface="Arial" panose="020B0604020202020204" pitchFamily="34" charset="0"/>
              </a:rPr>
              <a:t>CLSM </a:t>
            </a:r>
            <a:r>
              <a:rPr lang="en-US" sz="1000" dirty="0" smtClean="0">
                <a:latin typeface="Arial" panose="020B0604020202020204" pitchFamily="34" charset="0"/>
                <a:cs typeface="Arial" panose="020B0604020202020204" pitchFamily="34" charset="0"/>
              </a:rPr>
              <a:t>examinations were carried out. Arrows </a:t>
            </a:r>
            <a:r>
              <a:rPr lang="en-US" sz="1000" dirty="0">
                <a:latin typeface="Arial" panose="020B0604020202020204" pitchFamily="34" charset="0"/>
                <a:cs typeface="Arial" panose="020B0604020202020204" pitchFamily="34" charset="0"/>
              </a:rPr>
              <a:t>indicate cell conjugates in the representative examples. </a:t>
            </a:r>
            <a:r>
              <a:rPr lang="en-US" sz="1000" dirty="0" smtClean="0">
                <a:latin typeface="Arial" panose="020B0604020202020204" pitchFamily="34" charset="0"/>
                <a:cs typeface="Arial" panose="020B0604020202020204" pitchFamily="34" charset="0"/>
              </a:rPr>
              <a:t>Scale </a:t>
            </a:r>
            <a:r>
              <a:rPr lang="en-US" sz="1000" dirty="0">
                <a:latin typeface="Arial" panose="020B0604020202020204" pitchFamily="34" charset="0"/>
                <a:cs typeface="Arial" panose="020B0604020202020204" pitchFamily="34" charset="0"/>
              </a:rPr>
              <a:t>bars, </a:t>
            </a:r>
            <a:r>
              <a:rPr lang="en-US" sz="1000" dirty="0" smtClean="0">
                <a:latin typeface="Arial" panose="020B0604020202020204" pitchFamily="34" charset="0"/>
                <a:cs typeface="Arial" panose="020B0604020202020204" pitchFamily="34" charset="0"/>
              </a:rPr>
              <a:t>20 µm</a:t>
            </a:r>
            <a:r>
              <a:rPr lang="en-US" sz="1000" dirty="0">
                <a:latin typeface="Arial" panose="020B0604020202020204" pitchFamily="34" charset="0"/>
                <a:cs typeface="Arial" panose="020B0604020202020204" pitchFamily="34" charset="0"/>
              </a:rPr>
              <a:t>. Images are representative of 2 independent experiments. </a:t>
            </a:r>
            <a:r>
              <a:rPr lang="en-US" sz="1000" b="1" dirty="0" smtClean="0">
                <a:latin typeface="Arial" panose="020B0604020202020204" pitchFamily="34" charset="0"/>
                <a:cs typeface="Arial" panose="020B0604020202020204" pitchFamily="34" charset="0"/>
              </a:rPr>
              <a:t>(B)</a:t>
            </a:r>
            <a:r>
              <a:rPr lang="en-US" sz="1000" dirty="0" smtClean="0">
                <a:latin typeface="Arial" panose="020B0604020202020204" pitchFamily="34" charset="0"/>
                <a:cs typeface="Arial" panose="020B0604020202020204" pitchFamily="34" charset="0"/>
              </a:rPr>
              <a:t> </a:t>
            </a:r>
            <a:r>
              <a:rPr lang="en-US" sz="1000" dirty="0">
                <a:latin typeface="Arial" panose="020B0604020202020204" pitchFamily="34" charset="0"/>
                <a:cs typeface="Arial" panose="020B0604020202020204" pitchFamily="34" charset="0"/>
              </a:rPr>
              <a:t>Quantitative analysis of cell conjugates, expressed as mean percentage of </a:t>
            </a:r>
            <a:r>
              <a:rPr lang="en-US" sz="1000" dirty="0" smtClean="0">
                <a:latin typeface="Arial" panose="020B0604020202020204" pitchFamily="34" charset="0"/>
                <a:cs typeface="Arial" panose="020B0604020202020204" pitchFamily="34" charset="0"/>
              </a:rPr>
              <a:t>tumor </a:t>
            </a:r>
            <a:r>
              <a:rPr lang="en-US" sz="1000" dirty="0">
                <a:latin typeface="Arial" panose="020B0604020202020204" pitchFamily="34" charset="0"/>
                <a:cs typeface="Arial" panose="020B0604020202020204" pitchFamily="34" charset="0"/>
              </a:rPr>
              <a:t>cells conjugated with </a:t>
            </a:r>
            <a:r>
              <a:rPr lang="en-US" sz="1000" dirty="0" smtClean="0">
                <a:latin typeface="Arial" panose="020B0604020202020204" pitchFamily="34" charset="0"/>
                <a:cs typeface="Arial" panose="020B0604020202020204" pitchFamily="34" charset="0"/>
              </a:rPr>
              <a:t>EO </a:t>
            </a:r>
            <a:r>
              <a:rPr lang="en-US" sz="1000" dirty="0">
                <a:latin typeface="Arial" panose="020B0604020202020204" pitchFamily="34" charset="0"/>
                <a:cs typeface="Arial" panose="020B0604020202020204" pitchFamily="34" charset="0"/>
              </a:rPr>
              <a:t>from </a:t>
            </a:r>
            <a:r>
              <a:rPr lang="en-US" sz="1000" dirty="0" smtClean="0">
                <a:latin typeface="Arial" panose="020B0604020202020204" pitchFamily="34" charset="0"/>
                <a:cs typeface="Arial" panose="020B0604020202020204" pitchFamily="34" charset="0"/>
              </a:rPr>
              <a:t>co-cultures </a:t>
            </a:r>
            <a:r>
              <a:rPr lang="en-US" sz="1000" dirty="0">
                <a:latin typeface="Arial" panose="020B0604020202020204" pitchFamily="34" charset="0"/>
                <a:cs typeface="Arial" panose="020B0604020202020204" pitchFamily="34" charset="0"/>
              </a:rPr>
              <a:t>(mean ± SD of 2 independent experiments). </a:t>
            </a:r>
            <a:r>
              <a:rPr lang="en-US" sz="1000" dirty="0" smtClean="0">
                <a:latin typeface="Arial" panose="020B0604020202020204" pitchFamily="34" charset="0"/>
                <a:cs typeface="Arial" panose="020B0604020202020204" pitchFamily="34" charset="0"/>
              </a:rPr>
              <a:t>*P&lt;0.05. </a:t>
            </a:r>
            <a:endParaRPr lang="it-IT"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232363513"/>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8" name="Gruppo 57"/>
          <p:cNvGrpSpPr/>
          <p:nvPr/>
        </p:nvGrpSpPr>
        <p:grpSpPr>
          <a:xfrm>
            <a:off x="345183" y="1129677"/>
            <a:ext cx="5197558" cy="2363993"/>
            <a:chOff x="408872" y="706596"/>
            <a:chExt cx="5197558" cy="2363993"/>
          </a:xfrm>
        </p:grpSpPr>
        <p:sp>
          <p:nvSpPr>
            <p:cNvPr id="25" name="CasellaDiTesto 24"/>
            <p:cNvSpPr txBox="1"/>
            <p:nvPr/>
          </p:nvSpPr>
          <p:spPr>
            <a:xfrm>
              <a:off x="2567313" y="713764"/>
              <a:ext cx="881862" cy="238367"/>
            </a:xfrm>
            <a:prstGeom prst="rect">
              <a:avLst/>
            </a:prstGeom>
            <a:noFill/>
          </p:spPr>
          <p:txBody>
            <a:bodyPr wrap="square" rtlCol="0">
              <a:spAutoFit/>
            </a:bodyPr>
            <a:lstStyle/>
            <a:p>
              <a:pPr algn="ctr"/>
              <a:r>
                <a:rPr lang="it-IT" sz="1000" dirty="0" smtClean="0">
                  <a:solidFill>
                    <a:srgbClr val="FF0000"/>
                  </a:solidFill>
                  <a:latin typeface="Arial" panose="020B0604020202020204" pitchFamily="34" charset="0"/>
                  <a:cs typeface="Arial" panose="020B0604020202020204" pitchFamily="34" charset="0"/>
                </a:rPr>
                <a:t>ICAM-1</a:t>
              </a:r>
              <a:endParaRPr lang="it-IT" sz="1000" dirty="0">
                <a:solidFill>
                  <a:srgbClr val="FF0000"/>
                </a:solidFill>
                <a:latin typeface="Arial" panose="020B0604020202020204" pitchFamily="34" charset="0"/>
                <a:cs typeface="Arial" panose="020B0604020202020204" pitchFamily="34" charset="0"/>
              </a:endParaRPr>
            </a:p>
          </p:txBody>
        </p:sp>
        <p:sp>
          <p:nvSpPr>
            <p:cNvPr id="26" name="CasellaDiTesto 25"/>
            <p:cNvSpPr txBox="1"/>
            <p:nvPr/>
          </p:nvSpPr>
          <p:spPr>
            <a:xfrm>
              <a:off x="3655450" y="713764"/>
              <a:ext cx="689316" cy="238367"/>
            </a:xfrm>
            <a:prstGeom prst="rect">
              <a:avLst/>
            </a:prstGeom>
            <a:noFill/>
          </p:spPr>
          <p:txBody>
            <a:bodyPr wrap="square" rtlCol="0">
              <a:spAutoFit/>
            </a:bodyPr>
            <a:lstStyle/>
            <a:p>
              <a:pPr algn="ctr"/>
              <a:r>
                <a:rPr lang="it-IT" sz="1000" dirty="0" err="1" smtClean="0">
                  <a:solidFill>
                    <a:srgbClr val="00B050"/>
                  </a:solidFill>
                  <a:latin typeface="Arial" panose="020B0604020202020204" pitchFamily="34" charset="0"/>
                  <a:cs typeface="Arial" panose="020B0604020202020204" pitchFamily="34" charset="0"/>
                </a:rPr>
                <a:t>Actin</a:t>
              </a:r>
              <a:endParaRPr lang="it-IT" sz="1000" dirty="0">
                <a:solidFill>
                  <a:srgbClr val="00B050"/>
                </a:solidFill>
                <a:latin typeface="Arial" panose="020B0604020202020204" pitchFamily="34" charset="0"/>
                <a:cs typeface="Arial" panose="020B0604020202020204" pitchFamily="34" charset="0"/>
              </a:endParaRPr>
            </a:p>
          </p:txBody>
        </p:sp>
        <p:sp>
          <p:nvSpPr>
            <p:cNvPr id="27" name="CasellaDiTesto 26"/>
            <p:cNvSpPr txBox="1"/>
            <p:nvPr/>
          </p:nvSpPr>
          <p:spPr>
            <a:xfrm>
              <a:off x="1507268" y="706596"/>
              <a:ext cx="660989" cy="238367"/>
            </a:xfrm>
            <a:prstGeom prst="rect">
              <a:avLst/>
            </a:prstGeom>
            <a:noFill/>
          </p:spPr>
          <p:txBody>
            <a:bodyPr wrap="square" rtlCol="0">
              <a:spAutoFit/>
            </a:bodyPr>
            <a:lstStyle/>
            <a:p>
              <a:pPr algn="ctr"/>
              <a:r>
                <a:rPr lang="it-IT" sz="1000" dirty="0" smtClean="0">
                  <a:solidFill>
                    <a:srgbClr val="0070C0"/>
                  </a:solidFill>
                  <a:latin typeface="Arial" panose="020B0604020202020204" pitchFamily="34" charset="0"/>
                  <a:cs typeface="Arial" panose="020B0604020202020204" pitchFamily="34" charset="0"/>
                </a:rPr>
                <a:t>DAPI</a:t>
              </a:r>
              <a:endParaRPr lang="it-IT" sz="1000" dirty="0">
                <a:solidFill>
                  <a:srgbClr val="0070C0"/>
                </a:solidFill>
                <a:latin typeface="Arial" panose="020B0604020202020204" pitchFamily="34" charset="0"/>
                <a:cs typeface="Arial" panose="020B0604020202020204" pitchFamily="34" charset="0"/>
              </a:endParaRPr>
            </a:p>
          </p:txBody>
        </p:sp>
        <p:pic>
          <p:nvPicPr>
            <p:cNvPr id="28" name="Immagine 27"/>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297629" y="909893"/>
              <a:ext cx="1055519" cy="1064718"/>
            </a:xfrm>
            <a:prstGeom prst="rect">
              <a:avLst/>
            </a:prstGeom>
          </p:spPr>
        </p:pic>
        <p:pic>
          <p:nvPicPr>
            <p:cNvPr id="29" name="Immagine 28"/>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550490" y="918378"/>
              <a:ext cx="1055519" cy="1064718"/>
            </a:xfrm>
            <a:prstGeom prst="rect">
              <a:avLst/>
            </a:prstGeom>
          </p:spPr>
        </p:pic>
        <p:pic>
          <p:nvPicPr>
            <p:cNvPr id="30" name="Immagine 29"/>
            <p:cNvPicPr>
              <a:picLocks noChangeAspect="1"/>
            </p:cNvPicPr>
            <p:nvPr/>
          </p:nvPicPr>
          <p:blipFill>
            <a:blip r:embed="rId4" cstate="print">
              <a:extLst>
                <a:ext uri="{BEBA8EAE-BF5A-486C-A8C5-ECC9F3942E4B}">
                  <a14:imgProps xmlns:a14="http://schemas.microsoft.com/office/drawing/2010/main">
                    <a14:imgLayer r:embed="rId5">
                      <a14:imgEffect>
                        <a14:brightnessContrast bright="20000" contrast="20000"/>
                      </a14:imgEffect>
                    </a14:imgLayer>
                  </a14:imgProps>
                </a:ext>
                <a:ext uri="{28A0092B-C50C-407E-A947-70E740481C1C}">
                  <a14:useLocalDpi xmlns:a14="http://schemas.microsoft.com/office/drawing/2010/main" val="0"/>
                </a:ext>
              </a:extLst>
            </a:blip>
            <a:stretch>
              <a:fillRect/>
            </a:stretch>
          </p:blipFill>
          <p:spPr>
            <a:xfrm>
              <a:off x="2389268" y="918378"/>
              <a:ext cx="1055519" cy="1064718"/>
            </a:xfrm>
            <a:prstGeom prst="rect">
              <a:avLst/>
            </a:prstGeom>
          </p:spPr>
        </p:pic>
        <p:pic>
          <p:nvPicPr>
            <p:cNvPr id="31" name="Immagine 30"/>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3468116" y="918378"/>
              <a:ext cx="1055519" cy="1064718"/>
            </a:xfrm>
            <a:prstGeom prst="rect">
              <a:avLst/>
            </a:prstGeom>
          </p:spPr>
        </p:pic>
        <p:pic>
          <p:nvPicPr>
            <p:cNvPr id="32" name="Immagine 31"/>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1307659" y="2005871"/>
              <a:ext cx="1053268" cy="1064718"/>
            </a:xfrm>
            <a:prstGeom prst="rect">
              <a:avLst/>
            </a:prstGeom>
          </p:spPr>
        </p:pic>
        <p:pic>
          <p:nvPicPr>
            <p:cNvPr id="33" name="Immagine 32"/>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4553162" y="2005871"/>
              <a:ext cx="1053268" cy="1064718"/>
            </a:xfrm>
            <a:prstGeom prst="rect">
              <a:avLst/>
            </a:prstGeom>
          </p:spPr>
        </p:pic>
        <p:pic>
          <p:nvPicPr>
            <p:cNvPr id="34" name="Immagine 33"/>
            <p:cNvPicPr>
              <a:picLocks noChangeAspect="1"/>
            </p:cNvPicPr>
            <p:nvPr/>
          </p:nvPicPr>
          <p:blipFill>
            <a:blip r:embed="rId9" cstate="print">
              <a:extLst>
                <a:ext uri="{BEBA8EAE-BF5A-486C-A8C5-ECC9F3942E4B}">
                  <a14:imgProps xmlns:a14="http://schemas.microsoft.com/office/drawing/2010/main">
                    <a14:imgLayer r:embed="rId10">
                      <a14:imgEffect>
                        <a14:brightnessContrast bright="40000" contrast="-20000"/>
                      </a14:imgEffect>
                    </a14:imgLayer>
                  </a14:imgProps>
                </a:ext>
                <a:ext uri="{28A0092B-C50C-407E-A947-70E740481C1C}">
                  <a14:useLocalDpi xmlns:a14="http://schemas.microsoft.com/office/drawing/2010/main" val="0"/>
                </a:ext>
              </a:extLst>
            </a:blip>
            <a:stretch>
              <a:fillRect/>
            </a:stretch>
          </p:blipFill>
          <p:spPr>
            <a:xfrm>
              <a:off x="2385803" y="2005871"/>
              <a:ext cx="1053268" cy="1064718"/>
            </a:xfrm>
            <a:prstGeom prst="rect">
              <a:avLst/>
            </a:prstGeom>
          </p:spPr>
        </p:pic>
        <p:pic>
          <p:nvPicPr>
            <p:cNvPr id="35" name="Immagine 34"/>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3469482" y="2005871"/>
              <a:ext cx="1053268" cy="1064718"/>
            </a:xfrm>
            <a:prstGeom prst="rect">
              <a:avLst/>
            </a:prstGeom>
          </p:spPr>
        </p:pic>
        <p:sp>
          <p:nvSpPr>
            <p:cNvPr id="36" name="CasellaDiTesto 35"/>
            <p:cNvSpPr txBox="1"/>
            <p:nvPr/>
          </p:nvSpPr>
          <p:spPr>
            <a:xfrm>
              <a:off x="865122" y="1331553"/>
              <a:ext cx="434834" cy="23836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defPPr>
                <a:defRPr lang="it-IT"/>
              </a:defPPr>
              <a:lvl1pPr algn="ctr">
                <a:spcBef>
                  <a:spcPct val="0"/>
                </a:spcBef>
                <a:buFontTx/>
                <a:buNone/>
                <a:defRPr sz="1000">
                  <a:latin typeface="Arial" panose="020B0604020202020204" pitchFamily="34" charset="0"/>
                  <a:cs typeface="Arial" panose="020B0604020202020204" pitchFamily="34" charset="0"/>
                </a:defRPr>
              </a:lvl1pPr>
              <a:lvl2pPr marL="742950" indent="-285750">
                <a:spcBef>
                  <a:spcPct val="20000"/>
                </a:spcBef>
                <a:buChar char="–"/>
                <a:defRPr sz="2800">
                  <a:latin typeface="Arial" panose="020B0604020202020204" pitchFamily="34" charset="0"/>
                </a:defRPr>
              </a:lvl2pPr>
              <a:lvl3pPr marL="1143000" indent="-228600">
                <a:spcBef>
                  <a:spcPct val="20000"/>
                </a:spcBef>
                <a:buChar char="•"/>
                <a:defRPr sz="2400">
                  <a:latin typeface="Arial" panose="020B0604020202020204" pitchFamily="34" charset="0"/>
                </a:defRPr>
              </a:lvl3pPr>
              <a:lvl4pPr marL="1600200" indent="-228600">
                <a:spcBef>
                  <a:spcPct val="20000"/>
                </a:spcBef>
                <a:buChar char="–"/>
                <a:defRPr sz="2000">
                  <a:latin typeface="Arial" panose="020B0604020202020204" pitchFamily="34" charset="0"/>
                </a:defRPr>
              </a:lvl4pPr>
              <a:lvl5pPr marL="2057400" indent="-228600">
                <a:spcBef>
                  <a:spcPct val="20000"/>
                </a:spcBef>
                <a:buChar char="»"/>
                <a:defRPr sz="2000">
                  <a:latin typeface="Arial" panose="020B0604020202020204" pitchFamily="34" charset="0"/>
                </a:defRPr>
              </a:lvl5pPr>
              <a:lvl6pPr marL="2514600" indent="-228600" eaLnBrk="0" fontAlgn="base" hangingPunct="0">
                <a:spcBef>
                  <a:spcPct val="20000"/>
                </a:spcBef>
                <a:spcAft>
                  <a:spcPct val="0"/>
                </a:spcAft>
                <a:buChar char="»"/>
                <a:defRPr sz="2000">
                  <a:latin typeface="Arial" panose="020B0604020202020204" pitchFamily="34" charset="0"/>
                </a:defRPr>
              </a:lvl6pPr>
              <a:lvl7pPr marL="2971800" indent="-228600" eaLnBrk="0" fontAlgn="base" hangingPunct="0">
                <a:spcBef>
                  <a:spcPct val="20000"/>
                </a:spcBef>
                <a:spcAft>
                  <a:spcPct val="0"/>
                </a:spcAft>
                <a:buChar char="»"/>
                <a:defRPr sz="2000">
                  <a:latin typeface="Arial" panose="020B0604020202020204" pitchFamily="34" charset="0"/>
                </a:defRPr>
              </a:lvl7pPr>
              <a:lvl8pPr marL="3429000" indent="-228600" eaLnBrk="0" fontAlgn="base" hangingPunct="0">
                <a:spcBef>
                  <a:spcPct val="20000"/>
                </a:spcBef>
                <a:spcAft>
                  <a:spcPct val="0"/>
                </a:spcAft>
                <a:buChar char="»"/>
                <a:defRPr sz="2000">
                  <a:latin typeface="Arial" panose="020B0604020202020204" pitchFamily="34" charset="0"/>
                </a:defRPr>
              </a:lvl8pPr>
              <a:lvl9pPr marL="3886200" indent="-228600" eaLnBrk="0" fontAlgn="base" hangingPunct="0">
                <a:spcBef>
                  <a:spcPct val="20000"/>
                </a:spcBef>
                <a:spcAft>
                  <a:spcPct val="0"/>
                </a:spcAft>
                <a:buChar char="»"/>
                <a:defRPr sz="2000">
                  <a:latin typeface="Arial" panose="020B0604020202020204" pitchFamily="34" charset="0"/>
                </a:defRPr>
              </a:lvl9pPr>
            </a:lstStyle>
            <a:p>
              <a:r>
                <a:rPr lang="it-IT" dirty="0"/>
                <a:t>CTR</a:t>
              </a:r>
            </a:p>
          </p:txBody>
        </p:sp>
        <p:sp>
          <p:nvSpPr>
            <p:cNvPr id="37" name="CasellaDiTesto 36"/>
            <p:cNvSpPr txBox="1"/>
            <p:nvPr/>
          </p:nvSpPr>
          <p:spPr>
            <a:xfrm>
              <a:off x="408872" y="2419046"/>
              <a:ext cx="891084" cy="23836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defPPr>
                <a:defRPr lang="it-IT"/>
              </a:defPPr>
              <a:lvl1pPr algn="ctr">
                <a:spcBef>
                  <a:spcPct val="0"/>
                </a:spcBef>
                <a:buFontTx/>
                <a:buNone/>
                <a:defRPr sz="1000">
                  <a:latin typeface="Arial" panose="020B0604020202020204" pitchFamily="34" charset="0"/>
                  <a:cs typeface="Arial" panose="020B0604020202020204" pitchFamily="34" charset="0"/>
                </a:defRPr>
              </a:lvl1pPr>
              <a:lvl2pPr marL="742950" indent="-285750">
                <a:spcBef>
                  <a:spcPct val="20000"/>
                </a:spcBef>
                <a:buChar char="–"/>
                <a:defRPr sz="2800">
                  <a:latin typeface="Arial" panose="020B0604020202020204" pitchFamily="34" charset="0"/>
                </a:defRPr>
              </a:lvl2pPr>
              <a:lvl3pPr marL="1143000" indent="-228600">
                <a:spcBef>
                  <a:spcPct val="20000"/>
                </a:spcBef>
                <a:buChar char="•"/>
                <a:defRPr sz="2400">
                  <a:latin typeface="Arial" panose="020B0604020202020204" pitchFamily="34" charset="0"/>
                </a:defRPr>
              </a:lvl3pPr>
              <a:lvl4pPr marL="1600200" indent="-228600">
                <a:spcBef>
                  <a:spcPct val="20000"/>
                </a:spcBef>
                <a:buChar char="–"/>
                <a:defRPr sz="2000">
                  <a:latin typeface="Arial" panose="020B0604020202020204" pitchFamily="34" charset="0"/>
                </a:defRPr>
              </a:lvl4pPr>
              <a:lvl5pPr marL="2057400" indent="-228600">
                <a:spcBef>
                  <a:spcPct val="20000"/>
                </a:spcBef>
                <a:buChar char="»"/>
                <a:defRPr sz="2000">
                  <a:latin typeface="Arial" panose="020B0604020202020204" pitchFamily="34" charset="0"/>
                </a:defRPr>
              </a:lvl5pPr>
              <a:lvl6pPr marL="2514600" indent="-228600" eaLnBrk="0" fontAlgn="base" hangingPunct="0">
                <a:spcBef>
                  <a:spcPct val="20000"/>
                </a:spcBef>
                <a:spcAft>
                  <a:spcPct val="0"/>
                </a:spcAft>
                <a:buChar char="»"/>
                <a:defRPr sz="2000">
                  <a:latin typeface="Arial" panose="020B0604020202020204" pitchFamily="34" charset="0"/>
                </a:defRPr>
              </a:lvl6pPr>
              <a:lvl7pPr marL="2971800" indent="-228600" eaLnBrk="0" fontAlgn="base" hangingPunct="0">
                <a:spcBef>
                  <a:spcPct val="20000"/>
                </a:spcBef>
                <a:spcAft>
                  <a:spcPct val="0"/>
                </a:spcAft>
                <a:buChar char="»"/>
                <a:defRPr sz="2000">
                  <a:latin typeface="Arial" panose="020B0604020202020204" pitchFamily="34" charset="0"/>
                </a:defRPr>
              </a:lvl7pPr>
              <a:lvl8pPr marL="3429000" indent="-228600" eaLnBrk="0" fontAlgn="base" hangingPunct="0">
                <a:spcBef>
                  <a:spcPct val="20000"/>
                </a:spcBef>
                <a:spcAft>
                  <a:spcPct val="0"/>
                </a:spcAft>
                <a:buChar char="»"/>
                <a:defRPr sz="2000">
                  <a:latin typeface="Arial" panose="020B0604020202020204" pitchFamily="34" charset="0"/>
                </a:defRPr>
              </a:lvl8pPr>
              <a:lvl9pPr marL="3886200" indent="-228600" eaLnBrk="0" fontAlgn="base" hangingPunct="0">
                <a:spcBef>
                  <a:spcPct val="20000"/>
                </a:spcBef>
                <a:spcAft>
                  <a:spcPct val="0"/>
                </a:spcAft>
                <a:buChar char="»"/>
                <a:defRPr sz="2000">
                  <a:latin typeface="Arial" panose="020B0604020202020204" pitchFamily="34" charset="0"/>
                </a:defRPr>
              </a:lvl9pPr>
            </a:lstStyle>
            <a:p>
              <a:r>
                <a:rPr lang="it-IT" dirty="0"/>
                <a:t>+ CD18 </a:t>
              </a:r>
              <a:r>
                <a:rPr lang="it-IT" dirty="0" err="1"/>
                <a:t>mAb</a:t>
              </a:r>
              <a:endParaRPr lang="it-IT" dirty="0"/>
            </a:p>
          </p:txBody>
        </p:sp>
        <p:sp>
          <p:nvSpPr>
            <p:cNvPr id="38" name="CasellaDiTesto 37"/>
            <p:cNvSpPr txBox="1"/>
            <p:nvPr/>
          </p:nvSpPr>
          <p:spPr>
            <a:xfrm>
              <a:off x="4733591" y="713764"/>
              <a:ext cx="689316" cy="238367"/>
            </a:xfrm>
            <a:prstGeom prst="rect">
              <a:avLst/>
            </a:prstGeom>
            <a:noFill/>
          </p:spPr>
          <p:txBody>
            <a:bodyPr wrap="square" rtlCol="0">
              <a:spAutoFit/>
            </a:bodyPr>
            <a:lstStyle/>
            <a:p>
              <a:pPr algn="ctr"/>
              <a:r>
                <a:rPr lang="it-IT" sz="1000" dirty="0" smtClean="0">
                  <a:latin typeface="Arial" panose="020B0604020202020204" pitchFamily="34" charset="0"/>
                  <a:cs typeface="Arial" panose="020B0604020202020204" pitchFamily="34" charset="0"/>
                </a:rPr>
                <a:t>Merge</a:t>
              </a:r>
              <a:endParaRPr lang="it-IT" sz="1000" dirty="0">
                <a:latin typeface="Arial" panose="020B0604020202020204" pitchFamily="34" charset="0"/>
                <a:cs typeface="Arial" panose="020B0604020202020204" pitchFamily="34" charset="0"/>
              </a:endParaRPr>
            </a:p>
          </p:txBody>
        </p:sp>
        <p:cxnSp>
          <p:nvCxnSpPr>
            <p:cNvPr id="24" name="Connettore 1 39"/>
            <p:cNvCxnSpPr/>
            <p:nvPr/>
          </p:nvCxnSpPr>
          <p:spPr>
            <a:xfrm>
              <a:off x="4584034" y="3030669"/>
              <a:ext cx="235620"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39" name="Connettore 1 39"/>
            <p:cNvCxnSpPr/>
            <p:nvPr/>
          </p:nvCxnSpPr>
          <p:spPr>
            <a:xfrm>
              <a:off x="4584034" y="1948913"/>
              <a:ext cx="235620"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41" name="Connettore 2 40"/>
            <p:cNvCxnSpPr/>
            <p:nvPr/>
          </p:nvCxnSpPr>
          <p:spPr>
            <a:xfrm flipH="1" flipV="1">
              <a:off x="5288270" y="2369194"/>
              <a:ext cx="173263" cy="208894"/>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45" name="Connettore 2 44"/>
            <p:cNvCxnSpPr/>
            <p:nvPr/>
          </p:nvCxnSpPr>
          <p:spPr>
            <a:xfrm>
              <a:off x="5096445" y="1724168"/>
              <a:ext cx="258925" cy="75022"/>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50" name="Connettore 2 49"/>
            <p:cNvCxnSpPr/>
            <p:nvPr/>
          </p:nvCxnSpPr>
          <p:spPr>
            <a:xfrm flipH="1" flipV="1">
              <a:off x="5282252" y="1495598"/>
              <a:ext cx="272211" cy="20658"/>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52" name="Connettore 2 51"/>
            <p:cNvCxnSpPr/>
            <p:nvPr/>
          </p:nvCxnSpPr>
          <p:spPr>
            <a:xfrm flipV="1">
              <a:off x="4783260" y="1384192"/>
              <a:ext cx="258595" cy="32969"/>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grpSp>
      <p:sp>
        <p:nvSpPr>
          <p:cNvPr id="40" name="Rettangolo 39"/>
          <p:cNvSpPr/>
          <p:nvPr/>
        </p:nvSpPr>
        <p:spPr>
          <a:xfrm>
            <a:off x="29923" y="3929392"/>
            <a:ext cx="6063569" cy="1477328"/>
          </a:xfrm>
          <a:prstGeom prst="rect">
            <a:avLst/>
          </a:prstGeom>
        </p:spPr>
        <p:txBody>
          <a:bodyPr wrap="square">
            <a:spAutoFit/>
          </a:bodyPr>
          <a:lstStyle/>
          <a:p>
            <a:pPr algn="just"/>
            <a:r>
              <a:rPr lang="en-US" sz="1000" b="1" dirty="0" smtClean="0">
                <a:latin typeface="Arial" panose="020B0604020202020204" pitchFamily="34" charset="0"/>
                <a:cs typeface="Arial" panose="020B0604020202020204" pitchFamily="34" charset="0"/>
              </a:rPr>
              <a:t>Figure S11</a:t>
            </a:r>
            <a:r>
              <a:rPr lang="en-US" sz="1000" b="1" dirty="0" smtClean="0">
                <a:latin typeface="Arial" panose="020B0604020202020204" pitchFamily="34" charset="0"/>
                <a:cs typeface="Arial" panose="020B0604020202020204" pitchFamily="34" charset="0"/>
              </a:rPr>
              <a:t>.</a:t>
            </a:r>
            <a:r>
              <a:rPr lang="en-US" sz="1000" dirty="0" smtClean="0">
                <a:latin typeface="Arial" panose="020B0604020202020204" pitchFamily="34" charset="0"/>
                <a:cs typeface="Arial" panose="020B0604020202020204" pitchFamily="34" charset="0"/>
              </a:rPr>
              <a:t> </a:t>
            </a:r>
            <a:r>
              <a:rPr lang="en-US" sz="1000" b="1" dirty="0" smtClean="0">
                <a:latin typeface="Arial" panose="020B0604020202020204" pitchFamily="34" charset="0"/>
                <a:cs typeface="Arial" panose="020B0604020202020204" pitchFamily="34" charset="0"/>
              </a:rPr>
              <a:t>ICAM-1 does not </a:t>
            </a:r>
            <a:r>
              <a:rPr lang="en-US" sz="1000" b="1" dirty="0">
                <a:latin typeface="Arial" panose="020B0604020202020204" pitchFamily="34" charset="0"/>
                <a:cs typeface="Arial" panose="020B0604020202020204" pitchFamily="34" charset="0"/>
              </a:rPr>
              <a:t>compensate for </a:t>
            </a:r>
            <a:r>
              <a:rPr lang="en-US" sz="1000" b="1" dirty="0" smtClean="0">
                <a:latin typeface="Arial" panose="020B0604020202020204" pitchFamily="34" charset="0"/>
                <a:cs typeface="Arial" panose="020B0604020202020204" pitchFamily="34" charset="0"/>
              </a:rPr>
              <a:t>the lack </a:t>
            </a:r>
            <a:r>
              <a:rPr lang="en-US" sz="1000" b="1" dirty="0">
                <a:latin typeface="Arial" panose="020B0604020202020204" pitchFamily="34" charset="0"/>
                <a:cs typeface="Arial" panose="020B0604020202020204" pitchFamily="34" charset="0"/>
              </a:rPr>
              <a:t>of CD11b/CD18-mediated adhesion.</a:t>
            </a:r>
            <a:r>
              <a:rPr lang="en-US" sz="1000" dirty="0">
                <a:latin typeface="Arial" panose="020B0604020202020204" pitchFamily="34" charset="0"/>
                <a:cs typeface="Arial" panose="020B0604020202020204" pitchFamily="34" charset="0"/>
              </a:rPr>
              <a:t> </a:t>
            </a:r>
            <a:r>
              <a:rPr lang="en-US" sz="1000" dirty="0" smtClean="0">
                <a:latin typeface="Arial" panose="020B0604020202020204" pitchFamily="34" charset="0"/>
                <a:cs typeface="Arial" panose="020B0604020202020204" pitchFamily="34" charset="0"/>
              </a:rPr>
              <a:t>IL-5 EO and IL-33 EO </a:t>
            </a:r>
            <a:r>
              <a:rPr lang="en-US" sz="1000" dirty="0">
                <a:latin typeface="Arial" panose="020B0604020202020204" pitchFamily="34" charset="0"/>
                <a:cs typeface="Arial" panose="020B0604020202020204" pitchFamily="34" charset="0"/>
              </a:rPr>
              <a:t>were </a:t>
            </a:r>
            <a:r>
              <a:rPr lang="en-US" sz="1000" dirty="0" smtClean="0">
                <a:latin typeface="Arial" panose="020B0604020202020204" pitchFamily="34" charset="0"/>
                <a:cs typeface="Arial" panose="020B0604020202020204" pitchFamily="34" charset="0"/>
              </a:rPr>
              <a:t>incubated with or without anti-CD18 </a:t>
            </a:r>
            <a:r>
              <a:rPr lang="en-US" sz="1000" dirty="0" err="1" smtClean="0">
                <a:latin typeface="Arial" panose="020B0604020202020204" pitchFamily="34" charset="0"/>
                <a:cs typeface="Arial" panose="020B0604020202020204" pitchFamily="34" charset="0"/>
              </a:rPr>
              <a:t>mAb</a:t>
            </a:r>
            <a:r>
              <a:rPr lang="en-US" sz="1000" dirty="0" smtClean="0">
                <a:latin typeface="Arial" panose="020B0604020202020204" pitchFamily="34" charset="0"/>
                <a:cs typeface="Arial" panose="020B0604020202020204" pitchFamily="34" charset="0"/>
              </a:rPr>
              <a:t> </a:t>
            </a:r>
            <a:r>
              <a:rPr lang="en-US" sz="1000" dirty="0">
                <a:latin typeface="Arial" panose="020B0604020202020204" pitchFamily="34" charset="0"/>
                <a:cs typeface="Arial" panose="020B0604020202020204" pitchFamily="34" charset="0"/>
              </a:rPr>
              <a:t>(10 µg/ml) for 20 min at 4°C, then mixed </a:t>
            </a:r>
            <a:r>
              <a:rPr lang="en-US" sz="1000" dirty="0" smtClean="0">
                <a:latin typeface="Arial" panose="020B0604020202020204" pitchFamily="34" charset="0"/>
                <a:cs typeface="Arial" panose="020B0604020202020204" pitchFamily="34" charset="0"/>
              </a:rPr>
              <a:t>with </a:t>
            </a:r>
            <a:r>
              <a:rPr lang="en-US" sz="1000" dirty="0">
                <a:latin typeface="Arial" panose="020B0604020202020204" pitchFamily="34" charset="0"/>
                <a:cs typeface="Arial" panose="020B0604020202020204" pitchFamily="34" charset="0"/>
              </a:rPr>
              <a:t>B16 </a:t>
            </a:r>
            <a:r>
              <a:rPr lang="en-US" sz="1000" dirty="0" smtClean="0">
                <a:latin typeface="Arial" panose="020B0604020202020204" pitchFamily="34" charset="0"/>
                <a:cs typeface="Arial" panose="020B0604020202020204" pitchFamily="34" charset="0"/>
              </a:rPr>
              <a:t>melanoma </a:t>
            </a:r>
            <a:r>
              <a:rPr lang="en-US" sz="1000" dirty="0">
                <a:latin typeface="Arial" panose="020B0604020202020204" pitchFamily="34" charset="0"/>
                <a:cs typeface="Arial" panose="020B0604020202020204" pitchFamily="34" charset="0"/>
              </a:rPr>
              <a:t>cells (5:1 ratio</a:t>
            </a:r>
            <a:r>
              <a:rPr lang="en-US" sz="1000" dirty="0" smtClean="0">
                <a:latin typeface="Arial" panose="020B0604020202020204" pitchFamily="34" charset="0"/>
                <a:cs typeface="Arial" panose="020B0604020202020204" pitchFamily="34" charset="0"/>
              </a:rPr>
              <a:t>) and </a:t>
            </a:r>
            <a:r>
              <a:rPr lang="en-US" sz="1000" dirty="0">
                <a:latin typeface="Arial" panose="020B0604020202020204" pitchFamily="34" charset="0"/>
                <a:cs typeface="Arial" panose="020B0604020202020204" pitchFamily="34" charset="0"/>
              </a:rPr>
              <a:t>allowed to conjugate for 60 min at </a:t>
            </a:r>
            <a:r>
              <a:rPr lang="en-US" sz="1000" dirty="0" smtClean="0">
                <a:latin typeface="Arial" panose="020B0604020202020204" pitchFamily="34" charset="0"/>
                <a:cs typeface="Arial" panose="020B0604020202020204" pitchFamily="34" charset="0"/>
              </a:rPr>
              <a:t>37°C. Cell </a:t>
            </a:r>
            <a:r>
              <a:rPr lang="en-US" sz="1000" dirty="0">
                <a:latin typeface="Arial" panose="020B0604020202020204" pitchFamily="34" charset="0"/>
                <a:cs typeface="Arial" panose="020B0604020202020204" pitchFamily="34" charset="0"/>
              </a:rPr>
              <a:t>conjugates were </a:t>
            </a:r>
            <a:r>
              <a:rPr lang="en-US" sz="1000" dirty="0" smtClean="0">
                <a:latin typeface="Arial" panose="020B0604020202020204" pitchFamily="34" charset="0"/>
                <a:cs typeface="Arial" panose="020B0604020202020204" pitchFamily="34" charset="0"/>
              </a:rPr>
              <a:t>then transferred </a:t>
            </a:r>
            <a:r>
              <a:rPr lang="en-US" sz="1000" dirty="0">
                <a:latin typeface="Arial" panose="020B0604020202020204" pitchFamily="34" charset="0"/>
                <a:cs typeface="Arial" panose="020B0604020202020204" pitchFamily="34" charset="0"/>
              </a:rPr>
              <a:t>onto poly-L-lysine-coated </a:t>
            </a:r>
            <a:r>
              <a:rPr lang="en-US" sz="1000" dirty="0" smtClean="0">
                <a:latin typeface="Arial" panose="020B0604020202020204" pitchFamily="34" charset="0"/>
                <a:cs typeface="Arial" panose="020B0604020202020204" pitchFamily="34" charset="0"/>
              </a:rPr>
              <a:t>coverslips and stained for ICAM-1 (detected in red). Cells were then </a:t>
            </a:r>
            <a:r>
              <a:rPr lang="en-US" sz="1000" dirty="0">
                <a:latin typeface="Arial" panose="020B0604020202020204" pitchFamily="34" charset="0"/>
                <a:cs typeface="Arial" panose="020B0604020202020204" pitchFamily="34" charset="0"/>
              </a:rPr>
              <a:t>fixed, </a:t>
            </a:r>
            <a:r>
              <a:rPr lang="en-US" sz="1000" dirty="0" err="1">
                <a:latin typeface="Arial" panose="020B0604020202020204" pitchFamily="34" charset="0"/>
                <a:cs typeface="Arial" panose="020B0604020202020204" pitchFamily="34" charset="0"/>
              </a:rPr>
              <a:t>permeabilized</a:t>
            </a:r>
            <a:r>
              <a:rPr lang="en-US" sz="1000" dirty="0">
                <a:latin typeface="Arial" panose="020B0604020202020204" pitchFamily="34" charset="0"/>
                <a:cs typeface="Arial" panose="020B0604020202020204" pitchFamily="34" charset="0"/>
              </a:rPr>
              <a:t> and labelled with Alexa Fluor®-488 </a:t>
            </a:r>
            <a:r>
              <a:rPr lang="en-US" sz="1000" dirty="0" err="1">
                <a:latin typeface="Arial" panose="020B0604020202020204" pitchFamily="34" charset="0"/>
                <a:cs typeface="Arial" panose="020B0604020202020204" pitchFamily="34" charset="0"/>
              </a:rPr>
              <a:t>phalloidin</a:t>
            </a:r>
            <a:r>
              <a:rPr lang="en-US" sz="1000" dirty="0">
                <a:latin typeface="Arial" panose="020B0604020202020204" pitchFamily="34" charset="0"/>
                <a:cs typeface="Arial" panose="020B0604020202020204" pitchFamily="34" charset="0"/>
              </a:rPr>
              <a:t> for actin staining (detected in green). Nuclei </a:t>
            </a:r>
            <a:r>
              <a:rPr lang="en-US" sz="1000" dirty="0" smtClean="0">
                <a:latin typeface="Arial" panose="020B0604020202020204" pitchFamily="34" charset="0"/>
                <a:cs typeface="Arial" panose="020B0604020202020204" pitchFamily="34" charset="0"/>
              </a:rPr>
              <a:t>were stained with DAPI (blue). </a:t>
            </a:r>
            <a:r>
              <a:rPr lang="en-US" sz="1000" dirty="0">
                <a:latin typeface="Arial" panose="020B0604020202020204" pitchFamily="34" charset="0"/>
                <a:cs typeface="Arial" panose="020B0604020202020204" pitchFamily="34" charset="0"/>
              </a:rPr>
              <a:t>CLSM </a:t>
            </a:r>
            <a:r>
              <a:rPr lang="en-US" sz="1000" dirty="0" smtClean="0">
                <a:latin typeface="Arial" panose="020B0604020202020204" pitchFamily="34" charset="0"/>
                <a:cs typeface="Arial" panose="020B0604020202020204" pitchFamily="34" charset="0"/>
              </a:rPr>
              <a:t>examinations were carried out. Arrows </a:t>
            </a:r>
            <a:r>
              <a:rPr lang="en-US" sz="1000" dirty="0">
                <a:latin typeface="Arial" panose="020B0604020202020204" pitchFamily="34" charset="0"/>
                <a:cs typeface="Arial" panose="020B0604020202020204" pitchFamily="34" charset="0"/>
              </a:rPr>
              <a:t>indicate cell conjugates </a:t>
            </a:r>
            <a:r>
              <a:rPr lang="en-US" sz="1000" dirty="0" smtClean="0">
                <a:latin typeface="Arial" panose="020B0604020202020204" pitchFamily="34" charset="0"/>
                <a:cs typeface="Arial" panose="020B0604020202020204" pitchFamily="34" charset="0"/>
              </a:rPr>
              <a:t>with ICAM-1 polarization to the synapses, showing no increase of polarization intensity in the presence </a:t>
            </a:r>
            <a:r>
              <a:rPr lang="en-US" sz="1000" dirty="0">
                <a:latin typeface="Arial" panose="020B0604020202020204" pitchFamily="34" charset="0"/>
                <a:cs typeface="Arial" panose="020B0604020202020204" pitchFamily="34" charset="0"/>
              </a:rPr>
              <a:t>of anti-CD18 </a:t>
            </a:r>
            <a:r>
              <a:rPr lang="en-US" sz="1000" dirty="0" err="1" smtClean="0">
                <a:latin typeface="Arial" panose="020B0604020202020204" pitchFamily="34" charset="0"/>
                <a:cs typeface="Arial" panose="020B0604020202020204" pitchFamily="34" charset="0"/>
              </a:rPr>
              <a:t>mAb</a:t>
            </a:r>
            <a:r>
              <a:rPr lang="en-US" sz="1000" dirty="0" smtClean="0">
                <a:latin typeface="Arial" panose="020B0604020202020204" pitchFamily="34" charset="0"/>
                <a:cs typeface="Arial" panose="020B0604020202020204" pitchFamily="34" charset="0"/>
              </a:rPr>
              <a:t>. Scale </a:t>
            </a:r>
            <a:r>
              <a:rPr lang="en-US" sz="1000" dirty="0">
                <a:latin typeface="Arial" panose="020B0604020202020204" pitchFamily="34" charset="0"/>
                <a:cs typeface="Arial" panose="020B0604020202020204" pitchFamily="34" charset="0"/>
              </a:rPr>
              <a:t>bars, </a:t>
            </a:r>
            <a:r>
              <a:rPr lang="en-US" sz="1000" dirty="0" smtClean="0">
                <a:latin typeface="Arial" panose="020B0604020202020204" pitchFamily="34" charset="0"/>
                <a:cs typeface="Arial" panose="020B0604020202020204" pitchFamily="34" charset="0"/>
              </a:rPr>
              <a:t>20 µm</a:t>
            </a:r>
            <a:r>
              <a:rPr lang="en-US" sz="1000" dirty="0">
                <a:latin typeface="Arial" panose="020B0604020202020204" pitchFamily="34" charset="0"/>
                <a:cs typeface="Arial" panose="020B0604020202020204" pitchFamily="34" charset="0"/>
              </a:rPr>
              <a:t>. Images are representative of 2 independent experiments. </a:t>
            </a:r>
            <a:endParaRPr lang="it-IT"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62982112"/>
      </p:ext>
    </p:extLst>
  </p:cSld>
  <p:clrMapOvr>
    <a:masterClrMapping/>
  </p:clrMapOvr>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3" name="CasellaDiTesto 142"/>
          <p:cNvSpPr txBox="1"/>
          <p:nvPr/>
        </p:nvSpPr>
        <p:spPr>
          <a:xfrm>
            <a:off x="32096" y="52032"/>
            <a:ext cx="332142" cy="338554"/>
          </a:xfrm>
          <a:prstGeom prst="rect">
            <a:avLst/>
          </a:prstGeom>
          <a:noFill/>
        </p:spPr>
        <p:txBody>
          <a:bodyPr wrap="none" rtlCol="0">
            <a:spAutoFit/>
          </a:bodyPr>
          <a:lstStyle/>
          <a:p>
            <a:r>
              <a:rPr lang="it-IT" sz="1600" b="1" dirty="0">
                <a:latin typeface="Arial" panose="020B0604020202020204" pitchFamily="34" charset="0"/>
                <a:cs typeface="Arial" panose="020B0604020202020204" pitchFamily="34" charset="0"/>
              </a:rPr>
              <a:t>A</a:t>
            </a:r>
          </a:p>
        </p:txBody>
      </p:sp>
      <p:sp>
        <p:nvSpPr>
          <p:cNvPr id="220" name="CasellaDiTesto 219"/>
          <p:cNvSpPr txBox="1"/>
          <p:nvPr/>
        </p:nvSpPr>
        <p:spPr>
          <a:xfrm>
            <a:off x="3643502" y="52032"/>
            <a:ext cx="332142" cy="338554"/>
          </a:xfrm>
          <a:prstGeom prst="rect">
            <a:avLst/>
          </a:prstGeom>
          <a:noFill/>
        </p:spPr>
        <p:txBody>
          <a:bodyPr wrap="none" rtlCol="0">
            <a:spAutoFit/>
          </a:bodyPr>
          <a:lstStyle/>
          <a:p>
            <a:r>
              <a:rPr lang="it-IT" sz="1600" b="1" dirty="0">
                <a:latin typeface="Arial" panose="020B0604020202020204" pitchFamily="34" charset="0"/>
                <a:cs typeface="Arial" panose="020B0604020202020204" pitchFamily="34" charset="0"/>
              </a:rPr>
              <a:t>B</a:t>
            </a:r>
          </a:p>
        </p:txBody>
      </p:sp>
      <p:sp>
        <p:nvSpPr>
          <p:cNvPr id="149" name="CasellaDiTesto 148"/>
          <p:cNvSpPr txBox="1"/>
          <p:nvPr/>
        </p:nvSpPr>
        <p:spPr>
          <a:xfrm>
            <a:off x="3661490" y="2650065"/>
            <a:ext cx="332142" cy="338554"/>
          </a:xfrm>
          <a:prstGeom prst="rect">
            <a:avLst/>
          </a:prstGeom>
          <a:noFill/>
        </p:spPr>
        <p:txBody>
          <a:bodyPr wrap="none" rtlCol="0">
            <a:spAutoFit/>
          </a:bodyPr>
          <a:lstStyle/>
          <a:p>
            <a:r>
              <a:rPr lang="it-IT" sz="1600" b="1" dirty="0">
                <a:latin typeface="Arial" panose="020B0604020202020204" pitchFamily="34" charset="0"/>
                <a:cs typeface="Arial" panose="020B0604020202020204" pitchFamily="34" charset="0"/>
              </a:rPr>
              <a:t>D</a:t>
            </a:r>
          </a:p>
        </p:txBody>
      </p:sp>
      <p:sp>
        <p:nvSpPr>
          <p:cNvPr id="151" name="CasellaDiTesto 150"/>
          <p:cNvSpPr txBox="1"/>
          <p:nvPr/>
        </p:nvSpPr>
        <p:spPr>
          <a:xfrm>
            <a:off x="77932" y="3230207"/>
            <a:ext cx="332142" cy="338554"/>
          </a:xfrm>
          <a:prstGeom prst="rect">
            <a:avLst/>
          </a:prstGeom>
          <a:noFill/>
        </p:spPr>
        <p:txBody>
          <a:bodyPr wrap="none" rtlCol="0">
            <a:spAutoFit/>
          </a:bodyPr>
          <a:lstStyle/>
          <a:p>
            <a:r>
              <a:rPr lang="it-IT" sz="1600" b="1" dirty="0">
                <a:latin typeface="Arial" panose="020B0604020202020204" pitchFamily="34" charset="0"/>
                <a:cs typeface="Arial" panose="020B0604020202020204" pitchFamily="34" charset="0"/>
              </a:rPr>
              <a:t>C</a:t>
            </a:r>
          </a:p>
        </p:txBody>
      </p:sp>
      <p:pic>
        <p:nvPicPr>
          <p:cNvPr id="162" name="Picture 3"/>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28213" b="29412"/>
          <a:stretch/>
        </p:blipFill>
        <p:spPr bwMode="auto">
          <a:xfrm>
            <a:off x="4988560" y="3962246"/>
            <a:ext cx="935010" cy="101784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64" name="Freccia angolare in su 163"/>
          <p:cNvSpPr/>
          <p:nvPr/>
        </p:nvSpPr>
        <p:spPr>
          <a:xfrm rot="5400000">
            <a:off x="4262645" y="4206295"/>
            <a:ext cx="448946" cy="226023"/>
          </a:xfrm>
          <a:prstGeom prst="bentUpArrow">
            <a:avLst>
              <a:gd name="adj1" fmla="val 36372"/>
              <a:gd name="adj2" fmla="val 32108"/>
              <a:gd name="adj3" fmla="val 24999"/>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pic>
        <p:nvPicPr>
          <p:cNvPr id="145" name="Picture 14"/>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9866" r="1" b="10044"/>
          <a:stretch/>
        </p:blipFill>
        <p:spPr bwMode="auto">
          <a:xfrm>
            <a:off x="5094404" y="2709527"/>
            <a:ext cx="1136849" cy="116712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46" name="Picture 15"/>
          <p:cNvPicPr>
            <a:picLocks noChangeArrowheads="1"/>
          </p:cNvPicPr>
          <p:nvPr/>
        </p:nvPicPr>
        <p:blipFill rotWithShape="1">
          <a:blip r:embed="rId4" cstate="print">
            <a:extLst>
              <a:ext uri="{28A0092B-C50C-407E-A947-70E740481C1C}">
                <a14:useLocalDpi xmlns:a14="http://schemas.microsoft.com/office/drawing/2010/main" val="0"/>
              </a:ext>
            </a:extLst>
          </a:blip>
          <a:srcRect b="12023"/>
          <a:stretch/>
        </p:blipFill>
        <p:spPr bwMode="auto">
          <a:xfrm>
            <a:off x="3944053" y="2709527"/>
            <a:ext cx="1270975" cy="116712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47" name="CasellaDiTesto 146"/>
          <p:cNvSpPr txBox="1"/>
          <p:nvPr/>
        </p:nvSpPr>
        <p:spPr>
          <a:xfrm>
            <a:off x="4215326" y="2787248"/>
            <a:ext cx="825867" cy="215444"/>
          </a:xfrm>
          <a:prstGeom prst="rect">
            <a:avLst/>
          </a:prstGeom>
          <a:noFill/>
        </p:spPr>
        <p:txBody>
          <a:bodyPr wrap="none" rtlCol="0">
            <a:spAutoFit/>
          </a:bodyPr>
          <a:lstStyle/>
          <a:p>
            <a:r>
              <a:rPr lang="it-IT" sz="800" dirty="0" err="1" smtClean="0">
                <a:latin typeface="Arial" panose="020B0604020202020204" pitchFamily="34" charset="0"/>
                <a:cs typeface="Arial" panose="020B0604020202020204" pitchFamily="34" charset="0"/>
              </a:rPr>
              <a:t>Slope</a:t>
            </a:r>
            <a:r>
              <a:rPr lang="it-IT" sz="800" dirty="0" smtClean="0">
                <a:latin typeface="Arial" panose="020B0604020202020204" pitchFamily="34" charset="0"/>
                <a:cs typeface="Arial" panose="020B0604020202020204" pitchFamily="34" charset="0"/>
              </a:rPr>
              <a:t>=0.4023</a:t>
            </a:r>
            <a:endParaRPr lang="it-IT" sz="800" dirty="0">
              <a:latin typeface="Arial" panose="020B0604020202020204" pitchFamily="34" charset="0"/>
              <a:cs typeface="Arial" panose="020B0604020202020204" pitchFamily="34" charset="0"/>
            </a:endParaRPr>
          </a:p>
        </p:txBody>
      </p:sp>
      <p:sp>
        <p:nvSpPr>
          <p:cNvPr id="148" name="CasellaDiTesto 147"/>
          <p:cNvSpPr txBox="1"/>
          <p:nvPr/>
        </p:nvSpPr>
        <p:spPr>
          <a:xfrm>
            <a:off x="5218017" y="2787248"/>
            <a:ext cx="825867" cy="215444"/>
          </a:xfrm>
          <a:prstGeom prst="rect">
            <a:avLst/>
          </a:prstGeom>
          <a:noFill/>
        </p:spPr>
        <p:txBody>
          <a:bodyPr wrap="none" rtlCol="0">
            <a:spAutoFit/>
          </a:bodyPr>
          <a:lstStyle/>
          <a:p>
            <a:r>
              <a:rPr lang="it-IT" sz="800" dirty="0" err="1" smtClean="0">
                <a:latin typeface="Arial" panose="020B0604020202020204" pitchFamily="34" charset="0"/>
                <a:cs typeface="Arial" panose="020B0604020202020204" pitchFamily="34" charset="0"/>
              </a:rPr>
              <a:t>Slope</a:t>
            </a:r>
            <a:r>
              <a:rPr lang="it-IT" sz="800" dirty="0" smtClean="0">
                <a:latin typeface="Arial" panose="020B0604020202020204" pitchFamily="34" charset="0"/>
                <a:cs typeface="Arial" panose="020B0604020202020204" pitchFamily="34" charset="0"/>
              </a:rPr>
              <a:t>=1.0940</a:t>
            </a:r>
            <a:endParaRPr lang="it-IT" sz="800" dirty="0">
              <a:latin typeface="Arial" panose="020B0604020202020204" pitchFamily="34" charset="0"/>
              <a:cs typeface="Arial" panose="020B0604020202020204" pitchFamily="34" charset="0"/>
            </a:endParaRPr>
          </a:p>
        </p:txBody>
      </p:sp>
      <p:grpSp>
        <p:nvGrpSpPr>
          <p:cNvPr id="246" name="Gruppo 245"/>
          <p:cNvGrpSpPr/>
          <p:nvPr/>
        </p:nvGrpSpPr>
        <p:grpSpPr>
          <a:xfrm>
            <a:off x="3715332" y="172635"/>
            <a:ext cx="2519659" cy="2363959"/>
            <a:chOff x="3715332" y="595276"/>
            <a:chExt cx="2519659" cy="2363959"/>
          </a:xfrm>
        </p:grpSpPr>
        <p:pic>
          <p:nvPicPr>
            <p:cNvPr id="213" name="Picture 7"/>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b="20294"/>
            <a:stretch/>
          </p:blipFill>
          <p:spPr bwMode="auto">
            <a:xfrm>
              <a:off x="3904931" y="768379"/>
              <a:ext cx="1305997" cy="10341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14" name="Picture 8"/>
            <p:cNvPicPr>
              <a:picLocks noChangeAspect="1" noChangeArrowheads="1"/>
            </p:cNvPicPr>
            <p:nvPr/>
          </p:nvPicPr>
          <p:blipFill rotWithShape="1">
            <a:blip r:embed="rId6" cstate="print">
              <a:extLst>
                <a:ext uri="{28A0092B-C50C-407E-A947-70E740481C1C}">
                  <a14:useLocalDpi xmlns:a14="http://schemas.microsoft.com/office/drawing/2010/main" val="0"/>
                </a:ext>
              </a:extLst>
            </a:blip>
            <a:srcRect b="12112"/>
            <a:stretch/>
          </p:blipFill>
          <p:spPr bwMode="auto">
            <a:xfrm>
              <a:off x="3904931" y="1675128"/>
              <a:ext cx="1305997" cy="114028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cxnSp>
          <p:nvCxnSpPr>
            <p:cNvPr id="215" name="Connettore 1 55"/>
            <p:cNvCxnSpPr/>
            <p:nvPr/>
          </p:nvCxnSpPr>
          <p:spPr>
            <a:xfrm>
              <a:off x="4776769" y="866761"/>
              <a:ext cx="0" cy="1800194"/>
            </a:xfrm>
            <a:prstGeom prst="line">
              <a:avLst/>
            </a:prstGeom>
            <a:ln w="12700">
              <a:solidFill>
                <a:schemeClr val="tx1"/>
              </a:solidFill>
              <a:prstDash val="dash"/>
            </a:ln>
          </p:spPr>
          <p:style>
            <a:lnRef idx="1">
              <a:schemeClr val="accent1"/>
            </a:lnRef>
            <a:fillRef idx="0">
              <a:schemeClr val="accent1"/>
            </a:fillRef>
            <a:effectRef idx="0">
              <a:schemeClr val="accent1"/>
            </a:effectRef>
            <a:fontRef idx="minor">
              <a:schemeClr val="tx1"/>
            </a:fontRef>
          </p:style>
        </p:cxnSp>
        <p:grpSp>
          <p:nvGrpSpPr>
            <p:cNvPr id="216" name="Gruppo 215"/>
            <p:cNvGrpSpPr/>
            <p:nvPr/>
          </p:nvGrpSpPr>
          <p:grpSpPr>
            <a:xfrm>
              <a:off x="4237459" y="1048291"/>
              <a:ext cx="827583" cy="587020"/>
              <a:chOff x="6021188" y="310668"/>
              <a:chExt cx="918519" cy="651521"/>
            </a:xfrm>
          </p:grpSpPr>
          <p:sp>
            <p:nvSpPr>
              <p:cNvPr id="235" name="CasellaDiTesto 234"/>
              <p:cNvSpPr txBox="1"/>
              <p:nvPr/>
            </p:nvSpPr>
            <p:spPr>
              <a:xfrm>
                <a:off x="6021188" y="368613"/>
                <a:ext cx="651522" cy="239117"/>
              </a:xfrm>
              <a:prstGeom prst="rect">
                <a:avLst/>
              </a:prstGeom>
              <a:noFill/>
            </p:spPr>
            <p:txBody>
              <a:bodyPr wrap="none" rtlCol="0">
                <a:spAutoFit/>
              </a:bodyPr>
              <a:lstStyle/>
              <a:p>
                <a:r>
                  <a:rPr lang="it-IT" sz="800" dirty="0" smtClean="0">
                    <a:latin typeface="Arial" panose="020B0604020202020204" pitchFamily="34" charset="0"/>
                    <a:cs typeface="Arial" panose="020B0604020202020204" pitchFamily="34" charset="0"/>
                  </a:rPr>
                  <a:t>EO body</a:t>
                </a:r>
                <a:endParaRPr lang="it-IT" sz="800" dirty="0">
                  <a:latin typeface="Arial" panose="020B0604020202020204" pitchFamily="34" charset="0"/>
                  <a:cs typeface="Arial" panose="020B0604020202020204" pitchFamily="34" charset="0"/>
                </a:endParaRPr>
              </a:p>
            </p:txBody>
          </p:sp>
          <p:sp>
            <p:nvSpPr>
              <p:cNvPr id="236" name="CasellaDiTesto 235"/>
              <p:cNvSpPr txBox="1"/>
              <p:nvPr/>
            </p:nvSpPr>
            <p:spPr>
              <a:xfrm rot="5400000">
                <a:off x="6494388" y="516870"/>
                <a:ext cx="651521" cy="239117"/>
              </a:xfrm>
              <a:prstGeom prst="rect">
                <a:avLst/>
              </a:prstGeom>
              <a:noFill/>
            </p:spPr>
            <p:txBody>
              <a:bodyPr wrap="none" rtlCol="0">
                <a:spAutoFit/>
              </a:bodyPr>
              <a:lstStyle/>
              <a:p>
                <a:r>
                  <a:rPr lang="it-IT" sz="800" dirty="0" err="1" smtClean="0">
                    <a:latin typeface="Arial" panose="020B0604020202020204" pitchFamily="34" charset="0"/>
                    <a:cs typeface="Arial" panose="020B0604020202020204" pitchFamily="34" charset="0"/>
                  </a:rPr>
                  <a:t>Synapse</a:t>
                </a:r>
                <a:endParaRPr lang="it-IT" sz="800" dirty="0">
                  <a:latin typeface="Arial" panose="020B0604020202020204" pitchFamily="34" charset="0"/>
                  <a:cs typeface="Arial" panose="020B0604020202020204" pitchFamily="34" charset="0"/>
                </a:endParaRPr>
              </a:p>
            </p:txBody>
          </p:sp>
        </p:grpSp>
        <p:grpSp>
          <p:nvGrpSpPr>
            <p:cNvPr id="217" name="Gruppo 216"/>
            <p:cNvGrpSpPr/>
            <p:nvPr/>
          </p:nvGrpSpPr>
          <p:grpSpPr>
            <a:xfrm>
              <a:off x="4237459" y="1922706"/>
              <a:ext cx="827583" cy="587020"/>
              <a:chOff x="6021188" y="310668"/>
              <a:chExt cx="918519" cy="651521"/>
            </a:xfrm>
          </p:grpSpPr>
          <p:sp>
            <p:nvSpPr>
              <p:cNvPr id="233" name="CasellaDiTesto 232"/>
              <p:cNvSpPr txBox="1"/>
              <p:nvPr/>
            </p:nvSpPr>
            <p:spPr>
              <a:xfrm>
                <a:off x="6021188" y="368613"/>
                <a:ext cx="651522" cy="239117"/>
              </a:xfrm>
              <a:prstGeom prst="rect">
                <a:avLst/>
              </a:prstGeom>
              <a:noFill/>
            </p:spPr>
            <p:txBody>
              <a:bodyPr wrap="none" rtlCol="0">
                <a:spAutoFit/>
              </a:bodyPr>
              <a:lstStyle/>
              <a:p>
                <a:r>
                  <a:rPr lang="it-IT" sz="800" dirty="0" smtClean="0">
                    <a:latin typeface="Arial" panose="020B0604020202020204" pitchFamily="34" charset="0"/>
                    <a:cs typeface="Arial" panose="020B0604020202020204" pitchFamily="34" charset="0"/>
                  </a:rPr>
                  <a:t>EO body</a:t>
                </a:r>
                <a:endParaRPr lang="it-IT" sz="800" dirty="0">
                  <a:latin typeface="Arial" panose="020B0604020202020204" pitchFamily="34" charset="0"/>
                  <a:cs typeface="Arial" panose="020B0604020202020204" pitchFamily="34" charset="0"/>
                </a:endParaRPr>
              </a:p>
            </p:txBody>
          </p:sp>
          <p:sp>
            <p:nvSpPr>
              <p:cNvPr id="234" name="CasellaDiTesto 233"/>
              <p:cNvSpPr txBox="1"/>
              <p:nvPr/>
            </p:nvSpPr>
            <p:spPr>
              <a:xfrm rot="5400000">
                <a:off x="6494388" y="516870"/>
                <a:ext cx="651521" cy="239117"/>
              </a:xfrm>
              <a:prstGeom prst="rect">
                <a:avLst/>
              </a:prstGeom>
              <a:noFill/>
            </p:spPr>
            <p:txBody>
              <a:bodyPr wrap="none" rtlCol="0">
                <a:spAutoFit/>
              </a:bodyPr>
              <a:lstStyle/>
              <a:p>
                <a:r>
                  <a:rPr lang="it-IT" sz="800" dirty="0" err="1" smtClean="0">
                    <a:latin typeface="Arial" panose="020B0604020202020204" pitchFamily="34" charset="0"/>
                    <a:cs typeface="Arial" panose="020B0604020202020204" pitchFamily="34" charset="0"/>
                  </a:rPr>
                  <a:t>Synapse</a:t>
                </a:r>
                <a:endParaRPr lang="it-IT" sz="800" dirty="0">
                  <a:latin typeface="Arial" panose="020B0604020202020204" pitchFamily="34" charset="0"/>
                  <a:cs typeface="Arial" panose="020B0604020202020204" pitchFamily="34" charset="0"/>
                </a:endParaRPr>
              </a:p>
            </p:txBody>
          </p:sp>
        </p:grpSp>
        <p:sp>
          <p:nvSpPr>
            <p:cNvPr id="218" name="CasellaDiTesto 217"/>
            <p:cNvSpPr txBox="1"/>
            <p:nvPr/>
          </p:nvSpPr>
          <p:spPr>
            <a:xfrm rot="16200000">
              <a:off x="3604244" y="1193132"/>
              <a:ext cx="468398" cy="246221"/>
            </a:xfrm>
            <a:prstGeom prst="rect">
              <a:avLst/>
            </a:prstGeom>
            <a:noFill/>
          </p:spPr>
          <p:txBody>
            <a:bodyPr wrap="none" rtlCol="0">
              <a:spAutoFit/>
            </a:bodyPr>
            <a:lstStyle/>
            <a:p>
              <a:r>
                <a:rPr lang="it-IT" sz="1000" dirty="0" err="1" smtClean="0">
                  <a:latin typeface="Arial" panose="020B0604020202020204" pitchFamily="34" charset="0"/>
                  <a:cs typeface="Arial" panose="020B0604020202020204" pitchFamily="34" charset="0"/>
                </a:rPr>
                <a:t>Actin</a:t>
              </a:r>
              <a:endParaRPr lang="it-IT" sz="1000" dirty="0">
                <a:latin typeface="Arial" panose="020B0604020202020204" pitchFamily="34" charset="0"/>
                <a:cs typeface="Arial" panose="020B0604020202020204" pitchFamily="34" charset="0"/>
              </a:endParaRPr>
            </a:p>
          </p:txBody>
        </p:sp>
        <p:sp>
          <p:nvSpPr>
            <p:cNvPr id="219" name="CasellaDiTesto 218"/>
            <p:cNvSpPr txBox="1"/>
            <p:nvPr/>
          </p:nvSpPr>
          <p:spPr>
            <a:xfrm rot="16200000">
              <a:off x="3618671" y="2076610"/>
              <a:ext cx="439544" cy="246221"/>
            </a:xfrm>
            <a:prstGeom prst="rect">
              <a:avLst/>
            </a:prstGeom>
            <a:noFill/>
          </p:spPr>
          <p:txBody>
            <a:bodyPr wrap="none" rtlCol="0">
              <a:spAutoFit/>
            </a:bodyPr>
            <a:lstStyle/>
            <a:p>
              <a:pPr algn="ctr"/>
              <a:r>
                <a:rPr lang="it-IT" sz="1000" dirty="0" smtClean="0">
                  <a:latin typeface="Arial" panose="020B0604020202020204" pitchFamily="34" charset="0"/>
                  <a:cs typeface="Arial" panose="020B0604020202020204" pitchFamily="34" charset="0"/>
                </a:rPr>
                <a:t>EPX</a:t>
              </a:r>
              <a:endParaRPr lang="it-IT" sz="1000" dirty="0">
                <a:latin typeface="Arial" panose="020B0604020202020204" pitchFamily="34" charset="0"/>
                <a:cs typeface="Arial" panose="020B0604020202020204" pitchFamily="34" charset="0"/>
              </a:endParaRPr>
            </a:p>
          </p:txBody>
        </p:sp>
        <p:sp>
          <p:nvSpPr>
            <p:cNvPr id="221" name="CasellaDiTesto 220"/>
            <p:cNvSpPr txBox="1"/>
            <p:nvPr/>
          </p:nvSpPr>
          <p:spPr>
            <a:xfrm>
              <a:off x="4109353" y="595276"/>
              <a:ext cx="1066938" cy="246221"/>
            </a:xfrm>
            <a:prstGeom prst="rect">
              <a:avLst/>
            </a:prstGeom>
            <a:noFill/>
          </p:spPr>
          <p:txBody>
            <a:bodyPr wrap="square" rtlCol="0">
              <a:spAutoFit/>
            </a:bodyPr>
            <a:lstStyle/>
            <a:p>
              <a:pPr algn="ctr"/>
              <a:r>
                <a:rPr lang="it-IT" sz="1000" dirty="0" smtClean="0">
                  <a:latin typeface="Arial" panose="020B0604020202020204" pitchFamily="34" charset="0"/>
                  <a:cs typeface="Arial" panose="020B0604020202020204" pitchFamily="34" charset="0"/>
                </a:rPr>
                <a:t>B16/IL-5 EO</a:t>
              </a:r>
              <a:endParaRPr lang="it-IT" sz="1000" dirty="0">
                <a:latin typeface="Arial" panose="020B0604020202020204" pitchFamily="34" charset="0"/>
                <a:cs typeface="Arial" panose="020B0604020202020204" pitchFamily="34" charset="0"/>
              </a:endParaRPr>
            </a:p>
          </p:txBody>
        </p:sp>
        <p:pic>
          <p:nvPicPr>
            <p:cNvPr id="223" name="Picture 9"/>
            <p:cNvPicPr>
              <a:picLocks noChangeArrowheads="1"/>
            </p:cNvPicPr>
            <p:nvPr/>
          </p:nvPicPr>
          <p:blipFill rotWithShape="1">
            <a:blip r:embed="rId7" cstate="print">
              <a:extLst>
                <a:ext uri="{28A0092B-C50C-407E-A947-70E740481C1C}">
                  <a14:useLocalDpi xmlns:a14="http://schemas.microsoft.com/office/drawing/2010/main" val="0"/>
                </a:ext>
              </a:extLst>
            </a:blip>
            <a:srcRect l="10134" b="17736"/>
            <a:stretch/>
          </p:blipFill>
          <p:spPr bwMode="auto">
            <a:xfrm>
              <a:off x="5065298" y="762968"/>
              <a:ext cx="1165954" cy="105092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24" name="Picture 10"/>
            <p:cNvPicPr>
              <a:picLocks noChangeArrowheads="1"/>
            </p:cNvPicPr>
            <p:nvPr/>
          </p:nvPicPr>
          <p:blipFill rotWithShape="1">
            <a:blip r:embed="rId8" cstate="print">
              <a:extLst>
                <a:ext uri="{28A0092B-C50C-407E-A947-70E740481C1C}">
                  <a14:useLocalDpi xmlns:a14="http://schemas.microsoft.com/office/drawing/2010/main" val="0"/>
                </a:ext>
              </a:extLst>
            </a:blip>
            <a:srcRect l="10134" b="10277"/>
            <a:stretch/>
          </p:blipFill>
          <p:spPr bwMode="auto">
            <a:xfrm>
              <a:off x="5065298" y="1674595"/>
              <a:ext cx="1165954" cy="114082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cxnSp>
          <p:nvCxnSpPr>
            <p:cNvPr id="225" name="Connettore 1 75"/>
            <p:cNvCxnSpPr/>
            <p:nvPr/>
          </p:nvCxnSpPr>
          <p:spPr>
            <a:xfrm>
              <a:off x="5736598" y="873438"/>
              <a:ext cx="0" cy="1816412"/>
            </a:xfrm>
            <a:prstGeom prst="line">
              <a:avLst/>
            </a:prstGeom>
            <a:ln w="12700">
              <a:solidFill>
                <a:schemeClr val="tx1"/>
              </a:solidFill>
              <a:prstDash val="dash"/>
            </a:ln>
          </p:spPr>
          <p:style>
            <a:lnRef idx="1">
              <a:schemeClr val="accent1"/>
            </a:lnRef>
            <a:fillRef idx="0">
              <a:schemeClr val="accent1"/>
            </a:fillRef>
            <a:effectRef idx="0">
              <a:schemeClr val="accent1"/>
            </a:effectRef>
            <a:fontRef idx="minor">
              <a:schemeClr val="tx1"/>
            </a:fontRef>
          </p:style>
        </p:cxnSp>
        <p:grpSp>
          <p:nvGrpSpPr>
            <p:cNvPr id="226" name="Gruppo 225"/>
            <p:cNvGrpSpPr/>
            <p:nvPr/>
          </p:nvGrpSpPr>
          <p:grpSpPr>
            <a:xfrm>
              <a:off x="5221861" y="877432"/>
              <a:ext cx="861635" cy="587020"/>
              <a:chOff x="6030462" y="310668"/>
              <a:chExt cx="956312" cy="651521"/>
            </a:xfrm>
          </p:grpSpPr>
          <p:sp>
            <p:nvSpPr>
              <p:cNvPr id="231" name="CasellaDiTesto 230"/>
              <p:cNvSpPr txBox="1"/>
              <p:nvPr/>
            </p:nvSpPr>
            <p:spPr>
              <a:xfrm>
                <a:off x="6030462" y="368613"/>
                <a:ext cx="651522" cy="239117"/>
              </a:xfrm>
              <a:prstGeom prst="rect">
                <a:avLst/>
              </a:prstGeom>
              <a:noFill/>
            </p:spPr>
            <p:txBody>
              <a:bodyPr wrap="none" rtlCol="0">
                <a:spAutoFit/>
              </a:bodyPr>
              <a:lstStyle/>
              <a:p>
                <a:r>
                  <a:rPr lang="it-IT" sz="800" dirty="0" smtClean="0">
                    <a:latin typeface="Arial" panose="020B0604020202020204" pitchFamily="34" charset="0"/>
                    <a:cs typeface="Arial" panose="020B0604020202020204" pitchFamily="34" charset="0"/>
                  </a:rPr>
                  <a:t>EO body</a:t>
                </a:r>
                <a:endParaRPr lang="it-IT" sz="800" dirty="0">
                  <a:latin typeface="Arial" panose="020B0604020202020204" pitchFamily="34" charset="0"/>
                  <a:cs typeface="Arial" panose="020B0604020202020204" pitchFamily="34" charset="0"/>
                </a:endParaRPr>
              </a:p>
            </p:txBody>
          </p:sp>
          <p:sp>
            <p:nvSpPr>
              <p:cNvPr id="232" name="CasellaDiTesto 231"/>
              <p:cNvSpPr txBox="1"/>
              <p:nvPr/>
            </p:nvSpPr>
            <p:spPr>
              <a:xfrm rot="5400000">
                <a:off x="6541455" y="516870"/>
                <a:ext cx="651521" cy="239117"/>
              </a:xfrm>
              <a:prstGeom prst="rect">
                <a:avLst/>
              </a:prstGeom>
              <a:noFill/>
            </p:spPr>
            <p:txBody>
              <a:bodyPr wrap="none" rtlCol="0">
                <a:spAutoFit/>
              </a:bodyPr>
              <a:lstStyle/>
              <a:p>
                <a:r>
                  <a:rPr lang="it-IT" sz="800" dirty="0" err="1" smtClean="0">
                    <a:latin typeface="Arial" panose="020B0604020202020204" pitchFamily="34" charset="0"/>
                    <a:cs typeface="Arial" panose="020B0604020202020204" pitchFamily="34" charset="0"/>
                  </a:rPr>
                  <a:t>Synapse</a:t>
                </a:r>
                <a:endParaRPr lang="it-IT" sz="800" dirty="0">
                  <a:latin typeface="Arial" panose="020B0604020202020204" pitchFamily="34" charset="0"/>
                  <a:cs typeface="Arial" panose="020B0604020202020204" pitchFamily="34" charset="0"/>
                </a:endParaRPr>
              </a:p>
            </p:txBody>
          </p:sp>
        </p:grpSp>
        <p:grpSp>
          <p:nvGrpSpPr>
            <p:cNvPr id="227" name="Gruppo 226"/>
            <p:cNvGrpSpPr/>
            <p:nvPr/>
          </p:nvGrpSpPr>
          <p:grpSpPr>
            <a:xfrm>
              <a:off x="5221861" y="1798862"/>
              <a:ext cx="861635" cy="587020"/>
              <a:chOff x="6030462" y="310668"/>
              <a:chExt cx="956312" cy="651521"/>
            </a:xfrm>
          </p:grpSpPr>
          <p:sp>
            <p:nvSpPr>
              <p:cNvPr id="229" name="CasellaDiTesto 228"/>
              <p:cNvSpPr txBox="1"/>
              <p:nvPr/>
            </p:nvSpPr>
            <p:spPr>
              <a:xfrm>
                <a:off x="6030462" y="368613"/>
                <a:ext cx="651522" cy="239117"/>
              </a:xfrm>
              <a:prstGeom prst="rect">
                <a:avLst/>
              </a:prstGeom>
              <a:noFill/>
            </p:spPr>
            <p:txBody>
              <a:bodyPr wrap="none" rtlCol="0">
                <a:spAutoFit/>
              </a:bodyPr>
              <a:lstStyle/>
              <a:p>
                <a:r>
                  <a:rPr lang="it-IT" sz="800" dirty="0" smtClean="0">
                    <a:latin typeface="Arial" panose="020B0604020202020204" pitchFamily="34" charset="0"/>
                    <a:cs typeface="Arial" panose="020B0604020202020204" pitchFamily="34" charset="0"/>
                  </a:rPr>
                  <a:t>EO body</a:t>
                </a:r>
                <a:endParaRPr lang="it-IT" sz="800" dirty="0">
                  <a:latin typeface="Arial" panose="020B0604020202020204" pitchFamily="34" charset="0"/>
                  <a:cs typeface="Arial" panose="020B0604020202020204" pitchFamily="34" charset="0"/>
                </a:endParaRPr>
              </a:p>
            </p:txBody>
          </p:sp>
          <p:sp>
            <p:nvSpPr>
              <p:cNvPr id="230" name="CasellaDiTesto 229"/>
              <p:cNvSpPr txBox="1"/>
              <p:nvPr/>
            </p:nvSpPr>
            <p:spPr>
              <a:xfrm rot="5400000">
                <a:off x="6541455" y="516870"/>
                <a:ext cx="651521" cy="239117"/>
              </a:xfrm>
              <a:prstGeom prst="rect">
                <a:avLst/>
              </a:prstGeom>
              <a:noFill/>
            </p:spPr>
            <p:txBody>
              <a:bodyPr wrap="none" rtlCol="0">
                <a:spAutoFit/>
              </a:bodyPr>
              <a:lstStyle/>
              <a:p>
                <a:r>
                  <a:rPr lang="it-IT" sz="800" dirty="0" err="1" smtClean="0">
                    <a:latin typeface="Arial" panose="020B0604020202020204" pitchFamily="34" charset="0"/>
                    <a:cs typeface="Arial" panose="020B0604020202020204" pitchFamily="34" charset="0"/>
                  </a:rPr>
                  <a:t>Synapse</a:t>
                </a:r>
                <a:endParaRPr lang="it-IT" sz="800" dirty="0">
                  <a:latin typeface="Arial" panose="020B0604020202020204" pitchFamily="34" charset="0"/>
                  <a:cs typeface="Arial" panose="020B0604020202020204" pitchFamily="34" charset="0"/>
                </a:endParaRPr>
              </a:p>
            </p:txBody>
          </p:sp>
        </p:grpSp>
        <p:sp>
          <p:nvSpPr>
            <p:cNvPr id="228" name="CasellaDiTesto 227"/>
            <p:cNvSpPr txBox="1"/>
            <p:nvPr/>
          </p:nvSpPr>
          <p:spPr>
            <a:xfrm>
              <a:off x="5055245" y="603097"/>
              <a:ext cx="1179746" cy="246221"/>
            </a:xfrm>
            <a:prstGeom prst="rect">
              <a:avLst/>
            </a:prstGeom>
            <a:noFill/>
          </p:spPr>
          <p:txBody>
            <a:bodyPr wrap="square" rtlCol="0">
              <a:spAutoFit/>
            </a:bodyPr>
            <a:lstStyle/>
            <a:p>
              <a:pPr algn="ctr"/>
              <a:r>
                <a:rPr lang="it-IT" sz="1000" smtClean="0">
                  <a:latin typeface="Arial" panose="020B0604020202020204" pitchFamily="34" charset="0"/>
                  <a:cs typeface="Arial" panose="020B0604020202020204" pitchFamily="34" charset="0"/>
                </a:rPr>
                <a:t>B16/IL-33 </a:t>
              </a:r>
              <a:r>
                <a:rPr lang="it-IT" sz="1000" dirty="0" smtClean="0">
                  <a:latin typeface="Arial" panose="020B0604020202020204" pitchFamily="34" charset="0"/>
                  <a:cs typeface="Arial" panose="020B0604020202020204" pitchFamily="34" charset="0"/>
                </a:rPr>
                <a:t>EO</a:t>
              </a:r>
              <a:endParaRPr lang="it-IT" sz="1000" dirty="0">
                <a:latin typeface="Arial" panose="020B0604020202020204" pitchFamily="34" charset="0"/>
                <a:cs typeface="Arial" panose="020B0604020202020204" pitchFamily="34" charset="0"/>
              </a:endParaRPr>
            </a:p>
          </p:txBody>
        </p:sp>
        <p:sp>
          <p:nvSpPr>
            <p:cNvPr id="161" name="CasellaDiTesto 160"/>
            <p:cNvSpPr txBox="1"/>
            <p:nvPr/>
          </p:nvSpPr>
          <p:spPr>
            <a:xfrm>
              <a:off x="3803325" y="2743791"/>
              <a:ext cx="2380780" cy="215444"/>
            </a:xfrm>
            <a:prstGeom prst="rect">
              <a:avLst/>
            </a:prstGeom>
            <a:noFill/>
          </p:spPr>
          <p:txBody>
            <a:bodyPr wrap="none" rtlCol="0">
              <a:spAutoFit/>
            </a:bodyPr>
            <a:lstStyle/>
            <a:p>
              <a:r>
                <a:rPr lang="it-IT" sz="800" dirty="0" smtClean="0">
                  <a:latin typeface="Arial" panose="020B0604020202020204" pitchFamily="34" charset="0"/>
                  <a:cs typeface="Arial" panose="020B0604020202020204" pitchFamily="34" charset="0"/>
                </a:rPr>
                <a:t>X </a:t>
              </a:r>
              <a:r>
                <a:rPr lang="it-IT" sz="800" dirty="0" err="1" smtClean="0">
                  <a:latin typeface="Arial" panose="020B0604020202020204" pitchFamily="34" charset="0"/>
                  <a:cs typeface="Arial" panose="020B0604020202020204" pitchFamily="34" charset="0"/>
                </a:rPr>
                <a:t>axis</a:t>
              </a:r>
              <a:r>
                <a:rPr lang="it-IT" sz="800" dirty="0" smtClean="0">
                  <a:latin typeface="Arial" panose="020B0604020202020204" pitchFamily="34" charset="0"/>
                  <a:cs typeface="Arial" panose="020B0604020202020204" pitchFamily="34" charset="0"/>
                </a:rPr>
                <a:t> position on </a:t>
              </a:r>
              <a:r>
                <a:rPr lang="it-IT" sz="800" dirty="0" err="1" smtClean="0">
                  <a:latin typeface="Arial" panose="020B0604020202020204" pitchFamily="34" charset="0"/>
                  <a:cs typeface="Arial" panose="020B0604020202020204" pitchFamily="34" charset="0"/>
                </a:rPr>
                <a:t>Fluorescence</a:t>
              </a:r>
              <a:r>
                <a:rPr lang="it-IT" sz="800" dirty="0" smtClean="0">
                  <a:latin typeface="Arial" panose="020B0604020202020204" pitchFamily="34" charset="0"/>
                  <a:cs typeface="Arial" panose="020B0604020202020204" pitchFamily="34" charset="0"/>
                </a:rPr>
                <a:t> </a:t>
              </a:r>
              <a:r>
                <a:rPr lang="it-IT" sz="800" dirty="0" err="1" smtClean="0">
                  <a:latin typeface="Arial" panose="020B0604020202020204" pitchFamily="34" charset="0"/>
                  <a:cs typeface="Arial" panose="020B0604020202020204" pitchFamily="34" charset="0"/>
                </a:rPr>
                <a:t>profile</a:t>
              </a:r>
              <a:r>
                <a:rPr lang="it-IT" sz="800" dirty="0" smtClean="0">
                  <a:latin typeface="Arial" panose="020B0604020202020204" pitchFamily="34" charset="0"/>
                  <a:cs typeface="Arial" panose="020B0604020202020204" pitchFamily="34" charset="0"/>
                </a:rPr>
                <a:t> line (</a:t>
              </a:r>
              <a:r>
                <a:rPr lang="it-IT" sz="800" dirty="0" smtClean="0">
                  <a:latin typeface="Symbol" panose="05050102010706020507" pitchFamily="18" charset="2"/>
                  <a:cs typeface="Arial" panose="020B0604020202020204" pitchFamily="34" charset="0"/>
                </a:rPr>
                <a:t>m</a:t>
              </a:r>
              <a:r>
                <a:rPr lang="it-IT" sz="800" dirty="0" smtClean="0">
                  <a:latin typeface="Arial" panose="020B0604020202020204" pitchFamily="34" charset="0"/>
                  <a:cs typeface="Arial" panose="020B0604020202020204" pitchFamily="34" charset="0"/>
                </a:rPr>
                <a:t>m)</a:t>
              </a:r>
              <a:endParaRPr lang="it-IT" sz="800" dirty="0">
                <a:latin typeface="Arial" panose="020B0604020202020204" pitchFamily="34" charset="0"/>
                <a:cs typeface="Arial" panose="020B0604020202020204" pitchFamily="34" charset="0"/>
              </a:endParaRPr>
            </a:p>
          </p:txBody>
        </p:sp>
      </p:grpSp>
      <p:sp>
        <p:nvSpPr>
          <p:cNvPr id="165" name="CasellaDiTesto 164"/>
          <p:cNvSpPr txBox="1"/>
          <p:nvPr/>
        </p:nvSpPr>
        <p:spPr>
          <a:xfrm>
            <a:off x="3786755" y="3798432"/>
            <a:ext cx="2406428" cy="215444"/>
          </a:xfrm>
          <a:prstGeom prst="rect">
            <a:avLst/>
          </a:prstGeom>
          <a:noFill/>
        </p:spPr>
        <p:txBody>
          <a:bodyPr wrap="none" rtlCol="0">
            <a:spAutoFit/>
          </a:bodyPr>
          <a:lstStyle>
            <a:defPPr>
              <a:defRPr lang="it-IT"/>
            </a:defPPr>
            <a:lvl1pPr>
              <a:defRPr sz="800">
                <a:latin typeface="Arial" panose="020B0604020202020204" pitchFamily="34" charset="0"/>
                <a:cs typeface="Arial" panose="020B0604020202020204" pitchFamily="34" charset="0"/>
              </a:defRPr>
            </a:lvl1pPr>
          </a:lstStyle>
          <a:p>
            <a:r>
              <a:rPr lang="it-IT" dirty="0"/>
              <a:t>X </a:t>
            </a:r>
            <a:r>
              <a:rPr lang="it-IT" dirty="0" err="1"/>
              <a:t>axis</a:t>
            </a:r>
            <a:r>
              <a:rPr lang="it-IT" dirty="0"/>
              <a:t> position on </a:t>
            </a:r>
            <a:r>
              <a:rPr lang="it-IT" dirty="0" err="1"/>
              <a:t>Fluorescence</a:t>
            </a:r>
            <a:r>
              <a:rPr lang="it-IT" dirty="0"/>
              <a:t> </a:t>
            </a:r>
            <a:r>
              <a:rPr lang="it-IT" dirty="0" err="1"/>
              <a:t>profile</a:t>
            </a:r>
            <a:r>
              <a:rPr lang="it-IT" dirty="0"/>
              <a:t> line </a:t>
            </a:r>
            <a:r>
              <a:rPr lang="it-IT" dirty="0" smtClean="0"/>
              <a:t>(µm</a:t>
            </a:r>
            <a:r>
              <a:rPr lang="it-IT" dirty="0"/>
              <a:t>)</a:t>
            </a:r>
          </a:p>
        </p:txBody>
      </p:sp>
      <p:grpSp>
        <p:nvGrpSpPr>
          <p:cNvPr id="239" name="Gruppo 238"/>
          <p:cNvGrpSpPr/>
          <p:nvPr/>
        </p:nvGrpSpPr>
        <p:grpSpPr>
          <a:xfrm>
            <a:off x="24852" y="174646"/>
            <a:ext cx="3594090" cy="2778426"/>
            <a:chOff x="93092" y="396279"/>
            <a:chExt cx="3594090" cy="2778426"/>
          </a:xfrm>
        </p:grpSpPr>
        <p:sp>
          <p:nvSpPr>
            <p:cNvPr id="152" name="CasellaDiTesto 151"/>
            <p:cNvSpPr txBox="1"/>
            <p:nvPr/>
          </p:nvSpPr>
          <p:spPr>
            <a:xfrm>
              <a:off x="667250" y="412840"/>
              <a:ext cx="437861" cy="196207"/>
            </a:xfrm>
            <a:prstGeom prst="rect">
              <a:avLst/>
            </a:prstGeom>
            <a:noFill/>
          </p:spPr>
          <p:txBody>
            <a:bodyPr wrap="none" rtlCol="0">
              <a:spAutoFit/>
            </a:bodyPr>
            <a:lstStyle/>
            <a:p>
              <a:pPr algn="ctr"/>
              <a:r>
                <a:rPr lang="it-IT" sz="1100" dirty="0" smtClean="0">
                  <a:latin typeface="Arial" panose="020B0604020202020204" pitchFamily="34" charset="0"/>
                  <a:cs typeface="Arial" panose="020B0604020202020204" pitchFamily="34" charset="0"/>
                </a:rPr>
                <a:t>Merge</a:t>
              </a:r>
              <a:endParaRPr lang="it-IT" sz="1100" dirty="0">
                <a:latin typeface="Arial" panose="020B0604020202020204" pitchFamily="34" charset="0"/>
                <a:cs typeface="Arial" panose="020B0604020202020204" pitchFamily="34" charset="0"/>
              </a:endParaRPr>
            </a:p>
          </p:txBody>
        </p:sp>
        <p:sp>
          <p:nvSpPr>
            <p:cNvPr id="153" name="CasellaDiTesto 152"/>
            <p:cNvSpPr txBox="1"/>
            <p:nvPr/>
          </p:nvSpPr>
          <p:spPr>
            <a:xfrm>
              <a:off x="1468682" y="645821"/>
              <a:ext cx="354905" cy="173124"/>
            </a:xfrm>
            <a:prstGeom prst="rect">
              <a:avLst/>
            </a:prstGeom>
            <a:noFill/>
          </p:spPr>
          <p:txBody>
            <a:bodyPr wrap="none" rtlCol="0">
              <a:spAutoFit/>
            </a:bodyPr>
            <a:lstStyle/>
            <a:p>
              <a:r>
                <a:rPr lang="it-IT" sz="900" b="1" dirty="0" err="1" smtClean="0">
                  <a:solidFill>
                    <a:srgbClr val="FF0000"/>
                  </a:solidFill>
                  <a:latin typeface="Arial" panose="020B0604020202020204" pitchFamily="34" charset="0"/>
                  <a:cs typeface="Arial" panose="020B0604020202020204" pitchFamily="34" charset="0"/>
                </a:rPr>
                <a:t>Actin</a:t>
              </a:r>
              <a:endParaRPr lang="it-IT" sz="900" b="1" dirty="0">
                <a:solidFill>
                  <a:srgbClr val="FF0000"/>
                </a:solidFill>
                <a:latin typeface="Arial" panose="020B0604020202020204" pitchFamily="34" charset="0"/>
                <a:cs typeface="Arial" panose="020B0604020202020204" pitchFamily="34" charset="0"/>
              </a:endParaRPr>
            </a:p>
          </p:txBody>
        </p:sp>
        <p:sp>
          <p:nvSpPr>
            <p:cNvPr id="154" name="CasellaDiTesto 153"/>
            <p:cNvSpPr txBox="1"/>
            <p:nvPr/>
          </p:nvSpPr>
          <p:spPr>
            <a:xfrm>
              <a:off x="2587622" y="645497"/>
              <a:ext cx="311624" cy="173124"/>
            </a:xfrm>
            <a:prstGeom prst="rect">
              <a:avLst/>
            </a:prstGeom>
            <a:noFill/>
          </p:spPr>
          <p:txBody>
            <a:bodyPr wrap="none" rtlCol="0">
              <a:spAutoFit/>
            </a:bodyPr>
            <a:lstStyle/>
            <a:p>
              <a:r>
                <a:rPr lang="it-IT" sz="900" b="1" dirty="0" smtClean="0">
                  <a:solidFill>
                    <a:srgbClr val="92D050"/>
                  </a:solidFill>
                  <a:latin typeface="Arial" panose="020B0604020202020204" pitchFamily="34" charset="0"/>
                  <a:cs typeface="Arial" panose="020B0604020202020204" pitchFamily="34" charset="0"/>
                </a:rPr>
                <a:t>EPX</a:t>
              </a:r>
              <a:endParaRPr lang="it-IT" sz="900" b="1" dirty="0">
                <a:solidFill>
                  <a:srgbClr val="92D050"/>
                </a:solidFill>
                <a:latin typeface="Arial" panose="020B0604020202020204" pitchFamily="34" charset="0"/>
                <a:cs typeface="Arial" panose="020B0604020202020204" pitchFamily="34" charset="0"/>
              </a:endParaRPr>
            </a:p>
          </p:txBody>
        </p:sp>
        <p:sp>
          <p:nvSpPr>
            <p:cNvPr id="155" name="CasellaDiTesto 154"/>
            <p:cNvSpPr txBox="1"/>
            <p:nvPr/>
          </p:nvSpPr>
          <p:spPr>
            <a:xfrm>
              <a:off x="2080070" y="396279"/>
              <a:ext cx="1008931" cy="196207"/>
            </a:xfrm>
            <a:prstGeom prst="rect">
              <a:avLst/>
            </a:prstGeom>
            <a:noFill/>
          </p:spPr>
          <p:txBody>
            <a:bodyPr wrap="none" rtlCol="0">
              <a:spAutoFit/>
            </a:bodyPr>
            <a:lstStyle/>
            <a:p>
              <a:pPr algn="ctr"/>
              <a:r>
                <a:rPr lang="it-IT" sz="1100" dirty="0" smtClean="0">
                  <a:latin typeface="Arial" panose="020B0604020202020204" pitchFamily="34" charset="0"/>
                  <a:cs typeface="Arial" panose="020B0604020202020204" pitchFamily="34" charset="0"/>
                </a:rPr>
                <a:t>2.5X </a:t>
              </a:r>
              <a:r>
                <a:rPr lang="it-IT" sz="1100" dirty="0" err="1" smtClean="0">
                  <a:latin typeface="Arial" panose="020B0604020202020204" pitchFamily="34" charset="0"/>
                  <a:cs typeface="Arial" panose="020B0604020202020204" pitchFamily="34" charset="0"/>
                </a:rPr>
                <a:t>Magnification</a:t>
              </a:r>
              <a:endParaRPr lang="it-IT" sz="1100" dirty="0">
                <a:latin typeface="Arial" panose="020B0604020202020204" pitchFamily="34" charset="0"/>
                <a:cs typeface="Arial" panose="020B0604020202020204" pitchFamily="34" charset="0"/>
              </a:endParaRPr>
            </a:p>
          </p:txBody>
        </p:sp>
        <p:cxnSp>
          <p:nvCxnSpPr>
            <p:cNvPr id="156" name="Connettore 1 84"/>
            <p:cNvCxnSpPr/>
            <p:nvPr/>
          </p:nvCxnSpPr>
          <p:spPr>
            <a:xfrm>
              <a:off x="1683243" y="617495"/>
              <a:ext cx="1836204"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157" name="CasellaDiTesto 156"/>
            <p:cNvSpPr txBox="1"/>
            <p:nvPr/>
          </p:nvSpPr>
          <p:spPr>
            <a:xfrm>
              <a:off x="336515" y="645497"/>
              <a:ext cx="354905" cy="380873"/>
            </a:xfrm>
            <a:prstGeom prst="rect">
              <a:avLst/>
            </a:prstGeom>
            <a:noFill/>
          </p:spPr>
          <p:txBody>
            <a:bodyPr wrap="none" rtlCol="0">
              <a:spAutoFit/>
            </a:bodyPr>
            <a:lstStyle/>
            <a:p>
              <a:r>
                <a:rPr lang="it-IT" sz="900" b="1" dirty="0" err="1" smtClean="0">
                  <a:solidFill>
                    <a:srgbClr val="FF0000"/>
                  </a:solidFill>
                  <a:latin typeface="Arial" panose="020B0604020202020204" pitchFamily="34" charset="0"/>
                  <a:cs typeface="Arial" panose="020B0604020202020204" pitchFamily="34" charset="0"/>
                </a:rPr>
                <a:t>Actin</a:t>
              </a:r>
              <a:endParaRPr lang="it-IT" sz="900" b="1" dirty="0" smtClean="0">
                <a:solidFill>
                  <a:srgbClr val="FF0000"/>
                </a:solidFill>
                <a:latin typeface="Arial" panose="020B0604020202020204" pitchFamily="34" charset="0"/>
                <a:cs typeface="Arial" panose="020B0604020202020204" pitchFamily="34" charset="0"/>
              </a:endParaRPr>
            </a:p>
            <a:p>
              <a:r>
                <a:rPr lang="it-IT" sz="900" b="1" dirty="0" smtClean="0">
                  <a:solidFill>
                    <a:srgbClr val="92D050"/>
                  </a:solidFill>
                  <a:latin typeface="Arial" panose="020B0604020202020204" pitchFamily="34" charset="0"/>
                  <a:cs typeface="Arial" panose="020B0604020202020204" pitchFamily="34" charset="0"/>
                </a:rPr>
                <a:t>EPX</a:t>
              </a:r>
            </a:p>
            <a:p>
              <a:r>
                <a:rPr lang="it-IT" sz="900" b="1" dirty="0" smtClean="0">
                  <a:solidFill>
                    <a:srgbClr val="1934FB"/>
                  </a:solidFill>
                  <a:latin typeface="Arial" panose="020B0604020202020204" pitchFamily="34" charset="0"/>
                  <a:cs typeface="Arial" panose="020B0604020202020204" pitchFamily="34" charset="0"/>
                </a:rPr>
                <a:t>DAPI</a:t>
              </a:r>
              <a:endParaRPr lang="it-IT" sz="900" b="1" dirty="0">
                <a:solidFill>
                  <a:srgbClr val="1934FB"/>
                </a:solidFill>
                <a:latin typeface="Arial" panose="020B0604020202020204" pitchFamily="34" charset="0"/>
                <a:cs typeface="Arial" panose="020B0604020202020204" pitchFamily="34" charset="0"/>
              </a:endParaRPr>
            </a:p>
          </p:txBody>
        </p:sp>
        <p:pic>
          <p:nvPicPr>
            <p:cNvPr id="169" name="Picture 8"/>
            <p:cNvPicPr>
              <a:picLocks noChangeAspect="1" noChangeArrowheads="1"/>
            </p:cNvPicPr>
            <p:nvPr/>
          </p:nvPicPr>
          <p:blipFill rotWithShape="1">
            <a:blip r:embed="rId9" cstate="print">
              <a:extLst>
                <a:ext uri="{28A0092B-C50C-407E-A947-70E740481C1C}">
                  <a14:useLocalDpi xmlns:a14="http://schemas.microsoft.com/office/drawing/2010/main" val="0"/>
                </a:ext>
              </a:extLst>
            </a:blip>
            <a:srcRect l="27233" t="11558" r="36192" b="51187"/>
            <a:stretch/>
          </p:blipFill>
          <p:spPr bwMode="auto">
            <a:xfrm>
              <a:off x="2613248" y="665190"/>
              <a:ext cx="1066575" cy="108428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70" name="Picture 9"/>
            <p:cNvPicPr>
              <a:picLocks noChangeAspect="1" noChangeArrowheads="1"/>
            </p:cNvPicPr>
            <p:nvPr/>
          </p:nvPicPr>
          <p:blipFill rotWithShape="1">
            <a:blip r:embed="rId10" cstate="print">
              <a:extLst>
                <a:ext uri="{28A0092B-C50C-407E-A947-70E740481C1C}">
                  <a14:useLocalDpi xmlns:a14="http://schemas.microsoft.com/office/drawing/2010/main" val="0"/>
                </a:ext>
              </a:extLst>
            </a:blip>
            <a:srcRect l="27060" t="11481" r="35840" b="51351"/>
            <a:stretch/>
          </p:blipFill>
          <p:spPr bwMode="auto">
            <a:xfrm>
              <a:off x="1484090" y="665190"/>
              <a:ext cx="1080000" cy="108285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nvGrpSpPr>
            <p:cNvPr id="171" name="Gruppo 170"/>
            <p:cNvGrpSpPr/>
            <p:nvPr/>
          </p:nvGrpSpPr>
          <p:grpSpPr>
            <a:xfrm>
              <a:off x="364539" y="1785337"/>
              <a:ext cx="1079999" cy="1079999"/>
              <a:chOff x="179512" y="2787774"/>
              <a:chExt cx="1439999" cy="1440000"/>
            </a:xfrm>
          </p:grpSpPr>
          <p:pic>
            <p:nvPicPr>
              <p:cNvPr id="203" name="Picture 2"/>
              <p:cNvPicPr>
                <a:picLocks noChangeAspect="1" noChangeArrowheads="1"/>
              </p:cNvPicPr>
              <p:nvPr/>
            </p:nvPicPr>
            <p:blipFill>
              <a:blip r:embed="rId11" cstate="print">
                <a:extLst>
                  <a:ext uri="{28A0092B-C50C-407E-A947-70E740481C1C}">
                    <a14:useLocalDpi xmlns:a14="http://schemas.microsoft.com/office/drawing/2010/main" val="0"/>
                  </a:ext>
                </a:extLst>
              </a:blip>
              <a:srcRect/>
              <a:stretch>
                <a:fillRect/>
              </a:stretch>
            </p:blipFill>
            <p:spPr bwMode="auto">
              <a:xfrm>
                <a:off x="179512" y="2787774"/>
                <a:ext cx="1439999" cy="1440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04" name="Rettangolo 203"/>
              <p:cNvSpPr>
                <a:spLocks noChangeAspect="1"/>
              </p:cNvSpPr>
              <p:nvPr/>
            </p:nvSpPr>
            <p:spPr>
              <a:xfrm>
                <a:off x="592512" y="3452812"/>
                <a:ext cx="533820" cy="532557"/>
              </a:xfrm>
              <a:prstGeom prst="rect">
                <a:avLst/>
              </a:prstGeom>
              <a:noFill/>
              <a:ln w="12700">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grpSp>
        <p:pic>
          <p:nvPicPr>
            <p:cNvPr id="172" name="Picture 4"/>
            <p:cNvPicPr>
              <a:picLocks noChangeAspect="1" noChangeArrowheads="1"/>
            </p:cNvPicPr>
            <p:nvPr/>
          </p:nvPicPr>
          <p:blipFill rotWithShape="1">
            <a:blip r:embed="rId12" cstate="print">
              <a:extLst>
                <a:ext uri="{28A0092B-C50C-407E-A947-70E740481C1C}">
                  <a14:useLocalDpi xmlns:a14="http://schemas.microsoft.com/office/drawing/2010/main" val="0"/>
                </a:ext>
              </a:extLst>
            </a:blip>
            <a:srcRect l="28181" t="46601" r="34753" b="16263"/>
            <a:stretch/>
          </p:blipFill>
          <p:spPr bwMode="auto">
            <a:xfrm>
              <a:off x="1487057" y="1785457"/>
              <a:ext cx="1077975" cy="1079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73" name="Picture 6"/>
            <p:cNvPicPr>
              <a:picLocks noChangeAspect="1" noChangeArrowheads="1"/>
            </p:cNvPicPr>
            <p:nvPr/>
          </p:nvPicPr>
          <p:blipFill rotWithShape="1">
            <a:blip r:embed="rId13" cstate="print">
              <a:extLst>
                <a:ext uri="{28A0092B-C50C-407E-A947-70E740481C1C}">
                  <a14:useLocalDpi xmlns:a14="http://schemas.microsoft.com/office/drawing/2010/main" val="0"/>
                </a:ext>
              </a:extLst>
            </a:blip>
            <a:srcRect l="27835" t="46903" r="35096" b="15955"/>
            <a:stretch/>
          </p:blipFill>
          <p:spPr bwMode="auto">
            <a:xfrm>
              <a:off x="2607182" y="1785457"/>
              <a:ext cx="1080000" cy="1079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cxnSp>
          <p:nvCxnSpPr>
            <p:cNvPr id="174" name="Connettore 1 47"/>
            <p:cNvCxnSpPr/>
            <p:nvPr/>
          </p:nvCxnSpPr>
          <p:spPr>
            <a:xfrm>
              <a:off x="1233992" y="2779307"/>
              <a:ext cx="140400"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grpSp>
          <p:nvGrpSpPr>
            <p:cNvPr id="175" name="Gruppo 174"/>
            <p:cNvGrpSpPr/>
            <p:nvPr/>
          </p:nvGrpSpPr>
          <p:grpSpPr>
            <a:xfrm>
              <a:off x="361086" y="667346"/>
              <a:ext cx="1079085" cy="1079999"/>
              <a:chOff x="174909" y="336885"/>
              <a:chExt cx="1438780" cy="1440000"/>
            </a:xfrm>
          </p:grpSpPr>
          <p:grpSp>
            <p:nvGrpSpPr>
              <p:cNvPr id="199" name="Gruppo 198"/>
              <p:cNvGrpSpPr/>
              <p:nvPr/>
            </p:nvGrpSpPr>
            <p:grpSpPr>
              <a:xfrm>
                <a:off x="174909" y="336885"/>
                <a:ext cx="1438780" cy="1440000"/>
                <a:chOff x="174909" y="336885"/>
                <a:chExt cx="1438780" cy="1440000"/>
              </a:xfrm>
            </p:grpSpPr>
            <p:pic>
              <p:nvPicPr>
                <p:cNvPr id="201" name="Picture 6"/>
                <p:cNvPicPr>
                  <a:picLocks noChangeAspect="1" noChangeArrowheads="1"/>
                </p:cNvPicPr>
                <p:nvPr/>
              </p:nvPicPr>
              <p:blipFill>
                <a:blip r:embed="rId14" cstate="print">
                  <a:extLst>
                    <a:ext uri="{28A0092B-C50C-407E-A947-70E740481C1C}">
                      <a14:useLocalDpi xmlns:a14="http://schemas.microsoft.com/office/drawing/2010/main" val="0"/>
                    </a:ext>
                  </a:extLst>
                </a:blip>
                <a:srcRect/>
                <a:stretch>
                  <a:fillRect/>
                </a:stretch>
              </p:blipFill>
              <p:spPr bwMode="auto">
                <a:xfrm>
                  <a:off x="174909" y="336885"/>
                  <a:ext cx="1438780" cy="1440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02" name="Rettangolo 201"/>
                <p:cNvSpPr>
                  <a:spLocks noChangeAspect="1"/>
                </p:cNvSpPr>
                <p:nvPr/>
              </p:nvSpPr>
              <p:spPr>
                <a:xfrm>
                  <a:off x="562350" y="500062"/>
                  <a:ext cx="533820" cy="532557"/>
                </a:xfrm>
                <a:prstGeom prst="rect">
                  <a:avLst/>
                </a:prstGeom>
                <a:noFill/>
                <a:ln w="12700">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grpSp>
          <p:cxnSp>
            <p:nvCxnSpPr>
              <p:cNvPr id="200" name="Connettore 1 48"/>
              <p:cNvCxnSpPr/>
              <p:nvPr/>
            </p:nvCxnSpPr>
            <p:spPr>
              <a:xfrm>
                <a:off x="1326877" y="1668987"/>
                <a:ext cx="187200"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grpSp>
        <p:sp>
          <p:nvSpPr>
            <p:cNvPr id="176" name="CasellaDiTesto 175"/>
            <p:cNvSpPr txBox="1"/>
            <p:nvPr/>
          </p:nvSpPr>
          <p:spPr>
            <a:xfrm rot="16200000">
              <a:off x="-255562" y="1080897"/>
              <a:ext cx="958917" cy="261610"/>
            </a:xfrm>
            <a:prstGeom prst="rect">
              <a:avLst/>
            </a:prstGeom>
            <a:noFill/>
          </p:spPr>
          <p:txBody>
            <a:bodyPr wrap="none" rtlCol="0">
              <a:spAutoFit/>
            </a:bodyPr>
            <a:lstStyle>
              <a:defPPr>
                <a:defRPr lang="it-IT"/>
              </a:defPPr>
              <a:lvl1pPr algn="ctr">
                <a:defRPr sz="1100">
                  <a:latin typeface="Arial" panose="020B0604020202020204" pitchFamily="34" charset="0"/>
                  <a:cs typeface="Arial" panose="020B0604020202020204" pitchFamily="34" charset="0"/>
                </a:defRPr>
              </a:lvl1pPr>
            </a:lstStyle>
            <a:p>
              <a:r>
                <a:rPr lang="it-IT" dirty="0" smtClean="0"/>
                <a:t>B16/IL-5 EO</a:t>
              </a:r>
              <a:endParaRPr lang="it-IT" dirty="0"/>
            </a:p>
          </p:txBody>
        </p:sp>
        <p:sp>
          <p:nvSpPr>
            <p:cNvPr id="177" name="CasellaDiTesto 176"/>
            <p:cNvSpPr txBox="1"/>
            <p:nvPr/>
          </p:nvSpPr>
          <p:spPr>
            <a:xfrm rot="16200000">
              <a:off x="-294835" y="2194863"/>
              <a:ext cx="1037463" cy="261610"/>
            </a:xfrm>
            <a:prstGeom prst="rect">
              <a:avLst/>
            </a:prstGeom>
            <a:noFill/>
          </p:spPr>
          <p:txBody>
            <a:bodyPr wrap="none" rtlCol="0">
              <a:spAutoFit/>
            </a:bodyPr>
            <a:lstStyle>
              <a:defPPr>
                <a:defRPr lang="it-IT"/>
              </a:defPPr>
              <a:lvl1pPr algn="ctr">
                <a:defRPr sz="1100">
                  <a:latin typeface="Arial" panose="020B0604020202020204" pitchFamily="34" charset="0"/>
                  <a:cs typeface="Arial" panose="020B0604020202020204" pitchFamily="34" charset="0"/>
                </a:defRPr>
              </a:lvl1pPr>
            </a:lstStyle>
            <a:p>
              <a:r>
                <a:rPr lang="it-IT" dirty="0" smtClean="0"/>
                <a:t>B16/IL-33 EO</a:t>
              </a:r>
              <a:endParaRPr lang="it-IT" dirty="0"/>
            </a:p>
          </p:txBody>
        </p:sp>
        <p:sp>
          <p:nvSpPr>
            <p:cNvPr id="178" name="CasellaDiTesto 177"/>
            <p:cNvSpPr txBox="1"/>
            <p:nvPr/>
          </p:nvSpPr>
          <p:spPr>
            <a:xfrm>
              <a:off x="1467221" y="1765945"/>
              <a:ext cx="354904" cy="173124"/>
            </a:xfrm>
            <a:prstGeom prst="rect">
              <a:avLst/>
            </a:prstGeom>
            <a:noFill/>
          </p:spPr>
          <p:txBody>
            <a:bodyPr wrap="none" rtlCol="0">
              <a:spAutoFit/>
            </a:bodyPr>
            <a:lstStyle/>
            <a:p>
              <a:r>
                <a:rPr lang="it-IT" sz="900" b="1" dirty="0" err="1" smtClean="0">
                  <a:solidFill>
                    <a:srgbClr val="FF0000"/>
                  </a:solidFill>
                  <a:latin typeface="Arial" panose="020B0604020202020204" pitchFamily="34" charset="0"/>
                  <a:cs typeface="Arial" panose="020B0604020202020204" pitchFamily="34" charset="0"/>
                </a:rPr>
                <a:t>Actin</a:t>
              </a:r>
              <a:endParaRPr lang="it-IT" sz="900" b="1" dirty="0">
                <a:solidFill>
                  <a:srgbClr val="FF0000"/>
                </a:solidFill>
                <a:latin typeface="Arial" panose="020B0604020202020204" pitchFamily="34" charset="0"/>
                <a:cs typeface="Arial" panose="020B0604020202020204" pitchFamily="34" charset="0"/>
              </a:endParaRPr>
            </a:p>
          </p:txBody>
        </p:sp>
        <p:sp>
          <p:nvSpPr>
            <p:cNvPr id="179" name="CasellaDiTesto 178"/>
            <p:cNvSpPr txBox="1"/>
            <p:nvPr/>
          </p:nvSpPr>
          <p:spPr>
            <a:xfrm>
              <a:off x="2589917" y="1765945"/>
              <a:ext cx="311623" cy="173124"/>
            </a:xfrm>
            <a:prstGeom prst="rect">
              <a:avLst/>
            </a:prstGeom>
            <a:noFill/>
          </p:spPr>
          <p:txBody>
            <a:bodyPr wrap="none" rtlCol="0">
              <a:spAutoFit/>
            </a:bodyPr>
            <a:lstStyle/>
            <a:p>
              <a:r>
                <a:rPr lang="it-IT" sz="900" b="1" dirty="0" smtClean="0">
                  <a:solidFill>
                    <a:srgbClr val="92D050"/>
                  </a:solidFill>
                  <a:latin typeface="Arial" panose="020B0604020202020204" pitchFamily="34" charset="0"/>
                  <a:cs typeface="Arial" panose="020B0604020202020204" pitchFamily="34" charset="0"/>
                </a:rPr>
                <a:t>EPX</a:t>
              </a:r>
              <a:endParaRPr lang="it-IT" sz="900" b="1" dirty="0">
                <a:solidFill>
                  <a:srgbClr val="92D050"/>
                </a:solidFill>
                <a:latin typeface="Arial" panose="020B0604020202020204" pitchFamily="34" charset="0"/>
                <a:cs typeface="Arial" panose="020B0604020202020204" pitchFamily="34" charset="0"/>
              </a:endParaRPr>
            </a:p>
          </p:txBody>
        </p:sp>
        <p:sp>
          <p:nvSpPr>
            <p:cNvPr id="180" name="CasellaDiTesto 179"/>
            <p:cNvSpPr txBox="1"/>
            <p:nvPr/>
          </p:nvSpPr>
          <p:spPr>
            <a:xfrm>
              <a:off x="347097" y="1765621"/>
              <a:ext cx="354904" cy="380873"/>
            </a:xfrm>
            <a:prstGeom prst="rect">
              <a:avLst/>
            </a:prstGeom>
            <a:noFill/>
          </p:spPr>
          <p:txBody>
            <a:bodyPr wrap="none" rtlCol="0">
              <a:spAutoFit/>
            </a:bodyPr>
            <a:lstStyle/>
            <a:p>
              <a:r>
                <a:rPr lang="it-IT" sz="900" b="1" dirty="0" err="1" smtClean="0">
                  <a:solidFill>
                    <a:srgbClr val="FF0000"/>
                  </a:solidFill>
                  <a:latin typeface="Arial" panose="020B0604020202020204" pitchFamily="34" charset="0"/>
                  <a:cs typeface="Arial" panose="020B0604020202020204" pitchFamily="34" charset="0"/>
                </a:rPr>
                <a:t>Actin</a:t>
              </a:r>
              <a:endParaRPr lang="it-IT" sz="900" b="1" dirty="0" smtClean="0">
                <a:solidFill>
                  <a:srgbClr val="FF0000"/>
                </a:solidFill>
                <a:latin typeface="Arial" panose="020B0604020202020204" pitchFamily="34" charset="0"/>
                <a:cs typeface="Arial" panose="020B0604020202020204" pitchFamily="34" charset="0"/>
              </a:endParaRPr>
            </a:p>
            <a:p>
              <a:r>
                <a:rPr lang="it-IT" sz="900" b="1" dirty="0" smtClean="0">
                  <a:solidFill>
                    <a:srgbClr val="92D050"/>
                  </a:solidFill>
                  <a:latin typeface="Arial" panose="020B0604020202020204" pitchFamily="34" charset="0"/>
                  <a:cs typeface="Arial" panose="020B0604020202020204" pitchFamily="34" charset="0"/>
                </a:rPr>
                <a:t>EPX</a:t>
              </a:r>
            </a:p>
            <a:p>
              <a:r>
                <a:rPr lang="it-IT" sz="900" b="1" dirty="0" smtClean="0">
                  <a:solidFill>
                    <a:srgbClr val="1934FB"/>
                  </a:solidFill>
                  <a:latin typeface="Arial" panose="020B0604020202020204" pitchFamily="34" charset="0"/>
                  <a:cs typeface="Arial" panose="020B0604020202020204" pitchFamily="34" charset="0"/>
                </a:rPr>
                <a:t>DAPI</a:t>
              </a:r>
              <a:endParaRPr lang="it-IT" sz="900" b="1" dirty="0">
                <a:solidFill>
                  <a:srgbClr val="1934FB"/>
                </a:solidFill>
                <a:latin typeface="Arial" panose="020B0604020202020204" pitchFamily="34" charset="0"/>
                <a:cs typeface="Arial" panose="020B0604020202020204" pitchFamily="34" charset="0"/>
              </a:endParaRPr>
            </a:p>
          </p:txBody>
        </p:sp>
        <p:sp>
          <p:nvSpPr>
            <p:cNvPr id="181" name="Ovale 180"/>
            <p:cNvSpPr/>
            <p:nvPr/>
          </p:nvSpPr>
          <p:spPr>
            <a:xfrm>
              <a:off x="1980608" y="1093447"/>
              <a:ext cx="50626" cy="52875"/>
            </a:xfrm>
            <a:prstGeom prst="ellipse">
              <a:avLst/>
            </a:prstGeom>
            <a:noFill/>
            <a:ln w="28575">
              <a:solidFill>
                <a:srgbClr val="FF00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182" name="Ovale 181"/>
            <p:cNvSpPr/>
            <p:nvPr/>
          </p:nvSpPr>
          <p:spPr>
            <a:xfrm>
              <a:off x="2103836" y="1426282"/>
              <a:ext cx="50626" cy="52875"/>
            </a:xfrm>
            <a:prstGeom prst="ellipse">
              <a:avLst/>
            </a:prstGeom>
            <a:noFill/>
            <a:ln w="28575">
              <a:solidFill>
                <a:srgbClr val="FF00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183" name="Ovale 182"/>
            <p:cNvSpPr/>
            <p:nvPr/>
          </p:nvSpPr>
          <p:spPr>
            <a:xfrm>
              <a:off x="3104557" y="1098210"/>
              <a:ext cx="50626" cy="52875"/>
            </a:xfrm>
            <a:prstGeom prst="ellipse">
              <a:avLst/>
            </a:prstGeom>
            <a:noFill/>
            <a:ln w="28575">
              <a:solidFill>
                <a:srgbClr val="FF00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184" name="Ovale 183"/>
            <p:cNvSpPr/>
            <p:nvPr/>
          </p:nvSpPr>
          <p:spPr>
            <a:xfrm>
              <a:off x="3222429" y="1431045"/>
              <a:ext cx="50626" cy="52875"/>
            </a:xfrm>
            <a:prstGeom prst="ellipse">
              <a:avLst/>
            </a:prstGeom>
            <a:noFill/>
            <a:ln w="28575">
              <a:solidFill>
                <a:srgbClr val="FF00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grpSp>
          <p:nvGrpSpPr>
            <p:cNvPr id="185" name="Gruppo 184"/>
            <p:cNvGrpSpPr/>
            <p:nvPr/>
          </p:nvGrpSpPr>
          <p:grpSpPr>
            <a:xfrm>
              <a:off x="467247" y="2902550"/>
              <a:ext cx="3128935" cy="272155"/>
              <a:chOff x="1907704" y="3219822"/>
              <a:chExt cx="3351312" cy="362873"/>
            </a:xfrm>
          </p:grpSpPr>
          <p:grpSp>
            <p:nvGrpSpPr>
              <p:cNvPr id="190" name="Gruppo 189"/>
              <p:cNvGrpSpPr/>
              <p:nvPr/>
            </p:nvGrpSpPr>
            <p:grpSpPr>
              <a:xfrm>
                <a:off x="1907704" y="3219822"/>
                <a:ext cx="3351312" cy="362873"/>
                <a:chOff x="4148151" y="2880682"/>
                <a:chExt cx="3351312" cy="362873"/>
              </a:xfrm>
            </p:grpSpPr>
            <p:cxnSp>
              <p:nvCxnSpPr>
                <p:cNvPr id="193" name="Connettore 1 7"/>
                <p:cNvCxnSpPr/>
                <p:nvPr/>
              </p:nvCxnSpPr>
              <p:spPr>
                <a:xfrm>
                  <a:off x="4148151" y="3005648"/>
                  <a:ext cx="360040" cy="0"/>
                </a:xfrm>
                <a:prstGeom prst="line">
                  <a:avLst/>
                </a:prstGeom>
                <a:ln w="28575">
                  <a:prstDash val="sysDash"/>
                </a:ln>
              </p:spPr>
              <p:style>
                <a:lnRef idx="1">
                  <a:schemeClr val="accent1"/>
                </a:lnRef>
                <a:fillRef idx="0">
                  <a:schemeClr val="accent1"/>
                </a:fillRef>
                <a:effectRef idx="0">
                  <a:schemeClr val="accent1"/>
                </a:effectRef>
                <a:fontRef idx="minor">
                  <a:schemeClr val="tx1"/>
                </a:fontRef>
              </p:style>
            </p:cxnSp>
            <p:cxnSp>
              <p:nvCxnSpPr>
                <p:cNvPr id="194" name="Connettore 1 8"/>
                <p:cNvCxnSpPr/>
                <p:nvPr/>
              </p:nvCxnSpPr>
              <p:spPr>
                <a:xfrm>
                  <a:off x="4148151" y="3140010"/>
                  <a:ext cx="360040" cy="0"/>
                </a:xfrm>
                <a:prstGeom prst="line">
                  <a:avLst/>
                </a:prstGeom>
                <a:ln w="28575">
                  <a:solidFill>
                    <a:srgbClr val="FFFF00"/>
                  </a:solidFill>
                  <a:prstDash val="sysDash"/>
                </a:ln>
              </p:spPr>
              <p:style>
                <a:lnRef idx="1">
                  <a:schemeClr val="accent1"/>
                </a:lnRef>
                <a:fillRef idx="0">
                  <a:schemeClr val="accent1"/>
                </a:fillRef>
                <a:effectRef idx="0">
                  <a:schemeClr val="accent1"/>
                </a:effectRef>
                <a:fontRef idx="minor">
                  <a:schemeClr val="tx1"/>
                </a:fontRef>
              </p:style>
            </p:cxnSp>
            <p:cxnSp>
              <p:nvCxnSpPr>
                <p:cNvPr id="195" name="Connettore 1 9"/>
                <p:cNvCxnSpPr/>
                <p:nvPr/>
              </p:nvCxnSpPr>
              <p:spPr>
                <a:xfrm>
                  <a:off x="5657507" y="2999298"/>
                  <a:ext cx="360040" cy="0"/>
                </a:xfrm>
                <a:prstGeom prst="line">
                  <a:avLst/>
                </a:prstGeom>
                <a:ln w="28575">
                  <a:solidFill>
                    <a:schemeClr val="accent2"/>
                  </a:solidFill>
                  <a:prstDash val="sysDash"/>
                </a:ln>
              </p:spPr>
              <p:style>
                <a:lnRef idx="1">
                  <a:schemeClr val="accent1"/>
                </a:lnRef>
                <a:fillRef idx="0">
                  <a:schemeClr val="accent1"/>
                </a:fillRef>
                <a:effectRef idx="0">
                  <a:schemeClr val="accent1"/>
                </a:effectRef>
                <a:fontRef idx="minor">
                  <a:schemeClr val="tx1"/>
                </a:fontRef>
              </p:style>
            </p:cxnSp>
            <p:sp>
              <p:nvSpPr>
                <p:cNvPr id="196" name="CasellaDiTesto 195"/>
                <p:cNvSpPr txBox="1"/>
                <p:nvPr/>
              </p:nvSpPr>
              <p:spPr>
                <a:xfrm>
                  <a:off x="4509120" y="2880682"/>
                  <a:ext cx="1047082" cy="215444"/>
                </a:xfrm>
                <a:prstGeom prst="rect">
                  <a:avLst/>
                </a:prstGeom>
                <a:noFill/>
              </p:spPr>
              <p:txBody>
                <a:bodyPr wrap="none" rtlCol="0">
                  <a:spAutoFit/>
                </a:bodyPr>
                <a:lstStyle/>
                <a:p>
                  <a:r>
                    <a:rPr lang="it-IT" sz="800" dirty="0" err="1">
                      <a:latin typeface="Arial" panose="020B0604020202020204" pitchFamily="34" charset="0"/>
                      <a:cs typeface="Arial" panose="020B0604020202020204" pitchFamily="34" charset="0"/>
                    </a:rPr>
                    <a:t>S</a:t>
                  </a:r>
                  <a:r>
                    <a:rPr lang="it-IT" sz="800" dirty="0" err="1" smtClean="0">
                      <a:latin typeface="Arial" panose="020B0604020202020204" pitchFamily="34" charset="0"/>
                      <a:cs typeface="Arial" panose="020B0604020202020204" pitchFamily="34" charset="0"/>
                    </a:rPr>
                    <a:t>ynapse</a:t>
                  </a:r>
                  <a:r>
                    <a:rPr lang="it-IT" sz="800" dirty="0" smtClean="0">
                      <a:latin typeface="Arial" panose="020B0604020202020204" pitchFamily="34" charset="0"/>
                      <a:cs typeface="Arial" panose="020B0604020202020204" pitchFamily="34" charset="0"/>
                    </a:rPr>
                    <a:t> </a:t>
                  </a:r>
                  <a:r>
                    <a:rPr lang="it-IT" sz="800" dirty="0" err="1" smtClean="0">
                      <a:latin typeface="Arial" panose="020B0604020202020204" pitchFamily="34" charset="0"/>
                      <a:cs typeface="Arial" panose="020B0604020202020204" pitchFamily="34" charset="0"/>
                    </a:rPr>
                    <a:t>boundary</a:t>
                  </a:r>
                  <a:endParaRPr lang="it-IT" sz="800" dirty="0">
                    <a:latin typeface="Arial" panose="020B0604020202020204" pitchFamily="34" charset="0"/>
                    <a:cs typeface="Arial" panose="020B0604020202020204" pitchFamily="34" charset="0"/>
                  </a:endParaRPr>
                </a:p>
              </p:txBody>
            </p:sp>
            <p:sp>
              <p:nvSpPr>
                <p:cNvPr id="197" name="CasellaDiTesto 196"/>
                <p:cNvSpPr txBox="1"/>
                <p:nvPr/>
              </p:nvSpPr>
              <p:spPr>
                <a:xfrm>
                  <a:off x="4509120" y="3028111"/>
                  <a:ext cx="1047082" cy="215444"/>
                </a:xfrm>
                <a:prstGeom prst="rect">
                  <a:avLst/>
                </a:prstGeom>
                <a:noFill/>
              </p:spPr>
              <p:txBody>
                <a:bodyPr wrap="none" rtlCol="0">
                  <a:spAutoFit/>
                </a:bodyPr>
                <a:lstStyle/>
                <a:p>
                  <a:r>
                    <a:rPr lang="it-IT" sz="800" dirty="0" smtClean="0">
                      <a:latin typeface="Arial" panose="020B0604020202020204" pitchFamily="34" charset="0"/>
                      <a:cs typeface="Arial" panose="020B0604020202020204" pitchFamily="34" charset="0"/>
                    </a:rPr>
                    <a:t>EO body </a:t>
                  </a:r>
                  <a:r>
                    <a:rPr lang="it-IT" sz="800" dirty="0" err="1" smtClean="0">
                      <a:latin typeface="Arial" panose="020B0604020202020204" pitchFamily="34" charset="0"/>
                      <a:cs typeface="Arial" panose="020B0604020202020204" pitchFamily="34" charset="0"/>
                    </a:rPr>
                    <a:t>boundary</a:t>
                  </a:r>
                  <a:endParaRPr lang="it-IT" sz="800" dirty="0">
                    <a:latin typeface="Arial" panose="020B0604020202020204" pitchFamily="34" charset="0"/>
                    <a:cs typeface="Arial" panose="020B0604020202020204" pitchFamily="34" charset="0"/>
                  </a:endParaRPr>
                </a:p>
              </p:txBody>
            </p:sp>
            <p:sp>
              <p:nvSpPr>
                <p:cNvPr id="198" name="CasellaDiTesto 197"/>
                <p:cNvSpPr txBox="1"/>
                <p:nvPr/>
              </p:nvSpPr>
              <p:spPr>
                <a:xfrm>
                  <a:off x="6018476" y="2880682"/>
                  <a:ext cx="1480987" cy="215444"/>
                </a:xfrm>
                <a:prstGeom prst="rect">
                  <a:avLst/>
                </a:prstGeom>
                <a:noFill/>
              </p:spPr>
              <p:txBody>
                <a:bodyPr wrap="square" rtlCol="0">
                  <a:spAutoFit/>
                </a:bodyPr>
                <a:lstStyle/>
                <a:p>
                  <a:r>
                    <a:rPr lang="it-IT" sz="800" dirty="0" err="1">
                      <a:latin typeface="Arial" panose="020B0604020202020204" pitchFamily="34" charset="0"/>
                      <a:cs typeface="Arial" panose="020B0604020202020204" pitchFamily="34" charset="0"/>
                    </a:rPr>
                    <a:t>F</a:t>
                  </a:r>
                  <a:r>
                    <a:rPr lang="it-IT" sz="800" dirty="0" err="1" smtClean="0">
                      <a:latin typeface="Arial" panose="020B0604020202020204" pitchFamily="34" charset="0"/>
                      <a:cs typeface="Arial" panose="020B0604020202020204" pitchFamily="34" charset="0"/>
                    </a:rPr>
                    <a:t>luorescence</a:t>
                  </a:r>
                  <a:r>
                    <a:rPr lang="it-IT" sz="800" dirty="0" smtClean="0">
                      <a:latin typeface="Arial" panose="020B0604020202020204" pitchFamily="34" charset="0"/>
                      <a:cs typeface="Arial" panose="020B0604020202020204" pitchFamily="34" charset="0"/>
                    </a:rPr>
                    <a:t> </a:t>
                  </a:r>
                  <a:r>
                    <a:rPr lang="it-IT" sz="800" dirty="0" err="1" smtClean="0">
                      <a:latin typeface="Arial" panose="020B0604020202020204" pitchFamily="34" charset="0"/>
                      <a:cs typeface="Arial" panose="020B0604020202020204" pitchFamily="34" charset="0"/>
                    </a:rPr>
                    <a:t>profiling</a:t>
                  </a:r>
                  <a:r>
                    <a:rPr lang="it-IT" sz="800" dirty="0">
                      <a:latin typeface="Arial" panose="020B0604020202020204" pitchFamily="34" charset="0"/>
                      <a:cs typeface="Arial" panose="020B0604020202020204" pitchFamily="34" charset="0"/>
                    </a:rPr>
                    <a:t> </a:t>
                  </a:r>
                  <a:r>
                    <a:rPr lang="it-IT" sz="800" dirty="0" smtClean="0">
                      <a:latin typeface="Arial" panose="020B0604020202020204" pitchFamily="34" charset="0"/>
                      <a:cs typeface="Arial" panose="020B0604020202020204" pitchFamily="34" charset="0"/>
                    </a:rPr>
                    <a:t>line</a:t>
                  </a:r>
                  <a:endParaRPr lang="it-IT" sz="800" dirty="0">
                    <a:latin typeface="Arial" panose="020B0604020202020204" pitchFamily="34" charset="0"/>
                    <a:cs typeface="Arial" panose="020B0604020202020204" pitchFamily="34" charset="0"/>
                  </a:endParaRPr>
                </a:p>
              </p:txBody>
            </p:sp>
          </p:grpSp>
          <p:sp>
            <p:nvSpPr>
              <p:cNvPr id="191" name="Ovale 190"/>
              <p:cNvSpPr/>
              <p:nvPr/>
            </p:nvSpPr>
            <p:spPr>
              <a:xfrm>
                <a:off x="3687011" y="3442196"/>
                <a:ext cx="67501" cy="70500"/>
              </a:xfrm>
              <a:prstGeom prst="ellipse">
                <a:avLst/>
              </a:prstGeom>
              <a:noFill/>
              <a:ln w="28575">
                <a:solidFill>
                  <a:srgbClr val="FF00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192" name="CasellaDiTesto 191"/>
              <p:cNvSpPr txBox="1"/>
              <p:nvPr/>
            </p:nvSpPr>
            <p:spPr>
              <a:xfrm>
                <a:off x="3773562" y="3365872"/>
                <a:ext cx="1480987" cy="215444"/>
              </a:xfrm>
              <a:prstGeom prst="rect">
                <a:avLst/>
              </a:prstGeom>
              <a:noFill/>
            </p:spPr>
            <p:txBody>
              <a:bodyPr wrap="square" rtlCol="0">
                <a:spAutoFit/>
              </a:bodyPr>
              <a:lstStyle/>
              <a:p>
                <a:r>
                  <a:rPr lang="it-IT" sz="800" dirty="0" err="1" smtClean="0">
                    <a:latin typeface="Arial" panose="020B0604020202020204" pitchFamily="34" charset="0"/>
                    <a:cs typeface="Arial" panose="020B0604020202020204" pitchFamily="34" charset="0"/>
                  </a:rPr>
                  <a:t>Centroid</a:t>
                </a:r>
                <a:endParaRPr lang="it-IT" sz="800" dirty="0">
                  <a:latin typeface="Arial" panose="020B0604020202020204" pitchFamily="34" charset="0"/>
                  <a:cs typeface="Arial" panose="020B0604020202020204" pitchFamily="34" charset="0"/>
                </a:endParaRPr>
              </a:p>
            </p:txBody>
          </p:sp>
        </p:grpSp>
        <p:sp>
          <p:nvSpPr>
            <p:cNvPr id="186" name="Ovale 185"/>
            <p:cNvSpPr/>
            <p:nvPr/>
          </p:nvSpPr>
          <p:spPr>
            <a:xfrm>
              <a:off x="2099591" y="2150707"/>
              <a:ext cx="50626" cy="52875"/>
            </a:xfrm>
            <a:prstGeom prst="ellipse">
              <a:avLst/>
            </a:prstGeom>
            <a:noFill/>
            <a:ln w="28575">
              <a:solidFill>
                <a:srgbClr val="FF00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187" name="Ovale 186"/>
            <p:cNvSpPr/>
            <p:nvPr/>
          </p:nvSpPr>
          <p:spPr>
            <a:xfrm>
              <a:off x="1836704" y="2422358"/>
              <a:ext cx="50626" cy="52875"/>
            </a:xfrm>
            <a:prstGeom prst="ellipse">
              <a:avLst/>
            </a:prstGeom>
            <a:noFill/>
            <a:ln w="28575">
              <a:solidFill>
                <a:srgbClr val="FF00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188" name="Ovale 187"/>
            <p:cNvSpPr/>
            <p:nvPr/>
          </p:nvSpPr>
          <p:spPr>
            <a:xfrm>
              <a:off x="3217645" y="2150764"/>
              <a:ext cx="50626" cy="52875"/>
            </a:xfrm>
            <a:prstGeom prst="ellipse">
              <a:avLst/>
            </a:prstGeom>
            <a:noFill/>
            <a:ln w="28575">
              <a:solidFill>
                <a:srgbClr val="FF00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189" name="Ovale 188"/>
            <p:cNvSpPr/>
            <p:nvPr/>
          </p:nvSpPr>
          <p:spPr>
            <a:xfrm>
              <a:off x="2954758" y="2422415"/>
              <a:ext cx="50626" cy="52875"/>
            </a:xfrm>
            <a:prstGeom prst="ellipse">
              <a:avLst/>
            </a:prstGeom>
            <a:noFill/>
            <a:ln w="28575">
              <a:solidFill>
                <a:srgbClr val="FF00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167" name="CasellaDiTesto 166"/>
            <p:cNvSpPr txBox="1"/>
            <p:nvPr/>
          </p:nvSpPr>
          <p:spPr>
            <a:xfrm>
              <a:off x="1471979" y="642926"/>
              <a:ext cx="354905" cy="173124"/>
            </a:xfrm>
            <a:prstGeom prst="rect">
              <a:avLst/>
            </a:prstGeom>
            <a:noFill/>
          </p:spPr>
          <p:txBody>
            <a:bodyPr wrap="none" rtlCol="0">
              <a:spAutoFit/>
            </a:bodyPr>
            <a:lstStyle/>
            <a:p>
              <a:r>
                <a:rPr lang="it-IT" sz="900" b="1" dirty="0" err="1" smtClean="0">
                  <a:solidFill>
                    <a:srgbClr val="FF0000"/>
                  </a:solidFill>
                  <a:latin typeface="Arial" panose="020B0604020202020204" pitchFamily="34" charset="0"/>
                  <a:cs typeface="Arial" panose="020B0604020202020204" pitchFamily="34" charset="0"/>
                </a:rPr>
                <a:t>Actin</a:t>
              </a:r>
              <a:endParaRPr lang="it-IT" sz="900" b="1" dirty="0">
                <a:solidFill>
                  <a:srgbClr val="FF0000"/>
                </a:solidFill>
                <a:latin typeface="Arial" panose="020B0604020202020204" pitchFamily="34" charset="0"/>
                <a:cs typeface="Arial" panose="020B0604020202020204" pitchFamily="34" charset="0"/>
              </a:endParaRPr>
            </a:p>
          </p:txBody>
        </p:sp>
        <p:sp>
          <p:nvSpPr>
            <p:cNvPr id="168" name="CasellaDiTesto 167"/>
            <p:cNvSpPr txBox="1"/>
            <p:nvPr/>
          </p:nvSpPr>
          <p:spPr>
            <a:xfrm>
              <a:off x="2594675" y="642926"/>
              <a:ext cx="311624" cy="173124"/>
            </a:xfrm>
            <a:prstGeom prst="rect">
              <a:avLst/>
            </a:prstGeom>
            <a:noFill/>
          </p:spPr>
          <p:txBody>
            <a:bodyPr wrap="none" rtlCol="0">
              <a:spAutoFit/>
            </a:bodyPr>
            <a:lstStyle/>
            <a:p>
              <a:r>
                <a:rPr lang="it-IT" sz="900" b="1" dirty="0" smtClean="0">
                  <a:solidFill>
                    <a:srgbClr val="92D050"/>
                  </a:solidFill>
                  <a:latin typeface="Arial" panose="020B0604020202020204" pitchFamily="34" charset="0"/>
                  <a:cs typeface="Arial" panose="020B0604020202020204" pitchFamily="34" charset="0"/>
                </a:rPr>
                <a:t>EPX</a:t>
              </a:r>
              <a:endParaRPr lang="it-IT" sz="900" b="1" dirty="0">
                <a:solidFill>
                  <a:srgbClr val="92D050"/>
                </a:solidFill>
                <a:latin typeface="Arial" panose="020B0604020202020204" pitchFamily="34" charset="0"/>
                <a:cs typeface="Arial" panose="020B0604020202020204" pitchFamily="34" charset="0"/>
              </a:endParaRPr>
            </a:p>
          </p:txBody>
        </p:sp>
      </p:grpSp>
      <p:sp>
        <p:nvSpPr>
          <p:cNvPr id="241" name="CasellaDiTesto 240"/>
          <p:cNvSpPr txBox="1"/>
          <p:nvPr/>
        </p:nvSpPr>
        <p:spPr>
          <a:xfrm>
            <a:off x="5208756" y="4917933"/>
            <a:ext cx="398983" cy="461665"/>
          </a:xfrm>
          <a:prstGeom prst="rect">
            <a:avLst/>
          </a:prstGeom>
          <a:noFill/>
        </p:spPr>
        <p:txBody>
          <a:bodyPr wrap="square" rtlCol="0">
            <a:spAutoFit/>
          </a:bodyPr>
          <a:lstStyle/>
          <a:p>
            <a:pPr algn="ctr"/>
            <a:r>
              <a:rPr lang="it-IT" sz="800" b="1" dirty="0" smtClean="0">
                <a:latin typeface="Arial" panose="020B0604020202020204" pitchFamily="34" charset="0"/>
                <a:cs typeface="Arial" panose="020B0604020202020204" pitchFamily="34" charset="0"/>
              </a:rPr>
              <a:t>B16/IL-5</a:t>
            </a:r>
          </a:p>
          <a:p>
            <a:pPr algn="ctr"/>
            <a:r>
              <a:rPr lang="it-IT" sz="800" b="1" dirty="0" smtClean="0">
                <a:latin typeface="Arial" panose="020B0604020202020204" pitchFamily="34" charset="0"/>
                <a:cs typeface="Arial" panose="020B0604020202020204" pitchFamily="34" charset="0"/>
              </a:rPr>
              <a:t>EO</a:t>
            </a:r>
            <a:endParaRPr lang="it-IT" sz="800" b="1" dirty="0">
              <a:latin typeface="Arial" panose="020B0604020202020204" pitchFamily="34" charset="0"/>
              <a:cs typeface="Arial" panose="020B0604020202020204" pitchFamily="34" charset="0"/>
            </a:endParaRPr>
          </a:p>
        </p:txBody>
      </p:sp>
      <p:sp>
        <p:nvSpPr>
          <p:cNvPr id="242" name="CasellaDiTesto 241"/>
          <p:cNvSpPr txBox="1"/>
          <p:nvPr/>
        </p:nvSpPr>
        <p:spPr>
          <a:xfrm>
            <a:off x="5529408" y="4917933"/>
            <a:ext cx="424800" cy="461665"/>
          </a:xfrm>
          <a:prstGeom prst="rect">
            <a:avLst/>
          </a:prstGeom>
          <a:noFill/>
        </p:spPr>
        <p:txBody>
          <a:bodyPr wrap="square" rtlCol="0">
            <a:spAutoFit/>
          </a:bodyPr>
          <a:lstStyle/>
          <a:p>
            <a:pPr algn="ctr"/>
            <a:r>
              <a:rPr lang="it-IT" sz="800" b="1" dirty="0" smtClean="0">
                <a:latin typeface="Arial" panose="020B0604020202020204" pitchFamily="34" charset="0"/>
                <a:cs typeface="Arial" panose="020B0604020202020204" pitchFamily="34" charset="0"/>
              </a:rPr>
              <a:t>B16/IL-33</a:t>
            </a:r>
          </a:p>
          <a:p>
            <a:pPr algn="ctr"/>
            <a:r>
              <a:rPr lang="it-IT" sz="800" b="1" dirty="0" smtClean="0">
                <a:latin typeface="Arial" panose="020B0604020202020204" pitchFamily="34" charset="0"/>
                <a:cs typeface="Arial" panose="020B0604020202020204" pitchFamily="34" charset="0"/>
              </a:rPr>
              <a:t>EO</a:t>
            </a:r>
            <a:endParaRPr lang="it-IT" sz="800" b="1" dirty="0">
              <a:latin typeface="Arial" panose="020B0604020202020204" pitchFamily="34" charset="0"/>
              <a:cs typeface="Arial" panose="020B0604020202020204" pitchFamily="34" charset="0"/>
            </a:endParaRPr>
          </a:p>
        </p:txBody>
      </p:sp>
      <p:sp>
        <p:nvSpPr>
          <p:cNvPr id="244" name="Rettangolo 243"/>
          <p:cNvSpPr/>
          <p:nvPr/>
        </p:nvSpPr>
        <p:spPr>
          <a:xfrm>
            <a:off x="-30480" y="5436344"/>
            <a:ext cx="6181199" cy="2862322"/>
          </a:xfrm>
          <a:prstGeom prst="rect">
            <a:avLst/>
          </a:prstGeom>
        </p:spPr>
        <p:txBody>
          <a:bodyPr wrap="square">
            <a:spAutoFit/>
          </a:bodyPr>
          <a:lstStyle/>
          <a:p>
            <a:pPr algn="just"/>
            <a:r>
              <a:rPr lang="en-US" sz="1000" b="1" dirty="0" smtClean="0">
                <a:latin typeface="Arial" panose="020B0604020202020204" pitchFamily="34" charset="0"/>
                <a:cs typeface="Arial" panose="020B0604020202020204" pitchFamily="34" charset="0"/>
              </a:rPr>
              <a:t>Figure S12</a:t>
            </a:r>
            <a:r>
              <a:rPr lang="en-US" sz="1000" b="1" dirty="0" smtClean="0">
                <a:latin typeface="Arial" panose="020B0604020202020204" pitchFamily="34" charset="0"/>
                <a:cs typeface="Arial" panose="020B0604020202020204" pitchFamily="34" charset="0"/>
              </a:rPr>
              <a:t>. Quantitative analysis of protein polarization to the immune synapses.</a:t>
            </a:r>
            <a:r>
              <a:rPr lang="en-US" sz="1000" dirty="0" smtClean="0">
                <a:latin typeface="Arial" panose="020B0604020202020204" pitchFamily="34" charset="0"/>
                <a:cs typeface="Arial" panose="020B0604020202020204" pitchFamily="34" charset="0"/>
              </a:rPr>
              <a:t> (</a:t>
            </a:r>
            <a:r>
              <a:rPr lang="en-US" sz="1000" b="1" dirty="0" smtClean="0">
                <a:latin typeface="Arial" panose="020B0604020202020204" pitchFamily="34" charset="0"/>
                <a:cs typeface="Arial" panose="020B0604020202020204" pitchFamily="34" charset="0"/>
              </a:rPr>
              <a:t>A</a:t>
            </a:r>
            <a:r>
              <a:rPr lang="en-US" sz="1000" dirty="0" smtClean="0">
                <a:latin typeface="Arial" panose="020B0604020202020204" pitchFamily="34" charset="0"/>
                <a:cs typeface="Arial" panose="020B0604020202020204" pitchFamily="34" charset="0"/>
              </a:rPr>
              <a:t>) CLSM sample images of B16/IL-5 </a:t>
            </a:r>
            <a:r>
              <a:rPr lang="en-US" sz="1000" dirty="0">
                <a:latin typeface="Arial" panose="020B0604020202020204" pitchFamily="34" charset="0"/>
                <a:cs typeface="Arial" panose="020B0604020202020204" pitchFamily="34" charset="0"/>
              </a:rPr>
              <a:t>EO and </a:t>
            </a:r>
            <a:r>
              <a:rPr lang="en-US" sz="1000" dirty="0" smtClean="0">
                <a:latin typeface="Arial" panose="020B0604020202020204" pitchFamily="34" charset="0"/>
                <a:cs typeface="Arial" panose="020B0604020202020204" pitchFamily="34" charset="0"/>
              </a:rPr>
              <a:t>B16/IL-33 </a:t>
            </a:r>
            <a:r>
              <a:rPr lang="en-US" sz="1000" dirty="0">
                <a:latin typeface="Arial" panose="020B0604020202020204" pitchFamily="34" charset="0"/>
                <a:cs typeface="Arial" panose="020B0604020202020204" pitchFamily="34" charset="0"/>
              </a:rPr>
              <a:t>EO </a:t>
            </a:r>
            <a:r>
              <a:rPr lang="en-US" sz="1000" dirty="0" smtClean="0">
                <a:latin typeface="Arial" panose="020B0604020202020204" pitchFamily="34" charset="0"/>
                <a:cs typeface="Arial" panose="020B0604020202020204" pitchFamily="34" charset="0"/>
              </a:rPr>
              <a:t>conjugates stained with </a:t>
            </a:r>
            <a:r>
              <a:rPr lang="en-US" sz="1000" dirty="0" err="1" smtClean="0">
                <a:latin typeface="Arial" panose="020B0604020202020204" pitchFamily="34" charset="0"/>
                <a:cs typeface="Arial" panose="020B0604020202020204" pitchFamily="34" charset="0"/>
              </a:rPr>
              <a:t>mAbs</a:t>
            </a:r>
            <a:r>
              <a:rPr lang="en-US" sz="1000" dirty="0" smtClean="0">
                <a:latin typeface="Arial" panose="020B0604020202020204" pitchFamily="34" charset="0"/>
                <a:cs typeface="Arial" panose="020B0604020202020204" pitchFamily="34" charset="0"/>
              </a:rPr>
              <a:t> to detect actin (red) and EPX (green). </a:t>
            </a:r>
            <a:r>
              <a:rPr lang="en-US" sz="1000" dirty="0">
                <a:latin typeface="Arial" panose="020B0604020202020204" pitchFamily="34" charset="0"/>
                <a:cs typeface="Arial" panose="020B0604020202020204" pitchFamily="34" charset="0"/>
              </a:rPr>
              <a:t>Merged </a:t>
            </a:r>
            <a:r>
              <a:rPr lang="en-US" sz="1000" dirty="0" smtClean="0">
                <a:latin typeface="Arial" panose="020B0604020202020204" pitchFamily="34" charset="0"/>
                <a:cs typeface="Arial" panose="020B0604020202020204" pitchFamily="34" charset="0"/>
              </a:rPr>
              <a:t>image was split </a:t>
            </a:r>
            <a:r>
              <a:rPr lang="en-US" sz="1000" dirty="0">
                <a:latin typeface="Arial" panose="020B0604020202020204" pitchFamily="34" charset="0"/>
                <a:cs typeface="Arial" panose="020B0604020202020204" pitchFamily="34" charset="0"/>
              </a:rPr>
              <a:t>in the associated green and red fluorescence channels. The depicted synapse/EO body boundaries are created with ImageJ software to calculate the indicated centroids for each region. </a:t>
            </a:r>
            <a:r>
              <a:rPr lang="en-US" sz="1000" dirty="0" smtClean="0">
                <a:latin typeface="Arial" panose="020B0604020202020204" pitchFamily="34" charset="0"/>
                <a:cs typeface="Arial" panose="020B0604020202020204" pitchFamily="34" charset="0"/>
              </a:rPr>
              <a:t>Fluorescence </a:t>
            </a:r>
            <a:r>
              <a:rPr lang="en-US" sz="1000" dirty="0">
                <a:latin typeface="Arial" panose="020B0604020202020204" pitchFamily="34" charset="0"/>
                <a:cs typeface="Arial" panose="020B0604020202020204" pitchFamily="34" charset="0"/>
              </a:rPr>
              <a:t>lines are drawn </a:t>
            </a:r>
            <a:r>
              <a:rPr lang="en-US" sz="1000" dirty="0" smtClean="0">
                <a:latin typeface="Arial" panose="020B0604020202020204" pitchFamily="34" charset="0"/>
                <a:cs typeface="Arial" panose="020B0604020202020204" pitchFamily="34" charset="0"/>
              </a:rPr>
              <a:t>to </a:t>
            </a:r>
            <a:r>
              <a:rPr lang="en-US" sz="1000" dirty="0">
                <a:latin typeface="Arial" panose="020B0604020202020204" pitchFamily="34" charset="0"/>
                <a:cs typeface="Arial" panose="020B0604020202020204" pitchFamily="34" charset="0"/>
              </a:rPr>
              <a:t>interpolate the EO </a:t>
            </a:r>
            <a:r>
              <a:rPr lang="en-US" sz="1000" dirty="0" smtClean="0">
                <a:latin typeface="Arial" panose="020B0604020202020204" pitchFamily="34" charset="0"/>
                <a:cs typeface="Arial" panose="020B0604020202020204" pitchFamily="34" charset="0"/>
              </a:rPr>
              <a:t>body/synapse </a:t>
            </a:r>
            <a:r>
              <a:rPr lang="en-US" sz="1000" dirty="0">
                <a:latin typeface="Arial" panose="020B0604020202020204" pitchFamily="34" charset="0"/>
                <a:cs typeface="Arial" panose="020B0604020202020204" pitchFamily="34" charset="0"/>
              </a:rPr>
              <a:t>centroid points and are used for EPX </a:t>
            </a:r>
            <a:r>
              <a:rPr lang="en-US" sz="1000" dirty="0" smtClean="0">
                <a:latin typeface="Arial" panose="020B0604020202020204" pitchFamily="34" charset="0"/>
                <a:cs typeface="Arial" panose="020B0604020202020204" pitchFamily="34" charset="0"/>
              </a:rPr>
              <a:t>fluorescence </a:t>
            </a:r>
            <a:r>
              <a:rPr lang="en-US" sz="1000" dirty="0">
                <a:latin typeface="Arial" panose="020B0604020202020204" pitchFamily="34" charset="0"/>
                <a:cs typeface="Arial" panose="020B0604020202020204" pitchFamily="34" charset="0"/>
              </a:rPr>
              <a:t>ratio determination </a:t>
            </a:r>
            <a:r>
              <a:rPr lang="en-US" sz="1000" dirty="0" smtClean="0">
                <a:latin typeface="Arial" panose="020B0604020202020204" pitchFamily="34" charset="0"/>
                <a:cs typeface="Arial" panose="020B0604020202020204" pitchFamily="34" charset="0"/>
              </a:rPr>
              <a:t>(</a:t>
            </a:r>
            <a:r>
              <a:rPr lang="en-US" sz="1000" b="1" dirty="0">
                <a:latin typeface="Arial" panose="020B0604020202020204" pitchFamily="34" charset="0"/>
                <a:cs typeface="Arial" panose="020B0604020202020204" pitchFamily="34" charset="0"/>
              </a:rPr>
              <a:t>B</a:t>
            </a:r>
            <a:r>
              <a:rPr lang="en-US" sz="1000" dirty="0" smtClean="0">
                <a:latin typeface="Arial" panose="020B0604020202020204" pitchFamily="34" charset="0"/>
                <a:cs typeface="Arial" panose="020B0604020202020204" pitchFamily="34" charset="0"/>
              </a:rPr>
              <a:t>) </a:t>
            </a:r>
            <a:r>
              <a:rPr lang="en-US" sz="1000" dirty="0">
                <a:latin typeface="Arial" panose="020B0604020202020204" pitchFamily="34" charset="0"/>
                <a:cs typeface="Arial" panose="020B0604020202020204" pitchFamily="34" charset="0"/>
              </a:rPr>
              <a:t>and determination of EO polarization extent referred to EPX fluorescence distribution across the EO body and synapse </a:t>
            </a:r>
            <a:r>
              <a:rPr lang="en-US" sz="1000" dirty="0" smtClean="0">
                <a:latin typeface="Arial" panose="020B0604020202020204" pitchFamily="34" charset="0"/>
                <a:cs typeface="Arial" panose="020B0604020202020204" pitchFamily="34" charset="0"/>
              </a:rPr>
              <a:t>(</a:t>
            </a:r>
            <a:r>
              <a:rPr lang="en-US" sz="1000" b="1" dirty="0" smtClean="0">
                <a:latin typeface="Arial" panose="020B0604020202020204" pitchFamily="34" charset="0"/>
                <a:cs typeface="Arial" panose="020B0604020202020204" pitchFamily="34" charset="0"/>
              </a:rPr>
              <a:t>C</a:t>
            </a:r>
            <a:r>
              <a:rPr lang="en-US" sz="1000" b="1" dirty="0">
                <a:latin typeface="Arial" panose="020B0604020202020204" pitchFamily="34" charset="0"/>
                <a:cs typeface="Arial" panose="020B0604020202020204" pitchFamily="34" charset="0"/>
              </a:rPr>
              <a:t> </a:t>
            </a:r>
            <a:r>
              <a:rPr lang="en-US" sz="1000" dirty="0" smtClean="0">
                <a:latin typeface="Arial" panose="020B0604020202020204" pitchFamily="34" charset="0"/>
                <a:cs typeface="Arial" panose="020B0604020202020204" pitchFamily="34" charset="0"/>
              </a:rPr>
              <a:t>and</a:t>
            </a:r>
            <a:r>
              <a:rPr lang="en-US" sz="1000" b="1" dirty="0" smtClean="0">
                <a:latin typeface="Arial" panose="020B0604020202020204" pitchFamily="34" charset="0"/>
                <a:cs typeface="Arial" panose="020B0604020202020204" pitchFamily="34" charset="0"/>
              </a:rPr>
              <a:t> D</a:t>
            </a:r>
            <a:r>
              <a:rPr lang="en-US" sz="1000" dirty="0" smtClean="0">
                <a:latin typeface="Arial" panose="020B0604020202020204" pitchFamily="34" charset="0"/>
                <a:cs typeface="Arial" panose="020B0604020202020204" pitchFamily="34" charset="0"/>
              </a:rPr>
              <a:t>). (</a:t>
            </a:r>
            <a:r>
              <a:rPr lang="en-US" sz="1000" b="1" dirty="0" smtClean="0">
                <a:latin typeface="Arial" panose="020B0604020202020204" pitchFamily="34" charset="0"/>
                <a:cs typeface="Arial" panose="020B0604020202020204" pitchFamily="34" charset="0"/>
              </a:rPr>
              <a:t>B</a:t>
            </a:r>
            <a:r>
              <a:rPr lang="en-US" sz="1000" dirty="0" smtClean="0">
                <a:latin typeface="Arial" panose="020B0604020202020204" pitchFamily="34" charset="0"/>
                <a:cs typeface="Arial" panose="020B0604020202020204" pitchFamily="34" charset="0"/>
              </a:rPr>
              <a:t>) Fluorescence intensity </a:t>
            </a:r>
            <a:r>
              <a:rPr lang="en-US" sz="1000" dirty="0">
                <a:latin typeface="Arial" panose="020B0604020202020204" pitchFamily="34" charset="0"/>
                <a:cs typeface="Arial" panose="020B0604020202020204" pitchFamily="34" charset="0"/>
              </a:rPr>
              <a:t>of </a:t>
            </a:r>
            <a:r>
              <a:rPr lang="en-US" sz="1000" dirty="0" smtClean="0">
                <a:latin typeface="Arial" panose="020B0604020202020204" pitchFamily="34" charset="0"/>
                <a:cs typeface="Arial" panose="020B0604020202020204" pitchFamily="34" charset="0"/>
              </a:rPr>
              <a:t>actin </a:t>
            </a:r>
            <a:r>
              <a:rPr lang="en-US" sz="1000" dirty="0">
                <a:latin typeface="Arial" panose="020B0604020202020204" pitchFamily="34" charset="0"/>
                <a:cs typeface="Arial" panose="020B0604020202020204" pitchFamily="34" charset="0"/>
              </a:rPr>
              <a:t>and EPX of the indicated experimental </a:t>
            </a:r>
            <a:r>
              <a:rPr lang="en-US" sz="1000" dirty="0" smtClean="0">
                <a:latin typeface="Arial" panose="020B0604020202020204" pitchFamily="34" charset="0"/>
                <a:cs typeface="Arial" panose="020B0604020202020204" pitchFamily="34" charset="0"/>
              </a:rPr>
              <a:t>conditions. </a:t>
            </a:r>
            <a:r>
              <a:rPr lang="en-US" sz="1000" dirty="0">
                <a:latin typeface="Arial" panose="020B0604020202020204" pitchFamily="34" charset="0"/>
                <a:cs typeface="Arial" panose="020B0604020202020204" pitchFamily="34" charset="0"/>
              </a:rPr>
              <a:t>The </a:t>
            </a:r>
            <a:r>
              <a:rPr lang="en-US" sz="1000" dirty="0" smtClean="0">
                <a:latin typeface="Arial" panose="020B0604020202020204" pitchFamily="34" charset="0"/>
                <a:cs typeface="Arial" panose="020B0604020202020204" pitchFamily="34" charset="0"/>
              </a:rPr>
              <a:t>actin </a:t>
            </a:r>
            <a:r>
              <a:rPr lang="en-US" sz="1000" dirty="0">
                <a:latin typeface="Arial" panose="020B0604020202020204" pitchFamily="34" charset="0"/>
                <a:cs typeface="Arial" panose="020B0604020202020204" pitchFamily="34" charset="0"/>
              </a:rPr>
              <a:t>profiles </a:t>
            </a:r>
            <a:r>
              <a:rPr lang="en-US" sz="1000" dirty="0" smtClean="0">
                <a:latin typeface="Arial" panose="020B0604020202020204" pitchFamily="34" charset="0"/>
                <a:cs typeface="Arial" panose="020B0604020202020204" pitchFamily="34" charset="0"/>
              </a:rPr>
              <a:t>identify </a:t>
            </a:r>
            <a:r>
              <a:rPr lang="en-US" sz="1000" dirty="0">
                <a:latin typeface="Arial" panose="020B0604020202020204" pitchFamily="34" charset="0"/>
                <a:cs typeface="Arial" panose="020B0604020202020204" pitchFamily="34" charset="0"/>
              </a:rPr>
              <a:t>the X point of separation </a:t>
            </a:r>
            <a:r>
              <a:rPr lang="en-US" sz="1000" dirty="0" smtClean="0">
                <a:latin typeface="Arial" panose="020B0604020202020204" pitchFamily="34" charset="0"/>
                <a:cs typeface="Arial" panose="020B0604020202020204" pitchFamily="34" charset="0"/>
              </a:rPr>
              <a:t>between </a:t>
            </a:r>
            <a:r>
              <a:rPr lang="en-US" sz="1000" dirty="0">
                <a:latin typeface="Arial" panose="020B0604020202020204" pitchFamily="34" charset="0"/>
                <a:cs typeface="Arial" panose="020B0604020202020204" pitchFamily="34" charset="0"/>
              </a:rPr>
              <a:t>the synapse and the EO body within the EO-tumor cell contact area. The synaptic region was then translated to the EPX </a:t>
            </a:r>
            <a:r>
              <a:rPr lang="en-US" sz="1000" dirty="0" smtClean="0">
                <a:latin typeface="Arial" panose="020B0604020202020204" pitchFamily="34" charset="0"/>
                <a:cs typeface="Arial" panose="020B0604020202020204" pitchFamily="34" charset="0"/>
              </a:rPr>
              <a:t>fluorescence profile. (</a:t>
            </a:r>
            <a:r>
              <a:rPr lang="en-US" sz="1000" b="1" dirty="0" smtClean="0">
                <a:latin typeface="Arial" panose="020B0604020202020204" pitchFamily="34" charset="0"/>
                <a:cs typeface="Arial" panose="020B0604020202020204" pitchFamily="34" charset="0"/>
              </a:rPr>
              <a:t>C</a:t>
            </a:r>
            <a:r>
              <a:rPr lang="en-US" sz="1000" dirty="0" smtClean="0">
                <a:latin typeface="Arial" panose="020B0604020202020204" pitchFamily="34" charset="0"/>
                <a:cs typeface="Arial" panose="020B0604020202020204" pitchFamily="34" charset="0"/>
              </a:rPr>
              <a:t>) Fluorescence </a:t>
            </a:r>
            <a:r>
              <a:rPr lang="en-US" sz="1000" dirty="0">
                <a:latin typeface="Arial" panose="020B0604020202020204" pitchFamily="34" charset="0"/>
                <a:cs typeface="Arial" panose="020B0604020202020204" pitchFamily="34" charset="0"/>
              </a:rPr>
              <a:t>profiles in </a:t>
            </a:r>
            <a:r>
              <a:rPr lang="en-US" sz="1000" dirty="0" smtClean="0">
                <a:latin typeface="Arial" panose="020B0604020202020204" pitchFamily="34" charset="0"/>
                <a:cs typeface="Arial" panose="020B0604020202020204" pitchFamily="34" charset="0"/>
              </a:rPr>
              <a:t>these two </a:t>
            </a:r>
            <a:r>
              <a:rPr lang="en-US" sz="1000" dirty="0">
                <a:latin typeface="Arial" panose="020B0604020202020204" pitchFamily="34" charset="0"/>
                <a:cs typeface="Arial" panose="020B0604020202020204" pitchFamily="34" charset="0"/>
              </a:rPr>
              <a:t>zones </a:t>
            </a:r>
            <a:r>
              <a:rPr lang="en-US" sz="1000" dirty="0" smtClean="0">
                <a:latin typeface="Arial" panose="020B0604020202020204" pitchFamily="34" charset="0"/>
                <a:cs typeface="Arial" panose="020B0604020202020204" pitchFamily="34" charset="0"/>
              </a:rPr>
              <a:t>allow </a:t>
            </a:r>
            <a:r>
              <a:rPr lang="en-US" sz="1000" dirty="0">
                <a:latin typeface="Arial" panose="020B0604020202020204" pitchFamily="34" charset="0"/>
                <a:cs typeface="Arial" panose="020B0604020202020204" pitchFamily="34" charset="0"/>
              </a:rPr>
              <a:t>to calculate </a:t>
            </a:r>
            <a:r>
              <a:rPr lang="en-US" sz="1000" dirty="0" smtClean="0">
                <a:latin typeface="Arial" panose="020B0604020202020204" pitchFamily="34" charset="0"/>
                <a:cs typeface="Arial" panose="020B0604020202020204" pitchFamily="34" charset="0"/>
              </a:rPr>
              <a:t>the percent of fluorescence into synapse compared to the total fluorescence, obtained by dividing the sum of all EPX fluorescence channels inside the synapse region by the sum of the EPX fluorescence in all the profile channels. </a:t>
            </a:r>
            <a:r>
              <a:rPr lang="en-US" sz="1000" dirty="0" err="1" smtClean="0">
                <a:latin typeface="Arial" panose="020B0604020202020204" pitchFamily="34" charset="0"/>
                <a:cs typeface="Arial" panose="020B0604020202020204" pitchFamily="34" charset="0"/>
              </a:rPr>
              <a:t>Fluor</a:t>
            </a:r>
            <a:r>
              <a:rPr lang="en-US" sz="1000" baseline="-25000" dirty="0" err="1" smtClean="0">
                <a:latin typeface="Arial" panose="020B0604020202020204" pitchFamily="34" charset="0"/>
                <a:cs typeface="Arial" panose="020B0604020202020204" pitchFamily="34" charset="0"/>
              </a:rPr>
              <a:t>synapse</a:t>
            </a:r>
            <a:r>
              <a:rPr lang="en-US" sz="1000" dirty="0" smtClean="0">
                <a:latin typeface="Arial" panose="020B0604020202020204" pitchFamily="34" charset="0"/>
                <a:cs typeface="Arial" panose="020B0604020202020204" pitchFamily="34" charset="0"/>
              </a:rPr>
              <a:t>, single fluorescence channel </a:t>
            </a:r>
            <a:r>
              <a:rPr lang="en-US" sz="1000" dirty="0">
                <a:latin typeface="Arial" panose="020B0604020202020204" pitchFamily="34" charset="0"/>
                <a:cs typeface="Arial" panose="020B0604020202020204" pitchFamily="34" charset="0"/>
              </a:rPr>
              <a:t>inside the synapse profile region; </a:t>
            </a:r>
            <a:r>
              <a:rPr lang="en-US" sz="1000" dirty="0" err="1">
                <a:latin typeface="Arial" panose="020B0604020202020204" pitchFamily="34" charset="0"/>
                <a:cs typeface="Arial" panose="020B0604020202020204" pitchFamily="34" charset="0"/>
              </a:rPr>
              <a:t>Fluor</a:t>
            </a:r>
            <a:r>
              <a:rPr lang="en-US" sz="1000" baseline="-25000" dirty="0" err="1">
                <a:latin typeface="Arial" panose="020B0604020202020204" pitchFamily="34" charset="0"/>
                <a:cs typeface="Arial" panose="020B0604020202020204" pitchFamily="34" charset="0"/>
              </a:rPr>
              <a:t>Eo</a:t>
            </a:r>
            <a:r>
              <a:rPr lang="en-US" sz="1000" baseline="-25000" dirty="0">
                <a:latin typeface="Arial" panose="020B0604020202020204" pitchFamily="34" charset="0"/>
                <a:cs typeface="Arial" panose="020B0604020202020204" pitchFamily="34" charset="0"/>
              </a:rPr>
              <a:t> body</a:t>
            </a:r>
            <a:r>
              <a:rPr lang="en-US" sz="1000" dirty="0">
                <a:latin typeface="Arial" panose="020B0604020202020204" pitchFamily="34" charset="0"/>
                <a:cs typeface="Arial" panose="020B0604020202020204" pitchFamily="34" charset="0"/>
              </a:rPr>
              <a:t>, </a:t>
            </a:r>
            <a:r>
              <a:rPr lang="en-US" sz="1000" dirty="0" smtClean="0">
                <a:latin typeface="Arial" panose="020B0604020202020204" pitchFamily="34" charset="0"/>
                <a:cs typeface="Arial" panose="020B0604020202020204" pitchFamily="34" charset="0"/>
              </a:rPr>
              <a:t>single </a:t>
            </a:r>
            <a:r>
              <a:rPr lang="en-US" sz="1000" dirty="0">
                <a:latin typeface="Arial" panose="020B0604020202020204" pitchFamily="34" charset="0"/>
                <a:cs typeface="Arial" panose="020B0604020202020204" pitchFamily="34" charset="0"/>
              </a:rPr>
              <a:t>fluorescence </a:t>
            </a:r>
            <a:r>
              <a:rPr lang="en-US" sz="1000" dirty="0" smtClean="0">
                <a:latin typeface="Arial" panose="020B0604020202020204" pitchFamily="34" charset="0"/>
                <a:cs typeface="Arial" panose="020B0604020202020204" pitchFamily="34" charset="0"/>
              </a:rPr>
              <a:t>channel </a:t>
            </a:r>
            <a:r>
              <a:rPr lang="en-US" sz="1000" dirty="0">
                <a:latin typeface="Arial" panose="020B0604020202020204" pitchFamily="34" charset="0"/>
                <a:cs typeface="Arial" panose="020B0604020202020204" pitchFamily="34" charset="0"/>
              </a:rPr>
              <a:t>inside the EO body profile </a:t>
            </a:r>
            <a:r>
              <a:rPr lang="en-US" sz="1000" dirty="0" smtClean="0">
                <a:latin typeface="Arial" panose="020B0604020202020204" pitchFamily="34" charset="0"/>
                <a:cs typeface="Arial" panose="020B0604020202020204" pitchFamily="34" charset="0"/>
              </a:rPr>
              <a:t>region. (</a:t>
            </a:r>
            <a:r>
              <a:rPr lang="en-US" sz="1000" b="1" dirty="0" smtClean="0">
                <a:latin typeface="Arial" panose="020B0604020202020204" pitchFamily="34" charset="0"/>
                <a:cs typeface="Arial" panose="020B0604020202020204" pitchFamily="34" charset="0"/>
              </a:rPr>
              <a:t>D</a:t>
            </a:r>
            <a:r>
              <a:rPr lang="en-US" sz="1000" dirty="0" smtClean="0">
                <a:latin typeface="Arial" panose="020B0604020202020204" pitchFamily="34" charset="0"/>
                <a:cs typeface="Arial" panose="020B0604020202020204" pitchFamily="34" charset="0"/>
              </a:rPr>
              <a:t>) </a:t>
            </a:r>
            <a:r>
              <a:rPr lang="en-US" sz="1000" dirty="0">
                <a:latin typeface="Arial" panose="020B0604020202020204" pitchFamily="34" charset="0"/>
                <a:cs typeface="Arial" panose="020B0604020202020204" pitchFamily="34" charset="0"/>
              </a:rPr>
              <a:t>Calculation of the linear regression fit </a:t>
            </a:r>
            <a:r>
              <a:rPr lang="en-US" sz="1000" dirty="0" smtClean="0">
                <a:latin typeface="Arial" panose="020B0604020202020204" pitchFamily="34" charset="0"/>
                <a:cs typeface="Arial" panose="020B0604020202020204" pitchFamily="34" charset="0"/>
              </a:rPr>
              <a:t>(black line) associated </a:t>
            </a:r>
            <a:r>
              <a:rPr lang="en-US" sz="1000" dirty="0">
                <a:latin typeface="Arial" panose="020B0604020202020204" pitchFamily="34" charset="0"/>
                <a:cs typeface="Arial" panose="020B0604020202020204" pitchFamily="34" charset="0"/>
              </a:rPr>
              <a:t>to the EPX fluorescence profile points and X axis positions. Points represent linear regression +/- 95% confidence intervals. This regression fit yielded the </a:t>
            </a:r>
            <a:r>
              <a:rPr lang="en-US" sz="1000" dirty="0" smtClean="0">
                <a:latin typeface="Arial" panose="020B0604020202020204" pitchFamily="34" charset="0"/>
                <a:cs typeface="Arial" panose="020B0604020202020204" pitchFamily="34" charset="0"/>
              </a:rPr>
              <a:t>polarization coefficient (histogram plots) and is represented by the indicated </a:t>
            </a:r>
            <a:r>
              <a:rPr lang="en-US" sz="1000" dirty="0">
                <a:latin typeface="Arial" panose="020B0604020202020204" pitchFamily="34" charset="0"/>
                <a:cs typeface="Arial" panose="020B0604020202020204" pitchFamily="34" charset="0"/>
              </a:rPr>
              <a:t>slope values of the EO body/synapse complexes. </a:t>
            </a:r>
            <a:r>
              <a:rPr lang="en-US" sz="1000" dirty="0" smtClean="0">
                <a:latin typeface="Arial" panose="020B0604020202020204" pitchFamily="34" charset="0"/>
                <a:cs typeface="Arial" panose="020B0604020202020204" pitchFamily="34" charset="0"/>
              </a:rPr>
              <a:t>This coefficient </a:t>
            </a:r>
            <a:r>
              <a:rPr lang="en-US" sz="1000" dirty="0">
                <a:latin typeface="Arial" panose="020B0604020202020204" pitchFamily="34" charset="0"/>
                <a:cs typeface="Arial" panose="020B0604020202020204" pitchFamily="34" charset="0"/>
              </a:rPr>
              <a:t>represents a quantitative definition of the EPX polarization inside the analyzed eosinophil.</a:t>
            </a:r>
          </a:p>
        </p:txBody>
      </p:sp>
      <p:grpSp>
        <p:nvGrpSpPr>
          <p:cNvPr id="3" name="Gruppo 2"/>
          <p:cNvGrpSpPr/>
          <p:nvPr/>
        </p:nvGrpSpPr>
        <p:grpSpPr>
          <a:xfrm>
            <a:off x="2387600" y="3966680"/>
            <a:ext cx="1003835" cy="1416753"/>
            <a:chOff x="2779320" y="3981025"/>
            <a:chExt cx="1003835" cy="1416753"/>
          </a:xfrm>
        </p:grpSpPr>
        <p:sp>
          <p:nvSpPr>
            <p:cNvPr id="205" name="CasellaDiTesto 204"/>
            <p:cNvSpPr txBox="1"/>
            <p:nvPr/>
          </p:nvSpPr>
          <p:spPr>
            <a:xfrm>
              <a:off x="3010407" y="4936113"/>
              <a:ext cx="398983" cy="461665"/>
            </a:xfrm>
            <a:prstGeom prst="rect">
              <a:avLst/>
            </a:prstGeom>
            <a:noFill/>
          </p:spPr>
          <p:txBody>
            <a:bodyPr wrap="square" rtlCol="0">
              <a:spAutoFit/>
            </a:bodyPr>
            <a:lstStyle/>
            <a:p>
              <a:pPr algn="ctr"/>
              <a:r>
                <a:rPr lang="it-IT" sz="800" b="1" dirty="0" smtClean="0">
                  <a:latin typeface="Arial" panose="020B0604020202020204" pitchFamily="34" charset="0"/>
                  <a:cs typeface="Arial" panose="020B0604020202020204" pitchFamily="34" charset="0"/>
                </a:rPr>
                <a:t>B16/IL-5</a:t>
              </a:r>
            </a:p>
            <a:p>
              <a:pPr algn="ctr"/>
              <a:r>
                <a:rPr lang="it-IT" sz="800" b="1" dirty="0" smtClean="0">
                  <a:latin typeface="Arial" panose="020B0604020202020204" pitchFamily="34" charset="0"/>
                  <a:cs typeface="Arial" panose="020B0604020202020204" pitchFamily="34" charset="0"/>
                </a:rPr>
                <a:t>EO</a:t>
              </a:r>
              <a:endParaRPr lang="it-IT" sz="800" b="1" dirty="0">
                <a:latin typeface="Arial" panose="020B0604020202020204" pitchFamily="34" charset="0"/>
                <a:cs typeface="Arial" panose="020B0604020202020204" pitchFamily="34" charset="0"/>
              </a:endParaRPr>
            </a:p>
          </p:txBody>
        </p:sp>
        <p:sp>
          <p:nvSpPr>
            <p:cNvPr id="240" name="CasellaDiTesto 239"/>
            <p:cNvSpPr txBox="1"/>
            <p:nvPr/>
          </p:nvSpPr>
          <p:spPr>
            <a:xfrm>
              <a:off x="3358355" y="4936113"/>
              <a:ext cx="424800" cy="461665"/>
            </a:xfrm>
            <a:prstGeom prst="rect">
              <a:avLst/>
            </a:prstGeom>
            <a:noFill/>
          </p:spPr>
          <p:txBody>
            <a:bodyPr wrap="square" rtlCol="0">
              <a:spAutoFit/>
            </a:bodyPr>
            <a:lstStyle/>
            <a:p>
              <a:pPr algn="ctr"/>
              <a:r>
                <a:rPr lang="it-IT" sz="800" b="1" dirty="0" smtClean="0">
                  <a:latin typeface="Arial" panose="020B0604020202020204" pitchFamily="34" charset="0"/>
                  <a:cs typeface="Arial" panose="020B0604020202020204" pitchFamily="34" charset="0"/>
                </a:rPr>
                <a:t>B16/IL-33</a:t>
              </a:r>
            </a:p>
            <a:p>
              <a:pPr algn="ctr"/>
              <a:r>
                <a:rPr lang="it-IT" sz="800" b="1" dirty="0" smtClean="0">
                  <a:latin typeface="Arial" panose="020B0604020202020204" pitchFamily="34" charset="0"/>
                  <a:cs typeface="Arial" panose="020B0604020202020204" pitchFamily="34" charset="0"/>
                </a:rPr>
                <a:t>EO</a:t>
              </a:r>
              <a:endParaRPr lang="it-IT" sz="800" b="1" dirty="0">
                <a:latin typeface="Arial" panose="020B0604020202020204" pitchFamily="34" charset="0"/>
                <a:cs typeface="Arial" panose="020B0604020202020204" pitchFamily="34" charset="0"/>
              </a:endParaRPr>
            </a:p>
          </p:txBody>
        </p:sp>
        <p:pic>
          <p:nvPicPr>
            <p:cNvPr id="2051" name="Picture 3"/>
            <p:cNvPicPr>
              <a:picLocks noChangeAspect="1" noChangeArrowheads="1"/>
            </p:cNvPicPr>
            <p:nvPr/>
          </p:nvPicPr>
          <p:blipFill rotWithShape="1">
            <a:blip r:embed="rId15" cstate="print">
              <a:extLst>
                <a:ext uri="{28A0092B-C50C-407E-A947-70E740481C1C}">
                  <a14:useLocalDpi xmlns:a14="http://schemas.microsoft.com/office/drawing/2010/main" val="0"/>
                </a:ext>
              </a:extLst>
            </a:blip>
            <a:srcRect l="26640" t="1" b="30544"/>
            <a:stretch/>
          </p:blipFill>
          <p:spPr bwMode="auto">
            <a:xfrm>
              <a:off x="2779320" y="3981025"/>
              <a:ext cx="924730" cy="99271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mc:AlternateContent xmlns:mc="http://schemas.openxmlformats.org/markup-compatibility/2006" xmlns:a14="http://schemas.microsoft.com/office/drawing/2010/main">
        <mc:Choice Requires="a14">
          <p:sp>
            <p:nvSpPr>
              <p:cNvPr id="2" name="CasellaDiTesto 1"/>
              <p:cNvSpPr txBox="1"/>
              <p:nvPr/>
            </p:nvSpPr>
            <p:spPr>
              <a:xfrm>
                <a:off x="545440" y="3396520"/>
                <a:ext cx="2604623" cy="441211"/>
              </a:xfrm>
              <a:prstGeom prst="rect">
                <a:avLst/>
              </a:prstGeom>
              <a:noFill/>
            </p:spPr>
            <p:txBody>
              <a:bodyPr wrap="none" rtlCol="0">
                <a:spAutoFit/>
              </a:bodyPr>
              <a:lstStyle/>
              <a:p>
                <a:pPr/>
                <a14:m>
                  <m:oMathPara xmlns:m="http://schemas.openxmlformats.org/officeDocument/2006/math">
                    <m:oMathParaPr>
                      <m:jc m:val="centerGroup"/>
                    </m:oMathParaPr>
                    <m:oMath xmlns:m="http://schemas.openxmlformats.org/officeDocument/2006/math">
                      <m:r>
                        <a:rPr lang="it-IT" sz="1000" i="1" smtClean="0">
                          <a:latin typeface="Cambria Math"/>
                        </a:rPr>
                        <m:t>𝑅</m:t>
                      </m:r>
                      <m:r>
                        <a:rPr lang="it-IT" sz="1000" i="1" smtClean="0">
                          <a:latin typeface="Cambria Math"/>
                        </a:rPr>
                        <m:t>=100</m:t>
                      </m:r>
                      <m:d>
                        <m:dPr>
                          <m:ctrlPr>
                            <a:rPr lang="it-IT" sz="1000" i="1" smtClean="0">
                              <a:latin typeface="Cambria Math" panose="02040503050406030204" pitchFamily="18" charset="0"/>
                            </a:rPr>
                          </m:ctrlPr>
                        </m:dPr>
                        <m:e>
                          <m:f>
                            <m:fPr>
                              <m:ctrlPr>
                                <a:rPr lang="it-IT" sz="1000" i="1" smtClean="0">
                                  <a:latin typeface="Cambria Math" panose="02040503050406030204" pitchFamily="18" charset="0"/>
                                </a:rPr>
                              </m:ctrlPr>
                            </m:fPr>
                            <m:num>
                              <m:nary>
                                <m:naryPr>
                                  <m:chr m:val="∑"/>
                                  <m:subHide m:val="on"/>
                                  <m:supHide m:val="on"/>
                                  <m:ctrlPr>
                                    <a:rPr lang="it-IT" sz="1000" i="1">
                                      <a:latin typeface="Cambria Math" panose="02040503050406030204" pitchFamily="18" charset="0"/>
                                    </a:rPr>
                                  </m:ctrlPr>
                                </m:naryPr>
                                <m:sub/>
                                <m:sup/>
                                <m:e>
                                  <m:sSub>
                                    <m:sSubPr>
                                      <m:ctrlPr>
                                        <a:rPr lang="it-IT" sz="1000" i="1">
                                          <a:latin typeface="Cambria Math" panose="02040503050406030204" pitchFamily="18" charset="0"/>
                                        </a:rPr>
                                      </m:ctrlPr>
                                    </m:sSubPr>
                                    <m:e>
                                      <m:r>
                                        <a:rPr lang="it-IT" sz="1000" i="1">
                                          <a:latin typeface="Cambria Math"/>
                                        </a:rPr>
                                        <m:t>𝐹𝑙𝑢𝑜𝑟</m:t>
                                      </m:r>
                                    </m:e>
                                    <m:sub>
                                      <m:r>
                                        <a:rPr lang="it-IT" sz="1000" i="1">
                                          <a:latin typeface="Cambria Math"/>
                                        </a:rPr>
                                        <m:t>𝑠𝑦𝑛𝑎𝑝𝑠𝑒</m:t>
                                      </m:r>
                                    </m:sub>
                                  </m:sSub>
                                </m:e>
                              </m:nary>
                            </m:num>
                            <m:den>
                              <m:nary>
                                <m:naryPr>
                                  <m:chr m:val="∑"/>
                                  <m:subHide m:val="on"/>
                                  <m:supHide m:val="on"/>
                                  <m:ctrlPr>
                                    <a:rPr lang="it-IT" sz="1000" i="1">
                                      <a:latin typeface="Cambria Math" panose="02040503050406030204" pitchFamily="18" charset="0"/>
                                    </a:rPr>
                                  </m:ctrlPr>
                                </m:naryPr>
                                <m:sub/>
                                <m:sup/>
                                <m:e>
                                  <m:sSub>
                                    <m:sSubPr>
                                      <m:ctrlPr>
                                        <a:rPr lang="it-IT" sz="1000" i="1">
                                          <a:latin typeface="Cambria Math" panose="02040503050406030204" pitchFamily="18" charset="0"/>
                                        </a:rPr>
                                      </m:ctrlPr>
                                    </m:sSubPr>
                                    <m:e>
                                      <m:r>
                                        <a:rPr lang="it-IT" sz="1000" i="1">
                                          <a:latin typeface="Cambria Math"/>
                                        </a:rPr>
                                        <m:t>𝐹𝑙𝑢𝑜𝑟</m:t>
                                      </m:r>
                                    </m:e>
                                    <m:sub>
                                      <m:r>
                                        <a:rPr lang="it-IT" sz="1000" i="1">
                                          <a:latin typeface="Cambria Math"/>
                                        </a:rPr>
                                        <m:t>𝐸𝑂</m:t>
                                      </m:r>
                                      <m:r>
                                        <a:rPr lang="it-IT" sz="1000" i="1">
                                          <a:latin typeface="Cambria Math"/>
                                        </a:rPr>
                                        <m:t> </m:t>
                                      </m:r>
                                      <m:r>
                                        <a:rPr lang="it-IT" sz="1000" i="1">
                                          <a:latin typeface="Cambria Math"/>
                                        </a:rPr>
                                        <m:t>𝑏𝑜𝑑𝑦</m:t>
                                      </m:r>
                                    </m:sub>
                                  </m:sSub>
                                </m:e>
                              </m:nary>
                              <m:r>
                                <a:rPr lang="it-IT" sz="1000" b="0" i="1" smtClean="0">
                                  <a:latin typeface="Cambria Math"/>
                                </a:rPr>
                                <m:t>+</m:t>
                              </m:r>
                              <m:nary>
                                <m:naryPr>
                                  <m:chr m:val="∑"/>
                                  <m:subHide m:val="on"/>
                                  <m:supHide m:val="on"/>
                                  <m:ctrlPr>
                                    <a:rPr lang="it-IT" sz="1000" i="1">
                                      <a:latin typeface="Cambria Math" panose="02040503050406030204" pitchFamily="18" charset="0"/>
                                    </a:rPr>
                                  </m:ctrlPr>
                                </m:naryPr>
                                <m:sub/>
                                <m:sup/>
                                <m:e>
                                  <m:sSub>
                                    <m:sSubPr>
                                      <m:ctrlPr>
                                        <a:rPr lang="it-IT" sz="1000" i="1">
                                          <a:latin typeface="Cambria Math" panose="02040503050406030204" pitchFamily="18" charset="0"/>
                                        </a:rPr>
                                      </m:ctrlPr>
                                    </m:sSubPr>
                                    <m:e>
                                      <m:r>
                                        <a:rPr lang="it-IT" sz="1000" i="1">
                                          <a:latin typeface="Cambria Math"/>
                                        </a:rPr>
                                        <m:t>𝐹𝑙𝑢𝑜𝑟</m:t>
                                      </m:r>
                                    </m:e>
                                    <m:sub>
                                      <m:r>
                                        <a:rPr lang="it-IT" sz="1000" i="1">
                                          <a:latin typeface="Cambria Math"/>
                                        </a:rPr>
                                        <m:t>𝑠𝑦𝑛𝑎𝑝𝑠𝑒</m:t>
                                      </m:r>
                                    </m:sub>
                                  </m:sSub>
                                </m:e>
                              </m:nary>
                            </m:den>
                          </m:f>
                        </m:e>
                      </m:d>
                    </m:oMath>
                  </m:oMathPara>
                </a14:m>
                <a:endParaRPr lang="it-IT" sz="1000" dirty="0"/>
              </a:p>
            </p:txBody>
          </p:sp>
        </mc:Choice>
        <mc:Fallback xmlns="">
          <p:sp>
            <p:nvSpPr>
              <p:cNvPr id="2" name="CasellaDiTesto 1"/>
              <p:cNvSpPr txBox="1">
                <a:spLocks noRot="1" noChangeAspect="1" noMove="1" noResize="1" noEditPoints="1" noAdjustHandles="1" noChangeArrowheads="1" noChangeShapeType="1" noTextEdit="1"/>
              </p:cNvSpPr>
              <p:nvPr/>
            </p:nvSpPr>
            <p:spPr>
              <a:xfrm>
                <a:off x="545440" y="3396520"/>
                <a:ext cx="2604623" cy="441211"/>
              </a:xfrm>
              <a:prstGeom prst="rect">
                <a:avLst/>
              </a:prstGeom>
              <a:blipFill rotWithShape="1">
                <a:blip r:embed="rId16"/>
                <a:stretch>
                  <a:fillRect t="-47945" b="-76712"/>
                </a:stretch>
              </a:blipFill>
            </p:spPr>
            <p:txBody>
              <a:bodyPr/>
              <a:lstStyle/>
              <a:p>
                <a:r>
                  <a:rPr lang="it-IT">
                    <a:noFill/>
                  </a:rPr>
                  <a:t> </a:t>
                </a:r>
              </a:p>
            </p:txBody>
          </p:sp>
        </mc:Fallback>
      </mc:AlternateContent>
      <p:sp>
        <p:nvSpPr>
          <p:cNvPr id="93" name="Freccia angolare in su 92"/>
          <p:cNvSpPr/>
          <p:nvPr/>
        </p:nvSpPr>
        <p:spPr>
          <a:xfrm rot="5400000">
            <a:off x="1610933" y="4031651"/>
            <a:ext cx="448946" cy="226023"/>
          </a:xfrm>
          <a:prstGeom prst="bentUpArrow">
            <a:avLst>
              <a:gd name="adj1" fmla="val 36372"/>
              <a:gd name="adj2" fmla="val 32108"/>
              <a:gd name="adj3" fmla="val 24999"/>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4" name="CasellaDiTesto 3"/>
          <p:cNvSpPr txBox="1"/>
          <p:nvPr/>
        </p:nvSpPr>
        <p:spPr>
          <a:xfrm rot="16200000">
            <a:off x="1670831" y="4298724"/>
            <a:ext cx="1080120" cy="400110"/>
          </a:xfrm>
          <a:prstGeom prst="rect">
            <a:avLst/>
          </a:prstGeom>
          <a:noFill/>
        </p:spPr>
        <p:txBody>
          <a:bodyPr wrap="square" rtlCol="0">
            <a:spAutoFit/>
          </a:bodyPr>
          <a:lstStyle/>
          <a:p>
            <a:pPr algn="ctr"/>
            <a:r>
              <a:rPr lang="it-IT" sz="1000" dirty="0" err="1" smtClean="0">
                <a:latin typeface="Arial" panose="020B0604020202020204" pitchFamily="34" charset="0"/>
                <a:cs typeface="Arial" panose="020B0604020202020204" pitchFamily="34" charset="0"/>
              </a:rPr>
              <a:t>Percent</a:t>
            </a:r>
            <a:r>
              <a:rPr lang="it-IT" sz="1000" dirty="0" smtClean="0">
                <a:latin typeface="Arial" panose="020B0604020202020204" pitchFamily="34" charset="0"/>
                <a:cs typeface="Arial" panose="020B0604020202020204" pitchFamily="34" charset="0"/>
              </a:rPr>
              <a:t> of EPX </a:t>
            </a:r>
            <a:r>
              <a:rPr lang="it-IT" sz="1000" dirty="0" err="1" smtClean="0">
                <a:latin typeface="Arial" panose="020B0604020202020204" pitchFamily="34" charset="0"/>
                <a:cs typeface="Arial" panose="020B0604020202020204" pitchFamily="34" charset="0"/>
              </a:rPr>
              <a:t>fluorescence</a:t>
            </a:r>
            <a:endParaRPr lang="it-IT" sz="1000" dirty="0">
              <a:latin typeface="Arial" panose="020B0604020202020204" pitchFamily="34" charset="0"/>
              <a:cs typeface="Arial" panose="020B0604020202020204" pitchFamily="34" charset="0"/>
            </a:endParaRPr>
          </a:p>
        </p:txBody>
      </p:sp>
      <p:sp>
        <p:nvSpPr>
          <p:cNvPr id="96" name="CasellaDiTesto 95"/>
          <p:cNvSpPr txBox="1"/>
          <p:nvPr/>
        </p:nvSpPr>
        <p:spPr>
          <a:xfrm rot="16200000">
            <a:off x="4236337" y="4346080"/>
            <a:ext cx="1193880" cy="400110"/>
          </a:xfrm>
          <a:prstGeom prst="rect">
            <a:avLst/>
          </a:prstGeom>
          <a:noFill/>
        </p:spPr>
        <p:txBody>
          <a:bodyPr wrap="square" rtlCol="0">
            <a:spAutoFit/>
          </a:bodyPr>
          <a:lstStyle/>
          <a:p>
            <a:pPr algn="ctr"/>
            <a:r>
              <a:rPr lang="it-IT" sz="1000" dirty="0" smtClean="0">
                <a:latin typeface="Arial" panose="020B0604020202020204" pitchFamily="34" charset="0"/>
                <a:cs typeface="Arial" panose="020B0604020202020204" pitchFamily="34" charset="0"/>
              </a:rPr>
              <a:t>EPX </a:t>
            </a:r>
            <a:r>
              <a:rPr lang="it-IT" sz="1000" dirty="0" err="1" smtClean="0">
                <a:latin typeface="Arial" panose="020B0604020202020204" pitchFamily="34" charset="0"/>
                <a:cs typeface="Arial" panose="020B0604020202020204" pitchFamily="34" charset="0"/>
              </a:rPr>
              <a:t>polarization</a:t>
            </a:r>
            <a:r>
              <a:rPr lang="it-IT" sz="1000" dirty="0" smtClean="0">
                <a:latin typeface="Arial" panose="020B0604020202020204" pitchFamily="34" charset="0"/>
                <a:cs typeface="Arial" panose="020B0604020202020204" pitchFamily="34" charset="0"/>
              </a:rPr>
              <a:t> </a:t>
            </a:r>
            <a:r>
              <a:rPr lang="it-IT" sz="1000" dirty="0" err="1" smtClean="0">
                <a:latin typeface="Arial" panose="020B0604020202020204" pitchFamily="34" charset="0"/>
                <a:cs typeface="Arial" panose="020B0604020202020204" pitchFamily="34" charset="0"/>
              </a:rPr>
              <a:t>coefficient</a:t>
            </a:r>
            <a:endParaRPr lang="it-IT"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5928377"/>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uppo 1"/>
          <p:cNvGrpSpPr>
            <a:grpSpLocks/>
          </p:cNvGrpSpPr>
          <p:nvPr/>
        </p:nvGrpSpPr>
        <p:grpSpPr bwMode="auto">
          <a:xfrm>
            <a:off x="251594" y="1403896"/>
            <a:ext cx="5251450" cy="2052637"/>
            <a:chOff x="620026" y="3356598"/>
            <a:chExt cx="5252480" cy="2052000"/>
          </a:xfrm>
        </p:grpSpPr>
        <p:sp>
          <p:nvSpPr>
            <p:cNvPr id="5" name="CasellaDiTesto 41"/>
            <p:cNvSpPr txBox="1">
              <a:spLocks noChangeAspect="1"/>
            </p:cNvSpPr>
            <p:nvPr/>
          </p:nvSpPr>
          <p:spPr bwMode="auto">
            <a:xfrm>
              <a:off x="718470" y="3731132"/>
              <a:ext cx="357257" cy="2459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it-IT" altLang="it-IT" sz="1000">
                  <a:cs typeface="Arial" panose="020B0604020202020204" pitchFamily="34" charset="0"/>
                </a:rPr>
                <a:t>NT</a:t>
              </a:r>
            </a:p>
          </p:txBody>
        </p:sp>
        <p:sp>
          <p:nvSpPr>
            <p:cNvPr id="6" name="CasellaDiTesto 45"/>
            <p:cNvSpPr txBox="1">
              <a:spLocks noChangeAspect="1"/>
            </p:cNvSpPr>
            <p:nvPr/>
          </p:nvSpPr>
          <p:spPr bwMode="auto">
            <a:xfrm>
              <a:off x="678750" y="4309204"/>
              <a:ext cx="404278"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it-IT" altLang="it-IT" sz="1000">
                  <a:cs typeface="Arial" panose="020B0604020202020204" pitchFamily="34" charset="0"/>
                </a:rPr>
                <a:t>IL-5</a:t>
              </a:r>
            </a:p>
            <a:p>
              <a:pPr algn="ctr">
                <a:spcBef>
                  <a:spcPct val="0"/>
                </a:spcBef>
                <a:buFontTx/>
                <a:buNone/>
              </a:pPr>
              <a:r>
                <a:rPr lang="it-IT" altLang="it-IT" sz="1000">
                  <a:cs typeface="Arial" panose="020B0604020202020204" pitchFamily="34" charset="0"/>
                </a:rPr>
                <a:t>EO</a:t>
              </a:r>
            </a:p>
          </p:txBody>
        </p:sp>
        <p:pic>
          <p:nvPicPr>
            <p:cNvPr id="7" name="Picture 9" descr="F:\exp.79 spher 7mag18\b8_b16_nt_d2_vis_4x.tif"/>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052607" y="3550722"/>
              <a:ext cx="778302" cy="58406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8" name="CasellaDiTesto 44"/>
            <p:cNvSpPr txBox="1">
              <a:spLocks noChangeAspect="1"/>
            </p:cNvSpPr>
            <p:nvPr/>
          </p:nvSpPr>
          <p:spPr bwMode="auto">
            <a:xfrm>
              <a:off x="1121774" y="3356598"/>
              <a:ext cx="635125" cy="2459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it-IT" altLang="it-IT" sz="1000">
                  <a:cs typeface="Arial" panose="020B0604020202020204" pitchFamily="34" charset="0"/>
                </a:rPr>
                <a:t>Day 2</a:t>
              </a:r>
            </a:p>
          </p:txBody>
        </p:sp>
        <p:pic>
          <p:nvPicPr>
            <p:cNvPr id="9" name="Picture 2" descr="F:\exp.79 spher 7mag18\b2_b16_eosil5_d2_vis_4x.tif"/>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1052607" y="4183206"/>
              <a:ext cx="778302" cy="58406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 name="Picture 6" descr="F:\exp.79 spher 7mag18\b6_b16_eosil33_d2_vis_4x.tif"/>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1052607" y="4824534"/>
              <a:ext cx="778302" cy="58406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1" name="CasellaDiTesto 47"/>
            <p:cNvSpPr txBox="1">
              <a:spLocks noChangeAspect="1"/>
            </p:cNvSpPr>
            <p:nvPr/>
          </p:nvSpPr>
          <p:spPr bwMode="auto">
            <a:xfrm>
              <a:off x="620026" y="4948366"/>
              <a:ext cx="474755" cy="39992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it-IT" altLang="it-IT" sz="1000">
                  <a:cs typeface="Arial" panose="020B0604020202020204" pitchFamily="34" charset="0"/>
                </a:rPr>
                <a:t>IL-33</a:t>
              </a:r>
            </a:p>
            <a:p>
              <a:pPr algn="ctr">
                <a:spcBef>
                  <a:spcPct val="0"/>
                </a:spcBef>
                <a:buFontTx/>
                <a:buNone/>
              </a:pPr>
              <a:r>
                <a:rPr lang="it-IT" altLang="it-IT" sz="1000">
                  <a:cs typeface="Arial" panose="020B0604020202020204" pitchFamily="34" charset="0"/>
                </a:rPr>
                <a:t>EO</a:t>
              </a:r>
            </a:p>
          </p:txBody>
        </p:sp>
        <p:pic>
          <p:nvPicPr>
            <p:cNvPr id="12" name="Picture 10" descr="F:\exp.79 spher 7mag18\b8_b16 nt _d5_vis_4x.tif"/>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1863340" y="3550722"/>
              <a:ext cx="778302" cy="58406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3" name="CasellaDiTesto 49"/>
            <p:cNvSpPr txBox="1">
              <a:spLocks noChangeAspect="1"/>
            </p:cNvSpPr>
            <p:nvPr/>
          </p:nvSpPr>
          <p:spPr bwMode="auto">
            <a:xfrm>
              <a:off x="1988719" y="3356598"/>
              <a:ext cx="565261" cy="2459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it-IT" altLang="it-IT" sz="1000">
                  <a:cs typeface="Arial" panose="020B0604020202020204" pitchFamily="34" charset="0"/>
                </a:rPr>
                <a:t>Day 5</a:t>
              </a:r>
            </a:p>
          </p:txBody>
        </p:sp>
        <p:pic>
          <p:nvPicPr>
            <p:cNvPr id="14" name="Picture 4" descr="F:\exp.79 spher 7mag18\b2_b16 eosil5 _d5_vis_4x.tif"/>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1863340" y="4183206"/>
              <a:ext cx="778302" cy="58406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5" name="Picture 7" descr="F:\exp.79 spher 7mag18\b6_b16 eosil33 _d5_vis_4x.tif"/>
            <p:cNvPicPr>
              <a:picLocks noChangeAspect="1" noChangeArrowheads="1"/>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1863340" y="4824534"/>
              <a:ext cx="778302" cy="58406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6" name="Picture 11" descr="F:\exp.79 spher 7mag18\b8_ b16 nt _d6_vis_4x.tif"/>
            <p:cNvPicPr>
              <a:picLocks noChangeAspect="1" noChangeArrowheads="1"/>
            </p:cNvPicPr>
            <p:nvPr/>
          </p:nvPicPr>
          <p:blipFill>
            <a:blip r:embed="rId8" cstate="print">
              <a:extLst>
                <a:ext uri="{28A0092B-C50C-407E-A947-70E740481C1C}">
                  <a14:useLocalDpi xmlns:a14="http://schemas.microsoft.com/office/drawing/2010/main" val="0"/>
                </a:ext>
              </a:extLst>
            </a:blip>
            <a:srcRect/>
            <a:stretch>
              <a:fillRect/>
            </a:stretch>
          </p:blipFill>
          <p:spPr bwMode="auto">
            <a:xfrm>
              <a:off x="2668039" y="3550722"/>
              <a:ext cx="778302" cy="58406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7" name="CasellaDiTesto 53"/>
            <p:cNvSpPr txBox="1">
              <a:spLocks noChangeAspect="1"/>
            </p:cNvSpPr>
            <p:nvPr/>
          </p:nvSpPr>
          <p:spPr bwMode="auto">
            <a:xfrm>
              <a:off x="2785801" y="3356598"/>
              <a:ext cx="565261" cy="2459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it-IT" altLang="it-IT" sz="1000">
                  <a:cs typeface="Arial" panose="020B0604020202020204" pitchFamily="34" charset="0"/>
                </a:rPr>
                <a:t>Day 6</a:t>
              </a:r>
            </a:p>
          </p:txBody>
        </p:sp>
        <p:pic>
          <p:nvPicPr>
            <p:cNvPr id="18" name="Picture 5" descr="F:\exp.79 spher 7mag18\b2_ b16 eosil5 _d6_vis_4x.tif"/>
            <p:cNvPicPr>
              <a:picLocks noChangeAspect="1" noChangeArrowheads="1"/>
            </p:cNvPicPr>
            <p:nvPr/>
          </p:nvPicPr>
          <p:blipFill>
            <a:blip r:embed="rId9" cstate="print">
              <a:extLst>
                <a:ext uri="{28A0092B-C50C-407E-A947-70E740481C1C}">
                  <a14:useLocalDpi xmlns:a14="http://schemas.microsoft.com/office/drawing/2010/main" val="0"/>
                </a:ext>
              </a:extLst>
            </a:blip>
            <a:srcRect/>
            <a:stretch>
              <a:fillRect/>
            </a:stretch>
          </p:blipFill>
          <p:spPr bwMode="auto">
            <a:xfrm>
              <a:off x="2668039" y="4183206"/>
              <a:ext cx="778302" cy="58406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9" name="Picture 8" descr="F:\exp.79 spher 7mag18\b6_ b16 eosil33 _d6_vis_4x.tif"/>
            <p:cNvPicPr>
              <a:picLocks noChangeAspect="1" noChangeArrowheads="1"/>
            </p:cNvPicPr>
            <p:nvPr/>
          </p:nvPicPr>
          <p:blipFill>
            <a:blip r:embed="rId10" cstate="print">
              <a:extLst>
                <a:ext uri="{28A0092B-C50C-407E-A947-70E740481C1C}">
                  <a14:useLocalDpi xmlns:a14="http://schemas.microsoft.com/office/drawing/2010/main" val="0"/>
                </a:ext>
              </a:extLst>
            </a:blip>
            <a:srcRect/>
            <a:stretch>
              <a:fillRect/>
            </a:stretch>
          </p:blipFill>
          <p:spPr bwMode="auto">
            <a:xfrm>
              <a:off x="2668039" y="4824534"/>
              <a:ext cx="778302" cy="58406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0" name="Picture 9" descr="F:\exp.79 spher 7mag18\b8_ b16  _d7_vis_4x.tif"/>
            <p:cNvPicPr>
              <a:picLocks noChangeAspect="1" noChangeArrowheads="1"/>
            </p:cNvPicPr>
            <p:nvPr/>
          </p:nvPicPr>
          <p:blipFill>
            <a:blip r:embed="rId11" cstate="print">
              <a:extLst>
                <a:ext uri="{28A0092B-C50C-407E-A947-70E740481C1C}">
                  <a14:useLocalDpi xmlns:a14="http://schemas.microsoft.com/office/drawing/2010/main" val="0"/>
                </a:ext>
              </a:extLst>
            </a:blip>
            <a:srcRect/>
            <a:stretch>
              <a:fillRect/>
            </a:stretch>
          </p:blipFill>
          <p:spPr bwMode="auto">
            <a:xfrm>
              <a:off x="3478772" y="3553401"/>
              <a:ext cx="778302" cy="58406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1" name="CasellaDiTesto 57"/>
            <p:cNvSpPr txBox="1">
              <a:spLocks noChangeAspect="1"/>
            </p:cNvSpPr>
            <p:nvPr/>
          </p:nvSpPr>
          <p:spPr bwMode="auto">
            <a:xfrm>
              <a:off x="3582882" y="3356598"/>
              <a:ext cx="565261" cy="2459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it-IT" altLang="it-IT" sz="1000">
                  <a:cs typeface="Arial" panose="020B0604020202020204" pitchFamily="34" charset="0"/>
                </a:rPr>
                <a:t>Day 7</a:t>
              </a:r>
            </a:p>
          </p:txBody>
        </p:sp>
        <p:pic>
          <p:nvPicPr>
            <p:cNvPr id="22" name="Picture 2" descr="F:\exp.79 spher 7mag18\b2_ b16 eosil5 _d7_vis_4x.tif"/>
            <p:cNvPicPr>
              <a:picLocks noChangeAspect="1" noChangeArrowheads="1"/>
            </p:cNvPicPr>
            <p:nvPr/>
          </p:nvPicPr>
          <p:blipFill>
            <a:blip r:embed="rId12" cstate="print">
              <a:extLst>
                <a:ext uri="{28A0092B-C50C-407E-A947-70E740481C1C}">
                  <a14:useLocalDpi xmlns:a14="http://schemas.microsoft.com/office/drawing/2010/main" val="0"/>
                </a:ext>
              </a:extLst>
            </a:blip>
            <a:srcRect/>
            <a:stretch>
              <a:fillRect/>
            </a:stretch>
          </p:blipFill>
          <p:spPr bwMode="auto">
            <a:xfrm>
              <a:off x="3478772" y="4183206"/>
              <a:ext cx="778302" cy="58406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3" name="Picture 6" descr="F:\exp.79 spher 7mag18\b6_ b16 eosil33 _d7_vis_4x.tif"/>
            <p:cNvPicPr>
              <a:picLocks noChangeAspect="1" noChangeArrowheads="1"/>
            </p:cNvPicPr>
            <p:nvPr/>
          </p:nvPicPr>
          <p:blipFill>
            <a:blip r:embed="rId13" cstate="print">
              <a:extLst>
                <a:ext uri="{28A0092B-C50C-407E-A947-70E740481C1C}">
                  <a14:useLocalDpi xmlns:a14="http://schemas.microsoft.com/office/drawing/2010/main" val="0"/>
                </a:ext>
              </a:extLst>
            </a:blip>
            <a:srcRect/>
            <a:stretch>
              <a:fillRect/>
            </a:stretch>
          </p:blipFill>
          <p:spPr bwMode="auto">
            <a:xfrm>
              <a:off x="3478772" y="4824534"/>
              <a:ext cx="778302" cy="58406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4" name="Picture 10" descr="F:\exp.79 spher 7mag18\b8_ b16  _d8_vis_4x.tif"/>
            <p:cNvPicPr>
              <a:picLocks noChangeAspect="1" noChangeArrowheads="1"/>
            </p:cNvPicPr>
            <p:nvPr/>
          </p:nvPicPr>
          <p:blipFill>
            <a:blip r:embed="rId14" cstate="print">
              <a:extLst>
                <a:ext uri="{28A0092B-C50C-407E-A947-70E740481C1C}">
                  <a14:useLocalDpi xmlns:a14="http://schemas.microsoft.com/office/drawing/2010/main" val="0"/>
                </a:ext>
              </a:extLst>
            </a:blip>
            <a:srcRect/>
            <a:stretch>
              <a:fillRect/>
            </a:stretch>
          </p:blipFill>
          <p:spPr bwMode="auto">
            <a:xfrm>
              <a:off x="4289504" y="3553401"/>
              <a:ext cx="778302" cy="58406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5" name="CasellaDiTesto 61"/>
            <p:cNvSpPr txBox="1">
              <a:spLocks noChangeAspect="1"/>
            </p:cNvSpPr>
            <p:nvPr/>
          </p:nvSpPr>
          <p:spPr bwMode="auto">
            <a:xfrm>
              <a:off x="4379963" y="3356598"/>
              <a:ext cx="565261" cy="24598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it-IT" altLang="it-IT" sz="1000">
                  <a:cs typeface="Arial" panose="020B0604020202020204" pitchFamily="34" charset="0"/>
                </a:rPr>
                <a:t>Day 8</a:t>
              </a:r>
            </a:p>
          </p:txBody>
        </p:sp>
        <p:pic>
          <p:nvPicPr>
            <p:cNvPr id="26" name="Picture 3" descr="F:\exp.79 spher 7mag18\b2_ b16 eosil5 _d8_vis_4x.tif"/>
            <p:cNvPicPr>
              <a:picLocks noChangeAspect="1" noChangeArrowheads="1"/>
            </p:cNvPicPr>
            <p:nvPr/>
          </p:nvPicPr>
          <p:blipFill>
            <a:blip r:embed="rId15" cstate="print">
              <a:extLst>
                <a:ext uri="{28A0092B-C50C-407E-A947-70E740481C1C}">
                  <a14:useLocalDpi xmlns:a14="http://schemas.microsoft.com/office/drawing/2010/main" val="0"/>
                </a:ext>
              </a:extLst>
            </a:blip>
            <a:srcRect/>
            <a:stretch>
              <a:fillRect/>
            </a:stretch>
          </p:blipFill>
          <p:spPr bwMode="auto">
            <a:xfrm>
              <a:off x="4289504" y="4183206"/>
              <a:ext cx="778302" cy="58406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7" name="Picture 7" descr="F:\exp.79 spher 7mag18\b6_ b16 eosil33 _d8_vis_4x.tif"/>
            <p:cNvPicPr>
              <a:picLocks noChangeAspect="1" noChangeArrowheads="1"/>
            </p:cNvPicPr>
            <p:nvPr/>
          </p:nvPicPr>
          <p:blipFill>
            <a:blip r:embed="rId16" cstate="print">
              <a:extLst>
                <a:ext uri="{28A0092B-C50C-407E-A947-70E740481C1C}">
                  <a14:useLocalDpi xmlns:a14="http://schemas.microsoft.com/office/drawing/2010/main" val="0"/>
                </a:ext>
              </a:extLst>
            </a:blip>
            <a:srcRect/>
            <a:stretch>
              <a:fillRect/>
            </a:stretch>
          </p:blipFill>
          <p:spPr bwMode="auto">
            <a:xfrm>
              <a:off x="4289504" y="4824534"/>
              <a:ext cx="778302" cy="58406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28" name="Picture 11" descr="F:\exp.79 spher 7mag18\b8_ b16 nt _d9_vis_4x.tif"/>
            <p:cNvPicPr>
              <a:picLocks noChangeAspect="1" noChangeArrowheads="1"/>
            </p:cNvPicPr>
            <p:nvPr/>
          </p:nvPicPr>
          <p:blipFill>
            <a:blip r:embed="rId17" cstate="print">
              <a:extLst>
                <a:ext uri="{28A0092B-C50C-407E-A947-70E740481C1C}">
                  <a14:useLocalDpi xmlns:a14="http://schemas.microsoft.com/office/drawing/2010/main" val="0"/>
                </a:ext>
              </a:extLst>
            </a:blip>
            <a:srcRect/>
            <a:stretch>
              <a:fillRect/>
            </a:stretch>
          </p:blipFill>
          <p:spPr bwMode="auto">
            <a:xfrm>
              <a:off x="5094204" y="3553401"/>
              <a:ext cx="778302" cy="58406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9" name="CasellaDiTesto 68"/>
            <p:cNvSpPr txBox="1">
              <a:spLocks noChangeAspect="1"/>
            </p:cNvSpPr>
            <p:nvPr/>
          </p:nvSpPr>
          <p:spPr bwMode="auto">
            <a:xfrm>
              <a:off x="5177114" y="3356598"/>
              <a:ext cx="621651"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it-IT" altLang="it-IT" sz="1000">
                  <a:cs typeface="Arial" panose="020B0604020202020204" pitchFamily="34" charset="0"/>
                </a:rPr>
                <a:t>Day 9</a:t>
              </a:r>
            </a:p>
          </p:txBody>
        </p:sp>
        <p:pic>
          <p:nvPicPr>
            <p:cNvPr id="30" name="Picture 4" descr="F:\exp.79 spher 7mag18\b2_ b16 eosil5 _d9_vis_4x.tif"/>
            <p:cNvPicPr>
              <a:picLocks noChangeAspect="1" noChangeArrowheads="1"/>
            </p:cNvPicPr>
            <p:nvPr/>
          </p:nvPicPr>
          <p:blipFill>
            <a:blip r:embed="rId18" cstate="print">
              <a:extLst>
                <a:ext uri="{28A0092B-C50C-407E-A947-70E740481C1C}">
                  <a14:useLocalDpi xmlns:a14="http://schemas.microsoft.com/office/drawing/2010/main" val="0"/>
                </a:ext>
              </a:extLst>
            </a:blip>
            <a:srcRect/>
            <a:stretch>
              <a:fillRect/>
            </a:stretch>
          </p:blipFill>
          <p:spPr bwMode="auto">
            <a:xfrm>
              <a:off x="5094204" y="4183206"/>
              <a:ext cx="778302" cy="58406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31" name="Picture 8" descr="F:\exp.79 spher 7mag18\b6_ b16 eosil33 _d9_vis_4x.tif"/>
            <p:cNvPicPr>
              <a:picLocks noChangeAspect="1" noChangeArrowheads="1"/>
            </p:cNvPicPr>
            <p:nvPr/>
          </p:nvPicPr>
          <p:blipFill>
            <a:blip r:embed="rId19" cstate="print">
              <a:extLst>
                <a:ext uri="{28A0092B-C50C-407E-A947-70E740481C1C}">
                  <a14:useLocalDpi xmlns:a14="http://schemas.microsoft.com/office/drawing/2010/main" val="0"/>
                </a:ext>
              </a:extLst>
            </a:blip>
            <a:srcRect/>
            <a:stretch>
              <a:fillRect/>
            </a:stretch>
          </p:blipFill>
          <p:spPr bwMode="auto">
            <a:xfrm>
              <a:off x="5094204" y="4824534"/>
              <a:ext cx="778302" cy="58406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grpSp>
      <p:grpSp>
        <p:nvGrpSpPr>
          <p:cNvPr id="32" name="Gruppo 31"/>
          <p:cNvGrpSpPr/>
          <p:nvPr/>
        </p:nvGrpSpPr>
        <p:grpSpPr>
          <a:xfrm>
            <a:off x="1263029" y="2127047"/>
            <a:ext cx="4189959" cy="0"/>
            <a:chOff x="1703585" y="4477589"/>
            <a:chExt cx="4189959" cy="0"/>
          </a:xfrm>
        </p:grpSpPr>
        <p:cxnSp>
          <p:nvCxnSpPr>
            <p:cNvPr id="33" name="Connettore 1 11"/>
            <p:cNvCxnSpPr/>
            <p:nvPr/>
          </p:nvCxnSpPr>
          <p:spPr>
            <a:xfrm>
              <a:off x="1703585" y="4477589"/>
              <a:ext cx="144016"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34" name="Connettore 1 148"/>
            <p:cNvCxnSpPr/>
            <p:nvPr/>
          </p:nvCxnSpPr>
          <p:spPr>
            <a:xfrm>
              <a:off x="2513732" y="4477589"/>
              <a:ext cx="144016"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35" name="Connettore 1 149"/>
            <p:cNvCxnSpPr/>
            <p:nvPr/>
          </p:nvCxnSpPr>
          <p:spPr>
            <a:xfrm>
              <a:off x="3318520" y="4477589"/>
              <a:ext cx="144016"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36" name="Connettore 1 150"/>
            <p:cNvCxnSpPr/>
            <p:nvPr/>
          </p:nvCxnSpPr>
          <p:spPr>
            <a:xfrm>
              <a:off x="4129534" y="4477589"/>
              <a:ext cx="144016"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37" name="Connettore 1 151"/>
            <p:cNvCxnSpPr/>
            <p:nvPr/>
          </p:nvCxnSpPr>
          <p:spPr>
            <a:xfrm>
              <a:off x="4932164" y="4477589"/>
              <a:ext cx="144016"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38" name="Connettore 1 152"/>
            <p:cNvCxnSpPr/>
            <p:nvPr/>
          </p:nvCxnSpPr>
          <p:spPr>
            <a:xfrm>
              <a:off x="5749528" y="4477589"/>
              <a:ext cx="144016"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grpSp>
      <p:grpSp>
        <p:nvGrpSpPr>
          <p:cNvPr id="39" name="Gruppo 38"/>
          <p:cNvGrpSpPr/>
          <p:nvPr/>
        </p:nvGrpSpPr>
        <p:grpSpPr>
          <a:xfrm>
            <a:off x="1270174" y="2760042"/>
            <a:ext cx="4189959" cy="0"/>
            <a:chOff x="1703585" y="4477589"/>
            <a:chExt cx="4189959" cy="0"/>
          </a:xfrm>
        </p:grpSpPr>
        <p:cxnSp>
          <p:nvCxnSpPr>
            <p:cNvPr id="40" name="Connettore 1 154"/>
            <p:cNvCxnSpPr/>
            <p:nvPr/>
          </p:nvCxnSpPr>
          <p:spPr>
            <a:xfrm>
              <a:off x="1703585" y="4477589"/>
              <a:ext cx="144016"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41" name="Connettore 1 155"/>
            <p:cNvCxnSpPr/>
            <p:nvPr/>
          </p:nvCxnSpPr>
          <p:spPr>
            <a:xfrm>
              <a:off x="2513732" y="4477589"/>
              <a:ext cx="144016"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42" name="Connettore 1 156"/>
            <p:cNvCxnSpPr/>
            <p:nvPr/>
          </p:nvCxnSpPr>
          <p:spPr>
            <a:xfrm>
              <a:off x="3318520" y="4477589"/>
              <a:ext cx="144016"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43" name="Connettore 1 157"/>
            <p:cNvCxnSpPr/>
            <p:nvPr/>
          </p:nvCxnSpPr>
          <p:spPr>
            <a:xfrm>
              <a:off x="4129534" y="4477589"/>
              <a:ext cx="144016"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44" name="Connettore 1 158"/>
            <p:cNvCxnSpPr/>
            <p:nvPr/>
          </p:nvCxnSpPr>
          <p:spPr>
            <a:xfrm>
              <a:off x="4932164" y="4477589"/>
              <a:ext cx="144016"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45" name="Connettore 1 159"/>
            <p:cNvCxnSpPr/>
            <p:nvPr/>
          </p:nvCxnSpPr>
          <p:spPr>
            <a:xfrm>
              <a:off x="5749528" y="4477589"/>
              <a:ext cx="144016"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grpSp>
      <p:grpSp>
        <p:nvGrpSpPr>
          <p:cNvPr id="46" name="Gruppo 45"/>
          <p:cNvGrpSpPr/>
          <p:nvPr/>
        </p:nvGrpSpPr>
        <p:grpSpPr>
          <a:xfrm>
            <a:off x="1270174" y="3401764"/>
            <a:ext cx="4189959" cy="0"/>
            <a:chOff x="1703585" y="4477589"/>
            <a:chExt cx="4189959" cy="0"/>
          </a:xfrm>
        </p:grpSpPr>
        <p:cxnSp>
          <p:nvCxnSpPr>
            <p:cNvPr id="47" name="Connettore 1 161"/>
            <p:cNvCxnSpPr/>
            <p:nvPr/>
          </p:nvCxnSpPr>
          <p:spPr>
            <a:xfrm>
              <a:off x="1703585" y="4477589"/>
              <a:ext cx="144016"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48" name="Connettore 1 162"/>
            <p:cNvCxnSpPr/>
            <p:nvPr/>
          </p:nvCxnSpPr>
          <p:spPr>
            <a:xfrm>
              <a:off x="2513732" y="4477589"/>
              <a:ext cx="144016"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49" name="Connettore 1 163"/>
            <p:cNvCxnSpPr/>
            <p:nvPr/>
          </p:nvCxnSpPr>
          <p:spPr>
            <a:xfrm>
              <a:off x="3318520" y="4477589"/>
              <a:ext cx="144016"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50" name="Connettore 1 164"/>
            <p:cNvCxnSpPr/>
            <p:nvPr/>
          </p:nvCxnSpPr>
          <p:spPr>
            <a:xfrm>
              <a:off x="4129534" y="4477589"/>
              <a:ext cx="144016"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51" name="Connettore 1 165"/>
            <p:cNvCxnSpPr/>
            <p:nvPr/>
          </p:nvCxnSpPr>
          <p:spPr>
            <a:xfrm>
              <a:off x="4932164" y="4477589"/>
              <a:ext cx="144016"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52" name="Connettore 1 166"/>
            <p:cNvCxnSpPr/>
            <p:nvPr/>
          </p:nvCxnSpPr>
          <p:spPr>
            <a:xfrm>
              <a:off x="5749528" y="4477589"/>
              <a:ext cx="144016"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grpSp>
      <p:sp>
        <p:nvSpPr>
          <p:cNvPr id="53" name="CasellaDiTesto 52"/>
          <p:cNvSpPr txBox="1"/>
          <p:nvPr/>
        </p:nvSpPr>
        <p:spPr>
          <a:xfrm>
            <a:off x="133351" y="4938519"/>
            <a:ext cx="5662860" cy="1118255"/>
          </a:xfrm>
          <a:prstGeom prst="rect">
            <a:avLst/>
          </a:prstGeom>
          <a:noFill/>
        </p:spPr>
        <p:txBody>
          <a:bodyPr wrap="square" rtlCol="0">
            <a:spAutoFit/>
          </a:bodyPr>
          <a:lstStyle/>
          <a:p>
            <a:pPr algn="just">
              <a:lnSpc>
                <a:spcPts val="1600"/>
              </a:lnSpc>
            </a:pPr>
            <a:r>
              <a:rPr lang="en-US" sz="1000" b="1" dirty="0" smtClean="0">
                <a:latin typeface="Arial" panose="020B0604020202020204" pitchFamily="34" charset="0"/>
                <a:ea typeface="Times New Roman"/>
                <a:cs typeface="Arial" panose="020B0604020202020204" pitchFamily="34" charset="0"/>
              </a:rPr>
              <a:t>Figure S2</a:t>
            </a:r>
            <a:r>
              <a:rPr lang="en-US" sz="1000" b="1" dirty="0" smtClean="0">
                <a:latin typeface="Arial" panose="020B0604020202020204" pitchFamily="34" charset="0"/>
                <a:ea typeface="Times New Roman"/>
                <a:cs typeface="Arial" panose="020B0604020202020204" pitchFamily="34" charset="0"/>
              </a:rPr>
              <a:t>. </a:t>
            </a:r>
            <a:r>
              <a:rPr lang="en-US" sz="1000" b="1" dirty="0">
                <a:latin typeface="Arial" panose="020B0604020202020204" pitchFamily="34" charset="0"/>
                <a:ea typeface="Times New Roman"/>
                <a:cs typeface="Arial" panose="020B0604020202020204" pitchFamily="34" charset="0"/>
              </a:rPr>
              <a:t>IL-33 </a:t>
            </a:r>
            <a:r>
              <a:rPr lang="en-US" sz="1000" b="1" dirty="0" smtClean="0">
                <a:latin typeface="Arial" panose="020B0604020202020204" pitchFamily="34" charset="0"/>
                <a:ea typeface="Times New Roman"/>
                <a:cs typeface="Arial" panose="020B0604020202020204" pitchFamily="34" charset="0"/>
              </a:rPr>
              <a:t>activated </a:t>
            </a:r>
            <a:r>
              <a:rPr lang="en-US" sz="1000" b="1" dirty="0">
                <a:latin typeface="Arial" panose="020B0604020202020204" pitchFamily="34" charset="0"/>
                <a:ea typeface="Times New Roman"/>
                <a:cs typeface="Arial" panose="020B0604020202020204" pitchFamily="34" charset="0"/>
              </a:rPr>
              <a:t>eosinophils </a:t>
            </a:r>
            <a:r>
              <a:rPr lang="en-US" sz="1000" b="1" dirty="0" smtClean="0">
                <a:latin typeface="Arial" panose="020B0604020202020204" pitchFamily="34" charset="0"/>
                <a:ea typeface="Times New Roman"/>
                <a:cs typeface="Arial" panose="020B0604020202020204" pitchFamily="34" charset="0"/>
              </a:rPr>
              <a:t>prevent tumor spheroid formation</a:t>
            </a:r>
            <a:r>
              <a:rPr lang="en-US" sz="1000" dirty="0" smtClean="0">
                <a:latin typeface="Arial" panose="020B0604020202020204" pitchFamily="34" charset="0"/>
                <a:ea typeface="Times New Roman"/>
                <a:cs typeface="Arial" panose="020B0604020202020204" pitchFamily="34" charset="0"/>
              </a:rPr>
              <a:t>. B16.F10 </a:t>
            </a:r>
            <a:r>
              <a:rPr lang="en-US" sz="1000" dirty="0">
                <a:latin typeface="Arial" panose="020B0604020202020204" pitchFamily="34" charset="0"/>
                <a:ea typeface="Times New Roman"/>
                <a:cs typeface="Arial" panose="020B0604020202020204" pitchFamily="34" charset="0"/>
              </a:rPr>
              <a:t>melanoma cells were seeded in low-attachment 96 well plates (100 cells/well) alone or together with eosinophils (1000 cells/well), either IL-5 EO or IL-33 EO. Formation of 3D spheroids was monitored by microscopy starting from day 2. One representative experiment out of three is shown. Scale bar, 200 </a:t>
            </a:r>
            <a:r>
              <a:rPr lang="en-US" sz="1000" dirty="0">
                <a:latin typeface="Arial" panose="020B0604020202020204" pitchFamily="34" charset="0"/>
                <a:ea typeface="Times New Roman"/>
                <a:cs typeface="Arial" panose="020B0604020202020204" pitchFamily="34" charset="0"/>
                <a:sym typeface="Symbol"/>
              </a:rPr>
              <a:t></a:t>
            </a:r>
            <a:r>
              <a:rPr lang="en-US" sz="1000" dirty="0">
                <a:latin typeface="Arial" panose="020B0604020202020204" pitchFamily="34" charset="0"/>
                <a:ea typeface="Times New Roman"/>
                <a:cs typeface="Arial" panose="020B0604020202020204" pitchFamily="34" charset="0"/>
              </a:rPr>
              <a:t>m. </a:t>
            </a:r>
            <a:endParaRPr lang="it-IT"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06103433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uppo 1"/>
          <p:cNvGrpSpPr/>
          <p:nvPr/>
        </p:nvGrpSpPr>
        <p:grpSpPr>
          <a:xfrm>
            <a:off x="4450242" y="1281919"/>
            <a:ext cx="1316906" cy="2077574"/>
            <a:chOff x="7181850" y="3259661"/>
            <a:chExt cx="1316906" cy="2077574"/>
          </a:xfrm>
        </p:grpSpPr>
        <p:pic>
          <p:nvPicPr>
            <p:cNvPr id="11" name="Picture 64"/>
            <p:cNvPicPr>
              <a:picLocks noChangeAspect="1" noChangeArrowheads="1"/>
            </p:cNvPicPr>
            <p:nvPr/>
          </p:nvPicPr>
          <p:blipFill rotWithShape="1">
            <a:blip r:embed="rId2">
              <a:extLst>
                <a:ext uri="{28A0092B-C50C-407E-A947-70E740481C1C}">
                  <a14:useLocalDpi xmlns:a14="http://schemas.microsoft.com/office/drawing/2010/main" val="0"/>
                </a:ext>
              </a:extLst>
            </a:blip>
            <a:srcRect b="16100"/>
            <a:stretch/>
          </p:blipFill>
          <p:spPr bwMode="auto">
            <a:xfrm>
              <a:off x="7181850" y="3259661"/>
              <a:ext cx="1285874" cy="171238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2" name="Rettangolo 11"/>
            <p:cNvSpPr>
              <a:spLocks noChangeArrowheads="1"/>
            </p:cNvSpPr>
            <p:nvPr/>
          </p:nvSpPr>
          <p:spPr bwMode="auto">
            <a:xfrm>
              <a:off x="7713137" y="4937125"/>
              <a:ext cx="404278"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spcBef>
                  <a:spcPct val="0"/>
                </a:spcBef>
                <a:buFontTx/>
                <a:buNone/>
              </a:pPr>
              <a:r>
                <a:rPr lang="it-IT" altLang="it-IT" sz="1000" dirty="0">
                  <a:latin typeface="Arial" panose="020B0604020202020204" pitchFamily="34" charset="0"/>
                  <a:cs typeface="Arial" panose="020B0604020202020204" pitchFamily="34" charset="0"/>
                </a:rPr>
                <a:t>IL-5</a:t>
              </a:r>
            </a:p>
            <a:p>
              <a:pPr algn="ctr">
                <a:spcBef>
                  <a:spcPct val="0"/>
                </a:spcBef>
                <a:buFontTx/>
                <a:buNone/>
              </a:pPr>
              <a:r>
                <a:rPr lang="it-IT" altLang="it-IT" sz="1000" dirty="0">
                  <a:latin typeface="Arial" panose="020B0604020202020204" pitchFamily="34" charset="0"/>
                  <a:cs typeface="Arial" panose="020B0604020202020204" pitchFamily="34" charset="0"/>
                </a:rPr>
                <a:t>EO</a:t>
              </a:r>
            </a:p>
          </p:txBody>
        </p:sp>
        <p:sp>
          <p:nvSpPr>
            <p:cNvPr id="13" name="Rettangolo 12"/>
            <p:cNvSpPr>
              <a:spLocks noChangeArrowheads="1"/>
            </p:cNvSpPr>
            <p:nvPr/>
          </p:nvSpPr>
          <p:spPr bwMode="auto">
            <a:xfrm>
              <a:off x="8023946" y="4937125"/>
              <a:ext cx="474810" cy="40011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spcBef>
                  <a:spcPct val="0"/>
                </a:spcBef>
                <a:buFontTx/>
                <a:buNone/>
              </a:pPr>
              <a:r>
                <a:rPr lang="it-IT" altLang="it-IT" sz="1000">
                  <a:latin typeface="Arial" panose="020B0604020202020204" pitchFamily="34" charset="0"/>
                  <a:cs typeface="Arial" panose="020B0604020202020204" pitchFamily="34" charset="0"/>
                </a:rPr>
                <a:t>IL-33</a:t>
              </a:r>
            </a:p>
            <a:p>
              <a:pPr algn="ctr">
                <a:spcBef>
                  <a:spcPct val="0"/>
                </a:spcBef>
                <a:buFontTx/>
                <a:buNone/>
              </a:pPr>
              <a:r>
                <a:rPr lang="it-IT" altLang="it-IT" sz="1000">
                  <a:latin typeface="Arial" panose="020B0604020202020204" pitchFamily="34" charset="0"/>
                  <a:cs typeface="Arial" panose="020B0604020202020204" pitchFamily="34" charset="0"/>
                </a:rPr>
                <a:t>EO</a:t>
              </a:r>
            </a:p>
          </p:txBody>
        </p:sp>
      </p:grpSp>
      <p:grpSp>
        <p:nvGrpSpPr>
          <p:cNvPr id="3" name="Gruppo 2"/>
          <p:cNvGrpSpPr>
            <a:grpSpLocks noChangeAspect="1"/>
          </p:cNvGrpSpPr>
          <p:nvPr/>
        </p:nvGrpSpPr>
        <p:grpSpPr>
          <a:xfrm>
            <a:off x="523297" y="1263730"/>
            <a:ext cx="2019616" cy="2016000"/>
            <a:chOff x="734382" y="547642"/>
            <a:chExt cx="2524520" cy="2520000"/>
          </a:xfrm>
        </p:grpSpPr>
        <p:pic>
          <p:nvPicPr>
            <p:cNvPr id="9" name="Picture 6"/>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734382" y="547642"/>
              <a:ext cx="2524520" cy="2520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0" name="CasellaDiTesto 12">
              <a:extLst>
                <a:ext uri="{FF2B5EF4-FFF2-40B4-BE49-F238E27FC236}">
                  <a16:creationId xmlns:a16="http://schemas.microsoft.com/office/drawing/2014/main" id="{35F34B5C-74CC-4E9C-B7B3-27EE61F2C74F}"/>
                </a:ext>
              </a:extLst>
            </p:cNvPr>
            <p:cNvSpPr txBox="1"/>
            <p:nvPr/>
          </p:nvSpPr>
          <p:spPr>
            <a:xfrm>
              <a:off x="1933617" y="2432284"/>
              <a:ext cx="1093673" cy="276999"/>
            </a:xfrm>
            <a:prstGeom prst="rect">
              <a:avLst/>
            </a:prstGeom>
            <a:noFill/>
          </p:spPr>
          <p:txBody>
            <a:bodyPr wrap="square" rtlCol="0">
              <a:spAutoFit/>
            </a:bodyPr>
            <a:lst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r"/>
              <a:r>
                <a:rPr lang="it-IT" sz="1200" b="1" dirty="0" smtClean="0">
                  <a:solidFill>
                    <a:schemeClr val="bg1"/>
                  </a:solidFill>
                  <a:latin typeface="Arial" panose="020B0604020202020204" pitchFamily="34" charset="0"/>
                  <a:cs typeface="Arial" panose="020B0604020202020204" pitchFamily="34" charset="0"/>
                </a:rPr>
                <a:t>IL-5 EO</a:t>
              </a:r>
              <a:endParaRPr lang="it-IT" sz="1200" b="1" dirty="0">
                <a:solidFill>
                  <a:schemeClr val="bg1"/>
                </a:solidFill>
                <a:latin typeface="Arial" panose="020B0604020202020204" pitchFamily="34" charset="0"/>
                <a:cs typeface="Arial" panose="020B0604020202020204" pitchFamily="34" charset="0"/>
              </a:endParaRPr>
            </a:p>
          </p:txBody>
        </p:sp>
      </p:grpSp>
      <p:grpSp>
        <p:nvGrpSpPr>
          <p:cNvPr id="4" name="Gruppo 3"/>
          <p:cNvGrpSpPr>
            <a:grpSpLocks noChangeAspect="1"/>
          </p:cNvGrpSpPr>
          <p:nvPr/>
        </p:nvGrpSpPr>
        <p:grpSpPr>
          <a:xfrm>
            <a:off x="2400299" y="1255159"/>
            <a:ext cx="1789893" cy="2023200"/>
            <a:chOff x="1062562" y="3211050"/>
            <a:chExt cx="2237366" cy="2529001"/>
          </a:xfrm>
        </p:grpSpPr>
        <p:pic>
          <p:nvPicPr>
            <p:cNvPr id="7" name="Picture 4"/>
            <p:cNvPicPr>
              <a:picLocks noChangeArrowheads="1"/>
            </p:cNvPicPr>
            <p:nvPr/>
          </p:nvPicPr>
          <p:blipFill rotWithShape="1">
            <a:blip r:embed="rId4" cstate="print">
              <a:extLst>
                <a:ext uri="{28A0092B-C50C-407E-A947-70E740481C1C}">
                  <a14:useLocalDpi xmlns:a14="http://schemas.microsoft.com/office/drawing/2010/main" val="0"/>
                </a:ext>
              </a:extLst>
            </a:blip>
            <a:srcRect l="9929"/>
            <a:stretch/>
          </p:blipFill>
          <p:spPr bwMode="auto">
            <a:xfrm>
              <a:off x="1062562" y="3211050"/>
              <a:ext cx="2237366" cy="252900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8" name="CasellaDiTesto 13">
              <a:extLst>
                <a:ext uri="{FF2B5EF4-FFF2-40B4-BE49-F238E27FC236}">
                  <a16:creationId xmlns:a16="http://schemas.microsoft.com/office/drawing/2014/main" id="{C9C3BD42-305E-4417-91A1-F26E629873EB}"/>
                </a:ext>
              </a:extLst>
            </p:cNvPr>
            <p:cNvSpPr txBox="1"/>
            <p:nvPr/>
          </p:nvSpPr>
          <p:spPr>
            <a:xfrm>
              <a:off x="2021828" y="5104616"/>
              <a:ext cx="1044114" cy="276999"/>
            </a:xfrm>
            <a:prstGeom prst="rect">
              <a:avLst/>
            </a:prstGeom>
            <a:noFill/>
          </p:spPr>
          <p:txBody>
            <a:bodyPr wrap="square" rtlCol="0">
              <a:spAutoFit/>
            </a:bodyPr>
            <a:lst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r"/>
              <a:r>
                <a:rPr lang="it-IT" sz="1200" b="1" dirty="0" smtClean="0">
                  <a:solidFill>
                    <a:schemeClr val="bg1"/>
                  </a:solidFill>
                  <a:latin typeface="Arial" panose="020B0604020202020204" pitchFamily="34" charset="0"/>
                  <a:cs typeface="Arial" panose="020B0604020202020204" pitchFamily="34" charset="0"/>
                </a:rPr>
                <a:t>IL-33 EO</a:t>
              </a:r>
              <a:endParaRPr lang="it-IT" sz="1200" b="1" dirty="0">
                <a:solidFill>
                  <a:schemeClr val="bg1"/>
                </a:solidFill>
                <a:latin typeface="Arial" panose="020B0604020202020204" pitchFamily="34" charset="0"/>
                <a:cs typeface="Arial" panose="020B0604020202020204" pitchFamily="34" charset="0"/>
              </a:endParaRPr>
            </a:p>
          </p:txBody>
        </p:sp>
      </p:grpSp>
      <p:sp>
        <p:nvSpPr>
          <p:cNvPr id="5" name="CasellaDiTesto 16"/>
          <p:cNvSpPr txBox="1"/>
          <p:nvPr/>
        </p:nvSpPr>
        <p:spPr>
          <a:xfrm>
            <a:off x="4163848" y="1074930"/>
            <a:ext cx="332142" cy="338554"/>
          </a:xfrm>
          <a:prstGeom prst="rect">
            <a:avLst/>
          </a:prstGeom>
          <a:noFill/>
        </p:spPr>
        <p:txBody>
          <a:bodyPr wrap="none" rtlCol="0">
            <a:spAutoFit/>
          </a:bodyPr>
          <a:lst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it-IT" sz="1600" b="1" dirty="0">
                <a:latin typeface="Arial" panose="020B0604020202020204" pitchFamily="34" charset="0"/>
                <a:cs typeface="Arial" panose="020B0604020202020204" pitchFamily="34" charset="0"/>
              </a:rPr>
              <a:t>B</a:t>
            </a:r>
          </a:p>
        </p:txBody>
      </p:sp>
      <p:sp>
        <p:nvSpPr>
          <p:cNvPr id="6" name="CasellaDiTesto 26"/>
          <p:cNvSpPr txBox="1"/>
          <p:nvPr/>
        </p:nvSpPr>
        <p:spPr>
          <a:xfrm>
            <a:off x="84813" y="1074930"/>
            <a:ext cx="332142" cy="338554"/>
          </a:xfrm>
          <a:prstGeom prst="rect">
            <a:avLst/>
          </a:prstGeom>
          <a:noFill/>
        </p:spPr>
        <p:txBody>
          <a:bodyPr wrap="none" rtlCol="0">
            <a:spAutoFit/>
          </a:bodyPr>
          <a:lst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it-IT" sz="1600" b="1" dirty="0">
                <a:latin typeface="Arial" panose="020B0604020202020204" pitchFamily="34" charset="0"/>
                <a:cs typeface="Arial" panose="020B0604020202020204" pitchFamily="34" charset="0"/>
              </a:rPr>
              <a:t>A</a:t>
            </a:r>
          </a:p>
        </p:txBody>
      </p:sp>
      <p:sp>
        <p:nvSpPr>
          <p:cNvPr id="15" name="Rettangolo 14"/>
          <p:cNvSpPr/>
          <p:nvPr/>
        </p:nvSpPr>
        <p:spPr>
          <a:xfrm>
            <a:off x="29923" y="3716612"/>
            <a:ext cx="6063569" cy="1169551"/>
          </a:xfrm>
          <a:prstGeom prst="rect">
            <a:avLst/>
          </a:prstGeom>
        </p:spPr>
        <p:txBody>
          <a:bodyPr wrap="square">
            <a:spAutoFit/>
          </a:bodyPr>
          <a:lstStyle/>
          <a:p>
            <a:pPr algn="just"/>
            <a:r>
              <a:rPr lang="en-US" sz="1000" b="1" dirty="0" smtClean="0">
                <a:latin typeface="Arial" panose="020B0604020202020204" pitchFamily="34" charset="0"/>
                <a:cs typeface="Arial" panose="020B0604020202020204" pitchFamily="34" charset="0"/>
              </a:rPr>
              <a:t>Figure S3</a:t>
            </a:r>
            <a:r>
              <a:rPr lang="en-US" sz="1000" b="1" dirty="0" smtClean="0">
                <a:latin typeface="Arial" panose="020B0604020202020204" pitchFamily="34" charset="0"/>
                <a:cs typeface="Arial" panose="020B0604020202020204" pitchFamily="34" charset="0"/>
              </a:rPr>
              <a:t>.</a:t>
            </a:r>
            <a:r>
              <a:rPr lang="en-US" sz="1000" dirty="0" smtClean="0">
                <a:latin typeface="Arial" panose="020B0604020202020204" pitchFamily="34" charset="0"/>
                <a:cs typeface="Arial" panose="020B0604020202020204" pitchFamily="34" charset="0"/>
              </a:rPr>
              <a:t> </a:t>
            </a:r>
            <a:r>
              <a:rPr lang="en-US" sz="1000" dirty="0" smtClean="0">
                <a:latin typeface="Arial" panose="020B0604020202020204" pitchFamily="34" charset="0"/>
                <a:cs typeface="Arial" panose="020B0604020202020204" pitchFamily="34" charset="0"/>
              </a:rPr>
              <a:t>I</a:t>
            </a:r>
            <a:r>
              <a:rPr lang="it-IT" sz="1000" b="1" dirty="0" err="1" smtClean="0">
                <a:latin typeface="Arial" panose="020B0604020202020204" pitchFamily="34" charset="0"/>
                <a:cs typeface="Arial" panose="020B0604020202020204" pitchFamily="34" charset="0"/>
              </a:rPr>
              <a:t>nteractions</a:t>
            </a:r>
            <a:r>
              <a:rPr lang="it-IT" sz="1000" b="1" dirty="0" smtClean="0">
                <a:latin typeface="Arial" panose="020B0604020202020204" pitchFamily="34" charset="0"/>
                <a:cs typeface="Arial" panose="020B0604020202020204" pitchFamily="34" charset="0"/>
              </a:rPr>
              <a:t> </a:t>
            </a:r>
            <a:r>
              <a:rPr lang="it-IT" sz="1000" b="1" dirty="0" err="1">
                <a:latin typeface="Arial" panose="020B0604020202020204" pitchFamily="34" charset="0"/>
                <a:cs typeface="Arial" panose="020B0604020202020204" pitchFamily="34" charset="0"/>
              </a:rPr>
              <a:t>between</a:t>
            </a:r>
            <a:r>
              <a:rPr lang="it-IT" sz="1000" b="1" dirty="0">
                <a:latin typeface="Arial" panose="020B0604020202020204" pitchFamily="34" charset="0"/>
                <a:cs typeface="Arial" panose="020B0604020202020204" pitchFamily="34" charset="0"/>
              </a:rPr>
              <a:t> </a:t>
            </a:r>
            <a:r>
              <a:rPr lang="it-IT" sz="1000" b="1" dirty="0" err="1" smtClean="0">
                <a:latin typeface="Arial" panose="020B0604020202020204" pitchFamily="34" charset="0"/>
                <a:cs typeface="Arial" panose="020B0604020202020204" pitchFamily="34" charset="0"/>
              </a:rPr>
              <a:t>eosinophils</a:t>
            </a:r>
            <a:r>
              <a:rPr lang="it-IT" sz="1000" b="1" dirty="0" smtClean="0">
                <a:latin typeface="Arial" panose="020B0604020202020204" pitchFamily="34" charset="0"/>
                <a:cs typeface="Arial" panose="020B0604020202020204" pitchFamily="34" charset="0"/>
              </a:rPr>
              <a:t> and </a:t>
            </a:r>
            <a:r>
              <a:rPr lang="it-IT" sz="1000" b="1" dirty="0" smtClean="0">
                <a:latin typeface="Arial" panose="020B0604020202020204" pitchFamily="34" charset="0"/>
                <a:cs typeface="Arial" panose="020B0604020202020204" pitchFamily="34" charset="0"/>
              </a:rPr>
              <a:t>TC-1 </a:t>
            </a:r>
            <a:r>
              <a:rPr lang="it-IT" sz="1000" b="1" dirty="0" err="1" smtClean="0">
                <a:latin typeface="Arial" panose="020B0604020202020204" pitchFamily="34" charset="0"/>
                <a:cs typeface="Arial" panose="020B0604020202020204" pitchFamily="34" charset="0"/>
              </a:rPr>
              <a:t>tumor</a:t>
            </a:r>
            <a:r>
              <a:rPr lang="it-IT" sz="1000" b="1" dirty="0" smtClean="0">
                <a:latin typeface="Arial" panose="020B0604020202020204" pitchFamily="34" charset="0"/>
                <a:cs typeface="Arial" panose="020B0604020202020204" pitchFamily="34" charset="0"/>
              </a:rPr>
              <a:t> </a:t>
            </a:r>
            <a:r>
              <a:rPr lang="it-IT" sz="1000" b="1" dirty="0" err="1" smtClean="0">
                <a:latin typeface="Arial" panose="020B0604020202020204" pitchFamily="34" charset="0"/>
                <a:cs typeface="Arial" panose="020B0604020202020204" pitchFamily="34" charset="0"/>
              </a:rPr>
              <a:t>cells</a:t>
            </a:r>
            <a:r>
              <a:rPr lang="it-IT" sz="1000" b="1" dirty="0" smtClean="0">
                <a:latin typeface="Arial" panose="020B0604020202020204" pitchFamily="34" charset="0"/>
                <a:cs typeface="Arial" panose="020B0604020202020204" pitchFamily="34" charset="0"/>
              </a:rPr>
              <a:t>.</a:t>
            </a:r>
            <a:r>
              <a:rPr lang="it-IT" sz="1000" dirty="0" smtClean="0">
                <a:latin typeface="Arial" panose="020B0604020202020204" pitchFamily="34" charset="0"/>
                <a:cs typeface="Arial" panose="020B0604020202020204" pitchFamily="34" charset="0"/>
              </a:rPr>
              <a:t> (</a:t>
            </a:r>
            <a:r>
              <a:rPr lang="it-IT" sz="1000" b="1" dirty="0" smtClean="0">
                <a:latin typeface="Arial" panose="020B0604020202020204" pitchFamily="34" charset="0"/>
                <a:cs typeface="Arial" panose="020B0604020202020204" pitchFamily="34" charset="0"/>
              </a:rPr>
              <a:t>A</a:t>
            </a:r>
            <a:r>
              <a:rPr lang="it-IT" sz="1000" dirty="0" smtClean="0">
                <a:latin typeface="Arial" panose="020B0604020202020204" pitchFamily="34" charset="0"/>
                <a:cs typeface="Arial" panose="020B0604020202020204" pitchFamily="34" charset="0"/>
              </a:rPr>
              <a:t>) IL-5 EO and IL-33 EO </a:t>
            </a:r>
            <a:r>
              <a:rPr lang="it-IT" sz="1000" dirty="0">
                <a:latin typeface="Arial" panose="020B0604020202020204" pitchFamily="34" charset="0"/>
                <a:cs typeface="Arial" panose="020B0604020202020204" pitchFamily="34" charset="0"/>
              </a:rPr>
              <a:t>(3 x 10</a:t>
            </a:r>
            <a:r>
              <a:rPr lang="it-IT" sz="1000" baseline="30000" dirty="0">
                <a:latin typeface="Arial" panose="020B0604020202020204" pitchFamily="34" charset="0"/>
                <a:cs typeface="Arial" panose="020B0604020202020204" pitchFamily="34" charset="0"/>
              </a:rPr>
              <a:t>5</a:t>
            </a:r>
            <a:r>
              <a:rPr lang="it-IT" sz="1000" dirty="0">
                <a:latin typeface="Arial" panose="020B0604020202020204" pitchFamily="34" charset="0"/>
                <a:cs typeface="Arial" panose="020B0604020202020204" pitchFamily="34" charset="0"/>
              </a:rPr>
              <a:t>) </a:t>
            </a:r>
            <a:r>
              <a:rPr lang="it-IT" sz="1000" dirty="0" err="1" smtClean="0">
                <a:latin typeface="Arial" panose="020B0604020202020204" pitchFamily="34" charset="0"/>
                <a:cs typeface="Arial" panose="020B0604020202020204" pitchFamily="34" charset="0"/>
              </a:rPr>
              <a:t>were</a:t>
            </a:r>
            <a:r>
              <a:rPr lang="it-IT" sz="1000" dirty="0" smtClean="0">
                <a:latin typeface="Arial" panose="020B0604020202020204" pitchFamily="34" charset="0"/>
                <a:cs typeface="Arial" panose="020B0604020202020204" pitchFamily="34" charset="0"/>
              </a:rPr>
              <a:t> co-</a:t>
            </a:r>
            <a:r>
              <a:rPr lang="it-IT" sz="1000" dirty="0" err="1" smtClean="0">
                <a:latin typeface="Arial" panose="020B0604020202020204" pitchFamily="34" charset="0"/>
                <a:cs typeface="Arial" panose="020B0604020202020204" pitchFamily="34" charset="0"/>
              </a:rPr>
              <a:t>cultured</a:t>
            </a:r>
            <a:r>
              <a:rPr lang="it-IT" sz="1000" dirty="0" smtClean="0">
                <a:latin typeface="Arial" panose="020B0604020202020204" pitchFamily="34" charset="0"/>
                <a:cs typeface="Arial" panose="020B0604020202020204" pitchFamily="34" charset="0"/>
              </a:rPr>
              <a:t> with TC-1 </a:t>
            </a:r>
            <a:r>
              <a:rPr lang="it-IT" sz="1000" dirty="0" err="1" smtClean="0">
                <a:latin typeface="Arial" panose="020B0604020202020204" pitchFamily="34" charset="0"/>
                <a:cs typeface="Arial" panose="020B0604020202020204" pitchFamily="34" charset="0"/>
              </a:rPr>
              <a:t>tumor</a:t>
            </a:r>
            <a:r>
              <a:rPr lang="it-IT" sz="1000" dirty="0" smtClean="0">
                <a:latin typeface="Arial" panose="020B0604020202020204" pitchFamily="34" charset="0"/>
                <a:cs typeface="Arial" panose="020B0604020202020204" pitchFamily="34" charset="0"/>
              </a:rPr>
              <a:t> </a:t>
            </a:r>
            <a:r>
              <a:rPr lang="it-IT" sz="1000" dirty="0" err="1" smtClean="0">
                <a:latin typeface="Arial" panose="020B0604020202020204" pitchFamily="34" charset="0"/>
                <a:cs typeface="Arial" panose="020B0604020202020204" pitchFamily="34" charset="0"/>
              </a:rPr>
              <a:t>cells</a:t>
            </a:r>
            <a:r>
              <a:rPr lang="it-IT" sz="1000" dirty="0" smtClean="0">
                <a:latin typeface="Arial" panose="020B0604020202020204" pitchFamily="34" charset="0"/>
                <a:cs typeface="Arial" panose="020B0604020202020204" pitchFamily="34" charset="0"/>
              </a:rPr>
              <a:t> (2 x 10</a:t>
            </a:r>
            <a:r>
              <a:rPr lang="it-IT" sz="1000" baseline="30000" dirty="0" smtClean="0">
                <a:latin typeface="Arial" panose="020B0604020202020204" pitchFamily="34" charset="0"/>
                <a:cs typeface="Arial" panose="020B0604020202020204" pitchFamily="34" charset="0"/>
              </a:rPr>
              <a:t>5</a:t>
            </a:r>
            <a:r>
              <a:rPr lang="it-IT" sz="1000" dirty="0" smtClean="0">
                <a:latin typeface="Arial" panose="020B0604020202020204" pitchFamily="34" charset="0"/>
                <a:cs typeface="Arial" panose="020B0604020202020204" pitchFamily="34" charset="0"/>
              </a:rPr>
              <a:t>) for </a:t>
            </a:r>
            <a:r>
              <a:rPr lang="it-IT" sz="1000" dirty="0">
                <a:latin typeface="Arial" panose="020B0604020202020204" pitchFamily="34" charset="0"/>
                <a:cs typeface="Arial" panose="020B0604020202020204" pitchFamily="34" charset="0"/>
              </a:rPr>
              <a:t>5</a:t>
            </a:r>
            <a:r>
              <a:rPr lang="it-IT" sz="1000" dirty="0" smtClean="0">
                <a:latin typeface="Arial" panose="020B0604020202020204" pitchFamily="34" charset="0"/>
                <a:cs typeface="Arial" panose="020B0604020202020204" pitchFamily="34" charset="0"/>
              </a:rPr>
              <a:t> h on a </a:t>
            </a:r>
            <a:r>
              <a:rPr lang="it-IT" sz="1000" dirty="0" err="1" smtClean="0">
                <a:latin typeface="Arial" panose="020B0604020202020204" pitchFamily="34" charset="0"/>
                <a:cs typeface="Arial" panose="020B0604020202020204" pitchFamily="34" charset="0"/>
              </a:rPr>
              <a:t>Juli</a:t>
            </a:r>
            <a:r>
              <a:rPr lang="it-IT" sz="1000" dirty="0" smtClean="0">
                <a:latin typeface="Arial" panose="020B0604020202020204" pitchFamily="34" charset="0"/>
                <a:cs typeface="Arial" panose="020B0604020202020204" pitchFamily="34" charset="0"/>
              </a:rPr>
              <a:t> </a:t>
            </a:r>
            <a:r>
              <a:rPr lang="it-IT" sz="1000" dirty="0" err="1" smtClean="0">
                <a:latin typeface="Arial" panose="020B0604020202020204" pitchFamily="34" charset="0"/>
                <a:cs typeface="Arial" panose="020B0604020202020204" pitchFamily="34" charset="0"/>
              </a:rPr>
              <a:t>microscope</a:t>
            </a:r>
            <a:r>
              <a:rPr lang="it-IT" sz="1000" dirty="0" smtClean="0">
                <a:latin typeface="Arial" panose="020B0604020202020204" pitchFamily="34" charset="0"/>
                <a:cs typeface="Arial" panose="020B0604020202020204" pitchFamily="34" charset="0"/>
              </a:rPr>
              <a:t>. </a:t>
            </a:r>
            <a:r>
              <a:rPr lang="it-IT" sz="1000" dirty="0" err="1" smtClean="0">
                <a:latin typeface="Arial" panose="020B0604020202020204" pitchFamily="34" charset="0"/>
                <a:cs typeface="Arial" panose="020B0604020202020204" pitchFamily="34" charset="0"/>
              </a:rPr>
              <a:t>Tracking</a:t>
            </a:r>
            <a:r>
              <a:rPr lang="it-IT" sz="1000" dirty="0" smtClean="0">
                <a:latin typeface="Arial" panose="020B0604020202020204" pitchFamily="34" charset="0"/>
                <a:cs typeface="Arial" panose="020B0604020202020204" pitchFamily="34" charset="0"/>
              </a:rPr>
              <a:t> </a:t>
            </a:r>
            <a:r>
              <a:rPr lang="it-IT" sz="1000" dirty="0" err="1">
                <a:latin typeface="Arial" panose="020B0604020202020204" pitchFamily="34" charset="0"/>
                <a:cs typeface="Arial" panose="020B0604020202020204" pitchFamily="34" charset="0"/>
              </a:rPr>
              <a:t>analysis</a:t>
            </a:r>
            <a:r>
              <a:rPr lang="it-IT" sz="1000" dirty="0">
                <a:latin typeface="Arial" panose="020B0604020202020204" pitchFamily="34" charset="0"/>
                <a:cs typeface="Arial" panose="020B0604020202020204" pitchFamily="34" charset="0"/>
              </a:rPr>
              <a:t> of </a:t>
            </a:r>
            <a:r>
              <a:rPr lang="it-IT" sz="1000" dirty="0" smtClean="0">
                <a:latin typeface="Arial" panose="020B0604020202020204" pitchFamily="34" charset="0"/>
                <a:cs typeface="Arial" panose="020B0604020202020204" pitchFamily="34" charset="0"/>
              </a:rPr>
              <a:t>time </a:t>
            </a:r>
            <a:r>
              <a:rPr lang="it-IT" sz="1000" dirty="0" err="1">
                <a:latin typeface="Arial" panose="020B0604020202020204" pitchFamily="34" charset="0"/>
                <a:cs typeface="Arial" panose="020B0604020202020204" pitchFamily="34" charset="0"/>
              </a:rPr>
              <a:t>lapse</a:t>
            </a:r>
            <a:r>
              <a:rPr lang="it-IT" sz="1000" dirty="0">
                <a:latin typeface="Arial" panose="020B0604020202020204" pitchFamily="34" charset="0"/>
                <a:cs typeface="Arial" panose="020B0604020202020204" pitchFamily="34" charset="0"/>
              </a:rPr>
              <a:t> video </a:t>
            </a:r>
            <a:r>
              <a:rPr lang="it-IT" sz="1000" dirty="0" err="1" smtClean="0">
                <a:latin typeface="Arial" panose="020B0604020202020204" pitchFamily="34" charset="0"/>
                <a:cs typeface="Arial" panose="020B0604020202020204" pitchFamily="34" charset="0"/>
              </a:rPr>
              <a:t>recordings</a:t>
            </a:r>
            <a:r>
              <a:rPr lang="it-IT" sz="1000" dirty="0">
                <a:latin typeface="Arial" panose="020B0604020202020204" pitchFamily="34" charset="0"/>
                <a:cs typeface="Arial" panose="020B0604020202020204" pitchFamily="34" charset="0"/>
              </a:rPr>
              <a:t> </a:t>
            </a:r>
            <a:r>
              <a:rPr lang="it-IT" sz="1000" dirty="0" err="1" smtClean="0">
                <a:latin typeface="Arial" panose="020B0604020202020204" pitchFamily="34" charset="0"/>
                <a:cs typeface="Arial" panose="020B0604020202020204" pitchFamily="34" charset="0"/>
              </a:rPr>
              <a:t>was</a:t>
            </a:r>
            <a:r>
              <a:rPr lang="it-IT" sz="1000" dirty="0" smtClean="0">
                <a:latin typeface="Arial" panose="020B0604020202020204" pitchFamily="34" charset="0"/>
                <a:cs typeface="Arial" panose="020B0604020202020204" pitchFamily="34" charset="0"/>
              </a:rPr>
              <a:t> </a:t>
            </a:r>
            <a:r>
              <a:rPr lang="it-IT" sz="1000" dirty="0" err="1" smtClean="0">
                <a:latin typeface="Arial" panose="020B0604020202020204" pitchFamily="34" charset="0"/>
                <a:cs typeface="Arial" panose="020B0604020202020204" pitchFamily="34" charset="0"/>
              </a:rPr>
              <a:t>performed</a:t>
            </a:r>
            <a:r>
              <a:rPr lang="it-IT" sz="1000" dirty="0" smtClean="0">
                <a:latin typeface="Arial" panose="020B0604020202020204" pitchFamily="34" charset="0"/>
                <a:cs typeface="Arial" panose="020B0604020202020204" pitchFamily="34" charset="0"/>
              </a:rPr>
              <a:t> </a:t>
            </a:r>
            <a:r>
              <a:rPr lang="it-IT" sz="1000" dirty="0">
                <a:latin typeface="Arial" panose="020B0604020202020204" pitchFamily="34" charset="0"/>
                <a:cs typeface="Arial" panose="020B0604020202020204" pitchFamily="34" charset="0"/>
              </a:rPr>
              <a:t>by the </a:t>
            </a:r>
            <a:r>
              <a:rPr lang="it-IT" sz="1000" dirty="0" err="1">
                <a:latin typeface="Arial" panose="020B0604020202020204" pitchFamily="34" charset="0"/>
                <a:cs typeface="Arial" panose="020B0604020202020204" pitchFamily="34" charset="0"/>
              </a:rPr>
              <a:t>TrackMate</a:t>
            </a:r>
            <a:r>
              <a:rPr lang="it-IT" sz="1000" dirty="0">
                <a:latin typeface="Arial" panose="020B0604020202020204" pitchFamily="34" charset="0"/>
                <a:cs typeface="Arial" panose="020B0604020202020204" pitchFamily="34" charset="0"/>
              </a:rPr>
              <a:t> </a:t>
            </a:r>
            <a:r>
              <a:rPr lang="it-IT" sz="1000" dirty="0" err="1">
                <a:latin typeface="Arial" panose="020B0604020202020204" pitchFamily="34" charset="0"/>
                <a:cs typeface="Arial" panose="020B0604020202020204" pitchFamily="34" charset="0"/>
              </a:rPr>
              <a:t>plugin</a:t>
            </a:r>
            <a:r>
              <a:rPr lang="it-IT" sz="1000" dirty="0">
                <a:latin typeface="Arial" panose="020B0604020202020204" pitchFamily="34" charset="0"/>
                <a:cs typeface="Arial" panose="020B0604020202020204" pitchFamily="34" charset="0"/>
              </a:rPr>
              <a:t> of </a:t>
            </a:r>
            <a:r>
              <a:rPr lang="it-IT" sz="1000" dirty="0" smtClean="0">
                <a:latin typeface="Arial" panose="020B0604020202020204" pitchFamily="34" charset="0"/>
                <a:cs typeface="Arial" panose="020B0604020202020204" pitchFamily="34" charset="0"/>
              </a:rPr>
              <a:t>ImageJ software. Yellow </a:t>
            </a:r>
            <a:r>
              <a:rPr lang="it-IT" sz="1000" dirty="0" err="1">
                <a:latin typeface="Arial" panose="020B0604020202020204" pitchFamily="34" charset="0"/>
                <a:cs typeface="Arial" panose="020B0604020202020204" pitchFamily="34" charset="0"/>
              </a:rPr>
              <a:t>lines</a:t>
            </a:r>
            <a:r>
              <a:rPr lang="it-IT" sz="1000" dirty="0">
                <a:latin typeface="Arial" panose="020B0604020202020204" pitchFamily="34" charset="0"/>
                <a:cs typeface="Arial" panose="020B0604020202020204" pitchFamily="34" charset="0"/>
              </a:rPr>
              <a:t> </a:t>
            </a:r>
            <a:r>
              <a:rPr lang="it-IT" sz="1000" dirty="0" err="1">
                <a:latin typeface="Arial" panose="020B0604020202020204" pitchFamily="34" charset="0"/>
                <a:cs typeface="Arial" panose="020B0604020202020204" pitchFamily="34" charset="0"/>
              </a:rPr>
              <a:t>represent</a:t>
            </a:r>
            <a:r>
              <a:rPr lang="it-IT" sz="1000" dirty="0">
                <a:latin typeface="Arial" panose="020B0604020202020204" pitchFamily="34" charset="0"/>
                <a:cs typeface="Arial" panose="020B0604020202020204" pitchFamily="34" charset="0"/>
              </a:rPr>
              <a:t> </a:t>
            </a:r>
            <a:r>
              <a:rPr lang="it-IT" sz="1000" dirty="0" err="1" smtClean="0">
                <a:latin typeface="Arial" panose="020B0604020202020204" pitchFamily="34" charset="0"/>
                <a:cs typeface="Arial" panose="020B0604020202020204" pitchFamily="34" charset="0"/>
              </a:rPr>
              <a:t>trajectories</a:t>
            </a:r>
            <a:r>
              <a:rPr lang="it-IT" sz="1000" dirty="0" smtClean="0">
                <a:latin typeface="Arial" panose="020B0604020202020204" pitchFamily="34" charset="0"/>
                <a:cs typeface="Arial" panose="020B0604020202020204" pitchFamily="34" charset="0"/>
              </a:rPr>
              <a:t> of </a:t>
            </a:r>
            <a:r>
              <a:rPr lang="it-IT" sz="1000" dirty="0" err="1" smtClean="0">
                <a:latin typeface="Arial" panose="020B0604020202020204" pitchFamily="34" charset="0"/>
                <a:cs typeface="Arial" panose="020B0604020202020204" pitchFamily="34" charset="0"/>
              </a:rPr>
              <a:t>EOs</a:t>
            </a:r>
            <a:r>
              <a:rPr lang="it-IT" sz="1000" dirty="0" smtClean="0">
                <a:latin typeface="Arial" panose="020B0604020202020204" pitchFamily="34" charset="0"/>
                <a:cs typeface="Arial" panose="020B0604020202020204" pitchFamily="34" charset="0"/>
              </a:rPr>
              <a:t> </a:t>
            </a:r>
            <a:r>
              <a:rPr lang="it-IT" sz="1000" dirty="0" err="1" smtClean="0">
                <a:latin typeface="Arial" panose="020B0604020202020204" pitchFamily="34" charset="0"/>
                <a:cs typeface="Arial" panose="020B0604020202020204" pitchFamily="34" charset="0"/>
              </a:rPr>
              <a:t>obtained</a:t>
            </a:r>
            <a:r>
              <a:rPr lang="it-IT" sz="1000" dirty="0" smtClean="0">
                <a:latin typeface="Arial" panose="020B0604020202020204" pitchFamily="34" charset="0"/>
                <a:cs typeface="Arial" panose="020B0604020202020204" pitchFamily="34" charset="0"/>
              </a:rPr>
              <a:t> over the 24 h co-culture time. </a:t>
            </a:r>
            <a:r>
              <a:rPr lang="it-IT" sz="1000" dirty="0">
                <a:latin typeface="Arial" panose="020B0604020202020204" pitchFamily="34" charset="0"/>
                <a:cs typeface="Arial" panose="020B0604020202020204" pitchFamily="34" charset="0"/>
              </a:rPr>
              <a:t>White </a:t>
            </a:r>
            <a:r>
              <a:rPr lang="it-IT" sz="1000" dirty="0" err="1">
                <a:latin typeface="Arial" panose="020B0604020202020204" pitchFamily="34" charset="0"/>
                <a:cs typeface="Arial" panose="020B0604020202020204" pitchFamily="34" charset="0"/>
              </a:rPr>
              <a:t>dotted</a:t>
            </a:r>
            <a:r>
              <a:rPr lang="it-IT" sz="1000" dirty="0">
                <a:latin typeface="Arial" panose="020B0604020202020204" pitchFamily="34" charset="0"/>
                <a:cs typeface="Arial" panose="020B0604020202020204" pitchFamily="34" charset="0"/>
              </a:rPr>
              <a:t> </a:t>
            </a:r>
            <a:r>
              <a:rPr lang="it-IT" sz="1000" dirty="0" err="1">
                <a:latin typeface="Arial" panose="020B0604020202020204" pitchFamily="34" charset="0"/>
                <a:cs typeface="Arial" panose="020B0604020202020204" pitchFamily="34" charset="0"/>
              </a:rPr>
              <a:t>lines</a:t>
            </a:r>
            <a:r>
              <a:rPr lang="it-IT" sz="1000" dirty="0">
                <a:latin typeface="Arial" panose="020B0604020202020204" pitchFamily="34" charset="0"/>
                <a:cs typeface="Arial" panose="020B0604020202020204" pitchFamily="34" charset="0"/>
              </a:rPr>
              <a:t> </a:t>
            </a:r>
            <a:r>
              <a:rPr lang="it-IT" sz="1000" dirty="0" err="1">
                <a:latin typeface="Arial" panose="020B0604020202020204" pitchFamily="34" charset="0"/>
                <a:cs typeface="Arial" panose="020B0604020202020204" pitchFamily="34" charset="0"/>
              </a:rPr>
              <a:t>depict</a:t>
            </a:r>
            <a:r>
              <a:rPr lang="it-IT" sz="1000" dirty="0">
                <a:latin typeface="Arial" panose="020B0604020202020204" pitchFamily="34" charset="0"/>
                <a:cs typeface="Arial" panose="020B0604020202020204" pitchFamily="34" charset="0"/>
              </a:rPr>
              <a:t> the target </a:t>
            </a:r>
            <a:r>
              <a:rPr lang="it-IT" sz="1000" dirty="0" err="1" smtClean="0">
                <a:latin typeface="Arial" panose="020B0604020202020204" pitchFamily="34" charset="0"/>
                <a:cs typeface="Arial" panose="020B0604020202020204" pitchFamily="34" charset="0"/>
              </a:rPr>
              <a:t>tumor</a:t>
            </a:r>
            <a:r>
              <a:rPr lang="it-IT" sz="1000" dirty="0" smtClean="0">
                <a:latin typeface="Arial" panose="020B0604020202020204" pitchFamily="34" charset="0"/>
                <a:cs typeface="Arial" panose="020B0604020202020204" pitchFamily="34" charset="0"/>
              </a:rPr>
              <a:t> </a:t>
            </a:r>
            <a:r>
              <a:rPr lang="it-IT" sz="1000" dirty="0" err="1">
                <a:latin typeface="Arial" panose="020B0604020202020204" pitchFamily="34" charset="0"/>
                <a:cs typeface="Arial" panose="020B0604020202020204" pitchFamily="34" charset="0"/>
              </a:rPr>
              <a:t>cell</a:t>
            </a:r>
            <a:r>
              <a:rPr lang="it-IT" sz="1000" dirty="0">
                <a:latin typeface="Arial" panose="020B0604020202020204" pitchFamily="34" charset="0"/>
                <a:cs typeface="Arial" panose="020B0604020202020204" pitchFamily="34" charset="0"/>
              </a:rPr>
              <a:t>. </a:t>
            </a:r>
            <a:r>
              <a:rPr lang="it-IT" sz="1000" dirty="0" err="1" smtClean="0">
                <a:latin typeface="Arial" panose="020B0604020202020204" pitchFamily="34" charset="0"/>
                <a:cs typeface="Arial" panose="020B0604020202020204" pitchFamily="34" charset="0"/>
              </a:rPr>
              <a:t>Tracking</a:t>
            </a:r>
            <a:r>
              <a:rPr lang="it-IT" sz="1000" dirty="0" smtClean="0">
                <a:latin typeface="Arial" panose="020B0604020202020204" pitchFamily="34" charset="0"/>
                <a:cs typeface="Arial" panose="020B0604020202020204" pitchFamily="34" charset="0"/>
              </a:rPr>
              <a:t> </a:t>
            </a:r>
            <a:r>
              <a:rPr lang="it-IT" sz="1000" dirty="0" err="1">
                <a:latin typeface="Arial" panose="020B0604020202020204" pitchFamily="34" charset="0"/>
                <a:cs typeface="Arial" panose="020B0604020202020204" pitchFamily="34" charset="0"/>
              </a:rPr>
              <a:t>analysis</a:t>
            </a:r>
            <a:r>
              <a:rPr lang="it-IT" sz="1000" dirty="0">
                <a:latin typeface="Arial" panose="020B0604020202020204" pitchFamily="34" charset="0"/>
                <a:cs typeface="Arial" panose="020B0604020202020204" pitchFamily="34" charset="0"/>
              </a:rPr>
              <a:t> </a:t>
            </a:r>
            <a:r>
              <a:rPr lang="it-IT" sz="1000" dirty="0" err="1">
                <a:latin typeface="Arial" panose="020B0604020202020204" pitchFamily="34" charset="0"/>
                <a:cs typeface="Arial" panose="020B0604020202020204" pitchFamily="34" charset="0"/>
              </a:rPr>
              <a:t>was</a:t>
            </a:r>
            <a:r>
              <a:rPr lang="it-IT" sz="1000" dirty="0">
                <a:latin typeface="Arial" panose="020B0604020202020204" pitchFamily="34" charset="0"/>
                <a:cs typeface="Arial" panose="020B0604020202020204" pitchFamily="34" charset="0"/>
              </a:rPr>
              <a:t> made on 200 x 200 pixel </a:t>
            </a:r>
            <a:r>
              <a:rPr lang="it-IT" sz="1000" dirty="0" err="1">
                <a:latin typeface="Arial" panose="020B0604020202020204" pitchFamily="34" charset="0"/>
                <a:cs typeface="Arial" panose="020B0604020202020204" pitchFamily="34" charset="0"/>
              </a:rPr>
              <a:t>crops</a:t>
            </a:r>
            <a:r>
              <a:rPr lang="it-IT" sz="1000" dirty="0">
                <a:latin typeface="Arial" panose="020B0604020202020204" pitchFamily="34" charset="0"/>
                <a:cs typeface="Arial" panose="020B0604020202020204" pitchFamily="34" charset="0"/>
              </a:rPr>
              <a:t> </a:t>
            </a:r>
            <a:r>
              <a:rPr lang="it-IT" sz="1000" dirty="0" err="1">
                <a:latin typeface="Arial" panose="020B0604020202020204" pitchFamily="34" charset="0"/>
                <a:cs typeface="Arial" panose="020B0604020202020204" pitchFamily="34" charset="0"/>
              </a:rPr>
              <a:t>representative</a:t>
            </a:r>
            <a:r>
              <a:rPr lang="it-IT" sz="1000" dirty="0">
                <a:latin typeface="Arial" panose="020B0604020202020204" pitchFamily="34" charset="0"/>
                <a:cs typeface="Arial" panose="020B0604020202020204" pitchFamily="34" charset="0"/>
              </a:rPr>
              <a:t> of the time </a:t>
            </a:r>
            <a:r>
              <a:rPr lang="it-IT" sz="1000" dirty="0" err="1">
                <a:latin typeface="Arial" panose="020B0604020202020204" pitchFamily="34" charset="0"/>
                <a:cs typeface="Arial" panose="020B0604020202020204" pitchFamily="34" charset="0"/>
              </a:rPr>
              <a:t>lapse</a:t>
            </a:r>
            <a:r>
              <a:rPr lang="it-IT" sz="1000" dirty="0">
                <a:latin typeface="Arial" panose="020B0604020202020204" pitchFamily="34" charset="0"/>
                <a:cs typeface="Arial" panose="020B0604020202020204" pitchFamily="34" charset="0"/>
              </a:rPr>
              <a:t>. </a:t>
            </a:r>
            <a:r>
              <a:rPr lang="it-IT" sz="1000" dirty="0" err="1">
                <a:latin typeface="Arial" panose="020B0604020202020204" pitchFamily="34" charset="0"/>
                <a:cs typeface="Arial" panose="020B0604020202020204" pitchFamily="34" charset="0"/>
              </a:rPr>
              <a:t>One</a:t>
            </a:r>
            <a:r>
              <a:rPr lang="it-IT" sz="1000" dirty="0">
                <a:latin typeface="Arial" panose="020B0604020202020204" pitchFamily="34" charset="0"/>
                <a:cs typeface="Arial" panose="020B0604020202020204" pitchFamily="34" charset="0"/>
              </a:rPr>
              <a:t> </a:t>
            </a:r>
            <a:r>
              <a:rPr lang="it-IT" sz="1000" dirty="0" err="1">
                <a:latin typeface="Arial" panose="020B0604020202020204" pitchFamily="34" charset="0"/>
                <a:cs typeface="Arial" panose="020B0604020202020204" pitchFamily="34" charset="0"/>
              </a:rPr>
              <a:t>experiment</a:t>
            </a:r>
            <a:r>
              <a:rPr lang="it-IT" sz="1000" dirty="0">
                <a:latin typeface="Arial" panose="020B0604020202020204" pitchFamily="34" charset="0"/>
                <a:cs typeface="Arial" panose="020B0604020202020204" pitchFamily="34" charset="0"/>
              </a:rPr>
              <a:t> out of </a:t>
            </a:r>
            <a:r>
              <a:rPr lang="it-IT" sz="1000" dirty="0" err="1">
                <a:latin typeface="Arial" panose="020B0604020202020204" pitchFamily="34" charset="0"/>
                <a:cs typeface="Arial" panose="020B0604020202020204" pitchFamily="34" charset="0"/>
              </a:rPr>
              <a:t>three</a:t>
            </a:r>
            <a:r>
              <a:rPr lang="it-IT" sz="1000" dirty="0">
                <a:latin typeface="Arial" panose="020B0604020202020204" pitchFamily="34" charset="0"/>
                <a:cs typeface="Arial" panose="020B0604020202020204" pitchFamily="34" charset="0"/>
              </a:rPr>
              <a:t> </a:t>
            </a:r>
            <a:r>
              <a:rPr lang="it-IT" sz="1000" dirty="0" err="1">
                <a:latin typeface="Arial" panose="020B0604020202020204" pitchFamily="34" charset="0"/>
                <a:cs typeface="Arial" panose="020B0604020202020204" pitchFamily="34" charset="0"/>
              </a:rPr>
              <a:t>is</a:t>
            </a:r>
            <a:r>
              <a:rPr lang="it-IT" sz="1000" dirty="0">
                <a:latin typeface="Arial" panose="020B0604020202020204" pitchFamily="34" charset="0"/>
                <a:cs typeface="Arial" panose="020B0604020202020204" pitchFamily="34" charset="0"/>
              </a:rPr>
              <a:t> </a:t>
            </a:r>
            <a:r>
              <a:rPr lang="it-IT" sz="1000" dirty="0" err="1">
                <a:latin typeface="Arial" panose="020B0604020202020204" pitchFamily="34" charset="0"/>
                <a:cs typeface="Arial" panose="020B0604020202020204" pitchFamily="34" charset="0"/>
              </a:rPr>
              <a:t>shown</a:t>
            </a:r>
            <a:r>
              <a:rPr lang="it-IT" sz="1000" dirty="0">
                <a:latin typeface="Arial" panose="020B0604020202020204" pitchFamily="34" charset="0"/>
                <a:cs typeface="Arial" panose="020B0604020202020204" pitchFamily="34" charset="0"/>
              </a:rPr>
              <a:t>. </a:t>
            </a:r>
            <a:r>
              <a:rPr lang="it-IT" sz="1000" dirty="0" smtClean="0">
                <a:latin typeface="Arial" panose="020B0604020202020204" pitchFamily="34" charset="0"/>
                <a:cs typeface="Arial" panose="020B0604020202020204" pitchFamily="34" charset="0"/>
              </a:rPr>
              <a:t>(</a:t>
            </a:r>
            <a:r>
              <a:rPr lang="it-IT" sz="1000" b="1" dirty="0" smtClean="0">
                <a:latin typeface="Arial" panose="020B0604020202020204" pitchFamily="34" charset="0"/>
                <a:cs typeface="Arial" panose="020B0604020202020204" pitchFamily="34" charset="0"/>
              </a:rPr>
              <a:t>B</a:t>
            </a:r>
            <a:r>
              <a:rPr lang="it-IT" sz="1000" dirty="0" smtClean="0">
                <a:latin typeface="Arial" panose="020B0604020202020204" pitchFamily="34" charset="0"/>
                <a:cs typeface="Arial" panose="020B0604020202020204" pitchFamily="34" charset="0"/>
              </a:rPr>
              <a:t>) </a:t>
            </a:r>
            <a:r>
              <a:rPr lang="it-IT" sz="1000" dirty="0" err="1">
                <a:latin typeface="Arial" panose="020B0604020202020204" pitchFamily="34" charset="0"/>
                <a:cs typeface="Arial" panose="020B0604020202020204" pitchFamily="34" charset="0"/>
              </a:rPr>
              <a:t>Interaction</a:t>
            </a:r>
            <a:r>
              <a:rPr lang="it-IT" sz="1000" dirty="0">
                <a:latin typeface="Arial" panose="020B0604020202020204" pitchFamily="34" charset="0"/>
                <a:cs typeface="Arial" panose="020B0604020202020204" pitchFamily="34" charset="0"/>
              </a:rPr>
              <a:t> </a:t>
            </a:r>
            <a:r>
              <a:rPr lang="it-IT" sz="1000" dirty="0" err="1">
                <a:latin typeface="Arial" panose="020B0604020202020204" pitchFamily="34" charset="0"/>
                <a:cs typeface="Arial" panose="020B0604020202020204" pitchFamily="34" charset="0"/>
              </a:rPr>
              <a:t>times</a:t>
            </a:r>
            <a:r>
              <a:rPr lang="it-IT" sz="1000" dirty="0">
                <a:latin typeface="Arial" panose="020B0604020202020204" pitchFamily="34" charset="0"/>
                <a:cs typeface="Arial" panose="020B0604020202020204" pitchFamily="34" charset="0"/>
              </a:rPr>
              <a:t> </a:t>
            </a:r>
            <a:r>
              <a:rPr lang="it-IT" sz="1000" dirty="0" err="1">
                <a:latin typeface="Arial" panose="020B0604020202020204" pitchFamily="34" charset="0"/>
                <a:cs typeface="Arial" panose="020B0604020202020204" pitchFamily="34" charset="0"/>
              </a:rPr>
              <a:t>between</a:t>
            </a:r>
            <a:r>
              <a:rPr lang="it-IT" sz="1000" dirty="0">
                <a:latin typeface="Arial" panose="020B0604020202020204" pitchFamily="34" charset="0"/>
                <a:cs typeface="Arial" panose="020B0604020202020204" pitchFamily="34" charset="0"/>
              </a:rPr>
              <a:t> the </a:t>
            </a:r>
            <a:r>
              <a:rPr lang="it-IT" sz="1000" dirty="0" err="1">
                <a:latin typeface="Arial" panose="020B0604020202020204" pitchFamily="34" charset="0"/>
                <a:cs typeface="Arial" panose="020B0604020202020204" pitchFamily="34" charset="0"/>
              </a:rPr>
              <a:t>indicated</a:t>
            </a:r>
            <a:r>
              <a:rPr lang="it-IT" sz="1000" dirty="0">
                <a:latin typeface="Arial" panose="020B0604020202020204" pitchFamily="34" charset="0"/>
                <a:cs typeface="Arial" panose="020B0604020202020204" pitchFamily="34" charset="0"/>
              </a:rPr>
              <a:t> </a:t>
            </a:r>
            <a:r>
              <a:rPr lang="it-IT" sz="1000" dirty="0" err="1">
                <a:latin typeface="Arial" panose="020B0604020202020204" pitchFamily="34" charset="0"/>
                <a:cs typeface="Arial" panose="020B0604020202020204" pitchFamily="34" charset="0"/>
              </a:rPr>
              <a:t>EOs</a:t>
            </a:r>
            <a:r>
              <a:rPr lang="it-IT" sz="1000" dirty="0">
                <a:latin typeface="Arial" panose="020B0604020202020204" pitchFamily="34" charset="0"/>
                <a:cs typeface="Arial" panose="020B0604020202020204" pitchFamily="34" charset="0"/>
              </a:rPr>
              <a:t> and </a:t>
            </a:r>
            <a:r>
              <a:rPr lang="it-IT" sz="1000" dirty="0" err="1" smtClean="0">
                <a:latin typeface="Arial" panose="020B0604020202020204" pitchFamily="34" charset="0"/>
                <a:cs typeface="Arial" panose="020B0604020202020204" pitchFamily="34" charset="0"/>
              </a:rPr>
              <a:t>tumor</a:t>
            </a:r>
            <a:r>
              <a:rPr lang="it-IT" sz="1000" dirty="0" smtClean="0">
                <a:latin typeface="Arial" panose="020B0604020202020204" pitchFamily="34" charset="0"/>
                <a:cs typeface="Arial" panose="020B0604020202020204" pitchFamily="34" charset="0"/>
              </a:rPr>
              <a:t> </a:t>
            </a:r>
            <a:r>
              <a:rPr lang="it-IT" sz="1000" dirty="0" err="1" smtClean="0">
                <a:latin typeface="Arial" panose="020B0604020202020204" pitchFamily="34" charset="0"/>
                <a:cs typeface="Arial" panose="020B0604020202020204" pitchFamily="34" charset="0"/>
              </a:rPr>
              <a:t>cells</a:t>
            </a:r>
            <a:r>
              <a:rPr lang="it-IT" sz="1000" dirty="0" smtClean="0">
                <a:latin typeface="Arial" panose="020B0604020202020204" pitchFamily="34" charset="0"/>
                <a:cs typeface="Arial" panose="020B0604020202020204" pitchFamily="34" charset="0"/>
              </a:rPr>
              <a:t> </a:t>
            </a:r>
            <a:r>
              <a:rPr lang="it-IT" sz="1000" dirty="0" err="1" smtClean="0">
                <a:latin typeface="Arial" panose="020B0604020202020204" pitchFamily="34" charset="0"/>
                <a:cs typeface="Arial" panose="020B0604020202020204" pitchFamily="34" charset="0"/>
              </a:rPr>
              <a:t>processed</a:t>
            </a:r>
            <a:r>
              <a:rPr lang="it-IT" sz="1000" dirty="0" smtClean="0">
                <a:latin typeface="Arial" panose="020B0604020202020204" pitchFamily="34" charset="0"/>
                <a:cs typeface="Arial" panose="020B0604020202020204" pitchFamily="34" charset="0"/>
              </a:rPr>
              <a:t> </a:t>
            </a:r>
            <a:r>
              <a:rPr lang="it-IT" sz="1000" dirty="0">
                <a:latin typeface="Arial" panose="020B0604020202020204" pitchFamily="34" charset="0"/>
                <a:cs typeface="Arial" panose="020B0604020202020204" pitchFamily="34" charset="0"/>
              </a:rPr>
              <a:t>from </a:t>
            </a:r>
            <a:r>
              <a:rPr lang="it-IT" sz="1000" dirty="0" err="1">
                <a:latin typeface="Arial" panose="020B0604020202020204" pitchFamily="34" charset="0"/>
                <a:cs typeface="Arial" panose="020B0604020202020204" pitchFamily="34" charset="0"/>
              </a:rPr>
              <a:t>several</a:t>
            </a:r>
            <a:r>
              <a:rPr lang="it-IT" sz="1000" dirty="0">
                <a:latin typeface="Arial" panose="020B0604020202020204" pitchFamily="34" charset="0"/>
                <a:cs typeface="Arial" panose="020B0604020202020204" pitchFamily="34" charset="0"/>
              </a:rPr>
              <a:t> </a:t>
            </a:r>
            <a:r>
              <a:rPr lang="it-IT" sz="1000" dirty="0" err="1">
                <a:latin typeface="Arial" panose="020B0604020202020204" pitchFamily="34" charset="0"/>
                <a:cs typeface="Arial" panose="020B0604020202020204" pitchFamily="34" charset="0"/>
              </a:rPr>
              <a:t>regions</a:t>
            </a:r>
            <a:r>
              <a:rPr lang="it-IT" sz="1000" dirty="0">
                <a:latin typeface="Arial" panose="020B0604020202020204" pitchFamily="34" charset="0"/>
                <a:cs typeface="Arial" panose="020B0604020202020204" pitchFamily="34" charset="0"/>
              </a:rPr>
              <a:t> of the time </a:t>
            </a:r>
            <a:r>
              <a:rPr lang="it-IT" sz="1000" dirty="0" err="1" smtClean="0">
                <a:latin typeface="Arial" panose="020B0604020202020204" pitchFamily="34" charset="0"/>
                <a:cs typeface="Arial" panose="020B0604020202020204" pitchFamily="34" charset="0"/>
              </a:rPr>
              <a:t>lapse</a:t>
            </a:r>
            <a:r>
              <a:rPr lang="it-IT" sz="1000" dirty="0" smtClean="0">
                <a:latin typeface="Arial" panose="020B0604020202020204" pitchFamily="34" charset="0"/>
                <a:cs typeface="Arial" panose="020B0604020202020204" pitchFamily="34" charset="0"/>
              </a:rPr>
              <a:t> (</a:t>
            </a:r>
            <a:r>
              <a:rPr lang="it-IT" sz="1000" dirty="0" err="1" smtClean="0">
                <a:latin typeface="Arial" panose="020B0604020202020204" pitchFamily="34" charset="0"/>
                <a:cs typeface="Arial" panose="020B0604020202020204" pitchFamily="34" charset="0"/>
              </a:rPr>
              <a:t>mean±SD</a:t>
            </a:r>
            <a:r>
              <a:rPr lang="it-IT" sz="1000" dirty="0" smtClean="0">
                <a:latin typeface="Arial" panose="020B0604020202020204" pitchFamily="34" charset="0"/>
                <a:cs typeface="Arial" panose="020B0604020202020204" pitchFamily="34" charset="0"/>
              </a:rPr>
              <a:t>).  **P&lt;0.01.</a:t>
            </a:r>
            <a:endParaRPr lang="it-IT" sz="1000" dirty="0">
              <a:latin typeface="Arial" panose="020B0604020202020204" pitchFamily="34" charset="0"/>
              <a:cs typeface="Arial" panose="020B0604020202020204" pitchFamily="34" charset="0"/>
            </a:endParaRPr>
          </a:p>
        </p:txBody>
      </p:sp>
      <p:grpSp>
        <p:nvGrpSpPr>
          <p:cNvPr id="16" name="Gruppo 2"/>
          <p:cNvGrpSpPr>
            <a:grpSpLocks/>
          </p:cNvGrpSpPr>
          <p:nvPr/>
        </p:nvGrpSpPr>
        <p:grpSpPr bwMode="auto">
          <a:xfrm>
            <a:off x="4972012" y="1585100"/>
            <a:ext cx="382587" cy="246221"/>
            <a:chOff x="6548839" y="3797300"/>
            <a:chExt cx="382588" cy="246379"/>
          </a:xfrm>
        </p:grpSpPr>
        <p:cxnSp>
          <p:nvCxnSpPr>
            <p:cNvPr id="17" name="Connettore diritto 16"/>
            <p:cNvCxnSpPr/>
            <p:nvPr/>
          </p:nvCxnSpPr>
          <p:spPr bwMode="auto">
            <a:xfrm>
              <a:off x="6548839" y="3959329"/>
              <a:ext cx="382588" cy="0"/>
            </a:xfrm>
            <a:prstGeom prst="line">
              <a:avLst/>
            </a:prstGeom>
          </p:spPr>
          <p:style>
            <a:lnRef idx="1">
              <a:schemeClr val="dk1"/>
            </a:lnRef>
            <a:fillRef idx="0">
              <a:schemeClr val="dk1"/>
            </a:fillRef>
            <a:effectRef idx="0">
              <a:schemeClr val="dk1"/>
            </a:effectRef>
            <a:fontRef idx="minor">
              <a:schemeClr val="tx1"/>
            </a:fontRef>
          </p:style>
        </p:cxnSp>
        <p:sp>
          <p:nvSpPr>
            <p:cNvPr id="18" name="CasellaDiTesto 9"/>
            <p:cNvSpPr txBox="1">
              <a:spLocks noChangeArrowheads="1"/>
            </p:cNvSpPr>
            <p:nvPr/>
          </p:nvSpPr>
          <p:spPr bwMode="auto">
            <a:xfrm>
              <a:off x="6598107" y="3797300"/>
              <a:ext cx="284053" cy="24637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it-IT" altLang="it-IT" sz="1000" dirty="0" smtClean="0"/>
                <a:t>**</a:t>
              </a:r>
              <a:endParaRPr lang="it-IT" altLang="it-IT" sz="1000" dirty="0"/>
            </a:p>
          </p:txBody>
        </p:sp>
      </p:grpSp>
      <p:sp>
        <p:nvSpPr>
          <p:cNvPr id="19" name="CasellaDiTesto 18"/>
          <p:cNvSpPr txBox="1"/>
          <p:nvPr/>
        </p:nvSpPr>
        <p:spPr>
          <a:xfrm>
            <a:off x="3237325" y="3169558"/>
            <a:ext cx="817853" cy="261610"/>
          </a:xfrm>
          <a:prstGeom prst="rect">
            <a:avLst/>
          </a:prstGeom>
          <a:noFill/>
        </p:spPr>
        <p:txBody>
          <a:bodyPr wrap="none" rtlCol="0">
            <a:spAutoFit/>
          </a:bodyPr>
          <a:lstStyle/>
          <a:p>
            <a:r>
              <a:rPr lang="it-IT" sz="1100" dirty="0" smtClean="0"/>
              <a:t>X </a:t>
            </a:r>
            <a:r>
              <a:rPr lang="it-IT" sz="1100" dirty="0" err="1" smtClean="0"/>
              <a:t>axis</a:t>
            </a:r>
            <a:r>
              <a:rPr lang="it-IT" sz="1100" dirty="0" smtClean="0"/>
              <a:t> (</a:t>
            </a:r>
            <a:r>
              <a:rPr lang="it-IT" sz="1100" dirty="0" smtClean="0">
                <a:latin typeface="Symbol" panose="05050102010706020507" pitchFamily="18" charset="2"/>
              </a:rPr>
              <a:t>m</a:t>
            </a:r>
            <a:r>
              <a:rPr lang="it-IT" sz="1100" dirty="0" smtClean="0"/>
              <a:t>m)</a:t>
            </a:r>
            <a:endParaRPr lang="it-IT" sz="1100" dirty="0"/>
          </a:p>
        </p:txBody>
      </p:sp>
      <p:sp>
        <p:nvSpPr>
          <p:cNvPr id="20" name="CasellaDiTesto 19"/>
          <p:cNvSpPr txBox="1"/>
          <p:nvPr/>
        </p:nvSpPr>
        <p:spPr>
          <a:xfrm rot="16200000">
            <a:off x="70736" y="1633882"/>
            <a:ext cx="813043" cy="261610"/>
          </a:xfrm>
          <a:prstGeom prst="rect">
            <a:avLst/>
          </a:prstGeom>
          <a:noFill/>
        </p:spPr>
        <p:txBody>
          <a:bodyPr wrap="none" rtlCol="0">
            <a:spAutoFit/>
          </a:bodyPr>
          <a:lstStyle/>
          <a:p>
            <a:r>
              <a:rPr lang="it-IT" sz="1100" dirty="0"/>
              <a:t>Y</a:t>
            </a:r>
            <a:r>
              <a:rPr lang="it-IT" sz="1100" dirty="0" smtClean="0"/>
              <a:t> </a:t>
            </a:r>
            <a:r>
              <a:rPr lang="it-IT" sz="1100" dirty="0" err="1" smtClean="0"/>
              <a:t>axis</a:t>
            </a:r>
            <a:r>
              <a:rPr lang="it-IT" sz="1100" dirty="0" smtClean="0"/>
              <a:t> (</a:t>
            </a:r>
            <a:r>
              <a:rPr lang="it-IT" sz="1100" dirty="0" smtClean="0">
                <a:latin typeface="Symbol" panose="05050102010706020507" pitchFamily="18" charset="2"/>
              </a:rPr>
              <a:t>m</a:t>
            </a:r>
            <a:r>
              <a:rPr lang="it-IT" sz="1100" dirty="0" smtClean="0"/>
              <a:t>m)</a:t>
            </a:r>
            <a:endParaRPr lang="it-IT" sz="1100" dirty="0"/>
          </a:p>
        </p:txBody>
      </p:sp>
      <p:cxnSp>
        <p:nvCxnSpPr>
          <p:cNvPr id="21" name="Connettore 2 20"/>
          <p:cNvCxnSpPr/>
          <p:nvPr/>
        </p:nvCxnSpPr>
        <p:spPr>
          <a:xfrm>
            <a:off x="416297" y="3277267"/>
            <a:ext cx="2817989" cy="0"/>
          </a:xfrm>
          <a:prstGeom prst="straightConnector1">
            <a:avLst/>
          </a:prstGeom>
          <a:ln>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22" name="Connettore 2 21"/>
          <p:cNvCxnSpPr/>
          <p:nvPr/>
        </p:nvCxnSpPr>
        <p:spPr>
          <a:xfrm flipV="1">
            <a:off x="484877" y="2146934"/>
            <a:ext cx="0" cy="1224000"/>
          </a:xfrm>
          <a:prstGeom prst="straightConnector1">
            <a:avLst/>
          </a:prstGeom>
          <a:ln>
            <a:solidFill>
              <a:schemeClr val="tx1"/>
            </a:solidFill>
            <a:headEnd type="none" w="med" len="med"/>
            <a:tailEnd type="triangle" w="med" len="med"/>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537785521"/>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magine 3"/>
          <p:cNvPicPr>
            <a:picLocks noChangeAspect="1"/>
          </p:cNvPicPr>
          <p:nvPr/>
        </p:nvPicPr>
        <p:blipFill>
          <a:blip r:embed="rId3" cstate="print">
            <a:extLst>
              <a:ext uri="{BEBA8EAE-BF5A-486C-A8C5-ECC9F3942E4B}">
                <a14:imgProps xmlns:a14="http://schemas.microsoft.com/office/drawing/2010/main">
                  <a14:imgLayer r:embed="rId4">
                    <a14:imgEffect>
                      <a14:brightnessContrast bright="40000" contrast="40000"/>
                    </a14:imgEffect>
                  </a14:imgLayer>
                </a14:imgProps>
              </a:ext>
              <a:ext uri="{28A0092B-C50C-407E-A947-70E740481C1C}">
                <a14:useLocalDpi xmlns:a14="http://schemas.microsoft.com/office/drawing/2010/main" val="0"/>
              </a:ext>
            </a:extLst>
          </a:blip>
          <a:stretch>
            <a:fillRect/>
          </a:stretch>
        </p:blipFill>
        <p:spPr>
          <a:xfrm>
            <a:off x="1780103" y="2285946"/>
            <a:ext cx="1260000" cy="1260000"/>
          </a:xfrm>
          <a:prstGeom prst="rect">
            <a:avLst/>
          </a:prstGeom>
        </p:spPr>
      </p:pic>
      <p:pic>
        <p:nvPicPr>
          <p:cNvPr id="5" name="Immagine 4"/>
          <p:cNvPicPr>
            <a:picLocks noChangeAspect="1"/>
          </p:cNvPicPr>
          <p:nvPr/>
        </p:nvPicPr>
        <p:blipFill>
          <a:blip r:embed="rId5" cstate="print">
            <a:extLst>
              <a:ext uri="{BEBA8EAE-BF5A-486C-A8C5-ECC9F3942E4B}">
                <a14:imgProps xmlns:a14="http://schemas.microsoft.com/office/drawing/2010/main">
                  <a14:imgLayer r:embed="rId6">
                    <a14:imgEffect>
                      <a14:brightnessContrast bright="40000" contrast="40000"/>
                    </a14:imgEffect>
                  </a14:imgLayer>
                </a14:imgProps>
              </a:ext>
              <a:ext uri="{28A0092B-C50C-407E-A947-70E740481C1C}">
                <a14:useLocalDpi xmlns:a14="http://schemas.microsoft.com/office/drawing/2010/main" val="0"/>
              </a:ext>
            </a:extLst>
          </a:blip>
          <a:stretch>
            <a:fillRect/>
          </a:stretch>
        </p:blipFill>
        <p:spPr>
          <a:xfrm>
            <a:off x="4460198" y="2289873"/>
            <a:ext cx="1260000" cy="1260000"/>
          </a:xfrm>
          <a:prstGeom prst="rect">
            <a:avLst/>
          </a:prstGeom>
        </p:spPr>
      </p:pic>
      <p:cxnSp>
        <p:nvCxnSpPr>
          <p:cNvPr id="6" name="Connettore 1 83"/>
          <p:cNvCxnSpPr/>
          <p:nvPr/>
        </p:nvCxnSpPr>
        <p:spPr>
          <a:xfrm>
            <a:off x="1728496" y="1080343"/>
            <a:ext cx="414000"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7" name="Connettore 1 85"/>
          <p:cNvCxnSpPr/>
          <p:nvPr/>
        </p:nvCxnSpPr>
        <p:spPr>
          <a:xfrm>
            <a:off x="3706520" y="1080057"/>
            <a:ext cx="396000"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pic>
        <p:nvPicPr>
          <p:cNvPr id="9" name="Immagine 8"/>
          <p:cNvPicPr>
            <a:picLocks/>
          </p:cNvPicPr>
          <p:nvPr/>
        </p:nvPicPr>
        <p:blipFill>
          <a:blip r:embed="rId7" cstate="print">
            <a:extLst>
              <a:ext uri="{BEBA8EAE-BF5A-486C-A8C5-ECC9F3942E4B}">
                <a14:imgProps xmlns:a14="http://schemas.microsoft.com/office/drawing/2010/main">
                  <a14:imgLayer r:embed="rId8">
                    <a14:imgEffect>
                      <a14:brightnessContrast bright="40000" contrast="40000"/>
                    </a14:imgEffect>
                  </a14:imgLayer>
                </a14:imgProps>
              </a:ext>
              <a:ext uri="{28A0092B-C50C-407E-A947-70E740481C1C}">
                <a14:useLocalDpi xmlns:a14="http://schemas.microsoft.com/office/drawing/2010/main" val="0"/>
              </a:ext>
            </a:extLst>
          </a:blip>
          <a:stretch>
            <a:fillRect/>
          </a:stretch>
        </p:blipFill>
        <p:spPr>
          <a:xfrm>
            <a:off x="1778582" y="995228"/>
            <a:ext cx="1260000" cy="1260000"/>
          </a:xfrm>
          <a:prstGeom prst="rect">
            <a:avLst/>
          </a:prstGeom>
        </p:spPr>
      </p:pic>
      <p:pic>
        <p:nvPicPr>
          <p:cNvPr id="10" name="Immagine 9"/>
          <p:cNvPicPr>
            <a:picLocks/>
          </p:cNvPicPr>
          <p:nvPr/>
        </p:nvPicPr>
        <p:blipFill>
          <a:blip r:embed="rId9" cstate="print">
            <a:extLst>
              <a:ext uri="{BEBA8EAE-BF5A-486C-A8C5-ECC9F3942E4B}">
                <a14:imgProps xmlns:a14="http://schemas.microsoft.com/office/drawing/2010/main">
                  <a14:imgLayer r:embed="rId10">
                    <a14:imgEffect>
                      <a14:brightnessContrast bright="40000" contrast="40000"/>
                    </a14:imgEffect>
                  </a14:imgLayer>
                </a14:imgProps>
              </a:ext>
              <a:ext uri="{28A0092B-C50C-407E-A947-70E740481C1C}">
                <a14:useLocalDpi xmlns:a14="http://schemas.microsoft.com/office/drawing/2010/main" val="0"/>
              </a:ext>
            </a:extLst>
          </a:blip>
          <a:stretch>
            <a:fillRect/>
          </a:stretch>
        </p:blipFill>
        <p:spPr>
          <a:xfrm>
            <a:off x="490271" y="995228"/>
            <a:ext cx="1260000" cy="1260000"/>
          </a:xfrm>
          <a:prstGeom prst="rect">
            <a:avLst/>
          </a:prstGeom>
        </p:spPr>
      </p:pic>
      <p:pic>
        <p:nvPicPr>
          <p:cNvPr id="11" name="Immagine 10"/>
          <p:cNvPicPr>
            <a:picLocks/>
          </p:cNvPicPr>
          <p:nvPr/>
        </p:nvPicPr>
        <p:blipFill>
          <a:blip r:embed="rId11" cstate="print">
            <a:extLst>
              <a:ext uri="{BEBA8EAE-BF5A-486C-A8C5-ECC9F3942E4B}">
                <a14:imgProps xmlns:a14="http://schemas.microsoft.com/office/drawing/2010/main">
                  <a14:imgLayer r:embed="rId12">
                    <a14:imgEffect>
                      <a14:brightnessContrast bright="40000" contrast="40000"/>
                    </a14:imgEffect>
                  </a14:imgLayer>
                </a14:imgProps>
              </a:ext>
              <a:ext uri="{28A0092B-C50C-407E-A947-70E740481C1C}">
                <a14:useLocalDpi xmlns:a14="http://schemas.microsoft.com/office/drawing/2010/main" val="0"/>
              </a:ext>
            </a:extLst>
          </a:blip>
          <a:stretch>
            <a:fillRect/>
          </a:stretch>
        </p:blipFill>
        <p:spPr>
          <a:xfrm>
            <a:off x="4452137" y="995228"/>
            <a:ext cx="1260000" cy="1260000"/>
          </a:xfrm>
          <a:prstGeom prst="rect">
            <a:avLst/>
          </a:prstGeom>
        </p:spPr>
      </p:pic>
      <p:pic>
        <p:nvPicPr>
          <p:cNvPr id="12" name="Immagine 11"/>
          <p:cNvPicPr>
            <a:picLocks/>
          </p:cNvPicPr>
          <p:nvPr/>
        </p:nvPicPr>
        <p:blipFill>
          <a:blip r:embed="rId13" cstate="print">
            <a:extLst>
              <a:ext uri="{BEBA8EAE-BF5A-486C-A8C5-ECC9F3942E4B}">
                <a14:imgProps xmlns:a14="http://schemas.microsoft.com/office/drawing/2010/main">
                  <a14:imgLayer r:embed="rId14">
                    <a14:imgEffect>
                      <a14:brightnessContrast bright="40000" contrast="40000"/>
                    </a14:imgEffect>
                  </a14:imgLayer>
                </a14:imgProps>
              </a:ext>
              <a:ext uri="{28A0092B-C50C-407E-A947-70E740481C1C}">
                <a14:useLocalDpi xmlns:a14="http://schemas.microsoft.com/office/drawing/2010/main" val="0"/>
              </a:ext>
            </a:extLst>
          </a:blip>
          <a:stretch>
            <a:fillRect/>
          </a:stretch>
        </p:blipFill>
        <p:spPr>
          <a:xfrm>
            <a:off x="3164240" y="995228"/>
            <a:ext cx="1260000" cy="1260000"/>
          </a:xfrm>
          <a:prstGeom prst="rect">
            <a:avLst/>
          </a:prstGeom>
        </p:spPr>
      </p:pic>
      <p:sp>
        <p:nvSpPr>
          <p:cNvPr id="13" name="CasellaDiTesto 42"/>
          <p:cNvSpPr txBox="1">
            <a:spLocks noChangeArrowheads="1"/>
          </p:cNvSpPr>
          <p:nvPr/>
        </p:nvSpPr>
        <p:spPr bwMode="auto">
          <a:xfrm>
            <a:off x="1736940" y="986188"/>
            <a:ext cx="665568"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it-IT" altLang="it-IT" sz="800" b="1" dirty="0" smtClean="0">
                <a:solidFill>
                  <a:srgbClr val="00B050"/>
                </a:solidFill>
              </a:rPr>
              <a:t>EPX</a:t>
            </a:r>
            <a:r>
              <a:rPr lang="it-IT" altLang="it-IT" sz="800" b="1" dirty="0" smtClean="0"/>
              <a:t>/</a:t>
            </a:r>
            <a:r>
              <a:rPr lang="it-IT" altLang="it-IT" sz="800" b="1" dirty="0" smtClean="0">
                <a:solidFill>
                  <a:srgbClr val="0070C0"/>
                </a:solidFill>
              </a:rPr>
              <a:t>DAPI</a:t>
            </a:r>
            <a:endParaRPr lang="it-IT" altLang="it-IT" sz="800" b="1" dirty="0">
              <a:solidFill>
                <a:srgbClr val="0070C0"/>
              </a:solidFill>
            </a:endParaRPr>
          </a:p>
        </p:txBody>
      </p:sp>
      <p:sp>
        <p:nvSpPr>
          <p:cNvPr id="14" name="Text Box 20"/>
          <p:cNvSpPr txBox="1">
            <a:spLocks noChangeArrowheads="1"/>
          </p:cNvSpPr>
          <p:nvPr/>
        </p:nvSpPr>
        <p:spPr bwMode="auto">
          <a:xfrm>
            <a:off x="4097988" y="687350"/>
            <a:ext cx="702435"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pPr algn="ctr">
              <a:defRPr/>
            </a:pPr>
            <a:r>
              <a:rPr lang="it-IT" altLang="it-IT" sz="1000" dirty="0" smtClean="0">
                <a:latin typeface="Arial" panose="020B0604020202020204" pitchFamily="34" charset="0"/>
                <a:cs typeface="Arial" panose="020B0604020202020204" pitchFamily="34" charset="0"/>
              </a:rPr>
              <a:t>IL-33 EO</a:t>
            </a:r>
            <a:endParaRPr lang="it-IT" altLang="it-IT" sz="1000" dirty="0">
              <a:latin typeface="Arial" panose="020B0604020202020204" pitchFamily="34" charset="0"/>
              <a:cs typeface="Arial" panose="020B0604020202020204" pitchFamily="34" charset="0"/>
            </a:endParaRPr>
          </a:p>
        </p:txBody>
      </p:sp>
      <p:sp>
        <p:nvSpPr>
          <p:cNvPr id="15" name="Text Box 28"/>
          <p:cNvSpPr txBox="1">
            <a:spLocks noChangeArrowheads="1"/>
          </p:cNvSpPr>
          <p:nvPr/>
        </p:nvSpPr>
        <p:spPr bwMode="auto">
          <a:xfrm>
            <a:off x="1284031" y="684860"/>
            <a:ext cx="990892"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p>
            <a:pPr algn="ctr">
              <a:defRPr/>
            </a:pPr>
            <a:r>
              <a:rPr lang="it-IT" altLang="it-IT" sz="1000" dirty="0" smtClean="0">
                <a:latin typeface="Arial" panose="020B0604020202020204" pitchFamily="34" charset="0"/>
                <a:cs typeface="Arial" panose="020B0604020202020204" pitchFamily="34" charset="0"/>
              </a:rPr>
              <a:t>IL-5 EO</a:t>
            </a:r>
            <a:endParaRPr lang="it-IT" altLang="it-IT" sz="1000" dirty="0">
              <a:latin typeface="Arial" panose="020B0604020202020204" pitchFamily="34" charset="0"/>
              <a:cs typeface="Arial" panose="020B0604020202020204" pitchFamily="34" charset="0"/>
            </a:endParaRPr>
          </a:p>
        </p:txBody>
      </p:sp>
      <p:cxnSp>
        <p:nvCxnSpPr>
          <p:cNvPr id="16" name="Connettore 1 114"/>
          <p:cNvCxnSpPr/>
          <p:nvPr/>
        </p:nvCxnSpPr>
        <p:spPr>
          <a:xfrm>
            <a:off x="3617591" y="931072"/>
            <a:ext cx="16383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 name="Connettore 1 119"/>
          <p:cNvCxnSpPr/>
          <p:nvPr/>
        </p:nvCxnSpPr>
        <p:spPr>
          <a:xfrm>
            <a:off x="951292" y="931072"/>
            <a:ext cx="16383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8" name="CasellaDiTesto 42"/>
          <p:cNvSpPr txBox="1">
            <a:spLocks noChangeArrowheads="1"/>
          </p:cNvSpPr>
          <p:nvPr/>
        </p:nvSpPr>
        <p:spPr bwMode="auto">
          <a:xfrm>
            <a:off x="4419822" y="985253"/>
            <a:ext cx="665568"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it-IT" altLang="it-IT" sz="800" b="1" dirty="0" smtClean="0">
                <a:solidFill>
                  <a:srgbClr val="00B050"/>
                </a:solidFill>
              </a:rPr>
              <a:t>EPX</a:t>
            </a:r>
            <a:r>
              <a:rPr lang="it-IT" altLang="it-IT" sz="800" b="1" dirty="0" smtClean="0"/>
              <a:t>/</a:t>
            </a:r>
            <a:r>
              <a:rPr lang="it-IT" altLang="it-IT" sz="800" b="1" dirty="0" smtClean="0">
                <a:solidFill>
                  <a:srgbClr val="0070C0"/>
                </a:solidFill>
              </a:rPr>
              <a:t>DAPI</a:t>
            </a:r>
            <a:endParaRPr lang="it-IT" altLang="it-IT" sz="800" b="1" dirty="0">
              <a:solidFill>
                <a:srgbClr val="0070C0"/>
              </a:solidFill>
            </a:endParaRPr>
          </a:p>
        </p:txBody>
      </p:sp>
      <p:sp>
        <p:nvSpPr>
          <p:cNvPr id="19" name="Text Box 28"/>
          <p:cNvSpPr txBox="1">
            <a:spLocks noChangeArrowheads="1"/>
          </p:cNvSpPr>
          <p:nvPr/>
        </p:nvSpPr>
        <p:spPr bwMode="auto">
          <a:xfrm rot="16200000">
            <a:off x="-135259" y="1543150"/>
            <a:ext cx="990892"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p>
            <a:pPr algn="ctr">
              <a:defRPr/>
            </a:pPr>
            <a:r>
              <a:rPr lang="it-IT" altLang="it-IT" sz="1000" dirty="0" smtClean="0">
                <a:latin typeface="Arial" panose="020B0604020202020204" pitchFamily="34" charset="0"/>
                <a:cs typeface="Arial" panose="020B0604020202020204" pitchFamily="34" charset="0"/>
              </a:rPr>
              <a:t>EPX</a:t>
            </a:r>
            <a:endParaRPr lang="it-IT" altLang="it-IT" sz="1000" dirty="0">
              <a:latin typeface="Arial" panose="020B0604020202020204" pitchFamily="34" charset="0"/>
              <a:cs typeface="Arial" panose="020B0604020202020204" pitchFamily="34" charset="0"/>
            </a:endParaRPr>
          </a:p>
        </p:txBody>
      </p:sp>
      <p:sp>
        <p:nvSpPr>
          <p:cNvPr id="20" name="CasellaDiTesto 42"/>
          <p:cNvSpPr txBox="1">
            <a:spLocks noChangeArrowheads="1"/>
          </p:cNvSpPr>
          <p:nvPr/>
        </p:nvSpPr>
        <p:spPr bwMode="auto">
          <a:xfrm>
            <a:off x="1736940" y="2259950"/>
            <a:ext cx="670376"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it-IT" altLang="it-IT" sz="800" b="1" dirty="0" smtClean="0">
                <a:solidFill>
                  <a:srgbClr val="00B050"/>
                </a:solidFill>
              </a:rPr>
              <a:t>ECP</a:t>
            </a:r>
            <a:r>
              <a:rPr lang="it-IT" altLang="it-IT" sz="800" b="1" dirty="0" smtClean="0"/>
              <a:t>/</a:t>
            </a:r>
            <a:r>
              <a:rPr lang="it-IT" altLang="it-IT" sz="800" b="1" dirty="0" smtClean="0">
                <a:solidFill>
                  <a:srgbClr val="0070C0"/>
                </a:solidFill>
              </a:rPr>
              <a:t>DAPI</a:t>
            </a:r>
            <a:endParaRPr lang="it-IT" altLang="it-IT" sz="800" b="1" dirty="0">
              <a:solidFill>
                <a:srgbClr val="0070C0"/>
              </a:solidFill>
            </a:endParaRPr>
          </a:p>
        </p:txBody>
      </p:sp>
      <p:sp>
        <p:nvSpPr>
          <p:cNvPr id="21" name="CasellaDiTesto 42"/>
          <p:cNvSpPr txBox="1">
            <a:spLocks noChangeArrowheads="1"/>
          </p:cNvSpPr>
          <p:nvPr/>
        </p:nvSpPr>
        <p:spPr bwMode="auto">
          <a:xfrm>
            <a:off x="4419822" y="2271530"/>
            <a:ext cx="670376"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it-IT" altLang="it-IT" sz="800" b="1" dirty="0" smtClean="0">
                <a:solidFill>
                  <a:srgbClr val="00B050"/>
                </a:solidFill>
              </a:rPr>
              <a:t>ECP</a:t>
            </a:r>
            <a:r>
              <a:rPr lang="it-IT" altLang="it-IT" sz="800" b="1" dirty="0" smtClean="0"/>
              <a:t>/</a:t>
            </a:r>
            <a:r>
              <a:rPr lang="it-IT" altLang="it-IT" sz="800" b="1" dirty="0" smtClean="0">
                <a:solidFill>
                  <a:srgbClr val="0070C0"/>
                </a:solidFill>
              </a:rPr>
              <a:t>DAPI</a:t>
            </a:r>
            <a:endParaRPr lang="it-IT" altLang="it-IT" sz="800" b="1" dirty="0">
              <a:solidFill>
                <a:srgbClr val="0070C0"/>
              </a:solidFill>
            </a:endParaRPr>
          </a:p>
        </p:txBody>
      </p:sp>
      <p:sp>
        <p:nvSpPr>
          <p:cNvPr id="22" name="Text Box 28"/>
          <p:cNvSpPr txBox="1">
            <a:spLocks noChangeArrowheads="1"/>
          </p:cNvSpPr>
          <p:nvPr/>
        </p:nvSpPr>
        <p:spPr bwMode="auto">
          <a:xfrm rot="16200000">
            <a:off x="-131812" y="2798194"/>
            <a:ext cx="990892"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p>
            <a:pPr algn="ctr">
              <a:defRPr/>
            </a:pPr>
            <a:r>
              <a:rPr lang="it-IT" altLang="it-IT" sz="1000" dirty="0" smtClean="0">
                <a:latin typeface="Arial" panose="020B0604020202020204" pitchFamily="34" charset="0"/>
                <a:cs typeface="Arial" panose="020B0604020202020204" pitchFamily="34" charset="0"/>
              </a:rPr>
              <a:t>ECP</a:t>
            </a:r>
            <a:endParaRPr lang="it-IT" altLang="it-IT" sz="1000" dirty="0">
              <a:latin typeface="Arial" panose="020B0604020202020204" pitchFamily="34" charset="0"/>
              <a:cs typeface="Arial" panose="020B0604020202020204" pitchFamily="34" charset="0"/>
            </a:endParaRPr>
          </a:p>
        </p:txBody>
      </p:sp>
      <p:pic>
        <p:nvPicPr>
          <p:cNvPr id="23" name="Immagine 22"/>
          <p:cNvPicPr>
            <a:picLocks/>
          </p:cNvPicPr>
          <p:nvPr/>
        </p:nvPicPr>
        <p:blipFill>
          <a:blip r:embed="rId15" cstate="print">
            <a:extLst>
              <a:ext uri="{BEBA8EAE-BF5A-486C-A8C5-ECC9F3942E4B}">
                <a14:imgProps xmlns:a14="http://schemas.microsoft.com/office/drawing/2010/main">
                  <a14:imgLayer r:embed="rId16">
                    <a14:imgEffect>
                      <a14:brightnessContrast bright="40000" contrast="40000"/>
                    </a14:imgEffect>
                  </a14:imgLayer>
                </a14:imgProps>
              </a:ext>
              <a:ext uri="{28A0092B-C50C-407E-A947-70E740481C1C}">
                <a14:useLocalDpi xmlns:a14="http://schemas.microsoft.com/office/drawing/2010/main" val="0"/>
              </a:ext>
            </a:extLst>
          </a:blip>
          <a:stretch>
            <a:fillRect/>
          </a:stretch>
        </p:blipFill>
        <p:spPr>
          <a:xfrm>
            <a:off x="1780755" y="3587380"/>
            <a:ext cx="1260000" cy="1260000"/>
          </a:xfrm>
          <a:prstGeom prst="rect">
            <a:avLst/>
          </a:prstGeom>
        </p:spPr>
      </p:pic>
      <p:pic>
        <p:nvPicPr>
          <p:cNvPr id="24" name="Immagine 23"/>
          <p:cNvPicPr>
            <a:picLocks/>
          </p:cNvPicPr>
          <p:nvPr/>
        </p:nvPicPr>
        <p:blipFill>
          <a:blip r:embed="rId17" cstate="print">
            <a:extLst>
              <a:ext uri="{BEBA8EAE-BF5A-486C-A8C5-ECC9F3942E4B}">
                <a14:imgProps xmlns:a14="http://schemas.microsoft.com/office/drawing/2010/main">
                  <a14:imgLayer r:embed="rId18">
                    <a14:imgEffect>
                      <a14:brightnessContrast bright="40000" contrast="40000"/>
                    </a14:imgEffect>
                  </a14:imgLayer>
                </a14:imgProps>
              </a:ext>
              <a:ext uri="{28A0092B-C50C-407E-A947-70E740481C1C}">
                <a14:useLocalDpi xmlns:a14="http://schemas.microsoft.com/office/drawing/2010/main" val="0"/>
              </a:ext>
            </a:extLst>
          </a:blip>
          <a:stretch>
            <a:fillRect/>
          </a:stretch>
        </p:blipFill>
        <p:spPr>
          <a:xfrm>
            <a:off x="490271" y="3587380"/>
            <a:ext cx="1260000" cy="1260000"/>
          </a:xfrm>
          <a:prstGeom prst="rect">
            <a:avLst/>
          </a:prstGeom>
        </p:spPr>
      </p:pic>
      <p:pic>
        <p:nvPicPr>
          <p:cNvPr id="25" name="Immagine 24"/>
          <p:cNvPicPr>
            <a:picLocks/>
          </p:cNvPicPr>
          <p:nvPr/>
        </p:nvPicPr>
        <p:blipFill>
          <a:blip r:embed="rId19" cstate="print">
            <a:extLst>
              <a:ext uri="{BEBA8EAE-BF5A-486C-A8C5-ECC9F3942E4B}">
                <a14:imgProps xmlns:a14="http://schemas.microsoft.com/office/drawing/2010/main">
                  <a14:imgLayer r:embed="rId20">
                    <a14:imgEffect>
                      <a14:brightnessContrast bright="40000" contrast="40000"/>
                    </a14:imgEffect>
                  </a14:imgLayer>
                </a14:imgProps>
              </a:ext>
              <a:ext uri="{28A0092B-C50C-407E-A947-70E740481C1C}">
                <a14:useLocalDpi xmlns:a14="http://schemas.microsoft.com/office/drawing/2010/main" val="0"/>
              </a:ext>
            </a:extLst>
          </a:blip>
          <a:stretch>
            <a:fillRect/>
          </a:stretch>
        </p:blipFill>
        <p:spPr>
          <a:xfrm>
            <a:off x="4456471" y="3587380"/>
            <a:ext cx="1260000" cy="1260000"/>
          </a:xfrm>
          <a:prstGeom prst="rect">
            <a:avLst/>
          </a:prstGeom>
        </p:spPr>
      </p:pic>
      <p:pic>
        <p:nvPicPr>
          <p:cNvPr id="26" name="Immagine 25"/>
          <p:cNvPicPr>
            <a:picLocks/>
          </p:cNvPicPr>
          <p:nvPr/>
        </p:nvPicPr>
        <p:blipFill>
          <a:blip r:embed="rId21" cstate="print">
            <a:extLst>
              <a:ext uri="{BEBA8EAE-BF5A-486C-A8C5-ECC9F3942E4B}">
                <a14:imgProps xmlns:a14="http://schemas.microsoft.com/office/drawing/2010/main">
                  <a14:imgLayer r:embed="rId22">
                    <a14:imgEffect>
                      <a14:brightnessContrast bright="40000" contrast="40000"/>
                    </a14:imgEffect>
                  </a14:imgLayer>
                </a14:imgProps>
              </a:ext>
              <a:ext uri="{28A0092B-C50C-407E-A947-70E740481C1C}">
                <a14:useLocalDpi xmlns:a14="http://schemas.microsoft.com/office/drawing/2010/main" val="0"/>
              </a:ext>
            </a:extLst>
          </a:blip>
          <a:stretch>
            <a:fillRect/>
          </a:stretch>
        </p:blipFill>
        <p:spPr>
          <a:xfrm>
            <a:off x="3166574" y="3587380"/>
            <a:ext cx="1260000" cy="1260000"/>
          </a:xfrm>
          <a:prstGeom prst="rect">
            <a:avLst/>
          </a:prstGeom>
        </p:spPr>
      </p:pic>
      <p:sp>
        <p:nvSpPr>
          <p:cNvPr id="27" name="CasellaDiTesto 42"/>
          <p:cNvSpPr txBox="1">
            <a:spLocks noChangeArrowheads="1"/>
          </p:cNvSpPr>
          <p:nvPr/>
        </p:nvSpPr>
        <p:spPr bwMode="auto">
          <a:xfrm>
            <a:off x="1736940" y="3571882"/>
            <a:ext cx="737702"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it-IT" altLang="it-IT" sz="800" b="1" dirty="0" err="1" smtClean="0">
                <a:solidFill>
                  <a:srgbClr val="00B050"/>
                </a:solidFill>
              </a:rPr>
              <a:t>gzmB</a:t>
            </a:r>
            <a:r>
              <a:rPr lang="it-IT" altLang="it-IT" sz="800" b="1" dirty="0" smtClean="0"/>
              <a:t>/</a:t>
            </a:r>
            <a:r>
              <a:rPr lang="it-IT" altLang="it-IT" sz="800" b="1" dirty="0" smtClean="0">
                <a:solidFill>
                  <a:srgbClr val="0070C0"/>
                </a:solidFill>
              </a:rPr>
              <a:t>DAPI</a:t>
            </a:r>
            <a:endParaRPr lang="it-IT" altLang="it-IT" sz="800" b="1" dirty="0">
              <a:solidFill>
                <a:srgbClr val="0070C0"/>
              </a:solidFill>
            </a:endParaRPr>
          </a:p>
        </p:txBody>
      </p:sp>
      <p:sp>
        <p:nvSpPr>
          <p:cNvPr id="28" name="CasellaDiTesto 42"/>
          <p:cNvSpPr txBox="1">
            <a:spLocks noChangeArrowheads="1"/>
          </p:cNvSpPr>
          <p:nvPr/>
        </p:nvSpPr>
        <p:spPr bwMode="auto">
          <a:xfrm>
            <a:off x="4419822" y="3566716"/>
            <a:ext cx="737702"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it-IT" altLang="it-IT" sz="800" b="1" dirty="0" err="1" smtClean="0">
                <a:solidFill>
                  <a:srgbClr val="00B050"/>
                </a:solidFill>
              </a:rPr>
              <a:t>gzmB</a:t>
            </a:r>
            <a:r>
              <a:rPr lang="it-IT" altLang="it-IT" sz="800" b="1" dirty="0" smtClean="0"/>
              <a:t>/</a:t>
            </a:r>
            <a:r>
              <a:rPr lang="it-IT" altLang="it-IT" sz="800" b="1" dirty="0" smtClean="0">
                <a:solidFill>
                  <a:srgbClr val="0070C0"/>
                </a:solidFill>
              </a:rPr>
              <a:t>DAPI</a:t>
            </a:r>
            <a:endParaRPr lang="it-IT" altLang="it-IT" sz="800" b="1" dirty="0">
              <a:solidFill>
                <a:srgbClr val="0070C0"/>
              </a:solidFill>
            </a:endParaRPr>
          </a:p>
        </p:txBody>
      </p:sp>
      <p:sp>
        <p:nvSpPr>
          <p:cNvPr id="30" name="Text Box 28"/>
          <p:cNvSpPr txBox="1">
            <a:spLocks noChangeArrowheads="1"/>
          </p:cNvSpPr>
          <p:nvPr/>
        </p:nvSpPr>
        <p:spPr bwMode="auto">
          <a:xfrm rot="16200000">
            <a:off x="-137810" y="4103796"/>
            <a:ext cx="990892"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p>
            <a:pPr algn="ctr">
              <a:defRPr/>
            </a:pPr>
            <a:r>
              <a:rPr lang="it-IT" altLang="it-IT" sz="1000" dirty="0" smtClean="0">
                <a:latin typeface="Arial" panose="020B0604020202020204" pitchFamily="34" charset="0"/>
                <a:cs typeface="Arial" panose="020B0604020202020204" pitchFamily="34" charset="0"/>
              </a:rPr>
              <a:t>GZMB</a:t>
            </a:r>
            <a:endParaRPr lang="it-IT" altLang="it-IT" sz="1000" dirty="0">
              <a:latin typeface="Arial" panose="020B0604020202020204" pitchFamily="34" charset="0"/>
              <a:cs typeface="Arial" panose="020B0604020202020204" pitchFamily="34" charset="0"/>
            </a:endParaRPr>
          </a:p>
        </p:txBody>
      </p:sp>
      <p:pic>
        <p:nvPicPr>
          <p:cNvPr id="32" name="Immagine 31"/>
          <p:cNvPicPr>
            <a:picLocks noChangeAspect="1"/>
          </p:cNvPicPr>
          <p:nvPr/>
        </p:nvPicPr>
        <p:blipFill>
          <a:blip r:embed="rId23" cstate="print">
            <a:extLst>
              <a:ext uri="{BEBA8EAE-BF5A-486C-A8C5-ECC9F3942E4B}">
                <a14:imgProps xmlns:a14="http://schemas.microsoft.com/office/drawing/2010/main">
                  <a14:imgLayer r:embed="rId24">
                    <a14:imgEffect>
                      <a14:brightnessContrast bright="40000" contrast="40000"/>
                    </a14:imgEffect>
                  </a14:imgLayer>
                </a14:imgProps>
              </a:ext>
              <a:ext uri="{28A0092B-C50C-407E-A947-70E740481C1C}">
                <a14:useLocalDpi xmlns:a14="http://schemas.microsoft.com/office/drawing/2010/main" val="0"/>
              </a:ext>
            </a:extLst>
          </a:blip>
          <a:stretch>
            <a:fillRect/>
          </a:stretch>
        </p:blipFill>
        <p:spPr>
          <a:xfrm>
            <a:off x="486729" y="2285946"/>
            <a:ext cx="1260000" cy="1260000"/>
          </a:xfrm>
          <a:prstGeom prst="rect">
            <a:avLst/>
          </a:prstGeom>
        </p:spPr>
      </p:pic>
      <p:pic>
        <p:nvPicPr>
          <p:cNvPr id="33" name="Immagine 32"/>
          <p:cNvPicPr>
            <a:picLocks noChangeAspect="1"/>
          </p:cNvPicPr>
          <p:nvPr/>
        </p:nvPicPr>
        <p:blipFill>
          <a:blip r:embed="rId25" cstate="print">
            <a:extLst>
              <a:ext uri="{BEBA8EAE-BF5A-486C-A8C5-ECC9F3942E4B}">
                <a14:imgProps xmlns:a14="http://schemas.microsoft.com/office/drawing/2010/main">
                  <a14:imgLayer r:embed="rId26">
                    <a14:imgEffect>
                      <a14:brightnessContrast bright="40000" contrast="40000"/>
                    </a14:imgEffect>
                  </a14:imgLayer>
                </a14:imgProps>
              </a:ext>
              <a:ext uri="{28A0092B-C50C-407E-A947-70E740481C1C}">
                <a14:useLocalDpi xmlns:a14="http://schemas.microsoft.com/office/drawing/2010/main" val="0"/>
              </a:ext>
            </a:extLst>
          </a:blip>
          <a:stretch>
            <a:fillRect/>
          </a:stretch>
        </p:blipFill>
        <p:spPr>
          <a:xfrm>
            <a:off x="3164890" y="2293139"/>
            <a:ext cx="1260000" cy="1260000"/>
          </a:xfrm>
          <a:prstGeom prst="rect">
            <a:avLst/>
          </a:prstGeom>
        </p:spPr>
      </p:pic>
      <p:cxnSp>
        <p:nvCxnSpPr>
          <p:cNvPr id="34" name="Connettore 1 105"/>
          <p:cNvCxnSpPr/>
          <p:nvPr/>
        </p:nvCxnSpPr>
        <p:spPr>
          <a:xfrm>
            <a:off x="2713940" y="2196485"/>
            <a:ext cx="284400"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35" name="Connettore 1 106"/>
          <p:cNvCxnSpPr/>
          <p:nvPr/>
        </p:nvCxnSpPr>
        <p:spPr>
          <a:xfrm>
            <a:off x="5361503" y="2199395"/>
            <a:ext cx="284400"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36" name="Connettore 1 107"/>
          <p:cNvCxnSpPr/>
          <p:nvPr/>
        </p:nvCxnSpPr>
        <p:spPr>
          <a:xfrm>
            <a:off x="5361503" y="3496979"/>
            <a:ext cx="284400"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37" name="Connettore 1 109"/>
          <p:cNvCxnSpPr/>
          <p:nvPr/>
        </p:nvCxnSpPr>
        <p:spPr>
          <a:xfrm>
            <a:off x="2713940" y="3496979"/>
            <a:ext cx="284400"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38" name="Connettore 1 111"/>
          <p:cNvCxnSpPr/>
          <p:nvPr/>
        </p:nvCxnSpPr>
        <p:spPr>
          <a:xfrm>
            <a:off x="2713940" y="4790127"/>
            <a:ext cx="284400"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39" name="Connettore 1 112"/>
          <p:cNvCxnSpPr/>
          <p:nvPr/>
        </p:nvCxnSpPr>
        <p:spPr>
          <a:xfrm>
            <a:off x="5361503" y="4791946"/>
            <a:ext cx="284400"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sp>
        <p:nvSpPr>
          <p:cNvPr id="41" name="Rettangolo 40"/>
          <p:cNvSpPr/>
          <p:nvPr/>
        </p:nvSpPr>
        <p:spPr>
          <a:xfrm>
            <a:off x="39448" y="5409742"/>
            <a:ext cx="6063569" cy="707886"/>
          </a:xfrm>
          <a:prstGeom prst="rect">
            <a:avLst/>
          </a:prstGeom>
        </p:spPr>
        <p:txBody>
          <a:bodyPr wrap="square">
            <a:spAutoFit/>
          </a:bodyPr>
          <a:lstStyle/>
          <a:p>
            <a:pPr algn="just"/>
            <a:r>
              <a:rPr lang="en-US" sz="1000" b="1" dirty="0" smtClean="0">
                <a:latin typeface="Arial" panose="020B0604020202020204" pitchFamily="34" charset="0"/>
                <a:cs typeface="Arial" panose="020B0604020202020204" pitchFamily="34" charset="0"/>
              </a:rPr>
              <a:t>Figure S4</a:t>
            </a:r>
            <a:r>
              <a:rPr lang="en-US" sz="1000" b="1" dirty="0" smtClean="0">
                <a:latin typeface="Arial" panose="020B0604020202020204" pitchFamily="34" charset="0"/>
                <a:cs typeface="Arial" panose="020B0604020202020204" pitchFamily="34" charset="0"/>
              </a:rPr>
              <a:t>.</a:t>
            </a:r>
            <a:r>
              <a:rPr lang="en-US" sz="1000" dirty="0" smtClean="0">
                <a:latin typeface="Arial" panose="020B0604020202020204" pitchFamily="34" charset="0"/>
                <a:cs typeface="Arial" panose="020B0604020202020204" pitchFamily="34" charset="0"/>
              </a:rPr>
              <a:t> </a:t>
            </a:r>
            <a:r>
              <a:rPr lang="en-US" sz="1000" b="1" dirty="0">
                <a:latin typeface="Arial" panose="020B0604020202020204" pitchFamily="34" charset="0"/>
                <a:cs typeface="Arial" panose="020B0604020202020204" pitchFamily="34" charset="0"/>
              </a:rPr>
              <a:t>Detection of EPX, ECP and GZMB </a:t>
            </a:r>
            <a:r>
              <a:rPr lang="en-US" sz="1000" b="1" dirty="0" smtClean="0">
                <a:latin typeface="Arial" panose="020B0604020202020204" pitchFamily="34" charset="0"/>
                <a:cs typeface="Arial" panose="020B0604020202020204" pitchFamily="34" charset="0"/>
              </a:rPr>
              <a:t>expression in eosinophils by CLSM.</a:t>
            </a:r>
            <a:r>
              <a:rPr lang="en-US" sz="1000" dirty="0" smtClean="0">
                <a:latin typeface="Arial" panose="020B0604020202020204" pitchFamily="34" charset="0"/>
                <a:cs typeface="Arial" panose="020B0604020202020204" pitchFamily="34" charset="0"/>
              </a:rPr>
              <a:t> IL-5 EO and IL-33 EO were </a:t>
            </a:r>
            <a:r>
              <a:rPr lang="en-US" sz="1000" dirty="0">
                <a:latin typeface="Arial" panose="020B0604020202020204" pitchFamily="34" charset="0"/>
                <a:cs typeface="Arial" panose="020B0604020202020204" pitchFamily="34" charset="0"/>
              </a:rPr>
              <a:t>fixed, </a:t>
            </a:r>
            <a:r>
              <a:rPr lang="en-US" sz="1000" dirty="0" err="1">
                <a:latin typeface="Arial" panose="020B0604020202020204" pitchFamily="34" charset="0"/>
                <a:cs typeface="Arial" panose="020B0604020202020204" pitchFamily="34" charset="0"/>
              </a:rPr>
              <a:t>permeabilized</a:t>
            </a:r>
            <a:r>
              <a:rPr lang="en-US" sz="1000" dirty="0">
                <a:latin typeface="Arial" panose="020B0604020202020204" pitchFamily="34" charset="0"/>
                <a:cs typeface="Arial" panose="020B0604020202020204" pitchFamily="34" charset="0"/>
              </a:rPr>
              <a:t> and labelled for EPX, ECP or GZMB expression, all detected in green. DAPI was used to stain nuclei (blue). Scale bars, </a:t>
            </a:r>
            <a:r>
              <a:rPr lang="en-US" sz="1000" dirty="0" smtClean="0">
                <a:latin typeface="Arial" panose="020B0604020202020204" pitchFamily="34" charset="0"/>
                <a:cs typeface="Arial" panose="020B0604020202020204" pitchFamily="34" charset="0"/>
              </a:rPr>
              <a:t>20 µm</a:t>
            </a:r>
            <a:r>
              <a:rPr lang="en-US" sz="1000" dirty="0">
                <a:latin typeface="Arial" panose="020B0604020202020204" pitchFamily="34" charset="0"/>
                <a:cs typeface="Arial" panose="020B0604020202020204" pitchFamily="34" charset="0"/>
              </a:rPr>
              <a:t>. Images are representative of 5 independent experiments</a:t>
            </a:r>
            <a:r>
              <a:rPr lang="en-US" sz="1000" dirty="0" smtClean="0">
                <a:latin typeface="Arial" panose="020B0604020202020204" pitchFamily="34" charset="0"/>
                <a:cs typeface="Arial" panose="020B0604020202020204" pitchFamily="34" charset="0"/>
              </a:rPr>
              <a:t>.</a:t>
            </a:r>
            <a:endParaRPr lang="it-IT"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703313099"/>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0" name="Gruppo 9"/>
          <p:cNvGrpSpPr>
            <a:grpSpLocks noChangeAspect="1"/>
          </p:cNvGrpSpPr>
          <p:nvPr/>
        </p:nvGrpSpPr>
        <p:grpSpPr>
          <a:xfrm>
            <a:off x="625017" y="1434749"/>
            <a:ext cx="1742886" cy="1681429"/>
            <a:chOff x="254685" y="1096549"/>
            <a:chExt cx="2370346" cy="2286763"/>
          </a:xfrm>
        </p:grpSpPr>
        <p:pic>
          <p:nvPicPr>
            <p:cNvPr id="4" name="Picture 11"/>
            <p:cNvPicPr>
              <a:picLocks noChangeAspect="1" noChangeArrowheads="1"/>
            </p:cNvPicPr>
            <p:nvPr/>
          </p:nvPicPr>
          <p:blipFill>
            <a:blip r:embed="rId3">
              <a:extLst>
                <a:ext uri="{28A0092B-C50C-407E-A947-70E740481C1C}">
                  <a14:useLocalDpi xmlns:a14="http://schemas.microsoft.com/office/drawing/2010/main" val="0"/>
                </a:ext>
              </a:extLst>
            </a:blip>
            <a:srcRect r="11774"/>
            <a:stretch>
              <a:fillRect/>
            </a:stretch>
          </p:blipFill>
          <p:spPr bwMode="auto">
            <a:xfrm>
              <a:off x="254685" y="1096549"/>
              <a:ext cx="2370346" cy="228676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5" name="Text Box 12"/>
            <p:cNvSpPr txBox="1">
              <a:spLocks noChangeArrowheads="1"/>
            </p:cNvSpPr>
            <p:nvPr/>
          </p:nvSpPr>
          <p:spPr bwMode="auto">
            <a:xfrm>
              <a:off x="1899273" y="1854201"/>
              <a:ext cx="242888" cy="27463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pPr algn="ctr"/>
              <a:r>
                <a:rPr lang="it-IT" altLang="it-IT" sz="1200" dirty="0">
                  <a:latin typeface="Arial" panose="020B0604020202020204" pitchFamily="34" charset="0"/>
                  <a:cs typeface="Arial" panose="020B0604020202020204" pitchFamily="34" charset="0"/>
                </a:rPr>
                <a:t>*</a:t>
              </a:r>
            </a:p>
          </p:txBody>
        </p:sp>
      </p:grpSp>
      <p:grpSp>
        <p:nvGrpSpPr>
          <p:cNvPr id="13" name="Gruppo 12"/>
          <p:cNvGrpSpPr/>
          <p:nvPr/>
        </p:nvGrpSpPr>
        <p:grpSpPr>
          <a:xfrm>
            <a:off x="2680442" y="1292068"/>
            <a:ext cx="3047942" cy="1734860"/>
            <a:chOff x="2767903" y="1292068"/>
            <a:chExt cx="3047942" cy="1734860"/>
          </a:xfrm>
        </p:grpSpPr>
        <p:pic>
          <p:nvPicPr>
            <p:cNvPr id="6" name="Immagine 5"/>
            <p:cNvPicPr>
              <a:picLocks noChangeAspect="1"/>
            </p:cNvPicPr>
            <p:nvPr/>
          </p:nvPicPr>
          <p:blipFill rotWithShape="1">
            <a:blip r:embed="rId4"/>
            <a:srcRect t="10616"/>
            <a:stretch/>
          </p:blipFill>
          <p:spPr>
            <a:xfrm>
              <a:off x="2767903" y="1524000"/>
              <a:ext cx="1602857" cy="1502928"/>
            </a:xfrm>
            <a:prstGeom prst="rect">
              <a:avLst/>
            </a:prstGeom>
          </p:spPr>
        </p:pic>
        <p:pic>
          <p:nvPicPr>
            <p:cNvPr id="9" name="Immagine 8"/>
            <p:cNvPicPr>
              <a:picLocks noChangeAspect="1"/>
            </p:cNvPicPr>
            <p:nvPr/>
          </p:nvPicPr>
          <p:blipFill rotWithShape="1">
            <a:blip r:embed="rId5"/>
            <a:srcRect l="7541" t="10616"/>
            <a:stretch/>
          </p:blipFill>
          <p:spPr>
            <a:xfrm>
              <a:off x="4333868" y="1524000"/>
              <a:ext cx="1481977" cy="1502928"/>
            </a:xfrm>
            <a:prstGeom prst="rect">
              <a:avLst/>
            </a:prstGeom>
          </p:spPr>
        </p:pic>
        <p:sp>
          <p:nvSpPr>
            <p:cNvPr id="11" name="Text Box 28"/>
            <p:cNvSpPr txBox="1">
              <a:spLocks noChangeArrowheads="1"/>
            </p:cNvSpPr>
            <p:nvPr/>
          </p:nvSpPr>
          <p:spPr bwMode="auto">
            <a:xfrm>
              <a:off x="3417561" y="1292068"/>
              <a:ext cx="492454" cy="246221"/>
            </a:xfrm>
            <a:prstGeom prst="rect">
              <a:avLst/>
            </a:prstGeom>
            <a:solidFill>
              <a:schemeClr val="bg1"/>
            </a:solidFill>
            <a:ln>
              <a:noFill/>
            </a:ln>
            <a:effectLst/>
            <a:extLst/>
          </p:spPr>
          <p:txBody>
            <a:bodyPr wrap="square">
              <a:spAutoFit/>
            </a:bodyPr>
            <a:lstStyle/>
            <a:p>
              <a:pPr algn="ctr">
                <a:defRPr/>
              </a:pPr>
              <a:r>
                <a:rPr lang="it-IT" altLang="it-IT" sz="1000" dirty="0" smtClean="0">
                  <a:latin typeface="Arial" panose="020B0604020202020204" pitchFamily="34" charset="0"/>
                  <a:cs typeface="Arial" panose="020B0604020202020204" pitchFamily="34" charset="0"/>
                </a:rPr>
                <a:t>CTR</a:t>
              </a:r>
              <a:endParaRPr lang="it-IT" altLang="it-IT" sz="1000" dirty="0">
                <a:latin typeface="Arial" panose="020B0604020202020204" pitchFamily="34" charset="0"/>
                <a:cs typeface="Arial" panose="020B0604020202020204" pitchFamily="34" charset="0"/>
              </a:endParaRPr>
            </a:p>
          </p:txBody>
        </p:sp>
        <p:sp>
          <p:nvSpPr>
            <p:cNvPr id="12" name="Text Box 28"/>
            <p:cNvSpPr txBox="1">
              <a:spLocks noChangeArrowheads="1"/>
            </p:cNvSpPr>
            <p:nvPr/>
          </p:nvSpPr>
          <p:spPr bwMode="auto">
            <a:xfrm>
              <a:off x="4856601" y="1292068"/>
              <a:ext cx="492454" cy="246221"/>
            </a:xfrm>
            <a:prstGeom prst="rect">
              <a:avLst/>
            </a:prstGeom>
            <a:solidFill>
              <a:schemeClr val="bg1"/>
            </a:solidFill>
            <a:ln>
              <a:noFill/>
            </a:ln>
            <a:effectLst/>
            <a:extLst/>
          </p:spPr>
          <p:txBody>
            <a:bodyPr wrap="square">
              <a:spAutoFit/>
            </a:bodyPr>
            <a:lstStyle/>
            <a:p>
              <a:pPr algn="ctr">
                <a:defRPr/>
              </a:pPr>
              <a:r>
                <a:rPr lang="it-IT" altLang="it-IT" sz="1000" dirty="0" smtClean="0">
                  <a:latin typeface="Arial" panose="020B0604020202020204" pitchFamily="34" charset="0"/>
                  <a:cs typeface="Arial" panose="020B0604020202020204" pitchFamily="34" charset="0"/>
                </a:rPr>
                <a:t>IL-33</a:t>
              </a:r>
              <a:endParaRPr lang="it-IT" altLang="it-IT" sz="1000" dirty="0">
                <a:latin typeface="Arial" panose="020B0604020202020204" pitchFamily="34" charset="0"/>
                <a:cs typeface="Arial" panose="020B0604020202020204" pitchFamily="34" charset="0"/>
              </a:endParaRPr>
            </a:p>
          </p:txBody>
        </p:sp>
      </p:grpSp>
      <p:sp>
        <p:nvSpPr>
          <p:cNvPr id="17" name="Rettangolo 16"/>
          <p:cNvSpPr/>
          <p:nvPr/>
        </p:nvSpPr>
        <p:spPr>
          <a:xfrm>
            <a:off x="29923" y="3566449"/>
            <a:ext cx="6063569" cy="1169551"/>
          </a:xfrm>
          <a:prstGeom prst="rect">
            <a:avLst/>
          </a:prstGeom>
        </p:spPr>
        <p:txBody>
          <a:bodyPr wrap="square">
            <a:spAutoFit/>
          </a:bodyPr>
          <a:lstStyle/>
          <a:p>
            <a:pPr algn="just"/>
            <a:r>
              <a:rPr lang="en-US" sz="1000" b="1" dirty="0" smtClean="0">
                <a:latin typeface="Arial" panose="020B0604020202020204" pitchFamily="34" charset="0"/>
                <a:cs typeface="Arial" panose="020B0604020202020204" pitchFamily="34" charset="0"/>
              </a:rPr>
              <a:t>Figure S5</a:t>
            </a:r>
            <a:r>
              <a:rPr lang="en-US" sz="1000" b="1" dirty="0" smtClean="0">
                <a:latin typeface="Arial" panose="020B0604020202020204" pitchFamily="34" charset="0"/>
                <a:cs typeface="Arial" panose="020B0604020202020204" pitchFamily="34" charset="0"/>
              </a:rPr>
              <a:t>. Recruitment of tumor-infiltrating eosinophils following IL-33 exposure </a:t>
            </a:r>
            <a:r>
              <a:rPr lang="en-US" sz="1000" b="1" i="1" dirty="0" smtClean="0">
                <a:latin typeface="Arial" panose="020B0604020202020204" pitchFamily="34" charset="0"/>
                <a:cs typeface="Arial" panose="020B0604020202020204" pitchFamily="34" charset="0"/>
              </a:rPr>
              <a:t>in vivo</a:t>
            </a:r>
            <a:r>
              <a:rPr lang="en-US" sz="1000" b="1" dirty="0" smtClean="0">
                <a:latin typeface="Arial" panose="020B0604020202020204" pitchFamily="34" charset="0"/>
                <a:cs typeface="Arial" panose="020B0604020202020204" pitchFamily="34" charset="0"/>
              </a:rPr>
              <a:t>.</a:t>
            </a:r>
            <a:r>
              <a:rPr lang="en-US" sz="1000" dirty="0" smtClean="0">
                <a:latin typeface="Arial" panose="020B0604020202020204" pitchFamily="34" charset="0"/>
                <a:cs typeface="Arial" panose="020B0604020202020204" pitchFamily="34" charset="0"/>
              </a:rPr>
              <a:t> C57Bl/6 mice were implanted subcutaneously with B16.F10 melanoma cells (8 x 10</a:t>
            </a:r>
            <a:r>
              <a:rPr lang="en-US" sz="1000" baseline="30000" dirty="0" smtClean="0">
                <a:latin typeface="Arial" panose="020B0604020202020204" pitchFamily="34" charset="0"/>
                <a:cs typeface="Arial" panose="020B0604020202020204" pitchFamily="34" charset="0"/>
              </a:rPr>
              <a:t>5</a:t>
            </a:r>
            <a:r>
              <a:rPr lang="en-US" sz="1000" dirty="0" smtClean="0">
                <a:latin typeface="Arial" panose="020B0604020202020204" pitchFamily="34" charset="0"/>
                <a:cs typeface="Arial" panose="020B0604020202020204" pitchFamily="34" charset="0"/>
              </a:rPr>
              <a:t> cells/mouse) and then treated by repeated intraperitoneal injections with IL-33 (0,4 µg/mouse). (</a:t>
            </a:r>
            <a:r>
              <a:rPr lang="en-US" sz="1000" b="1" dirty="0" smtClean="0">
                <a:latin typeface="Arial" panose="020B0604020202020204" pitchFamily="34" charset="0"/>
                <a:cs typeface="Arial" panose="020B0604020202020204" pitchFamily="34" charset="0"/>
              </a:rPr>
              <a:t>A</a:t>
            </a:r>
            <a:r>
              <a:rPr lang="en-US" sz="1000" dirty="0" smtClean="0">
                <a:latin typeface="Arial" panose="020B0604020202020204" pitchFamily="34" charset="0"/>
                <a:cs typeface="Arial" panose="020B0604020202020204" pitchFamily="34" charset="0"/>
              </a:rPr>
              <a:t>)</a:t>
            </a:r>
            <a:r>
              <a:rPr lang="en-US" sz="1000" b="1" dirty="0" smtClean="0">
                <a:latin typeface="Arial" panose="020B0604020202020204" pitchFamily="34" charset="0"/>
                <a:cs typeface="Arial" panose="020B0604020202020204" pitchFamily="34" charset="0"/>
              </a:rPr>
              <a:t> </a:t>
            </a:r>
            <a:r>
              <a:rPr lang="en-US" sz="1000" dirty="0" smtClean="0">
                <a:latin typeface="Arial" panose="020B0604020202020204" pitchFamily="34" charset="0"/>
                <a:cs typeface="Arial" panose="020B0604020202020204" pitchFamily="34" charset="0"/>
              </a:rPr>
              <a:t>Tumor growth curve. Mean tumor diameter for individual mice (n=6) ±SEM is shown. *P&lt;0,05. (</a:t>
            </a:r>
            <a:r>
              <a:rPr lang="en-US" sz="1000" b="1" dirty="0" smtClean="0">
                <a:latin typeface="Arial" panose="020B0604020202020204" pitchFamily="34" charset="0"/>
                <a:cs typeface="Arial" panose="020B0604020202020204" pitchFamily="34" charset="0"/>
              </a:rPr>
              <a:t>B</a:t>
            </a:r>
            <a:r>
              <a:rPr lang="en-US" sz="1000" dirty="0" smtClean="0">
                <a:latin typeface="Arial" panose="020B0604020202020204" pitchFamily="34" charset="0"/>
                <a:cs typeface="Arial" panose="020B0604020202020204" pitchFamily="34" charset="0"/>
              </a:rPr>
              <a:t>)</a:t>
            </a:r>
            <a:r>
              <a:rPr lang="en-US" sz="1000" b="1" dirty="0" smtClean="0">
                <a:latin typeface="Arial" panose="020B0604020202020204" pitchFamily="34" charset="0"/>
                <a:cs typeface="Arial" panose="020B0604020202020204" pitchFamily="34" charset="0"/>
              </a:rPr>
              <a:t> </a:t>
            </a:r>
            <a:r>
              <a:rPr lang="en-US" sz="1000" dirty="0" smtClean="0">
                <a:latin typeface="Arial" panose="020B0604020202020204" pitchFamily="34" charset="0"/>
                <a:cs typeface="Arial" panose="020B0604020202020204" pitchFamily="34" charset="0"/>
              </a:rPr>
              <a:t>Three days after the last administration of IL-33 (day 16) mice were sacrificed and tumor excised. Pooled cell suspensions were stained with fluorescence labelled antibodies and </a:t>
            </a:r>
            <a:r>
              <a:rPr lang="en-US" sz="1000" dirty="0" err="1" smtClean="0">
                <a:latin typeface="Arial" panose="020B0604020202020204" pitchFamily="34" charset="0"/>
                <a:cs typeface="Arial" panose="020B0604020202020204" pitchFamily="34" charset="0"/>
              </a:rPr>
              <a:t>analysed</a:t>
            </a:r>
            <a:r>
              <a:rPr lang="en-US" sz="1000" dirty="0" smtClean="0">
                <a:latin typeface="Arial" panose="020B0604020202020204" pitchFamily="34" charset="0"/>
                <a:cs typeface="Arial" panose="020B0604020202020204" pitchFamily="34" charset="0"/>
              </a:rPr>
              <a:t> by FACS. Plots show percentages of Siglec-F</a:t>
            </a:r>
            <a:r>
              <a:rPr lang="en-US" sz="1000" baseline="30000" dirty="0" smtClean="0">
                <a:latin typeface="Arial" panose="020B0604020202020204" pitchFamily="34" charset="0"/>
                <a:cs typeface="Arial" panose="020B0604020202020204" pitchFamily="34" charset="0"/>
              </a:rPr>
              <a:t>+</a:t>
            </a:r>
            <a:r>
              <a:rPr lang="en-US" sz="1000" dirty="0" smtClean="0">
                <a:latin typeface="Arial" panose="020B0604020202020204" pitchFamily="34" charset="0"/>
                <a:cs typeface="Arial" panose="020B0604020202020204" pitchFamily="34" charset="0"/>
              </a:rPr>
              <a:t>CD11b</a:t>
            </a:r>
            <a:r>
              <a:rPr lang="en-US" sz="1000" baseline="30000" dirty="0" smtClean="0">
                <a:latin typeface="Arial" panose="020B0604020202020204" pitchFamily="34" charset="0"/>
                <a:cs typeface="Arial" panose="020B0604020202020204" pitchFamily="34" charset="0"/>
              </a:rPr>
              <a:t>+</a:t>
            </a:r>
            <a:r>
              <a:rPr lang="en-US" sz="1000" dirty="0" smtClean="0">
                <a:latin typeface="Arial" panose="020B0604020202020204" pitchFamily="34" charset="0"/>
                <a:cs typeface="Arial" panose="020B0604020202020204" pitchFamily="34" charset="0"/>
              </a:rPr>
              <a:t> eosinophils in gated CD45</a:t>
            </a:r>
            <a:r>
              <a:rPr lang="en-US" sz="1000" baseline="30000" dirty="0" smtClean="0">
                <a:latin typeface="Arial" panose="020B0604020202020204" pitchFamily="34" charset="0"/>
                <a:cs typeface="Arial" panose="020B0604020202020204" pitchFamily="34" charset="0"/>
              </a:rPr>
              <a:t>+</a:t>
            </a:r>
            <a:r>
              <a:rPr lang="en-US" sz="1000" dirty="0" smtClean="0">
                <a:latin typeface="Arial" panose="020B0604020202020204" pitchFamily="34" charset="0"/>
                <a:cs typeface="Arial" panose="020B0604020202020204" pitchFamily="34" charset="0"/>
              </a:rPr>
              <a:t> population. One representative experiment out of 10 is shown. </a:t>
            </a:r>
            <a:endParaRPr lang="en-US" sz="1000" dirty="0">
              <a:latin typeface="Arial" panose="020B0604020202020204" pitchFamily="34" charset="0"/>
              <a:cs typeface="Arial" panose="020B0604020202020204" pitchFamily="34" charset="0"/>
            </a:endParaRPr>
          </a:p>
        </p:txBody>
      </p:sp>
      <p:sp>
        <p:nvSpPr>
          <p:cNvPr id="16" name="CasellaDiTesto 16"/>
          <p:cNvSpPr txBox="1"/>
          <p:nvPr/>
        </p:nvSpPr>
        <p:spPr>
          <a:xfrm>
            <a:off x="2416205" y="1065834"/>
            <a:ext cx="332142" cy="338554"/>
          </a:xfrm>
          <a:prstGeom prst="rect">
            <a:avLst/>
          </a:prstGeom>
          <a:noFill/>
        </p:spPr>
        <p:txBody>
          <a:bodyPr wrap="none" rtlCol="0">
            <a:spAutoFit/>
          </a:bodyPr>
          <a:lst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it-IT" sz="1600" b="1" dirty="0">
                <a:latin typeface="Arial" panose="020B0604020202020204" pitchFamily="34" charset="0"/>
                <a:cs typeface="Arial" panose="020B0604020202020204" pitchFamily="34" charset="0"/>
              </a:rPr>
              <a:t>B</a:t>
            </a:r>
          </a:p>
        </p:txBody>
      </p:sp>
      <p:sp>
        <p:nvSpPr>
          <p:cNvPr id="18" name="CasellaDiTesto 26"/>
          <p:cNvSpPr txBox="1"/>
          <p:nvPr/>
        </p:nvSpPr>
        <p:spPr>
          <a:xfrm>
            <a:off x="352514" y="1065834"/>
            <a:ext cx="332142" cy="338554"/>
          </a:xfrm>
          <a:prstGeom prst="rect">
            <a:avLst/>
          </a:prstGeom>
          <a:noFill/>
        </p:spPr>
        <p:txBody>
          <a:bodyPr wrap="none" rtlCol="0">
            <a:spAutoFit/>
          </a:bodyPr>
          <a:lst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it-IT" sz="1600" b="1" dirty="0">
                <a:latin typeface="Arial" panose="020B0604020202020204" pitchFamily="34" charset="0"/>
                <a:cs typeface="Arial" panose="020B0604020202020204" pitchFamily="34" charset="0"/>
              </a:rPr>
              <a:t>A</a:t>
            </a:r>
          </a:p>
        </p:txBody>
      </p:sp>
    </p:spTree>
    <p:extLst>
      <p:ext uri="{BB962C8B-B14F-4D97-AF65-F5344CB8AC3E}">
        <p14:creationId xmlns:p14="http://schemas.microsoft.com/office/powerpoint/2010/main" val="3324676194"/>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Immagine 9"/>
          <p:cNvPicPr>
            <a:picLocks/>
          </p:cNvPicPr>
          <p:nvPr/>
        </p:nvPicPr>
        <p:blipFill>
          <a:blip r:embed="rId3" cstate="print">
            <a:extLst>
              <a:ext uri="{BEBA8EAE-BF5A-486C-A8C5-ECC9F3942E4B}">
                <a14:imgProps xmlns:a14="http://schemas.microsoft.com/office/drawing/2010/main">
                  <a14:imgLayer r:embed="rId4">
                    <a14:imgEffect>
                      <a14:brightnessContrast bright="14000" contrast="18000"/>
                    </a14:imgEffect>
                  </a14:imgLayer>
                </a14:imgProps>
              </a:ext>
              <a:ext uri="{28A0092B-C50C-407E-A947-70E740481C1C}">
                <a14:useLocalDpi xmlns:a14="http://schemas.microsoft.com/office/drawing/2010/main" val="0"/>
              </a:ext>
            </a:extLst>
          </a:blip>
          <a:stretch>
            <a:fillRect/>
          </a:stretch>
        </p:blipFill>
        <p:spPr>
          <a:xfrm>
            <a:off x="1784815" y="2198812"/>
            <a:ext cx="1381375" cy="1381375"/>
          </a:xfrm>
          <a:prstGeom prst="rect">
            <a:avLst/>
          </a:prstGeom>
        </p:spPr>
      </p:pic>
      <p:pic>
        <p:nvPicPr>
          <p:cNvPr id="8" name="Immagine 7"/>
          <p:cNvPicPr>
            <a:picLocks/>
          </p:cNvPicPr>
          <p:nvPr/>
        </p:nvPicPr>
        <p:blipFill>
          <a:blip r:embed="rId5" cstate="print">
            <a:extLst>
              <a:ext uri="{BEBA8EAE-BF5A-486C-A8C5-ECC9F3942E4B}">
                <a14:imgProps xmlns:a14="http://schemas.microsoft.com/office/drawing/2010/main">
                  <a14:imgLayer r:embed="rId6">
                    <a14:imgEffect>
                      <a14:brightnessContrast bright="12000" contrast="8000"/>
                    </a14:imgEffect>
                  </a14:imgLayer>
                </a14:imgProps>
              </a:ext>
              <a:ext uri="{28A0092B-C50C-407E-A947-70E740481C1C}">
                <a14:useLocalDpi xmlns:a14="http://schemas.microsoft.com/office/drawing/2010/main" val="0"/>
              </a:ext>
            </a:extLst>
          </a:blip>
          <a:stretch>
            <a:fillRect/>
          </a:stretch>
        </p:blipFill>
        <p:spPr>
          <a:xfrm>
            <a:off x="4605416" y="2198812"/>
            <a:ext cx="1381375" cy="1381375"/>
          </a:xfrm>
          <a:prstGeom prst="rect">
            <a:avLst/>
          </a:prstGeom>
        </p:spPr>
      </p:pic>
      <p:sp>
        <p:nvSpPr>
          <p:cNvPr id="44" name="Text Box 20"/>
          <p:cNvSpPr txBox="1">
            <a:spLocks noChangeArrowheads="1"/>
          </p:cNvSpPr>
          <p:nvPr/>
        </p:nvSpPr>
        <p:spPr bwMode="auto">
          <a:xfrm rot="16200000">
            <a:off x="-85309" y="3440380"/>
            <a:ext cx="479619" cy="24391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pPr algn="ctr">
              <a:defRPr/>
            </a:pPr>
            <a:r>
              <a:rPr lang="it-IT" altLang="it-IT" sz="1000" dirty="0">
                <a:latin typeface="Arial" panose="020B0604020202020204" pitchFamily="34" charset="0"/>
                <a:cs typeface="Arial" panose="020B0604020202020204" pitchFamily="34" charset="0"/>
              </a:rPr>
              <a:t>IL-33</a:t>
            </a:r>
          </a:p>
        </p:txBody>
      </p:sp>
      <p:sp>
        <p:nvSpPr>
          <p:cNvPr id="163" name="CasellaDiTesto 8"/>
          <p:cNvSpPr txBox="1"/>
          <p:nvPr/>
        </p:nvSpPr>
        <p:spPr>
          <a:xfrm>
            <a:off x="786611" y="522781"/>
            <a:ext cx="482824" cy="246221"/>
          </a:xfrm>
          <a:prstGeom prst="rect">
            <a:avLst/>
          </a:prstGeom>
          <a:noFill/>
        </p:spPr>
        <p:txBody>
          <a:bodyPr wrap="none" rtlCol="0">
            <a:spAutoFit/>
          </a:bodyPr>
          <a:lst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it-IT" sz="1000" dirty="0">
                <a:solidFill>
                  <a:srgbClr val="0070C0"/>
                </a:solidFill>
                <a:latin typeface="Arial" panose="020B0604020202020204" pitchFamily="34" charset="0"/>
                <a:cs typeface="Arial" panose="020B0604020202020204" pitchFamily="34" charset="0"/>
              </a:rPr>
              <a:t>DAPI</a:t>
            </a:r>
          </a:p>
        </p:txBody>
      </p:sp>
      <p:sp>
        <p:nvSpPr>
          <p:cNvPr id="164" name="CasellaDiTesto 8"/>
          <p:cNvSpPr txBox="1"/>
          <p:nvPr/>
        </p:nvSpPr>
        <p:spPr>
          <a:xfrm>
            <a:off x="3485119" y="523777"/>
            <a:ext cx="774571" cy="246221"/>
          </a:xfrm>
          <a:prstGeom prst="rect">
            <a:avLst/>
          </a:prstGeom>
          <a:noFill/>
        </p:spPr>
        <p:txBody>
          <a:bodyPr wrap="none" rtlCol="0">
            <a:spAutoFit/>
          </a:bodyPr>
          <a:lst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it-IT" sz="1000" dirty="0" smtClean="0">
                <a:solidFill>
                  <a:srgbClr val="FF0000"/>
                </a:solidFill>
                <a:latin typeface="Arial" panose="020B0604020202020204" pitchFamily="34" charset="0"/>
                <a:cs typeface="Arial" panose="020B0604020202020204" pitchFamily="34" charset="0"/>
              </a:rPr>
              <a:t>SIGLEC-F</a:t>
            </a:r>
            <a:endParaRPr lang="it-IT" sz="1000" dirty="0">
              <a:solidFill>
                <a:srgbClr val="FF0000"/>
              </a:solidFill>
              <a:latin typeface="Arial" panose="020B0604020202020204" pitchFamily="34" charset="0"/>
              <a:cs typeface="Arial" panose="020B0604020202020204" pitchFamily="34" charset="0"/>
            </a:endParaRPr>
          </a:p>
        </p:txBody>
      </p:sp>
      <p:sp>
        <p:nvSpPr>
          <p:cNvPr id="165" name="CasellaDiTesto 8"/>
          <p:cNvSpPr txBox="1"/>
          <p:nvPr/>
        </p:nvSpPr>
        <p:spPr>
          <a:xfrm>
            <a:off x="2305867" y="522689"/>
            <a:ext cx="439544" cy="246221"/>
          </a:xfrm>
          <a:prstGeom prst="rect">
            <a:avLst/>
          </a:prstGeom>
          <a:noFill/>
        </p:spPr>
        <p:txBody>
          <a:bodyPr wrap="none" rtlCol="0">
            <a:spAutoFit/>
          </a:bodyPr>
          <a:lst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it-IT" sz="1000" dirty="0" smtClean="0">
                <a:solidFill>
                  <a:srgbClr val="00B050"/>
                </a:solidFill>
                <a:latin typeface="Arial" panose="020B0604020202020204" pitchFamily="34" charset="0"/>
                <a:cs typeface="Arial" panose="020B0604020202020204" pitchFamily="34" charset="0"/>
              </a:rPr>
              <a:t>EPX</a:t>
            </a:r>
            <a:endParaRPr lang="it-IT" sz="1000" dirty="0">
              <a:solidFill>
                <a:srgbClr val="00B050"/>
              </a:solidFill>
              <a:latin typeface="Arial" panose="020B0604020202020204" pitchFamily="34" charset="0"/>
              <a:cs typeface="Arial" panose="020B0604020202020204" pitchFamily="34" charset="0"/>
            </a:endParaRPr>
          </a:p>
        </p:txBody>
      </p:sp>
      <p:sp>
        <p:nvSpPr>
          <p:cNvPr id="173" name="CasellaDiTesto 8"/>
          <p:cNvSpPr txBox="1"/>
          <p:nvPr/>
        </p:nvSpPr>
        <p:spPr>
          <a:xfrm>
            <a:off x="4990492" y="522690"/>
            <a:ext cx="546945" cy="246221"/>
          </a:xfrm>
          <a:prstGeom prst="rect">
            <a:avLst/>
          </a:prstGeom>
          <a:noFill/>
        </p:spPr>
        <p:txBody>
          <a:bodyPr wrap="none" rtlCol="0">
            <a:spAutoFit/>
          </a:bodyPr>
          <a:lst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it-IT" sz="1000" dirty="0">
                <a:latin typeface="Arial" panose="020B0604020202020204" pitchFamily="34" charset="0"/>
                <a:cs typeface="Arial" panose="020B0604020202020204" pitchFamily="34" charset="0"/>
              </a:rPr>
              <a:t>merge</a:t>
            </a:r>
          </a:p>
        </p:txBody>
      </p:sp>
      <p:sp>
        <p:nvSpPr>
          <p:cNvPr id="176" name="Rettangolo 175"/>
          <p:cNvSpPr/>
          <p:nvPr/>
        </p:nvSpPr>
        <p:spPr>
          <a:xfrm>
            <a:off x="5115971" y="2355476"/>
            <a:ext cx="737245" cy="729546"/>
          </a:xfrm>
          <a:prstGeom prst="rect">
            <a:avLst/>
          </a:prstGeom>
          <a:noFill/>
          <a:ln w="9525">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606"/>
          </a:p>
        </p:txBody>
      </p:sp>
      <p:cxnSp>
        <p:nvCxnSpPr>
          <p:cNvPr id="177" name="Connettore 1 176"/>
          <p:cNvCxnSpPr/>
          <p:nvPr/>
        </p:nvCxnSpPr>
        <p:spPr>
          <a:xfrm flipH="1">
            <a:off x="4598912" y="3085022"/>
            <a:ext cx="523390" cy="520975"/>
          </a:xfrm>
          <a:prstGeom prst="line">
            <a:avLst/>
          </a:prstGeom>
          <a:ln>
            <a:solidFill>
              <a:schemeClr val="bg1"/>
            </a:solidFill>
            <a:prstDash val="dash"/>
          </a:ln>
        </p:spPr>
        <p:style>
          <a:lnRef idx="1">
            <a:schemeClr val="accent1"/>
          </a:lnRef>
          <a:fillRef idx="0">
            <a:schemeClr val="accent1"/>
          </a:fillRef>
          <a:effectRef idx="0">
            <a:schemeClr val="accent1"/>
          </a:effectRef>
          <a:fontRef idx="minor">
            <a:schemeClr val="tx1"/>
          </a:fontRef>
        </p:style>
      </p:cxnSp>
      <p:cxnSp>
        <p:nvCxnSpPr>
          <p:cNvPr id="178" name="Connettore 1 177"/>
          <p:cNvCxnSpPr/>
          <p:nvPr/>
        </p:nvCxnSpPr>
        <p:spPr>
          <a:xfrm>
            <a:off x="5853216" y="3085023"/>
            <a:ext cx="102476" cy="495165"/>
          </a:xfrm>
          <a:prstGeom prst="line">
            <a:avLst/>
          </a:prstGeom>
          <a:ln>
            <a:solidFill>
              <a:schemeClr val="bg1"/>
            </a:solidFill>
            <a:prstDash val="dash"/>
          </a:ln>
        </p:spPr>
        <p:style>
          <a:lnRef idx="1">
            <a:schemeClr val="accent1"/>
          </a:lnRef>
          <a:fillRef idx="0">
            <a:schemeClr val="accent1"/>
          </a:fillRef>
          <a:effectRef idx="0">
            <a:schemeClr val="accent1"/>
          </a:effectRef>
          <a:fontRef idx="minor">
            <a:schemeClr val="tx1"/>
          </a:fontRef>
        </p:style>
      </p:cxnSp>
      <p:pic>
        <p:nvPicPr>
          <p:cNvPr id="198" name="Immagine 197"/>
          <p:cNvPicPr>
            <a:picLocks/>
          </p:cNvPicPr>
          <p:nvPr/>
        </p:nvPicPr>
        <p:blipFill>
          <a:blip r:embed="rId7" cstate="print">
            <a:extLst>
              <a:ext uri="{BEBA8EAE-BF5A-486C-A8C5-ECC9F3942E4B}">
                <a14:imgProps xmlns:a14="http://schemas.microsoft.com/office/drawing/2010/main">
                  <a14:imgLayer r:embed="rId8">
                    <a14:imgEffect>
                      <a14:brightnessContrast bright="5000"/>
                    </a14:imgEffect>
                  </a14:imgLayer>
                </a14:imgProps>
              </a:ext>
              <a:ext uri="{28A0092B-C50C-407E-A947-70E740481C1C}">
                <a14:useLocalDpi xmlns:a14="http://schemas.microsoft.com/office/drawing/2010/main" val="0"/>
              </a:ext>
            </a:extLst>
          </a:blip>
          <a:stretch>
            <a:fillRect/>
          </a:stretch>
        </p:blipFill>
        <p:spPr>
          <a:xfrm>
            <a:off x="377672" y="2198812"/>
            <a:ext cx="1381375" cy="1381375"/>
          </a:xfrm>
          <a:prstGeom prst="rect">
            <a:avLst/>
          </a:prstGeom>
        </p:spPr>
      </p:pic>
      <p:cxnSp>
        <p:nvCxnSpPr>
          <p:cNvPr id="217" name="Connettore 1 216"/>
          <p:cNvCxnSpPr/>
          <p:nvPr/>
        </p:nvCxnSpPr>
        <p:spPr>
          <a:xfrm>
            <a:off x="5546544" y="3530394"/>
            <a:ext cx="305188"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pic>
        <p:nvPicPr>
          <p:cNvPr id="9" name="Immagine 8"/>
          <p:cNvPicPr>
            <a:picLocks/>
          </p:cNvPicPr>
          <p:nvPr/>
        </p:nvPicPr>
        <p:blipFill>
          <a:blip r:embed="rId9" cstate="print">
            <a:extLst>
              <a:ext uri="{BEBA8EAE-BF5A-486C-A8C5-ECC9F3942E4B}">
                <a14:imgProps xmlns:a14="http://schemas.microsoft.com/office/drawing/2010/main">
                  <a14:imgLayer r:embed="rId10">
                    <a14:imgEffect>
                      <a14:brightnessContrast bright="13000" contrast="10000"/>
                    </a14:imgEffect>
                  </a14:imgLayer>
                </a14:imgProps>
              </a:ext>
              <a:ext uri="{28A0092B-C50C-407E-A947-70E740481C1C}">
                <a14:useLocalDpi xmlns:a14="http://schemas.microsoft.com/office/drawing/2010/main" val="0"/>
              </a:ext>
            </a:extLst>
          </a:blip>
          <a:stretch>
            <a:fillRect/>
          </a:stretch>
        </p:blipFill>
        <p:spPr>
          <a:xfrm>
            <a:off x="3191863" y="2198812"/>
            <a:ext cx="1381375" cy="1381375"/>
          </a:xfrm>
          <a:prstGeom prst="rect">
            <a:avLst/>
          </a:prstGeom>
        </p:spPr>
      </p:pic>
      <p:pic>
        <p:nvPicPr>
          <p:cNvPr id="11" name="Immagine 10"/>
          <p:cNvPicPr>
            <a:picLocks/>
          </p:cNvPicPr>
          <p:nvPr/>
        </p:nvPicPr>
        <p:blipFill>
          <a:blip r:embed="rId11" cstate="print">
            <a:extLst>
              <a:ext uri="{28A0092B-C50C-407E-A947-70E740481C1C}">
                <a14:useLocalDpi xmlns:a14="http://schemas.microsoft.com/office/drawing/2010/main" val="0"/>
              </a:ext>
            </a:extLst>
          </a:blip>
          <a:stretch>
            <a:fillRect/>
          </a:stretch>
        </p:blipFill>
        <p:spPr>
          <a:xfrm>
            <a:off x="383413" y="3605997"/>
            <a:ext cx="1381375" cy="1381375"/>
          </a:xfrm>
          <a:prstGeom prst="rect">
            <a:avLst/>
          </a:prstGeom>
        </p:spPr>
      </p:pic>
      <p:pic>
        <p:nvPicPr>
          <p:cNvPr id="13" name="Immagine 12"/>
          <p:cNvPicPr>
            <a:picLocks/>
          </p:cNvPicPr>
          <p:nvPr/>
        </p:nvPicPr>
        <p:blipFill>
          <a:blip r:embed="rId12" cstate="print">
            <a:extLst>
              <a:ext uri="{28A0092B-C50C-407E-A947-70E740481C1C}">
                <a14:useLocalDpi xmlns:a14="http://schemas.microsoft.com/office/drawing/2010/main" val="0"/>
              </a:ext>
            </a:extLst>
          </a:blip>
          <a:stretch>
            <a:fillRect/>
          </a:stretch>
        </p:blipFill>
        <p:spPr>
          <a:xfrm>
            <a:off x="4605415" y="3605997"/>
            <a:ext cx="1381375" cy="1381375"/>
          </a:xfrm>
          <a:prstGeom prst="rect">
            <a:avLst/>
          </a:prstGeom>
        </p:spPr>
      </p:pic>
      <p:pic>
        <p:nvPicPr>
          <p:cNvPr id="14" name="Immagine 13"/>
          <p:cNvPicPr>
            <a:picLocks/>
          </p:cNvPicPr>
          <p:nvPr/>
        </p:nvPicPr>
        <p:blipFill>
          <a:blip r:embed="rId13" cstate="print">
            <a:extLst>
              <a:ext uri="{28A0092B-C50C-407E-A947-70E740481C1C}">
                <a14:useLocalDpi xmlns:a14="http://schemas.microsoft.com/office/drawing/2010/main" val="0"/>
              </a:ext>
            </a:extLst>
          </a:blip>
          <a:stretch>
            <a:fillRect/>
          </a:stretch>
        </p:blipFill>
        <p:spPr>
          <a:xfrm>
            <a:off x="3192131" y="3607510"/>
            <a:ext cx="1381375" cy="1381375"/>
          </a:xfrm>
          <a:prstGeom prst="rect">
            <a:avLst/>
          </a:prstGeom>
        </p:spPr>
      </p:pic>
      <p:pic>
        <p:nvPicPr>
          <p:cNvPr id="15" name="Immagine 14"/>
          <p:cNvPicPr>
            <a:picLocks/>
          </p:cNvPicPr>
          <p:nvPr/>
        </p:nvPicPr>
        <p:blipFill>
          <a:blip r:embed="rId14" cstate="print">
            <a:extLst>
              <a:ext uri="{28A0092B-C50C-407E-A947-70E740481C1C}">
                <a14:useLocalDpi xmlns:a14="http://schemas.microsoft.com/office/drawing/2010/main" val="0"/>
              </a:ext>
            </a:extLst>
          </a:blip>
          <a:stretch>
            <a:fillRect/>
          </a:stretch>
        </p:blipFill>
        <p:spPr>
          <a:xfrm>
            <a:off x="1787927" y="3605997"/>
            <a:ext cx="1381375" cy="1381375"/>
          </a:xfrm>
          <a:prstGeom prst="rect">
            <a:avLst/>
          </a:prstGeom>
        </p:spPr>
      </p:pic>
      <p:cxnSp>
        <p:nvCxnSpPr>
          <p:cNvPr id="19" name="Connettore 1 18"/>
          <p:cNvCxnSpPr/>
          <p:nvPr/>
        </p:nvCxnSpPr>
        <p:spPr>
          <a:xfrm>
            <a:off x="276164" y="2474251"/>
            <a:ext cx="0" cy="222693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218" name="Text Box 20"/>
          <p:cNvSpPr txBox="1">
            <a:spLocks noChangeArrowheads="1"/>
          </p:cNvSpPr>
          <p:nvPr/>
        </p:nvSpPr>
        <p:spPr bwMode="auto">
          <a:xfrm rot="16200000">
            <a:off x="-74691" y="1372348"/>
            <a:ext cx="449162"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pPr algn="ctr">
              <a:defRPr/>
            </a:pPr>
            <a:r>
              <a:rPr lang="it-IT" altLang="it-IT" sz="1000" dirty="0">
                <a:latin typeface="Arial" panose="020B0604020202020204" pitchFamily="34" charset="0"/>
                <a:cs typeface="Arial" panose="020B0604020202020204" pitchFamily="34" charset="0"/>
              </a:rPr>
              <a:t>CTR</a:t>
            </a:r>
          </a:p>
        </p:txBody>
      </p:sp>
      <p:cxnSp>
        <p:nvCxnSpPr>
          <p:cNvPr id="220" name="Connettore 1 219"/>
          <p:cNvCxnSpPr/>
          <p:nvPr/>
        </p:nvCxnSpPr>
        <p:spPr>
          <a:xfrm>
            <a:off x="276164" y="838988"/>
            <a:ext cx="0" cy="126251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pic>
        <p:nvPicPr>
          <p:cNvPr id="22" name="Immagine 21"/>
          <p:cNvPicPr>
            <a:picLocks/>
          </p:cNvPicPr>
          <p:nvPr/>
        </p:nvPicPr>
        <p:blipFill>
          <a:blip r:embed="rId15" cstate="print">
            <a:extLst>
              <a:ext uri="{28A0092B-C50C-407E-A947-70E740481C1C}">
                <a14:useLocalDpi xmlns:a14="http://schemas.microsoft.com/office/drawing/2010/main" val="0"/>
              </a:ext>
            </a:extLst>
          </a:blip>
          <a:stretch>
            <a:fillRect/>
          </a:stretch>
        </p:blipFill>
        <p:spPr>
          <a:xfrm>
            <a:off x="378135" y="763786"/>
            <a:ext cx="1381375" cy="1381375"/>
          </a:xfrm>
          <a:prstGeom prst="rect">
            <a:avLst/>
          </a:prstGeom>
        </p:spPr>
      </p:pic>
      <p:pic>
        <p:nvPicPr>
          <p:cNvPr id="25" name="Immagine 24"/>
          <p:cNvPicPr>
            <a:picLocks/>
          </p:cNvPicPr>
          <p:nvPr/>
        </p:nvPicPr>
        <p:blipFill>
          <a:blip r:embed="rId16" cstate="print">
            <a:extLst>
              <a:ext uri="{28A0092B-C50C-407E-A947-70E740481C1C}">
                <a14:useLocalDpi xmlns:a14="http://schemas.microsoft.com/office/drawing/2010/main" val="0"/>
              </a:ext>
            </a:extLst>
          </a:blip>
          <a:stretch>
            <a:fillRect/>
          </a:stretch>
        </p:blipFill>
        <p:spPr>
          <a:xfrm>
            <a:off x="4600805" y="760587"/>
            <a:ext cx="1381375" cy="1381375"/>
          </a:xfrm>
          <a:prstGeom prst="rect">
            <a:avLst/>
          </a:prstGeom>
        </p:spPr>
      </p:pic>
      <p:pic>
        <p:nvPicPr>
          <p:cNvPr id="26" name="Immagine 25"/>
          <p:cNvPicPr>
            <a:picLocks/>
          </p:cNvPicPr>
          <p:nvPr/>
        </p:nvPicPr>
        <p:blipFill>
          <a:blip r:embed="rId17" cstate="print">
            <a:extLst>
              <a:ext uri="{28A0092B-C50C-407E-A947-70E740481C1C}">
                <a14:useLocalDpi xmlns:a14="http://schemas.microsoft.com/office/drawing/2010/main" val="0"/>
              </a:ext>
            </a:extLst>
          </a:blip>
          <a:stretch>
            <a:fillRect/>
          </a:stretch>
        </p:blipFill>
        <p:spPr>
          <a:xfrm>
            <a:off x="3187705" y="763786"/>
            <a:ext cx="1381375" cy="1381375"/>
          </a:xfrm>
          <a:prstGeom prst="rect">
            <a:avLst/>
          </a:prstGeom>
        </p:spPr>
      </p:pic>
      <p:pic>
        <p:nvPicPr>
          <p:cNvPr id="27" name="Immagine 26"/>
          <p:cNvPicPr>
            <a:picLocks/>
          </p:cNvPicPr>
          <p:nvPr/>
        </p:nvPicPr>
        <p:blipFill>
          <a:blip r:embed="rId18" cstate="print">
            <a:extLst>
              <a:ext uri="{28A0092B-C50C-407E-A947-70E740481C1C}">
                <a14:useLocalDpi xmlns:a14="http://schemas.microsoft.com/office/drawing/2010/main" val="0"/>
              </a:ext>
            </a:extLst>
          </a:blip>
          <a:stretch>
            <a:fillRect/>
          </a:stretch>
        </p:blipFill>
        <p:spPr>
          <a:xfrm>
            <a:off x="1782920" y="763786"/>
            <a:ext cx="1381375" cy="1381375"/>
          </a:xfrm>
          <a:prstGeom prst="rect">
            <a:avLst/>
          </a:prstGeom>
        </p:spPr>
      </p:pic>
      <p:cxnSp>
        <p:nvCxnSpPr>
          <p:cNvPr id="221" name="Connettore 1 220"/>
          <p:cNvCxnSpPr/>
          <p:nvPr/>
        </p:nvCxnSpPr>
        <p:spPr>
          <a:xfrm>
            <a:off x="5541032" y="2087952"/>
            <a:ext cx="305188"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32" name="Connettore 1 31"/>
          <p:cNvCxnSpPr/>
          <p:nvPr/>
        </p:nvCxnSpPr>
        <p:spPr>
          <a:xfrm>
            <a:off x="4664901" y="4930797"/>
            <a:ext cx="522000"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sp>
        <p:nvSpPr>
          <p:cNvPr id="31" name="Rettangolo 30"/>
          <p:cNvSpPr/>
          <p:nvPr/>
        </p:nvSpPr>
        <p:spPr>
          <a:xfrm>
            <a:off x="29923" y="5371642"/>
            <a:ext cx="6063569" cy="1323439"/>
          </a:xfrm>
          <a:prstGeom prst="rect">
            <a:avLst/>
          </a:prstGeom>
        </p:spPr>
        <p:txBody>
          <a:bodyPr wrap="square">
            <a:spAutoFit/>
          </a:bodyPr>
          <a:lstStyle/>
          <a:p>
            <a:pPr algn="just"/>
            <a:r>
              <a:rPr lang="en-US" sz="1000" b="1" dirty="0" smtClean="0">
                <a:latin typeface="Arial" panose="020B0604020202020204" pitchFamily="34" charset="0"/>
                <a:cs typeface="Arial" panose="020B0604020202020204" pitchFamily="34" charset="0"/>
              </a:rPr>
              <a:t>Figure S6</a:t>
            </a:r>
            <a:r>
              <a:rPr lang="en-US" sz="1000" b="1" dirty="0" smtClean="0">
                <a:latin typeface="Arial" panose="020B0604020202020204" pitchFamily="34" charset="0"/>
                <a:cs typeface="Arial" panose="020B0604020202020204" pitchFamily="34" charset="0"/>
              </a:rPr>
              <a:t>. </a:t>
            </a:r>
            <a:r>
              <a:rPr lang="en-US" sz="1000" b="1" i="1" dirty="0" smtClean="0">
                <a:latin typeface="Arial" panose="020B0604020202020204" pitchFamily="34" charset="0"/>
                <a:cs typeface="Arial" panose="020B0604020202020204" pitchFamily="34" charset="0"/>
              </a:rPr>
              <a:t>In situ</a:t>
            </a:r>
            <a:r>
              <a:rPr lang="en-US" sz="1000" b="1" dirty="0" smtClean="0">
                <a:latin typeface="Arial" panose="020B0604020202020204" pitchFamily="34" charset="0"/>
                <a:cs typeface="Arial" panose="020B0604020202020204" pitchFamily="34" charset="0"/>
              </a:rPr>
              <a:t> detection of EPX expression in tumor-infiltrating eosinophils.</a:t>
            </a:r>
            <a:r>
              <a:rPr lang="en-US" sz="1000" dirty="0" smtClean="0">
                <a:latin typeface="Arial" panose="020B0604020202020204" pitchFamily="34" charset="0"/>
                <a:cs typeface="Arial" panose="020B0604020202020204" pitchFamily="34" charset="0"/>
              </a:rPr>
              <a:t> C57Bl/6 mice were implanted subcutaneously with B16 melanoma cells (8 x 10</a:t>
            </a:r>
            <a:r>
              <a:rPr lang="en-US" sz="1000" baseline="30000" dirty="0" smtClean="0">
                <a:latin typeface="Arial" panose="020B0604020202020204" pitchFamily="34" charset="0"/>
                <a:cs typeface="Arial" panose="020B0604020202020204" pitchFamily="34" charset="0"/>
              </a:rPr>
              <a:t>5</a:t>
            </a:r>
            <a:r>
              <a:rPr lang="en-US" sz="1000" dirty="0" smtClean="0">
                <a:latin typeface="Arial" panose="020B0604020202020204" pitchFamily="34" charset="0"/>
                <a:cs typeface="Arial" panose="020B0604020202020204" pitchFamily="34" charset="0"/>
              </a:rPr>
              <a:t> cells/mouse) and then treated by repeated intraperitoneal injections with IL-33 (0,4 µg/mouse). Three days after the last administration of IL-33 (day 16) mice were sacrificed and tumors were harvested. </a:t>
            </a:r>
            <a:r>
              <a:rPr lang="en-US" sz="1000" dirty="0">
                <a:latin typeface="Arial" panose="020B0604020202020204" pitchFamily="34" charset="0"/>
                <a:cs typeface="Arial" panose="020B0604020202020204" pitchFamily="34" charset="0"/>
              </a:rPr>
              <a:t>FFPE </a:t>
            </a:r>
            <a:r>
              <a:rPr lang="en-US" sz="1000" dirty="0" smtClean="0">
                <a:latin typeface="Arial" panose="020B0604020202020204" pitchFamily="34" charset="0"/>
                <a:cs typeface="Arial" panose="020B0604020202020204" pitchFamily="34" charset="0"/>
              </a:rPr>
              <a:t>tissue sections </a:t>
            </a:r>
            <a:r>
              <a:rPr lang="en-US" sz="1000" dirty="0">
                <a:latin typeface="Arial" panose="020B0604020202020204" pitchFamily="34" charset="0"/>
                <a:cs typeface="Arial" panose="020B0604020202020204" pitchFamily="34" charset="0"/>
              </a:rPr>
              <a:t>(</a:t>
            </a:r>
            <a:r>
              <a:rPr lang="en-US" sz="1000" dirty="0" smtClean="0">
                <a:latin typeface="Arial" panose="020B0604020202020204" pitchFamily="34" charset="0"/>
                <a:cs typeface="Arial" panose="020B0604020202020204" pitchFamily="34" charset="0"/>
              </a:rPr>
              <a:t>5 µm </a:t>
            </a:r>
            <a:r>
              <a:rPr lang="en-US" sz="1000" dirty="0">
                <a:latin typeface="Arial" panose="020B0604020202020204" pitchFamily="34" charset="0"/>
                <a:cs typeface="Arial" panose="020B0604020202020204" pitchFamily="34" charset="0"/>
              </a:rPr>
              <a:t>thick) were </a:t>
            </a:r>
            <a:r>
              <a:rPr lang="en-US" sz="1000" dirty="0" smtClean="0">
                <a:latin typeface="Arial" panose="020B0604020202020204" pitchFamily="34" charset="0"/>
                <a:cs typeface="Arial" panose="020B0604020202020204" pitchFamily="34" charset="0"/>
              </a:rPr>
              <a:t>stained with </a:t>
            </a:r>
            <a:r>
              <a:rPr lang="en-US" sz="1000" dirty="0" err="1" smtClean="0">
                <a:latin typeface="Arial" panose="020B0604020202020204" pitchFamily="34" charset="0"/>
                <a:cs typeface="Arial" panose="020B0604020202020204" pitchFamily="34" charset="0"/>
              </a:rPr>
              <a:t>mAbs</a:t>
            </a:r>
            <a:r>
              <a:rPr lang="en-US" sz="1000" dirty="0" smtClean="0">
                <a:latin typeface="Arial" panose="020B0604020202020204" pitchFamily="34" charset="0"/>
                <a:cs typeface="Arial" panose="020B0604020202020204" pitchFamily="34" charset="0"/>
              </a:rPr>
              <a:t> to detect </a:t>
            </a:r>
            <a:r>
              <a:rPr lang="en-US" sz="1000" dirty="0" err="1" smtClean="0">
                <a:latin typeface="Arial" panose="020B0604020202020204" pitchFamily="34" charset="0"/>
                <a:cs typeface="Arial" panose="020B0604020202020204" pitchFamily="34" charset="0"/>
              </a:rPr>
              <a:t>Siglec</a:t>
            </a:r>
            <a:r>
              <a:rPr lang="en-US" sz="1000" dirty="0" smtClean="0">
                <a:latin typeface="Arial" panose="020B0604020202020204" pitchFamily="34" charset="0"/>
                <a:cs typeface="Arial" panose="020B0604020202020204" pitchFamily="34" charset="0"/>
              </a:rPr>
              <a:t>-F (red) and EPX (green</a:t>
            </a:r>
            <a:r>
              <a:rPr lang="en-US" sz="1000" dirty="0">
                <a:latin typeface="Arial" panose="020B0604020202020204" pitchFamily="34" charset="0"/>
                <a:cs typeface="Arial" panose="020B0604020202020204" pitchFamily="34" charset="0"/>
              </a:rPr>
              <a:t>). </a:t>
            </a:r>
            <a:r>
              <a:rPr lang="en-US" sz="1000" dirty="0" smtClean="0">
                <a:latin typeface="Arial" panose="020B0604020202020204" pitchFamily="34" charset="0"/>
                <a:cs typeface="Arial" panose="020B0604020202020204" pitchFamily="34" charset="0"/>
              </a:rPr>
              <a:t>Nuclei were stained with DAPI (blue). Single channels and merged images </a:t>
            </a:r>
            <a:r>
              <a:rPr lang="en-US" sz="1000" dirty="0">
                <a:latin typeface="Arial" panose="020B0604020202020204" pitchFamily="34" charset="0"/>
                <a:cs typeface="Arial" panose="020B0604020202020204" pitchFamily="34" charset="0"/>
              </a:rPr>
              <a:t>are shown. </a:t>
            </a:r>
            <a:r>
              <a:rPr lang="en-US" sz="1000" dirty="0" err="1">
                <a:latin typeface="Arial" panose="020B0604020202020204" pitchFamily="34" charset="0"/>
                <a:cs typeface="Arial" panose="020B0604020202020204" pitchFamily="34" charset="0"/>
              </a:rPr>
              <a:t>Colocalizations</a:t>
            </a:r>
            <a:r>
              <a:rPr lang="en-US" sz="1000" dirty="0">
                <a:latin typeface="Arial" panose="020B0604020202020204" pitchFamily="34" charset="0"/>
                <a:cs typeface="Arial" panose="020B0604020202020204" pitchFamily="34" charset="0"/>
              </a:rPr>
              <a:t> are shown in yellow. Inserts represent higher-power magnification images of necrotic areas </a:t>
            </a:r>
            <a:r>
              <a:rPr lang="en-US" sz="1000" dirty="0" smtClean="0">
                <a:latin typeface="Arial" panose="020B0604020202020204" pitchFamily="34" charset="0"/>
                <a:cs typeface="Arial" panose="020B0604020202020204" pitchFamily="34" charset="0"/>
              </a:rPr>
              <a:t>(N) with </a:t>
            </a:r>
            <a:r>
              <a:rPr lang="en-US" sz="1000" dirty="0">
                <a:latin typeface="Arial" panose="020B0604020202020204" pitchFamily="34" charset="0"/>
                <a:cs typeface="Arial" panose="020B0604020202020204" pitchFamily="34" charset="0"/>
              </a:rPr>
              <a:t>EO infiltration in tissues from IL-33 treated mice. </a:t>
            </a:r>
            <a:r>
              <a:rPr lang="en-US" sz="1000" dirty="0" smtClean="0">
                <a:latin typeface="Arial" panose="020B0604020202020204" pitchFamily="34" charset="0"/>
                <a:cs typeface="Arial" panose="020B0604020202020204" pitchFamily="34" charset="0"/>
              </a:rPr>
              <a:t>Scale </a:t>
            </a:r>
            <a:r>
              <a:rPr lang="en-US" sz="1000" dirty="0">
                <a:latin typeface="Arial" panose="020B0604020202020204" pitchFamily="34" charset="0"/>
                <a:cs typeface="Arial" panose="020B0604020202020204" pitchFamily="34" charset="0"/>
              </a:rPr>
              <a:t>bars correspond to 50 µm. Panels are representative of 2 independent experiments.</a:t>
            </a:r>
          </a:p>
        </p:txBody>
      </p:sp>
      <p:sp>
        <p:nvSpPr>
          <p:cNvPr id="29" name="Figura a mano libera 28"/>
          <p:cNvSpPr>
            <a:spLocks noChangeAspect="1"/>
          </p:cNvSpPr>
          <p:nvPr/>
        </p:nvSpPr>
        <p:spPr>
          <a:xfrm>
            <a:off x="545356" y="760193"/>
            <a:ext cx="909882" cy="1198408"/>
          </a:xfrm>
          <a:custGeom>
            <a:avLst/>
            <a:gdLst>
              <a:gd name="connsiteX0" fmla="*/ 324293 w 866554"/>
              <a:gd name="connsiteY0" fmla="*/ 33 h 1141341"/>
              <a:gd name="connsiteX1" fmla="*/ 340242 w 866554"/>
              <a:gd name="connsiteY1" fmla="*/ 26614 h 1141341"/>
              <a:gd name="connsiteX2" fmla="*/ 345558 w 866554"/>
              <a:gd name="connsiteY2" fmla="*/ 42563 h 1141341"/>
              <a:gd name="connsiteX3" fmla="*/ 356191 w 866554"/>
              <a:gd name="connsiteY3" fmla="*/ 63828 h 1141341"/>
              <a:gd name="connsiteX4" fmla="*/ 372140 w 866554"/>
              <a:gd name="connsiteY4" fmla="*/ 101042 h 1141341"/>
              <a:gd name="connsiteX5" fmla="*/ 382772 w 866554"/>
              <a:gd name="connsiteY5" fmla="*/ 132940 h 1141341"/>
              <a:gd name="connsiteX6" fmla="*/ 388089 w 866554"/>
              <a:gd name="connsiteY6" fmla="*/ 148889 h 1141341"/>
              <a:gd name="connsiteX7" fmla="*/ 398721 w 866554"/>
              <a:gd name="connsiteY7" fmla="*/ 228633 h 1141341"/>
              <a:gd name="connsiteX8" fmla="*/ 393405 w 866554"/>
              <a:gd name="connsiteY8" fmla="*/ 324326 h 1141341"/>
              <a:gd name="connsiteX9" fmla="*/ 372140 w 866554"/>
              <a:gd name="connsiteY9" fmla="*/ 372172 h 1141341"/>
              <a:gd name="connsiteX10" fmla="*/ 366823 w 866554"/>
              <a:gd name="connsiteY10" fmla="*/ 388121 h 1141341"/>
              <a:gd name="connsiteX11" fmla="*/ 356191 w 866554"/>
              <a:gd name="connsiteY11" fmla="*/ 409386 h 1141341"/>
              <a:gd name="connsiteX12" fmla="*/ 350875 w 866554"/>
              <a:gd name="connsiteY12" fmla="*/ 425335 h 1141341"/>
              <a:gd name="connsiteX13" fmla="*/ 345558 w 866554"/>
              <a:gd name="connsiteY13" fmla="*/ 446600 h 1141341"/>
              <a:gd name="connsiteX14" fmla="*/ 334926 w 866554"/>
              <a:gd name="connsiteY14" fmla="*/ 462549 h 1141341"/>
              <a:gd name="connsiteX15" fmla="*/ 329609 w 866554"/>
              <a:gd name="connsiteY15" fmla="*/ 478498 h 1141341"/>
              <a:gd name="connsiteX16" fmla="*/ 303028 w 866554"/>
              <a:gd name="connsiteY16" fmla="*/ 510396 h 1141341"/>
              <a:gd name="connsiteX17" fmla="*/ 292396 w 866554"/>
              <a:gd name="connsiteY17" fmla="*/ 531661 h 1141341"/>
              <a:gd name="connsiteX18" fmla="*/ 281763 w 866554"/>
              <a:gd name="connsiteY18" fmla="*/ 563558 h 1141341"/>
              <a:gd name="connsiteX19" fmla="*/ 271130 w 866554"/>
              <a:gd name="connsiteY19" fmla="*/ 579507 h 1141341"/>
              <a:gd name="connsiteX20" fmla="*/ 265814 w 866554"/>
              <a:gd name="connsiteY20" fmla="*/ 595456 h 1141341"/>
              <a:gd name="connsiteX21" fmla="*/ 233916 w 866554"/>
              <a:gd name="connsiteY21" fmla="*/ 616721 h 1141341"/>
              <a:gd name="connsiteX22" fmla="*/ 217968 w 866554"/>
              <a:gd name="connsiteY22" fmla="*/ 627354 h 1141341"/>
              <a:gd name="connsiteX23" fmla="*/ 186070 w 866554"/>
              <a:gd name="connsiteY23" fmla="*/ 659252 h 1141341"/>
              <a:gd name="connsiteX24" fmla="*/ 154172 w 866554"/>
              <a:gd name="connsiteY24" fmla="*/ 675200 h 1141341"/>
              <a:gd name="connsiteX25" fmla="*/ 127591 w 866554"/>
              <a:gd name="connsiteY25" fmla="*/ 685833 h 1141341"/>
              <a:gd name="connsiteX26" fmla="*/ 74428 w 866554"/>
              <a:gd name="connsiteY26" fmla="*/ 723047 h 1141341"/>
              <a:gd name="connsiteX27" fmla="*/ 42530 w 866554"/>
              <a:gd name="connsiteY27" fmla="*/ 733679 h 1141341"/>
              <a:gd name="connsiteX28" fmla="*/ 26582 w 866554"/>
              <a:gd name="connsiteY28" fmla="*/ 744312 h 1141341"/>
              <a:gd name="connsiteX29" fmla="*/ 15949 w 866554"/>
              <a:gd name="connsiteY29" fmla="*/ 776210 h 1141341"/>
              <a:gd name="connsiteX30" fmla="*/ 0 w 866554"/>
              <a:gd name="connsiteY30" fmla="*/ 818740 h 1141341"/>
              <a:gd name="connsiteX31" fmla="*/ 10633 w 866554"/>
              <a:gd name="connsiteY31" fmla="*/ 903800 h 1141341"/>
              <a:gd name="connsiteX32" fmla="*/ 21265 w 866554"/>
              <a:gd name="connsiteY32" fmla="*/ 919749 h 1141341"/>
              <a:gd name="connsiteX33" fmla="*/ 26582 w 866554"/>
              <a:gd name="connsiteY33" fmla="*/ 967596 h 1141341"/>
              <a:gd name="connsiteX34" fmla="*/ 53163 w 866554"/>
              <a:gd name="connsiteY34" fmla="*/ 988861 h 1141341"/>
              <a:gd name="connsiteX35" fmla="*/ 85061 w 866554"/>
              <a:gd name="connsiteY35" fmla="*/ 1015442 h 1141341"/>
              <a:gd name="connsiteX36" fmla="*/ 116958 w 866554"/>
              <a:gd name="connsiteY36" fmla="*/ 1031391 h 1141341"/>
              <a:gd name="connsiteX37" fmla="*/ 164805 w 866554"/>
              <a:gd name="connsiteY37" fmla="*/ 1057972 h 1141341"/>
              <a:gd name="connsiteX38" fmla="*/ 260498 w 866554"/>
              <a:gd name="connsiteY38" fmla="*/ 1047340 h 1141341"/>
              <a:gd name="connsiteX39" fmla="*/ 292396 w 866554"/>
              <a:gd name="connsiteY39" fmla="*/ 1020758 h 1141341"/>
              <a:gd name="connsiteX40" fmla="*/ 372140 w 866554"/>
              <a:gd name="connsiteY40" fmla="*/ 1031391 h 1141341"/>
              <a:gd name="connsiteX41" fmla="*/ 404037 w 866554"/>
              <a:gd name="connsiteY41" fmla="*/ 1057972 h 1141341"/>
              <a:gd name="connsiteX42" fmla="*/ 419986 w 866554"/>
              <a:gd name="connsiteY42" fmla="*/ 1063289 h 1141341"/>
              <a:gd name="connsiteX43" fmla="*/ 451884 w 866554"/>
              <a:gd name="connsiteY43" fmla="*/ 1084554 h 1141341"/>
              <a:gd name="connsiteX44" fmla="*/ 467833 w 866554"/>
              <a:gd name="connsiteY44" fmla="*/ 1095186 h 1141341"/>
              <a:gd name="connsiteX45" fmla="*/ 489098 w 866554"/>
              <a:gd name="connsiteY45" fmla="*/ 1105819 h 1141341"/>
              <a:gd name="connsiteX46" fmla="*/ 531628 w 866554"/>
              <a:gd name="connsiteY46" fmla="*/ 1127084 h 1141341"/>
              <a:gd name="connsiteX47" fmla="*/ 584791 w 866554"/>
              <a:gd name="connsiteY47" fmla="*/ 1132400 h 1141341"/>
              <a:gd name="connsiteX48" fmla="*/ 707065 w 866554"/>
              <a:gd name="connsiteY48" fmla="*/ 1132400 h 1141341"/>
              <a:gd name="connsiteX49" fmla="*/ 781493 w 866554"/>
              <a:gd name="connsiteY49" fmla="*/ 1127084 h 1141341"/>
              <a:gd name="connsiteX50" fmla="*/ 802758 w 866554"/>
              <a:gd name="connsiteY50" fmla="*/ 1095186 h 1141341"/>
              <a:gd name="connsiteX51" fmla="*/ 808075 w 866554"/>
              <a:gd name="connsiteY51" fmla="*/ 1079238 h 1141341"/>
              <a:gd name="connsiteX52" fmla="*/ 818707 w 866554"/>
              <a:gd name="connsiteY52" fmla="*/ 1063289 h 1141341"/>
              <a:gd name="connsiteX53" fmla="*/ 839972 w 866554"/>
              <a:gd name="connsiteY53" fmla="*/ 1026075 h 1141341"/>
              <a:gd name="connsiteX54" fmla="*/ 850605 w 866554"/>
              <a:gd name="connsiteY54" fmla="*/ 994177 h 1141341"/>
              <a:gd name="connsiteX55" fmla="*/ 855921 w 866554"/>
              <a:gd name="connsiteY55" fmla="*/ 972912 h 1141341"/>
              <a:gd name="connsiteX56" fmla="*/ 866554 w 866554"/>
              <a:gd name="connsiteY56" fmla="*/ 941014 h 1141341"/>
              <a:gd name="connsiteX57" fmla="*/ 861237 w 866554"/>
              <a:gd name="connsiteY57" fmla="*/ 898484 h 1141341"/>
              <a:gd name="connsiteX58" fmla="*/ 850605 w 866554"/>
              <a:gd name="connsiteY58" fmla="*/ 877219 h 1141341"/>
              <a:gd name="connsiteX59" fmla="*/ 845289 w 866554"/>
              <a:gd name="connsiteY59" fmla="*/ 861270 h 1141341"/>
              <a:gd name="connsiteX60" fmla="*/ 839972 w 866554"/>
              <a:gd name="connsiteY60" fmla="*/ 840005 h 1141341"/>
              <a:gd name="connsiteX61" fmla="*/ 808075 w 866554"/>
              <a:gd name="connsiteY61" fmla="*/ 813424 h 1141341"/>
              <a:gd name="connsiteX62" fmla="*/ 797442 w 866554"/>
              <a:gd name="connsiteY62" fmla="*/ 797475 h 1141341"/>
              <a:gd name="connsiteX63" fmla="*/ 786809 w 866554"/>
              <a:gd name="connsiteY63" fmla="*/ 754945 h 1141341"/>
              <a:gd name="connsiteX64" fmla="*/ 776177 w 866554"/>
              <a:gd name="connsiteY64" fmla="*/ 723047 h 1141341"/>
              <a:gd name="connsiteX65" fmla="*/ 770861 w 866554"/>
              <a:gd name="connsiteY65" fmla="*/ 707098 h 1141341"/>
              <a:gd name="connsiteX66" fmla="*/ 765544 w 866554"/>
              <a:gd name="connsiteY66" fmla="*/ 691149 h 1141341"/>
              <a:gd name="connsiteX67" fmla="*/ 754912 w 866554"/>
              <a:gd name="connsiteY67" fmla="*/ 675200 h 1141341"/>
              <a:gd name="connsiteX68" fmla="*/ 749596 w 866554"/>
              <a:gd name="connsiteY68" fmla="*/ 659252 h 1141341"/>
              <a:gd name="connsiteX69" fmla="*/ 733647 w 866554"/>
              <a:gd name="connsiteY69" fmla="*/ 643303 h 1141341"/>
              <a:gd name="connsiteX70" fmla="*/ 723014 w 866554"/>
              <a:gd name="connsiteY70" fmla="*/ 622038 h 1141341"/>
              <a:gd name="connsiteX71" fmla="*/ 701749 w 866554"/>
              <a:gd name="connsiteY71" fmla="*/ 590140 h 1141341"/>
              <a:gd name="connsiteX72" fmla="*/ 696433 w 866554"/>
              <a:gd name="connsiteY72" fmla="*/ 574191 h 1141341"/>
              <a:gd name="connsiteX73" fmla="*/ 664535 w 866554"/>
              <a:gd name="connsiteY73" fmla="*/ 526345 h 1141341"/>
              <a:gd name="connsiteX74" fmla="*/ 653903 w 866554"/>
              <a:gd name="connsiteY74" fmla="*/ 510396 h 1141341"/>
              <a:gd name="connsiteX75" fmla="*/ 637954 w 866554"/>
              <a:gd name="connsiteY75" fmla="*/ 478498 h 1141341"/>
              <a:gd name="connsiteX76" fmla="*/ 632637 w 866554"/>
              <a:gd name="connsiteY76" fmla="*/ 462549 h 1141341"/>
              <a:gd name="connsiteX77" fmla="*/ 616689 w 866554"/>
              <a:gd name="connsiteY77" fmla="*/ 414703 h 1141341"/>
              <a:gd name="connsiteX78" fmla="*/ 606056 w 866554"/>
              <a:gd name="connsiteY78" fmla="*/ 382805 h 1141341"/>
              <a:gd name="connsiteX79" fmla="*/ 590107 w 866554"/>
              <a:gd name="connsiteY79" fmla="*/ 366856 h 1141341"/>
              <a:gd name="connsiteX80" fmla="*/ 584791 w 866554"/>
              <a:gd name="connsiteY80" fmla="*/ 350907 h 1141341"/>
              <a:gd name="connsiteX81" fmla="*/ 574158 w 866554"/>
              <a:gd name="connsiteY81" fmla="*/ 334958 h 1141341"/>
              <a:gd name="connsiteX82" fmla="*/ 568842 w 866554"/>
              <a:gd name="connsiteY82" fmla="*/ 308377 h 1141341"/>
              <a:gd name="connsiteX83" fmla="*/ 595423 w 866554"/>
              <a:gd name="connsiteY83" fmla="*/ 175470 h 1141341"/>
              <a:gd name="connsiteX84" fmla="*/ 611372 w 866554"/>
              <a:gd name="connsiteY84" fmla="*/ 164838 h 1141341"/>
              <a:gd name="connsiteX85" fmla="*/ 627321 w 866554"/>
              <a:gd name="connsiteY85" fmla="*/ 143572 h 1141341"/>
              <a:gd name="connsiteX86" fmla="*/ 637954 w 866554"/>
              <a:gd name="connsiteY86" fmla="*/ 127624 h 1141341"/>
              <a:gd name="connsiteX87" fmla="*/ 653903 w 866554"/>
              <a:gd name="connsiteY87" fmla="*/ 111675 h 1141341"/>
              <a:gd name="connsiteX88" fmla="*/ 675168 w 866554"/>
              <a:gd name="connsiteY88" fmla="*/ 79777 h 1141341"/>
              <a:gd name="connsiteX89" fmla="*/ 685800 w 866554"/>
              <a:gd name="connsiteY89" fmla="*/ 63828 h 1141341"/>
              <a:gd name="connsiteX90" fmla="*/ 680484 w 866554"/>
              <a:gd name="connsiteY90" fmla="*/ 37247 h 1141341"/>
              <a:gd name="connsiteX91" fmla="*/ 669851 w 866554"/>
              <a:gd name="connsiteY91" fmla="*/ 21298 h 1141341"/>
              <a:gd name="connsiteX92" fmla="*/ 324293 w 866554"/>
              <a:gd name="connsiteY92" fmla="*/ 33 h 114134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Lst>
            <a:rect l="l" t="t" r="r" b="b"/>
            <a:pathLst>
              <a:path w="866554" h="1141341">
                <a:moveTo>
                  <a:pt x="324293" y="33"/>
                </a:moveTo>
                <a:cubicBezTo>
                  <a:pt x="269358" y="919"/>
                  <a:pt x="335621" y="17372"/>
                  <a:pt x="340242" y="26614"/>
                </a:cubicBezTo>
                <a:cubicBezTo>
                  <a:pt x="342748" y="31626"/>
                  <a:pt x="343351" y="37412"/>
                  <a:pt x="345558" y="42563"/>
                </a:cubicBezTo>
                <a:cubicBezTo>
                  <a:pt x="348680" y="49847"/>
                  <a:pt x="352647" y="56740"/>
                  <a:pt x="356191" y="63828"/>
                </a:cubicBezTo>
                <a:cubicBezTo>
                  <a:pt x="370254" y="120083"/>
                  <a:pt x="351160" y="53836"/>
                  <a:pt x="372140" y="101042"/>
                </a:cubicBezTo>
                <a:cubicBezTo>
                  <a:pt x="376692" y="111284"/>
                  <a:pt x="379228" y="122307"/>
                  <a:pt x="382772" y="132940"/>
                </a:cubicBezTo>
                <a:lnTo>
                  <a:pt x="388089" y="148889"/>
                </a:lnTo>
                <a:cubicBezTo>
                  <a:pt x="391673" y="170392"/>
                  <a:pt x="398721" y="209112"/>
                  <a:pt x="398721" y="228633"/>
                </a:cubicBezTo>
                <a:cubicBezTo>
                  <a:pt x="398721" y="260580"/>
                  <a:pt x="397368" y="292626"/>
                  <a:pt x="393405" y="324326"/>
                </a:cubicBezTo>
                <a:cubicBezTo>
                  <a:pt x="388833" y="360899"/>
                  <a:pt x="384382" y="347689"/>
                  <a:pt x="372140" y="372172"/>
                </a:cubicBezTo>
                <a:cubicBezTo>
                  <a:pt x="369634" y="377184"/>
                  <a:pt x="369031" y="382970"/>
                  <a:pt x="366823" y="388121"/>
                </a:cubicBezTo>
                <a:cubicBezTo>
                  <a:pt x="363701" y="395405"/>
                  <a:pt x="359313" y="402102"/>
                  <a:pt x="356191" y="409386"/>
                </a:cubicBezTo>
                <a:cubicBezTo>
                  <a:pt x="353984" y="414537"/>
                  <a:pt x="352415" y="419947"/>
                  <a:pt x="350875" y="425335"/>
                </a:cubicBezTo>
                <a:cubicBezTo>
                  <a:pt x="348868" y="432360"/>
                  <a:pt x="348436" y="439884"/>
                  <a:pt x="345558" y="446600"/>
                </a:cubicBezTo>
                <a:cubicBezTo>
                  <a:pt x="343041" y="452473"/>
                  <a:pt x="337783" y="456834"/>
                  <a:pt x="334926" y="462549"/>
                </a:cubicBezTo>
                <a:cubicBezTo>
                  <a:pt x="332420" y="467561"/>
                  <a:pt x="332115" y="473486"/>
                  <a:pt x="329609" y="478498"/>
                </a:cubicBezTo>
                <a:cubicBezTo>
                  <a:pt x="322206" y="493303"/>
                  <a:pt x="314787" y="498637"/>
                  <a:pt x="303028" y="510396"/>
                </a:cubicBezTo>
                <a:cubicBezTo>
                  <a:pt x="299484" y="517484"/>
                  <a:pt x="295339" y="524303"/>
                  <a:pt x="292396" y="531661"/>
                </a:cubicBezTo>
                <a:cubicBezTo>
                  <a:pt x="288234" y="542067"/>
                  <a:pt x="287980" y="554233"/>
                  <a:pt x="281763" y="563558"/>
                </a:cubicBezTo>
                <a:lnTo>
                  <a:pt x="271130" y="579507"/>
                </a:lnTo>
                <a:cubicBezTo>
                  <a:pt x="269358" y="584823"/>
                  <a:pt x="269777" y="591493"/>
                  <a:pt x="265814" y="595456"/>
                </a:cubicBezTo>
                <a:cubicBezTo>
                  <a:pt x="256778" y="604492"/>
                  <a:pt x="244549" y="609632"/>
                  <a:pt x="233916" y="616721"/>
                </a:cubicBezTo>
                <a:cubicBezTo>
                  <a:pt x="228600" y="620265"/>
                  <a:pt x="222486" y="622836"/>
                  <a:pt x="217968" y="627354"/>
                </a:cubicBezTo>
                <a:cubicBezTo>
                  <a:pt x="207335" y="637987"/>
                  <a:pt x="200335" y="654497"/>
                  <a:pt x="186070" y="659252"/>
                </a:cubicBezTo>
                <a:cubicBezTo>
                  <a:pt x="145988" y="672612"/>
                  <a:pt x="195388" y="654592"/>
                  <a:pt x="154172" y="675200"/>
                </a:cubicBezTo>
                <a:cubicBezTo>
                  <a:pt x="145637" y="679468"/>
                  <a:pt x="135933" y="681198"/>
                  <a:pt x="127591" y="685833"/>
                </a:cubicBezTo>
                <a:cubicBezTo>
                  <a:pt x="109394" y="695943"/>
                  <a:pt x="94529" y="716347"/>
                  <a:pt x="74428" y="723047"/>
                </a:cubicBezTo>
                <a:lnTo>
                  <a:pt x="42530" y="733679"/>
                </a:lnTo>
                <a:cubicBezTo>
                  <a:pt x="37214" y="737223"/>
                  <a:pt x="29968" y="738894"/>
                  <a:pt x="26582" y="744312"/>
                </a:cubicBezTo>
                <a:cubicBezTo>
                  <a:pt x="20642" y="753816"/>
                  <a:pt x="20112" y="765804"/>
                  <a:pt x="15949" y="776210"/>
                </a:cubicBezTo>
                <a:cubicBezTo>
                  <a:pt x="3235" y="807994"/>
                  <a:pt x="8334" y="793738"/>
                  <a:pt x="0" y="818740"/>
                </a:cubicBezTo>
                <a:cubicBezTo>
                  <a:pt x="641" y="826434"/>
                  <a:pt x="1948" y="883536"/>
                  <a:pt x="10633" y="903800"/>
                </a:cubicBezTo>
                <a:cubicBezTo>
                  <a:pt x="13150" y="909673"/>
                  <a:pt x="17721" y="914433"/>
                  <a:pt x="21265" y="919749"/>
                </a:cubicBezTo>
                <a:cubicBezTo>
                  <a:pt x="23037" y="935698"/>
                  <a:pt x="22690" y="952028"/>
                  <a:pt x="26582" y="967596"/>
                </a:cubicBezTo>
                <a:cubicBezTo>
                  <a:pt x="31703" y="988081"/>
                  <a:pt x="38712" y="981636"/>
                  <a:pt x="53163" y="988861"/>
                </a:cubicBezTo>
                <a:cubicBezTo>
                  <a:pt x="72961" y="998760"/>
                  <a:pt x="67426" y="1000745"/>
                  <a:pt x="85061" y="1015442"/>
                </a:cubicBezTo>
                <a:cubicBezTo>
                  <a:pt x="98803" y="1026894"/>
                  <a:pt x="100972" y="1026063"/>
                  <a:pt x="116958" y="1031391"/>
                </a:cubicBezTo>
                <a:cubicBezTo>
                  <a:pt x="153519" y="1055764"/>
                  <a:pt x="136733" y="1048615"/>
                  <a:pt x="164805" y="1057972"/>
                </a:cubicBezTo>
                <a:cubicBezTo>
                  <a:pt x="169249" y="1057655"/>
                  <a:pt x="237802" y="1057067"/>
                  <a:pt x="260498" y="1047340"/>
                </a:cubicBezTo>
                <a:cubicBezTo>
                  <a:pt x="273450" y="1041789"/>
                  <a:pt x="282816" y="1030338"/>
                  <a:pt x="292396" y="1020758"/>
                </a:cubicBezTo>
                <a:cubicBezTo>
                  <a:pt x="306640" y="1021945"/>
                  <a:pt x="350427" y="1020534"/>
                  <a:pt x="372140" y="1031391"/>
                </a:cubicBezTo>
                <a:cubicBezTo>
                  <a:pt x="406923" y="1048783"/>
                  <a:pt x="368770" y="1034460"/>
                  <a:pt x="404037" y="1057972"/>
                </a:cubicBezTo>
                <a:cubicBezTo>
                  <a:pt x="408700" y="1061081"/>
                  <a:pt x="415087" y="1060567"/>
                  <a:pt x="419986" y="1063289"/>
                </a:cubicBezTo>
                <a:cubicBezTo>
                  <a:pt x="431157" y="1069495"/>
                  <a:pt x="441251" y="1077466"/>
                  <a:pt x="451884" y="1084554"/>
                </a:cubicBezTo>
                <a:cubicBezTo>
                  <a:pt x="457200" y="1088098"/>
                  <a:pt x="462118" y="1092329"/>
                  <a:pt x="467833" y="1095186"/>
                </a:cubicBezTo>
                <a:cubicBezTo>
                  <a:pt x="474921" y="1098730"/>
                  <a:pt x="482170" y="1101970"/>
                  <a:pt x="489098" y="1105819"/>
                </a:cubicBezTo>
                <a:cubicBezTo>
                  <a:pt x="502743" y="1113400"/>
                  <a:pt x="515498" y="1124603"/>
                  <a:pt x="531628" y="1127084"/>
                </a:cubicBezTo>
                <a:cubicBezTo>
                  <a:pt x="549230" y="1129792"/>
                  <a:pt x="567070" y="1130628"/>
                  <a:pt x="584791" y="1132400"/>
                </a:cubicBezTo>
                <a:cubicBezTo>
                  <a:pt x="634007" y="1148807"/>
                  <a:pt x="597660" y="1138836"/>
                  <a:pt x="707065" y="1132400"/>
                </a:cubicBezTo>
                <a:cubicBezTo>
                  <a:pt x="731895" y="1130939"/>
                  <a:pt x="756684" y="1128856"/>
                  <a:pt x="781493" y="1127084"/>
                </a:cubicBezTo>
                <a:cubicBezTo>
                  <a:pt x="794132" y="1089166"/>
                  <a:pt x="776212" y="1135003"/>
                  <a:pt x="802758" y="1095186"/>
                </a:cubicBezTo>
                <a:cubicBezTo>
                  <a:pt x="805866" y="1090524"/>
                  <a:pt x="805569" y="1084250"/>
                  <a:pt x="808075" y="1079238"/>
                </a:cubicBezTo>
                <a:cubicBezTo>
                  <a:pt x="810932" y="1073523"/>
                  <a:pt x="815163" y="1068605"/>
                  <a:pt x="818707" y="1063289"/>
                </a:cubicBezTo>
                <a:cubicBezTo>
                  <a:pt x="833307" y="1004885"/>
                  <a:pt x="811179" y="1077901"/>
                  <a:pt x="839972" y="1026075"/>
                </a:cubicBezTo>
                <a:cubicBezTo>
                  <a:pt x="845415" y="1016278"/>
                  <a:pt x="847887" y="1005050"/>
                  <a:pt x="850605" y="994177"/>
                </a:cubicBezTo>
                <a:cubicBezTo>
                  <a:pt x="852377" y="987089"/>
                  <a:pt x="853821" y="979910"/>
                  <a:pt x="855921" y="972912"/>
                </a:cubicBezTo>
                <a:cubicBezTo>
                  <a:pt x="859142" y="962177"/>
                  <a:pt x="866554" y="941014"/>
                  <a:pt x="866554" y="941014"/>
                </a:cubicBezTo>
                <a:cubicBezTo>
                  <a:pt x="864782" y="926837"/>
                  <a:pt x="864702" y="912344"/>
                  <a:pt x="861237" y="898484"/>
                </a:cubicBezTo>
                <a:cubicBezTo>
                  <a:pt x="859315" y="890796"/>
                  <a:pt x="853727" y="884503"/>
                  <a:pt x="850605" y="877219"/>
                </a:cubicBezTo>
                <a:cubicBezTo>
                  <a:pt x="848398" y="872068"/>
                  <a:pt x="846829" y="866658"/>
                  <a:pt x="845289" y="861270"/>
                </a:cubicBezTo>
                <a:cubicBezTo>
                  <a:pt x="843282" y="854245"/>
                  <a:pt x="843597" y="846349"/>
                  <a:pt x="839972" y="840005"/>
                </a:cubicBezTo>
                <a:cubicBezTo>
                  <a:pt x="833674" y="828984"/>
                  <a:pt x="818238" y="820199"/>
                  <a:pt x="808075" y="813424"/>
                </a:cubicBezTo>
                <a:cubicBezTo>
                  <a:pt x="804531" y="808108"/>
                  <a:pt x="800299" y="803190"/>
                  <a:pt x="797442" y="797475"/>
                </a:cubicBezTo>
                <a:cubicBezTo>
                  <a:pt x="790992" y="784575"/>
                  <a:pt x="790447" y="768283"/>
                  <a:pt x="786809" y="754945"/>
                </a:cubicBezTo>
                <a:cubicBezTo>
                  <a:pt x="783860" y="744132"/>
                  <a:pt x="779721" y="733680"/>
                  <a:pt x="776177" y="723047"/>
                </a:cubicBezTo>
                <a:lnTo>
                  <a:pt x="770861" y="707098"/>
                </a:lnTo>
                <a:cubicBezTo>
                  <a:pt x="769089" y="701782"/>
                  <a:pt x="768652" y="695812"/>
                  <a:pt x="765544" y="691149"/>
                </a:cubicBezTo>
                <a:cubicBezTo>
                  <a:pt x="762000" y="685833"/>
                  <a:pt x="757769" y="680915"/>
                  <a:pt x="754912" y="675200"/>
                </a:cubicBezTo>
                <a:cubicBezTo>
                  <a:pt x="752406" y="670188"/>
                  <a:pt x="752704" y="663914"/>
                  <a:pt x="749596" y="659252"/>
                </a:cubicBezTo>
                <a:cubicBezTo>
                  <a:pt x="745425" y="652996"/>
                  <a:pt x="738017" y="649421"/>
                  <a:pt x="733647" y="643303"/>
                </a:cubicBezTo>
                <a:cubicBezTo>
                  <a:pt x="729041" y="636854"/>
                  <a:pt x="727091" y="628834"/>
                  <a:pt x="723014" y="622038"/>
                </a:cubicBezTo>
                <a:cubicBezTo>
                  <a:pt x="716439" y="611080"/>
                  <a:pt x="701749" y="590140"/>
                  <a:pt x="701749" y="590140"/>
                </a:cubicBezTo>
                <a:cubicBezTo>
                  <a:pt x="699977" y="584824"/>
                  <a:pt x="699154" y="579090"/>
                  <a:pt x="696433" y="574191"/>
                </a:cubicBezTo>
                <a:cubicBezTo>
                  <a:pt x="696415" y="574159"/>
                  <a:pt x="669862" y="534335"/>
                  <a:pt x="664535" y="526345"/>
                </a:cubicBezTo>
                <a:cubicBezTo>
                  <a:pt x="660991" y="521029"/>
                  <a:pt x="655924" y="516457"/>
                  <a:pt x="653903" y="510396"/>
                </a:cubicBezTo>
                <a:cubicBezTo>
                  <a:pt x="640538" y="470307"/>
                  <a:pt x="658566" y="519722"/>
                  <a:pt x="637954" y="478498"/>
                </a:cubicBezTo>
                <a:cubicBezTo>
                  <a:pt x="635448" y="473486"/>
                  <a:pt x="634605" y="467796"/>
                  <a:pt x="632637" y="462549"/>
                </a:cubicBezTo>
                <a:cubicBezTo>
                  <a:pt x="605989" y="391490"/>
                  <a:pt x="634504" y="474087"/>
                  <a:pt x="616689" y="414703"/>
                </a:cubicBezTo>
                <a:cubicBezTo>
                  <a:pt x="613468" y="403968"/>
                  <a:pt x="613981" y="390730"/>
                  <a:pt x="606056" y="382805"/>
                </a:cubicBezTo>
                <a:lnTo>
                  <a:pt x="590107" y="366856"/>
                </a:lnTo>
                <a:cubicBezTo>
                  <a:pt x="588335" y="361540"/>
                  <a:pt x="587297" y="355919"/>
                  <a:pt x="584791" y="350907"/>
                </a:cubicBezTo>
                <a:cubicBezTo>
                  <a:pt x="581934" y="345192"/>
                  <a:pt x="576402" y="340941"/>
                  <a:pt x="574158" y="334958"/>
                </a:cubicBezTo>
                <a:cubicBezTo>
                  <a:pt x="570985" y="326498"/>
                  <a:pt x="570614" y="317237"/>
                  <a:pt x="568842" y="308377"/>
                </a:cubicBezTo>
                <a:cubicBezTo>
                  <a:pt x="570036" y="285685"/>
                  <a:pt x="557273" y="200902"/>
                  <a:pt x="595423" y="175470"/>
                </a:cubicBezTo>
                <a:lnTo>
                  <a:pt x="611372" y="164838"/>
                </a:lnTo>
                <a:cubicBezTo>
                  <a:pt x="616688" y="157749"/>
                  <a:pt x="622171" y="150782"/>
                  <a:pt x="627321" y="143572"/>
                </a:cubicBezTo>
                <a:cubicBezTo>
                  <a:pt x="631035" y="138373"/>
                  <a:pt x="633864" y="132532"/>
                  <a:pt x="637954" y="127624"/>
                </a:cubicBezTo>
                <a:cubicBezTo>
                  <a:pt x="642767" y="121848"/>
                  <a:pt x="649287" y="117610"/>
                  <a:pt x="653903" y="111675"/>
                </a:cubicBezTo>
                <a:cubicBezTo>
                  <a:pt x="661748" y="101588"/>
                  <a:pt x="668080" y="90410"/>
                  <a:pt x="675168" y="79777"/>
                </a:cubicBezTo>
                <a:lnTo>
                  <a:pt x="685800" y="63828"/>
                </a:lnTo>
                <a:cubicBezTo>
                  <a:pt x="684028" y="54968"/>
                  <a:pt x="683657" y="45707"/>
                  <a:pt x="680484" y="37247"/>
                </a:cubicBezTo>
                <a:cubicBezTo>
                  <a:pt x="678240" y="31264"/>
                  <a:pt x="676233" y="21612"/>
                  <a:pt x="669851" y="21298"/>
                </a:cubicBezTo>
                <a:cubicBezTo>
                  <a:pt x="565424" y="16162"/>
                  <a:pt x="379228" y="-853"/>
                  <a:pt x="324293" y="33"/>
                </a:cubicBezTo>
                <a:close/>
              </a:path>
            </a:pathLst>
          </a:custGeom>
          <a:noFill/>
          <a:ln w="9525">
            <a:solidFill>
              <a:srgbClr val="FFFF0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30" name="Figura a mano libera 29"/>
          <p:cNvSpPr>
            <a:spLocks noChangeAspect="1"/>
          </p:cNvSpPr>
          <p:nvPr/>
        </p:nvSpPr>
        <p:spPr>
          <a:xfrm>
            <a:off x="722005" y="2181566"/>
            <a:ext cx="683064" cy="880520"/>
          </a:xfrm>
          <a:custGeom>
            <a:avLst/>
            <a:gdLst>
              <a:gd name="connsiteX0" fmla="*/ 262393 w 650539"/>
              <a:gd name="connsiteY0" fmla="*/ 24027 h 838590"/>
              <a:gd name="connsiteX1" fmla="*/ 241128 w 650539"/>
              <a:gd name="connsiteY1" fmla="*/ 50609 h 838590"/>
              <a:gd name="connsiteX2" fmla="*/ 214547 w 650539"/>
              <a:gd name="connsiteY2" fmla="*/ 82506 h 838590"/>
              <a:gd name="connsiteX3" fmla="*/ 209230 w 650539"/>
              <a:gd name="connsiteY3" fmla="*/ 98455 h 838590"/>
              <a:gd name="connsiteX4" fmla="*/ 203914 w 650539"/>
              <a:gd name="connsiteY4" fmla="*/ 130353 h 838590"/>
              <a:gd name="connsiteX5" fmla="*/ 187965 w 650539"/>
              <a:gd name="connsiteY5" fmla="*/ 140985 h 838590"/>
              <a:gd name="connsiteX6" fmla="*/ 161384 w 650539"/>
              <a:gd name="connsiteY6" fmla="*/ 172883 h 838590"/>
              <a:gd name="connsiteX7" fmla="*/ 145435 w 650539"/>
              <a:gd name="connsiteY7" fmla="*/ 178199 h 838590"/>
              <a:gd name="connsiteX8" fmla="*/ 108221 w 650539"/>
              <a:gd name="connsiteY8" fmla="*/ 199464 h 838590"/>
              <a:gd name="connsiteX9" fmla="*/ 92272 w 650539"/>
              <a:gd name="connsiteY9" fmla="*/ 204781 h 838590"/>
              <a:gd name="connsiteX10" fmla="*/ 76323 w 650539"/>
              <a:gd name="connsiteY10" fmla="*/ 300474 h 838590"/>
              <a:gd name="connsiteX11" fmla="*/ 65691 w 650539"/>
              <a:gd name="connsiteY11" fmla="*/ 332371 h 838590"/>
              <a:gd name="connsiteX12" fmla="*/ 86956 w 650539"/>
              <a:gd name="connsiteY12" fmla="*/ 412116 h 838590"/>
              <a:gd name="connsiteX13" fmla="*/ 108221 w 650539"/>
              <a:gd name="connsiteY13" fmla="*/ 417432 h 838590"/>
              <a:gd name="connsiteX14" fmla="*/ 124170 w 650539"/>
              <a:gd name="connsiteY14" fmla="*/ 428064 h 838590"/>
              <a:gd name="connsiteX15" fmla="*/ 129486 w 650539"/>
              <a:gd name="connsiteY15" fmla="*/ 444013 h 838590"/>
              <a:gd name="connsiteX16" fmla="*/ 113537 w 650539"/>
              <a:gd name="connsiteY16" fmla="*/ 502492 h 838590"/>
              <a:gd name="connsiteX17" fmla="*/ 108221 w 650539"/>
              <a:gd name="connsiteY17" fmla="*/ 518441 h 838590"/>
              <a:gd name="connsiteX18" fmla="*/ 76323 w 650539"/>
              <a:gd name="connsiteY18" fmla="*/ 539706 h 838590"/>
              <a:gd name="connsiteX19" fmla="*/ 44426 w 650539"/>
              <a:gd name="connsiteY19" fmla="*/ 555655 h 838590"/>
              <a:gd name="connsiteX20" fmla="*/ 17844 w 650539"/>
              <a:gd name="connsiteY20" fmla="*/ 592869 h 838590"/>
              <a:gd name="connsiteX21" fmla="*/ 12528 w 650539"/>
              <a:gd name="connsiteY21" fmla="*/ 630083 h 838590"/>
              <a:gd name="connsiteX22" fmla="*/ 7212 w 650539"/>
              <a:gd name="connsiteY22" fmla="*/ 667297 h 838590"/>
              <a:gd name="connsiteX23" fmla="*/ 55058 w 650539"/>
              <a:gd name="connsiteY23" fmla="*/ 693878 h 838590"/>
              <a:gd name="connsiteX24" fmla="*/ 71007 w 650539"/>
              <a:gd name="connsiteY24" fmla="*/ 699195 h 838590"/>
              <a:gd name="connsiteX25" fmla="*/ 86956 w 650539"/>
              <a:gd name="connsiteY25" fmla="*/ 704511 h 838590"/>
              <a:gd name="connsiteX26" fmla="*/ 118853 w 650539"/>
              <a:gd name="connsiteY26" fmla="*/ 725776 h 838590"/>
              <a:gd name="connsiteX27" fmla="*/ 134802 w 650539"/>
              <a:gd name="connsiteY27" fmla="*/ 736409 h 838590"/>
              <a:gd name="connsiteX28" fmla="*/ 150751 w 650539"/>
              <a:gd name="connsiteY28" fmla="*/ 741725 h 838590"/>
              <a:gd name="connsiteX29" fmla="*/ 198598 w 650539"/>
              <a:gd name="connsiteY29" fmla="*/ 773623 h 838590"/>
              <a:gd name="connsiteX30" fmla="*/ 214547 w 650539"/>
              <a:gd name="connsiteY30" fmla="*/ 784255 h 838590"/>
              <a:gd name="connsiteX31" fmla="*/ 225179 w 650539"/>
              <a:gd name="connsiteY31" fmla="*/ 800204 h 838590"/>
              <a:gd name="connsiteX32" fmla="*/ 241128 w 650539"/>
              <a:gd name="connsiteY32" fmla="*/ 805520 h 838590"/>
              <a:gd name="connsiteX33" fmla="*/ 273026 w 650539"/>
              <a:gd name="connsiteY33" fmla="*/ 821469 h 838590"/>
              <a:gd name="connsiteX34" fmla="*/ 320872 w 650539"/>
              <a:gd name="connsiteY34" fmla="*/ 837418 h 838590"/>
              <a:gd name="connsiteX35" fmla="*/ 352770 w 650539"/>
              <a:gd name="connsiteY35" fmla="*/ 816153 h 838590"/>
              <a:gd name="connsiteX36" fmla="*/ 565421 w 650539"/>
              <a:gd name="connsiteY36" fmla="*/ 810837 h 838590"/>
              <a:gd name="connsiteX37" fmla="*/ 581370 w 650539"/>
              <a:gd name="connsiteY37" fmla="*/ 800204 h 838590"/>
              <a:gd name="connsiteX38" fmla="*/ 607951 w 650539"/>
              <a:gd name="connsiteY38" fmla="*/ 768306 h 838590"/>
              <a:gd name="connsiteX39" fmla="*/ 629216 w 650539"/>
              <a:gd name="connsiteY39" fmla="*/ 762990 h 838590"/>
              <a:gd name="connsiteX40" fmla="*/ 634533 w 650539"/>
              <a:gd name="connsiteY40" fmla="*/ 693878 h 838590"/>
              <a:gd name="connsiteX41" fmla="*/ 639849 w 650539"/>
              <a:gd name="connsiteY41" fmla="*/ 614134 h 838590"/>
              <a:gd name="connsiteX42" fmla="*/ 645165 w 650539"/>
              <a:gd name="connsiteY42" fmla="*/ 598185 h 838590"/>
              <a:gd name="connsiteX43" fmla="*/ 650481 w 650539"/>
              <a:gd name="connsiteY43" fmla="*/ 576920 h 838590"/>
              <a:gd name="connsiteX44" fmla="*/ 645165 w 650539"/>
              <a:gd name="connsiteY44" fmla="*/ 502492 h 838590"/>
              <a:gd name="connsiteX45" fmla="*/ 613267 w 650539"/>
              <a:gd name="connsiteY45" fmla="*/ 481227 h 838590"/>
              <a:gd name="connsiteX46" fmla="*/ 597319 w 650539"/>
              <a:gd name="connsiteY46" fmla="*/ 470595 h 838590"/>
              <a:gd name="connsiteX47" fmla="*/ 586686 w 650539"/>
              <a:gd name="connsiteY47" fmla="*/ 454646 h 838590"/>
              <a:gd name="connsiteX48" fmla="*/ 602635 w 650539"/>
              <a:gd name="connsiteY48" fmla="*/ 364269 h 838590"/>
              <a:gd name="connsiteX49" fmla="*/ 607951 w 650539"/>
              <a:gd name="connsiteY49" fmla="*/ 268576 h 838590"/>
              <a:gd name="connsiteX50" fmla="*/ 623900 w 650539"/>
              <a:gd name="connsiteY50" fmla="*/ 263260 h 838590"/>
              <a:gd name="connsiteX51" fmla="*/ 634533 w 650539"/>
              <a:gd name="connsiteY51" fmla="*/ 247311 h 838590"/>
              <a:gd name="connsiteX52" fmla="*/ 629216 w 650539"/>
              <a:gd name="connsiteY52" fmla="*/ 188832 h 838590"/>
              <a:gd name="connsiteX53" fmla="*/ 618584 w 650539"/>
              <a:gd name="connsiteY53" fmla="*/ 135669 h 838590"/>
              <a:gd name="connsiteX54" fmla="*/ 576053 w 650539"/>
              <a:gd name="connsiteY54" fmla="*/ 98455 h 838590"/>
              <a:gd name="connsiteX55" fmla="*/ 544156 w 650539"/>
              <a:gd name="connsiteY55" fmla="*/ 71874 h 838590"/>
              <a:gd name="connsiteX56" fmla="*/ 528207 w 650539"/>
              <a:gd name="connsiteY56" fmla="*/ 61241 h 838590"/>
              <a:gd name="connsiteX57" fmla="*/ 262393 w 650539"/>
              <a:gd name="connsiteY57" fmla="*/ 24027 h 83859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Lst>
            <a:rect l="l" t="t" r="r" b="b"/>
            <a:pathLst>
              <a:path w="650539" h="838590">
                <a:moveTo>
                  <a:pt x="262393" y="24027"/>
                </a:moveTo>
                <a:cubicBezTo>
                  <a:pt x="214547" y="22255"/>
                  <a:pt x="248600" y="42069"/>
                  <a:pt x="241128" y="50609"/>
                </a:cubicBezTo>
                <a:cubicBezTo>
                  <a:pt x="227410" y="66287"/>
                  <a:pt x="223614" y="64372"/>
                  <a:pt x="214547" y="82506"/>
                </a:cubicBezTo>
                <a:cubicBezTo>
                  <a:pt x="212041" y="87518"/>
                  <a:pt x="211002" y="93139"/>
                  <a:pt x="209230" y="98455"/>
                </a:cubicBezTo>
                <a:cubicBezTo>
                  <a:pt x="207458" y="109088"/>
                  <a:pt x="208735" y="120712"/>
                  <a:pt x="203914" y="130353"/>
                </a:cubicBezTo>
                <a:cubicBezTo>
                  <a:pt x="201057" y="136068"/>
                  <a:pt x="192483" y="136467"/>
                  <a:pt x="187965" y="140985"/>
                </a:cubicBezTo>
                <a:cubicBezTo>
                  <a:pt x="168349" y="160601"/>
                  <a:pt x="187515" y="155462"/>
                  <a:pt x="161384" y="172883"/>
                </a:cubicBezTo>
                <a:cubicBezTo>
                  <a:pt x="156721" y="175991"/>
                  <a:pt x="150586" y="175992"/>
                  <a:pt x="145435" y="178199"/>
                </a:cubicBezTo>
                <a:cubicBezTo>
                  <a:pt x="80213" y="206152"/>
                  <a:pt x="161596" y="172777"/>
                  <a:pt x="108221" y="199464"/>
                </a:cubicBezTo>
                <a:cubicBezTo>
                  <a:pt x="103209" y="201970"/>
                  <a:pt x="97588" y="203009"/>
                  <a:pt x="92272" y="204781"/>
                </a:cubicBezTo>
                <a:cubicBezTo>
                  <a:pt x="64861" y="245901"/>
                  <a:pt x="90415" y="201828"/>
                  <a:pt x="76323" y="300474"/>
                </a:cubicBezTo>
                <a:cubicBezTo>
                  <a:pt x="74738" y="311569"/>
                  <a:pt x="65691" y="332371"/>
                  <a:pt x="65691" y="332371"/>
                </a:cubicBezTo>
                <a:cubicBezTo>
                  <a:pt x="68328" y="364017"/>
                  <a:pt x="57082" y="395045"/>
                  <a:pt x="86956" y="412116"/>
                </a:cubicBezTo>
                <a:cubicBezTo>
                  <a:pt x="93300" y="415741"/>
                  <a:pt x="101133" y="415660"/>
                  <a:pt x="108221" y="417432"/>
                </a:cubicBezTo>
                <a:cubicBezTo>
                  <a:pt x="113537" y="420976"/>
                  <a:pt x="120179" y="423075"/>
                  <a:pt x="124170" y="428064"/>
                </a:cubicBezTo>
                <a:cubicBezTo>
                  <a:pt x="127671" y="432440"/>
                  <a:pt x="129486" y="438409"/>
                  <a:pt x="129486" y="444013"/>
                </a:cubicBezTo>
                <a:cubicBezTo>
                  <a:pt x="129486" y="483722"/>
                  <a:pt x="129364" y="478754"/>
                  <a:pt x="113537" y="502492"/>
                </a:cubicBezTo>
                <a:cubicBezTo>
                  <a:pt x="111765" y="507808"/>
                  <a:pt x="112184" y="514478"/>
                  <a:pt x="108221" y="518441"/>
                </a:cubicBezTo>
                <a:cubicBezTo>
                  <a:pt x="99185" y="527477"/>
                  <a:pt x="88446" y="535665"/>
                  <a:pt x="76323" y="539706"/>
                </a:cubicBezTo>
                <a:cubicBezTo>
                  <a:pt x="63353" y="544030"/>
                  <a:pt x="54731" y="545350"/>
                  <a:pt x="44426" y="555655"/>
                </a:cubicBezTo>
                <a:cubicBezTo>
                  <a:pt x="37832" y="562249"/>
                  <a:pt x="23881" y="583814"/>
                  <a:pt x="17844" y="592869"/>
                </a:cubicBezTo>
                <a:cubicBezTo>
                  <a:pt x="16072" y="605274"/>
                  <a:pt x="16129" y="618081"/>
                  <a:pt x="12528" y="630083"/>
                </a:cubicBezTo>
                <a:cubicBezTo>
                  <a:pt x="5796" y="652523"/>
                  <a:pt x="-8750" y="639363"/>
                  <a:pt x="7212" y="667297"/>
                </a:cubicBezTo>
                <a:cubicBezTo>
                  <a:pt x="18448" y="686959"/>
                  <a:pt x="34866" y="687147"/>
                  <a:pt x="55058" y="693878"/>
                </a:cubicBezTo>
                <a:lnTo>
                  <a:pt x="71007" y="699195"/>
                </a:lnTo>
                <a:lnTo>
                  <a:pt x="86956" y="704511"/>
                </a:lnTo>
                <a:lnTo>
                  <a:pt x="118853" y="725776"/>
                </a:lnTo>
                <a:cubicBezTo>
                  <a:pt x="124169" y="729320"/>
                  <a:pt x="128740" y="734389"/>
                  <a:pt x="134802" y="736409"/>
                </a:cubicBezTo>
                <a:lnTo>
                  <a:pt x="150751" y="741725"/>
                </a:lnTo>
                <a:lnTo>
                  <a:pt x="198598" y="773623"/>
                </a:lnTo>
                <a:lnTo>
                  <a:pt x="214547" y="784255"/>
                </a:lnTo>
                <a:cubicBezTo>
                  <a:pt x="218091" y="789571"/>
                  <a:pt x="220190" y="796213"/>
                  <a:pt x="225179" y="800204"/>
                </a:cubicBezTo>
                <a:cubicBezTo>
                  <a:pt x="229555" y="803705"/>
                  <a:pt x="236116" y="803014"/>
                  <a:pt x="241128" y="805520"/>
                </a:cubicBezTo>
                <a:cubicBezTo>
                  <a:pt x="282351" y="826132"/>
                  <a:pt x="232938" y="808107"/>
                  <a:pt x="273026" y="821469"/>
                </a:cubicBezTo>
                <a:cubicBezTo>
                  <a:pt x="288037" y="831478"/>
                  <a:pt x="299383" y="842194"/>
                  <a:pt x="320872" y="837418"/>
                </a:cubicBezTo>
                <a:cubicBezTo>
                  <a:pt x="378372" y="824640"/>
                  <a:pt x="301672" y="818530"/>
                  <a:pt x="352770" y="816153"/>
                </a:cubicBezTo>
                <a:cubicBezTo>
                  <a:pt x="423599" y="812859"/>
                  <a:pt x="494537" y="812609"/>
                  <a:pt x="565421" y="810837"/>
                </a:cubicBezTo>
                <a:cubicBezTo>
                  <a:pt x="570737" y="807293"/>
                  <a:pt x="576852" y="804722"/>
                  <a:pt x="581370" y="800204"/>
                </a:cubicBezTo>
                <a:cubicBezTo>
                  <a:pt x="596050" y="785523"/>
                  <a:pt x="587628" y="779919"/>
                  <a:pt x="607951" y="768306"/>
                </a:cubicBezTo>
                <a:cubicBezTo>
                  <a:pt x="614295" y="764681"/>
                  <a:pt x="622128" y="764762"/>
                  <a:pt x="629216" y="762990"/>
                </a:cubicBezTo>
                <a:cubicBezTo>
                  <a:pt x="630988" y="739953"/>
                  <a:pt x="632887" y="716925"/>
                  <a:pt x="634533" y="693878"/>
                </a:cubicBezTo>
                <a:cubicBezTo>
                  <a:pt x="636431" y="667305"/>
                  <a:pt x="636907" y="640611"/>
                  <a:pt x="639849" y="614134"/>
                </a:cubicBezTo>
                <a:cubicBezTo>
                  <a:pt x="640468" y="608564"/>
                  <a:pt x="643626" y="603573"/>
                  <a:pt x="645165" y="598185"/>
                </a:cubicBezTo>
                <a:cubicBezTo>
                  <a:pt x="647172" y="591160"/>
                  <a:pt x="648709" y="584008"/>
                  <a:pt x="650481" y="576920"/>
                </a:cubicBezTo>
                <a:cubicBezTo>
                  <a:pt x="648709" y="552111"/>
                  <a:pt x="654180" y="525673"/>
                  <a:pt x="645165" y="502492"/>
                </a:cubicBezTo>
                <a:cubicBezTo>
                  <a:pt x="640533" y="490582"/>
                  <a:pt x="623900" y="488315"/>
                  <a:pt x="613267" y="481227"/>
                </a:cubicBezTo>
                <a:lnTo>
                  <a:pt x="597319" y="470595"/>
                </a:lnTo>
                <a:cubicBezTo>
                  <a:pt x="593775" y="465279"/>
                  <a:pt x="587085" y="461023"/>
                  <a:pt x="586686" y="454646"/>
                </a:cubicBezTo>
                <a:cubicBezTo>
                  <a:pt x="583065" y="396721"/>
                  <a:pt x="584942" y="399653"/>
                  <a:pt x="602635" y="364269"/>
                </a:cubicBezTo>
                <a:cubicBezTo>
                  <a:pt x="604407" y="332371"/>
                  <a:pt x="601370" y="299838"/>
                  <a:pt x="607951" y="268576"/>
                </a:cubicBezTo>
                <a:cubicBezTo>
                  <a:pt x="609105" y="263092"/>
                  <a:pt x="619524" y="266761"/>
                  <a:pt x="623900" y="263260"/>
                </a:cubicBezTo>
                <a:cubicBezTo>
                  <a:pt x="628889" y="259269"/>
                  <a:pt x="630989" y="252627"/>
                  <a:pt x="634533" y="247311"/>
                </a:cubicBezTo>
                <a:cubicBezTo>
                  <a:pt x="645492" y="214432"/>
                  <a:pt x="638543" y="244796"/>
                  <a:pt x="629216" y="188832"/>
                </a:cubicBezTo>
                <a:cubicBezTo>
                  <a:pt x="628017" y="181637"/>
                  <a:pt x="622910" y="145762"/>
                  <a:pt x="618584" y="135669"/>
                </a:cubicBezTo>
                <a:cubicBezTo>
                  <a:pt x="609724" y="114995"/>
                  <a:pt x="595545" y="111450"/>
                  <a:pt x="576053" y="98455"/>
                </a:cubicBezTo>
                <a:cubicBezTo>
                  <a:pt x="536461" y="72061"/>
                  <a:pt x="585085" y="105982"/>
                  <a:pt x="544156" y="71874"/>
                </a:cubicBezTo>
                <a:cubicBezTo>
                  <a:pt x="539247" y="67784"/>
                  <a:pt x="533523" y="64785"/>
                  <a:pt x="528207" y="61241"/>
                </a:cubicBezTo>
                <a:cubicBezTo>
                  <a:pt x="509490" y="-51063"/>
                  <a:pt x="310239" y="25799"/>
                  <a:pt x="262393" y="24027"/>
                </a:cubicBezTo>
                <a:close/>
              </a:path>
            </a:pathLst>
          </a:custGeom>
          <a:noFill/>
          <a:ln w="9525">
            <a:solidFill>
              <a:srgbClr val="FFFF0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2" name="Figura a mano libera 1"/>
          <p:cNvSpPr/>
          <p:nvPr/>
        </p:nvSpPr>
        <p:spPr>
          <a:xfrm>
            <a:off x="1088302" y="3605997"/>
            <a:ext cx="370248" cy="1381375"/>
          </a:xfrm>
          <a:custGeom>
            <a:avLst/>
            <a:gdLst>
              <a:gd name="connsiteX0" fmla="*/ 527322 w 560981"/>
              <a:gd name="connsiteY0" fmla="*/ 0 h 1330022"/>
              <a:gd name="connsiteX1" fmla="*/ 549762 w 560981"/>
              <a:gd name="connsiteY1" fmla="*/ 44878 h 1330022"/>
              <a:gd name="connsiteX2" fmla="*/ 555371 w 560981"/>
              <a:gd name="connsiteY2" fmla="*/ 123416 h 1330022"/>
              <a:gd name="connsiteX3" fmla="*/ 560981 w 560981"/>
              <a:gd name="connsiteY3" fmla="*/ 185124 h 1330022"/>
              <a:gd name="connsiteX4" fmla="*/ 555371 w 560981"/>
              <a:gd name="connsiteY4" fmla="*/ 213173 h 1330022"/>
              <a:gd name="connsiteX5" fmla="*/ 538542 w 560981"/>
              <a:gd name="connsiteY5" fmla="*/ 218783 h 1330022"/>
              <a:gd name="connsiteX6" fmla="*/ 521713 w 560981"/>
              <a:gd name="connsiteY6" fmla="*/ 230002 h 1330022"/>
              <a:gd name="connsiteX7" fmla="*/ 504883 w 560981"/>
              <a:gd name="connsiteY7" fmla="*/ 235612 h 1330022"/>
              <a:gd name="connsiteX8" fmla="*/ 482444 w 560981"/>
              <a:gd name="connsiteY8" fmla="*/ 246832 h 1330022"/>
              <a:gd name="connsiteX9" fmla="*/ 448785 w 560981"/>
              <a:gd name="connsiteY9" fmla="*/ 258051 h 1330022"/>
              <a:gd name="connsiteX10" fmla="*/ 426346 w 560981"/>
              <a:gd name="connsiteY10" fmla="*/ 297320 h 1330022"/>
              <a:gd name="connsiteX11" fmla="*/ 415126 w 560981"/>
              <a:gd name="connsiteY11" fmla="*/ 314150 h 1330022"/>
              <a:gd name="connsiteX12" fmla="*/ 403906 w 560981"/>
              <a:gd name="connsiteY12" fmla="*/ 347808 h 1330022"/>
              <a:gd name="connsiteX13" fmla="*/ 387077 w 560981"/>
              <a:gd name="connsiteY13" fmla="*/ 381467 h 1330022"/>
              <a:gd name="connsiteX14" fmla="*/ 392687 w 560981"/>
              <a:gd name="connsiteY14" fmla="*/ 527323 h 1330022"/>
              <a:gd name="connsiteX15" fmla="*/ 398297 w 560981"/>
              <a:gd name="connsiteY15" fmla="*/ 544152 h 1330022"/>
              <a:gd name="connsiteX16" fmla="*/ 415126 w 560981"/>
              <a:gd name="connsiteY16" fmla="*/ 555372 h 1330022"/>
              <a:gd name="connsiteX17" fmla="*/ 420736 w 560981"/>
              <a:gd name="connsiteY17" fmla="*/ 633909 h 1330022"/>
              <a:gd name="connsiteX18" fmla="*/ 437565 w 560981"/>
              <a:gd name="connsiteY18" fmla="*/ 650738 h 1330022"/>
              <a:gd name="connsiteX19" fmla="*/ 448785 w 560981"/>
              <a:gd name="connsiteY19" fmla="*/ 684397 h 1330022"/>
              <a:gd name="connsiteX20" fmla="*/ 460005 w 560981"/>
              <a:gd name="connsiteY20" fmla="*/ 701227 h 1330022"/>
              <a:gd name="connsiteX21" fmla="*/ 465614 w 560981"/>
              <a:gd name="connsiteY21" fmla="*/ 718056 h 1330022"/>
              <a:gd name="connsiteX22" fmla="*/ 482444 w 560981"/>
              <a:gd name="connsiteY22" fmla="*/ 729276 h 1330022"/>
              <a:gd name="connsiteX23" fmla="*/ 476834 w 560981"/>
              <a:gd name="connsiteY23" fmla="*/ 768545 h 1330022"/>
              <a:gd name="connsiteX24" fmla="*/ 465614 w 560981"/>
              <a:gd name="connsiteY24" fmla="*/ 819033 h 1330022"/>
              <a:gd name="connsiteX25" fmla="*/ 437565 w 560981"/>
              <a:gd name="connsiteY25" fmla="*/ 852692 h 1330022"/>
              <a:gd name="connsiteX26" fmla="*/ 409516 w 560981"/>
              <a:gd name="connsiteY26" fmla="*/ 886351 h 1330022"/>
              <a:gd name="connsiteX27" fmla="*/ 403906 w 560981"/>
              <a:gd name="connsiteY27" fmla="*/ 903180 h 1330022"/>
              <a:gd name="connsiteX28" fmla="*/ 387077 w 560981"/>
              <a:gd name="connsiteY28" fmla="*/ 925619 h 1330022"/>
              <a:gd name="connsiteX29" fmla="*/ 375857 w 560981"/>
              <a:gd name="connsiteY29" fmla="*/ 942449 h 1330022"/>
              <a:gd name="connsiteX30" fmla="*/ 359028 w 560981"/>
              <a:gd name="connsiteY30" fmla="*/ 976108 h 1330022"/>
              <a:gd name="connsiteX31" fmla="*/ 353418 w 560981"/>
              <a:gd name="connsiteY31" fmla="*/ 992937 h 1330022"/>
              <a:gd name="connsiteX32" fmla="*/ 342198 w 560981"/>
              <a:gd name="connsiteY32" fmla="*/ 1015377 h 1330022"/>
              <a:gd name="connsiteX33" fmla="*/ 342198 w 560981"/>
              <a:gd name="connsiteY33" fmla="*/ 1110743 h 1330022"/>
              <a:gd name="connsiteX34" fmla="*/ 291710 w 560981"/>
              <a:gd name="connsiteY34" fmla="*/ 1144402 h 1330022"/>
              <a:gd name="connsiteX35" fmla="*/ 258051 w 560981"/>
              <a:gd name="connsiteY35" fmla="*/ 1178061 h 1330022"/>
              <a:gd name="connsiteX36" fmla="*/ 246832 w 560981"/>
              <a:gd name="connsiteY36" fmla="*/ 1194891 h 1330022"/>
              <a:gd name="connsiteX37" fmla="*/ 213173 w 560981"/>
              <a:gd name="connsiteY37" fmla="*/ 1217330 h 1330022"/>
              <a:gd name="connsiteX38" fmla="*/ 196343 w 560981"/>
              <a:gd name="connsiteY38" fmla="*/ 1228550 h 1330022"/>
              <a:gd name="connsiteX39" fmla="*/ 179514 w 560981"/>
              <a:gd name="connsiteY39" fmla="*/ 1239769 h 1330022"/>
              <a:gd name="connsiteX40" fmla="*/ 129025 w 560981"/>
              <a:gd name="connsiteY40" fmla="*/ 1279038 h 1330022"/>
              <a:gd name="connsiteX41" fmla="*/ 95367 w 560981"/>
              <a:gd name="connsiteY41" fmla="*/ 1295867 h 1330022"/>
              <a:gd name="connsiteX42" fmla="*/ 78537 w 560981"/>
              <a:gd name="connsiteY42" fmla="*/ 1312697 h 1330022"/>
              <a:gd name="connsiteX43" fmla="*/ 33659 w 560981"/>
              <a:gd name="connsiteY43" fmla="*/ 1329526 h 1330022"/>
              <a:gd name="connsiteX44" fmla="*/ 0 w 560981"/>
              <a:gd name="connsiteY44" fmla="*/ 1329526 h 133002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Lst>
            <a:rect l="l" t="t" r="r" b="b"/>
            <a:pathLst>
              <a:path w="560981" h="1330022">
                <a:moveTo>
                  <a:pt x="527322" y="0"/>
                </a:moveTo>
                <a:cubicBezTo>
                  <a:pt x="533750" y="10713"/>
                  <a:pt x="547995" y="29856"/>
                  <a:pt x="549762" y="44878"/>
                </a:cubicBezTo>
                <a:cubicBezTo>
                  <a:pt x="552828" y="70944"/>
                  <a:pt x="553278" y="97254"/>
                  <a:pt x="555371" y="123416"/>
                </a:cubicBezTo>
                <a:cubicBezTo>
                  <a:pt x="557018" y="144004"/>
                  <a:pt x="559111" y="164555"/>
                  <a:pt x="560981" y="185124"/>
                </a:cubicBezTo>
                <a:cubicBezTo>
                  <a:pt x="559111" y="194474"/>
                  <a:pt x="560660" y="205239"/>
                  <a:pt x="555371" y="213173"/>
                </a:cubicBezTo>
                <a:cubicBezTo>
                  <a:pt x="552091" y="218093"/>
                  <a:pt x="543831" y="216139"/>
                  <a:pt x="538542" y="218783"/>
                </a:cubicBezTo>
                <a:cubicBezTo>
                  <a:pt x="532512" y="221798"/>
                  <a:pt x="527743" y="226987"/>
                  <a:pt x="521713" y="230002"/>
                </a:cubicBezTo>
                <a:cubicBezTo>
                  <a:pt x="516424" y="232647"/>
                  <a:pt x="510318" y="233283"/>
                  <a:pt x="504883" y="235612"/>
                </a:cubicBezTo>
                <a:cubicBezTo>
                  <a:pt x="497197" y="238906"/>
                  <a:pt x="490208" y="243726"/>
                  <a:pt x="482444" y="246832"/>
                </a:cubicBezTo>
                <a:cubicBezTo>
                  <a:pt x="471463" y="251224"/>
                  <a:pt x="448785" y="258051"/>
                  <a:pt x="448785" y="258051"/>
                </a:cubicBezTo>
                <a:cubicBezTo>
                  <a:pt x="408088" y="312317"/>
                  <a:pt x="447764" y="254485"/>
                  <a:pt x="426346" y="297320"/>
                </a:cubicBezTo>
                <a:cubicBezTo>
                  <a:pt x="423331" y="303351"/>
                  <a:pt x="417864" y="307989"/>
                  <a:pt x="415126" y="314150"/>
                </a:cubicBezTo>
                <a:cubicBezTo>
                  <a:pt x="410323" y="324957"/>
                  <a:pt x="410466" y="337968"/>
                  <a:pt x="403906" y="347808"/>
                </a:cubicBezTo>
                <a:cubicBezTo>
                  <a:pt x="389407" y="369558"/>
                  <a:pt x="394819" y="358242"/>
                  <a:pt x="387077" y="381467"/>
                </a:cubicBezTo>
                <a:cubicBezTo>
                  <a:pt x="388947" y="430086"/>
                  <a:pt x="389339" y="478784"/>
                  <a:pt x="392687" y="527323"/>
                </a:cubicBezTo>
                <a:cubicBezTo>
                  <a:pt x="393094" y="533222"/>
                  <a:pt x="394603" y="539535"/>
                  <a:pt x="398297" y="544152"/>
                </a:cubicBezTo>
                <a:cubicBezTo>
                  <a:pt x="402509" y="549417"/>
                  <a:pt x="409516" y="551632"/>
                  <a:pt x="415126" y="555372"/>
                </a:cubicBezTo>
                <a:cubicBezTo>
                  <a:pt x="416996" y="581551"/>
                  <a:pt x="414725" y="608361"/>
                  <a:pt x="420736" y="633909"/>
                </a:cubicBezTo>
                <a:cubicBezTo>
                  <a:pt x="422553" y="641631"/>
                  <a:pt x="433712" y="643803"/>
                  <a:pt x="437565" y="650738"/>
                </a:cubicBezTo>
                <a:cubicBezTo>
                  <a:pt x="443309" y="661076"/>
                  <a:pt x="442225" y="674557"/>
                  <a:pt x="448785" y="684397"/>
                </a:cubicBezTo>
                <a:lnTo>
                  <a:pt x="460005" y="701227"/>
                </a:lnTo>
                <a:cubicBezTo>
                  <a:pt x="461875" y="706837"/>
                  <a:pt x="461920" y="713439"/>
                  <a:pt x="465614" y="718056"/>
                </a:cubicBezTo>
                <a:cubicBezTo>
                  <a:pt x="469826" y="723321"/>
                  <a:pt x="480981" y="722694"/>
                  <a:pt x="482444" y="729276"/>
                </a:cubicBezTo>
                <a:cubicBezTo>
                  <a:pt x="485312" y="742184"/>
                  <a:pt x="478845" y="755476"/>
                  <a:pt x="476834" y="768545"/>
                </a:cubicBezTo>
                <a:cubicBezTo>
                  <a:pt x="474919" y="780994"/>
                  <a:pt x="472394" y="805472"/>
                  <a:pt x="465614" y="819033"/>
                </a:cubicBezTo>
                <a:cubicBezTo>
                  <a:pt x="455168" y="839925"/>
                  <a:pt x="453074" y="834081"/>
                  <a:pt x="437565" y="852692"/>
                </a:cubicBezTo>
                <a:cubicBezTo>
                  <a:pt x="398514" y="899554"/>
                  <a:pt x="458687" y="837180"/>
                  <a:pt x="409516" y="886351"/>
                </a:cubicBezTo>
                <a:cubicBezTo>
                  <a:pt x="407646" y="891961"/>
                  <a:pt x="406840" y="898046"/>
                  <a:pt x="403906" y="903180"/>
                </a:cubicBezTo>
                <a:cubicBezTo>
                  <a:pt x="399267" y="911298"/>
                  <a:pt x="392511" y="918011"/>
                  <a:pt x="387077" y="925619"/>
                </a:cubicBezTo>
                <a:cubicBezTo>
                  <a:pt x="383158" y="931106"/>
                  <a:pt x="379597" y="936839"/>
                  <a:pt x="375857" y="942449"/>
                </a:cubicBezTo>
                <a:cubicBezTo>
                  <a:pt x="361761" y="984741"/>
                  <a:pt x="380774" y="932617"/>
                  <a:pt x="359028" y="976108"/>
                </a:cubicBezTo>
                <a:cubicBezTo>
                  <a:pt x="356383" y="981397"/>
                  <a:pt x="355747" y="987502"/>
                  <a:pt x="353418" y="992937"/>
                </a:cubicBezTo>
                <a:cubicBezTo>
                  <a:pt x="350124" y="1000624"/>
                  <a:pt x="345938" y="1007897"/>
                  <a:pt x="342198" y="1015377"/>
                </a:cubicBezTo>
                <a:cubicBezTo>
                  <a:pt x="343611" y="1029508"/>
                  <a:pt x="354344" y="1091655"/>
                  <a:pt x="342198" y="1110743"/>
                </a:cubicBezTo>
                <a:cubicBezTo>
                  <a:pt x="332372" y="1126185"/>
                  <a:pt x="305039" y="1131073"/>
                  <a:pt x="291710" y="1144402"/>
                </a:cubicBezTo>
                <a:cubicBezTo>
                  <a:pt x="280490" y="1155622"/>
                  <a:pt x="266852" y="1164858"/>
                  <a:pt x="258051" y="1178061"/>
                </a:cubicBezTo>
                <a:cubicBezTo>
                  <a:pt x="254311" y="1183671"/>
                  <a:pt x="251906" y="1190451"/>
                  <a:pt x="246832" y="1194891"/>
                </a:cubicBezTo>
                <a:cubicBezTo>
                  <a:pt x="236684" y="1203771"/>
                  <a:pt x="224393" y="1209850"/>
                  <a:pt x="213173" y="1217330"/>
                </a:cubicBezTo>
                <a:lnTo>
                  <a:pt x="196343" y="1228550"/>
                </a:lnTo>
                <a:cubicBezTo>
                  <a:pt x="190733" y="1232290"/>
                  <a:pt x="184281" y="1235002"/>
                  <a:pt x="179514" y="1239769"/>
                </a:cubicBezTo>
                <a:cubicBezTo>
                  <a:pt x="153149" y="1266134"/>
                  <a:pt x="169285" y="1252199"/>
                  <a:pt x="129025" y="1279038"/>
                </a:cubicBezTo>
                <a:cubicBezTo>
                  <a:pt x="107276" y="1293537"/>
                  <a:pt x="118592" y="1288125"/>
                  <a:pt x="95367" y="1295867"/>
                </a:cubicBezTo>
                <a:cubicBezTo>
                  <a:pt x="89757" y="1301477"/>
                  <a:pt x="84993" y="1308086"/>
                  <a:pt x="78537" y="1312697"/>
                </a:cubicBezTo>
                <a:cubicBezTo>
                  <a:pt x="67528" y="1320560"/>
                  <a:pt x="47315" y="1328160"/>
                  <a:pt x="33659" y="1329526"/>
                </a:cubicBezTo>
                <a:cubicBezTo>
                  <a:pt x="22495" y="1330642"/>
                  <a:pt x="11220" y="1329526"/>
                  <a:pt x="0" y="1329526"/>
                </a:cubicBezTo>
              </a:path>
            </a:pathLst>
          </a:custGeom>
          <a:noFill/>
          <a:ln w="9525">
            <a:solidFill>
              <a:srgbClr val="FFFF0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37" name="Figura a mano libera 36"/>
          <p:cNvSpPr/>
          <p:nvPr/>
        </p:nvSpPr>
        <p:spPr>
          <a:xfrm>
            <a:off x="2514132" y="3605997"/>
            <a:ext cx="370248" cy="1381375"/>
          </a:xfrm>
          <a:custGeom>
            <a:avLst/>
            <a:gdLst>
              <a:gd name="connsiteX0" fmla="*/ 527322 w 560981"/>
              <a:gd name="connsiteY0" fmla="*/ 0 h 1330022"/>
              <a:gd name="connsiteX1" fmla="*/ 549762 w 560981"/>
              <a:gd name="connsiteY1" fmla="*/ 44878 h 1330022"/>
              <a:gd name="connsiteX2" fmla="*/ 555371 w 560981"/>
              <a:gd name="connsiteY2" fmla="*/ 123416 h 1330022"/>
              <a:gd name="connsiteX3" fmla="*/ 560981 w 560981"/>
              <a:gd name="connsiteY3" fmla="*/ 185124 h 1330022"/>
              <a:gd name="connsiteX4" fmla="*/ 555371 w 560981"/>
              <a:gd name="connsiteY4" fmla="*/ 213173 h 1330022"/>
              <a:gd name="connsiteX5" fmla="*/ 538542 w 560981"/>
              <a:gd name="connsiteY5" fmla="*/ 218783 h 1330022"/>
              <a:gd name="connsiteX6" fmla="*/ 521713 w 560981"/>
              <a:gd name="connsiteY6" fmla="*/ 230002 h 1330022"/>
              <a:gd name="connsiteX7" fmla="*/ 504883 w 560981"/>
              <a:gd name="connsiteY7" fmla="*/ 235612 h 1330022"/>
              <a:gd name="connsiteX8" fmla="*/ 482444 w 560981"/>
              <a:gd name="connsiteY8" fmla="*/ 246832 h 1330022"/>
              <a:gd name="connsiteX9" fmla="*/ 448785 w 560981"/>
              <a:gd name="connsiteY9" fmla="*/ 258051 h 1330022"/>
              <a:gd name="connsiteX10" fmla="*/ 426346 w 560981"/>
              <a:gd name="connsiteY10" fmla="*/ 297320 h 1330022"/>
              <a:gd name="connsiteX11" fmla="*/ 415126 w 560981"/>
              <a:gd name="connsiteY11" fmla="*/ 314150 h 1330022"/>
              <a:gd name="connsiteX12" fmla="*/ 403906 w 560981"/>
              <a:gd name="connsiteY12" fmla="*/ 347808 h 1330022"/>
              <a:gd name="connsiteX13" fmla="*/ 387077 w 560981"/>
              <a:gd name="connsiteY13" fmla="*/ 381467 h 1330022"/>
              <a:gd name="connsiteX14" fmla="*/ 392687 w 560981"/>
              <a:gd name="connsiteY14" fmla="*/ 527323 h 1330022"/>
              <a:gd name="connsiteX15" fmla="*/ 398297 w 560981"/>
              <a:gd name="connsiteY15" fmla="*/ 544152 h 1330022"/>
              <a:gd name="connsiteX16" fmla="*/ 415126 w 560981"/>
              <a:gd name="connsiteY16" fmla="*/ 555372 h 1330022"/>
              <a:gd name="connsiteX17" fmla="*/ 420736 w 560981"/>
              <a:gd name="connsiteY17" fmla="*/ 633909 h 1330022"/>
              <a:gd name="connsiteX18" fmla="*/ 437565 w 560981"/>
              <a:gd name="connsiteY18" fmla="*/ 650738 h 1330022"/>
              <a:gd name="connsiteX19" fmla="*/ 448785 w 560981"/>
              <a:gd name="connsiteY19" fmla="*/ 684397 h 1330022"/>
              <a:gd name="connsiteX20" fmla="*/ 460005 w 560981"/>
              <a:gd name="connsiteY20" fmla="*/ 701227 h 1330022"/>
              <a:gd name="connsiteX21" fmla="*/ 465614 w 560981"/>
              <a:gd name="connsiteY21" fmla="*/ 718056 h 1330022"/>
              <a:gd name="connsiteX22" fmla="*/ 482444 w 560981"/>
              <a:gd name="connsiteY22" fmla="*/ 729276 h 1330022"/>
              <a:gd name="connsiteX23" fmla="*/ 476834 w 560981"/>
              <a:gd name="connsiteY23" fmla="*/ 768545 h 1330022"/>
              <a:gd name="connsiteX24" fmla="*/ 465614 w 560981"/>
              <a:gd name="connsiteY24" fmla="*/ 819033 h 1330022"/>
              <a:gd name="connsiteX25" fmla="*/ 437565 w 560981"/>
              <a:gd name="connsiteY25" fmla="*/ 852692 h 1330022"/>
              <a:gd name="connsiteX26" fmla="*/ 409516 w 560981"/>
              <a:gd name="connsiteY26" fmla="*/ 886351 h 1330022"/>
              <a:gd name="connsiteX27" fmla="*/ 403906 w 560981"/>
              <a:gd name="connsiteY27" fmla="*/ 903180 h 1330022"/>
              <a:gd name="connsiteX28" fmla="*/ 387077 w 560981"/>
              <a:gd name="connsiteY28" fmla="*/ 925619 h 1330022"/>
              <a:gd name="connsiteX29" fmla="*/ 375857 w 560981"/>
              <a:gd name="connsiteY29" fmla="*/ 942449 h 1330022"/>
              <a:gd name="connsiteX30" fmla="*/ 359028 w 560981"/>
              <a:gd name="connsiteY30" fmla="*/ 976108 h 1330022"/>
              <a:gd name="connsiteX31" fmla="*/ 353418 w 560981"/>
              <a:gd name="connsiteY31" fmla="*/ 992937 h 1330022"/>
              <a:gd name="connsiteX32" fmla="*/ 342198 w 560981"/>
              <a:gd name="connsiteY32" fmla="*/ 1015377 h 1330022"/>
              <a:gd name="connsiteX33" fmla="*/ 342198 w 560981"/>
              <a:gd name="connsiteY33" fmla="*/ 1110743 h 1330022"/>
              <a:gd name="connsiteX34" fmla="*/ 291710 w 560981"/>
              <a:gd name="connsiteY34" fmla="*/ 1144402 h 1330022"/>
              <a:gd name="connsiteX35" fmla="*/ 258051 w 560981"/>
              <a:gd name="connsiteY35" fmla="*/ 1178061 h 1330022"/>
              <a:gd name="connsiteX36" fmla="*/ 246832 w 560981"/>
              <a:gd name="connsiteY36" fmla="*/ 1194891 h 1330022"/>
              <a:gd name="connsiteX37" fmla="*/ 213173 w 560981"/>
              <a:gd name="connsiteY37" fmla="*/ 1217330 h 1330022"/>
              <a:gd name="connsiteX38" fmla="*/ 196343 w 560981"/>
              <a:gd name="connsiteY38" fmla="*/ 1228550 h 1330022"/>
              <a:gd name="connsiteX39" fmla="*/ 179514 w 560981"/>
              <a:gd name="connsiteY39" fmla="*/ 1239769 h 1330022"/>
              <a:gd name="connsiteX40" fmla="*/ 129025 w 560981"/>
              <a:gd name="connsiteY40" fmla="*/ 1279038 h 1330022"/>
              <a:gd name="connsiteX41" fmla="*/ 95367 w 560981"/>
              <a:gd name="connsiteY41" fmla="*/ 1295867 h 1330022"/>
              <a:gd name="connsiteX42" fmla="*/ 78537 w 560981"/>
              <a:gd name="connsiteY42" fmla="*/ 1312697 h 1330022"/>
              <a:gd name="connsiteX43" fmla="*/ 33659 w 560981"/>
              <a:gd name="connsiteY43" fmla="*/ 1329526 h 1330022"/>
              <a:gd name="connsiteX44" fmla="*/ 0 w 560981"/>
              <a:gd name="connsiteY44" fmla="*/ 1329526 h 133002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Lst>
            <a:rect l="l" t="t" r="r" b="b"/>
            <a:pathLst>
              <a:path w="560981" h="1330022">
                <a:moveTo>
                  <a:pt x="527322" y="0"/>
                </a:moveTo>
                <a:cubicBezTo>
                  <a:pt x="533750" y="10713"/>
                  <a:pt x="547995" y="29856"/>
                  <a:pt x="549762" y="44878"/>
                </a:cubicBezTo>
                <a:cubicBezTo>
                  <a:pt x="552828" y="70944"/>
                  <a:pt x="553278" y="97254"/>
                  <a:pt x="555371" y="123416"/>
                </a:cubicBezTo>
                <a:cubicBezTo>
                  <a:pt x="557018" y="144004"/>
                  <a:pt x="559111" y="164555"/>
                  <a:pt x="560981" y="185124"/>
                </a:cubicBezTo>
                <a:cubicBezTo>
                  <a:pt x="559111" y="194474"/>
                  <a:pt x="560660" y="205239"/>
                  <a:pt x="555371" y="213173"/>
                </a:cubicBezTo>
                <a:cubicBezTo>
                  <a:pt x="552091" y="218093"/>
                  <a:pt x="543831" y="216139"/>
                  <a:pt x="538542" y="218783"/>
                </a:cubicBezTo>
                <a:cubicBezTo>
                  <a:pt x="532512" y="221798"/>
                  <a:pt x="527743" y="226987"/>
                  <a:pt x="521713" y="230002"/>
                </a:cubicBezTo>
                <a:cubicBezTo>
                  <a:pt x="516424" y="232647"/>
                  <a:pt x="510318" y="233283"/>
                  <a:pt x="504883" y="235612"/>
                </a:cubicBezTo>
                <a:cubicBezTo>
                  <a:pt x="497197" y="238906"/>
                  <a:pt x="490208" y="243726"/>
                  <a:pt x="482444" y="246832"/>
                </a:cubicBezTo>
                <a:cubicBezTo>
                  <a:pt x="471463" y="251224"/>
                  <a:pt x="448785" y="258051"/>
                  <a:pt x="448785" y="258051"/>
                </a:cubicBezTo>
                <a:cubicBezTo>
                  <a:pt x="408088" y="312317"/>
                  <a:pt x="447764" y="254485"/>
                  <a:pt x="426346" y="297320"/>
                </a:cubicBezTo>
                <a:cubicBezTo>
                  <a:pt x="423331" y="303351"/>
                  <a:pt x="417864" y="307989"/>
                  <a:pt x="415126" y="314150"/>
                </a:cubicBezTo>
                <a:cubicBezTo>
                  <a:pt x="410323" y="324957"/>
                  <a:pt x="410466" y="337968"/>
                  <a:pt x="403906" y="347808"/>
                </a:cubicBezTo>
                <a:cubicBezTo>
                  <a:pt x="389407" y="369558"/>
                  <a:pt x="394819" y="358242"/>
                  <a:pt x="387077" y="381467"/>
                </a:cubicBezTo>
                <a:cubicBezTo>
                  <a:pt x="388947" y="430086"/>
                  <a:pt x="389339" y="478784"/>
                  <a:pt x="392687" y="527323"/>
                </a:cubicBezTo>
                <a:cubicBezTo>
                  <a:pt x="393094" y="533222"/>
                  <a:pt x="394603" y="539535"/>
                  <a:pt x="398297" y="544152"/>
                </a:cubicBezTo>
                <a:cubicBezTo>
                  <a:pt x="402509" y="549417"/>
                  <a:pt x="409516" y="551632"/>
                  <a:pt x="415126" y="555372"/>
                </a:cubicBezTo>
                <a:cubicBezTo>
                  <a:pt x="416996" y="581551"/>
                  <a:pt x="414725" y="608361"/>
                  <a:pt x="420736" y="633909"/>
                </a:cubicBezTo>
                <a:cubicBezTo>
                  <a:pt x="422553" y="641631"/>
                  <a:pt x="433712" y="643803"/>
                  <a:pt x="437565" y="650738"/>
                </a:cubicBezTo>
                <a:cubicBezTo>
                  <a:pt x="443309" y="661076"/>
                  <a:pt x="442225" y="674557"/>
                  <a:pt x="448785" y="684397"/>
                </a:cubicBezTo>
                <a:lnTo>
                  <a:pt x="460005" y="701227"/>
                </a:lnTo>
                <a:cubicBezTo>
                  <a:pt x="461875" y="706837"/>
                  <a:pt x="461920" y="713439"/>
                  <a:pt x="465614" y="718056"/>
                </a:cubicBezTo>
                <a:cubicBezTo>
                  <a:pt x="469826" y="723321"/>
                  <a:pt x="480981" y="722694"/>
                  <a:pt x="482444" y="729276"/>
                </a:cubicBezTo>
                <a:cubicBezTo>
                  <a:pt x="485312" y="742184"/>
                  <a:pt x="478845" y="755476"/>
                  <a:pt x="476834" y="768545"/>
                </a:cubicBezTo>
                <a:cubicBezTo>
                  <a:pt x="474919" y="780994"/>
                  <a:pt x="472394" y="805472"/>
                  <a:pt x="465614" y="819033"/>
                </a:cubicBezTo>
                <a:cubicBezTo>
                  <a:pt x="455168" y="839925"/>
                  <a:pt x="453074" y="834081"/>
                  <a:pt x="437565" y="852692"/>
                </a:cubicBezTo>
                <a:cubicBezTo>
                  <a:pt x="398514" y="899554"/>
                  <a:pt x="458687" y="837180"/>
                  <a:pt x="409516" y="886351"/>
                </a:cubicBezTo>
                <a:cubicBezTo>
                  <a:pt x="407646" y="891961"/>
                  <a:pt x="406840" y="898046"/>
                  <a:pt x="403906" y="903180"/>
                </a:cubicBezTo>
                <a:cubicBezTo>
                  <a:pt x="399267" y="911298"/>
                  <a:pt x="392511" y="918011"/>
                  <a:pt x="387077" y="925619"/>
                </a:cubicBezTo>
                <a:cubicBezTo>
                  <a:pt x="383158" y="931106"/>
                  <a:pt x="379597" y="936839"/>
                  <a:pt x="375857" y="942449"/>
                </a:cubicBezTo>
                <a:cubicBezTo>
                  <a:pt x="361761" y="984741"/>
                  <a:pt x="380774" y="932617"/>
                  <a:pt x="359028" y="976108"/>
                </a:cubicBezTo>
                <a:cubicBezTo>
                  <a:pt x="356383" y="981397"/>
                  <a:pt x="355747" y="987502"/>
                  <a:pt x="353418" y="992937"/>
                </a:cubicBezTo>
                <a:cubicBezTo>
                  <a:pt x="350124" y="1000624"/>
                  <a:pt x="345938" y="1007897"/>
                  <a:pt x="342198" y="1015377"/>
                </a:cubicBezTo>
                <a:cubicBezTo>
                  <a:pt x="343611" y="1029508"/>
                  <a:pt x="354344" y="1091655"/>
                  <a:pt x="342198" y="1110743"/>
                </a:cubicBezTo>
                <a:cubicBezTo>
                  <a:pt x="332372" y="1126185"/>
                  <a:pt x="305039" y="1131073"/>
                  <a:pt x="291710" y="1144402"/>
                </a:cubicBezTo>
                <a:cubicBezTo>
                  <a:pt x="280490" y="1155622"/>
                  <a:pt x="266852" y="1164858"/>
                  <a:pt x="258051" y="1178061"/>
                </a:cubicBezTo>
                <a:cubicBezTo>
                  <a:pt x="254311" y="1183671"/>
                  <a:pt x="251906" y="1190451"/>
                  <a:pt x="246832" y="1194891"/>
                </a:cubicBezTo>
                <a:cubicBezTo>
                  <a:pt x="236684" y="1203771"/>
                  <a:pt x="224393" y="1209850"/>
                  <a:pt x="213173" y="1217330"/>
                </a:cubicBezTo>
                <a:lnTo>
                  <a:pt x="196343" y="1228550"/>
                </a:lnTo>
                <a:cubicBezTo>
                  <a:pt x="190733" y="1232290"/>
                  <a:pt x="184281" y="1235002"/>
                  <a:pt x="179514" y="1239769"/>
                </a:cubicBezTo>
                <a:cubicBezTo>
                  <a:pt x="153149" y="1266134"/>
                  <a:pt x="169285" y="1252199"/>
                  <a:pt x="129025" y="1279038"/>
                </a:cubicBezTo>
                <a:cubicBezTo>
                  <a:pt x="107276" y="1293537"/>
                  <a:pt x="118592" y="1288125"/>
                  <a:pt x="95367" y="1295867"/>
                </a:cubicBezTo>
                <a:cubicBezTo>
                  <a:pt x="89757" y="1301477"/>
                  <a:pt x="84993" y="1308086"/>
                  <a:pt x="78537" y="1312697"/>
                </a:cubicBezTo>
                <a:cubicBezTo>
                  <a:pt x="67528" y="1320560"/>
                  <a:pt x="47315" y="1328160"/>
                  <a:pt x="33659" y="1329526"/>
                </a:cubicBezTo>
                <a:cubicBezTo>
                  <a:pt x="22495" y="1330642"/>
                  <a:pt x="11220" y="1329526"/>
                  <a:pt x="0" y="1329526"/>
                </a:cubicBezTo>
              </a:path>
            </a:pathLst>
          </a:custGeom>
          <a:noFill/>
          <a:ln w="9525">
            <a:solidFill>
              <a:srgbClr val="FFFF0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38" name="Figura a mano libera 37"/>
          <p:cNvSpPr/>
          <p:nvPr/>
        </p:nvSpPr>
        <p:spPr>
          <a:xfrm>
            <a:off x="3906296" y="3605997"/>
            <a:ext cx="370248" cy="1381375"/>
          </a:xfrm>
          <a:custGeom>
            <a:avLst/>
            <a:gdLst>
              <a:gd name="connsiteX0" fmla="*/ 527322 w 560981"/>
              <a:gd name="connsiteY0" fmla="*/ 0 h 1330022"/>
              <a:gd name="connsiteX1" fmla="*/ 549762 w 560981"/>
              <a:gd name="connsiteY1" fmla="*/ 44878 h 1330022"/>
              <a:gd name="connsiteX2" fmla="*/ 555371 w 560981"/>
              <a:gd name="connsiteY2" fmla="*/ 123416 h 1330022"/>
              <a:gd name="connsiteX3" fmla="*/ 560981 w 560981"/>
              <a:gd name="connsiteY3" fmla="*/ 185124 h 1330022"/>
              <a:gd name="connsiteX4" fmla="*/ 555371 w 560981"/>
              <a:gd name="connsiteY4" fmla="*/ 213173 h 1330022"/>
              <a:gd name="connsiteX5" fmla="*/ 538542 w 560981"/>
              <a:gd name="connsiteY5" fmla="*/ 218783 h 1330022"/>
              <a:gd name="connsiteX6" fmla="*/ 521713 w 560981"/>
              <a:gd name="connsiteY6" fmla="*/ 230002 h 1330022"/>
              <a:gd name="connsiteX7" fmla="*/ 504883 w 560981"/>
              <a:gd name="connsiteY7" fmla="*/ 235612 h 1330022"/>
              <a:gd name="connsiteX8" fmla="*/ 482444 w 560981"/>
              <a:gd name="connsiteY8" fmla="*/ 246832 h 1330022"/>
              <a:gd name="connsiteX9" fmla="*/ 448785 w 560981"/>
              <a:gd name="connsiteY9" fmla="*/ 258051 h 1330022"/>
              <a:gd name="connsiteX10" fmla="*/ 426346 w 560981"/>
              <a:gd name="connsiteY10" fmla="*/ 297320 h 1330022"/>
              <a:gd name="connsiteX11" fmla="*/ 415126 w 560981"/>
              <a:gd name="connsiteY11" fmla="*/ 314150 h 1330022"/>
              <a:gd name="connsiteX12" fmla="*/ 403906 w 560981"/>
              <a:gd name="connsiteY12" fmla="*/ 347808 h 1330022"/>
              <a:gd name="connsiteX13" fmla="*/ 387077 w 560981"/>
              <a:gd name="connsiteY13" fmla="*/ 381467 h 1330022"/>
              <a:gd name="connsiteX14" fmla="*/ 392687 w 560981"/>
              <a:gd name="connsiteY14" fmla="*/ 527323 h 1330022"/>
              <a:gd name="connsiteX15" fmla="*/ 398297 w 560981"/>
              <a:gd name="connsiteY15" fmla="*/ 544152 h 1330022"/>
              <a:gd name="connsiteX16" fmla="*/ 415126 w 560981"/>
              <a:gd name="connsiteY16" fmla="*/ 555372 h 1330022"/>
              <a:gd name="connsiteX17" fmla="*/ 420736 w 560981"/>
              <a:gd name="connsiteY17" fmla="*/ 633909 h 1330022"/>
              <a:gd name="connsiteX18" fmla="*/ 437565 w 560981"/>
              <a:gd name="connsiteY18" fmla="*/ 650738 h 1330022"/>
              <a:gd name="connsiteX19" fmla="*/ 448785 w 560981"/>
              <a:gd name="connsiteY19" fmla="*/ 684397 h 1330022"/>
              <a:gd name="connsiteX20" fmla="*/ 460005 w 560981"/>
              <a:gd name="connsiteY20" fmla="*/ 701227 h 1330022"/>
              <a:gd name="connsiteX21" fmla="*/ 465614 w 560981"/>
              <a:gd name="connsiteY21" fmla="*/ 718056 h 1330022"/>
              <a:gd name="connsiteX22" fmla="*/ 482444 w 560981"/>
              <a:gd name="connsiteY22" fmla="*/ 729276 h 1330022"/>
              <a:gd name="connsiteX23" fmla="*/ 476834 w 560981"/>
              <a:gd name="connsiteY23" fmla="*/ 768545 h 1330022"/>
              <a:gd name="connsiteX24" fmla="*/ 465614 w 560981"/>
              <a:gd name="connsiteY24" fmla="*/ 819033 h 1330022"/>
              <a:gd name="connsiteX25" fmla="*/ 437565 w 560981"/>
              <a:gd name="connsiteY25" fmla="*/ 852692 h 1330022"/>
              <a:gd name="connsiteX26" fmla="*/ 409516 w 560981"/>
              <a:gd name="connsiteY26" fmla="*/ 886351 h 1330022"/>
              <a:gd name="connsiteX27" fmla="*/ 403906 w 560981"/>
              <a:gd name="connsiteY27" fmla="*/ 903180 h 1330022"/>
              <a:gd name="connsiteX28" fmla="*/ 387077 w 560981"/>
              <a:gd name="connsiteY28" fmla="*/ 925619 h 1330022"/>
              <a:gd name="connsiteX29" fmla="*/ 375857 w 560981"/>
              <a:gd name="connsiteY29" fmla="*/ 942449 h 1330022"/>
              <a:gd name="connsiteX30" fmla="*/ 359028 w 560981"/>
              <a:gd name="connsiteY30" fmla="*/ 976108 h 1330022"/>
              <a:gd name="connsiteX31" fmla="*/ 353418 w 560981"/>
              <a:gd name="connsiteY31" fmla="*/ 992937 h 1330022"/>
              <a:gd name="connsiteX32" fmla="*/ 342198 w 560981"/>
              <a:gd name="connsiteY32" fmla="*/ 1015377 h 1330022"/>
              <a:gd name="connsiteX33" fmla="*/ 342198 w 560981"/>
              <a:gd name="connsiteY33" fmla="*/ 1110743 h 1330022"/>
              <a:gd name="connsiteX34" fmla="*/ 291710 w 560981"/>
              <a:gd name="connsiteY34" fmla="*/ 1144402 h 1330022"/>
              <a:gd name="connsiteX35" fmla="*/ 258051 w 560981"/>
              <a:gd name="connsiteY35" fmla="*/ 1178061 h 1330022"/>
              <a:gd name="connsiteX36" fmla="*/ 246832 w 560981"/>
              <a:gd name="connsiteY36" fmla="*/ 1194891 h 1330022"/>
              <a:gd name="connsiteX37" fmla="*/ 213173 w 560981"/>
              <a:gd name="connsiteY37" fmla="*/ 1217330 h 1330022"/>
              <a:gd name="connsiteX38" fmla="*/ 196343 w 560981"/>
              <a:gd name="connsiteY38" fmla="*/ 1228550 h 1330022"/>
              <a:gd name="connsiteX39" fmla="*/ 179514 w 560981"/>
              <a:gd name="connsiteY39" fmla="*/ 1239769 h 1330022"/>
              <a:gd name="connsiteX40" fmla="*/ 129025 w 560981"/>
              <a:gd name="connsiteY40" fmla="*/ 1279038 h 1330022"/>
              <a:gd name="connsiteX41" fmla="*/ 95367 w 560981"/>
              <a:gd name="connsiteY41" fmla="*/ 1295867 h 1330022"/>
              <a:gd name="connsiteX42" fmla="*/ 78537 w 560981"/>
              <a:gd name="connsiteY42" fmla="*/ 1312697 h 1330022"/>
              <a:gd name="connsiteX43" fmla="*/ 33659 w 560981"/>
              <a:gd name="connsiteY43" fmla="*/ 1329526 h 1330022"/>
              <a:gd name="connsiteX44" fmla="*/ 0 w 560981"/>
              <a:gd name="connsiteY44" fmla="*/ 1329526 h 133002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Lst>
            <a:rect l="l" t="t" r="r" b="b"/>
            <a:pathLst>
              <a:path w="560981" h="1330022">
                <a:moveTo>
                  <a:pt x="527322" y="0"/>
                </a:moveTo>
                <a:cubicBezTo>
                  <a:pt x="533750" y="10713"/>
                  <a:pt x="547995" y="29856"/>
                  <a:pt x="549762" y="44878"/>
                </a:cubicBezTo>
                <a:cubicBezTo>
                  <a:pt x="552828" y="70944"/>
                  <a:pt x="553278" y="97254"/>
                  <a:pt x="555371" y="123416"/>
                </a:cubicBezTo>
                <a:cubicBezTo>
                  <a:pt x="557018" y="144004"/>
                  <a:pt x="559111" y="164555"/>
                  <a:pt x="560981" y="185124"/>
                </a:cubicBezTo>
                <a:cubicBezTo>
                  <a:pt x="559111" y="194474"/>
                  <a:pt x="560660" y="205239"/>
                  <a:pt x="555371" y="213173"/>
                </a:cubicBezTo>
                <a:cubicBezTo>
                  <a:pt x="552091" y="218093"/>
                  <a:pt x="543831" y="216139"/>
                  <a:pt x="538542" y="218783"/>
                </a:cubicBezTo>
                <a:cubicBezTo>
                  <a:pt x="532512" y="221798"/>
                  <a:pt x="527743" y="226987"/>
                  <a:pt x="521713" y="230002"/>
                </a:cubicBezTo>
                <a:cubicBezTo>
                  <a:pt x="516424" y="232647"/>
                  <a:pt x="510318" y="233283"/>
                  <a:pt x="504883" y="235612"/>
                </a:cubicBezTo>
                <a:cubicBezTo>
                  <a:pt x="497197" y="238906"/>
                  <a:pt x="490208" y="243726"/>
                  <a:pt x="482444" y="246832"/>
                </a:cubicBezTo>
                <a:cubicBezTo>
                  <a:pt x="471463" y="251224"/>
                  <a:pt x="448785" y="258051"/>
                  <a:pt x="448785" y="258051"/>
                </a:cubicBezTo>
                <a:cubicBezTo>
                  <a:pt x="408088" y="312317"/>
                  <a:pt x="447764" y="254485"/>
                  <a:pt x="426346" y="297320"/>
                </a:cubicBezTo>
                <a:cubicBezTo>
                  <a:pt x="423331" y="303351"/>
                  <a:pt x="417864" y="307989"/>
                  <a:pt x="415126" y="314150"/>
                </a:cubicBezTo>
                <a:cubicBezTo>
                  <a:pt x="410323" y="324957"/>
                  <a:pt x="410466" y="337968"/>
                  <a:pt x="403906" y="347808"/>
                </a:cubicBezTo>
                <a:cubicBezTo>
                  <a:pt x="389407" y="369558"/>
                  <a:pt x="394819" y="358242"/>
                  <a:pt x="387077" y="381467"/>
                </a:cubicBezTo>
                <a:cubicBezTo>
                  <a:pt x="388947" y="430086"/>
                  <a:pt x="389339" y="478784"/>
                  <a:pt x="392687" y="527323"/>
                </a:cubicBezTo>
                <a:cubicBezTo>
                  <a:pt x="393094" y="533222"/>
                  <a:pt x="394603" y="539535"/>
                  <a:pt x="398297" y="544152"/>
                </a:cubicBezTo>
                <a:cubicBezTo>
                  <a:pt x="402509" y="549417"/>
                  <a:pt x="409516" y="551632"/>
                  <a:pt x="415126" y="555372"/>
                </a:cubicBezTo>
                <a:cubicBezTo>
                  <a:pt x="416996" y="581551"/>
                  <a:pt x="414725" y="608361"/>
                  <a:pt x="420736" y="633909"/>
                </a:cubicBezTo>
                <a:cubicBezTo>
                  <a:pt x="422553" y="641631"/>
                  <a:pt x="433712" y="643803"/>
                  <a:pt x="437565" y="650738"/>
                </a:cubicBezTo>
                <a:cubicBezTo>
                  <a:pt x="443309" y="661076"/>
                  <a:pt x="442225" y="674557"/>
                  <a:pt x="448785" y="684397"/>
                </a:cubicBezTo>
                <a:lnTo>
                  <a:pt x="460005" y="701227"/>
                </a:lnTo>
                <a:cubicBezTo>
                  <a:pt x="461875" y="706837"/>
                  <a:pt x="461920" y="713439"/>
                  <a:pt x="465614" y="718056"/>
                </a:cubicBezTo>
                <a:cubicBezTo>
                  <a:pt x="469826" y="723321"/>
                  <a:pt x="480981" y="722694"/>
                  <a:pt x="482444" y="729276"/>
                </a:cubicBezTo>
                <a:cubicBezTo>
                  <a:pt x="485312" y="742184"/>
                  <a:pt x="478845" y="755476"/>
                  <a:pt x="476834" y="768545"/>
                </a:cubicBezTo>
                <a:cubicBezTo>
                  <a:pt x="474919" y="780994"/>
                  <a:pt x="472394" y="805472"/>
                  <a:pt x="465614" y="819033"/>
                </a:cubicBezTo>
                <a:cubicBezTo>
                  <a:pt x="455168" y="839925"/>
                  <a:pt x="453074" y="834081"/>
                  <a:pt x="437565" y="852692"/>
                </a:cubicBezTo>
                <a:cubicBezTo>
                  <a:pt x="398514" y="899554"/>
                  <a:pt x="458687" y="837180"/>
                  <a:pt x="409516" y="886351"/>
                </a:cubicBezTo>
                <a:cubicBezTo>
                  <a:pt x="407646" y="891961"/>
                  <a:pt x="406840" y="898046"/>
                  <a:pt x="403906" y="903180"/>
                </a:cubicBezTo>
                <a:cubicBezTo>
                  <a:pt x="399267" y="911298"/>
                  <a:pt x="392511" y="918011"/>
                  <a:pt x="387077" y="925619"/>
                </a:cubicBezTo>
                <a:cubicBezTo>
                  <a:pt x="383158" y="931106"/>
                  <a:pt x="379597" y="936839"/>
                  <a:pt x="375857" y="942449"/>
                </a:cubicBezTo>
                <a:cubicBezTo>
                  <a:pt x="361761" y="984741"/>
                  <a:pt x="380774" y="932617"/>
                  <a:pt x="359028" y="976108"/>
                </a:cubicBezTo>
                <a:cubicBezTo>
                  <a:pt x="356383" y="981397"/>
                  <a:pt x="355747" y="987502"/>
                  <a:pt x="353418" y="992937"/>
                </a:cubicBezTo>
                <a:cubicBezTo>
                  <a:pt x="350124" y="1000624"/>
                  <a:pt x="345938" y="1007897"/>
                  <a:pt x="342198" y="1015377"/>
                </a:cubicBezTo>
                <a:cubicBezTo>
                  <a:pt x="343611" y="1029508"/>
                  <a:pt x="354344" y="1091655"/>
                  <a:pt x="342198" y="1110743"/>
                </a:cubicBezTo>
                <a:cubicBezTo>
                  <a:pt x="332372" y="1126185"/>
                  <a:pt x="305039" y="1131073"/>
                  <a:pt x="291710" y="1144402"/>
                </a:cubicBezTo>
                <a:cubicBezTo>
                  <a:pt x="280490" y="1155622"/>
                  <a:pt x="266852" y="1164858"/>
                  <a:pt x="258051" y="1178061"/>
                </a:cubicBezTo>
                <a:cubicBezTo>
                  <a:pt x="254311" y="1183671"/>
                  <a:pt x="251906" y="1190451"/>
                  <a:pt x="246832" y="1194891"/>
                </a:cubicBezTo>
                <a:cubicBezTo>
                  <a:pt x="236684" y="1203771"/>
                  <a:pt x="224393" y="1209850"/>
                  <a:pt x="213173" y="1217330"/>
                </a:cubicBezTo>
                <a:lnTo>
                  <a:pt x="196343" y="1228550"/>
                </a:lnTo>
                <a:cubicBezTo>
                  <a:pt x="190733" y="1232290"/>
                  <a:pt x="184281" y="1235002"/>
                  <a:pt x="179514" y="1239769"/>
                </a:cubicBezTo>
                <a:cubicBezTo>
                  <a:pt x="153149" y="1266134"/>
                  <a:pt x="169285" y="1252199"/>
                  <a:pt x="129025" y="1279038"/>
                </a:cubicBezTo>
                <a:cubicBezTo>
                  <a:pt x="107276" y="1293537"/>
                  <a:pt x="118592" y="1288125"/>
                  <a:pt x="95367" y="1295867"/>
                </a:cubicBezTo>
                <a:cubicBezTo>
                  <a:pt x="89757" y="1301477"/>
                  <a:pt x="84993" y="1308086"/>
                  <a:pt x="78537" y="1312697"/>
                </a:cubicBezTo>
                <a:cubicBezTo>
                  <a:pt x="67528" y="1320560"/>
                  <a:pt x="47315" y="1328160"/>
                  <a:pt x="33659" y="1329526"/>
                </a:cubicBezTo>
                <a:cubicBezTo>
                  <a:pt x="22495" y="1330642"/>
                  <a:pt x="11220" y="1329526"/>
                  <a:pt x="0" y="1329526"/>
                </a:cubicBezTo>
              </a:path>
            </a:pathLst>
          </a:custGeom>
          <a:noFill/>
          <a:ln w="9525">
            <a:solidFill>
              <a:srgbClr val="FFFF0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39" name="Figura a mano libera 38"/>
          <p:cNvSpPr/>
          <p:nvPr/>
        </p:nvSpPr>
        <p:spPr>
          <a:xfrm>
            <a:off x="5320904" y="3605997"/>
            <a:ext cx="370248" cy="1381375"/>
          </a:xfrm>
          <a:custGeom>
            <a:avLst/>
            <a:gdLst>
              <a:gd name="connsiteX0" fmla="*/ 527322 w 560981"/>
              <a:gd name="connsiteY0" fmla="*/ 0 h 1330022"/>
              <a:gd name="connsiteX1" fmla="*/ 549762 w 560981"/>
              <a:gd name="connsiteY1" fmla="*/ 44878 h 1330022"/>
              <a:gd name="connsiteX2" fmla="*/ 555371 w 560981"/>
              <a:gd name="connsiteY2" fmla="*/ 123416 h 1330022"/>
              <a:gd name="connsiteX3" fmla="*/ 560981 w 560981"/>
              <a:gd name="connsiteY3" fmla="*/ 185124 h 1330022"/>
              <a:gd name="connsiteX4" fmla="*/ 555371 w 560981"/>
              <a:gd name="connsiteY4" fmla="*/ 213173 h 1330022"/>
              <a:gd name="connsiteX5" fmla="*/ 538542 w 560981"/>
              <a:gd name="connsiteY5" fmla="*/ 218783 h 1330022"/>
              <a:gd name="connsiteX6" fmla="*/ 521713 w 560981"/>
              <a:gd name="connsiteY6" fmla="*/ 230002 h 1330022"/>
              <a:gd name="connsiteX7" fmla="*/ 504883 w 560981"/>
              <a:gd name="connsiteY7" fmla="*/ 235612 h 1330022"/>
              <a:gd name="connsiteX8" fmla="*/ 482444 w 560981"/>
              <a:gd name="connsiteY8" fmla="*/ 246832 h 1330022"/>
              <a:gd name="connsiteX9" fmla="*/ 448785 w 560981"/>
              <a:gd name="connsiteY9" fmla="*/ 258051 h 1330022"/>
              <a:gd name="connsiteX10" fmla="*/ 426346 w 560981"/>
              <a:gd name="connsiteY10" fmla="*/ 297320 h 1330022"/>
              <a:gd name="connsiteX11" fmla="*/ 415126 w 560981"/>
              <a:gd name="connsiteY11" fmla="*/ 314150 h 1330022"/>
              <a:gd name="connsiteX12" fmla="*/ 403906 w 560981"/>
              <a:gd name="connsiteY12" fmla="*/ 347808 h 1330022"/>
              <a:gd name="connsiteX13" fmla="*/ 387077 w 560981"/>
              <a:gd name="connsiteY13" fmla="*/ 381467 h 1330022"/>
              <a:gd name="connsiteX14" fmla="*/ 392687 w 560981"/>
              <a:gd name="connsiteY14" fmla="*/ 527323 h 1330022"/>
              <a:gd name="connsiteX15" fmla="*/ 398297 w 560981"/>
              <a:gd name="connsiteY15" fmla="*/ 544152 h 1330022"/>
              <a:gd name="connsiteX16" fmla="*/ 415126 w 560981"/>
              <a:gd name="connsiteY16" fmla="*/ 555372 h 1330022"/>
              <a:gd name="connsiteX17" fmla="*/ 420736 w 560981"/>
              <a:gd name="connsiteY17" fmla="*/ 633909 h 1330022"/>
              <a:gd name="connsiteX18" fmla="*/ 437565 w 560981"/>
              <a:gd name="connsiteY18" fmla="*/ 650738 h 1330022"/>
              <a:gd name="connsiteX19" fmla="*/ 448785 w 560981"/>
              <a:gd name="connsiteY19" fmla="*/ 684397 h 1330022"/>
              <a:gd name="connsiteX20" fmla="*/ 460005 w 560981"/>
              <a:gd name="connsiteY20" fmla="*/ 701227 h 1330022"/>
              <a:gd name="connsiteX21" fmla="*/ 465614 w 560981"/>
              <a:gd name="connsiteY21" fmla="*/ 718056 h 1330022"/>
              <a:gd name="connsiteX22" fmla="*/ 482444 w 560981"/>
              <a:gd name="connsiteY22" fmla="*/ 729276 h 1330022"/>
              <a:gd name="connsiteX23" fmla="*/ 476834 w 560981"/>
              <a:gd name="connsiteY23" fmla="*/ 768545 h 1330022"/>
              <a:gd name="connsiteX24" fmla="*/ 465614 w 560981"/>
              <a:gd name="connsiteY24" fmla="*/ 819033 h 1330022"/>
              <a:gd name="connsiteX25" fmla="*/ 437565 w 560981"/>
              <a:gd name="connsiteY25" fmla="*/ 852692 h 1330022"/>
              <a:gd name="connsiteX26" fmla="*/ 409516 w 560981"/>
              <a:gd name="connsiteY26" fmla="*/ 886351 h 1330022"/>
              <a:gd name="connsiteX27" fmla="*/ 403906 w 560981"/>
              <a:gd name="connsiteY27" fmla="*/ 903180 h 1330022"/>
              <a:gd name="connsiteX28" fmla="*/ 387077 w 560981"/>
              <a:gd name="connsiteY28" fmla="*/ 925619 h 1330022"/>
              <a:gd name="connsiteX29" fmla="*/ 375857 w 560981"/>
              <a:gd name="connsiteY29" fmla="*/ 942449 h 1330022"/>
              <a:gd name="connsiteX30" fmla="*/ 359028 w 560981"/>
              <a:gd name="connsiteY30" fmla="*/ 976108 h 1330022"/>
              <a:gd name="connsiteX31" fmla="*/ 353418 w 560981"/>
              <a:gd name="connsiteY31" fmla="*/ 992937 h 1330022"/>
              <a:gd name="connsiteX32" fmla="*/ 342198 w 560981"/>
              <a:gd name="connsiteY32" fmla="*/ 1015377 h 1330022"/>
              <a:gd name="connsiteX33" fmla="*/ 342198 w 560981"/>
              <a:gd name="connsiteY33" fmla="*/ 1110743 h 1330022"/>
              <a:gd name="connsiteX34" fmla="*/ 291710 w 560981"/>
              <a:gd name="connsiteY34" fmla="*/ 1144402 h 1330022"/>
              <a:gd name="connsiteX35" fmla="*/ 258051 w 560981"/>
              <a:gd name="connsiteY35" fmla="*/ 1178061 h 1330022"/>
              <a:gd name="connsiteX36" fmla="*/ 246832 w 560981"/>
              <a:gd name="connsiteY36" fmla="*/ 1194891 h 1330022"/>
              <a:gd name="connsiteX37" fmla="*/ 213173 w 560981"/>
              <a:gd name="connsiteY37" fmla="*/ 1217330 h 1330022"/>
              <a:gd name="connsiteX38" fmla="*/ 196343 w 560981"/>
              <a:gd name="connsiteY38" fmla="*/ 1228550 h 1330022"/>
              <a:gd name="connsiteX39" fmla="*/ 179514 w 560981"/>
              <a:gd name="connsiteY39" fmla="*/ 1239769 h 1330022"/>
              <a:gd name="connsiteX40" fmla="*/ 129025 w 560981"/>
              <a:gd name="connsiteY40" fmla="*/ 1279038 h 1330022"/>
              <a:gd name="connsiteX41" fmla="*/ 95367 w 560981"/>
              <a:gd name="connsiteY41" fmla="*/ 1295867 h 1330022"/>
              <a:gd name="connsiteX42" fmla="*/ 78537 w 560981"/>
              <a:gd name="connsiteY42" fmla="*/ 1312697 h 1330022"/>
              <a:gd name="connsiteX43" fmla="*/ 33659 w 560981"/>
              <a:gd name="connsiteY43" fmla="*/ 1329526 h 1330022"/>
              <a:gd name="connsiteX44" fmla="*/ 0 w 560981"/>
              <a:gd name="connsiteY44" fmla="*/ 1329526 h 133002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Lst>
            <a:rect l="l" t="t" r="r" b="b"/>
            <a:pathLst>
              <a:path w="560981" h="1330022">
                <a:moveTo>
                  <a:pt x="527322" y="0"/>
                </a:moveTo>
                <a:cubicBezTo>
                  <a:pt x="533750" y="10713"/>
                  <a:pt x="547995" y="29856"/>
                  <a:pt x="549762" y="44878"/>
                </a:cubicBezTo>
                <a:cubicBezTo>
                  <a:pt x="552828" y="70944"/>
                  <a:pt x="553278" y="97254"/>
                  <a:pt x="555371" y="123416"/>
                </a:cubicBezTo>
                <a:cubicBezTo>
                  <a:pt x="557018" y="144004"/>
                  <a:pt x="559111" y="164555"/>
                  <a:pt x="560981" y="185124"/>
                </a:cubicBezTo>
                <a:cubicBezTo>
                  <a:pt x="559111" y="194474"/>
                  <a:pt x="560660" y="205239"/>
                  <a:pt x="555371" y="213173"/>
                </a:cubicBezTo>
                <a:cubicBezTo>
                  <a:pt x="552091" y="218093"/>
                  <a:pt x="543831" y="216139"/>
                  <a:pt x="538542" y="218783"/>
                </a:cubicBezTo>
                <a:cubicBezTo>
                  <a:pt x="532512" y="221798"/>
                  <a:pt x="527743" y="226987"/>
                  <a:pt x="521713" y="230002"/>
                </a:cubicBezTo>
                <a:cubicBezTo>
                  <a:pt x="516424" y="232647"/>
                  <a:pt x="510318" y="233283"/>
                  <a:pt x="504883" y="235612"/>
                </a:cubicBezTo>
                <a:cubicBezTo>
                  <a:pt x="497197" y="238906"/>
                  <a:pt x="490208" y="243726"/>
                  <a:pt x="482444" y="246832"/>
                </a:cubicBezTo>
                <a:cubicBezTo>
                  <a:pt x="471463" y="251224"/>
                  <a:pt x="448785" y="258051"/>
                  <a:pt x="448785" y="258051"/>
                </a:cubicBezTo>
                <a:cubicBezTo>
                  <a:pt x="408088" y="312317"/>
                  <a:pt x="447764" y="254485"/>
                  <a:pt x="426346" y="297320"/>
                </a:cubicBezTo>
                <a:cubicBezTo>
                  <a:pt x="423331" y="303351"/>
                  <a:pt x="417864" y="307989"/>
                  <a:pt x="415126" y="314150"/>
                </a:cubicBezTo>
                <a:cubicBezTo>
                  <a:pt x="410323" y="324957"/>
                  <a:pt x="410466" y="337968"/>
                  <a:pt x="403906" y="347808"/>
                </a:cubicBezTo>
                <a:cubicBezTo>
                  <a:pt x="389407" y="369558"/>
                  <a:pt x="394819" y="358242"/>
                  <a:pt x="387077" y="381467"/>
                </a:cubicBezTo>
                <a:cubicBezTo>
                  <a:pt x="388947" y="430086"/>
                  <a:pt x="389339" y="478784"/>
                  <a:pt x="392687" y="527323"/>
                </a:cubicBezTo>
                <a:cubicBezTo>
                  <a:pt x="393094" y="533222"/>
                  <a:pt x="394603" y="539535"/>
                  <a:pt x="398297" y="544152"/>
                </a:cubicBezTo>
                <a:cubicBezTo>
                  <a:pt x="402509" y="549417"/>
                  <a:pt x="409516" y="551632"/>
                  <a:pt x="415126" y="555372"/>
                </a:cubicBezTo>
                <a:cubicBezTo>
                  <a:pt x="416996" y="581551"/>
                  <a:pt x="414725" y="608361"/>
                  <a:pt x="420736" y="633909"/>
                </a:cubicBezTo>
                <a:cubicBezTo>
                  <a:pt x="422553" y="641631"/>
                  <a:pt x="433712" y="643803"/>
                  <a:pt x="437565" y="650738"/>
                </a:cubicBezTo>
                <a:cubicBezTo>
                  <a:pt x="443309" y="661076"/>
                  <a:pt x="442225" y="674557"/>
                  <a:pt x="448785" y="684397"/>
                </a:cubicBezTo>
                <a:lnTo>
                  <a:pt x="460005" y="701227"/>
                </a:lnTo>
                <a:cubicBezTo>
                  <a:pt x="461875" y="706837"/>
                  <a:pt x="461920" y="713439"/>
                  <a:pt x="465614" y="718056"/>
                </a:cubicBezTo>
                <a:cubicBezTo>
                  <a:pt x="469826" y="723321"/>
                  <a:pt x="480981" y="722694"/>
                  <a:pt x="482444" y="729276"/>
                </a:cubicBezTo>
                <a:cubicBezTo>
                  <a:pt x="485312" y="742184"/>
                  <a:pt x="478845" y="755476"/>
                  <a:pt x="476834" y="768545"/>
                </a:cubicBezTo>
                <a:cubicBezTo>
                  <a:pt x="474919" y="780994"/>
                  <a:pt x="472394" y="805472"/>
                  <a:pt x="465614" y="819033"/>
                </a:cubicBezTo>
                <a:cubicBezTo>
                  <a:pt x="455168" y="839925"/>
                  <a:pt x="453074" y="834081"/>
                  <a:pt x="437565" y="852692"/>
                </a:cubicBezTo>
                <a:cubicBezTo>
                  <a:pt x="398514" y="899554"/>
                  <a:pt x="458687" y="837180"/>
                  <a:pt x="409516" y="886351"/>
                </a:cubicBezTo>
                <a:cubicBezTo>
                  <a:pt x="407646" y="891961"/>
                  <a:pt x="406840" y="898046"/>
                  <a:pt x="403906" y="903180"/>
                </a:cubicBezTo>
                <a:cubicBezTo>
                  <a:pt x="399267" y="911298"/>
                  <a:pt x="392511" y="918011"/>
                  <a:pt x="387077" y="925619"/>
                </a:cubicBezTo>
                <a:cubicBezTo>
                  <a:pt x="383158" y="931106"/>
                  <a:pt x="379597" y="936839"/>
                  <a:pt x="375857" y="942449"/>
                </a:cubicBezTo>
                <a:cubicBezTo>
                  <a:pt x="361761" y="984741"/>
                  <a:pt x="380774" y="932617"/>
                  <a:pt x="359028" y="976108"/>
                </a:cubicBezTo>
                <a:cubicBezTo>
                  <a:pt x="356383" y="981397"/>
                  <a:pt x="355747" y="987502"/>
                  <a:pt x="353418" y="992937"/>
                </a:cubicBezTo>
                <a:cubicBezTo>
                  <a:pt x="350124" y="1000624"/>
                  <a:pt x="345938" y="1007897"/>
                  <a:pt x="342198" y="1015377"/>
                </a:cubicBezTo>
                <a:cubicBezTo>
                  <a:pt x="343611" y="1029508"/>
                  <a:pt x="354344" y="1091655"/>
                  <a:pt x="342198" y="1110743"/>
                </a:cubicBezTo>
                <a:cubicBezTo>
                  <a:pt x="332372" y="1126185"/>
                  <a:pt x="305039" y="1131073"/>
                  <a:pt x="291710" y="1144402"/>
                </a:cubicBezTo>
                <a:cubicBezTo>
                  <a:pt x="280490" y="1155622"/>
                  <a:pt x="266852" y="1164858"/>
                  <a:pt x="258051" y="1178061"/>
                </a:cubicBezTo>
                <a:cubicBezTo>
                  <a:pt x="254311" y="1183671"/>
                  <a:pt x="251906" y="1190451"/>
                  <a:pt x="246832" y="1194891"/>
                </a:cubicBezTo>
                <a:cubicBezTo>
                  <a:pt x="236684" y="1203771"/>
                  <a:pt x="224393" y="1209850"/>
                  <a:pt x="213173" y="1217330"/>
                </a:cubicBezTo>
                <a:lnTo>
                  <a:pt x="196343" y="1228550"/>
                </a:lnTo>
                <a:cubicBezTo>
                  <a:pt x="190733" y="1232290"/>
                  <a:pt x="184281" y="1235002"/>
                  <a:pt x="179514" y="1239769"/>
                </a:cubicBezTo>
                <a:cubicBezTo>
                  <a:pt x="153149" y="1266134"/>
                  <a:pt x="169285" y="1252199"/>
                  <a:pt x="129025" y="1279038"/>
                </a:cubicBezTo>
                <a:cubicBezTo>
                  <a:pt x="107276" y="1293537"/>
                  <a:pt x="118592" y="1288125"/>
                  <a:pt x="95367" y="1295867"/>
                </a:cubicBezTo>
                <a:cubicBezTo>
                  <a:pt x="89757" y="1301477"/>
                  <a:pt x="84993" y="1308086"/>
                  <a:pt x="78537" y="1312697"/>
                </a:cubicBezTo>
                <a:cubicBezTo>
                  <a:pt x="67528" y="1320560"/>
                  <a:pt x="47315" y="1328160"/>
                  <a:pt x="33659" y="1329526"/>
                </a:cubicBezTo>
                <a:cubicBezTo>
                  <a:pt x="22495" y="1330642"/>
                  <a:pt x="11220" y="1329526"/>
                  <a:pt x="0" y="1329526"/>
                </a:cubicBezTo>
              </a:path>
            </a:pathLst>
          </a:custGeom>
          <a:noFill/>
          <a:ln w="9525">
            <a:solidFill>
              <a:srgbClr val="FFFF0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40" name="CasellaDiTesto 39"/>
          <p:cNvSpPr txBox="1"/>
          <p:nvPr/>
        </p:nvSpPr>
        <p:spPr>
          <a:xfrm>
            <a:off x="864582" y="1444292"/>
            <a:ext cx="277640" cy="246221"/>
          </a:xfrm>
          <a:prstGeom prst="rect">
            <a:avLst/>
          </a:prstGeom>
          <a:noFill/>
        </p:spPr>
        <p:txBody>
          <a:bodyPr wrap="none" rtlCol="0">
            <a:spAutoFit/>
          </a:bodyPr>
          <a:lstStyle/>
          <a:p>
            <a:pPr algn="ctr"/>
            <a:r>
              <a:rPr lang="it-IT" sz="1000" b="1" dirty="0" smtClean="0">
                <a:solidFill>
                  <a:srgbClr val="FFFF00"/>
                </a:solidFill>
              </a:rPr>
              <a:t>N</a:t>
            </a:r>
            <a:endParaRPr lang="it-IT" sz="1000" b="1" dirty="0">
              <a:solidFill>
                <a:srgbClr val="FFFF00"/>
              </a:solidFill>
            </a:endParaRPr>
          </a:p>
        </p:txBody>
      </p:sp>
      <p:sp>
        <p:nvSpPr>
          <p:cNvPr id="41" name="CasellaDiTesto 40"/>
          <p:cNvSpPr txBox="1"/>
          <p:nvPr/>
        </p:nvSpPr>
        <p:spPr>
          <a:xfrm>
            <a:off x="1003402" y="2241392"/>
            <a:ext cx="277640" cy="246221"/>
          </a:xfrm>
          <a:prstGeom prst="rect">
            <a:avLst/>
          </a:prstGeom>
          <a:noFill/>
        </p:spPr>
        <p:txBody>
          <a:bodyPr wrap="none" rtlCol="0">
            <a:spAutoFit/>
          </a:bodyPr>
          <a:lstStyle/>
          <a:p>
            <a:pPr algn="ctr"/>
            <a:r>
              <a:rPr lang="it-IT" sz="1000" b="1" dirty="0" smtClean="0">
                <a:solidFill>
                  <a:srgbClr val="FFFF00"/>
                </a:solidFill>
              </a:rPr>
              <a:t>N</a:t>
            </a:r>
            <a:endParaRPr lang="it-IT" sz="1000" b="1" dirty="0">
              <a:solidFill>
                <a:srgbClr val="FFFF00"/>
              </a:solidFill>
            </a:endParaRPr>
          </a:p>
        </p:txBody>
      </p:sp>
      <p:sp>
        <p:nvSpPr>
          <p:cNvPr id="42" name="CasellaDiTesto 41"/>
          <p:cNvSpPr txBox="1"/>
          <p:nvPr/>
        </p:nvSpPr>
        <p:spPr>
          <a:xfrm>
            <a:off x="731814" y="3622767"/>
            <a:ext cx="277640" cy="246221"/>
          </a:xfrm>
          <a:prstGeom prst="rect">
            <a:avLst/>
          </a:prstGeom>
          <a:noFill/>
        </p:spPr>
        <p:txBody>
          <a:bodyPr wrap="none" rtlCol="0">
            <a:spAutoFit/>
          </a:bodyPr>
          <a:lstStyle/>
          <a:p>
            <a:pPr algn="ctr"/>
            <a:r>
              <a:rPr lang="it-IT" sz="1000" b="1" dirty="0" smtClean="0">
                <a:solidFill>
                  <a:srgbClr val="FFFF00"/>
                </a:solidFill>
              </a:rPr>
              <a:t>N</a:t>
            </a:r>
            <a:endParaRPr lang="it-IT" sz="1000" b="1" dirty="0">
              <a:solidFill>
                <a:srgbClr val="FFFF00"/>
              </a:solidFill>
            </a:endParaRPr>
          </a:p>
        </p:txBody>
      </p:sp>
      <p:sp>
        <p:nvSpPr>
          <p:cNvPr id="43" name="Figura a mano libera 42"/>
          <p:cNvSpPr>
            <a:spLocks noChangeAspect="1"/>
          </p:cNvSpPr>
          <p:nvPr/>
        </p:nvSpPr>
        <p:spPr>
          <a:xfrm>
            <a:off x="4949960" y="2181566"/>
            <a:ext cx="683064" cy="880520"/>
          </a:xfrm>
          <a:custGeom>
            <a:avLst/>
            <a:gdLst>
              <a:gd name="connsiteX0" fmla="*/ 262393 w 650539"/>
              <a:gd name="connsiteY0" fmla="*/ 24027 h 838590"/>
              <a:gd name="connsiteX1" fmla="*/ 241128 w 650539"/>
              <a:gd name="connsiteY1" fmla="*/ 50609 h 838590"/>
              <a:gd name="connsiteX2" fmla="*/ 214547 w 650539"/>
              <a:gd name="connsiteY2" fmla="*/ 82506 h 838590"/>
              <a:gd name="connsiteX3" fmla="*/ 209230 w 650539"/>
              <a:gd name="connsiteY3" fmla="*/ 98455 h 838590"/>
              <a:gd name="connsiteX4" fmla="*/ 203914 w 650539"/>
              <a:gd name="connsiteY4" fmla="*/ 130353 h 838590"/>
              <a:gd name="connsiteX5" fmla="*/ 187965 w 650539"/>
              <a:gd name="connsiteY5" fmla="*/ 140985 h 838590"/>
              <a:gd name="connsiteX6" fmla="*/ 161384 w 650539"/>
              <a:gd name="connsiteY6" fmla="*/ 172883 h 838590"/>
              <a:gd name="connsiteX7" fmla="*/ 145435 w 650539"/>
              <a:gd name="connsiteY7" fmla="*/ 178199 h 838590"/>
              <a:gd name="connsiteX8" fmla="*/ 108221 w 650539"/>
              <a:gd name="connsiteY8" fmla="*/ 199464 h 838590"/>
              <a:gd name="connsiteX9" fmla="*/ 92272 w 650539"/>
              <a:gd name="connsiteY9" fmla="*/ 204781 h 838590"/>
              <a:gd name="connsiteX10" fmla="*/ 76323 w 650539"/>
              <a:gd name="connsiteY10" fmla="*/ 300474 h 838590"/>
              <a:gd name="connsiteX11" fmla="*/ 65691 w 650539"/>
              <a:gd name="connsiteY11" fmla="*/ 332371 h 838590"/>
              <a:gd name="connsiteX12" fmla="*/ 86956 w 650539"/>
              <a:gd name="connsiteY12" fmla="*/ 412116 h 838590"/>
              <a:gd name="connsiteX13" fmla="*/ 108221 w 650539"/>
              <a:gd name="connsiteY13" fmla="*/ 417432 h 838590"/>
              <a:gd name="connsiteX14" fmla="*/ 124170 w 650539"/>
              <a:gd name="connsiteY14" fmla="*/ 428064 h 838590"/>
              <a:gd name="connsiteX15" fmla="*/ 129486 w 650539"/>
              <a:gd name="connsiteY15" fmla="*/ 444013 h 838590"/>
              <a:gd name="connsiteX16" fmla="*/ 113537 w 650539"/>
              <a:gd name="connsiteY16" fmla="*/ 502492 h 838590"/>
              <a:gd name="connsiteX17" fmla="*/ 108221 w 650539"/>
              <a:gd name="connsiteY17" fmla="*/ 518441 h 838590"/>
              <a:gd name="connsiteX18" fmla="*/ 76323 w 650539"/>
              <a:gd name="connsiteY18" fmla="*/ 539706 h 838590"/>
              <a:gd name="connsiteX19" fmla="*/ 44426 w 650539"/>
              <a:gd name="connsiteY19" fmla="*/ 555655 h 838590"/>
              <a:gd name="connsiteX20" fmla="*/ 17844 w 650539"/>
              <a:gd name="connsiteY20" fmla="*/ 592869 h 838590"/>
              <a:gd name="connsiteX21" fmla="*/ 12528 w 650539"/>
              <a:gd name="connsiteY21" fmla="*/ 630083 h 838590"/>
              <a:gd name="connsiteX22" fmla="*/ 7212 w 650539"/>
              <a:gd name="connsiteY22" fmla="*/ 667297 h 838590"/>
              <a:gd name="connsiteX23" fmla="*/ 55058 w 650539"/>
              <a:gd name="connsiteY23" fmla="*/ 693878 h 838590"/>
              <a:gd name="connsiteX24" fmla="*/ 71007 w 650539"/>
              <a:gd name="connsiteY24" fmla="*/ 699195 h 838590"/>
              <a:gd name="connsiteX25" fmla="*/ 86956 w 650539"/>
              <a:gd name="connsiteY25" fmla="*/ 704511 h 838590"/>
              <a:gd name="connsiteX26" fmla="*/ 118853 w 650539"/>
              <a:gd name="connsiteY26" fmla="*/ 725776 h 838590"/>
              <a:gd name="connsiteX27" fmla="*/ 134802 w 650539"/>
              <a:gd name="connsiteY27" fmla="*/ 736409 h 838590"/>
              <a:gd name="connsiteX28" fmla="*/ 150751 w 650539"/>
              <a:gd name="connsiteY28" fmla="*/ 741725 h 838590"/>
              <a:gd name="connsiteX29" fmla="*/ 198598 w 650539"/>
              <a:gd name="connsiteY29" fmla="*/ 773623 h 838590"/>
              <a:gd name="connsiteX30" fmla="*/ 214547 w 650539"/>
              <a:gd name="connsiteY30" fmla="*/ 784255 h 838590"/>
              <a:gd name="connsiteX31" fmla="*/ 225179 w 650539"/>
              <a:gd name="connsiteY31" fmla="*/ 800204 h 838590"/>
              <a:gd name="connsiteX32" fmla="*/ 241128 w 650539"/>
              <a:gd name="connsiteY32" fmla="*/ 805520 h 838590"/>
              <a:gd name="connsiteX33" fmla="*/ 273026 w 650539"/>
              <a:gd name="connsiteY33" fmla="*/ 821469 h 838590"/>
              <a:gd name="connsiteX34" fmla="*/ 320872 w 650539"/>
              <a:gd name="connsiteY34" fmla="*/ 837418 h 838590"/>
              <a:gd name="connsiteX35" fmla="*/ 352770 w 650539"/>
              <a:gd name="connsiteY35" fmla="*/ 816153 h 838590"/>
              <a:gd name="connsiteX36" fmla="*/ 565421 w 650539"/>
              <a:gd name="connsiteY36" fmla="*/ 810837 h 838590"/>
              <a:gd name="connsiteX37" fmla="*/ 581370 w 650539"/>
              <a:gd name="connsiteY37" fmla="*/ 800204 h 838590"/>
              <a:gd name="connsiteX38" fmla="*/ 607951 w 650539"/>
              <a:gd name="connsiteY38" fmla="*/ 768306 h 838590"/>
              <a:gd name="connsiteX39" fmla="*/ 629216 w 650539"/>
              <a:gd name="connsiteY39" fmla="*/ 762990 h 838590"/>
              <a:gd name="connsiteX40" fmla="*/ 634533 w 650539"/>
              <a:gd name="connsiteY40" fmla="*/ 693878 h 838590"/>
              <a:gd name="connsiteX41" fmla="*/ 639849 w 650539"/>
              <a:gd name="connsiteY41" fmla="*/ 614134 h 838590"/>
              <a:gd name="connsiteX42" fmla="*/ 645165 w 650539"/>
              <a:gd name="connsiteY42" fmla="*/ 598185 h 838590"/>
              <a:gd name="connsiteX43" fmla="*/ 650481 w 650539"/>
              <a:gd name="connsiteY43" fmla="*/ 576920 h 838590"/>
              <a:gd name="connsiteX44" fmla="*/ 645165 w 650539"/>
              <a:gd name="connsiteY44" fmla="*/ 502492 h 838590"/>
              <a:gd name="connsiteX45" fmla="*/ 613267 w 650539"/>
              <a:gd name="connsiteY45" fmla="*/ 481227 h 838590"/>
              <a:gd name="connsiteX46" fmla="*/ 597319 w 650539"/>
              <a:gd name="connsiteY46" fmla="*/ 470595 h 838590"/>
              <a:gd name="connsiteX47" fmla="*/ 586686 w 650539"/>
              <a:gd name="connsiteY47" fmla="*/ 454646 h 838590"/>
              <a:gd name="connsiteX48" fmla="*/ 602635 w 650539"/>
              <a:gd name="connsiteY48" fmla="*/ 364269 h 838590"/>
              <a:gd name="connsiteX49" fmla="*/ 607951 w 650539"/>
              <a:gd name="connsiteY49" fmla="*/ 268576 h 838590"/>
              <a:gd name="connsiteX50" fmla="*/ 623900 w 650539"/>
              <a:gd name="connsiteY50" fmla="*/ 263260 h 838590"/>
              <a:gd name="connsiteX51" fmla="*/ 634533 w 650539"/>
              <a:gd name="connsiteY51" fmla="*/ 247311 h 838590"/>
              <a:gd name="connsiteX52" fmla="*/ 629216 w 650539"/>
              <a:gd name="connsiteY52" fmla="*/ 188832 h 838590"/>
              <a:gd name="connsiteX53" fmla="*/ 618584 w 650539"/>
              <a:gd name="connsiteY53" fmla="*/ 135669 h 838590"/>
              <a:gd name="connsiteX54" fmla="*/ 576053 w 650539"/>
              <a:gd name="connsiteY54" fmla="*/ 98455 h 838590"/>
              <a:gd name="connsiteX55" fmla="*/ 544156 w 650539"/>
              <a:gd name="connsiteY55" fmla="*/ 71874 h 838590"/>
              <a:gd name="connsiteX56" fmla="*/ 528207 w 650539"/>
              <a:gd name="connsiteY56" fmla="*/ 61241 h 838590"/>
              <a:gd name="connsiteX57" fmla="*/ 262393 w 650539"/>
              <a:gd name="connsiteY57" fmla="*/ 24027 h 83859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Lst>
            <a:rect l="l" t="t" r="r" b="b"/>
            <a:pathLst>
              <a:path w="650539" h="838590">
                <a:moveTo>
                  <a:pt x="262393" y="24027"/>
                </a:moveTo>
                <a:cubicBezTo>
                  <a:pt x="214547" y="22255"/>
                  <a:pt x="248600" y="42069"/>
                  <a:pt x="241128" y="50609"/>
                </a:cubicBezTo>
                <a:cubicBezTo>
                  <a:pt x="227410" y="66287"/>
                  <a:pt x="223614" y="64372"/>
                  <a:pt x="214547" y="82506"/>
                </a:cubicBezTo>
                <a:cubicBezTo>
                  <a:pt x="212041" y="87518"/>
                  <a:pt x="211002" y="93139"/>
                  <a:pt x="209230" y="98455"/>
                </a:cubicBezTo>
                <a:cubicBezTo>
                  <a:pt x="207458" y="109088"/>
                  <a:pt x="208735" y="120712"/>
                  <a:pt x="203914" y="130353"/>
                </a:cubicBezTo>
                <a:cubicBezTo>
                  <a:pt x="201057" y="136068"/>
                  <a:pt x="192483" y="136467"/>
                  <a:pt x="187965" y="140985"/>
                </a:cubicBezTo>
                <a:cubicBezTo>
                  <a:pt x="168349" y="160601"/>
                  <a:pt x="187515" y="155462"/>
                  <a:pt x="161384" y="172883"/>
                </a:cubicBezTo>
                <a:cubicBezTo>
                  <a:pt x="156721" y="175991"/>
                  <a:pt x="150586" y="175992"/>
                  <a:pt x="145435" y="178199"/>
                </a:cubicBezTo>
                <a:cubicBezTo>
                  <a:pt x="80213" y="206152"/>
                  <a:pt x="161596" y="172777"/>
                  <a:pt x="108221" y="199464"/>
                </a:cubicBezTo>
                <a:cubicBezTo>
                  <a:pt x="103209" y="201970"/>
                  <a:pt x="97588" y="203009"/>
                  <a:pt x="92272" y="204781"/>
                </a:cubicBezTo>
                <a:cubicBezTo>
                  <a:pt x="64861" y="245901"/>
                  <a:pt x="90415" y="201828"/>
                  <a:pt x="76323" y="300474"/>
                </a:cubicBezTo>
                <a:cubicBezTo>
                  <a:pt x="74738" y="311569"/>
                  <a:pt x="65691" y="332371"/>
                  <a:pt x="65691" y="332371"/>
                </a:cubicBezTo>
                <a:cubicBezTo>
                  <a:pt x="68328" y="364017"/>
                  <a:pt x="57082" y="395045"/>
                  <a:pt x="86956" y="412116"/>
                </a:cubicBezTo>
                <a:cubicBezTo>
                  <a:pt x="93300" y="415741"/>
                  <a:pt x="101133" y="415660"/>
                  <a:pt x="108221" y="417432"/>
                </a:cubicBezTo>
                <a:cubicBezTo>
                  <a:pt x="113537" y="420976"/>
                  <a:pt x="120179" y="423075"/>
                  <a:pt x="124170" y="428064"/>
                </a:cubicBezTo>
                <a:cubicBezTo>
                  <a:pt x="127671" y="432440"/>
                  <a:pt x="129486" y="438409"/>
                  <a:pt x="129486" y="444013"/>
                </a:cubicBezTo>
                <a:cubicBezTo>
                  <a:pt x="129486" y="483722"/>
                  <a:pt x="129364" y="478754"/>
                  <a:pt x="113537" y="502492"/>
                </a:cubicBezTo>
                <a:cubicBezTo>
                  <a:pt x="111765" y="507808"/>
                  <a:pt x="112184" y="514478"/>
                  <a:pt x="108221" y="518441"/>
                </a:cubicBezTo>
                <a:cubicBezTo>
                  <a:pt x="99185" y="527477"/>
                  <a:pt x="88446" y="535665"/>
                  <a:pt x="76323" y="539706"/>
                </a:cubicBezTo>
                <a:cubicBezTo>
                  <a:pt x="63353" y="544030"/>
                  <a:pt x="54731" y="545350"/>
                  <a:pt x="44426" y="555655"/>
                </a:cubicBezTo>
                <a:cubicBezTo>
                  <a:pt x="37832" y="562249"/>
                  <a:pt x="23881" y="583814"/>
                  <a:pt x="17844" y="592869"/>
                </a:cubicBezTo>
                <a:cubicBezTo>
                  <a:pt x="16072" y="605274"/>
                  <a:pt x="16129" y="618081"/>
                  <a:pt x="12528" y="630083"/>
                </a:cubicBezTo>
                <a:cubicBezTo>
                  <a:pt x="5796" y="652523"/>
                  <a:pt x="-8750" y="639363"/>
                  <a:pt x="7212" y="667297"/>
                </a:cubicBezTo>
                <a:cubicBezTo>
                  <a:pt x="18448" y="686959"/>
                  <a:pt x="34866" y="687147"/>
                  <a:pt x="55058" y="693878"/>
                </a:cubicBezTo>
                <a:lnTo>
                  <a:pt x="71007" y="699195"/>
                </a:lnTo>
                <a:lnTo>
                  <a:pt x="86956" y="704511"/>
                </a:lnTo>
                <a:lnTo>
                  <a:pt x="118853" y="725776"/>
                </a:lnTo>
                <a:cubicBezTo>
                  <a:pt x="124169" y="729320"/>
                  <a:pt x="128740" y="734389"/>
                  <a:pt x="134802" y="736409"/>
                </a:cubicBezTo>
                <a:lnTo>
                  <a:pt x="150751" y="741725"/>
                </a:lnTo>
                <a:lnTo>
                  <a:pt x="198598" y="773623"/>
                </a:lnTo>
                <a:lnTo>
                  <a:pt x="214547" y="784255"/>
                </a:lnTo>
                <a:cubicBezTo>
                  <a:pt x="218091" y="789571"/>
                  <a:pt x="220190" y="796213"/>
                  <a:pt x="225179" y="800204"/>
                </a:cubicBezTo>
                <a:cubicBezTo>
                  <a:pt x="229555" y="803705"/>
                  <a:pt x="236116" y="803014"/>
                  <a:pt x="241128" y="805520"/>
                </a:cubicBezTo>
                <a:cubicBezTo>
                  <a:pt x="282351" y="826132"/>
                  <a:pt x="232938" y="808107"/>
                  <a:pt x="273026" y="821469"/>
                </a:cubicBezTo>
                <a:cubicBezTo>
                  <a:pt x="288037" y="831478"/>
                  <a:pt x="299383" y="842194"/>
                  <a:pt x="320872" y="837418"/>
                </a:cubicBezTo>
                <a:cubicBezTo>
                  <a:pt x="378372" y="824640"/>
                  <a:pt x="301672" y="818530"/>
                  <a:pt x="352770" y="816153"/>
                </a:cubicBezTo>
                <a:cubicBezTo>
                  <a:pt x="423599" y="812859"/>
                  <a:pt x="494537" y="812609"/>
                  <a:pt x="565421" y="810837"/>
                </a:cubicBezTo>
                <a:cubicBezTo>
                  <a:pt x="570737" y="807293"/>
                  <a:pt x="576852" y="804722"/>
                  <a:pt x="581370" y="800204"/>
                </a:cubicBezTo>
                <a:cubicBezTo>
                  <a:pt x="596050" y="785523"/>
                  <a:pt x="587628" y="779919"/>
                  <a:pt x="607951" y="768306"/>
                </a:cubicBezTo>
                <a:cubicBezTo>
                  <a:pt x="614295" y="764681"/>
                  <a:pt x="622128" y="764762"/>
                  <a:pt x="629216" y="762990"/>
                </a:cubicBezTo>
                <a:cubicBezTo>
                  <a:pt x="630988" y="739953"/>
                  <a:pt x="632887" y="716925"/>
                  <a:pt x="634533" y="693878"/>
                </a:cubicBezTo>
                <a:cubicBezTo>
                  <a:pt x="636431" y="667305"/>
                  <a:pt x="636907" y="640611"/>
                  <a:pt x="639849" y="614134"/>
                </a:cubicBezTo>
                <a:cubicBezTo>
                  <a:pt x="640468" y="608564"/>
                  <a:pt x="643626" y="603573"/>
                  <a:pt x="645165" y="598185"/>
                </a:cubicBezTo>
                <a:cubicBezTo>
                  <a:pt x="647172" y="591160"/>
                  <a:pt x="648709" y="584008"/>
                  <a:pt x="650481" y="576920"/>
                </a:cubicBezTo>
                <a:cubicBezTo>
                  <a:pt x="648709" y="552111"/>
                  <a:pt x="654180" y="525673"/>
                  <a:pt x="645165" y="502492"/>
                </a:cubicBezTo>
                <a:cubicBezTo>
                  <a:pt x="640533" y="490582"/>
                  <a:pt x="623900" y="488315"/>
                  <a:pt x="613267" y="481227"/>
                </a:cubicBezTo>
                <a:lnTo>
                  <a:pt x="597319" y="470595"/>
                </a:lnTo>
                <a:cubicBezTo>
                  <a:pt x="593775" y="465279"/>
                  <a:pt x="587085" y="461023"/>
                  <a:pt x="586686" y="454646"/>
                </a:cubicBezTo>
                <a:cubicBezTo>
                  <a:pt x="583065" y="396721"/>
                  <a:pt x="584942" y="399653"/>
                  <a:pt x="602635" y="364269"/>
                </a:cubicBezTo>
                <a:cubicBezTo>
                  <a:pt x="604407" y="332371"/>
                  <a:pt x="601370" y="299838"/>
                  <a:pt x="607951" y="268576"/>
                </a:cubicBezTo>
                <a:cubicBezTo>
                  <a:pt x="609105" y="263092"/>
                  <a:pt x="619524" y="266761"/>
                  <a:pt x="623900" y="263260"/>
                </a:cubicBezTo>
                <a:cubicBezTo>
                  <a:pt x="628889" y="259269"/>
                  <a:pt x="630989" y="252627"/>
                  <a:pt x="634533" y="247311"/>
                </a:cubicBezTo>
                <a:cubicBezTo>
                  <a:pt x="645492" y="214432"/>
                  <a:pt x="638543" y="244796"/>
                  <a:pt x="629216" y="188832"/>
                </a:cubicBezTo>
                <a:cubicBezTo>
                  <a:pt x="628017" y="181637"/>
                  <a:pt x="622910" y="145762"/>
                  <a:pt x="618584" y="135669"/>
                </a:cubicBezTo>
                <a:cubicBezTo>
                  <a:pt x="609724" y="114995"/>
                  <a:pt x="595545" y="111450"/>
                  <a:pt x="576053" y="98455"/>
                </a:cubicBezTo>
                <a:cubicBezTo>
                  <a:pt x="536461" y="72061"/>
                  <a:pt x="585085" y="105982"/>
                  <a:pt x="544156" y="71874"/>
                </a:cubicBezTo>
                <a:cubicBezTo>
                  <a:pt x="539247" y="67784"/>
                  <a:pt x="533523" y="64785"/>
                  <a:pt x="528207" y="61241"/>
                </a:cubicBezTo>
                <a:cubicBezTo>
                  <a:pt x="509490" y="-51063"/>
                  <a:pt x="310239" y="25799"/>
                  <a:pt x="262393" y="24027"/>
                </a:cubicBezTo>
                <a:close/>
              </a:path>
            </a:pathLst>
          </a:custGeom>
          <a:noFill/>
          <a:ln w="9525">
            <a:solidFill>
              <a:srgbClr val="FFFF0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45" name="Figura a mano libera 44"/>
          <p:cNvSpPr>
            <a:spLocks noChangeAspect="1"/>
          </p:cNvSpPr>
          <p:nvPr/>
        </p:nvSpPr>
        <p:spPr>
          <a:xfrm>
            <a:off x="2131323" y="2181566"/>
            <a:ext cx="683064" cy="880520"/>
          </a:xfrm>
          <a:custGeom>
            <a:avLst/>
            <a:gdLst>
              <a:gd name="connsiteX0" fmla="*/ 262393 w 650539"/>
              <a:gd name="connsiteY0" fmla="*/ 24027 h 838590"/>
              <a:gd name="connsiteX1" fmla="*/ 241128 w 650539"/>
              <a:gd name="connsiteY1" fmla="*/ 50609 h 838590"/>
              <a:gd name="connsiteX2" fmla="*/ 214547 w 650539"/>
              <a:gd name="connsiteY2" fmla="*/ 82506 h 838590"/>
              <a:gd name="connsiteX3" fmla="*/ 209230 w 650539"/>
              <a:gd name="connsiteY3" fmla="*/ 98455 h 838590"/>
              <a:gd name="connsiteX4" fmla="*/ 203914 w 650539"/>
              <a:gd name="connsiteY4" fmla="*/ 130353 h 838590"/>
              <a:gd name="connsiteX5" fmla="*/ 187965 w 650539"/>
              <a:gd name="connsiteY5" fmla="*/ 140985 h 838590"/>
              <a:gd name="connsiteX6" fmla="*/ 161384 w 650539"/>
              <a:gd name="connsiteY6" fmla="*/ 172883 h 838590"/>
              <a:gd name="connsiteX7" fmla="*/ 145435 w 650539"/>
              <a:gd name="connsiteY7" fmla="*/ 178199 h 838590"/>
              <a:gd name="connsiteX8" fmla="*/ 108221 w 650539"/>
              <a:gd name="connsiteY8" fmla="*/ 199464 h 838590"/>
              <a:gd name="connsiteX9" fmla="*/ 92272 w 650539"/>
              <a:gd name="connsiteY9" fmla="*/ 204781 h 838590"/>
              <a:gd name="connsiteX10" fmla="*/ 76323 w 650539"/>
              <a:gd name="connsiteY10" fmla="*/ 300474 h 838590"/>
              <a:gd name="connsiteX11" fmla="*/ 65691 w 650539"/>
              <a:gd name="connsiteY11" fmla="*/ 332371 h 838590"/>
              <a:gd name="connsiteX12" fmla="*/ 86956 w 650539"/>
              <a:gd name="connsiteY12" fmla="*/ 412116 h 838590"/>
              <a:gd name="connsiteX13" fmla="*/ 108221 w 650539"/>
              <a:gd name="connsiteY13" fmla="*/ 417432 h 838590"/>
              <a:gd name="connsiteX14" fmla="*/ 124170 w 650539"/>
              <a:gd name="connsiteY14" fmla="*/ 428064 h 838590"/>
              <a:gd name="connsiteX15" fmla="*/ 129486 w 650539"/>
              <a:gd name="connsiteY15" fmla="*/ 444013 h 838590"/>
              <a:gd name="connsiteX16" fmla="*/ 113537 w 650539"/>
              <a:gd name="connsiteY16" fmla="*/ 502492 h 838590"/>
              <a:gd name="connsiteX17" fmla="*/ 108221 w 650539"/>
              <a:gd name="connsiteY17" fmla="*/ 518441 h 838590"/>
              <a:gd name="connsiteX18" fmla="*/ 76323 w 650539"/>
              <a:gd name="connsiteY18" fmla="*/ 539706 h 838590"/>
              <a:gd name="connsiteX19" fmla="*/ 44426 w 650539"/>
              <a:gd name="connsiteY19" fmla="*/ 555655 h 838590"/>
              <a:gd name="connsiteX20" fmla="*/ 17844 w 650539"/>
              <a:gd name="connsiteY20" fmla="*/ 592869 h 838590"/>
              <a:gd name="connsiteX21" fmla="*/ 12528 w 650539"/>
              <a:gd name="connsiteY21" fmla="*/ 630083 h 838590"/>
              <a:gd name="connsiteX22" fmla="*/ 7212 w 650539"/>
              <a:gd name="connsiteY22" fmla="*/ 667297 h 838590"/>
              <a:gd name="connsiteX23" fmla="*/ 55058 w 650539"/>
              <a:gd name="connsiteY23" fmla="*/ 693878 h 838590"/>
              <a:gd name="connsiteX24" fmla="*/ 71007 w 650539"/>
              <a:gd name="connsiteY24" fmla="*/ 699195 h 838590"/>
              <a:gd name="connsiteX25" fmla="*/ 86956 w 650539"/>
              <a:gd name="connsiteY25" fmla="*/ 704511 h 838590"/>
              <a:gd name="connsiteX26" fmla="*/ 118853 w 650539"/>
              <a:gd name="connsiteY26" fmla="*/ 725776 h 838590"/>
              <a:gd name="connsiteX27" fmla="*/ 134802 w 650539"/>
              <a:gd name="connsiteY27" fmla="*/ 736409 h 838590"/>
              <a:gd name="connsiteX28" fmla="*/ 150751 w 650539"/>
              <a:gd name="connsiteY28" fmla="*/ 741725 h 838590"/>
              <a:gd name="connsiteX29" fmla="*/ 198598 w 650539"/>
              <a:gd name="connsiteY29" fmla="*/ 773623 h 838590"/>
              <a:gd name="connsiteX30" fmla="*/ 214547 w 650539"/>
              <a:gd name="connsiteY30" fmla="*/ 784255 h 838590"/>
              <a:gd name="connsiteX31" fmla="*/ 225179 w 650539"/>
              <a:gd name="connsiteY31" fmla="*/ 800204 h 838590"/>
              <a:gd name="connsiteX32" fmla="*/ 241128 w 650539"/>
              <a:gd name="connsiteY32" fmla="*/ 805520 h 838590"/>
              <a:gd name="connsiteX33" fmla="*/ 273026 w 650539"/>
              <a:gd name="connsiteY33" fmla="*/ 821469 h 838590"/>
              <a:gd name="connsiteX34" fmla="*/ 320872 w 650539"/>
              <a:gd name="connsiteY34" fmla="*/ 837418 h 838590"/>
              <a:gd name="connsiteX35" fmla="*/ 352770 w 650539"/>
              <a:gd name="connsiteY35" fmla="*/ 816153 h 838590"/>
              <a:gd name="connsiteX36" fmla="*/ 565421 w 650539"/>
              <a:gd name="connsiteY36" fmla="*/ 810837 h 838590"/>
              <a:gd name="connsiteX37" fmla="*/ 581370 w 650539"/>
              <a:gd name="connsiteY37" fmla="*/ 800204 h 838590"/>
              <a:gd name="connsiteX38" fmla="*/ 607951 w 650539"/>
              <a:gd name="connsiteY38" fmla="*/ 768306 h 838590"/>
              <a:gd name="connsiteX39" fmla="*/ 629216 w 650539"/>
              <a:gd name="connsiteY39" fmla="*/ 762990 h 838590"/>
              <a:gd name="connsiteX40" fmla="*/ 634533 w 650539"/>
              <a:gd name="connsiteY40" fmla="*/ 693878 h 838590"/>
              <a:gd name="connsiteX41" fmla="*/ 639849 w 650539"/>
              <a:gd name="connsiteY41" fmla="*/ 614134 h 838590"/>
              <a:gd name="connsiteX42" fmla="*/ 645165 w 650539"/>
              <a:gd name="connsiteY42" fmla="*/ 598185 h 838590"/>
              <a:gd name="connsiteX43" fmla="*/ 650481 w 650539"/>
              <a:gd name="connsiteY43" fmla="*/ 576920 h 838590"/>
              <a:gd name="connsiteX44" fmla="*/ 645165 w 650539"/>
              <a:gd name="connsiteY44" fmla="*/ 502492 h 838590"/>
              <a:gd name="connsiteX45" fmla="*/ 613267 w 650539"/>
              <a:gd name="connsiteY45" fmla="*/ 481227 h 838590"/>
              <a:gd name="connsiteX46" fmla="*/ 597319 w 650539"/>
              <a:gd name="connsiteY46" fmla="*/ 470595 h 838590"/>
              <a:gd name="connsiteX47" fmla="*/ 586686 w 650539"/>
              <a:gd name="connsiteY47" fmla="*/ 454646 h 838590"/>
              <a:gd name="connsiteX48" fmla="*/ 602635 w 650539"/>
              <a:gd name="connsiteY48" fmla="*/ 364269 h 838590"/>
              <a:gd name="connsiteX49" fmla="*/ 607951 w 650539"/>
              <a:gd name="connsiteY49" fmla="*/ 268576 h 838590"/>
              <a:gd name="connsiteX50" fmla="*/ 623900 w 650539"/>
              <a:gd name="connsiteY50" fmla="*/ 263260 h 838590"/>
              <a:gd name="connsiteX51" fmla="*/ 634533 w 650539"/>
              <a:gd name="connsiteY51" fmla="*/ 247311 h 838590"/>
              <a:gd name="connsiteX52" fmla="*/ 629216 w 650539"/>
              <a:gd name="connsiteY52" fmla="*/ 188832 h 838590"/>
              <a:gd name="connsiteX53" fmla="*/ 618584 w 650539"/>
              <a:gd name="connsiteY53" fmla="*/ 135669 h 838590"/>
              <a:gd name="connsiteX54" fmla="*/ 576053 w 650539"/>
              <a:gd name="connsiteY54" fmla="*/ 98455 h 838590"/>
              <a:gd name="connsiteX55" fmla="*/ 544156 w 650539"/>
              <a:gd name="connsiteY55" fmla="*/ 71874 h 838590"/>
              <a:gd name="connsiteX56" fmla="*/ 528207 w 650539"/>
              <a:gd name="connsiteY56" fmla="*/ 61241 h 838590"/>
              <a:gd name="connsiteX57" fmla="*/ 262393 w 650539"/>
              <a:gd name="connsiteY57" fmla="*/ 24027 h 83859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Lst>
            <a:rect l="l" t="t" r="r" b="b"/>
            <a:pathLst>
              <a:path w="650539" h="838590">
                <a:moveTo>
                  <a:pt x="262393" y="24027"/>
                </a:moveTo>
                <a:cubicBezTo>
                  <a:pt x="214547" y="22255"/>
                  <a:pt x="248600" y="42069"/>
                  <a:pt x="241128" y="50609"/>
                </a:cubicBezTo>
                <a:cubicBezTo>
                  <a:pt x="227410" y="66287"/>
                  <a:pt x="223614" y="64372"/>
                  <a:pt x="214547" y="82506"/>
                </a:cubicBezTo>
                <a:cubicBezTo>
                  <a:pt x="212041" y="87518"/>
                  <a:pt x="211002" y="93139"/>
                  <a:pt x="209230" y="98455"/>
                </a:cubicBezTo>
                <a:cubicBezTo>
                  <a:pt x="207458" y="109088"/>
                  <a:pt x="208735" y="120712"/>
                  <a:pt x="203914" y="130353"/>
                </a:cubicBezTo>
                <a:cubicBezTo>
                  <a:pt x="201057" y="136068"/>
                  <a:pt x="192483" y="136467"/>
                  <a:pt x="187965" y="140985"/>
                </a:cubicBezTo>
                <a:cubicBezTo>
                  <a:pt x="168349" y="160601"/>
                  <a:pt x="187515" y="155462"/>
                  <a:pt x="161384" y="172883"/>
                </a:cubicBezTo>
                <a:cubicBezTo>
                  <a:pt x="156721" y="175991"/>
                  <a:pt x="150586" y="175992"/>
                  <a:pt x="145435" y="178199"/>
                </a:cubicBezTo>
                <a:cubicBezTo>
                  <a:pt x="80213" y="206152"/>
                  <a:pt x="161596" y="172777"/>
                  <a:pt x="108221" y="199464"/>
                </a:cubicBezTo>
                <a:cubicBezTo>
                  <a:pt x="103209" y="201970"/>
                  <a:pt x="97588" y="203009"/>
                  <a:pt x="92272" y="204781"/>
                </a:cubicBezTo>
                <a:cubicBezTo>
                  <a:pt x="64861" y="245901"/>
                  <a:pt x="90415" y="201828"/>
                  <a:pt x="76323" y="300474"/>
                </a:cubicBezTo>
                <a:cubicBezTo>
                  <a:pt x="74738" y="311569"/>
                  <a:pt x="65691" y="332371"/>
                  <a:pt x="65691" y="332371"/>
                </a:cubicBezTo>
                <a:cubicBezTo>
                  <a:pt x="68328" y="364017"/>
                  <a:pt x="57082" y="395045"/>
                  <a:pt x="86956" y="412116"/>
                </a:cubicBezTo>
                <a:cubicBezTo>
                  <a:pt x="93300" y="415741"/>
                  <a:pt x="101133" y="415660"/>
                  <a:pt x="108221" y="417432"/>
                </a:cubicBezTo>
                <a:cubicBezTo>
                  <a:pt x="113537" y="420976"/>
                  <a:pt x="120179" y="423075"/>
                  <a:pt x="124170" y="428064"/>
                </a:cubicBezTo>
                <a:cubicBezTo>
                  <a:pt x="127671" y="432440"/>
                  <a:pt x="129486" y="438409"/>
                  <a:pt x="129486" y="444013"/>
                </a:cubicBezTo>
                <a:cubicBezTo>
                  <a:pt x="129486" y="483722"/>
                  <a:pt x="129364" y="478754"/>
                  <a:pt x="113537" y="502492"/>
                </a:cubicBezTo>
                <a:cubicBezTo>
                  <a:pt x="111765" y="507808"/>
                  <a:pt x="112184" y="514478"/>
                  <a:pt x="108221" y="518441"/>
                </a:cubicBezTo>
                <a:cubicBezTo>
                  <a:pt x="99185" y="527477"/>
                  <a:pt x="88446" y="535665"/>
                  <a:pt x="76323" y="539706"/>
                </a:cubicBezTo>
                <a:cubicBezTo>
                  <a:pt x="63353" y="544030"/>
                  <a:pt x="54731" y="545350"/>
                  <a:pt x="44426" y="555655"/>
                </a:cubicBezTo>
                <a:cubicBezTo>
                  <a:pt x="37832" y="562249"/>
                  <a:pt x="23881" y="583814"/>
                  <a:pt x="17844" y="592869"/>
                </a:cubicBezTo>
                <a:cubicBezTo>
                  <a:pt x="16072" y="605274"/>
                  <a:pt x="16129" y="618081"/>
                  <a:pt x="12528" y="630083"/>
                </a:cubicBezTo>
                <a:cubicBezTo>
                  <a:pt x="5796" y="652523"/>
                  <a:pt x="-8750" y="639363"/>
                  <a:pt x="7212" y="667297"/>
                </a:cubicBezTo>
                <a:cubicBezTo>
                  <a:pt x="18448" y="686959"/>
                  <a:pt x="34866" y="687147"/>
                  <a:pt x="55058" y="693878"/>
                </a:cubicBezTo>
                <a:lnTo>
                  <a:pt x="71007" y="699195"/>
                </a:lnTo>
                <a:lnTo>
                  <a:pt x="86956" y="704511"/>
                </a:lnTo>
                <a:lnTo>
                  <a:pt x="118853" y="725776"/>
                </a:lnTo>
                <a:cubicBezTo>
                  <a:pt x="124169" y="729320"/>
                  <a:pt x="128740" y="734389"/>
                  <a:pt x="134802" y="736409"/>
                </a:cubicBezTo>
                <a:lnTo>
                  <a:pt x="150751" y="741725"/>
                </a:lnTo>
                <a:lnTo>
                  <a:pt x="198598" y="773623"/>
                </a:lnTo>
                <a:lnTo>
                  <a:pt x="214547" y="784255"/>
                </a:lnTo>
                <a:cubicBezTo>
                  <a:pt x="218091" y="789571"/>
                  <a:pt x="220190" y="796213"/>
                  <a:pt x="225179" y="800204"/>
                </a:cubicBezTo>
                <a:cubicBezTo>
                  <a:pt x="229555" y="803705"/>
                  <a:pt x="236116" y="803014"/>
                  <a:pt x="241128" y="805520"/>
                </a:cubicBezTo>
                <a:cubicBezTo>
                  <a:pt x="282351" y="826132"/>
                  <a:pt x="232938" y="808107"/>
                  <a:pt x="273026" y="821469"/>
                </a:cubicBezTo>
                <a:cubicBezTo>
                  <a:pt x="288037" y="831478"/>
                  <a:pt x="299383" y="842194"/>
                  <a:pt x="320872" y="837418"/>
                </a:cubicBezTo>
                <a:cubicBezTo>
                  <a:pt x="378372" y="824640"/>
                  <a:pt x="301672" y="818530"/>
                  <a:pt x="352770" y="816153"/>
                </a:cubicBezTo>
                <a:cubicBezTo>
                  <a:pt x="423599" y="812859"/>
                  <a:pt x="494537" y="812609"/>
                  <a:pt x="565421" y="810837"/>
                </a:cubicBezTo>
                <a:cubicBezTo>
                  <a:pt x="570737" y="807293"/>
                  <a:pt x="576852" y="804722"/>
                  <a:pt x="581370" y="800204"/>
                </a:cubicBezTo>
                <a:cubicBezTo>
                  <a:pt x="596050" y="785523"/>
                  <a:pt x="587628" y="779919"/>
                  <a:pt x="607951" y="768306"/>
                </a:cubicBezTo>
                <a:cubicBezTo>
                  <a:pt x="614295" y="764681"/>
                  <a:pt x="622128" y="764762"/>
                  <a:pt x="629216" y="762990"/>
                </a:cubicBezTo>
                <a:cubicBezTo>
                  <a:pt x="630988" y="739953"/>
                  <a:pt x="632887" y="716925"/>
                  <a:pt x="634533" y="693878"/>
                </a:cubicBezTo>
                <a:cubicBezTo>
                  <a:pt x="636431" y="667305"/>
                  <a:pt x="636907" y="640611"/>
                  <a:pt x="639849" y="614134"/>
                </a:cubicBezTo>
                <a:cubicBezTo>
                  <a:pt x="640468" y="608564"/>
                  <a:pt x="643626" y="603573"/>
                  <a:pt x="645165" y="598185"/>
                </a:cubicBezTo>
                <a:cubicBezTo>
                  <a:pt x="647172" y="591160"/>
                  <a:pt x="648709" y="584008"/>
                  <a:pt x="650481" y="576920"/>
                </a:cubicBezTo>
                <a:cubicBezTo>
                  <a:pt x="648709" y="552111"/>
                  <a:pt x="654180" y="525673"/>
                  <a:pt x="645165" y="502492"/>
                </a:cubicBezTo>
                <a:cubicBezTo>
                  <a:pt x="640533" y="490582"/>
                  <a:pt x="623900" y="488315"/>
                  <a:pt x="613267" y="481227"/>
                </a:cubicBezTo>
                <a:lnTo>
                  <a:pt x="597319" y="470595"/>
                </a:lnTo>
                <a:cubicBezTo>
                  <a:pt x="593775" y="465279"/>
                  <a:pt x="587085" y="461023"/>
                  <a:pt x="586686" y="454646"/>
                </a:cubicBezTo>
                <a:cubicBezTo>
                  <a:pt x="583065" y="396721"/>
                  <a:pt x="584942" y="399653"/>
                  <a:pt x="602635" y="364269"/>
                </a:cubicBezTo>
                <a:cubicBezTo>
                  <a:pt x="604407" y="332371"/>
                  <a:pt x="601370" y="299838"/>
                  <a:pt x="607951" y="268576"/>
                </a:cubicBezTo>
                <a:cubicBezTo>
                  <a:pt x="609105" y="263092"/>
                  <a:pt x="619524" y="266761"/>
                  <a:pt x="623900" y="263260"/>
                </a:cubicBezTo>
                <a:cubicBezTo>
                  <a:pt x="628889" y="259269"/>
                  <a:pt x="630989" y="252627"/>
                  <a:pt x="634533" y="247311"/>
                </a:cubicBezTo>
                <a:cubicBezTo>
                  <a:pt x="645492" y="214432"/>
                  <a:pt x="638543" y="244796"/>
                  <a:pt x="629216" y="188832"/>
                </a:cubicBezTo>
                <a:cubicBezTo>
                  <a:pt x="628017" y="181637"/>
                  <a:pt x="622910" y="145762"/>
                  <a:pt x="618584" y="135669"/>
                </a:cubicBezTo>
                <a:cubicBezTo>
                  <a:pt x="609724" y="114995"/>
                  <a:pt x="595545" y="111450"/>
                  <a:pt x="576053" y="98455"/>
                </a:cubicBezTo>
                <a:cubicBezTo>
                  <a:pt x="536461" y="72061"/>
                  <a:pt x="585085" y="105982"/>
                  <a:pt x="544156" y="71874"/>
                </a:cubicBezTo>
                <a:cubicBezTo>
                  <a:pt x="539247" y="67784"/>
                  <a:pt x="533523" y="64785"/>
                  <a:pt x="528207" y="61241"/>
                </a:cubicBezTo>
                <a:cubicBezTo>
                  <a:pt x="509490" y="-51063"/>
                  <a:pt x="310239" y="25799"/>
                  <a:pt x="262393" y="24027"/>
                </a:cubicBezTo>
                <a:close/>
              </a:path>
            </a:pathLst>
          </a:custGeom>
          <a:noFill/>
          <a:ln w="9525">
            <a:solidFill>
              <a:srgbClr val="FFFF0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46" name="Figura a mano libera 45"/>
          <p:cNvSpPr>
            <a:spLocks noChangeAspect="1"/>
          </p:cNvSpPr>
          <p:nvPr/>
        </p:nvSpPr>
        <p:spPr>
          <a:xfrm>
            <a:off x="3535031" y="2181566"/>
            <a:ext cx="683064" cy="880520"/>
          </a:xfrm>
          <a:custGeom>
            <a:avLst/>
            <a:gdLst>
              <a:gd name="connsiteX0" fmla="*/ 262393 w 650539"/>
              <a:gd name="connsiteY0" fmla="*/ 24027 h 838590"/>
              <a:gd name="connsiteX1" fmla="*/ 241128 w 650539"/>
              <a:gd name="connsiteY1" fmla="*/ 50609 h 838590"/>
              <a:gd name="connsiteX2" fmla="*/ 214547 w 650539"/>
              <a:gd name="connsiteY2" fmla="*/ 82506 h 838590"/>
              <a:gd name="connsiteX3" fmla="*/ 209230 w 650539"/>
              <a:gd name="connsiteY3" fmla="*/ 98455 h 838590"/>
              <a:gd name="connsiteX4" fmla="*/ 203914 w 650539"/>
              <a:gd name="connsiteY4" fmla="*/ 130353 h 838590"/>
              <a:gd name="connsiteX5" fmla="*/ 187965 w 650539"/>
              <a:gd name="connsiteY5" fmla="*/ 140985 h 838590"/>
              <a:gd name="connsiteX6" fmla="*/ 161384 w 650539"/>
              <a:gd name="connsiteY6" fmla="*/ 172883 h 838590"/>
              <a:gd name="connsiteX7" fmla="*/ 145435 w 650539"/>
              <a:gd name="connsiteY7" fmla="*/ 178199 h 838590"/>
              <a:gd name="connsiteX8" fmla="*/ 108221 w 650539"/>
              <a:gd name="connsiteY8" fmla="*/ 199464 h 838590"/>
              <a:gd name="connsiteX9" fmla="*/ 92272 w 650539"/>
              <a:gd name="connsiteY9" fmla="*/ 204781 h 838590"/>
              <a:gd name="connsiteX10" fmla="*/ 76323 w 650539"/>
              <a:gd name="connsiteY10" fmla="*/ 300474 h 838590"/>
              <a:gd name="connsiteX11" fmla="*/ 65691 w 650539"/>
              <a:gd name="connsiteY11" fmla="*/ 332371 h 838590"/>
              <a:gd name="connsiteX12" fmla="*/ 86956 w 650539"/>
              <a:gd name="connsiteY12" fmla="*/ 412116 h 838590"/>
              <a:gd name="connsiteX13" fmla="*/ 108221 w 650539"/>
              <a:gd name="connsiteY13" fmla="*/ 417432 h 838590"/>
              <a:gd name="connsiteX14" fmla="*/ 124170 w 650539"/>
              <a:gd name="connsiteY14" fmla="*/ 428064 h 838590"/>
              <a:gd name="connsiteX15" fmla="*/ 129486 w 650539"/>
              <a:gd name="connsiteY15" fmla="*/ 444013 h 838590"/>
              <a:gd name="connsiteX16" fmla="*/ 113537 w 650539"/>
              <a:gd name="connsiteY16" fmla="*/ 502492 h 838590"/>
              <a:gd name="connsiteX17" fmla="*/ 108221 w 650539"/>
              <a:gd name="connsiteY17" fmla="*/ 518441 h 838590"/>
              <a:gd name="connsiteX18" fmla="*/ 76323 w 650539"/>
              <a:gd name="connsiteY18" fmla="*/ 539706 h 838590"/>
              <a:gd name="connsiteX19" fmla="*/ 44426 w 650539"/>
              <a:gd name="connsiteY19" fmla="*/ 555655 h 838590"/>
              <a:gd name="connsiteX20" fmla="*/ 17844 w 650539"/>
              <a:gd name="connsiteY20" fmla="*/ 592869 h 838590"/>
              <a:gd name="connsiteX21" fmla="*/ 12528 w 650539"/>
              <a:gd name="connsiteY21" fmla="*/ 630083 h 838590"/>
              <a:gd name="connsiteX22" fmla="*/ 7212 w 650539"/>
              <a:gd name="connsiteY22" fmla="*/ 667297 h 838590"/>
              <a:gd name="connsiteX23" fmla="*/ 55058 w 650539"/>
              <a:gd name="connsiteY23" fmla="*/ 693878 h 838590"/>
              <a:gd name="connsiteX24" fmla="*/ 71007 w 650539"/>
              <a:gd name="connsiteY24" fmla="*/ 699195 h 838590"/>
              <a:gd name="connsiteX25" fmla="*/ 86956 w 650539"/>
              <a:gd name="connsiteY25" fmla="*/ 704511 h 838590"/>
              <a:gd name="connsiteX26" fmla="*/ 118853 w 650539"/>
              <a:gd name="connsiteY26" fmla="*/ 725776 h 838590"/>
              <a:gd name="connsiteX27" fmla="*/ 134802 w 650539"/>
              <a:gd name="connsiteY27" fmla="*/ 736409 h 838590"/>
              <a:gd name="connsiteX28" fmla="*/ 150751 w 650539"/>
              <a:gd name="connsiteY28" fmla="*/ 741725 h 838590"/>
              <a:gd name="connsiteX29" fmla="*/ 198598 w 650539"/>
              <a:gd name="connsiteY29" fmla="*/ 773623 h 838590"/>
              <a:gd name="connsiteX30" fmla="*/ 214547 w 650539"/>
              <a:gd name="connsiteY30" fmla="*/ 784255 h 838590"/>
              <a:gd name="connsiteX31" fmla="*/ 225179 w 650539"/>
              <a:gd name="connsiteY31" fmla="*/ 800204 h 838590"/>
              <a:gd name="connsiteX32" fmla="*/ 241128 w 650539"/>
              <a:gd name="connsiteY32" fmla="*/ 805520 h 838590"/>
              <a:gd name="connsiteX33" fmla="*/ 273026 w 650539"/>
              <a:gd name="connsiteY33" fmla="*/ 821469 h 838590"/>
              <a:gd name="connsiteX34" fmla="*/ 320872 w 650539"/>
              <a:gd name="connsiteY34" fmla="*/ 837418 h 838590"/>
              <a:gd name="connsiteX35" fmla="*/ 352770 w 650539"/>
              <a:gd name="connsiteY35" fmla="*/ 816153 h 838590"/>
              <a:gd name="connsiteX36" fmla="*/ 565421 w 650539"/>
              <a:gd name="connsiteY36" fmla="*/ 810837 h 838590"/>
              <a:gd name="connsiteX37" fmla="*/ 581370 w 650539"/>
              <a:gd name="connsiteY37" fmla="*/ 800204 h 838590"/>
              <a:gd name="connsiteX38" fmla="*/ 607951 w 650539"/>
              <a:gd name="connsiteY38" fmla="*/ 768306 h 838590"/>
              <a:gd name="connsiteX39" fmla="*/ 629216 w 650539"/>
              <a:gd name="connsiteY39" fmla="*/ 762990 h 838590"/>
              <a:gd name="connsiteX40" fmla="*/ 634533 w 650539"/>
              <a:gd name="connsiteY40" fmla="*/ 693878 h 838590"/>
              <a:gd name="connsiteX41" fmla="*/ 639849 w 650539"/>
              <a:gd name="connsiteY41" fmla="*/ 614134 h 838590"/>
              <a:gd name="connsiteX42" fmla="*/ 645165 w 650539"/>
              <a:gd name="connsiteY42" fmla="*/ 598185 h 838590"/>
              <a:gd name="connsiteX43" fmla="*/ 650481 w 650539"/>
              <a:gd name="connsiteY43" fmla="*/ 576920 h 838590"/>
              <a:gd name="connsiteX44" fmla="*/ 645165 w 650539"/>
              <a:gd name="connsiteY44" fmla="*/ 502492 h 838590"/>
              <a:gd name="connsiteX45" fmla="*/ 613267 w 650539"/>
              <a:gd name="connsiteY45" fmla="*/ 481227 h 838590"/>
              <a:gd name="connsiteX46" fmla="*/ 597319 w 650539"/>
              <a:gd name="connsiteY46" fmla="*/ 470595 h 838590"/>
              <a:gd name="connsiteX47" fmla="*/ 586686 w 650539"/>
              <a:gd name="connsiteY47" fmla="*/ 454646 h 838590"/>
              <a:gd name="connsiteX48" fmla="*/ 602635 w 650539"/>
              <a:gd name="connsiteY48" fmla="*/ 364269 h 838590"/>
              <a:gd name="connsiteX49" fmla="*/ 607951 w 650539"/>
              <a:gd name="connsiteY49" fmla="*/ 268576 h 838590"/>
              <a:gd name="connsiteX50" fmla="*/ 623900 w 650539"/>
              <a:gd name="connsiteY50" fmla="*/ 263260 h 838590"/>
              <a:gd name="connsiteX51" fmla="*/ 634533 w 650539"/>
              <a:gd name="connsiteY51" fmla="*/ 247311 h 838590"/>
              <a:gd name="connsiteX52" fmla="*/ 629216 w 650539"/>
              <a:gd name="connsiteY52" fmla="*/ 188832 h 838590"/>
              <a:gd name="connsiteX53" fmla="*/ 618584 w 650539"/>
              <a:gd name="connsiteY53" fmla="*/ 135669 h 838590"/>
              <a:gd name="connsiteX54" fmla="*/ 576053 w 650539"/>
              <a:gd name="connsiteY54" fmla="*/ 98455 h 838590"/>
              <a:gd name="connsiteX55" fmla="*/ 544156 w 650539"/>
              <a:gd name="connsiteY55" fmla="*/ 71874 h 838590"/>
              <a:gd name="connsiteX56" fmla="*/ 528207 w 650539"/>
              <a:gd name="connsiteY56" fmla="*/ 61241 h 838590"/>
              <a:gd name="connsiteX57" fmla="*/ 262393 w 650539"/>
              <a:gd name="connsiteY57" fmla="*/ 24027 h 83859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Lst>
            <a:rect l="l" t="t" r="r" b="b"/>
            <a:pathLst>
              <a:path w="650539" h="838590">
                <a:moveTo>
                  <a:pt x="262393" y="24027"/>
                </a:moveTo>
                <a:cubicBezTo>
                  <a:pt x="214547" y="22255"/>
                  <a:pt x="248600" y="42069"/>
                  <a:pt x="241128" y="50609"/>
                </a:cubicBezTo>
                <a:cubicBezTo>
                  <a:pt x="227410" y="66287"/>
                  <a:pt x="223614" y="64372"/>
                  <a:pt x="214547" y="82506"/>
                </a:cubicBezTo>
                <a:cubicBezTo>
                  <a:pt x="212041" y="87518"/>
                  <a:pt x="211002" y="93139"/>
                  <a:pt x="209230" y="98455"/>
                </a:cubicBezTo>
                <a:cubicBezTo>
                  <a:pt x="207458" y="109088"/>
                  <a:pt x="208735" y="120712"/>
                  <a:pt x="203914" y="130353"/>
                </a:cubicBezTo>
                <a:cubicBezTo>
                  <a:pt x="201057" y="136068"/>
                  <a:pt x="192483" y="136467"/>
                  <a:pt x="187965" y="140985"/>
                </a:cubicBezTo>
                <a:cubicBezTo>
                  <a:pt x="168349" y="160601"/>
                  <a:pt x="187515" y="155462"/>
                  <a:pt x="161384" y="172883"/>
                </a:cubicBezTo>
                <a:cubicBezTo>
                  <a:pt x="156721" y="175991"/>
                  <a:pt x="150586" y="175992"/>
                  <a:pt x="145435" y="178199"/>
                </a:cubicBezTo>
                <a:cubicBezTo>
                  <a:pt x="80213" y="206152"/>
                  <a:pt x="161596" y="172777"/>
                  <a:pt x="108221" y="199464"/>
                </a:cubicBezTo>
                <a:cubicBezTo>
                  <a:pt x="103209" y="201970"/>
                  <a:pt x="97588" y="203009"/>
                  <a:pt x="92272" y="204781"/>
                </a:cubicBezTo>
                <a:cubicBezTo>
                  <a:pt x="64861" y="245901"/>
                  <a:pt x="90415" y="201828"/>
                  <a:pt x="76323" y="300474"/>
                </a:cubicBezTo>
                <a:cubicBezTo>
                  <a:pt x="74738" y="311569"/>
                  <a:pt x="65691" y="332371"/>
                  <a:pt x="65691" y="332371"/>
                </a:cubicBezTo>
                <a:cubicBezTo>
                  <a:pt x="68328" y="364017"/>
                  <a:pt x="57082" y="395045"/>
                  <a:pt x="86956" y="412116"/>
                </a:cubicBezTo>
                <a:cubicBezTo>
                  <a:pt x="93300" y="415741"/>
                  <a:pt x="101133" y="415660"/>
                  <a:pt x="108221" y="417432"/>
                </a:cubicBezTo>
                <a:cubicBezTo>
                  <a:pt x="113537" y="420976"/>
                  <a:pt x="120179" y="423075"/>
                  <a:pt x="124170" y="428064"/>
                </a:cubicBezTo>
                <a:cubicBezTo>
                  <a:pt x="127671" y="432440"/>
                  <a:pt x="129486" y="438409"/>
                  <a:pt x="129486" y="444013"/>
                </a:cubicBezTo>
                <a:cubicBezTo>
                  <a:pt x="129486" y="483722"/>
                  <a:pt x="129364" y="478754"/>
                  <a:pt x="113537" y="502492"/>
                </a:cubicBezTo>
                <a:cubicBezTo>
                  <a:pt x="111765" y="507808"/>
                  <a:pt x="112184" y="514478"/>
                  <a:pt x="108221" y="518441"/>
                </a:cubicBezTo>
                <a:cubicBezTo>
                  <a:pt x="99185" y="527477"/>
                  <a:pt x="88446" y="535665"/>
                  <a:pt x="76323" y="539706"/>
                </a:cubicBezTo>
                <a:cubicBezTo>
                  <a:pt x="63353" y="544030"/>
                  <a:pt x="54731" y="545350"/>
                  <a:pt x="44426" y="555655"/>
                </a:cubicBezTo>
                <a:cubicBezTo>
                  <a:pt x="37832" y="562249"/>
                  <a:pt x="23881" y="583814"/>
                  <a:pt x="17844" y="592869"/>
                </a:cubicBezTo>
                <a:cubicBezTo>
                  <a:pt x="16072" y="605274"/>
                  <a:pt x="16129" y="618081"/>
                  <a:pt x="12528" y="630083"/>
                </a:cubicBezTo>
                <a:cubicBezTo>
                  <a:pt x="5796" y="652523"/>
                  <a:pt x="-8750" y="639363"/>
                  <a:pt x="7212" y="667297"/>
                </a:cubicBezTo>
                <a:cubicBezTo>
                  <a:pt x="18448" y="686959"/>
                  <a:pt x="34866" y="687147"/>
                  <a:pt x="55058" y="693878"/>
                </a:cubicBezTo>
                <a:lnTo>
                  <a:pt x="71007" y="699195"/>
                </a:lnTo>
                <a:lnTo>
                  <a:pt x="86956" y="704511"/>
                </a:lnTo>
                <a:lnTo>
                  <a:pt x="118853" y="725776"/>
                </a:lnTo>
                <a:cubicBezTo>
                  <a:pt x="124169" y="729320"/>
                  <a:pt x="128740" y="734389"/>
                  <a:pt x="134802" y="736409"/>
                </a:cubicBezTo>
                <a:lnTo>
                  <a:pt x="150751" y="741725"/>
                </a:lnTo>
                <a:lnTo>
                  <a:pt x="198598" y="773623"/>
                </a:lnTo>
                <a:lnTo>
                  <a:pt x="214547" y="784255"/>
                </a:lnTo>
                <a:cubicBezTo>
                  <a:pt x="218091" y="789571"/>
                  <a:pt x="220190" y="796213"/>
                  <a:pt x="225179" y="800204"/>
                </a:cubicBezTo>
                <a:cubicBezTo>
                  <a:pt x="229555" y="803705"/>
                  <a:pt x="236116" y="803014"/>
                  <a:pt x="241128" y="805520"/>
                </a:cubicBezTo>
                <a:cubicBezTo>
                  <a:pt x="282351" y="826132"/>
                  <a:pt x="232938" y="808107"/>
                  <a:pt x="273026" y="821469"/>
                </a:cubicBezTo>
                <a:cubicBezTo>
                  <a:pt x="288037" y="831478"/>
                  <a:pt x="299383" y="842194"/>
                  <a:pt x="320872" y="837418"/>
                </a:cubicBezTo>
                <a:cubicBezTo>
                  <a:pt x="378372" y="824640"/>
                  <a:pt x="301672" y="818530"/>
                  <a:pt x="352770" y="816153"/>
                </a:cubicBezTo>
                <a:cubicBezTo>
                  <a:pt x="423599" y="812859"/>
                  <a:pt x="494537" y="812609"/>
                  <a:pt x="565421" y="810837"/>
                </a:cubicBezTo>
                <a:cubicBezTo>
                  <a:pt x="570737" y="807293"/>
                  <a:pt x="576852" y="804722"/>
                  <a:pt x="581370" y="800204"/>
                </a:cubicBezTo>
                <a:cubicBezTo>
                  <a:pt x="596050" y="785523"/>
                  <a:pt x="587628" y="779919"/>
                  <a:pt x="607951" y="768306"/>
                </a:cubicBezTo>
                <a:cubicBezTo>
                  <a:pt x="614295" y="764681"/>
                  <a:pt x="622128" y="764762"/>
                  <a:pt x="629216" y="762990"/>
                </a:cubicBezTo>
                <a:cubicBezTo>
                  <a:pt x="630988" y="739953"/>
                  <a:pt x="632887" y="716925"/>
                  <a:pt x="634533" y="693878"/>
                </a:cubicBezTo>
                <a:cubicBezTo>
                  <a:pt x="636431" y="667305"/>
                  <a:pt x="636907" y="640611"/>
                  <a:pt x="639849" y="614134"/>
                </a:cubicBezTo>
                <a:cubicBezTo>
                  <a:pt x="640468" y="608564"/>
                  <a:pt x="643626" y="603573"/>
                  <a:pt x="645165" y="598185"/>
                </a:cubicBezTo>
                <a:cubicBezTo>
                  <a:pt x="647172" y="591160"/>
                  <a:pt x="648709" y="584008"/>
                  <a:pt x="650481" y="576920"/>
                </a:cubicBezTo>
                <a:cubicBezTo>
                  <a:pt x="648709" y="552111"/>
                  <a:pt x="654180" y="525673"/>
                  <a:pt x="645165" y="502492"/>
                </a:cubicBezTo>
                <a:cubicBezTo>
                  <a:pt x="640533" y="490582"/>
                  <a:pt x="623900" y="488315"/>
                  <a:pt x="613267" y="481227"/>
                </a:cubicBezTo>
                <a:lnTo>
                  <a:pt x="597319" y="470595"/>
                </a:lnTo>
                <a:cubicBezTo>
                  <a:pt x="593775" y="465279"/>
                  <a:pt x="587085" y="461023"/>
                  <a:pt x="586686" y="454646"/>
                </a:cubicBezTo>
                <a:cubicBezTo>
                  <a:pt x="583065" y="396721"/>
                  <a:pt x="584942" y="399653"/>
                  <a:pt x="602635" y="364269"/>
                </a:cubicBezTo>
                <a:cubicBezTo>
                  <a:pt x="604407" y="332371"/>
                  <a:pt x="601370" y="299838"/>
                  <a:pt x="607951" y="268576"/>
                </a:cubicBezTo>
                <a:cubicBezTo>
                  <a:pt x="609105" y="263092"/>
                  <a:pt x="619524" y="266761"/>
                  <a:pt x="623900" y="263260"/>
                </a:cubicBezTo>
                <a:cubicBezTo>
                  <a:pt x="628889" y="259269"/>
                  <a:pt x="630989" y="252627"/>
                  <a:pt x="634533" y="247311"/>
                </a:cubicBezTo>
                <a:cubicBezTo>
                  <a:pt x="645492" y="214432"/>
                  <a:pt x="638543" y="244796"/>
                  <a:pt x="629216" y="188832"/>
                </a:cubicBezTo>
                <a:cubicBezTo>
                  <a:pt x="628017" y="181637"/>
                  <a:pt x="622910" y="145762"/>
                  <a:pt x="618584" y="135669"/>
                </a:cubicBezTo>
                <a:cubicBezTo>
                  <a:pt x="609724" y="114995"/>
                  <a:pt x="595545" y="111450"/>
                  <a:pt x="576053" y="98455"/>
                </a:cubicBezTo>
                <a:cubicBezTo>
                  <a:pt x="536461" y="72061"/>
                  <a:pt x="585085" y="105982"/>
                  <a:pt x="544156" y="71874"/>
                </a:cubicBezTo>
                <a:cubicBezTo>
                  <a:pt x="539247" y="67784"/>
                  <a:pt x="533523" y="64785"/>
                  <a:pt x="528207" y="61241"/>
                </a:cubicBezTo>
                <a:cubicBezTo>
                  <a:pt x="509490" y="-51063"/>
                  <a:pt x="310239" y="25799"/>
                  <a:pt x="262393" y="24027"/>
                </a:cubicBezTo>
                <a:close/>
              </a:path>
            </a:pathLst>
          </a:custGeom>
          <a:noFill/>
          <a:ln w="9525">
            <a:solidFill>
              <a:srgbClr val="FFFF0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47" name="Figura a mano libera 46"/>
          <p:cNvSpPr>
            <a:spLocks noChangeAspect="1"/>
          </p:cNvSpPr>
          <p:nvPr/>
        </p:nvSpPr>
        <p:spPr>
          <a:xfrm>
            <a:off x="1950613" y="760193"/>
            <a:ext cx="909882" cy="1198408"/>
          </a:xfrm>
          <a:custGeom>
            <a:avLst/>
            <a:gdLst>
              <a:gd name="connsiteX0" fmla="*/ 324293 w 866554"/>
              <a:gd name="connsiteY0" fmla="*/ 33 h 1141341"/>
              <a:gd name="connsiteX1" fmla="*/ 340242 w 866554"/>
              <a:gd name="connsiteY1" fmla="*/ 26614 h 1141341"/>
              <a:gd name="connsiteX2" fmla="*/ 345558 w 866554"/>
              <a:gd name="connsiteY2" fmla="*/ 42563 h 1141341"/>
              <a:gd name="connsiteX3" fmla="*/ 356191 w 866554"/>
              <a:gd name="connsiteY3" fmla="*/ 63828 h 1141341"/>
              <a:gd name="connsiteX4" fmla="*/ 372140 w 866554"/>
              <a:gd name="connsiteY4" fmla="*/ 101042 h 1141341"/>
              <a:gd name="connsiteX5" fmla="*/ 382772 w 866554"/>
              <a:gd name="connsiteY5" fmla="*/ 132940 h 1141341"/>
              <a:gd name="connsiteX6" fmla="*/ 388089 w 866554"/>
              <a:gd name="connsiteY6" fmla="*/ 148889 h 1141341"/>
              <a:gd name="connsiteX7" fmla="*/ 398721 w 866554"/>
              <a:gd name="connsiteY7" fmla="*/ 228633 h 1141341"/>
              <a:gd name="connsiteX8" fmla="*/ 393405 w 866554"/>
              <a:gd name="connsiteY8" fmla="*/ 324326 h 1141341"/>
              <a:gd name="connsiteX9" fmla="*/ 372140 w 866554"/>
              <a:gd name="connsiteY9" fmla="*/ 372172 h 1141341"/>
              <a:gd name="connsiteX10" fmla="*/ 366823 w 866554"/>
              <a:gd name="connsiteY10" fmla="*/ 388121 h 1141341"/>
              <a:gd name="connsiteX11" fmla="*/ 356191 w 866554"/>
              <a:gd name="connsiteY11" fmla="*/ 409386 h 1141341"/>
              <a:gd name="connsiteX12" fmla="*/ 350875 w 866554"/>
              <a:gd name="connsiteY12" fmla="*/ 425335 h 1141341"/>
              <a:gd name="connsiteX13" fmla="*/ 345558 w 866554"/>
              <a:gd name="connsiteY13" fmla="*/ 446600 h 1141341"/>
              <a:gd name="connsiteX14" fmla="*/ 334926 w 866554"/>
              <a:gd name="connsiteY14" fmla="*/ 462549 h 1141341"/>
              <a:gd name="connsiteX15" fmla="*/ 329609 w 866554"/>
              <a:gd name="connsiteY15" fmla="*/ 478498 h 1141341"/>
              <a:gd name="connsiteX16" fmla="*/ 303028 w 866554"/>
              <a:gd name="connsiteY16" fmla="*/ 510396 h 1141341"/>
              <a:gd name="connsiteX17" fmla="*/ 292396 w 866554"/>
              <a:gd name="connsiteY17" fmla="*/ 531661 h 1141341"/>
              <a:gd name="connsiteX18" fmla="*/ 281763 w 866554"/>
              <a:gd name="connsiteY18" fmla="*/ 563558 h 1141341"/>
              <a:gd name="connsiteX19" fmla="*/ 271130 w 866554"/>
              <a:gd name="connsiteY19" fmla="*/ 579507 h 1141341"/>
              <a:gd name="connsiteX20" fmla="*/ 265814 w 866554"/>
              <a:gd name="connsiteY20" fmla="*/ 595456 h 1141341"/>
              <a:gd name="connsiteX21" fmla="*/ 233916 w 866554"/>
              <a:gd name="connsiteY21" fmla="*/ 616721 h 1141341"/>
              <a:gd name="connsiteX22" fmla="*/ 217968 w 866554"/>
              <a:gd name="connsiteY22" fmla="*/ 627354 h 1141341"/>
              <a:gd name="connsiteX23" fmla="*/ 186070 w 866554"/>
              <a:gd name="connsiteY23" fmla="*/ 659252 h 1141341"/>
              <a:gd name="connsiteX24" fmla="*/ 154172 w 866554"/>
              <a:gd name="connsiteY24" fmla="*/ 675200 h 1141341"/>
              <a:gd name="connsiteX25" fmla="*/ 127591 w 866554"/>
              <a:gd name="connsiteY25" fmla="*/ 685833 h 1141341"/>
              <a:gd name="connsiteX26" fmla="*/ 74428 w 866554"/>
              <a:gd name="connsiteY26" fmla="*/ 723047 h 1141341"/>
              <a:gd name="connsiteX27" fmla="*/ 42530 w 866554"/>
              <a:gd name="connsiteY27" fmla="*/ 733679 h 1141341"/>
              <a:gd name="connsiteX28" fmla="*/ 26582 w 866554"/>
              <a:gd name="connsiteY28" fmla="*/ 744312 h 1141341"/>
              <a:gd name="connsiteX29" fmla="*/ 15949 w 866554"/>
              <a:gd name="connsiteY29" fmla="*/ 776210 h 1141341"/>
              <a:gd name="connsiteX30" fmla="*/ 0 w 866554"/>
              <a:gd name="connsiteY30" fmla="*/ 818740 h 1141341"/>
              <a:gd name="connsiteX31" fmla="*/ 10633 w 866554"/>
              <a:gd name="connsiteY31" fmla="*/ 903800 h 1141341"/>
              <a:gd name="connsiteX32" fmla="*/ 21265 w 866554"/>
              <a:gd name="connsiteY32" fmla="*/ 919749 h 1141341"/>
              <a:gd name="connsiteX33" fmla="*/ 26582 w 866554"/>
              <a:gd name="connsiteY33" fmla="*/ 967596 h 1141341"/>
              <a:gd name="connsiteX34" fmla="*/ 53163 w 866554"/>
              <a:gd name="connsiteY34" fmla="*/ 988861 h 1141341"/>
              <a:gd name="connsiteX35" fmla="*/ 85061 w 866554"/>
              <a:gd name="connsiteY35" fmla="*/ 1015442 h 1141341"/>
              <a:gd name="connsiteX36" fmla="*/ 116958 w 866554"/>
              <a:gd name="connsiteY36" fmla="*/ 1031391 h 1141341"/>
              <a:gd name="connsiteX37" fmla="*/ 164805 w 866554"/>
              <a:gd name="connsiteY37" fmla="*/ 1057972 h 1141341"/>
              <a:gd name="connsiteX38" fmla="*/ 260498 w 866554"/>
              <a:gd name="connsiteY38" fmla="*/ 1047340 h 1141341"/>
              <a:gd name="connsiteX39" fmla="*/ 292396 w 866554"/>
              <a:gd name="connsiteY39" fmla="*/ 1020758 h 1141341"/>
              <a:gd name="connsiteX40" fmla="*/ 372140 w 866554"/>
              <a:gd name="connsiteY40" fmla="*/ 1031391 h 1141341"/>
              <a:gd name="connsiteX41" fmla="*/ 404037 w 866554"/>
              <a:gd name="connsiteY41" fmla="*/ 1057972 h 1141341"/>
              <a:gd name="connsiteX42" fmla="*/ 419986 w 866554"/>
              <a:gd name="connsiteY42" fmla="*/ 1063289 h 1141341"/>
              <a:gd name="connsiteX43" fmla="*/ 451884 w 866554"/>
              <a:gd name="connsiteY43" fmla="*/ 1084554 h 1141341"/>
              <a:gd name="connsiteX44" fmla="*/ 467833 w 866554"/>
              <a:gd name="connsiteY44" fmla="*/ 1095186 h 1141341"/>
              <a:gd name="connsiteX45" fmla="*/ 489098 w 866554"/>
              <a:gd name="connsiteY45" fmla="*/ 1105819 h 1141341"/>
              <a:gd name="connsiteX46" fmla="*/ 531628 w 866554"/>
              <a:gd name="connsiteY46" fmla="*/ 1127084 h 1141341"/>
              <a:gd name="connsiteX47" fmla="*/ 584791 w 866554"/>
              <a:gd name="connsiteY47" fmla="*/ 1132400 h 1141341"/>
              <a:gd name="connsiteX48" fmla="*/ 707065 w 866554"/>
              <a:gd name="connsiteY48" fmla="*/ 1132400 h 1141341"/>
              <a:gd name="connsiteX49" fmla="*/ 781493 w 866554"/>
              <a:gd name="connsiteY49" fmla="*/ 1127084 h 1141341"/>
              <a:gd name="connsiteX50" fmla="*/ 802758 w 866554"/>
              <a:gd name="connsiteY50" fmla="*/ 1095186 h 1141341"/>
              <a:gd name="connsiteX51" fmla="*/ 808075 w 866554"/>
              <a:gd name="connsiteY51" fmla="*/ 1079238 h 1141341"/>
              <a:gd name="connsiteX52" fmla="*/ 818707 w 866554"/>
              <a:gd name="connsiteY52" fmla="*/ 1063289 h 1141341"/>
              <a:gd name="connsiteX53" fmla="*/ 839972 w 866554"/>
              <a:gd name="connsiteY53" fmla="*/ 1026075 h 1141341"/>
              <a:gd name="connsiteX54" fmla="*/ 850605 w 866554"/>
              <a:gd name="connsiteY54" fmla="*/ 994177 h 1141341"/>
              <a:gd name="connsiteX55" fmla="*/ 855921 w 866554"/>
              <a:gd name="connsiteY55" fmla="*/ 972912 h 1141341"/>
              <a:gd name="connsiteX56" fmla="*/ 866554 w 866554"/>
              <a:gd name="connsiteY56" fmla="*/ 941014 h 1141341"/>
              <a:gd name="connsiteX57" fmla="*/ 861237 w 866554"/>
              <a:gd name="connsiteY57" fmla="*/ 898484 h 1141341"/>
              <a:gd name="connsiteX58" fmla="*/ 850605 w 866554"/>
              <a:gd name="connsiteY58" fmla="*/ 877219 h 1141341"/>
              <a:gd name="connsiteX59" fmla="*/ 845289 w 866554"/>
              <a:gd name="connsiteY59" fmla="*/ 861270 h 1141341"/>
              <a:gd name="connsiteX60" fmla="*/ 839972 w 866554"/>
              <a:gd name="connsiteY60" fmla="*/ 840005 h 1141341"/>
              <a:gd name="connsiteX61" fmla="*/ 808075 w 866554"/>
              <a:gd name="connsiteY61" fmla="*/ 813424 h 1141341"/>
              <a:gd name="connsiteX62" fmla="*/ 797442 w 866554"/>
              <a:gd name="connsiteY62" fmla="*/ 797475 h 1141341"/>
              <a:gd name="connsiteX63" fmla="*/ 786809 w 866554"/>
              <a:gd name="connsiteY63" fmla="*/ 754945 h 1141341"/>
              <a:gd name="connsiteX64" fmla="*/ 776177 w 866554"/>
              <a:gd name="connsiteY64" fmla="*/ 723047 h 1141341"/>
              <a:gd name="connsiteX65" fmla="*/ 770861 w 866554"/>
              <a:gd name="connsiteY65" fmla="*/ 707098 h 1141341"/>
              <a:gd name="connsiteX66" fmla="*/ 765544 w 866554"/>
              <a:gd name="connsiteY66" fmla="*/ 691149 h 1141341"/>
              <a:gd name="connsiteX67" fmla="*/ 754912 w 866554"/>
              <a:gd name="connsiteY67" fmla="*/ 675200 h 1141341"/>
              <a:gd name="connsiteX68" fmla="*/ 749596 w 866554"/>
              <a:gd name="connsiteY68" fmla="*/ 659252 h 1141341"/>
              <a:gd name="connsiteX69" fmla="*/ 733647 w 866554"/>
              <a:gd name="connsiteY69" fmla="*/ 643303 h 1141341"/>
              <a:gd name="connsiteX70" fmla="*/ 723014 w 866554"/>
              <a:gd name="connsiteY70" fmla="*/ 622038 h 1141341"/>
              <a:gd name="connsiteX71" fmla="*/ 701749 w 866554"/>
              <a:gd name="connsiteY71" fmla="*/ 590140 h 1141341"/>
              <a:gd name="connsiteX72" fmla="*/ 696433 w 866554"/>
              <a:gd name="connsiteY72" fmla="*/ 574191 h 1141341"/>
              <a:gd name="connsiteX73" fmla="*/ 664535 w 866554"/>
              <a:gd name="connsiteY73" fmla="*/ 526345 h 1141341"/>
              <a:gd name="connsiteX74" fmla="*/ 653903 w 866554"/>
              <a:gd name="connsiteY74" fmla="*/ 510396 h 1141341"/>
              <a:gd name="connsiteX75" fmla="*/ 637954 w 866554"/>
              <a:gd name="connsiteY75" fmla="*/ 478498 h 1141341"/>
              <a:gd name="connsiteX76" fmla="*/ 632637 w 866554"/>
              <a:gd name="connsiteY76" fmla="*/ 462549 h 1141341"/>
              <a:gd name="connsiteX77" fmla="*/ 616689 w 866554"/>
              <a:gd name="connsiteY77" fmla="*/ 414703 h 1141341"/>
              <a:gd name="connsiteX78" fmla="*/ 606056 w 866554"/>
              <a:gd name="connsiteY78" fmla="*/ 382805 h 1141341"/>
              <a:gd name="connsiteX79" fmla="*/ 590107 w 866554"/>
              <a:gd name="connsiteY79" fmla="*/ 366856 h 1141341"/>
              <a:gd name="connsiteX80" fmla="*/ 584791 w 866554"/>
              <a:gd name="connsiteY80" fmla="*/ 350907 h 1141341"/>
              <a:gd name="connsiteX81" fmla="*/ 574158 w 866554"/>
              <a:gd name="connsiteY81" fmla="*/ 334958 h 1141341"/>
              <a:gd name="connsiteX82" fmla="*/ 568842 w 866554"/>
              <a:gd name="connsiteY82" fmla="*/ 308377 h 1141341"/>
              <a:gd name="connsiteX83" fmla="*/ 595423 w 866554"/>
              <a:gd name="connsiteY83" fmla="*/ 175470 h 1141341"/>
              <a:gd name="connsiteX84" fmla="*/ 611372 w 866554"/>
              <a:gd name="connsiteY84" fmla="*/ 164838 h 1141341"/>
              <a:gd name="connsiteX85" fmla="*/ 627321 w 866554"/>
              <a:gd name="connsiteY85" fmla="*/ 143572 h 1141341"/>
              <a:gd name="connsiteX86" fmla="*/ 637954 w 866554"/>
              <a:gd name="connsiteY86" fmla="*/ 127624 h 1141341"/>
              <a:gd name="connsiteX87" fmla="*/ 653903 w 866554"/>
              <a:gd name="connsiteY87" fmla="*/ 111675 h 1141341"/>
              <a:gd name="connsiteX88" fmla="*/ 675168 w 866554"/>
              <a:gd name="connsiteY88" fmla="*/ 79777 h 1141341"/>
              <a:gd name="connsiteX89" fmla="*/ 685800 w 866554"/>
              <a:gd name="connsiteY89" fmla="*/ 63828 h 1141341"/>
              <a:gd name="connsiteX90" fmla="*/ 680484 w 866554"/>
              <a:gd name="connsiteY90" fmla="*/ 37247 h 1141341"/>
              <a:gd name="connsiteX91" fmla="*/ 669851 w 866554"/>
              <a:gd name="connsiteY91" fmla="*/ 21298 h 1141341"/>
              <a:gd name="connsiteX92" fmla="*/ 324293 w 866554"/>
              <a:gd name="connsiteY92" fmla="*/ 33 h 114134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Lst>
            <a:rect l="l" t="t" r="r" b="b"/>
            <a:pathLst>
              <a:path w="866554" h="1141341">
                <a:moveTo>
                  <a:pt x="324293" y="33"/>
                </a:moveTo>
                <a:cubicBezTo>
                  <a:pt x="269358" y="919"/>
                  <a:pt x="335621" y="17372"/>
                  <a:pt x="340242" y="26614"/>
                </a:cubicBezTo>
                <a:cubicBezTo>
                  <a:pt x="342748" y="31626"/>
                  <a:pt x="343351" y="37412"/>
                  <a:pt x="345558" y="42563"/>
                </a:cubicBezTo>
                <a:cubicBezTo>
                  <a:pt x="348680" y="49847"/>
                  <a:pt x="352647" y="56740"/>
                  <a:pt x="356191" y="63828"/>
                </a:cubicBezTo>
                <a:cubicBezTo>
                  <a:pt x="370254" y="120083"/>
                  <a:pt x="351160" y="53836"/>
                  <a:pt x="372140" y="101042"/>
                </a:cubicBezTo>
                <a:cubicBezTo>
                  <a:pt x="376692" y="111284"/>
                  <a:pt x="379228" y="122307"/>
                  <a:pt x="382772" y="132940"/>
                </a:cubicBezTo>
                <a:lnTo>
                  <a:pt x="388089" y="148889"/>
                </a:lnTo>
                <a:cubicBezTo>
                  <a:pt x="391673" y="170392"/>
                  <a:pt x="398721" y="209112"/>
                  <a:pt x="398721" y="228633"/>
                </a:cubicBezTo>
                <a:cubicBezTo>
                  <a:pt x="398721" y="260580"/>
                  <a:pt x="397368" y="292626"/>
                  <a:pt x="393405" y="324326"/>
                </a:cubicBezTo>
                <a:cubicBezTo>
                  <a:pt x="388833" y="360899"/>
                  <a:pt x="384382" y="347689"/>
                  <a:pt x="372140" y="372172"/>
                </a:cubicBezTo>
                <a:cubicBezTo>
                  <a:pt x="369634" y="377184"/>
                  <a:pt x="369031" y="382970"/>
                  <a:pt x="366823" y="388121"/>
                </a:cubicBezTo>
                <a:cubicBezTo>
                  <a:pt x="363701" y="395405"/>
                  <a:pt x="359313" y="402102"/>
                  <a:pt x="356191" y="409386"/>
                </a:cubicBezTo>
                <a:cubicBezTo>
                  <a:pt x="353984" y="414537"/>
                  <a:pt x="352415" y="419947"/>
                  <a:pt x="350875" y="425335"/>
                </a:cubicBezTo>
                <a:cubicBezTo>
                  <a:pt x="348868" y="432360"/>
                  <a:pt x="348436" y="439884"/>
                  <a:pt x="345558" y="446600"/>
                </a:cubicBezTo>
                <a:cubicBezTo>
                  <a:pt x="343041" y="452473"/>
                  <a:pt x="337783" y="456834"/>
                  <a:pt x="334926" y="462549"/>
                </a:cubicBezTo>
                <a:cubicBezTo>
                  <a:pt x="332420" y="467561"/>
                  <a:pt x="332115" y="473486"/>
                  <a:pt x="329609" y="478498"/>
                </a:cubicBezTo>
                <a:cubicBezTo>
                  <a:pt x="322206" y="493303"/>
                  <a:pt x="314787" y="498637"/>
                  <a:pt x="303028" y="510396"/>
                </a:cubicBezTo>
                <a:cubicBezTo>
                  <a:pt x="299484" y="517484"/>
                  <a:pt x="295339" y="524303"/>
                  <a:pt x="292396" y="531661"/>
                </a:cubicBezTo>
                <a:cubicBezTo>
                  <a:pt x="288234" y="542067"/>
                  <a:pt x="287980" y="554233"/>
                  <a:pt x="281763" y="563558"/>
                </a:cubicBezTo>
                <a:lnTo>
                  <a:pt x="271130" y="579507"/>
                </a:lnTo>
                <a:cubicBezTo>
                  <a:pt x="269358" y="584823"/>
                  <a:pt x="269777" y="591493"/>
                  <a:pt x="265814" y="595456"/>
                </a:cubicBezTo>
                <a:cubicBezTo>
                  <a:pt x="256778" y="604492"/>
                  <a:pt x="244549" y="609632"/>
                  <a:pt x="233916" y="616721"/>
                </a:cubicBezTo>
                <a:cubicBezTo>
                  <a:pt x="228600" y="620265"/>
                  <a:pt x="222486" y="622836"/>
                  <a:pt x="217968" y="627354"/>
                </a:cubicBezTo>
                <a:cubicBezTo>
                  <a:pt x="207335" y="637987"/>
                  <a:pt x="200335" y="654497"/>
                  <a:pt x="186070" y="659252"/>
                </a:cubicBezTo>
                <a:cubicBezTo>
                  <a:pt x="145988" y="672612"/>
                  <a:pt x="195388" y="654592"/>
                  <a:pt x="154172" y="675200"/>
                </a:cubicBezTo>
                <a:cubicBezTo>
                  <a:pt x="145637" y="679468"/>
                  <a:pt x="135933" y="681198"/>
                  <a:pt x="127591" y="685833"/>
                </a:cubicBezTo>
                <a:cubicBezTo>
                  <a:pt x="109394" y="695943"/>
                  <a:pt x="94529" y="716347"/>
                  <a:pt x="74428" y="723047"/>
                </a:cubicBezTo>
                <a:lnTo>
                  <a:pt x="42530" y="733679"/>
                </a:lnTo>
                <a:cubicBezTo>
                  <a:pt x="37214" y="737223"/>
                  <a:pt x="29968" y="738894"/>
                  <a:pt x="26582" y="744312"/>
                </a:cubicBezTo>
                <a:cubicBezTo>
                  <a:pt x="20642" y="753816"/>
                  <a:pt x="20112" y="765804"/>
                  <a:pt x="15949" y="776210"/>
                </a:cubicBezTo>
                <a:cubicBezTo>
                  <a:pt x="3235" y="807994"/>
                  <a:pt x="8334" y="793738"/>
                  <a:pt x="0" y="818740"/>
                </a:cubicBezTo>
                <a:cubicBezTo>
                  <a:pt x="641" y="826434"/>
                  <a:pt x="1948" y="883536"/>
                  <a:pt x="10633" y="903800"/>
                </a:cubicBezTo>
                <a:cubicBezTo>
                  <a:pt x="13150" y="909673"/>
                  <a:pt x="17721" y="914433"/>
                  <a:pt x="21265" y="919749"/>
                </a:cubicBezTo>
                <a:cubicBezTo>
                  <a:pt x="23037" y="935698"/>
                  <a:pt x="22690" y="952028"/>
                  <a:pt x="26582" y="967596"/>
                </a:cubicBezTo>
                <a:cubicBezTo>
                  <a:pt x="31703" y="988081"/>
                  <a:pt x="38712" y="981636"/>
                  <a:pt x="53163" y="988861"/>
                </a:cubicBezTo>
                <a:cubicBezTo>
                  <a:pt x="72961" y="998760"/>
                  <a:pt x="67426" y="1000745"/>
                  <a:pt x="85061" y="1015442"/>
                </a:cubicBezTo>
                <a:cubicBezTo>
                  <a:pt x="98803" y="1026894"/>
                  <a:pt x="100972" y="1026063"/>
                  <a:pt x="116958" y="1031391"/>
                </a:cubicBezTo>
                <a:cubicBezTo>
                  <a:pt x="153519" y="1055764"/>
                  <a:pt x="136733" y="1048615"/>
                  <a:pt x="164805" y="1057972"/>
                </a:cubicBezTo>
                <a:cubicBezTo>
                  <a:pt x="169249" y="1057655"/>
                  <a:pt x="237802" y="1057067"/>
                  <a:pt x="260498" y="1047340"/>
                </a:cubicBezTo>
                <a:cubicBezTo>
                  <a:pt x="273450" y="1041789"/>
                  <a:pt x="282816" y="1030338"/>
                  <a:pt x="292396" y="1020758"/>
                </a:cubicBezTo>
                <a:cubicBezTo>
                  <a:pt x="306640" y="1021945"/>
                  <a:pt x="350427" y="1020534"/>
                  <a:pt x="372140" y="1031391"/>
                </a:cubicBezTo>
                <a:cubicBezTo>
                  <a:pt x="406923" y="1048783"/>
                  <a:pt x="368770" y="1034460"/>
                  <a:pt x="404037" y="1057972"/>
                </a:cubicBezTo>
                <a:cubicBezTo>
                  <a:pt x="408700" y="1061081"/>
                  <a:pt x="415087" y="1060567"/>
                  <a:pt x="419986" y="1063289"/>
                </a:cubicBezTo>
                <a:cubicBezTo>
                  <a:pt x="431157" y="1069495"/>
                  <a:pt x="441251" y="1077466"/>
                  <a:pt x="451884" y="1084554"/>
                </a:cubicBezTo>
                <a:cubicBezTo>
                  <a:pt x="457200" y="1088098"/>
                  <a:pt x="462118" y="1092329"/>
                  <a:pt x="467833" y="1095186"/>
                </a:cubicBezTo>
                <a:cubicBezTo>
                  <a:pt x="474921" y="1098730"/>
                  <a:pt x="482170" y="1101970"/>
                  <a:pt x="489098" y="1105819"/>
                </a:cubicBezTo>
                <a:cubicBezTo>
                  <a:pt x="502743" y="1113400"/>
                  <a:pt x="515498" y="1124603"/>
                  <a:pt x="531628" y="1127084"/>
                </a:cubicBezTo>
                <a:cubicBezTo>
                  <a:pt x="549230" y="1129792"/>
                  <a:pt x="567070" y="1130628"/>
                  <a:pt x="584791" y="1132400"/>
                </a:cubicBezTo>
                <a:cubicBezTo>
                  <a:pt x="634007" y="1148807"/>
                  <a:pt x="597660" y="1138836"/>
                  <a:pt x="707065" y="1132400"/>
                </a:cubicBezTo>
                <a:cubicBezTo>
                  <a:pt x="731895" y="1130939"/>
                  <a:pt x="756684" y="1128856"/>
                  <a:pt x="781493" y="1127084"/>
                </a:cubicBezTo>
                <a:cubicBezTo>
                  <a:pt x="794132" y="1089166"/>
                  <a:pt x="776212" y="1135003"/>
                  <a:pt x="802758" y="1095186"/>
                </a:cubicBezTo>
                <a:cubicBezTo>
                  <a:pt x="805866" y="1090524"/>
                  <a:pt x="805569" y="1084250"/>
                  <a:pt x="808075" y="1079238"/>
                </a:cubicBezTo>
                <a:cubicBezTo>
                  <a:pt x="810932" y="1073523"/>
                  <a:pt x="815163" y="1068605"/>
                  <a:pt x="818707" y="1063289"/>
                </a:cubicBezTo>
                <a:cubicBezTo>
                  <a:pt x="833307" y="1004885"/>
                  <a:pt x="811179" y="1077901"/>
                  <a:pt x="839972" y="1026075"/>
                </a:cubicBezTo>
                <a:cubicBezTo>
                  <a:pt x="845415" y="1016278"/>
                  <a:pt x="847887" y="1005050"/>
                  <a:pt x="850605" y="994177"/>
                </a:cubicBezTo>
                <a:cubicBezTo>
                  <a:pt x="852377" y="987089"/>
                  <a:pt x="853821" y="979910"/>
                  <a:pt x="855921" y="972912"/>
                </a:cubicBezTo>
                <a:cubicBezTo>
                  <a:pt x="859142" y="962177"/>
                  <a:pt x="866554" y="941014"/>
                  <a:pt x="866554" y="941014"/>
                </a:cubicBezTo>
                <a:cubicBezTo>
                  <a:pt x="864782" y="926837"/>
                  <a:pt x="864702" y="912344"/>
                  <a:pt x="861237" y="898484"/>
                </a:cubicBezTo>
                <a:cubicBezTo>
                  <a:pt x="859315" y="890796"/>
                  <a:pt x="853727" y="884503"/>
                  <a:pt x="850605" y="877219"/>
                </a:cubicBezTo>
                <a:cubicBezTo>
                  <a:pt x="848398" y="872068"/>
                  <a:pt x="846829" y="866658"/>
                  <a:pt x="845289" y="861270"/>
                </a:cubicBezTo>
                <a:cubicBezTo>
                  <a:pt x="843282" y="854245"/>
                  <a:pt x="843597" y="846349"/>
                  <a:pt x="839972" y="840005"/>
                </a:cubicBezTo>
                <a:cubicBezTo>
                  <a:pt x="833674" y="828984"/>
                  <a:pt x="818238" y="820199"/>
                  <a:pt x="808075" y="813424"/>
                </a:cubicBezTo>
                <a:cubicBezTo>
                  <a:pt x="804531" y="808108"/>
                  <a:pt x="800299" y="803190"/>
                  <a:pt x="797442" y="797475"/>
                </a:cubicBezTo>
                <a:cubicBezTo>
                  <a:pt x="790992" y="784575"/>
                  <a:pt x="790447" y="768283"/>
                  <a:pt x="786809" y="754945"/>
                </a:cubicBezTo>
                <a:cubicBezTo>
                  <a:pt x="783860" y="744132"/>
                  <a:pt x="779721" y="733680"/>
                  <a:pt x="776177" y="723047"/>
                </a:cubicBezTo>
                <a:lnTo>
                  <a:pt x="770861" y="707098"/>
                </a:lnTo>
                <a:cubicBezTo>
                  <a:pt x="769089" y="701782"/>
                  <a:pt x="768652" y="695812"/>
                  <a:pt x="765544" y="691149"/>
                </a:cubicBezTo>
                <a:cubicBezTo>
                  <a:pt x="762000" y="685833"/>
                  <a:pt x="757769" y="680915"/>
                  <a:pt x="754912" y="675200"/>
                </a:cubicBezTo>
                <a:cubicBezTo>
                  <a:pt x="752406" y="670188"/>
                  <a:pt x="752704" y="663914"/>
                  <a:pt x="749596" y="659252"/>
                </a:cubicBezTo>
                <a:cubicBezTo>
                  <a:pt x="745425" y="652996"/>
                  <a:pt x="738017" y="649421"/>
                  <a:pt x="733647" y="643303"/>
                </a:cubicBezTo>
                <a:cubicBezTo>
                  <a:pt x="729041" y="636854"/>
                  <a:pt x="727091" y="628834"/>
                  <a:pt x="723014" y="622038"/>
                </a:cubicBezTo>
                <a:cubicBezTo>
                  <a:pt x="716439" y="611080"/>
                  <a:pt x="701749" y="590140"/>
                  <a:pt x="701749" y="590140"/>
                </a:cubicBezTo>
                <a:cubicBezTo>
                  <a:pt x="699977" y="584824"/>
                  <a:pt x="699154" y="579090"/>
                  <a:pt x="696433" y="574191"/>
                </a:cubicBezTo>
                <a:cubicBezTo>
                  <a:pt x="696415" y="574159"/>
                  <a:pt x="669862" y="534335"/>
                  <a:pt x="664535" y="526345"/>
                </a:cubicBezTo>
                <a:cubicBezTo>
                  <a:pt x="660991" y="521029"/>
                  <a:pt x="655924" y="516457"/>
                  <a:pt x="653903" y="510396"/>
                </a:cubicBezTo>
                <a:cubicBezTo>
                  <a:pt x="640538" y="470307"/>
                  <a:pt x="658566" y="519722"/>
                  <a:pt x="637954" y="478498"/>
                </a:cubicBezTo>
                <a:cubicBezTo>
                  <a:pt x="635448" y="473486"/>
                  <a:pt x="634605" y="467796"/>
                  <a:pt x="632637" y="462549"/>
                </a:cubicBezTo>
                <a:cubicBezTo>
                  <a:pt x="605989" y="391490"/>
                  <a:pt x="634504" y="474087"/>
                  <a:pt x="616689" y="414703"/>
                </a:cubicBezTo>
                <a:cubicBezTo>
                  <a:pt x="613468" y="403968"/>
                  <a:pt x="613981" y="390730"/>
                  <a:pt x="606056" y="382805"/>
                </a:cubicBezTo>
                <a:lnTo>
                  <a:pt x="590107" y="366856"/>
                </a:lnTo>
                <a:cubicBezTo>
                  <a:pt x="588335" y="361540"/>
                  <a:pt x="587297" y="355919"/>
                  <a:pt x="584791" y="350907"/>
                </a:cubicBezTo>
                <a:cubicBezTo>
                  <a:pt x="581934" y="345192"/>
                  <a:pt x="576402" y="340941"/>
                  <a:pt x="574158" y="334958"/>
                </a:cubicBezTo>
                <a:cubicBezTo>
                  <a:pt x="570985" y="326498"/>
                  <a:pt x="570614" y="317237"/>
                  <a:pt x="568842" y="308377"/>
                </a:cubicBezTo>
                <a:cubicBezTo>
                  <a:pt x="570036" y="285685"/>
                  <a:pt x="557273" y="200902"/>
                  <a:pt x="595423" y="175470"/>
                </a:cubicBezTo>
                <a:lnTo>
                  <a:pt x="611372" y="164838"/>
                </a:lnTo>
                <a:cubicBezTo>
                  <a:pt x="616688" y="157749"/>
                  <a:pt x="622171" y="150782"/>
                  <a:pt x="627321" y="143572"/>
                </a:cubicBezTo>
                <a:cubicBezTo>
                  <a:pt x="631035" y="138373"/>
                  <a:pt x="633864" y="132532"/>
                  <a:pt x="637954" y="127624"/>
                </a:cubicBezTo>
                <a:cubicBezTo>
                  <a:pt x="642767" y="121848"/>
                  <a:pt x="649287" y="117610"/>
                  <a:pt x="653903" y="111675"/>
                </a:cubicBezTo>
                <a:cubicBezTo>
                  <a:pt x="661748" y="101588"/>
                  <a:pt x="668080" y="90410"/>
                  <a:pt x="675168" y="79777"/>
                </a:cubicBezTo>
                <a:lnTo>
                  <a:pt x="685800" y="63828"/>
                </a:lnTo>
                <a:cubicBezTo>
                  <a:pt x="684028" y="54968"/>
                  <a:pt x="683657" y="45707"/>
                  <a:pt x="680484" y="37247"/>
                </a:cubicBezTo>
                <a:cubicBezTo>
                  <a:pt x="678240" y="31264"/>
                  <a:pt x="676233" y="21612"/>
                  <a:pt x="669851" y="21298"/>
                </a:cubicBezTo>
                <a:cubicBezTo>
                  <a:pt x="565424" y="16162"/>
                  <a:pt x="379228" y="-853"/>
                  <a:pt x="324293" y="33"/>
                </a:cubicBezTo>
                <a:close/>
              </a:path>
            </a:pathLst>
          </a:custGeom>
          <a:noFill/>
          <a:ln w="9525">
            <a:solidFill>
              <a:srgbClr val="FFFF0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48" name="Figura a mano libera 47"/>
          <p:cNvSpPr>
            <a:spLocks noChangeAspect="1"/>
          </p:cNvSpPr>
          <p:nvPr/>
        </p:nvSpPr>
        <p:spPr>
          <a:xfrm>
            <a:off x="3350260" y="760193"/>
            <a:ext cx="909882" cy="1198408"/>
          </a:xfrm>
          <a:custGeom>
            <a:avLst/>
            <a:gdLst>
              <a:gd name="connsiteX0" fmla="*/ 324293 w 866554"/>
              <a:gd name="connsiteY0" fmla="*/ 33 h 1141341"/>
              <a:gd name="connsiteX1" fmla="*/ 340242 w 866554"/>
              <a:gd name="connsiteY1" fmla="*/ 26614 h 1141341"/>
              <a:gd name="connsiteX2" fmla="*/ 345558 w 866554"/>
              <a:gd name="connsiteY2" fmla="*/ 42563 h 1141341"/>
              <a:gd name="connsiteX3" fmla="*/ 356191 w 866554"/>
              <a:gd name="connsiteY3" fmla="*/ 63828 h 1141341"/>
              <a:gd name="connsiteX4" fmla="*/ 372140 w 866554"/>
              <a:gd name="connsiteY4" fmla="*/ 101042 h 1141341"/>
              <a:gd name="connsiteX5" fmla="*/ 382772 w 866554"/>
              <a:gd name="connsiteY5" fmla="*/ 132940 h 1141341"/>
              <a:gd name="connsiteX6" fmla="*/ 388089 w 866554"/>
              <a:gd name="connsiteY6" fmla="*/ 148889 h 1141341"/>
              <a:gd name="connsiteX7" fmla="*/ 398721 w 866554"/>
              <a:gd name="connsiteY7" fmla="*/ 228633 h 1141341"/>
              <a:gd name="connsiteX8" fmla="*/ 393405 w 866554"/>
              <a:gd name="connsiteY8" fmla="*/ 324326 h 1141341"/>
              <a:gd name="connsiteX9" fmla="*/ 372140 w 866554"/>
              <a:gd name="connsiteY9" fmla="*/ 372172 h 1141341"/>
              <a:gd name="connsiteX10" fmla="*/ 366823 w 866554"/>
              <a:gd name="connsiteY10" fmla="*/ 388121 h 1141341"/>
              <a:gd name="connsiteX11" fmla="*/ 356191 w 866554"/>
              <a:gd name="connsiteY11" fmla="*/ 409386 h 1141341"/>
              <a:gd name="connsiteX12" fmla="*/ 350875 w 866554"/>
              <a:gd name="connsiteY12" fmla="*/ 425335 h 1141341"/>
              <a:gd name="connsiteX13" fmla="*/ 345558 w 866554"/>
              <a:gd name="connsiteY13" fmla="*/ 446600 h 1141341"/>
              <a:gd name="connsiteX14" fmla="*/ 334926 w 866554"/>
              <a:gd name="connsiteY14" fmla="*/ 462549 h 1141341"/>
              <a:gd name="connsiteX15" fmla="*/ 329609 w 866554"/>
              <a:gd name="connsiteY15" fmla="*/ 478498 h 1141341"/>
              <a:gd name="connsiteX16" fmla="*/ 303028 w 866554"/>
              <a:gd name="connsiteY16" fmla="*/ 510396 h 1141341"/>
              <a:gd name="connsiteX17" fmla="*/ 292396 w 866554"/>
              <a:gd name="connsiteY17" fmla="*/ 531661 h 1141341"/>
              <a:gd name="connsiteX18" fmla="*/ 281763 w 866554"/>
              <a:gd name="connsiteY18" fmla="*/ 563558 h 1141341"/>
              <a:gd name="connsiteX19" fmla="*/ 271130 w 866554"/>
              <a:gd name="connsiteY19" fmla="*/ 579507 h 1141341"/>
              <a:gd name="connsiteX20" fmla="*/ 265814 w 866554"/>
              <a:gd name="connsiteY20" fmla="*/ 595456 h 1141341"/>
              <a:gd name="connsiteX21" fmla="*/ 233916 w 866554"/>
              <a:gd name="connsiteY21" fmla="*/ 616721 h 1141341"/>
              <a:gd name="connsiteX22" fmla="*/ 217968 w 866554"/>
              <a:gd name="connsiteY22" fmla="*/ 627354 h 1141341"/>
              <a:gd name="connsiteX23" fmla="*/ 186070 w 866554"/>
              <a:gd name="connsiteY23" fmla="*/ 659252 h 1141341"/>
              <a:gd name="connsiteX24" fmla="*/ 154172 w 866554"/>
              <a:gd name="connsiteY24" fmla="*/ 675200 h 1141341"/>
              <a:gd name="connsiteX25" fmla="*/ 127591 w 866554"/>
              <a:gd name="connsiteY25" fmla="*/ 685833 h 1141341"/>
              <a:gd name="connsiteX26" fmla="*/ 74428 w 866554"/>
              <a:gd name="connsiteY26" fmla="*/ 723047 h 1141341"/>
              <a:gd name="connsiteX27" fmla="*/ 42530 w 866554"/>
              <a:gd name="connsiteY27" fmla="*/ 733679 h 1141341"/>
              <a:gd name="connsiteX28" fmla="*/ 26582 w 866554"/>
              <a:gd name="connsiteY28" fmla="*/ 744312 h 1141341"/>
              <a:gd name="connsiteX29" fmla="*/ 15949 w 866554"/>
              <a:gd name="connsiteY29" fmla="*/ 776210 h 1141341"/>
              <a:gd name="connsiteX30" fmla="*/ 0 w 866554"/>
              <a:gd name="connsiteY30" fmla="*/ 818740 h 1141341"/>
              <a:gd name="connsiteX31" fmla="*/ 10633 w 866554"/>
              <a:gd name="connsiteY31" fmla="*/ 903800 h 1141341"/>
              <a:gd name="connsiteX32" fmla="*/ 21265 w 866554"/>
              <a:gd name="connsiteY32" fmla="*/ 919749 h 1141341"/>
              <a:gd name="connsiteX33" fmla="*/ 26582 w 866554"/>
              <a:gd name="connsiteY33" fmla="*/ 967596 h 1141341"/>
              <a:gd name="connsiteX34" fmla="*/ 53163 w 866554"/>
              <a:gd name="connsiteY34" fmla="*/ 988861 h 1141341"/>
              <a:gd name="connsiteX35" fmla="*/ 85061 w 866554"/>
              <a:gd name="connsiteY35" fmla="*/ 1015442 h 1141341"/>
              <a:gd name="connsiteX36" fmla="*/ 116958 w 866554"/>
              <a:gd name="connsiteY36" fmla="*/ 1031391 h 1141341"/>
              <a:gd name="connsiteX37" fmla="*/ 164805 w 866554"/>
              <a:gd name="connsiteY37" fmla="*/ 1057972 h 1141341"/>
              <a:gd name="connsiteX38" fmla="*/ 260498 w 866554"/>
              <a:gd name="connsiteY38" fmla="*/ 1047340 h 1141341"/>
              <a:gd name="connsiteX39" fmla="*/ 292396 w 866554"/>
              <a:gd name="connsiteY39" fmla="*/ 1020758 h 1141341"/>
              <a:gd name="connsiteX40" fmla="*/ 372140 w 866554"/>
              <a:gd name="connsiteY40" fmla="*/ 1031391 h 1141341"/>
              <a:gd name="connsiteX41" fmla="*/ 404037 w 866554"/>
              <a:gd name="connsiteY41" fmla="*/ 1057972 h 1141341"/>
              <a:gd name="connsiteX42" fmla="*/ 419986 w 866554"/>
              <a:gd name="connsiteY42" fmla="*/ 1063289 h 1141341"/>
              <a:gd name="connsiteX43" fmla="*/ 451884 w 866554"/>
              <a:gd name="connsiteY43" fmla="*/ 1084554 h 1141341"/>
              <a:gd name="connsiteX44" fmla="*/ 467833 w 866554"/>
              <a:gd name="connsiteY44" fmla="*/ 1095186 h 1141341"/>
              <a:gd name="connsiteX45" fmla="*/ 489098 w 866554"/>
              <a:gd name="connsiteY45" fmla="*/ 1105819 h 1141341"/>
              <a:gd name="connsiteX46" fmla="*/ 531628 w 866554"/>
              <a:gd name="connsiteY46" fmla="*/ 1127084 h 1141341"/>
              <a:gd name="connsiteX47" fmla="*/ 584791 w 866554"/>
              <a:gd name="connsiteY47" fmla="*/ 1132400 h 1141341"/>
              <a:gd name="connsiteX48" fmla="*/ 707065 w 866554"/>
              <a:gd name="connsiteY48" fmla="*/ 1132400 h 1141341"/>
              <a:gd name="connsiteX49" fmla="*/ 781493 w 866554"/>
              <a:gd name="connsiteY49" fmla="*/ 1127084 h 1141341"/>
              <a:gd name="connsiteX50" fmla="*/ 802758 w 866554"/>
              <a:gd name="connsiteY50" fmla="*/ 1095186 h 1141341"/>
              <a:gd name="connsiteX51" fmla="*/ 808075 w 866554"/>
              <a:gd name="connsiteY51" fmla="*/ 1079238 h 1141341"/>
              <a:gd name="connsiteX52" fmla="*/ 818707 w 866554"/>
              <a:gd name="connsiteY52" fmla="*/ 1063289 h 1141341"/>
              <a:gd name="connsiteX53" fmla="*/ 839972 w 866554"/>
              <a:gd name="connsiteY53" fmla="*/ 1026075 h 1141341"/>
              <a:gd name="connsiteX54" fmla="*/ 850605 w 866554"/>
              <a:gd name="connsiteY54" fmla="*/ 994177 h 1141341"/>
              <a:gd name="connsiteX55" fmla="*/ 855921 w 866554"/>
              <a:gd name="connsiteY55" fmla="*/ 972912 h 1141341"/>
              <a:gd name="connsiteX56" fmla="*/ 866554 w 866554"/>
              <a:gd name="connsiteY56" fmla="*/ 941014 h 1141341"/>
              <a:gd name="connsiteX57" fmla="*/ 861237 w 866554"/>
              <a:gd name="connsiteY57" fmla="*/ 898484 h 1141341"/>
              <a:gd name="connsiteX58" fmla="*/ 850605 w 866554"/>
              <a:gd name="connsiteY58" fmla="*/ 877219 h 1141341"/>
              <a:gd name="connsiteX59" fmla="*/ 845289 w 866554"/>
              <a:gd name="connsiteY59" fmla="*/ 861270 h 1141341"/>
              <a:gd name="connsiteX60" fmla="*/ 839972 w 866554"/>
              <a:gd name="connsiteY60" fmla="*/ 840005 h 1141341"/>
              <a:gd name="connsiteX61" fmla="*/ 808075 w 866554"/>
              <a:gd name="connsiteY61" fmla="*/ 813424 h 1141341"/>
              <a:gd name="connsiteX62" fmla="*/ 797442 w 866554"/>
              <a:gd name="connsiteY62" fmla="*/ 797475 h 1141341"/>
              <a:gd name="connsiteX63" fmla="*/ 786809 w 866554"/>
              <a:gd name="connsiteY63" fmla="*/ 754945 h 1141341"/>
              <a:gd name="connsiteX64" fmla="*/ 776177 w 866554"/>
              <a:gd name="connsiteY64" fmla="*/ 723047 h 1141341"/>
              <a:gd name="connsiteX65" fmla="*/ 770861 w 866554"/>
              <a:gd name="connsiteY65" fmla="*/ 707098 h 1141341"/>
              <a:gd name="connsiteX66" fmla="*/ 765544 w 866554"/>
              <a:gd name="connsiteY66" fmla="*/ 691149 h 1141341"/>
              <a:gd name="connsiteX67" fmla="*/ 754912 w 866554"/>
              <a:gd name="connsiteY67" fmla="*/ 675200 h 1141341"/>
              <a:gd name="connsiteX68" fmla="*/ 749596 w 866554"/>
              <a:gd name="connsiteY68" fmla="*/ 659252 h 1141341"/>
              <a:gd name="connsiteX69" fmla="*/ 733647 w 866554"/>
              <a:gd name="connsiteY69" fmla="*/ 643303 h 1141341"/>
              <a:gd name="connsiteX70" fmla="*/ 723014 w 866554"/>
              <a:gd name="connsiteY70" fmla="*/ 622038 h 1141341"/>
              <a:gd name="connsiteX71" fmla="*/ 701749 w 866554"/>
              <a:gd name="connsiteY71" fmla="*/ 590140 h 1141341"/>
              <a:gd name="connsiteX72" fmla="*/ 696433 w 866554"/>
              <a:gd name="connsiteY72" fmla="*/ 574191 h 1141341"/>
              <a:gd name="connsiteX73" fmla="*/ 664535 w 866554"/>
              <a:gd name="connsiteY73" fmla="*/ 526345 h 1141341"/>
              <a:gd name="connsiteX74" fmla="*/ 653903 w 866554"/>
              <a:gd name="connsiteY74" fmla="*/ 510396 h 1141341"/>
              <a:gd name="connsiteX75" fmla="*/ 637954 w 866554"/>
              <a:gd name="connsiteY75" fmla="*/ 478498 h 1141341"/>
              <a:gd name="connsiteX76" fmla="*/ 632637 w 866554"/>
              <a:gd name="connsiteY76" fmla="*/ 462549 h 1141341"/>
              <a:gd name="connsiteX77" fmla="*/ 616689 w 866554"/>
              <a:gd name="connsiteY77" fmla="*/ 414703 h 1141341"/>
              <a:gd name="connsiteX78" fmla="*/ 606056 w 866554"/>
              <a:gd name="connsiteY78" fmla="*/ 382805 h 1141341"/>
              <a:gd name="connsiteX79" fmla="*/ 590107 w 866554"/>
              <a:gd name="connsiteY79" fmla="*/ 366856 h 1141341"/>
              <a:gd name="connsiteX80" fmla="*/ 584791 w 866554"/>
              <a:gd name="connsiteY80" fmla="*/ 350907 h 1141341"/>
              <a:gd name="connsiteX81" fmla="*/ 574158 w 866554"/>
              <a:gd name="connsiteY81" fmla="*/ 334958 h 1141341"/>
              <a:gd name="connsiteX82" fmla="*/ 568842 w 866554"/>
              <a:gd name="connsiteY82" fmla="*/ 308377 h 1141341"/>
              <a:gd name="connsiteX83" fmla="*/ 595423 w 866554"/>
              <a:gd name="connsiteY83" fmla="*/ 175470 h 1141341"/>
              <a:gd name="connsiteX84" fmla="*/ 611372 w 866554"/>
              <a:gd name="connsiteY84" fmla="*/ 164838 h 1141341"/>
              <a:gd name="connsiteX85" fmla="*/ 627321 w 866554"/>
              <a:gd name="connsiteY85" fmla="*/ 143572 h 1141341"/>
              <a:gd name="connsiteX86" fmla="*/ 637954 w 866554"/>
              <a:gd name="connsiteY86" fmla="*/ 127624 h 1141341"/>
              <a:gd name="connsiteX87" fmla="*/ 653903 w 866554"/>
              <a:gd name="connsiteY87" fmla="*/ 111675 h 1141341"/>
              <a:gd name="connsiteX88" fmla="*/ 675168 w 866554"/>
              <a:gd name="connsiteY88" fmla="*/ 79777 h 1141341"/>
              <a:gd name="connsiteX89" fmla="*/ 685800 w 866554"/>
              <a:gd name="connsiteY89" fmla="*/ 63828 h 1141341"/>
              <a:gd name="connsiteX90" fmla="*/ 680484 w 866554"/>
              <a:gd name="connsiteY90" fmla="*/ 37247 h 1141341"/>
              <a:gd name="connsiteX91" fmla="*/ 669851 w 866554"/>
              <a:gd name="connsiteY91" fmla="*/ 21298 h 1141341"/>
              <a:gd name="connsiteX92" fmla="*/ 324293 w 866554"/>
              <a:gd name="connsiteY92" fmla="*/ 33 h 114134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Lst>
            <a:rect l="l" t="t" r="r" b="b"/>
            <a:pathLst>
              <a:path w="866554" h="1141341">
                <a:moveTo>
                  <a:pt x="324293" y="33"/>
                </a:moveTo>
                <a:cubicBezTo>
                  <a:pt x="269358" y="919"/>
                  <a:pt x="335621" y="17372"/>
                  <a:pt x="340242" y="26614"/>
                </a:cubicBezTo>
                <a:cubicBezTo>
                  <a:pt x="342748" y="31626"/>
                  <a:pt x="343351" y="37412"/>
                  <a:pt x="345558" y="42563"/>
                </a:cubicBezTo>
                <a:cubicBezTo>
                  <a:pt x="348680" y="49847"/>
                  <a:pt x="352647" y="56740"/>
                  <a:pt x="356191" y="63828"/>
                </a:cubicBezTo>
                <a:cubicBezTo>
                  <a:pt x="370254" y="120083"/>
                  <a:pt x="351160" y="53836"/>
                  <a:pt x="372140" y="101042"/>
                </a:cubicBezTo>
                <a:cubicBezTo>
                  <a:pt x="376692" y="111284"/>
                  <a:pt x="379228" y="122307"/>
                  <a:pt x="382772" y="132940"/>
                </a:cubicBezTo>
                <a:lnTo>
                  <a:pt x="388089" y="148889"/>
                </a:lnTo>
                <a:cubicBezTo>
                  <a:pt x="391673" y="170392"/>
                  <a:pt x="398721" y="209112"/>
                  <a:pt x="398721" y="228633"/>
                </a:cubicBezTo>
                <a:cubicBezTo>
                  <a:pt x="398721" y="260580"/>
                  <a:pt x="397368" y="292626"/>
                  <a:pt x="393405" y="324326"/>
                </a:cubicBezTo>
                <a:cubicBezTo>
                  <a:pt x="388833" y="360899"/>
                  <a:pt x="384382" y="347689"/>
                  <a:pt x="372140" y="372172"/>
                </a:cubicBezTo>
                <a:cubicBezTo>
                  <a:pt x="369634" y="377184"/>
                  <a:pt x="369031" y="382970"/>
                  <a:pt x="366823" y="388121"/>
                </a:cubicBezTo>
                <a:cubicBezTo>
                  <a:pt x="363701" y="395405"/>
                  <a:pt x="359313" y="402102"/>
                  <a:pt x="356191" y="409386"/>
                </a:cubicBezTo>
                <a:cubicBezTo>
                  <a:pt x="353984" y="414537"/>
                  <a:pt x="352415" y="419947"/>
                  <a:pt x="350875" y="425335"/>
                </a:cubicBezTo>
                <a:cubicBezTo>
                  <a:pt x="348868" y="432360"/>
                  <a:pt x="348436" y="439884"/>
                  <a:pt x="345558" y="446600"/>
                </a:cubicBezTo>
                <a:cubicBezTo>
                  <a:pt x="343041" y="452473"/>
                  <a:pt x="337783" y="456834"/>
                  <a:pt x="334926" y="462549"/>
                </a:cubicBezTo>
                <a:cubicBezTo>
                  <a:pt x="332420" y="467561"/>
                  <a:pt x="332115" y="473486"/>
                  <a:pt x="329609" y="478498"/>
                </a:cubicBezTo>
                <a:cubicBezTo>
                  <a:pt x="322206" y="493303"/>
                  <a:pt x="314787" y="498637"/>
                  <a:pt x="303028" y="510396"/>
                </a:cubicBezTo>
                <a:cubicBezTo>
                  <a:pt x="299484" y="517484"/>
                  <a:pt x="295339" y="524303"/>
                  <a:pt x="292396" y="531661"/>
                </a:cubicBezTo>
                <a:cubicBezTo>
                  <a:pt x="288234" y="542067"/>
                  <a:pt x="287980" y="554233"/>
                  <a:pt x="281763" y="563558"/>
                </a:cubicBezTo>
                <a:lnTo>
                  <a:pt x="271130" y="579507"/>
                </a:lnTo>
                <a:cubicBezTo>
                  <a:pt x="269358" y="584823"/>
                  <a:pt x="269777" y="591493"/>
                  <a:pt x="265814" y="595456"/>
                </a:cubicBezTo>
                <a:cubicBezTo>
                  <a:pt x="256778" y="604492"/>
                  <a:pt x="244549" y="609632"/>
                  <a:pt x="233916" y="616721"/>
                </a:cubicBezTo>
                <a:cubicBezTo>
                  <a:pt x="228600" y="620265"/>
                  <a:pt x="222486" y="622836"/>
                  <a:pt x="217968" y="627354"/>
                </a:cubicBezTo>
                <a:cubicBezTo>
                  <a:pt x="207335" y="637987"/>
                  <a:pt x="200335" y="654497"/>
                  <a:pt x="186070" y="659252"/>
                </a:cubicBezTo>
                <a:cubicBezTo>
                  <a:pt x="145988" y="672612"/>
                  <a:pt x="195388" y="654592"/>
                  <a:pt x="154172" y="675200"/>
                </a:cubicBezTo>
                <a:cubicBezTo>
                  <a:pt x="145637" y="679468"/>
                  <a:pt x="135933" y="681198"/>
                  <a:pt x="127591" y="685833"/>
                </a:cubicBezTo>
                <a:cubicBezTo>
                  <a:pt x="109394" y="695943"/>
                  <a:pt x="94529" y="716347"/>
                  <a:pt x="74428" y="723047"/>
                </a:cubicBezTo>
                <a:lnTo>
                  <a:pt x="42530" y="733679"/>
                </a:lnTo>
                <a:cubicBezTo>
                  <a:pt x="37214" y="737223"/>
                  <a:pt x="29968" y="738894"/>
                  <a:pt x="26582" y="744312"/>
                </a:cubicBezTo>
                <a:cubicBezTo>
                  <a:pt x="20642" y="753816"/>
                  <a:pt x="20112" y="765804"/>
                  <a:pt x="15949" y="776210"/>
                </a:cubicBezTo>
                <a:cubicBezTo>
                  <a:pt x="3235" y="807994"/>
                  <a:pt x="8334" y="793738"/>
                  <a:pt x="0" y="818740"/>
                </a:cubicBezTo>
                <a:cubicBezTo>
                  <a:pt x="641" y="826434"/>
                  <a:pt x="1948" y="883536"/>
                  <a:pt x="10633" y="903800"/>
                </a:cubicBezTo>
                <a:cubicBezTo>
                  <a:pt x="13150" y="909673"/>
                  <a:pt x="17721" y="914433"/>
                  <a:pt x="21265" y="919749"/>
                </a:cubicBezTo>
                <a:cubicBezTo>
                  <a:pt x="23037" y="935698"/>
                  <a:pt x="22690" y="952028"/>
                  <a:pt x="26582" y="967596"/>
                </a:cubicBezTo>
                <a:cubicBezTo>
                  <a:pt x="31703" y="988081"/>
                  <a:pt x="38712" y="981636"/>
                  <a:pt x="53163" y="988861"/>
                </a:cubicBezTo>
                <a:cubicBezTo>
                  <a:pt x="72961" y="998760"/>
                  <a:pt x="67426" y="1000745"/>
                  <a:pt x="85061" y="1015442"/>
                </a:cubicBezTo>
                <a:cubicBezTo>
                  <a:pt x="98803" y="1026894"/>
                  <a:pt x="100972" y="1026063"/>
                  <a:pt x="116958" y="1031391"/>
                </a:cubicBezTo>
                <a:cubicBezTo>
                  <a:pt x="153519" y="1055764"/>
                  <a:pt x="136733" y="1048615"/>
                  <a:pt x="164805" y="1057972"/>
                </a:cubicBezTo>
                <a:cubicBezTo>
                  <a:pt x="169249" y="1057655"/>
                  <a:pt x="237802" y="1057067"/>
                  <a:pt x="260498" y="1047340"/>
                </a:cubicBezTo>
                <a:cubicBezTo>
                  <a:pt x="273450" y="1041789"/>
                  <a:pt x="282816" y="1030338"/>
                  <a:pt x="292396" y="1020758"/>
                </a:cubicBezTo>
                <a:cubicBezTo>
                  <a:pt x="306640" y="1021945"/>
                  <a:pt x="350427" y="1020534"/>
                  <a:pt x="372140" y="1031391"/>
                </a:cubicBezTo>
                <a:cubicBezTo>
                  <a:pt x="406923" y="1048783"/>
                  <a:pt x="368770" y="1034460"/>
                  <a:pt x="404037" y="1057972"/>
                </a:cubicBezTo>
                <a:cubicBezTo>
                  <a:pt x="408700" y="1061081"/>
                  <a:pt x="415087" y="1060567"/>
                  <a:pt x="419986" y="1063289"/>
                </a:cubicBezTo>
                <a:cubicBezTo>
                  <a:pt x="431157" y="1069495"/>
                  <a:pt x="441251" y="1077466"/>
                  <a:pt x="451884" y="1084554"/>
                </a:cubicBezTo>
                <a:cubicBezTo>
                  <a:pt x="457200" y="1088098"/>
                  <a:pt x="462118" y="1092329"/>
                  <a:pt x="467833" y="1095186"/>
                </a:cubicBezTo>
                <a:cubicBezTo>
                  <a:pt x="474921" y="1098730"/>
                  <a:pt x="482170" y="1101970"/>
                  <a:pt x="489098" y="1105819"/>
                </a:cubicBezTo>
                <a:cubicBezTo>
                  <a:pt x="502743" y="1113400"/>
                  <a:pt x="515498" y="1124603"/>
                  <a:pt x="531628" y="1127084"/>
                </a:cubicBezTo>
                <a:cubicBezTo>
                  <a:pt x="549230" y="1129792"/>
                  <a:pt x="567070" y="1130628"/>
                  <a:pt x="584791" y="1132400"/>
                </a:cubicBezTo>
                <a:cubicBezTo>
                  <a:pt x="634007" y="1148807"/>
                  <a:pt x="597660" y="1138836"/>
                  <a:pt x="707065" y="1132400"/>
                </a:cubicBezTo>
                <a:cubicBezTo>
                  <a:pt x="731895" y="1130939"/>
                  <a:pt x="756684" y="1128856"/>
                  <a:pt x="781493" y="1127084"/>
                </a:cubicBezTo>
                <a:cubicBezTo>
                  <a:pt x="794132" y="1089166"/>
                  <a:pt x="776212" y="1135003"/>
                  <a:pt x="802758" y="1095186"/>
                </a:cubicBezTo>
                <a:cubicBezTo>
                  <a:pt x="805866" y="1090524"/>
                  <a:pt x="805569" y="1084250"/>
                  <a:pt x="808075" y="1079238"/>
                </a:cubicBezTo>
                <a:cubicBezTo>
                  <a:pt x="810932" y="1073523"/>
                  <a:pt x="815163" y="1068605"/>
                  <a:pt x="818707" y="1063289"/>
                </a:cubicBezTo>
                <a:cubicBezTo>
                  <a:pt x="833307" y="1004885"/>
                  <a:pt x="811179" y="1077901"/>
                  <a:pt x="839972" y="1026075"/>
                </a:cubicBezTo>
                <a:cubicBezTo>
                  <a:pt x="845415" y="1016278"/>
                  <a:pt x="847887" y="1005050"/>
                  <a:pt x="850605" y="994177"/>
                </a:cubicBezTo>
                <a:cubicBezTo>
                  <a:pt x="852377" y="987089"/>
                  <a:pt x="853821" y="979910"/>
                  <a:pt x="855921" y="972912"/>
                </a:cubicBezTo>
                <a:cubicBezTo>
                  <a:pt x="859142" y="962177"/>
                  <a:pt x="866554" y="941014"/>
                  <a:pt x="866554" y="941014"/>
                </a:cubicBezTo>
                <a:cubicBezTo>
                  <a:pt x="864782" y="926837"/>
                  <a:pt x="864702" y="912344"/>
                  <a:pt x="861237" y="898484"/>
                </a:cubicBezTo>
                <a:cubicBezTo>
                  <a:pt x="859315" y="890796"/>
                  <a:pt x="853727" y="884503"/>
                  <a:pt x="850605" y="877219"/>
                </a:cubicBezTo>
                <a:cubicBezTo>
                  <a:pt x="848398" y="872068"/>
                  <a:pt x="846829" y="866658"/>
                  <a:pt x="845289" y="861270"/>
                </a:cubicBezTo>
                <a:cubicBezTo>
                  <a:pt x="843282" y="854245"/>
                  <a:pt x="843597" y="846349"/>
                  <a:pt x="839972" y="840005"/>
                </a:cubicBezTo>
                <a:cubicBezTo>
                  <a:pt x="833674" y="828984"/>
                  <a:pt x="818238" y="820199"/>
                  <a:pt x="808075" y="813424"/>
                </a:cubicBezTo>
                <a:cubicBezTo>
                  <a:pt x="804531" y="808108"/>
                  <a:pt x="800299" y="803190"/>
                  <a:pt x="797442" y="797475"/>
                </a:cubicBezTo>
                <a:cubicBezTo>
                  <a:pt x="790992" y="784575"/>
                  <a:pt x="790447" y="768283"/>
                  <a:pt x="786809" y="754945"/>
                </a:cubicBezTo>
                <a:cubicBezTo>
                  <a:pt x="783860" y="744132"/>
                  <a:pt x="779721" y="733680"/>
                  <a:pt x="776177" y="723047"/>
                </a:cubicBezTo>
                <a:lnTo>
                  <a:pt x="770861" y="707098"/>
                </a:lnTo>
                <a:cubicBezTo>
                  <a:pt x="769089" y="701782"/>
                  <a:pt x="768652" y="695812"/>
                  <a:pt x="765544" y="691149"/>
                </a:cubicBezTo>
                <a:cubicBezTo>
                  <a:pt x="762000" y="685833"/>
                  <a:pt x="757769" y="680915"/>
                  <a:pt x="754912" y="675200"/>
                </a:cubicBezTo>
                <a:cubicBezTo>
                  <a:pt x="752406" y="670188"/>
                  <a:pt x="752704" y="663914"/>
                  <a:pt x="749596" y="659252"/>
                </a:cubicBezTo>
                <a:cubicBezTo>
                  <a:pt x="745425" y="652996"/>
                  <a:pt x="738017" y="649421"/>
                  <a:pt x="733647" y="643303"/>
                </a:cubicBezTo>
                <a:cubicBezTo>
                  <a:pt x="729041" y="636854"/>
                  <a:pt x="727091" y="628834"/>
                  <a:pt x="723014" y="622038"/>
                </a:cubicBezTo>
                <a:cubicBezTo>
                  <a:pt x="716439" y="611080"/>
                  <a:pt x="701749" y="590140"/>
                  <a:pt x="701749" y="590140"/>
                </a:cubicBezTo>
                <a:cubicBezTo>
                  <a:pt x="699977" y="584824"/>
                  <a:pt x="699154" y="579090"/>
                  <a:pt x="696433" y="574191"/>
                </a:cubicBezTo>
                <a:cubicBezTo>
                  <a:pt x="696415" y="574159"/>
                  <a:pt x="669862" y="534335"/>
                  <a:pt x="664535" y="526345"/>
                </a:cubicBezTo>
                <a:cubicBezTo>
                  <a:pt x="660991" y="521029"/>
                  <a:pt x="655924" y="516457"/>
                  <a:pt x="653903" y="510396"/>
                </a:cubicBezTo>
                <a:cubicBezTo>
                  <a:pt x="640538" y="470307"/>
                  <a:pt x="658566" y="519722"/>
                  <a:pt x="637954" y="478498"/>
                </a:cubicBezTo>
                <a:cubicBezTo>
                  <a:pt x="635448" y="473486"/>
                  <a:pt x="634605" y="467796"/>
                  <a:pt x="632637" y="462549"/>
                </a:cubicBezTo>
                <a:cubicBezTo>
                  <a:pt x="605989" y="391490"/>
                  <a:pt x="634504" y="474087"/>
                  <a:pt x="616689" y="414703"/>
                </a:cubicBezTo>
                <a:cubicBezTo>
                  <a:pt x="613468" y="403968"/>
                  <a:pt x="613981" y="390730"/>
                  <a:pt x="606056" y="382805"/>
                </a:cubicBezTo>
                <a:lnTo>
                  <a:pt x="590107" y="366856"/>
                </a:lnTo>
                <a:cubicBezTo>
                  <a:pt x="588335" y="361540"/>
                  <a:pt x="587297" y="355919"/>
                  <a:pt x="584791" y="350907"/>
                </a:cubicBezTo>
                <a:cubicBezTo>
                  <a:pt x="581934" y="345192"/>
                  <a:pt x="576402" y="340941"/>
                  <a:pt x="574158" y="334958"/>
                </a:cubicBezTo>
                <a:cubicBezTo>
                  <a:pt x="570985" y="326498"/>
                  <a:pt x="570614" y="317237"/>
                  <a:pt x="568842" y="308377"/>
                </a:cubicBezTo>
                <a:cubicBezTo>
                  <a:pt x="570036" y="285685"/>
                  <a:pt x="557273" y="200902"/>
                  <a:pt x="595423" y="175470"/>
                </a:cubicBezTo>
                <a:lnTo>
                  <a:pt x="611372" y="164838"/>
                </a:lnTo>
                <a:cubicBezTo>
                  <a:pt x="616688" y="157749"/>
                  <a:pt x="622171" y="150782"/>
                  <a:pt x="627321" y="143572"/>
                </a:cubicBezTo>
                <a:cubicBezTo>
                  <a:pt x="631035" y="138373"/>
                  <a:pt x="633864" y="132532"/>
                  <a:pt x="637954" y="127624"/>
                </a:cubicBezTo>
                <a:cubicBezTo>
                  <a:pt x="642767" y="121848"/>
                  <a:pt x="649287" y="117610"/>
                  <a:pt x="653903" y="111675"/>
                </a:cubicBezTo>
                <a:cubicBezTo>
                  <a:pt x="661748" y="101588"/>
                  <a:pt x="668080" y="90410"/>
                  <a:pt x="675168" y="79777"/>
                </a:cubicBezTo>
                <a:lnTo>
                  <a:pt x="685800" y="63828"/>
                </a:lnTo>
                <a:cubicBezTo>
                  <a:pt x="684028" y="54968"/>
                  <a:pt x="683657" y="45707"/>
                  <a:pt x="680484" y="37247"/>
                </a:cubicBezTo>
                <a:cubicBezTo>
                  <a:pt x="678240" y="31264"/>
                  <a:pt x="676233" y="21612"/>
                  <a:pt x="669851" y="21298"/>
                </a:cubicBezTo>
                <a:cubicBezTo>
                  <a:pt x="565424" y="16162"/>
                  <a:pt x="379228" y="-853"/>
                  <a:pt x="324293" y="33"/>
                </a:cubicBezTo>
                <a:close/>
              </a:path>
            </a:pathLst>
          </a:custGeom>
          <a:noFill/>
          <a:ln w="9525">
            <a:solidFill>
              <a:srgbClr val="FFFF0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49" name="Figura a mano libera 48"/>
          <p:cNvSpPr>
            <a:spLocks noChangeAspect="1"/>
          </p:cNvSpPr>
          <p:nvPr/>
        </p:nvSpPr>
        <p:spPr>
          <a:xfrm>
            <a:off x="4744297" y="760193"/>
            <a:ext cx="909882" cy="1198408"/>
          </a:xfrm>
          <a:custGeom>
            <a:avLst/>
            <a:gdLst>
              <a:gd name="connsiteX0" fmla="*/ 324293 w 866554"/>
              <a:gd name="connsiteY0" fmla="*/ 33 h 1141341"/>
              <a:gd name="connsiteX1" fmla="*/ 340242 w 866554"/>
              <a:gd name="connsiteY1" fmla="*/ 26614 h 1141341"/>
              <a:gd name="connsiteX2" fmla="*/ 345558 w 866554"/>
              <a:gd name="connsiteY2" fmla="*/ 42563 h 1141341"/>
              <a:gd name="connsiteX3" fmla="*/ 356191 w 866554"/>
              <a:gd name="connsiteY3" fmla="*/ 63828 h 1141341"/>
              <a:gd name="connsiteX4" fmla="*/ 372140 w 866554"/>
              <a:gd name="connsiteY4" fmla="*/ 101042 h 1141341"/>
              <a:gd name="connsiteX5" fmla="*/ 382772 w 866554"/>
              <a:gd name="connsiteY5" fmla="*/ 132940 h 1141341"/>
              <a:gd name="connsiteX6" fmla="*/ 388089 w 866554"/>
              <a:gd name="connsiteY6" fmla="*/ 148889 h 1141341"/>
              <a:gd name="connsiteX7" fmla="*/ 398721 w 866554"/>
              <a:gd name="connsiteY7" fmla="*/ 228633 h 1141341"/>
              <a:gd name="connsiteX8" fmla="*/ 393405 w 866554"/>
              <a:gd name="connsiteY8" fmla="*/ 324326 h 1141341"/>
              <a:gd name="connsiteX9" fmla="*/ 372140 w 866554"/>
              <a:gd name="connsiteY9" fmla="*/ 372172 h 1141341"/>
              <a:gd name="connsiteX10" fmla="*/ 366823 w 866554"/>
              <a:gd name="connsiteY10" fmla="*/ 388121 h 1141341"/>
              <a:gd name="connsiteX11" fmla="*/ 356191 w 866554"/>
              <a:gd name="connsiteY11" fmla="*/ 409386 h 1141341"/>
              <a:gd name="connsiteX12" fmla="*/ 350875 w 866554"/>
              <a:gd name="connsiteY12" fmla="*/ 425335 h 1141341"/>
              <a:gd name="connsiteX13" fmla="*/ 345558 w 866554"/>
              <a:gd name="connsiteY13" fmla="*/ 446600 h 1141341"/>
              <a:gd name="connsiteX14" fmla="*/ 334926 w 866554"/>
              <a:gd name="connsiteY14" fmla="*/ 462549 h 1141341"/>
              <a:gd name="connsiteX15" fmla="*/ 329609 w 866554"/>
              <a:gd name="connsiteY15" fmla="*/ 478498 h 1141341"/>
              <a:gd name="connsiteX16" fmla="*/ 303028 w 866554"/>
              <a:gd name="connsiteY16" fmla="*/ 510396 h 1141341"/>
              <a:gd name="connsiteX17" fmla="*/ 292396 w 866554"/>
              <a:gd name="connsiteY17" fmla="*/ 531661 h 1141341"/>
              <a:gd name="connsiteX18" fmla="*/ 281763 w 866554"/>
              <a:gd name="connsiteY18" fmla="*/ 563558 h 1141341"/>
              <a:gd name="connsiteX19" fmla="*/ 271130 w 866554"/>
              <a:gd name="connsiteY19" fmla="*/ 579507 h 1141341"/>
              <a:gd name="connsiteX20" fmla="*/ 265814 w 866554"/>
              <a:gd name="connsiteY20" fmla="*/ 595456 h 1141341"/>
              <a:gd name="connsiteX21" fmla="*/ 233916 w 866554"/>
              <a:gd name="connsiteY21" fmla="*/ 616721 h 1141341"/>
              <a:gd name="connsiteX22" fmla="*/ 217968 w 866554"/>
              <a:gd name="connsiteY22" fmla="*/ 627354 h 1141341"/>
              <a:gd name="connsiteX23" fmla="*/ 186070 w 866554"/>
              <a:gd name="connsiteY23" fmla="*/ 659252 h 1141341"/>
              <a:gd name="connsiteX24" fmla="*/ 154172 w 866554"/>
              <a:gd name="connsiteY24" fmla="*/ 675200 h 1141341"/>
              <a:gd name="connsiteX25" fmla="*/ 127591 w 866554"/>
              <a:gd name="connsiteY25" fmla="*/ 685833 h 1141341"/>
              <a:gd name="connsiteX26" fmla="*/ 74428 w 866554"/>
              <a:gd name="connsiteY26" fmla="*/ 723047 h 1141341"/>
              <a:gd name="connsiteX27" fmla="*/ 42530 w 866554"/>
              <a:gd name="connsiteY27" fmla="*/ 733679 h 1141341"/>
              <a:gd name="connsiteX28" fmla="*/ 26582 w 866554"/>
              <a:gd name="connsiteY28" fmla="*/ 744312 h 1141341"/>
              <a:gd name="connsiteX29" fmla="*/ 15949 w 866554"/>
              <a:gd name="connsiteY29" fmla="*/ 776210 h 1141341"/>
              <a:gd name="connsiteX30" fmla="*/ 0 w 866554"/>
              <a:gd name="connsiteY30" fmla="*/ 818740 h 1141341"/>
              <a:gd name="connsiteX31" fmla="*/ 10633 w 866554"/>
              <a:gd name="connsiteY31" fmla="*/ 903800 h 1141341"/>
              <a:gd name="connsiteX32" fmla="*/ 21265 w 866554"/>
              <a:gd name="connsiteY32" fmla="*/ 919749 h 1141341"/>
              <a:gd name="connsiteX33" fmla="*/ 26582 w 866554"/>
              <a:gd name="connsiteY33" fmla="*/ 967596 h 1141341"/>
              <a:gd name="connsiteX34" fmla="*/ 53163 w 866554"/>
              <a:gd name="connsiteY34" fmla="*/ 988861 h 1141341"/>
              <a:gd name="connsiteX35" fmla="*/ 85061 w 866554"/>
              <a:gd name="connsiteY35" fmla="*/ 1015442 h 1141341"/>
              <a:gd name="connsiteX36" fmla="*/ 116958 w 866554"/>
              <a:gd name="connsiteY36" fmla="*/ 1031391 h 1141341"/>
              <a:gd name="connsiteX37" fmla="*/ 164805 w 866554"/>
              <a:gd name="connsiteY37" fmla="*/ 1057972 h 1141341"/>
              <a:gd name="connsiteX38" fmla="*/ 260498 w 866554"/>
              <a:gd name="connsiteY38" fmla="*/ 1047340 h 1141341"/>
              <a:gd name="connsiteX39" fmla="*/ 292396 w 866554"/>
              <a:gd name="connsiteY39" fmla="*/ 1020758 h 1141341"/>
              <a:gd name="connsiteX40" fmla="*/ 372140 w 866554"/>
              <a:gd name="connsiteY40" fmla="*/ 1031391 h 1141341"/>
              <a:gd name="connsiteX41" fmla="*/ 404037 w 866554"/>
              <a:gd name="connsiteY41" fmla="*/ 1057972 h 1141341"/>
              <a:gd name="connsiteX42" fmla="*/ 419986 w 866554"/>
              <a:gd name="connsiteY42" fmla="*/ 1063289 h 1141341"/>
              <a:gd name="connsiteX43" fmla="*/ 451884 w 866554"/>
              <a:gd name="connsiteY43" fmla="*/ 1084554 h 1141341"/>
              <a:gd name="connsiteX44" fmla="*/ 467833 w 866554"/>
              <a:gd name="connsiteY44" fmla="*/ 1095186 h 1141341"/>
              <a:gd name="connsiteX45" fmla="*/ 489098 w 866554"/>
              <a:gd name="connsiteY45" fmla="*/ 1105819 h 1141341"/>
              <a:gd name="connsiteX46" fmla="*/ 531628 w 866554"/>
              <a:gd name="connsiteY46" fmla="*/ 1127084 h 1141341"/>
              <a:gd name="connsiteX47" fmla="*/ 584791 w 866554"/>
              <a:gd name="connsiteY47" fmla="*/ 1132400 h 1141341"/>
              <a:gd name="connsiteX48" fmla="*/ 707065 w 866554"/>
              <a:gd name="connsiteY48" fmla="*/ 1132400 h 1141341"/>
              <a:gd name="connsiteX49" fmla="*/ 781493 w 866554"/>
              <a:gd name="connsiteY49" fmla="*/ 1127084 h 1141341"/>
              <a:gd name="connsiteX50" fmla="*/ 802758 w 866554"/>
              <a:gd name="connsiteY50" fmla="*/ 1095186 h 1141341"/>
              <a:gd name="connsiteX51" fmla="*/ 808075 w 866554"/>
              <a:gd name="connsiteY51" fmla="*/ 1079238 h 1141341"/>
              <a:gd name="connsiteX52" fmla="*/ 818707 w 866554"/>
              <a:gd name="connsiteY52" fmla="*/ 1063289 h 1141341"/>
              <a:gd name="connsiteX53" fmla="*/ 839972 w 866554"/>
              <a:gd name="connsiteY53" fmla="*/ 1026075 h 1141341"/>
              <a:gd name="connsiteX54" fmla="*/ 850605 w 866554"/>
              <a:gd name="connsiteY54" fmla="*/ 994177 h 1141341"/>
              <a:gd name="connsiteX55" fmla="*/ 855921 w 866554"/>
              <a:gd name="connsiteY55" fmla="*/ 972912 h 1141341"/>
              <a:gd name="connsiteX56" fmla="*/ 866554 w 866554"/>
              <a:gd name="connsiteY56" fmla="*/ 941014 h 1141341"/>
              <a:gd name="connsiteX57" fmla="*/ 861237 w 866554"/>
              <a:gd name="connsiteY57" fmla="*/ 898484 h 1141341"/>
              <a:gd name="connsiteX58" fmla="*/ 850605 w 866554"/>
              <a:gd name="connsiteY58" fmla="*/ 877219 h 1141341"/>
              <a:gd name="connsiteX59" fmla="*/ 845289 w 866554"/>
              <a:gd name="connsiteY59" fmla="*/ 861270 h 1141341"/>
              <a:gd name="connsiteX60" fmla="*/ 839972 w 866554"/>
              <a:gd name="connsiteY60" fmla="*/ 840005 h 1141341"/>
              <a:gd name="connsiteX61" fmla="*/ 808075 w 866554"/>
              <a:gd name="connsiteY61" fmla="*/ 813424 h 1141341"/>
              <a:gd name="connsiteX62" fmla="*/ 797442 w 866554"/>
              <a:gd name="connsiteY62" fmla="*/ 797475 h 1141341"/>
              <a:gd name="connsiteX63" fmla="*/ 786809 w 866554"/>
              <a:gd name="connsiteY63" fmla="*/ 754945 h 1141341"/>
              <a:gd name="connsiteX64" fmla="*/ 776177 w 866554"/>
              <a:gd name="connsiteY64" fmla="*/ 723047 h 1141341"/>
              <a:gd name="connsiteX65" fmla="*/ 770861 w 866554"/>
              <a:gd name="connsiteY65" fmla="*/ 707098 h 1141341"/>
              <a:gd name="connsiteX66" fmla="*/ 765544 w 866554"/>
              <a:gd name="connsiteY66" fmla="*/ 691149 h 1141341"/>
              <a:gd name="connsiteX67" fmla="*/ 754912 w 866554"/>
              <a:gd name="connsiteY67" fmla="*/ 675200 h 1141341"/>
              <a:gd name="connsiteX68" fmla="*/ 749596 w 866554"/>
              <a:gd name="connsiteY68" fmla="*/ 659252 h 1141341"/>
              <a:gd name="connsiteX69" fmla="*/ 733647 w 866554"/>
              <a:gd name="connsiteY69" fmla="*/ 643303 h 1141341"/>
              <a:gd name="connsiteX70" fmla="*/ 723014 w 866554"/>
              <a:gd name="connsiteY70" fmla="*/ 622038 h 1141341"/>
              <a:gd name="connsiteX71" fmla="*/ 701749 w 866554"/>
              <a:gd name="connsiteY71" fmla="*/ 590140 h 1141341"/>
              <a:gd name="connsiteX72" fmla="*/ 696433 w 866554"/>
              <a:gd name="connsiteY72" fmla="*/ 574191 h 1141341"/>
              <a:gd name="connsiteX73" fmla="*/ 664535 w 866554"/>
              <a:gd name="connsiteY73" fmla="*/ 526345 h 1141341"/>
              <a:gd name="connsiteX74" fmla="*/ 653903 w 866554"/>
              <a:gd name="connsiteY74" fmla="*/ 510396 h 1141341"/>
              <a:gd name="connsiteX75" fmla="*/ 637954 w 866554"/>
              <a:gd name="connsiteY75" fmla="*/ 478498 h 1141341"/>
              <a:gd name="connsiteX76" fmla="*/ 632637 w 866554"/>
              <a:gd name="connsiteY76" fmla="*/ 462549 h 1141341"/>
              <a:gd name="connsiteX77" fmla="*/ 616689 w 866554"/>
              <a:gd name="connsiteY77" fmla="*/ 414703 h 1141341"/>
              <a:gd name="connsiteX78" fmla="*/ 606056 w 866554"/>
              <a:gd name="connsiteY78" fmla="*/ 382805 h 1141341"/>
              <a:gd name="connsiteX79" fmla="*/ 590107 w 866554"/>
              <a:gd name="connsiteY79" fmla="*/ 366856 h 1141341"/>
              <a:gd name="connsiteX80" fmla="*/ 584791 w 866554"/>
              <a:gd name="connsiteY80" fmla="*/ 350907 h 1141341"/>
              <a:gd name="connsiteX81" fmla="*/ 574158 w 866554"/>
              <a:gd name="connsiteY81" fmla="*/ 334958 h 1141341"/>
              <a:gd name="connsiteX82" fmla="*/ 568842 w 866554"/>
              <a:gd name="connsiteY82" fmla="*/ 308377 h 1141341"/>
              <a:gd name="connsiteX83" fmla="*/ 595423 w 866554"/>
              <a:gd name="connsiteY83" fmla="*/ 175470 h 1141341"/>
              <a:gd name="connsiteX84" fmla="*/ 611372 w 866554"/>
              <a:gd name="connsiteY84" fmla="*/ 164838 h 1141341"/>
              <a:gd name="connsiteX85" fmla="*/ 627321 w 866554"/>
              <a:gd name="connsiteY85" fmla="*/ 143572 h 1141341"/>
              <a:gd name="connsiteX86" fmla="*/ 637954 w 866554"/>
              <a:gd name="connsiteY86" fmla="*/ 127624 h 1141341"/>
              <a:gd name="connsiteX87" fmla="*/ 653903 w 866554"/>
              <a:gd name="connsiteY87" fmla="*/ 111675 h 1141341"/>
              <a:gd name="connsiteX88" fmla="*/ 675168 w 866554"/>
              <a:gd name="connsiteY88" fmla="*/ 79777 h 1141341"/>
              <a:gd name="connsiteX89" fmla="*/ 685800 w 866554"/>
              <a:gd name="connsiteY89" fmla="*/ 63828 h 1141341"/>
              <a:gd name="connsiteX90" fmla="*/ 680484 w 866554"/>
              <a:gd name="connsiteY90" fmla="*/ 37247 h 1141341"/>
              <a:gd name="connsiteX91" fmla="*/ 669851 w 866554"/>
              <a:gd name="connsiteY91" fmla="*/ 21298 h 1141341"/>
              <a:gd name="connsiteX92" fmla="*/ 324293 w 866554"/>
              <a:gd name="connsiteY92" fmla="*/ 33 h 114134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Lst>
            <a:rect l="l" t="t" r="r" b="b"/>
            <a:pathLst>
              <a:path w="866554" h="1141341">
                <a:moveTo>
                  <a:pt x="324293" y="33"/>
                </a:moveTo>
                <a:cubicBezTo>
                  <a:pt x="269358" y="919"/>
                  <a:pt x="335621" y="17372"/>
                  <a:pt x="340242" y="26614"/>
                </a:cubicBezTo>
                <a:cubicBezTo>
                  <a:pt x="342748" y="31626"/>
                  <a:pt x="343351" y="37412"/>
                  <a:pt x="345558" y="42563"/>
                </a:cubicBezTo>
                <a:cubicBezTo>
                  <a:pt x="348680" y="49847"/>
                  <a:pt x="352647" y="56740"/>
                  <a:pt x="356191" y="63828"/>
                </a:cubicBezTo>
                <a:cubicBezTo>
                  <a:pt x="370254" y="120083"/>
                  <a:pt x="351160" y="53836"/>
                  <a:pt x="372140" y="101042"/>
                </a:cubicBezTo>
                <a:cubicBezTo>
                  <a:pt x="376692" y="111284"/>
                  <a:pt x="379228" y="122307"/>
                  <a:pt x="382772" y="132940"/>
                </a:cubicBezTo>
                <a:lnTo>
                  <a:pt x="388089" y="148889"/>
                </a:lnTo>
                <a:cubicBezTo>
                  <a:pt x="391673" y="170392"/>
                  <a:pt x="398721" y="209112"/>
                  <a:pt x="398721" y="228633"/>
                </a:cubicBezTo>
                <a:cubicBezTo>
                  <a:pt x="398721" y="260580"/>
                  <a:pt x="397368" y="292626"/>
                  <a:pt x="393405" y="324326"/>
                </a:cubicBezTo>
                <a:cubicBezTo>
                  <a:pt x="388833" y="360899"/>
                  <a:pt x="384382" y="347689"/>
                  <a:pt x="372140" y="372172"/>
                </a:cubicBezTo>
                <a:cubicBezTo>
                  <a:pt x="369634" y="377184"/>
                  <a:pt x="369031" y="382970"/>
                  <a:pt x="366823" y="388121"/>
                </a:cubicBezTo>
                <a:cubicBezTo>
                  <a:pt x="363701" y="395405"/>
                  <a:pt x="359313" y="402102"/>
                  <a:pt x="356191" y="409386"/>
                </a:cubicBezTo>
                <a:cubicBezTo>
                  <a:pt x="353984" y="414537"/>
                  <a:pt x="352415" y="419947"/>
                  <a:pt x="350875" y="425335"/>
                </a:cubicBezTo>
                <a:cubicBezTo>
                  <a:pt x="348868" y="432360"/>
                  <a:pt x="348436" y="439884"/>
                  <a:pt x="345558" y="446600"/>
                </a:cubicBezTo>
                <a:cubicBezTo>
                  <a:pt x="343041" y="452473"/>
                  <a:pt x="337783" y="456834"/>
                  <a:pt x="334926" y="462549"/>
                </a:cubicBezTo>
                <a:cubicBezTo>
                  <a:pt x="332420" y="467561"/>
                  <a:pt x="332115" y="473486"/>
                  <a:pt x="329609" y="478498"/>
                </a:cubicBezTo>
                <a:cubicBezTo>
                  <a:pt x="322206" y="493303"/>
                  <a:pt x="314787" y="498637"/>
                  <a:pt x="303028" y="510396"/>
                </a:cubicBezTo>
                <a:cubicBezTo>
                  <a:pt x="299484" y="517484"/>
                  <a:pt x="295339" y="524303"/>
                  <a:pt x="292396" y="531661"/>
                </a:cubicBezTo>
                <a:cubicBezTo>
                  <a:pt x="288234" y="542067"/>
                  <a:pt x="287980" y="554233"/>
                  <a:pt x="281763" y="563558"/>
                </a:cubicBezTo>
                <a:lnTo>
                  <a:pt x="271130" y="579507"/>
                </a:lnTo>
                <a:cubicBezTo>
                  <a:pt x="269358" y="584823"/>
                  <a:pt x="269777" y="591493"/>
                  <a:pt x="265814" y="595456"/>
                </a:cubicBezTo>
                <a:cubicBezTo>
                  <a:pt x="256778" y="604492"/>
                  <a:pt x="244549" y="609632"/>
                  <a:pt x="233916" y="616721"/>
                </a:cubicBezTo>
                <a:cubicBezTo>
                  <a:pt x="228600" y="620265"/>
                  <a:pt x="222486" y="622836"/>
                  <a:pt x="217968" y="627354"/>
                </a:cubicBezTo>
                <a:cubicBezTo>
                  <a:pt x="207335" y="637987"/>
                  <a:pt x="200335" y="654497"/>
                  <a:pt x="186070" y="659252"/>
                </a:cubicBezTo>
                <a:cubicBezTo>
                  <a:pt x="145988" y="672612"/>
                  <a:pt x="195388" y="654592"/>
                  <a:pt x="154172" y="675200"/>
                </a:cubicBezTo>
                <a:cubicBezTo>
                  <a:pt x="145637" y="679468"/>
                  <a:pt x="135933" y="681198"/>
                  <a:pt x="127591" y="685833"/>
                </a:cubicBezTo>
                <a:cubicBezTo>
                  <a:pt x="109394" y="695943"/>
                  <a:pt x="94529" y="716347"/>
                  <a:pt x="74428" y="723047"/>
                </a:cubicBezTo>
                <a:lnTo>
                  <a:pt x="42530" y="733679"/>
                </a:lnTo>
                <a:cubicBezTo>
                  <a:pt x="37214" y="737223"/>
                  <a:pt x="29968" y="738894"/>
                  <a:pt x="26582" y="744312"/>
                </a:cubicBezTo>
                <a:cubicBezTo>
                  <a:pt x="20642" y="753816"/>
                  <a:pt x="20112" y="765804"/>
                  <a:pt x="15949" y="776210"/>
                </a:cubicBezTo>
                <a:cubicBezTo>
                  <a:pt x="3235" y="807994"/>
                  <a:pt x="8334" y="793738"/>
                  <a:pt x="0" y="818740"/>
                </a:cubicBezTo>
                <a:cubicBezTo>
                  <a:pt x="641" y="826434"/>
                  <a:pt x="1948" y="883536"/>
                  <a:pt x="10633" y="903800"/>
                </a:cubicBezTo>
                <a:cubicBezTo>
                  <a:pt x="13150" y="909673"/>
                  <a:pt x="17721" y="914433"/>
                  <a:pt x="21265" y="919749"/>
                </a:cubicBezTo>
                <a:cubicBezTo>
                  <a:pt x="23037" y="935698"/>
                  <a:pt x="22690" y="952028"/>
                  <a:pt x="26582" y="967596"/>
                </a:cubicBezTo>
                <a:cubicBezTo>
                  <a:pt x="31703" y="988081"/>
                  <a:pt x="38712" y="981636"/>
                  <a:pt x="53163" y="988861"/>
                </a:cubicBezTo>
                <a:cubicBezTo>
                  <a:pt x="72961" y="998760"/>
                  <a:pt x="67426" y="1000745"/>
                  <a:pt x="85061" y="1015442"/>
                </a:cubicBezTo>
                <a:cubicBezTo>
                  <a:pt x="98803" y="1026894"/>
                  <a:pt x="100972" y="1026063"/>
                  <a:pt x="116958" y="1031391"/>
                </a:cubicBezTo>
                <a:cubicBezTo>
                  <a:pt x="153519" y="1055764"/>
                  <a:pt x="136733" y="1048615"/>
                  <a:pt x="164805" y="1057972"/>
                </a:cubicBezTo>
                <a:cubicBezTo>
                  <a:pt x="169249" y="1057655"/>
                  <a:pt x="237802" y="1057067"/>
                  <a:pt x="260498" y="1047340"/>
                </a:cubicBezTo>
                <a:cubicBezTo>
                  <a:pt x="273450" y="1041789"/>
                  <a:pt x="282816" y="1030338"/>
                  <a:pt x="292396" y="1020758"/>
                </a:cubicBezTo>
                <a:cubicBezTo>
                  <a:pt x="306640" y="1021945"/>
                  <a:pt x="350427" y="1020534"/>
                  <a:pt x="372140" y="1031391"/>
                </a:cubicBezTo>
                <a:cubicBezTo>
                  <a:pt x="406923" y="1048783"/>
                  <a:pt x="368770" y="1034460"/>
                  <a:pt x="404037" y="1057972"/>
                </a:cubicBezTo>
                <a:cubicBezTo>
                  <a:pt x="408700" y="1061081"/>
                  <a:pt x="415087" y="1060567"/>
                  <a:pt x="419986" y="1063289"/>
                </a:cubicBezTo>
                <a:cubicBezTo>
                  <a:pt x="431157" y="1069495"/>
                  <a:pt x="441251" y="1077466"/>
                  <a:pt x="451884" y="1084554"/>
                </a:cubicBezTo>
                <a:cubicBezTo>
                  <a:pt x="457200" y="1088098"/>
                  <a:pt x="462118" y="1092329"/>
                  <a:pt x="467833" y="1095186"/>
                </a:cubicBezTo>
                <a:cubicBezTo>
                  <a:pt x="474921" y="1098730"/>
                  <a:pt x="482170" y="1101970"/>
                  <a:pt x="489098" y="1105819"/>
                </a:cubicBezTo>
                <a:cubicBezTo>
                  <a:pt x="502743" y="1113400"/>
                  <a:pt x="515498" y="1124603"/>
                  <a:pt x="531628" y="1127084"/>
                </a:cubicBezTo>
                <a:cubicBezTo>
                  <a:pt x="549230" y="1129792"/>
                  <a:pt x="567070" y="1130628"/>
                  <a:pt x="584791" y="1132400"/>
                </a:cubicBezTo>
                <a:cubicBezTo>
                  <a:pt x="634007" y="1148807"/>
                  <a:pt x="597660" y="1138836"/>
                  <a:pt x="707065" y="1132400"/>
                </a:cubicBezTo>
                <a:cubicBezTo>
                  <a:pt x="731895" y="1130939"/>
                  <a:pt x="756684" y="1128856"/>
                  <a:pt x="781493" y="1127084"/>
                </a:cubicBezTo>
                <a:cubicBezTo>
                  <a:pt x="794132" y="1089166"/>
                  <a:pt x="776212" y="1135003"/>
                  <a:pt x="802758" y="1095186"/>
                </a:cubicBezTo>
                <a:cubicBezTo>
                  <a:pt x="805866" y="1090524"/>
                  <a:pt x="805569" y="1084250"/>
                  <a:pt x="808075" y="1079238"/>
                </a:cubicBezTo>
                <a:cubicBezTo>
                  <a:pt x="810932" y="1073523"/>
                  <a:pt x="815163" y="1068605"/>
                  <a:pt x="818707" y="1063289"/>
                </a:cubicBezTo>
                <a:cubicBezTo>
                  <a:pt x="833307" y="1004885"/>
                  <a:pt x="811179" y="1077901"/>
                  <a:pt x="839972" y="1026075"/>
                </a:cubicBezTo>
                <a:cubicBezTo>
                  <a:pt x="845415" y="1016278"/>
                  <a:pt x="847887" y="1005050"/>
                  <a:pt x="850605" y="994177"/>
                </a:cubicBezTo>
                <a:cubicBezTo>
                  <a:pt x="852377" y="987089"/>
                  <a:pt x="853821" y="979910"/>
                  <a:pt x="855921" y="972912"/>
                </a:cubicBezTo>
                <a:cubicBezTo>
                  <a:pt x="859142" y="962177"/>
                  <a:pt x="866554" y="941014"/>
                  <a:pt x="866554" y="941014"/>
                </a:cubicBezTo>
                <a:cubicBezTo>
                  <a:pt x="864782" y="926837"/>
                  <a:pt x="864702" y="912344"/>
                  <a:pt x="861237" y="898484"/>
                </a:cubicBezTo>
                <a:cubicBezTo>
                  <a:pt x="859315" y="890796"/>
                  <a:pt x="853727" y="884503"/>
                  <a:pt x="850605" y="877219"/>
                </a:cubicBezTo>
                <a:cubicBezTo>
                  <a:pt x="848398" y="872068"/>
                  <a:pt x="846829" y="866658"/>
                  <a:pt x="845289" y="861270"/>
                </a:cubicBezTo>
                <a:cubicBezTo>
                  <a:pt x="843282" y="854245"/>
                  <a:pt x="843597" y="846349"/>
                  <a:pt x="839972" y="840005"/>
                </a:cubicBezTo>
                <a:cubicBezTo>
                  <a:pt x="833674" y="828984"/>
                  <a:pt x="818238" y="820199"/>
                  <a:pt x="808075" y="813424"/>
                </a:cubicBezTo>
                <a:cubicBezTo>
                  <a:pt x="804531" y="808108"/>
                  <a:pt x="800299" y="803190"/>
                  <a:pt x="797442" y="797475"/>
                </a:cubicBezTo>
                <a:cubicBezTo>
                  <a:pt x="790992" y="784575"/>
                  <a:pt x="790447" y="768283"/>
                  <a:pt x="786809" y="754945"/>
                </a:cubicBezTo>
                <a:cubicBezTo>
                  <a:pt x="783860" y="744132"/>
                  <a:pt x="779721" y="733680"/>
                  <a:pt x="776177" y="723047"/>
                </a:cubicBezTo>
                <a:lnTo>
                  <a:pt x="770861" y="707098"/>
                </a:lnTo>
                <a:cubicBezTo>
                  <a:pt x="769089" y="701782"/>
                  <a:pt x="768652" y="695812"/>
                  <a:pt x="765544" y="691149"/>
                </a:cubicBezTo>
                <a:cubicBezTo>
                  <a:pt x="762000" y="685833"/>
                  <a:pt x="757769" y="680915"/>
                  <a:pt x="754912" y="675200"/>
                </a:cubicBezTo>
                <a:cubicBezTo>
                  <a:pt x="752406" y="670188"/>
                  <a:pt x="752704" y="663914"/>
                  <a:pt x="749596" y="659252"/>
                </a:cubicBezTo>
                <a:cubicBezTo>
                  <a:pt x="745425" y="652996"/>
                  <a:pt x="738017" y="649421"/>
                  <a:pt x="733647" y="643303"/>
                </a:cubicBezTo>
                <a:cubicBezTo>
                  <a:pt x="729041" y="636854"/>
                  <a:pt x="727091" y="628834"/>
                  <a:pt x="723014" y="622038"/>
                </a:cubicBezTo>
                <a:cubicBezTo>
                  <a:pt x="716439" y="611080"/>
                  <a:pt x="701749" y="590140"/>
                  <a:pt x="701749" y="590140"/>
                </a:cubicBezTo>
                <a:cubicBezTo>
                  <a:pt x="699977" y="584824"/>
                  <a:pt x="699154" y="579090"/>
                  <a:pt x="696433" y="574191"/>
                </a:cubicBezTo>
                <a:cubicBezTo>
                  <a:pt x="696415" y="574159"/>
                  <a:pt x="669862" y="534335"/>
                  <a:pt x="664535" y="526345"/>
                </a:cubicBezTo>
                <a:cubicBezTo>
                  <a:pt x="660991" y="521029"/>
                  <a:pt x="655924" y="516457"/>
                  <a:pt x="653903" y="510396"/>
                </a:cubicBezTo>
                <a:cubicBezTo>
                  <a:pt x="640538" y="470307"/>
                  <a:pt x="658566" y="519722"/>
                  <a:pt x="637954" y="478498"/>
                </a:cubicBezTo>
                <a:cubicBezTo>
                  <a:pt x="635448" y="473486"/>
                  <a:pt x="634605" y="467796"/>
                  <a:pt x="632637" y="462549"/>
                </a:cubicBezTo>
                <a:cubicBezTo>
                  <a:pt x="605989" y="391490"/>
                  <a:pt x="634504" y="474087"/>
                  <a:pt x="616689" y="414703"/>
                </a:cubicBezTo>
                <a:cubicBezTo>
                  <a:pt x="613468" y="403968"/>
                  <a:pt x="613981" y="390730"/>
                  <a:pt x="606056" y="382805"/>
                </a:cubicBezTo>
                <a:lnTo>
                  <a:pt x="590107" y="366856"/>
                </a:lnTo>
                <a:cubicBezTo>
                  <a:pt x="588335" y="361540"/>
                  <a:pt x="587297" y="355919"/>
                  <a:pt x="584791" y="350907"/>
                </a:cubicBezTo>
                <a:cubicBezTo>
                  <a:pt x="581934" y="345192"/>
                  <a:pt x="576402" y="340941"/>
                  <a:pt x="574158" y="334958"/>
                </a:cubicBezTo>
                <a:cubicBezTo>
                  <a:pt x="570985" y="326498"/>
                  <a:pt x="570614" y="317237"/>
                  <a:pt x="568842" y="308377"/>
                </a:cubicBezTo>
                <a:cubicBezTo>
                  <a:pt x="570036" y="285685"/>
                  <a:pt x="557273" y="200902"/>
                  <a:pt x="595423" y="175470"/>
                </a:cubicBezTo>
                <a:lnTo>
                  <a:pt x="611372" y="164838"/>
                </a:lnTo>
                <a:cubicBezTo>
                  <a:pt x="616688" y="157749"/>
                  <a:pt x="622171" y="150782"/>
                  <a:pt x="627321" y="143572"/>
                </a:cubicBezTo>
                <a:cubicBezTo>
                  <a:pt x="631035" y="138373"/>
                  <a:pt x="633864" y="132532"/>
                  <a:pt x="637954" y="127624"/>
                </a:cubicBezTo>
                <a:cubicBezTo>
                  <a:pt x="642767" y="121848"/>
                  <a:pt x="649287" y="117610"/>
                  <a:pt x="653903" y="111675"/>
                </a:cubicBezTo>
                <a:cubicBezTo>
                  <a:pt x="661748" y="101588"/>
                  <a:pt x="668080" y="90410"/>
                  <a:pt x="675168" y="79777"/>
                </a:cubicBezTo>
                <a:lnTo>
                  <a:pt x="685800" y="63828"/>
                </a:lnTo>
                <a:cubicBezTo>
                  <a:pt x="684028" y="54968"/>
                  <a:pt x="683657" y="45707"/>
                  <a:pt x="680484" y="37247"/>
                </a:cubicBezTo>
                <a:cubicBezTo>
                  <a:pt x="678240" y="31264"/>
                  <a:pt x="676233" y="21612"/>
                  <a:pt x="669851" y="21298"/>
                </a:cubicBezTo>
                <a:cubicBezTo>
                  <a:pt x="565424" y="16162"/>
                  <a:pt x="379228" y="-853"/>
                  <a:pt x="324293" y="33"/>
                </a:cubicBezTo>
                <a:close/>
              </a:path>
            </a:pathLst>
          </a:custGeom>
          <a:noFill/>
          <a:ln w="9525">
            <a:solidFill>
              <a:srgbClr val="FFFF0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Tree>
    <p:extLst>
      <p:ext uri="{BB962C8B-B14F-4D97-AF65-F5344CB8AC3E}">
        <p14:creationId xmlns:p14="http://schemas.microsoft.com/office/powerpoint/2010/main" val="4094066986"/>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Immagine 5"/>
          <p:cNvPicPr>
            <a:picLocks noChangeAspect="1"/>
          </p:cNvPicPr>
          <p:nvPr/>
        </p:nvPicPr>
        <p:blipFill>
          <a:blip r:embed="rId3" cstate="print">
            <a:extLst>
              <a:ext uri="{BEBA8EAE-BF5A-486C-A8C5-ECC9F3942E4B}">
                <a14:imgProps xmlns:a14="http://schemas.microsoft.com/office/drawing/2010/main">
                  <a14:imgLayer r:embed="rId4">
                    <a14:imgEffect>
                      <a14:brightnessContrast contrast="32000"/>
                    </a14:imgEffect>
                  </a14:imgLayer>
                </a14:imgProps>
              </a:ext>
              <a:ext uri="{28A0092B-C50C-407E-A947-70E740481C1C}">
                <a14:useLocalDpi xmlns:a14="http://schemas.microsoft.com/office/drawing/2010/main" val="0"/>
              </a:ext>
            </a:extLst>
          </a:blip>
          <a:stretch>
            <a:fillRect/>
          </a:stretch>
        </p:blipFill>
        <p:spPr>
          <a:xfrm>
            <a:off x="4608360" y="3612525"/>
            <a:ext cx="1382400" cy="1388295"/>
          </a:xfrm>
          <a:prstGeom prst="rect">
            <a:avLst/>
          </a:prstGeom>
        </p:spPr>
      </p:pic>
      <p:pic>
        <p:nvPicPr>
          <p:cNvPr id="3" name="Immagine 2"/>
          <p:cNvPicPr>
            <a:picLocks noChangeAspect="1"/>
          </p:cNvPicPr>
          <p:nvPr/>
        </p:nvPicPr>
        <p:blipFill>
          <a:blip r:embed="rId5" cstate="print">
            <a:extLst>
              <a:ext uri="{BEBA8EAE-BF5A-486C-A8C5-ECC9F3942E4B}">
                <a14:imgProps xmlns:a14="http://schemas.microsoft.com/office/drawing/2010/main">
                  <a14:imgLayer r:embed="rId6">
                    <a14:imgEffect>
                      <a14:brightnessContrast bright="16000" contrast="19000"/>
                    </a14:imgEffect>
                  </a14:imgLayer>
                </a14:imgProps>
              </a:ext>
              <a:ext uri="{28A0092B-C50C-407E-A947-70E740481C1C}">
                <a14:useLocalDpi xmlns:a14="http://schemas.microsoft.com/office/drawing/2010/main" val="0"/>
              </a:ext>
            </a:extLst>
          </a:blip>
          <a:stretch>
            <a:fillRect/>
          </a:stretch>
        </p:blipFill>
        <p:spPr>
          <a:xfrm>
            <a:off x="4602628" y="2185364"/>
            <a:ext cx="1382400" cy="1394317"/>
          </a:xfrm>
          <a:prstGeom prst="rect">
            <a:avLst/>
          </a:prstGeom>
        </p:spPr>
      </p:pic>
      <p:pic>
        <p:nvPicPr>
          <p:cNvPr id="33" name="Immagine 32"/>
          <p:cNvPicPr>
            <a:picLocks/>
          </p:cNvPicPr>
          <p:nvPr/>
        </p:nvPicPr>
        <p:blipFill>
          <a:blip r:embed="rId7" cstate="print">
            <a:extLst>
              <a:ext uri="{BEBA8EAE-BF5A-486C-A8C5-ECC9F3942E4B}">
                <a14:imgProps xmlns:a14="http://schemas.microsoft.com/office/drawing/2010/main">
                  <a14:imgLayer r:embed="rId8">
                    <a14:imgEffect>
                      <a14:brightnessContrast bright="18000" contrast="28000"/>
                    </a14:imgEffect>
                  </a14:imgLayer>
                </a14:imgProps>
              </a:ext>
              <a:ext uri="{28A0092B-C50C-407E-A947-70E740481C1C}">
                <a14:useLocalDpi xmlns:a14="http://schemas.microsoft.com/office/drawing/2010/main" val="0"/>
              </a:ext>
            </a:extLst>
          </a:blip>
          <a:stretch>
            <a:fillRect/>
          </a:stretch>
        </p:blipFill>
        <p:spPr>
          <a:xfrm>
            <a:off x="4600805" y="768805"/>
            <a:ext cx="1381375" cy="1381375"/>
          </a:xfrm>
          <a:prstGeom prst="rect">
            <a:avLst/>
          </a:prstGeom>
        </p:spPr>
      </p:pic>
      <p:sp>
        <p:nvSpPr>
          <p:cNvPr id="44" name="Text Box 20"/>
          <p:cNvSpPr txBox="1">
            <a:spLocks noChangeArrowheads="1"/>
          </p:cNvSpPr>
          <p:nvPr/>
        </p:nvSpPr>
        <p:spPr bwMode="auto">
          <a:xfrm rot="16200000">
            <a:off x="-85309" y="3440380"/>
            <a:ext cx="479619" cy="24391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pPr algn="ctr">
              <a:defRPr/>
            </a:pPr>
            <a:r>
              <a:rPr lang="it-IT" altLang="it-IT" sz="1000" dirty="0">
                <a:latin typeface="Arial" panose="020B0604020202020204" pitchFamily="34" charset="0"/>
                <a:cs typeface="Arial" panose="020B0604020202020204" pitchFamily="34" charset="0"/>
              </a:rPr>
              <a:t>IL-33</a:t>
            </a:r>
          </a:p>
        </p:txBody>
      </p:sp>
      <p:sp>
        <p:nvSpPr>
          <p:cNvPr id="163" name="CasellaDiTesto 8"/>
          <p:cNvSpPr txBox="1"/>
          <p:nvPr/>
        </p:nvSpPr>
        <p:spPr>
          <a:xfrm>
            <a:off x="786611" y="522781"/>
            <a:ext cx="482824" cy="246221"/>
          </a:xfrm>
          <a:prstGeom prst="rect">
            <a:avLst/>
          </a:prstGeom>
          <a:noFill/>
        </p:spPr>
        <p:txBody>
          <a:bodyPr wrap="none" rtlCol="0">
            <a:spAutoFit/>
          </a:bodyPr>
          <a:lst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it-IT" sz="1000" dirty="0">
                <a:solidFill>
                  <a:srgbClr val="0070C0"/>
                </a:solidFill>
                <a:latin typeface="Arial" panose="020B0604020202020204" pitchFamily="34" charset="0"/>
                <a:cs typeface="Arial" panose="020B0604020202020204" pitchFamily="34" charset="0"/>
              </a:rPr>
              <a:t>DAPI</a:t>
            </a:r>
          </a:p>
        </p:txBody>
      </p:sp>
      <p:sp>
        <p:nvSpPr>
          <p:cNvPr id="164" name="CasellaDiTesto 8"/>
          <p:cNvSpPr txBox="1"/>
          <p:nvPr/>
        </p:nvSpPr>
        <p:spPr>
          <a:xfrm>
            <a:off x="3546032" y="523777"/>
            <a:ext cx="652743" cy="246221"/>
          </a:xfrm>
          <a:prstGeom prst="rect">
            <a:avLst/>
          </a:prstGeom>
          <a:noFill/>
        </p:spPr>
        <p:txBody>
          <a:bodyPr wrap="none" rtlCol="0">
            <a:spAutoFit/>
          </a:bodyPr>
          <a:lst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it-IT" sz="1000" dirty="0">
                <a:solidFill>
                  <a:srgbClr val="FF0000"/>
                </a:solidFill>
                <a:latin typeface="Arial" panose="020B0604020202020204" pitchFamily="34" charset="0"/>
                <a:cs typeface="Arial" panose="020B0604020202020204" pitchFamily="34" charset="0"/>
              </a:rPr>
              <a:t>SIGLEC</a:t>
            </a:r>
          </a:p>
        </p:txBody>
      </p:sp>
      <p:sp>
        <p:nvSpPr>
          <p:cNvPr id="165" name="CasellaDiTesto 8"/>
          <p:cNvSpPr txBox="1"/>
          <p:nvPr/>
        </p:nvSpPr>
        <p:spPr>
          <a:xfrm>
            <a:off x="2215170" y="522689"/>
            <a:ext cx="554959" cy="246221"/>
          </a:xfrm>
          <a:prstGeom prst="rect">
            <a:avLst/>
          </a:prstGeom>
          <a:noFill/>
        </p:spPr>
        <p:txBody>
          <a:bodyPr wrap="none" rtlCol="0">
            <a:spAutoFit/>
          </a:bodyPr>
          <a:lst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it-IT" sz="1000" dirty="0">
                <a:solidFill>
                  <a:srgbClr val="00B050"/>
                </a:solidFill>
                <a:latin typeface="Arial" panose="020B0604020202020204" pitchFamily="34" charset="0"/>
                <a:cs typeface="Arial" panose="020B0604020202020204" pitchFamily="34" charset="0"/>
              </a:rPr>
              <a:t>GZMB</a:t>
            </a:r>
          </a:p>
        </p:txBody>
      </p:sp>
      <p:sp>
        <p:nvSpPr>
          <p:cNvPr id="173" name="CasellaDiTesto 8"/>
          <p:cNvSpPr txBox="1"/>
          <p:nvPr/>
        </p:nvSpPr>
        <p:spPr>
          <a:xfrm>
            <a:off x="4990492" y="522690"/>
            <a:ext cx="546945" cy="246221"/>
          </a:xfrm>
          <a:prstGeom prst="rect">
            <a:avLst/>
          </a:prstGeom>
          <a:noFill/>
        </p:spPr>
        <p:txBody>
          <a:bodyPr wrap="none" rtlCol="0">
            <a:spAutoFit/>
          </a:bodyPr>
          <a:lst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it-IT" sz="1000" dirty="0">
                <a:latin typeface="Arial" panose="020B0604020202020204" pitchFamily="34" charset="0"/>
                <a:cs typeface="Arial" panose="020B0604020202020204" pitchFamily="34" charset="0"/>
              </a:rPr>
              <a:t>merge</a:t>
            </a:r>
          </a:p>
        </p:txBody>
      </p:sp>
      <p:sp>
        <p:nvSpPr>
          <p:cNvPr id="176" name="Rettangolo 175"/>
          <p:cNvSpPr/>
          <p:nvPr/>
        </p:nvSpPr>
        <p:spPr>
          <a:xfrm>
            <a:off x="4908124" y="2208729"/>
            <a:ext cx="713036" cy="705590"/>
          </a:xfrm>
          <a:prstGeom prst="rect">
            <a:avLst/>
          </a:prstGeom>
          <a:noFill/>
          <a:ln w="9525">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606"/>
          </a:p>
        </p:txBody>
      </p:sp>
      <p:cxnSp>
        <p:nvCxnSpPr>
          <p:cNvPr id="177" name="Connettore 1 176"/>
          <p:cNvCxnSpPr/>
          <p:nvPr/>
        </p:nvCxnSpPr>
        <p:spPr>
          <a:xfrm flipH="1">
            <a:off x="4598564" y="2927767"/>
            <a:ext cx="309561" cy="652420"/>
          </a:xfrm>
          <a:prstGeom prst="line">
            <a:avLst/>
          </a:prstGeom>
          <a:ln>
            <a:solidFill>
              <a:schemeClr val="bg1"/>
            </a:solidFill>
            <a:prstDash val="dash"/>
          </a:ln>
        </p:spPr>
        <p:style>
          <a:lnRef idx="1">
            <a:schemeClr val="accent1"/>
          </a:lnRef>
          <a:fillRef idx="0">
            <a:schemeClr val="accent1"/>
          </a:fillRef>
          <a:effectRef idx="0">
            <a:schemeClr val="accent1"/>
          </a:effectRef>
          <a:fontRef idx="minor">
            <a:schemeClr val="tx1"/>
          </a:fontRef>
        </p:style>
      </p:cxnSp>
      <p:cxnSp>
        <p:nvCxnSpPr>
          <p:cNvPr id="178" name="Connettore 1 177"/>
          <p:cNvCxnSpPr/>
          <p:nvPr/>
        </p:nvCxnSpPr>
        <p:spPr>
          <a:xfrm>
            <a:off x="5621160" y="2927767"/>
            <a:ext cx="334532" cy="652420"/>
          </a:xfrm>
          <a:prstGeom prst="line">
            <a:avLst/>
          </a:prstGeom>
          <a:ln>
            <a:solidFill>
              <a:schemeClr val="bg1"/>
            </a:solidFill>
            <a:prstDash val="dash"/>
          </a:ln>
        </p:spPr>
        <p:style>
          <a:lnRef idx="1">
            <a:schemeClr val="accent1"/>
          </a:lnRef>
          <a:fillRef idx="0">
            <a:schemeClr val="accent1"/>
          </a:fillRef>
          <a:effectRef idx="0">
            <a:schemeClr val="accent1"/>
          </a:effectRef>
          <a:fontRef idx="minor">
            <a:schemeClr val="tx1"/>
          </a:fontRef>
        </p:style>
      </p:cxnSp>
      <p:cxnSp>
        <p:nvCxnSpPr>
          <p:cNvPr id="19" name="Connettore 1 18"/>
          <p:cNvCxnSpPr/>
          <p:nvPr/>
        </p:nvCxnSpPr>
        <p:spPr>
          <a:xfrm>
            <a:off x="276164" y="2474251"/>
            <a:ext cx="0" cy="2226932"/>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218" name="Text Box 20"/>
          <p:cNvSpPr txBox="1">
            <a:spLocks noChangeArrowheads="1"/>
          </p:cNvSpPr>
          <p:nvPr/>
        </p:nvSpPr>
        <p:spPr bwMode="auto">
          <a:xfrm rot="16200000">
            <a:off x="-74691" y="1372348"/>
            <a:ext cx="449162"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pPr algn="ctr">
              <a:defRPr/>
            </a:pPr>
            <a:r>
              <a:rPr lang="it-IT" altLang="it-IT" sz="1000" dirty="0">
                <a:latin typeface="Arial" panose="020B0604020202020204" pitchFamily="34" charset="0"/>
                <a:cs typeface="Arial" panose="020B0604020202020204" pitchFamily="34" charset="0"/>
              </a:rPr>
              <a:t>CTR</a:t>
            </a:r>
          </a:p>
        </p:txBody>
      </p:sp>
      <p:cxnSp>
        <p:nvCxnSpPr>
          <p:cNvPr id="220" name="Connettore 1 219"/>
          <p:cNvCxnSpPr/>
          <p:nvPr/>
        </p:nvCxnSpPr>
        <p:spPr>
          <a:xfrm>
            <a:off x="276164" y="838988"/>
            <a:ext cx="0" cy="1262513"/>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1" name="Connettore 1 220"/>
          <p:cNvCxnSpPr/>
          <p:nvPr/>
        </p:nvCxnSpPr>
        <p:spPr>
          <a:xfrm>
            <a:off x="5608350" y="2093562"/>
            <a:ext cx="305188"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pic>
        <p:nvPicPr>
          <p:cNvPr id="2" name="Immagine 1"/>
          <p:cNvPicPr>
            <a:picLocks/>
          </p:cNvPicPr>
          <p:nvPr/>
        </p:nvPicPr>
        <p:blipFill>
          <a:blip r:embed="rId9" cstate="print">
            <a:extLst>
              <a:ext uri="{BEBA8EAE-BF5A-486C-A8C5-ECC9F3942E4B}">
                <a14:imgProps xmlns:a14="http://schemas.microsoft.com/office/drawing/2010/main">
                  <a14:imgLayer r:embed="rId10">
                    <a14:imgEffect>
                      <a14:brightnessContrast bright="32000" contrast="44000"/>
                    </a14:imgEffect>
                  </a14:imgLayer>
                </a14:imgProps>
              </a:ext>
              <a:ext uri="{28A0092B-C50C-407E-A947-70E740481C1C}">
                <a14:useLocalDpi xmlns:a14="http://schemas.microsoft.com/office/drawing/2010/main" val="0"/>
              </a:ext>
            </a:extLst>
          </a:blip>
          <a:stretch>
            <a:fillRect/>
          </a:stretch>
        </p:blipFill>
        <p:spPr>
          <a:xfrm>
            <a:off x="372281" y="2192088"/>
            <a:ext cx="1381375" cy="1381375"/>
          </a:xfrm>
          <a:prstGeom prst="rect">
            <a:avLst/>
          </a:prstGeom>
        </p:spPr>
      </p:pic>
      <p:cxnSp>
        <p:nvCxnSpPr>
          <p:cNvPr id="34" name="Connettore 1 33"/>
          <p:cNvCxnSpPr/>
          <p:nvPr/>
        </p:nvCxnSpPr>
        <p:spPr>
          <a:xfrm>
            <a:off x="4714853" y="3528924"/>
            <a:ext cx="305188"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pic>
        <p:nvPicPr>
          <p:cNvPr id="12" name="Immagine 11"/>
          <p:cNvPicPr>
            <a:picLocks/>
          </p:cNvPicPr>
          <p:nvPr/>
        </p:nvPicPr>
        <p:blipFill>
          <a:blip r:embed="rId11" cstate="print">
            <a:extLst>
              <a:ext uri="{BEBA8EAE-BF5A-486C-A8C5-ECC9F3942E4B}">
                <a14:imgProps xmlns:a14="http://schemas.microsoft.com/office/drawing/2010/main">
                  <a14:imgLayer r:embed="rId12">
                    <a14:imgEffect>
                      <a14:brightnessContrast contrast="30000"/>
                    </a14:imgEffect>
                  </a14:imgLayer>
                </a14:imgProps>
              </a:ext>
              <a:ext uri="{28A0092B-C50C-407E-A947-70E740481C1C}">
                <a14:useLocalDpi xmlns:a14="http://schemas.microsoft.com/office/drawing/2010/main" val="0"/>
              </a:ext>
            </a:extLst>
          </a:blip>
          <a:stretch>
            <a:fillRect/>
          </a:stretch>
        </p:blipFill>
        <p:spPr>
          <a:xfrm>
            <a:off x="371167" y="3607028"/>
            <a:ext cx="1381375" cy="1381375"/>
          </a:xfrm>
          <a:prstGeom prst="rect">
            <a:avLst/>
          </a:prstGeom>
        </p:spPr>
      </p:pic>
      <p:pic>
        <p:nvPicPr>
          <p:cNvPr id="29" name="Immagine 28"/>
          <p:cNvPicPr>
            <a:picLocks/>
          </p:cNvPicPr>
          <p:nvPr/>
        </p:nvPicPr>
        <p:blipFill>
          <a:blip r:embed="rId13" cstate="print">
            <a:extLst>
              <a:ext uri="{BEBA8EAE-BF5A-486C-A8C5-ECC9F3942E4B}">
                <a14:imgProps xmlns:a14="http://schemas.microsoft.com/office/drawing/2010/main">
                  <a14:imgLayer r:embed="rId14">
                    <a14:imgEffect>
                      <a14:brightnessContrast bright="18000" contrast="26000"/>
                    </a14:imgEffect>
                  </a14:imgLayer>
                </a14:imgProps>
              </a:ext>
              <a:ext uri="{28A0092B-C50C-407E-A947-70E740481C1C}">
                <a14:useLocalDpi xmlns:a14="http://schemas.microsoft.com/office/drawing/2010/main" val="0"/>
              </a:ext>
            </a:extLst>
          </a:blip>
          <a:stretch>
            <a:fillRect/>
          </a:stretch>
        </p:blipFill>
        <p:spPr>
          <a:xfrm>
            <a:off x="379864" y="774259"/>
            <a:ext cx="1381375" cy="1381375"/>
          </a:xfrm>
          <a:prstGeom prst="rect">
            <a:avLst/>
          </a:prstGeom>
        </p:spPr>
      </p:pic>
      <p:pic>
        <p:nvPicPr>
          <p:cNvPr id="31" name="Immagine 30"/>
          <p:cNvPicPr>
            <a:picLocks/>
          </p:cNvPicPr>
          <p:nvPr/>
        </p:nvPicPr>
        <p:blipFill>
          <a:blip r:embed="rId15" cstate="print">
            <a:extLst>
              <a:ext uri="{28A0092B-C50C-407E-A947-70E740481C1C}">
                <a14:useLocalDpi xmlns:a14="http://schemas.microsoft.com/office/drawing/2010/main" val="0"/>
              </a:ext>
            </a:extLst>
          </a:blip>
          <a:stretch>
            <a:fillRect/>
          </a:stretch>
        </p:blipFill>
        <p:spPr>
          <a:xfrm>
            <a:off x="3192062" y="774259"/>
            <a:ext cx="1381375" cy="1381375"/>
          </a:xfrm>
          <a:prstGeom prst="rect">
            <a:avLst/>
          </a:prstGeom>
        </p:spPr>
      </p:pic>
      <p:pic>
        <p:nvPicPr>
          <p:cNvPr id="32" name="Immagine 31"/>
          <p:cNvPicPr>
            <a:picLocks/>
          </p:cNvPicPr>
          <p:nvPr/>
        </p:nvPicPr>
        <p:blipFill>
          <a:blip r:embed="rId16" cstate="print">
            <a:extLst>
              <a:ext uri="{28A0092B-C50C-407E-A947-70E740481C1C}">
                <a14:useLocalDpi xmlns:a14="http://schemas.microsoft.com/office/drawing/2010/main" val="0"/>
              </a:ext>
            </a:extLst>
          </a:blip>
          <a:stretch>
            <a:fillRect/>
          </a:stretch>
        </p:blipFill>
        <p:spPr>
          <a:xfrm>
            <a:off x="1786366" y="774259"/>
            <a:ext cx="1381375" cy="1381375"/>
          </a:xfrm>
          <a:prstGeom prst="rect">
            <a:avLst/>
          </a:prstGeom>
        </p:spPr>
      </p:pic>
      <p:cxnSp>
        <p:nvCxnSpPr>
          <p:cNvPr id="36" name="Connettore 1 35"/>
          <p:cNvCxnSpPr/>
          <p:nvPr/>
        </p:nvCxnSpPr>
        <p:spPr>
          <a:xfrm>
            <a:off x="5380780" y="4965741"/>
            <a:ext cx="558000"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pic>
        <p:nvPicPr>
          <p:cNvPr id="4" name="Immagine 3"/>
          <p:cNvPicPr>
            <a:picLocks noChangeAspect="1"/>
          </p:cNvPicPr>
          <p:nvPr/>
        </p:nvPicPr>
        <p:blipFill>
          <a:blip r:embed="rId17" cstate="print">
            <a:extLst>
              <a:ext uri="{BEBA8EAE-BF5A-486C-A8C5-ECC9F3942E4B}">
                <a14:imgProps xmlns:a14="http://schemas.microsoft.com/office/drawing/2010/main">
                  <a14:imgLayer r:embed="rId18">
                    <a14:imgEffect>
                      <a14:brightnessContrast bright="21000" contrast="19000"/>
                    </a14:imgEffect>
                  </a14:imgLayer>
                </a14:imgProps>
              </a:ext>
              <a:ext uri="{28A0092B-C50C-407E-A947-70E740481C1C}">
                <a14:useLocalDpi xmlns:a14="http://schemas.microsoft.com/office/drawing/2010/main" val="0"/>
              </a:ext>
            </a:extLst>
          </a:blip>
          <a:stretch>
            <a:fillRect/>
          </a:stretch>
        </p:blipFill>
        <p:spPr>
          <a:xfrm>
            <a:off x="3195751" y="2189615"/>
            <a:ext cx="1382400" cy="1394317"/>
          </a:xfrm>
          <a:prstGeom prst="rect">
            <a:avLst/>
          </a:prstGeom>
        </p:spPr>
      </p:pic>
      <p:pic>
        <p:nvPicPr>
          <p:cNvPr id="5" name="Immagine 4"/>
          <p:cNvPicPr>
            <a:picLocks noChangeAspect="1"/>
          </p:cNvPicPr>
          <p:nvPr/>
        </p:nvPicPr>
        <p:blipFill>
          <a:blip r:embed="rId19" cstate="print">
            <a:extLst>
              <a:ext uri="{BEBA8EAE-BF5A-486C-A8C5-ECC9F3942E4B}">
                <a14:imgProps xmlns:a14="http://schemas.microsoft.com/office/drawing/2010/main">
                  <a14:imgLayer r:embed="rId20">
                    <a14:imgEffect>
                      <a14:brightnessContrast bright="23000" contrast="6000"/>
                    </a14:imgEffect>
                  </a14:imgLayer>
                </a14:imgProps>
              </a:ext>
              <a:ext uri="{28A0092B-C50C-407E-A947-70E740481C1C}">
                <a14:useLocalDpi xmlns:a14="http://schemas.microsoft.com/office/drawing/2010/main" val="0"/>
              </a:ext>
            </a:extLst>
          </a:blip>
          <a:stretch>
            <a:fillRect/>
          </a:stretch>
        </p:blipFill>
        <p:spPr>
          <a:xfrm>
            <a:off x="1787009" y="2191063"/>
            <a:ext cx="1382400" cy="1394317"/>
          </a:xfrm>
          <a:prstGeom prst="rect">
            <a:avLst/>
          </a:prstGeom>
        </p:spPr>
      </p:pic>
      <p:pic>
        <p:nvPicPr>
          <p:cNvPr id="8" name="Immagine 7"/>
          <p:cNvPicPr>
            <a:picLocks noChangeAspect="1"/>
          </p:cNvPicPr>
          <p:nvPr/>
        </p:nvPicPr>
        <p:blipFill>
          <a:blip r:embed="rId21" cstate="print">
            <a:extLst>
              <a:ext uri="{BEBA8EAE-BF5A-486C-A8C5-ECC9F3942E4B}">
                <a14:imgProps xmlns:a14="http://schemas.microsoft.com/office/drawing/2010/main">
                  <a14:imgLayer r:embed="rId22">
                    <a14:imgEffect>
                      <a14:brightnessContrast bright="5000" contrast="12000"/>
                    </a14:imgEffect>
                  </a14:imgLayer>
                </a14:imgProps>
              </a:ext>
              <a:ext uri="{28A0092B-C50C-407E-A947-70E740481C1C}">
                <a14:useLocalDpi xmlns:a14="http://schemas.microsoft.com/office/drawing/2010/main" val="0"/>
              </a:ext>
            </a:extLst>
          </a:blip>
          <a:stretch>
            <a:fillRect/>
          </a:stretch>
        </p:blipFill>
        <p:spPr>
          <a:xfrm>
            <a:off x="3200812" y="3612018"/>
            <a:ext cx="1382400" cy="1388295"/>
          </a:xfrm>
          <a:prstGeom prst="rect">
            <a:avLst/>
          </a:prstGeom>
        </p:spPr>
      </p:pic>
      <p:pic>
        <p:nvPicPr>
          <p:cNvPr id="9" name="Immagine 8"/>
          <p:cNvPicPr>
            <a:picLocks noChangeAspect="1"/>
          </p:cNvPicPr>
          <p:nvPr/>
        </p:nvPicPr>
        <p:blipFill>
          <a:blip r:embed="rId23" cstate="print">
            <a:extLst>
              <a:ext uri="{28A0092B-C50C-407E-A947-70E740481C1C}">
                <a14:useLocalDpi xmlns:a14="http://schemas.microsoft.com/office/drawing/2010/main" val="0"/>
              </a:ext>
            </a:extLst>
          </a:blip>
          <a:stretch>
            <a:fillRect/>
          </a:stretch>
        </p:blipFill>
        <p:spPr>
          <a:xfrm>
            <a:off x="1785341" y="3607889"/>
            <a:ext cx="1382400" cy="1388295"/>
          </a:xfrm>
          <a:prstGeom prst="rect">
            <a:avLst/>
          </a:prstGeom>
        </p:spPr>
      </p:pic>
      <p:sp>
        <p:nvSpPr>
          <p:cNvPr id="35" name="Rettangolo 34"/>
          <p:cNvSpPr/>
          <p:nvPr/>
        </p:nvSpPr>
        <p:spPr>
          <a:xfrm>
            <a:off x="29923" y="5409742"/>
            <a:ext cx="6063569" cy="1477328"/>
          </a:xfrm>
          <a:prstGeom prst="rect">
            <a:avLst/>
          </a:prstGeom>
        </p:spPr>
        <p:txBody>
          <a:bodyPr wrap="square">
            <a:spAutoFit/>
          </a:bodyPr>
          <a:lstStyle/>
          <a:p>
            <a:pPr algn="just"/>
            <a:r>
              <a:rPr lang="en-US" sz="1000" b="1" dirty="0" smtClean="0">
                <a:latin typeface="Arial" panose="020B0604020202020204" pitchFamily="34" charset="0"/>
                <a:cs typeface="Arial" panose="020B0604020202020204" pitchFamily="34" charset="0"/>
              </a:rPr>
              <a:t>Figure S7</a:t>
            </a:r>
            <a:r>
              <a:rPr lang="en-US" sz="1000" b="1" dirty="0" smtClean="0">
                <a:latin typeface="Arial" panose="020B0604020202020204" pitchFamily="34" charset="0"/>
                <a:cs typeface="Arial" panose="020B0604020202020204" pitchFamily="34" charset="0"/>
              </a:rPr>
              <a:t>. </a:t>
            </a:r>
            <a:r>
              <a:rPr lang="en-US" sz="1000" b="1" i="1" dirty="0" smtClean="0">
                <a:latin typeface="Arial" panose="020B0604020202020204" pitchFamily="34" charset="0"/>
                <a:cs typeface="Arial" panose="020B0604020202020204" pitchFamily="34" charset="0"/>
              </a:rPr>
              <a:t>In situ</a:t>
            </a:r>
            <a:r>
              <a:rPr lang="en-US" sz="1000" b="1" dirty="0" smtClean="0">
                <a:latin typeface="Arial" panose="020B0604020202020204" pitchFamily="34" charset="0"/>
                <a:cs typeface="Arial" panose="020B0604020202020204" pitchFamily="34" charset="0"/>
              </a:rPr>
              <a:t> detection of granzyme-B (GZMB) expression in tumor-infiltrating eosinophils.</a:t>
            </a:r>
            <a:r>
              <a:rPr lang="en-US" sz="1000" dirty="0" smtClean="0">
                <a:latin typeface="Arial" panose="020B0604020202020204" pitchFamily="34" charset="0"/>
                <a:cs typeface="Arial" panose="020B0604020202020204" pitchFamily="34" charset="0"/>
              </a:rPr>
              <a:t> C57Bl/6 mice were implanted subcutaneously with B16 melanoma cells (8 x 10</a:t>
            </a:r>
            <a:r>
              <a:rPr lang="en-US" sz="1000" baseline="30000" dirty="0" smtClean="0">
                <a:latin typeface="Arial" panose="020B0604020202020204" pitchFamily="34" charset="0"/>
                <a:cs typeface="Arial" panose="020B0604020202020204" pitchFamily="34" charset="0"/>
              </a:rPr>
              <a:t>5</a:t>
            </a:r>
            <a:r>
              <a:rPr lang="en-US" sz="1000" dirty="0" smtClean="0">
                <a:latin typeface="Arial" panose="020B0604020202020204" pitchFamily="34" charset="0"/>
                <a:cs typeface="Arial" panose="020B0604020202020204" pitchFamily="34" charset="0"/>
              </a:rPr>
              <a:t> cells/mouse) and then treated by repeated intraperitoneal injections with IL-33 (0,4 µg/mouse). Three days after the last administration of IL-33 (day 16) mice were sacrificed and tumors were harvested. </a:t>
            </a:r>
            <a:r>
              <a:rPr lang="en-US" sz="1000" dirty="0">
                <a:latin typeface="Arial" panose="020B0604020202020204" pitchFamily="34" charset="0"/>
                <a:cs typeface="Arial" panose="020B0604020202020204" pitchFamily="34" charset="0"/>
              </a:rPr>
              <a:t>FFPE </a:t>
            </a:r>
            <a:r>
              <a:rPr lang="en-US" sz="1000" dirty="0" smtClean="0">
                <a:latin typeface="Arial" panose="020B0604020202020204" pitchFamily="34" charset="0"/>
                <a:cs typeface="Arial" panose="020B0604020202020204" pitchFamily="34" charset="0"/>
              </a:rPr>
              <a:t>tissue sections </a:t>
            </a:r>
            <a:r>
              <a:rPr lang="en-US" sz="1000" dirty="0">
                <a:latin typeface="Arial" panose="020B0604020202020204" pitchFamily="34" charset="0"/>
                <a:cs typeface="Arial" panose="020B0604020202020204" pitchFamily="34" charset="0"/>
              </a:rPr>
              <a:t>(</a:t>
            </a:r>
            <a:r>
              <a:rPr lang="en-US" sz="1000" dirty="0" smtClean="0">
                <a:latin typeface="Arial" panose="020B0604020202020204" pitchFamily="34" charset="0"/>
                <a:cs typeface="Arial" panose="020B0604020202020204" pitchFamily="34" charset="0"/>
              </a:rPr>
              <a:t>5 µm </a:t>
            </a:r>
            <a:r>
              <a:rPr lang="en-US" sz="1000" dirty="0">
                <a:latin typeface="Arial" panose="020B0604020202020204" pitchFamily="34" charset="0"/>
                <a:cs typeface="Arial" panose="020B0604020202020204" pitchFamily="34" charset="0"/>
              </a:rPr>
              <a:t>thick) were </a:t>
            </a:r>
            <a:r>
              <a:rPr lang="en-US" sz="1000" dirty="0" smtClean="0">
                <a:latin typeface="Arial" panose="020B0604020202020204" pitchFamily="34" charset="0"/>
                <a:cs typeface="Arial" panose="020B0604020202020204" pitchFamily="34" charset="0"/>
              </a:rPr>
              <a:t>stained with </a:t>
            </a:r>
            <a:r>
              <a:rPr lang="en-US" sz="1000" dirty="0" err="1" smtClean="0">
                <a:latin typeface="Arial" panose="020B0604020202020204" pitchFamily="34" charset="0"/>
                <a:cs typeface="Arial" panose="020B0604020202020204" pitchFamily="34" charset="0"/>
              </a:rPr>
              <a:t>mAbs</a:t>
            </a:r>
            <a:r>
              <a:rPr lang="en-US" sz="1000" dirty="0" smtClean="0">
                <a:latin typeface="Arial" panose="020B0604020202020204" pitchFamily="34" charset="0"/>
                <a:cs typeface="Arial" panose="020B0604020202020204" pitchFamily="34" charset="0"/>
              </a:rPr>
              <a:t> to detect </a:t>
            </a:r>
            <a:r>
              <a:rPr lang="en-US" sz="1000" dirty="0" err="1" smtClean="0">
                <a:latin typeface="Arial" panose="020B0604020202020204" pitchFamily="34" charset="0"/>
                <a:cs typeface="Arial" panose="020B0604020202020204" pitchFamily="34" charset="0"/>
              </a:rPr>
              <a:t>Siglec</a:t>
            </a:r>
            <a:r>
              <a:rPr lang="en-US" sz="1000" dirty="0" smtClean="0">
                <a:latin typeface="Arial" panose="020B0604020202020204" pitchFamily="34" charset="0"/>
                <a:cs typeface="Arial" panose="020B0604020202020204" pitchFamily="34" charset="0"/>
              </a:rPr>
              <a:t>-F (red) and </a:t>
            </a:r>
            <a:r>
              <a:rPr lang="en-US" sz="1000" dirty="0">
                <a:latin typeface="Arial" panose="020B0604020202020204" pitchFamily="34" charset="0"/>
                <a:cs typeface="Arial" panose="020B0604020202020204" pitchFamily="34" charset="0"/>
              </a:rPr>
              <a:t>GZMB </a:t>
            </a:r>
            <a:r>
              <a:rPr lang="en-US" sz="1000" dirty="0" smtClean="0">
                <a:latin typeface="Arial" panose="020B0604020202020204" pitchFamily="34" charset="0"/>
                <a:cs typeface="Arial" panose="020B0604020202020204" pitchFamily="34" charset="0"/>
              </a:rPr>
              <a:t>(green</a:t>
            </a:r>
            <a:r>
              <a:rPr lang="en-US" sz="1000" dirty="0">
                <a:latin typeface="Arial" panose="020B0604020202020204" pitchFamily="34" charset="0"/>
                <a:cs typeface="Arial" panose="020B0604020202020204" pitchFamily="34" charset="0"/>
              </a:rPr>
              <a:t>). </a:t>
            </a:r>
            <a:r>
              <a:rPr lang="en-US" sz="1000" dirty="0" smtClean="0">
                <a:latin typeface="Arial" panose="020B0604020202020204" pitchFamily="34" charset="0"/>
                <a:cs typeface="Arial" panose="020B0604020202020204" pitchFamily="34" charset="0"/>
              </a:rPr>
              <a:t>Nuclei were stained with DAPI (blue). Single channels and merged images </a:t>
            </a:r>
            <a:r>
              <a:rPr lang="en-US" sz="1000" dirty="0">
                <a:latin typeface="Arial" panose="020B0604020202020204" pitchFamily="34" charset="0"/>
                <a:cs typeface="Arial" panose="020B0604020202020204" pitchFamily="34" charset="0"/>
              </a:rPr>
              <a:t>are shown. </a:t>
            </a:r>
            <a:r>
              <a:rPr lang="en-US" sz="1000" dirty="0" err="1">
                <a:latin typeface="Arial" panose="020B0604020202020204" pitchFamily="34" charset="0"/>
                <a:cs typeface="Arial" panose="020B0604020202020204" pitchFamily="34" charset="0"/>
              </a:rPr>
              <a:t>Colocalizations</a:t>
            </a:r>
            <a:r>
              <a:rPr lang="en-US" sz="1000" dirty="0">
                <a:latin typeface="Arial" panose="020B0604020202020204" pitchFamily="34" charset="0"/>
                <a:cs typeface="Arial" panose="020B0604020202020204" pitchFamily="34" charset="0"/>
              </a:rPr>
              <a:t> are shown in yellow. Inserts represent higher-power magnification images of necrotic areas </a:t>
            </a:r>
            <a:r>
              <a:rPr lang="en-US" sz="1000" dirty="0" smtClean="0">
                <a:latin typeface="Arial" panose="020B0604020202020204" pitchFamily="34" charset="0"/>
                <a:cs typeface="Arial" panose="020B0604020202020204" pitchFamily="34" charset="0"/>
              </a:rPr>
              <a:t>(N) with </a:t>
            </a:r>
            <a:r>
              <a:rPr lang="en-US" sz="1000" dirty="0">
                <a:latin typeface="Arial" panose="020B0604020202020204" pitchFamily="34" charset="0"/>
                <a:cs typeface="Arial" panose="020B0604020202020204" pitchFamily="34" charset="0"/>
              </a:rPr>
              <a:t>EO infiltration in tissues from IL-33 treated mice. </a:t>
            </a:r>
            <a:r>
              <a:rPr lang="en-US" sz="1000" dirty="0" smtClean="0">
                <a:latin typeface="Arial" panose="020B0604020202020204" pitchFamily="34" charset="0"/>
                <a:cs typeface="Arial" panose="020B0604020202020204" pitchFamily="34" charset="0"/>
              </a:rPr>
              <a:t>Scale </a:t>
            </a:r>
            <a:r>
              <a:rPr lang="en-US" sz="1000" dirty="0">
                <a:latin typeface="Arial" panose="020B0604020202020204" pitchFamily="34" charset="0"/>
                <a:cs typeface="Arial" panose="020B0604020202020204" pitchFamily="34" charset="0"/>
              </a:rPr>
              <a:t>bars correspond to 50 µm. Panels are representative of 2 independent experiments.</a:t>
            </a:r>
          </a:p>
        </p:txBody>
      </p:sp>
      <p:sp>
        <p:nvSpPr>
          <p:cNvPr id="10" name="Figura a mano libera 9"/>
          <p:cNvSpPr/>
          <p:nvPr/>
        </p:nvSpPr>
        <p:spPr>
          <a:xfrm>
            <a:off x="730368" y="2192149"/>
            <a:ext cx="1012696" cy="1370139"/>
          </a:xfrm>
          <a:custGeom>
            <a:avLst/>
            <a:gdLst>
              <a:gd name="connsiteX0" fmla="*/ 145952 w 1012696"/>
              <a:gd name="connsiteY0" fmla="*/ 28 h 1370139"/>
              <a:gd name="connsiteX1" fmla="*/ 131060 w 1012696"/>
              <a:gd name="connsiteY1" fmla="*/ 14921 h 1370139"/>
              <a:gd name="connsiteX2" fmla="*/ 122124 w 1012696"/>
              <a:gd name="connsiteY2" fmla="*/ 20878 h 1370139"/>
              <a:gd name="connsiteX3" fmla="*/ 116167 w 1012696"/>
              <a:gd name="connsiteY3" fmla="*/ 29813 h 1370139"/>
              <a:gd name="connsiteX4" fmla="*/ 86382 w 1012696"/>
              <a:gd name="connsiteY4" fmla="*/ 47684 h 1370139"/>
              <a:gd name="connsiteX5" fmla="*/ 77447 w 1012696"/>
              <a:gd name="connsiteY5" fmla="*/ 53641 h 1370139"/>
              <a:gd name="connsiteX6" fmla="*/ 68511 w 1012696"/>
              <a:gd name="connsiteY6" fmla="*/ 56620 h 1370139"/>
              <a:gd name="connsiteX7" fmla="*/ 59576 w 1012696"/>
              <a:gd name="connsiteY7" fmla="*/ 62577 h 1370139"/>
              <a:gd name="connsiteX8" fmla="*/ 47662 w 1012696"/>
              <a:gd name="connsiteY8" fmla="*/ 71512 h 1370139"/>
              <a:gd name="connsiteX9" fmla="*/ 35748 w 1012696"/>
              <a:gd name="connsiteY9" fmla="*/ 74491 h 1370139"/>
              <a:gd name="connsiteX10" fmla="*/ 29791 w 1012696"/>
              <a:gd name="connsiteY10" fmla="*/ 83426 h 1370139"/>
              <a:gd name="connsiteX11" fmla="*/ 5963 w 1012696"/>
              <a:gd name="connsiteY11" fmla="*/ 95340 h 1370139"/>
              <a:gd name="connsiteX12" fmla="*/ 2984 w 1012696"/>
              <a:gd name="connsiteY12" fmla="*/ 128104 h 1370139"/>
              <a:gd name="connsiteX13" fmla="*/ 6 w 1012696"/>
              <a:gd name="connsiteY13" fmla="*/ 169803 h 1370139"/>
              <a:gd name="connsiteX14" fmla="*/ 14898 w 1012696"/>
              <a:gd name="connsiteY14" fmla="*/ 208523 h 1370139"/>
              <a:gd name="connsiteX15" fmla="*/ 14898 w 1012696"/>
              <a:gd name="connsiteY15" fmla="*/ 208523 h 1370139"/>
              <a:gd name="connsiteX16" fmla="*/ 23834 w 1012696"/>
              <a:gd name="connsiteY16" fmla="*/ 226394 h 1370139"/>
              <a:gd name="connsiteX17" fmla="*/ 32769 w 1012696"/>
              <a:gd name="connsiteY17" fmla="*/ 229373 h 1370139"/>
              <a:gd name="connsiteX18" fmla="*/ 50640 w 1012696"/>
              <a:gd name="connsiteY18" fmla="*/ 244265 h 1370139"/>
              <a:gd name="connsiteX19" fmla="*/ 59576 w 1012696"/>
              <a:gd name="connsiteY19" fmla="*/ 250222 h 1370139"/>
              <a:gd name="connsiteX20" fmla="*/ 62554 w 1012696"/>
              <a:gd name="connsiteY20" fmla="*/ 259158 h 1370139"/>
              <a:gd name="connsiteX21" fmla="*/ 80425 w 1012696"/>
              <a:gd name="connsiteY21" fmla="*/ 268093 h 1370139"/>
              <a:gd name="connsiteX22" fmla="*/ 89361 w 1012696"/>
              <a:gd name="connsiteY22" fmla="*/ 277029 h 1370139"/>
              <a:gd name="connsiteX23" fmla="*/ 98296 w 1012696"/>
              <a:gd name="connsiteY23" fmla="*/ 280007 h 1370139"/>
              <a:gd name="connsiteX24" fmla="*/ 101275 w 1012696"/>
              <a:gd name="connsiteY24" fmla="*/ 288943 h 1370139"/>
              <a:gd name="connsiteX25" fmla="*/ 116167 w 1012696"/>
              <a:gd name="connsiteY25" fmla="*/ 309792 h 1370139"/>
              <a:gd name="connsiteX26" fmla="*/ 128081 w 1012696"/>
              <a:gd name="connsiteY26" fmla="*/ 336599 h 1370139"/>
              <a:gd name="connsiteX27" fmla="*/ 137017 w 1012696"/>
              <a:gd name="connsiteY27" fmla="*/ 345534 h 1370139"/>
              <a:gd name="connsiteX28" fmla="*/ 145952 w 1012696"/>
              <a:gd name="connsiteY28" fmla="*/ 363405 h 1370139"/>
              <a:gd name="connsiteX29" fmla="*/ 154888 w 1012696"/>
              <a:gd name="connsiteY29" fmla="*/ 381276 h 1370139"/>
              <a:gd name="connsiteX30" fmla="*/ 163823 w 1012696"/>
              <a:gd name="connsiteY30" fmla="*/ 408083 h 1370139"/>
              <a:gd name="connsiteX31" fmla="*/ 166802 w 1012696"/>
              <a:gd name="connsiteY31" fmla="*/ 417018 h 1370139"/>
              <a:gd name="connsiteX32" fmla="*/ 172759 w 1012696"/>
              <a:gd name="connsiteY32" fmla="*/ 425954 h 1370139"/>
              <a:gd name="connsiteX33" fmla="*/ 178716 w 1012696"/>
              <a:gd name="connsiteY33" fmla="*/ 449782 h 1370139"/>
              <a:gd name="connsiteX34" fmla="*/ 190630 w 1012696"/>
              <a:gd name="connsiteY34" fmla="*/ 500416 h 1370139"/>
              <a:gd name="connsiteX35" fmla="*/ 193609 w 1012696"/>
              <a:gd name="connsiteY35" fmla="*/ 530201 h 1370139"/>
              <a:gd name="connsiteX36" fmla="*/ 199566 w 1012696"/>
              <a:gd name="connsiteY36" fmla="*/ 551051 h 1370139"/>
              <a:gd name="connsiteX37" fmla="*/ 202544 w 1012696"/>
              <a:gd name="connsiteY37" fmla="*/ 589772 h 1370139"/>
              <a:gd name="connsiteX38" fmla="*/ 205523 w 1012696"/>
              <a:gd name="connsiteY38" fmla="*/ 604664 h 1370139"/>
              <a:gd name="connsiteX39" fmla="*/ 208501 w 1012696"/>
              <a:gd name="connsiteY39" fmla="*/ 622535 h 1370139"/>
              <a:gd name="connsiteX40" fmla="*/ 214458 w 1012696"/>
              <a:gd name="connsiteY40" fmla="*/ 676148 h 1370139"/>
              <a:gd name="connsiteX41" fmla="*/ 220415 w 1012696"/>
              <a:gd name="connsiteY41" fmla="*/ 694019 h 1370139"/>
              <a:gd name="connsiteX42" fmla="*/ 223394 w 1012696"/>
              <a:gd name="connsiteY42" fmla="*/ 702955 h 1370139"/>
              <a:gd name="connsiteX43" fmla="*/ 235308 w 1012696"/>
              <a:gd name="connsiteY43" fmla="*/ 720826 h 1370139"/>
              <a:gd name="connsiteX44" fmla="*/ 247222 w 1012696"/>
              <a:gd name="connsiteY44" fmla="*/ 741675 h 1370139"/>
              <a:gd name="connsiteX45" fmla="*/ 253179 w 1012696"/>
              <a:gd name="connsiteY45" fmla="*/ 753589 h 1370139"/>
              <a:gd name="connsiteX46" fmla="*/ 262114 w 1012696"/>
              <a:gd name="connsiteY46" fmla="*/ 777417 h 1370139"/>
              <a:gd name="connsiteX47" fmla="*/ 265093 w 1012696"/>
              <a:gd name="connsiteY47" fmla="*/ 786353 h 1370139"/>
              <a:gd name="connsiteX48" fmla="*/ 271050 w 1012696"/>
              <a:gd name="connsiteY48" fmla="*/ 795288 h 1370139"/>
              <a:gd name="connsiteX49" fmla="*/ 277007 w 1012696"/>
              <a:gd name="connsiteY49" fmla="*/ 807202 h 1370139"/>
              <a:gd name="connsiteX50" fmla="*/ 285942 w 1012696"/>
              <a:gd name="connsiteY50" fmla="*/ 813159 h 1370139"/>
              <a:gd name="connsiteX51" fmla="*/ 288921 w 1012696"/>
              <a:gd name="connsiteY51" fmla="*/ 831030 h 1370139"/>
              <a:gd name="connsiteX52" fmla="*/ 300835 w 1012696"/>
              <a:gd name="connsiteY52" fmla="*/ 848901 h 1370139"/>
              <a:gd name="connsiteX53" fmla="*/ 327641 w 1012696"/>
              <a:gd name="connsiteY53" fmla="*/ 878686 h 1370139"/>
              <a:gd name="connsiteX54" fmla="*/ 345512 w 1012696"/>
              <a:gd name="connsiteY54" fmla="*/ 887622 h 1370139"/>
              <a:gd name="connsiteX55" fmla="*/ 354448 w 1012696"/>
              <a:gd name="connsiteY55" fmla="*/ 890600 h 1370139"/>
              <a:gd name="connsiteX56" fmla="*/ 363383 w 1012696"/>
              <a:gd name="connsiteY56" fmla="*/ 896557 h 1370139"/>
              <a:gd name="connsiteX57" fmla="*/ 375297 w 1012696"/>
              <a:gd name="connsiteY57" fmla="*/ 899536 h 1370139"/>
              <a:gd name="connsiteX58" fmla="*/ 425932 w 1012696"/>
              <a:gd name="connsiteY58" fmla="*/ 902514 h 1370139"/>
              <a:gd name="connsiteX59" fmla="*/ 446781 w 1012696"/>
              <a:gd name="connsiteY59" fmla="*/ 908471 h 1370139"/>
              <a:gd name="connsiteX60" fmla="*/ 455717 w 1012696"/>
              <a:gd name="connsiteY60" fmla="*/ 917407 h 1370139"/>
              <a:gd name="connsiteX61" fmla="*/ 464652 w 1012696"/>
              <a:gd name="connsiteY61" fmla="*/ 923364 h 1370139"/>
              <a:gd name="connsiteX62" fmla="*/ 476566 w 1012696"/>
              <a:gd name="connsiteY62" fmla="*/ 941235 h 1370139"/>
              <a:gd name="connsiteX63" fmla="*/ 485502 w 1012696"/>
              <a:gd name="connsiteY63" fmla="*/ 950170 h 1370139"/>
              <a:gd name="connsiteX64" fmla="*/ 506351 w 1012696"/>
              <a:gd name="connsiteY64" fmla="*/ 979955 h 1370139"/>
              <a:gd name="connsiteX65" fmla="*/ 524222 w 1012696"/>
              <a:gd name="connsiteY65" fmla="*/ 997826 h 1370139"/>
              <a:gd name="connsiteX66" fmla="*/ 533158 w 1012696"/>
              <a:gd name="connsiteY66" fmla="*/ 1006762 h 1370139"/>
              <a:gd name="connsiteX67" fmla="*/ 556986 w 1012696"/>
              <a:gd name="connsiteY67" fmla="*/ 1033568 h 1370139"/>
              <a:gd name="connsiteX68" fmla="*/ 565921 w 1012696"/>
              <a:gd name="connsiteY68" fmla="*/ 1042504 h 1370139"/>
              <a:gd name="connsiteX69" fmla="*/ 586771 w 1012696"/>
              <a:gd name="connsiteY69" fmla="*/ 1057396 h 1370139"/>
              <a:gd name="connsiteX70" fmla="*/ 595706 w 1012696"/>
              <a:gd name="connsiteY70" fmla="*/ 1066332 h 1370139"/>
              <a:gd name="connsiteX71" fmla="*/ 604642 w 1012696"/>
              <a:gd name="connsiteY71" fmla="*/ 1072289 h 1370139"/>
              <a:gd name="connsiteX72" fmla="*/ 631448 w 1012696"/>
              <a:gd name="connsiteY72" fmla="*/ 1096117 h 1370139"/>
              <a:gd name="connsiteX73" fmla="*/ 643362 w 1012696"/>
              <a:gd name="connsiteY73" fmla="*/ 1113988 h 1370139"/>
              <a:gd name="connsiteX74" fmla="*/ 658255 w 1012696"/>
              <a:gd name="connsiteY74" fmla="*/ 1140794 h 1370139"/>
              <a:gd name="connsiteX75" fmla="*/ 664212 w 1012696"/>
              <a:gd name="connsiteY75" fmla="*/ 1149730 h 1370139"/>
              <a:gd name="connsiteX76" fmla="*/ 673147 w 1012696"/>
              <a:gd name="connsiteY76" fmla="*/ 1155687 h 1370139"/>
              <a:gd name="connsiteX77" fmla="*/ 679104 w 1012696"/>
              <a:gd name="connsiteY77" fmla="*/ 1164622 h 1370139"/>
              <a:gd name="connsiteX78" fmla="*/ 696975 w 1012696"/>
              <a:gd name="connsiteY78" fmla="*/ 1173558 h 1370139"/>
              <a:gd name="connsiteX79" fmla="*/ 717825 w 1012696"/>
              <a:gd name="connsiteY79" fmla="*/ 1188450 h 1370139"/>
              <a:gd name="connsiteX80" fmla="*/ 735696 w 1012696"/>
              <a:gd name="connsiteY80" fmla="*/ 1209300 h 1370139"/>
              <a:gd name="connsiteX81" fmla="*/ 741653 w 1012696"/>
              <a:gd name="connsiteY81" fmla="*/ 1218235 h 1370139"/>
              <a:gd name="connsiteX82" fmla="*/ 756545 w 1012696"/>
              <a:gd name="connsiteY82" fmla="*/ 1221214 h 1370139"/>
              <a:gd name="connsiteX83" fmla="*/ 762502 w 1012696"/>
              <a:gd name="connsiteY83" fmla="*/ 1230149 h 1370139"/>
              <a:gd name="connsiteX84" fmla="*/ 768459 w 1012696"/>
              <a:gd name="connsiteY84" fmla="*/ 1271848 h 1370139"/>
              <a:gd name="connsiteX85" fmla="*/ 771438 w 1012696"/>
              <a:gd name="connsiteY85" fmla="*/ 1280784 h 1370139"/>
              <a:gd name="connsiteX86" fmla="*/ 780373 w 1012696"/>
              <a:gd name="connsiteY86" fmla="*/ 1316526 h 1370139"/>
              <a:gd name="connsiteX87" fmla="*/ 789309 w 1012696"/>
              <a:gd name="connsiteY87" fmla="*/ 1346311 h 1370139"/>
              <a:gd name="connsiteX88" fmla="*/ 792287 w 1012696"/>
              <a:gd name="connsiteY88" fmla="*/ 1355246 h 1370139"/>
              <a:gd name="connsiteX89" fmla="*/ 813137 w 1012696"/>
              <a:gd name="connsiteY89" fmla="*/ 1364182 h 1370139"/>
              <a:gd name="connsiteX90" fmla="*/ 875685 w 1012696"/>
              <a:gd name="connsiteY90" fmla="*/ 1367160 h 1370139"/>
              <a:gd name="connsiteX91" fmla="*/ 926320 w 1012696"/>
              <a:gd name="connsiteY91" fmla="*/ 1370139 h 1370139"/>
              <a:gd name="connsiteX92" fmla="*/ 985890 w 1012696"/>
              <a:gd name="connsiteY92" fmla="*/ 1367160 h 1370139"/>
              <a:gd name="connsiteX93" fmla="*/ 994825 w 1012696"/>
              <a:gd name="connsiteY93" fmla="*/ 1364182 h 1370139"/>
              <a:gd name="connsiteX94" fmla="*/ 1006739 w 1012696"/>
              <a:gd name="connsiteY94" fmla="*/ 1337375 h 1370139"/>
              <a:gd name="connsiteX95" fmla="*/ 1012696 w 1012696"/>
              <a:gd name="connsiteY95" fmla="*/ 1328440 h 1370139"/>
              <a:gd name="connsiteX96" fmla="*/ 1012696 w 1012696"/>
              <a:gd name="connsiteY96" fmla="*/ 1164622 h 1370139"/>
              <a:gd name="connsiteX97" fmla="*/ 1009718 w 1012696"/>
              <a:gd name="connsiteY97" fmla="*/ 1116966 h 1370139"/>
              <a:gd name="connsiteX98" fmla="*/ 1006739 w 1012696"/>
              <a:gd name="connsiteY98" fmla="*/ 1099095 h 1370139"/>
              <a:gd name="connsiteX99" fmla="*/ 1000782 w 1012696"/>
              <a:gd name="connsiteY99" fmla="*/ 1081224 h 1370139"/>
              <a:gd name="connsiteX100" fmla="*/ 1003761 w 1012696"/>
              <a:gd name="connsiteY100" fmla="*/ 1060375 h 1370139"/>
              <a:gd name="connsiteX101" fmla="*/ 1009718 w 1012696"/>
              <a:gd name="connsiteY101" fmla="*/ 1012719 h 1370139"/>
              <a:gd name="connsiteX102" fmla="*/ 1012696 w 1012696"/>
              <a:gd name="connsiteY102" fmla="*/ 997826 h 1370139"/>
              <a:gd name="connsiteX103" fmla="*/ 1009718 w 1012696"/>
              <a:gd name="connsiteY103" fmla="*/ 914428 h 1370139"/>
              <a:gd name="connsiteX104" fmla="*/ 1006739 w 1012696"/>
              <a:gd name="connsiteY104" fmla="*/ 899536 h 1370139"/>
              <a:gd name="connsiteX105" fmla="*/ 1000782 w 1012696"/>
              <a:gd name="connsiteY105" fmla="*/ 878686 h 1370139"/>
              <a:gd name="connsiteX106" fmla="*/ 991847 w 1012696"/>
              <a:gd name="connsiteY106" fmla="*/ 869751 h 1370139"/>
              <a:gd name="connsiteX107" fmla="*/ 973976 w 1012696"/>
              <a:gd name="connsiteY107" fmla="*/ 857837 h 1370139"/>
              <a:gd name="connsiteX108" fmla="*/ 965040 w 1012696"/>
              <a:gd name="connsiteY108" fmla="*/ 851880 h 1370139"/>
              <a:gd name="connsiteX109" fmla="*/ 956105 w 1012696"/>
              <a:gd name="connsiteY109" fmla="*/ 842944 h 1370139"/>
              <a:gd name="connsiteX110" fmla="*/ 938234 w 1012696"/>
              <a:gd name="connsiteY110" fmla="*/ 834009 h 1370139"/>
              <a:gd name="connsiteX111" fmla="*/ 902492 w 1012696"/>
              <a:gd name="connsiteY111" fmla="*/ 831030 h 1370139"/>
              <a:gd name="connsiteX112" fmla="*/ 878664 w 1012696"/>
              <a:gd name="connsiteY112" fmla="*/ 828052 h 1370139"/>
              <a:gd name="connsiteX113" fmla="*/ 869728 w 1012696"/>
              <a:gd name="connsiteY113" fmla="*/ 825073 h 1370139"/>
              <a:gd name="connsiteX114" fmla="*/ 848879 w 1012696"/>
              <a:gd name="connsiteY114" fmla="*/ 819116 h 1370139"/>
              <a:gd name="connsiteX115" fmla="*/ 831008 w 1012696"/>
              <a:gd name="connsiteY115" fmla="*/ 810181 h 1370139"/>
              <a:gd name="connsiteX116" fmla="*/ 822072 w 1012696"/>
              <a:gd name="connsiteY116" fmla="*/ 804224 h 1370139"/>
              <a:gd name="connsiteX117" fmla="*/ 813137 w 1012696"/>
              <a:gd name="connsiteY117" fmla="*/ 801245 h 1370139"/>
              <a:gd name="connsiteX118" fmla="*/ 804201 w 1012696"/>
              <a:gd name="connsiteY118" fmla="*/ 792310 h 1370139"/>
              <a:gd name="connsiteX119" fmla="*/ 795266 w 1012696"/>
              <a:gd name="connsiteY119" fmla="*/ 789331 h 1370139"/>
              <a:gd name="connsiteX120" fmla="*/ 777395 w 1012696"/>
              <a:gd name="connsiteY120" fmla="*/ 777417 h 1370139"/>
              <a:gd name="connsiteX121" fmla="*/ 762502 w 1012696"/>
              <a:gd name="connsiteY121" fmla="*/ 750611 h 1370139"/>
              <a:gd name="connsiteX122" fmla="*/ 756545 w 1012696"/>
              <a:gd name="connsiteY122" fmla="*/ 741675 h 1370139"/>
              <a:gd name="connsiteX123" fmla="*/ 750588 w 1012696"/>
              <a:gd name="connsiteY123" fmla="*/ 732740 h 1370139"/>
              <a:gd name="connsiteX124" fmla="*/ 741653 w 1012696"/>
              <a:gd name="connsiteY124" fmla="*/ 705933 h 1370139"/>
              <a:gd name="connsiteX125" fmla="*/ 738674 w 1012696"/>
              <a:gd name="connsiteY125" fmla="*/ 696998 h 1370139"/>
              <a:gd name="connsiteX126" fmla="*/ 732717 w 1012696"/>
              <a:gd name="connsiteY126" fmla="*/ 688062 h 1370139"/>
              <a:gd name="connsiteX127" fmla="*/ 723782 w 1012696"/>
              <a:gd name="connsiteY127" fmla="*/ 670191 h 1370139"/>
              <a:gd name="connsiteX128" fmla="*/ 717825 w 1012696"/>
              <a:gd name="connsiteY128" fmla="*/ 652320 h 1370139"/>
              <a:gd name="connsiteX129" fmla="*/ 711868 w 1012696"/>
              <a:gd name="connsiteY129" fmla="*/ 634449 h 1370139"/>
              <a:gd name="connsiteX130" fmla="*/ 705911 w 1012696"/>
              <a:gd name="connsiteY130" fmla="*/ 613600 h 1370139"/>
              <a:gd name="connsiteX131" fmla="*/ 699954 w 1012696"/>
              <a:gd name="connsiteY131" fmla="*/ 604664 h 1370139"/>
              <a:gd name="connsiteX132" fmla="*/ 696975 w 1012696"/>
              <a:gd name="connsiteY132" fmla="*/ 506373 h 1370139"/>
              <a:gd name="connsiteX133" fmla="*/ 693997 w 1012696"/>
              <a:gd name="connsiteY133" fmla="*/ 497438 h 1370139"/>
              <a:gd name="connsiteX134" fmla="*/ 691018 w 1012696"/>
              <a:gd name="connsiteY134" fmla="*/ 479567 h 1370139"/>
              <a:gd name="connsiteX135" fmla="*/ 688040 w 1012696"/>
              <a:gd name="connsiteY135" fmla="*/ 470631 h 1370139"/>
              <a:gd name="connsiteX136" fmla="*/ 679104 w 1012696"/>
              <a:gd name="connsiteY136" fmla="*/ 437868 h 1370139"/>
              <a:gd name="connsiteX137" fmla="*/ 676126 w 1012696"/>
              <a:gd name="connsiteY137" fmla="*/ 428932 h 1370139"/>
              <a:gd name="connsiteX138" fmla="*/ 673147 w 1012696"/>
              <a:gd name="connsiteY138" fmla="*/ 399147 h 1370139"/>
              <a:gd name="connsiteX139" fmla="*/ 670169 w 1012696"/>
              <a:gd name="connsiteY139" fmla="*/ 390212 h 1370139"/>
              <a:gd name="connsiteX140" fmla="*/ 661233 w 1012696"/>
              <a:gd name="connsiteY140" fmla="*/ 381276 h 1370139"/>
              <a:gd name="connsiteX141" fmla="*/ 655276 w 1012696"/>
              <a:gd name="connsiteY141" fmla="*/ 363405 h 1370139"/>
              <a:gd name="connsiteX142" fmla="*/ 646341 w 1012696"/>
              <a:gd name="connsiteY142" fmla="*/ 357448 h 1370139"/>
              <a:gd name="connsiteX143" fmla="*/ 625491 w 1012696"/>
              <a:gd name="connsiteY143" fmla="*/ 336599 h 1370139"/>
              <a:gd name="connsiteX144" fmla="*/ 595706 w 1012696"/>
              <a:gd name="connsiteY144" fmla="*/ 321706 h 1370139"/>
              <a:gd name="connsiteX145" fmla="*/ 586771 w 1012696"/>
              <a:gd name="connsiteY145" fmla="*/ 318728 h 1370139"/>
              <a:gd name="connsiteX146" fmla="*/ 574857 w 1012696"/>
              <a:gd name="connsiteY146" fmla="*/ 312771 h 1370139"/>
              <a:gd name="connsiteX147" fmla="*/ 565921 w 1012696"/>
              <a:gd name="connsiteY147" fmla="*/ 306814 h 1370139"/>
              <a:gd name="connsiteX148" fmla="*/ 545072 w 1012696"/>
              <a:gd name="connsiteY148" fmla="*/ 300857 h 1370139"/>
              <a:gd name="connsiteX149" fmla="*/ 542093 w 1012696"/>
              <a:gd name="connsiteY149" fmla="*/ 291921 h 1370139"/>
              <a:gd name="connsiteX150" fmla="*/ 515287 w 1012696"/>
              <a:gd name="connsiteY150" fmla="*/ 271072 h 1370139"/>
              <a:gd name="connsiteX151" fmla="*/ 497416 w 1012696"/>
              <a:gd name="connsiteY151" fmla="*/ 244265 h 1370139"/>
              <a:gd name="connsiteX152" fmla="*/ 491459 w 1012696"/>
              <a:gd name="connsiteY152" fmla="*/ 235330 h 1370139"/>
              <a:gd name="connsiteX153" fmla="*/ 485502 w 1012696"/>
              <a:gd name="connsiteY153" fmla="*/ 226394 h 1370139"/>
              <a:gd name="connsiteX154" fmla="*/ 467631 w 1012696"/>
              <a:gd name="connsiteY154" fmla="*/ 208523 h 1370139"/>
              <a:gd name="connsiteX155" fmla="*/ 455717 w 1012696"/>
              <a:gd name="connsiteY155" fmla="*/ 190652 h 1370139"/>
              <a:gd name="connsiteX156" fmla="*/ 449760 w 1012696"/>
              <a:gd name="connsiteY156" fmla="*/ 181717 h 1370139"/>
              <a:gd name="connsiteX157" fmla="*/ 440824 w 1012696"/>
              <a:gd name="connsiteY157" fmla="*/ 172781 h 1370139"/>
              <a:gd name="connsiteX158" fmla="*/ 434867 w 1012696"/>
              <a:gd name="connsiteY158" fmla="*/ 163846 h 1370139"/>
              <a:gd name="connsiteX159" fmla="*/ 422953 w 1012696"/>
              <a:gd name="connsiteY159" fmla="*/ 154910 h 1370139"/>
              <a:gd name="connsiteX160" fmla="*/ 416996 w 1012696"/>
              <a:gd name="connsiteY160" fmla="*/ 140018 h 1370139"/>
              <a:gd name="connsiteX161" fmla="*/ 396147 w 1012696"/>
              <a:gd name="connsiteY161" fmla="*/ 113211 h 1370139"/>
              <a:gd name="connsiteX162" fmla="*/ 393168 w 1012696"/>
              <a:gd name="connsiteY162" fmla="*/ 104276 h 1370139"/>
              <a:gd name="connsiteX163" fmla="*/ 387211 w 1012696"/>
              <a:gd name="connsiteY163" fmla="*/ 83426 h 1370139"/>
              <a:gd name="connsiteX164" fmla="*/ 384233 w 1012696"/>
              <a:gd name="connsiteY164" fmla="*/ 53641 h 1370139"/>
              <a:gd name="connsiteX165" fmla="*/ 381254 w 1012696"/>
              <a:gd name="connsiteY165" fmla="*/ 8964 h 1370139"/>
              <a:gd name="connsiteX166" fmla="*/ 357426 w 1012696"/>
              <a:gd name="connsiteY166" fmla="*/ 11942 h 1370139"/>
              <a:gd name="connsiteX167" fmla="*/ 336577 w 1012696"/>
              <a:gd name="connsiteY167" fmla="*/ 17899 h 1370139"/>
              <a:gd name="connsiteX168" fmla="*/ 282964 w 1012696"/>
              <a:gd name="connsiteY168" fmla="*/ 14921 h 1370139"/>
              <a:gd name="connsiteX169" fmla="*/ 244243 w 1012696"/>
              <a:gd name="connsiteY169" fmla="*/ 11942 h 1370139"/>
              <a:gd name="connsiteX170" fmla="*/ 145952 w 1012696"/>
              <a:gd name="connsiteY170" fmla="*/ 28 h 137013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 ang="0">
                <a:pos x="connsiteX136" y="connsiteY136"/>
              </a:cxn>
              <a:cxn ang="0">
                <a:pos x="connsiteX137" y="connsiteY137"/>
              </a:cxn>
              <a:cxn ang="0">
                <a:pos x="connsiteX138" y="connsiteY138"/>
              </a:cxn>
              <a:cxn ang="0">
                <a:pos x="connsiteX139" y="connsiteY139"/>
              </a:cxn>
              <a:cxn ang="0">
                <a:pos x="connsiteX140" y="connsiteY140"/>
              </a:cxn>
              <a:cxn ang="0">
                <a:pos x="connsiteX141" y="connsiteY141"/>
              </a:cxn>
              <a:cxn ang="0">
                <a:pos x="connsiteX142" y="connsiteY142"/>
              </a:cxn>
              <a:cxn ang="0">
                <a:pos x="connsiteX143" y="connsiteY143"/>
              </a:cxn>
              <a:cxn ang="0">
                <a:pos x="connsiteX144" y="connsiteY144"/>
              </a:cxn>
              <a:cxn ang="0">
                <a:pos x="connsiteX145" y="connsiteY145"/>
              </a:cxn>
              <a:cxn ang="0">
                <a:pos x="connsiteX146" y="connsiteY146"/>
              </a:cxn>
              <a:cxn ang="0">
                <a:pos x="connsiteX147" y="connsiteY147"/>
              </a:cxn>
              <a:cxn ang="0">
                <a:pos x="connsiteX148" y="connsiteY148"/>
              </a:cxn>
              <a:cxn ang="0">
                <a:pos x="connsiteX149" y="connsiteY149"/>
              </a:cxn>
              <a:cxn ang="0">
                <a:pos x="connsiteX150" y="connsiteY150"/>
              </a:cxn>
              <a:cxn ang="0">
                <a:pos x="connsiteX151" y="connsiteY151"/>
              </a:cxn>
              <a:cxn ang="0">
                <a:pos x="connsiteX152" y="connsiteY152"/>
              </a:cxn>
              <a:cxn ang="0">
                <a:pos x="connsiteX153" y="connsiteY153"/>
              </a:cxn>
              <a:cxn ang="0">
                <a:pos x="connsiteX154" y="connsiteY154"/>
              </a:cxn>
              <a:cxn ang="0">
                <a:pos x="connsiteX155" y="connsiteY155"/>
              </a:cxn>
              <a:cxn ang="0">
                <a:pos x="connsiteX156" y="connsiteY156"/>
              </a:cxn>
              <a:cxn ang="0">
                <a:pos x="connsiteX157" y="connsiteY157"/>
              </a:cxn>
              <a:cxn ang="0">
                <a:pos x="connsiteX158" y="connsiteY158"/>
              </a:cxn>
              <a:cxn ang="0">
                <a:pos x="connsiteX159" y="connsiteY159"/>
              </a:cxn>
              <a:cxn ang="0">
                <a:pos x="connsiteX160" y="connsiteY160"/>
              </a:cxn>
              <a:cxn ang="0">
                <a:pos x="connsiteX161" y="connsiteY161"/>
              </a:cxn>
              <a:cxn ang="0">
                <a:pos x="connsiteX162" y="connsiteY162"/>
              </a:cxn>
              <a:cxn ang="0">
                <a:pos x="connsiteX163" y="connsiteY163"/>
              </a:cxn>
              <a:cxn ang="0">
                <a:pos x="connsiteX164" y="connsiteY164"/>
              </a:cxn>
              <a:cxn ang="0">
                <a:pos x="connsiteX165" y="connsiteY165"/>
              </a:cxn>
              <a:cxn ang="0">
                <a:pos x="connsiteX166" y="connsiteY166"/>
              </a:cxn>
              <a:cxn ang="0">
                <a:pos x="connsiteX167" y="connsiteY167"/>
              </a:cxn>
              <a:cxn ang="0">
                <a:pos x="connsiteX168" y="connsiteY168"/>
              </a:cxn>
              <a:cxn ang="0">
                <a:pos x="connsiteX169" y="connsiteY169"/>
              </a:cxn>
              <a:cxn ang="0">
                <a:pos x="connsiteX170" y="connsiteY170"/>
              </a:cxn>
            </a:cxnLst>
            <a:rect l="l" t="t" r="r" b="b"/>
            <a:pathLst>
              <a:path w="1012696" h="1370139">
                <a:moveTo>
                  <a:pt x="145952" y="28"/>
                </a:moveTo>
                <a:cubicBezTo>
                  <a:pt x="127088" y="524"/>
                  <a:pt x="136343" y="10298"/>
                  <a:pt x="131060" y="14921"/>
                </a:cubicBezTo>
                <a:cubicBezTo>
                  <a:pt x="128366" y="17278"/>
                  <a:pt x="124655" y="18347"/>
                  <a:pt x="122124" y="20878"/>
                </a:cubicBezTo>
                <a:cubicBezTo>
                  <a:pt x="119593" y="23409"/>
                  <a:pt x="118861" y="27456"/>
                  <a:pt x="116167" y="29813"/>
                </a:cubicBezTo>
                <a:cubicBezTo>
                  <a:pt x="102450" y="41815"/>
                  <a:pt x="99832" y="39998"/>
                  <a:pt x="86382" y="47684"/>
                </a:cubicBezTo>
                <a:cubicBezTo>
                  <a:pt x="83274" y="49460"/>
                  <a:pt x="80649" y="52040"/>
                  <a:pt x="77447" y="53641"/>
                </a:cubicBezTo>
                <a:cubicBezTo>
                  <a:pt x="74639" y="55045"/>
                  <a:pt x="71319" y="55216"/>
                  <a:pt x="68511" y="56620"/>
                </a:cubicBezTo>
                <a:cubicBezTo>
                  <a:pt x="65309" y="58221"/>
                  <a:pt x="62489" y="60496"/>
                  <a:pt x="59576" y="62577"/>
                </a:cubicBezTo>
                <a:cubicBezTo>
                  <a:pt x="55537" y="65462"/>
                  <a:pt x="52102" y="69292"/>
                  <a:pt x="47662" y="71512"/>
                </a:cubicBezTo>
                <a:cubicBezTo>
                  <a:pt x="44001" y="73343"/>
                  <a:pt x="39719" y="73498"/>
                  <a:pt x="35748" y="74491"/>
                </a:cubicBezTo>
                <a:cubicBezTo>
                  <a:pt x="33762" y="77469"/>
                  <a:pt x="32322" y="80895"/>
                  <a:pt x="29791" y="83426"/>
                </a:cubicBezTo>
                <a:cubicBezTo>
                  <a:pt x="23843" y="89374"/>
                  <a:pt x="13073" y="92496"/>
                  <a:pt x="5963" y="95340"/>
                </a:cubicBezTo>
                <a:cubicBezTo>
                  <a:pt x="-5414" y="118094"/>
                  <a:pt x="2984" y="95647"/>
                  <a:pt x="2984" y="128104"/>
                </a:cubicBezTo>
                <a:cubicBezTo>
                  <a:pt x="2984" y="142039"/>
                  <a:pt x="999" y="155903"/>
                  <a:pt x="6" y="169803"/>
                </a:cubicBezTo>
                <a:cubicBezTo>
                  <a:pt x="3996" y="197739"/>
                  <a:pt x="-910" y="184811"/>
                  <a:pt x="14898" y="208523"/>
                </a:cubicBezTo>
                <a:lnTo>
                  <a:pt x="14898" y="208523"/>
                </a:lnTo>
                <a:cubicBezTo>
                  <a:pt x="16860" y="214410"/>
                  <a:pt x="18585" y="222195"/>
                  <a:pt x="23834" y="226394"/>
                </a:cubicBezTo>
                <a:cubicBezTo>
                  <a:pt x="26286" y="228355"/>
                  <a:pt x="29961" y="227969"/>
                  <a:pt x="32769" y="229373"/>
                </a:cubicBezTo>
                <a:cubicBezTo>
                  <a:pt x="43865" y="234921"/>
                  <a:pt x="40756" y="236028"/>
                  <a:pt x="50640" y="244265"/>
                </a:cubicBezTo>
                <a:cubicBezTo>
                  <a:pt x="53390" y="246557"/>
                  <a:pt x="56597" y="248236"/>
                  <a:pt x="59576" y="250222"/>
                </a:cubicBezTo>
                <a:cubicBezTo>
                  <a:pt x="60569" y="253201"/>
                  <a:pt x="60593" y="256706"/>
                  <a:pt x="62554" y="259158"/>
                </a:cubicBezTo>
                <a:cubicBezTo>
                  <a:pt x="66753" y="264407"/>
                  <a:pt x="74539" y="266131"/>
                  <a:pt x="80425" y="268093"/>
                </a:cubicBezTo>
                <a:cubicBezTo>
                  <a:pt x="83404" y="271072"/>
                  <a:pt x="85856" y="274692"/>
                  <a:pt x="89361" y="277029"/>
                </a:cubicBezTo>
                <a:cubicBezTo>
                  <a:pt x="91973" y="278770"/>
                  <a:pt x="96076" y="277787"/>
                  <a:pt x="98296" y="280007"/>
                </a:cubicBezTo>
                <a:cubicBezTo>
                  <a:pt x="100516" y="282227"/>
                  <a:pt x="99871" y="286135"/>
                  <a:pt x="101275" y="288943"/>
                </a:cubicBezTo>
                <a:cubicBezTo>
                  <a:pt x="103451" y="293295"/>
                  <a:pt x="114146" y="307097"/>
                  <a:pt x="116167" y="309792"/>
                </a:cubicBezTo>
                <a:cubicBezTo>
                  <a:pt x="120495" y="322777"/>
                  <a:pt x="120215" y="327160"/>
                  <a:pt x="128081" y="336599"/>
                </a:cubicBezTo>
                <a:cubicBezTo>
                  <a:pt x="130778" y="339835"/>
                  <a:pt x="134038" y="342556"/>
                  <a:pt x="137017" y="345534"/>
                </a:cubicBezTo>
                <a:cubicBezTo>
                  <a:pt x="144500" y="367989"/>
                  <a:pt x="134407" y="340317"/>
                  <a:pt x="145952" y="363405"/>
                </a:cubicBezTo>
                <a:cubicBezTo>
                  <a:pt x="158284" y="388067"/>
                  <a:pt x="137817" y="355671"/>
                  <a:pt x="154888" y="381276"/>
                </a:cubicBezTo>
                <a:lnTo>
                  <a:pt x="163823" y="408083"/>
                </a:lnTo>
                <a:cubicBezTo>
                  <a:pt x="164816" y="411061"/>
                  <a:pt x="165061" y="414406"/>
                  <a:pt x="166802" y="417018"/>
                </a:cubicBezTo>
                <a:lnTo>
                  <a:pt x="172759" y="425954"/>
                </a:lnTo>
                <a:cubicBezTo>
                  <a:pt x="181798" y="453073"/>
                  <a:pt x="167929" y="410232"/>
                  <a:pt x="178716" y="449782"/>
                </a:cubicBezTo>
                <a:cubicBezTo>
                  <a:pt x="188274" y="484827"/>
                  <a:pt x="183389" y="449730"/>
                  <a:pt x="190630" y="500416"/>
                </a:cubicBezTo>
                <a:cubicBezTo>
                  <a:pt x="192041" y="510294"/>
                  <a:pt x="192198" y="520323"/>
                  <a:pt x="193609" y="530201"/>
                </a:cubicBezTo>
                <a:cubicBezTo>
                  <a:pt x="194545" y="536751"/>
                  <a:pt x="197443" y="544682"/>
                  <a:pt x="199566" y="551051"/>
                </a:cubicBezTo>
                <a:cubicBezTo>
                  <a:pt x="200559" y="563958"/>
                  <a:pt x="201114" y="576906"/>
                  <a:pt x="202544" y="589772"/>
                </a:cubicBezTo>
                <a:cubicBezTo>
                  <a:pt x="203103" y="594803"/>
                  <a:pt x="204617" y="599683"/>
                  <a:pt x="205523" y="604664"/>
                </a:cubicBezTo>
                <a:cubicBezTo>
                  <a:pt x="206603" y="610606"/>
                  <a:pt x="207834" y="616533"/>
                  <a:pt x="208501" y="622535"/>
                </a:cubicBezTo>
                <a:cubicBezTo>
                  <a:pt x="210153" y="637400"/>
                  <a:pt x="210439" y="660070"/>
                  <a:pt x="214458" y="676148"/>
                </a:cubicBezTo>
                <a:cubicBezTo>
                  <a:pt x="215981" y="682240"/>
                  <a:pt x="218429" y="688062"/>
                  <a:pt x="220415" y="694019"/>
                </a:cubicBezTo>
                <a:cubicBezTo>
                  <a:pt x="221408" y="696998"/>
                  <a:pt x="221652" y="700343"/>
                  <a:pt x="223394" y="702955"/>
                </a:cubicBezTo>
                <a:lnTo>
                  <a:pt x="235308" y="720826"/>
                </a:lnTo>
                <a:cubicBezTo>
                  <a:pt x="241159" y="738380"/>
                  <a:pt x="234342" y="721067"/>
                  <a:pt x="247222" y="741675"/>
                </a:cubicBezTo>
                <a:cubicBezTo>
                  <a:pt x="249575" y="745440"/>
                  <a:pt x="251193" y="749618"/>
                  <a:pt x="253179" y="753589"/>
                </a:cubicBezTo>
                <a:cubicBezTo>
                  <a:pt x="258669" y="775552"/>
                  <a:pt x="252770" y="755615"/>
                  <a:pt x="262114" y="777417"/>
                </a:cubicBezTo>
                <a:cubicBezTo>
                  <a:pt x="263351" y="780303"/>
                  <a:pt x="263689" y="783545"/>
                  <a:pt x="265093" y="786353"/>
                </a:cubicBezTo>
                <a:cubicBezTo>
                  <a:pt x="266694" y="789555"/>
                  <a:pt x="269274" y="792180"/>
                  <a:pt x="271050" y="795288"/>
                </a:cubicBezTo>
                <a:cubicBezTo>
                  <a:pt x="273253" y="799143"/>
                  <a:pt x="274165" y="803791"/>
                  <a:pt x="277007" y="807202"/>
                </a:cubicBezTo>
                <a:cubicBezTo>
                  <a:pt x="279299" y="809952"/>
                  <a:pt x="282964" y="811173"/>
                  <a:pt x="285942" y="813159"/>
                </a:cubicBezTo>
                <a:cubicBezTo>
                  <a:pt x="286935" y="819116"/>
                  <a:pt x="286598" y="825455"/>
                  <a:pt x="288921" y="831030"/>
                </a:cubicBezTo>
                <a:cubicBezTo>
                  <a:pt x="291675" y="837639"/>
                  <a:pt x="296864" y="842944"/>
                  <a:pt x="300835" y="848901"/>
                </a:cubicBezTo>
                <a:cubicBezTo>
                  <a:pt x="307378" y="858716"/>
                  <a:pt x="317619" y="875345"/>
                  <a:pt x="327641" y="878686"/>
                </a:cubicBezTo>
                <a:cubicBezTo>
                  <a:pt x="350110" y="886176"/>
                  <a:pt x="322408" y="876071"/>
                  <a:pt x="345512" y="887622"/>
                </a:cubicBezTo>
                <a:cubicBezTo>
                  <a:pt x="348320" y="889026"/>
                  <a:pt x="351469" y="889607"/>
                  <a:pt x="354448" y="890600"/>
                </a:cubicBezTo>
                <a:cubicBezTo>
                  <a:pt x="357426" y="892586"/>
                  <a:pt x="360093" y="895147"/>
                  <a:pt x="363383" y="896557"/>
                </a:cubicBezTo>
                <a:cubicBezTo>
                  <a:pt x="367146" y="898170"/>
                  <a:pt x="371222" y="899148"/>
                  <a:pt x="375297" y="899536"/>
                </a:cubicBezTo>
                <a:cubicBezTo>
                  <a:pt x="392128" y="901139"/>
                  <a:pt x="409054" y="901521"/>
                  <a:pt x="425932" y="902514"/>
                </a:cubicBezTo>
                <a:cubicBezTo>
                  <a:pt x="427517" y="902910"/>
                  <a:pt x="444219" y="906763"/>
                  <a:pt x="446781" y="908471"/>
                </a:cubicBezTo>
                <a:cubicBezTo>
                  <a:pt x="450286" y="910808"/>
                  <a:pt x="452481" y="914710"/>
                  <a:pt x="455717" y="917407"/>
                </a:cubicBezTo>
                <a:cubicBezTo>
                  <a:pt x="458467" y="919699"/>
                  <a:pt x="461674" y="921378"/>
                  <a:pt x="464652" y="923364"/>
                </a:cubicBezTo>
                <a:cubicBezTo>
                  <a:pt x="468623" y="929321"/>
                  <a:pt x="471503" y="936173"/>
                  <a:pt x="476566" y="941235"/>
                </a:cubicBezTo>
                <a:cubicBezTo>
                  <a:pt x="479545" y="944213"/>
                  <a:pt x="482916" y="946845"/>
                  <a:pt x="485502" y="950170"/>
                </a:cubicBezTo>
                <a:cubicBezTo>
                  <a:pt x="493881" y="960942"/>
                  <a:pt x="497481" y="970099"/>
                  <a:pt x="506351" y="979955"/>
                </a:cubicBezTo>
                <a:cubicBezTo>
                  <a:pt x="511987" y="986217"/>
                  <a:pt x="518265" y="991869"/>
                  <a:pt x="524222" y="997826"/>
                </a:cubicBezTo>
                <a:cubicBezTo>
                  <a:pt x="527201" y="1000805"/>
                  <a:pt x="530821" y="1003257"/>
                  <a:pt x="533158" y="1006762"/>
                </a:cubicBezTo>
                <a:cubicBezTo>
                  <a:pt x="543789" y="1022707"/>
                  <a:pt x="536582" y="1013164"/>
                  <a:pt x="556986" y="1033568"/>
                </a:cubicBezTo>
                <a:cubicBezTo>
                  <a:pt x="559964" y="1036547"/>
                  <a:pt x="562416" y="1040168"/>
                  <a:pt x="565921" y="1042504"/>
                </a:cubicBezTo>
                <a:cubicBezTo>
                  <a:pt x="572991" y="1047217"/>
                  <a:pt x="580308" y="1051856"/>
                  <a:pt x="586771" y="1057396"/>
                </a:cubicBezTo>
                <a:cubicBezTo>
                  <a:pt x="589969" y="1060137"/>
                  <a:pt x="592470" y="1063635"/>
                  <a:pt x="595706" y="1066332"/>
                </a:cubicBezTo>
                <a:cubicBezTo>
                  <a:pt x="598456" y="1068624"/>
                  <a:pt x="601966" y="1069911"/>
                  <a:pt x="604642" y="1072289"/>
                </a:cubicBezTo>
                <a:cubicBezTo>
                  <a:pt x="635249" y="1099495"/>
                  <a:pt x="611167" y="1082596"/>
                  <a:pt x="631448" y="1096117"/>
                </a:cubicBezTo>
                <a:cubicBezTo>
                  <a:pt x="635419" y="1102074"/>
                  <a:pt x="641098" y="1107196"/>
                  <a:pt x="643362" y="1113988"/>
                </a:cubicBezTo>
                <a:cubicBezTo>
                  <a:pt x="648606" y="1129715"/>
                  <a:pt x="644599" y="1120310"/>
                  <a:pt x="658255" y="1140794"/>
                </a:cubicBezTo>
                <a:cubicBezTo>
                  <a:pt x="660241" y="1143773"/>
                  <a:pt x="661233" y="1147744"/>
                  <a:pt x="664212" y="1149730"/>
                </a:cubicBezTo>
                <a:lnTo>
                  <a:pt x="673147" y="1155687"/>
                </a:lnTo>
                <a:cubicBezTo>
                  <a:pt x="675133" y="1158665"/>
                  <a:pt x="676573" y="1162091"/>
                  <a:pt x="679104" y="1164622"/>
                </a:cubicBezTo>
                <a:cubicBezTo>
                  <a:pt x="687639" y="1173157"/>
                  <a:pt x="687286" y="1168713"/>
                  <a:pt x="696975" y="1173558"/>
                </a:cubicBezTo>
                <a:cubicBezTo>
                  <a:pt x="700747" y="1175444"/>
                  <a:pt x="715935" y="1186830"/>
                  <a:pt x="717825" y="1188450"/>
                </a:cubicBezTo>
                <a:cubicBezTo>
                  <a:pt x="725798" y="1195284"/>
                  <a:pt x="729503" y="1200631"/>
                  <a:pt x="735696" y="1209300"/>
                </a:cubicBezTo>
                <a:cubicBezTo>
                  <a:pt x="737777" y="1212213"/>
                  <a:pt x="738545" y="1216459"/>
                  <a:pt x="741653" y="1218235"/>
                </a:cubicBezTo>
                <a:cubicBezTo>
                  <a:pt x="746048" y="1220747"/>
                  <a:pt x="751581" y="1220221"/>
                  <a:pt x="756545" y="1221214"/>
                </a:cubicBezTo>
                <a:cubicBezTo>
                  <a:pt x="758531" y="1224192"/>
                  <a:pt x="761245" y="1226797"/>
                  <a:pt x="762502" y="1230149"/>
                </a:cubicBezTo>
                <a:cubicBezTo>
                  <a:pt x="765719" y="1238727"/>
                  <a:pt x="767631" y="1266879"/>
                  <a:pt x="768459" y="1271848"/>
                </a:cubicBezTo>
                <a:cubicBezTo>
                  <a:pt x="768975" y="1274945"/>
                  <a:pt x="770445" y="1277805"/>
                  <a:pt x="771438" y="1280784"/>
                </a:cubicBezTo>
                <a:cubicBezTo>
                  <a:pt x="781495" y="1341135"/>
                  <a:pt x="766219" y="1255197"/>
                  <a:pt x="780373" y="1316526"/>
                </a:cubicBezTo>
                <a:cubicBezTo>
                  <a:pt x="787138" y="1345838"/>
                  <a:pt x="777786" y="1329025"/>
                  <a:pt x="789309" y="1346311"/>
                </a:cubicBezTo>
                <a:cubicBezTo>
                  <a:pt x="790302" y="1349289"/>
                  <a:pt x="790067" y="1353026"/>
                  <a:pt x="792287" y="1355246"/>
                </a:cubicBezTo>
                <a:cubicBezTo>
                  <a:pt x="793907" y="1356866"/>
                  <a:pt x="809254" y="1363858"/>
                  <a:pt x="813137" y="1364182"/>
                </a:cubicBezTo>
                <a:cubicBezTo>
                  <a:pt x="833938" y="1365915"/>
                  <a:pt x="854841" y="1366063"/>
                  <a:pt x="875685" y="1367160"/>
                </a:cubicBezTo>
                <a:lnTo>
                  <a:pt x="926320" y="1370139"/>
                </a:lnTo>
                <a:cubicBezTo>
                  <a:pt x="946177" y="1369146"/>
                  <a:pt x="966083" y="1368882"/>
                  <a:pt x="985890" y="1367160"/>
                </a:cubicBezTo>
                <a:cubicBezTo>
                  <a:pt x="989018" y="1366888"/>
                  <a:pt x="992374" y="1366143"/>
                  <a:pt x="994825" y="1364182"/>
                </a:cubicBezTo>
                <a:cubicBezTo>
                  <a:pt x="1003485" y="1357254"/>
                  <a:pt x="1001018" y="1345956"/>
                  <a:pt x="1006739" y="1337375"/>
                </a:cubicBezTo>
                <a:lnTo>
                  <a:pt x="1012696" y="1328440"/>
                </a:lnTo>
                <a:cubicBezTo>
                  <a:pt x="997190" y="1266404"/>
                  <a:pt x="1012696" y="1332854"/>
                  <a:pt x="1012696" y="1164622"/>
                </a:cubicBezTo>
                <a:cubicBezTo>
                  <a:pt x="1012696" y="1148706"/>
                  <a:pt x="1011159" y="1132817"/>
                  <a:pt x="1009718" y="1116966"/>
                </a:cubicBezTo>
                <a:cubicBezTo>
                  <a:pt x="1009171" y="1110952"/>
                  <a:pt x="1008204" y="1104954"/>
                  <a:pt x="1006739" y="1099095"/>
                </a:cubicBezTo>
                <a:cubicBezTo>
                  <a:pt x="1005216" y="1093003"/>
                  <a:pt x="1000782" y="1081224"/>
                  <a:pt x="1000782" y="1081224"/>
                </a:cubicBezTo>
                <a:cubicBezTo>
                  <a:pt x="1001775" y="1074274"/>
                  <a:pt x="1002853" y="1067336"/>
                  <a:pt x="1003761" y="1060375"/>
                </a:cubicBezTo>
                <a:cubicBezTo>
                  <a:pt x="1005832" y="1044501"/>
                  <a:pt x="1006579" y="1028417"/>
                  <a:pt x="1009718" y="1012719"/>
                </a:cubicBezTo>
                <a:lnTo>
                  <a:pt x="1012696" y="997826"/>
                </a:lnTo>
                <a:cubicBezTo>
                  <a:pt x="1011703" y="970027"/>
                  <a:pt x="1011401" y="942194"/>
                  <a:pt x="1009718" y="914428"/>
                </a:cubicBezTo>
                <a:cubicBezTo>
                  <a:pt x="1009412" y="909375"/>
                  <a:pt x="1007837" y="904478"/>
                  <a:pt x="1006739" y="899536"/>
                </a:cubicBezTo>
                <a:cubicBezTo>
                  <a:pt x="1006407" y="898043"/>
                  <a:pt x="1002442" y="881176"/>
                  <a:pt x="1000782" y="878686"/>
                </a:cubicBezTo>
                <a:cubicBezTo>
                  <a:pt x="998446" y="875181"/>
                  <a:pt x="995172" y="872337"/>
                  <a:pt x="991847" y="869751"/>
                </a:cubicBezTo>
                <a:cubicBezTo>
                  <a:pt x="986196" y="865356"/>
                  <a:pt x="979933" y="861808"/>
                  <a:pt x="973976" y="857837"/>
                </a:cubicBezTo>
                <a:cubicBezTo>
                  <a:pt x="970997" y="855851"/>
                  <a:pt x="967571" y="854411"/>
                  <a:pt x="965040" y="851880"/>
                </a:cubicBezTo>
                <a:cubicBezTo>
                  <a:pt x="962062" y="848901"/>
                  <a:pt x="959341" y="845641"/>
                  <a:pt x="956105" y="842944"/>
                </a:cubicBezTo>
                <a:cubicBezTo>
                  <a:pt x="951324" y="838960"/>
                  <a:pt x="944631" y="834862"/>
                  <a:pt x="938234" y="834009"/>
                </a:cubicBezTo>
                <a:cubicBezTo>
                  <a:pt x="926384" y="832429"/>
                  <a:pt x="914388" y="832220"/>
                  <a:pt x="902492" y="831030"/>
                </a:cubicBezTo>
                <a:cubicBezTo>
                  <a:pt x="894527" y="830234"/>
                  <a:pt x="886607" y="829045"/>
                  <a:pt x="878664" y="828052"/>
                </a:cubicBezTo>
                <a:cubicBezTo>
                  <a:pt x="875685" y="827059"/>
                  <a:pt x="872747" y="825936"/>
                  <a:pt x="869728" y="825073"/>
                </a:cubicBezTo>
                <a:cubicBezTo>
                  <a:pt x="865266" y="823798"/>
                  <a:pt x="853646" y="821499"/>
                  <a:pt x="848879" y="819116"/>
                </a:cubicBezTo>
                <a:cubicBezTo>
                  <a:pt x="825792" y="807572"/>
                  <a:pt x="853459" y="817664"/>
                  <a:pt x="831008" y="810181"/>
                </a:cubicBezTo>
                <a:cubicBezTo>
                  <a:pt x="828029" y="808195"/>
                  <a:pt x="825274" y="805825"/>
                  <a:pt x="822072" y="804224"/>
                </a:cubicBezTo>
                <a:cubicBezTo>
                  <a:pt x="819264" y="802820"/>
                  <a:pt x="815749" y="802986"/>
                  <a:pt x="813137" y="801245"/>
                </a:cubicBezTo>
                <a:cubicBezTo>
                  <a:pt x="809632" y="798908"/>
                  <a:pt x="807706" y="794647"/>
                  <a:pt x="804201" y="792310"/>
                </a:cubicBezTo>
                <a:cubicBezTo>
                  <a:pt x="801589" y="790569"/>
                  <a:pt x="798010" y="790856"/>
                  <a:pt x="795266" y="789331"/>
                </a:cubicBezTo>
                <a:cubicBezTo>
                  <a:pt x="789008" y="785854"/>
                  <a:pt x="777395" y="777417"/>
                  <a:pt x="777395" y="777417"/>
                </a:cubicBezTo>
                <a:cubicBezTo>
                  <a:pt x="772151" y="761690"/>
                  <a:pt x="776158" y="771095"/>
                  <a:pt x="762502" y="750611"/>
                </a:cubicBezTo>
                <a:lnTo>
                  <a:pt x="756545" y="741675"/>
                </a:lnTo>
                <a:lnTo>
                  <a:pt x="750588" y="732740"/>
                </a:lnTo>
                <a:lnTo>
                  <a:pt x="741653" y="705933"/>
                </a:lnTo>
                <a:cubicBezTo>
                  <a:pt x="740660" y="702955"/>
                  <a:pt x="740415" y="699610"/>
                  <a:pt x="738674" y="696998"/>
                </a:cubicBezTo>
                <a:lnTo>
                  <a:pt x="732717" y="688062"/>
                </a:lnTo>
                <a:cubicBezTo>
                  <a:pt x="721859" y="655484"/>
                  <a:pt x="739175" y="704827"/>
                  <a:pt x="723782" y="670191"/>
                </a:cubicBezTo>
                <a:cubicBezTo>
                  <a:pt x="721232" y="664453"/>
                  <a:pt x="719811" y="658277"/>
                  <a:pt x="717825" y="652320"/>
                </a:cubicBezTo>
                <a:lnTo>
                  <a:pt x="711868" y="634449"/>
                </a:lnTo>
                <a:cubicBezTo>
                  <a:pt x="710915" y="630636"/>
                  <a:pt x="708046" y="617870"/>
                  <a:pt x="705911" y="613600"/>
                </a:cubicBezTo>
                <a:cubicBezTo>
                  <a:pt x="704310" y="610398"/>
                  <a:pt x="701940" y="607643"/>
                  <a:pt x="699954" y="604664"/>
                </a:cubicBezTo>
                <a:cubicBezTo>
                  <a:pt x="698961" y="571900"/>
                  <a:pt x="698793" y="539101"/>
                  <a:pt x="696975" y="506373"/>
                </a:cubicBezTo>
                <a:cubicBezTo>
                  <a:pt x="696801" y="503238"/>
                  <a:pt x="694678" y="500503"/>
                  <a:pt x="693997" y="497438"/>
                </a:cubicBezTo>
                <a:cubicBezTo>
                  <a:pt x="692687" y="491543"/>
                  <a:pt x="692328" y="485462"/>
                  <a:pt x="691018" y="479567"/>
                </a:cubicBezTo>
                <a:cubicBezTo>
                  <a:pt x="690337" y="476502"/>
                  <a:pt x="688801" y="473677"/>
                  <a:pt x="688040" y="470631"/>
                </a:cubicBezTo>
                <a:cubicBezTo>
                  <a:pt x="679621" y="436953"/>
                  <a:pt x="691882" y="476206"/>
                  <a:pt x="679104" y="437868"/>
                </a:cubicBezTo>
                <a:lnTo>
                  <a:pt x="676126" y="428932"/>
                </a:lnTo>
                <a:cubicBezTo>
                  <a:pt x="675133" y="419004"/>
                  <a:pt x="674664" y="409009"/>
                  <a:pt x="673147" y="399147"/>
                </a:cubicBezTo>
                <a:cubicBezTo>
                  <a:pt x="672670" y="396044"/>
                  <a:pt x="671910" y="392824"/>
                  <a:pt x="670169" y="390212"/>
                </a:cubicBezTo>
                <a:cubicBezTo>
                  <a:pt x="667832" y="386707"/>
                  <a:pt x="664212" y="384255"/>
                  <a:pt x="661233" y="381276"/>
                </a:cubicBezTo>
                <a:cubicBezTo>
                  <a:pt x="659247" y="375319"/>
                  <a:pt x="660501" y="366888"/>
                  <a:pt x="655276" y="363405"/>
                </a:cubicBezTo>
                <a:cubicBezTo>
                  <a:pt x="652298" y="361419"/>
                  <a:pt x="649002" y="359843"/>
                  <a:pt x="646341" y="357448"/>
                </a:cubicBezTo>
                <a:cubicBezTo>
                  <a:pt x="639035" y="350873"/>
                  <a:pt x="634617" y="340249"/>
                  <a:pt x="625491" y="336599"/>
                </a:cubicBezTo>
                <a:cubicBezTo>
                  <a:pt x="587232" y="321295"/>
                  <a:pt x="634666" y="341186"/>
                  <a:pt x="595706" y="321706"/>
                </a:cubicBezTo>
                <a:cubicBezTo>
                  <a:pt x="592898" y="320302"/>
                  <a:pt x="589657" y="319965"/>
                  <a:pt x="586771" y="318728"/>
                </a:cubicBezTo>
                <a:cubicBezTo>
                  <a:pt x="582690" y="316979"/>
                  <a:pt x="578712" y="314974"/>
                  <a:pt x="574857" y="312771"/>
                </a:cubicBezTo>
                <a:cubicBezTo>
                  <a:pt x="571749" y="310995"/>
                  <a:pt x="569245" y="308144"/>
                  <a:pt x="565921" y="306814"/>
                </a:cubicBezTo>
                <a:cubicBezTo>
                  <a:pt x="559210" y="304130"/>
                  <a:pt x="552022" y="302843"/>
                  <a:pt x="545072" y="300857"/>
                </a:cubicBezTo>
                <a:cubicBezTo>
                  <a:pt x="544079" y="297878"/>
                  <a:pt x="544021" y="294399"/>
                  <a:pt x="542093" y="291921"/>
                </a:cubicBezTo>
                <a:cubicBezTo>
                  <a:pt x="528029" y="273839"/>
                  <a:pt x="529968" y="275965"/>
                  <a:pt x="515287" y="271072"/>
                </a:cubicBezTo>
                <a:lnTo>
                  <a:pt x="497416" y="244265"/>
                </a:lnTo>
                <a:lnTo>
                  <a:pt x="491459" y="235330"/>
                </a:lnTo>
                <a:cubicBezTo>
                  <a:pt x="489473" y="232351"/>
                  <a:pt x="488033" y="228925"/>
                  <a:pt x="485502" y="226394"/>
                </a:cubicBezTo>
                <a:lnTo>
                  <a:pt x="467631" y="208523"/>
                </a:lnTo>
                <a:cubicBezTo>
                  <a:pt x="462396" y="192821"/>
                  <a:pt x="468111" y="205526"/>
                  <a:pt x="455717" y="190652"/>
                </a:cubicBezTo>
                <a:cubicBezTo>
                  <a:pt x="453425" y="187902"/>
                  <a:pt x="452052" y="184467"/>
                  <a:pt x="449760" y="181717"/>
                </a:cubicBezTo>
                <a:cubicBezTo>
                  <a:pt x="447063" y="178481"/>
                  <a:pt x="443521" y="176017"/>
                  <a:pt x="440824" y="172781"/>
                </a:cubicBezTo>
                <a:cubicBezTo>
                  <a:pt x="438532" y="170031"/>
                  <a:pt x="437398" y="166377"/>
                  <a:pt x="434867" y="163846"/>
                </a:cubicBezTo>
                <a:cubicBezTo>
                  <a:pt x="431357" y="160336"/>
                  <a:pt x="426924" y="157889"/>
                  <a:pt x="422953" y="154910"/>
                </a:cubicBezTo>
                <a:cubicBezTo>
                  <a:pt x="420967" y="149946"/>
                  <a:pt x="419830" y="144552"/>
                  <a:pt x="416996" y="140018"/>
                </a:cubicBezTo>
                <a:cubicBezTo>
                  <a:pt x="405981" y="122394"/>
                  <a:pt x="405328" y="140749"/>
                  <a:pt x="396147" y="113211"/>
                </a:cubicBezTo>
                <a:cubicBezTo>
                  <a:pt x="395154" y="110233"/>
                  <a:pt x="394031" y="107295"/>
                  <a:pt x="393168" y="104276"/>
                </a:cubicBezTo>
                <a:cubicBezTo>
                  <a:pt x="385685" y="78088"/>
                  <a:pt x="394356" y="104858"/>
                  <a:pt x="387211" y="83426"/>
                </a:cubicBezTo>
                <a:cubicBezTo>
                  <a:pt x="386218" y="73498"/>
                  <a:pt x="385029" y="63587"/>
                  <a:pt x="384233" y="53641"/>
                </a:cubicBezTo>
                <a:cubicBezTo>
                  <a:pt x="383043" y="38763"/>
                  <a:pt x="389325" y="21519"/>
                  <a:pt x="381254" y="8964"/>
                </a:cubicBezTo>
                <a:cubicBezTo>
                  <a:pt x="376925" y="2231"/>
                  <a:pt x="365369" y="10949"/>
                  <a:pt x="357426" y="11942"/>
                </a:cubicBezTo>
                <a:cubicBezTo>
                  <a:pt x="353209" y="13348"/>
                  <a:pt x="340321" y="17899"/>
                  <a:pt x="336577" y="17899"/>
                </a:cubicBezTo>
                <a:cubicBezTo>
                  <a:pt x="318678" y="17899"/>
                  <a:pt x="300825" y="16073"/>
                  <a:pt x="282964" y="14921"/>
                </a:cubicBezTo>
                <a:cubicBezTo>
                  <a:pt x="270046" y="14088"/>
                  <a:pt x="257132" y="13150"/>
                  <a:pt x="244243" y="11942"/>
                </a:cubicBezTo>
                <a:cubicBezTo>
                  <a:pt x="176271" y="5569"/>
                  <a:pt x="164816" y="-468"/>
                  <a:pt x="145952" y="28"/>
                </a:cubicBezTo>
                <a:close/>
              </a:path>
            </a:pathLst>
          </a:custGeom>
          <a:noFill/>
          <a:ln w="9525">
            <a:solidFill>
              <a:srgbClr val="FFFF0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38" name="Figura a mano libera 37"/>
          <p:cNvSpPr/>
          <p:nvPr/>
        </p:nvSpPr>
        <p:spPr>
          <a:xfrm>
            <a:off x="2151397" y="2192149"/>
            <a:ext cx="1012696" cy="1370139"/>
          </a:xfrm>
          <a:custGeom>
            <a:avLst/>
            <a:gdLst>
              <a:gd name="connsiteX0" fmla="*/ 145952 w 1012696"/>
              <a:gd name="connsiteY0" fmla="*/ 28 h 1370139"/>
              <a:gd name="connsiteX1" fmla="*/ 131060 w 1012696"/>
              <a:gd name="connsiteY1" fmla="*/ 14921 h 1370139"/>
              <a:gd name="connsiteX2" fmla="*/ 122124 w 1012696"/>
              <a:gd name="connsiteY2" fmla="*/ 20878 h 1370139"/>
              <a:gd name="connsiteX3" fmla="*/ 116167 w 1012696"/>
              <a:gd name="connsiteY3" fmla="*/ 29813 h 1370139"/>
              <a:gd name="connsiteX4" fmla="*/ 86382 w 1012696"/>
              <a:gd name="connsiteY4" fmla="*/ 47684 h 1370139"/>
              <a:gd name="connsiteX5" fmla="*/ 77447 w 1012696"/>
              <a:gd name="connsiteY5" fmla="*/ 53641 h 1370139"/>
              <a:gd name="connsiteX6" fmla="*/ 68511 w 1012696"/>
              <a:gd name="connsiteY6" fmla="*/ 56620 h 1370139"/>
              <a:gd name="connsiteX7" fmla="*/ 59576 w 1012696"/>
              <a:gd name="connsiteY7" fmla="*/ 62577 h 1370139"/>
              <a:gd name="connsiteX8" fmla="*/ 47662 w 1012696"/>
              <a:gd name="connsiteY8" fmla="*/ 71512 h 1370139"/>
              <a:gd name="connsiteX9" fmla="*/ 35748 w 1012696"/>
              <a:gd name="connsiteY9" fmla="*/ 74491 h 1370139"/>
              <a:gd name="connsiteX10" fmla="*/ 29791 w 1012696"/>
              <a:gd name="connsiteY10" fmla="*/ 83426 h 1370139"/>
              <a:gd name="connsiteX11" fmla="*/ 5963 w 1012696"/>
              <a:gd name="connsiteY11" fmla="*/ 95340 h 1370139"/>
              <a:gd name="connsiteX12" fmla="*/ 2984 w 1012696"/>
              <a:gd name="connsiteY12" fmla="*/ 128104 h 1370139"/>
              <a:gd name="connsiteX13" fmla="*/ 6 w 1012696"/>
              <a:gd name="connsiteY13" fmla="*/ 169803 h 1370139"/>
              <a:gd name="connsiteX14" fmla="*/ 14898 w 1012696"/>
              <a:gd name="connsiteY14" fmla="*/ 208523 h 1370139"/>
              <a:gd name="connsiteX15" fmla="*/ 14898 w 1012696"/>
              <a:gd name="connsiteY15" fmla="*/ 208523 h 1370139"/>
              <a:gd name="connsiteX16" fmla="*/ 23834 w 1012696"/>
              <a:gd name="connsiteY16" fmla="*/ 226394 h 1370139"/>
              <a:gd name="connsiteX17" fmla="*/ 32769 w 1012696"/>
              <a:gd name="connsiteY17" fmla="*/ 229373 h 1370139"/>
              <a:gd name="connsiteX18" fmla="*/ 50640 w 1012696"/>
              <a:gd name="connsiteY18" fmla="*/ 244265 h 1370139"/>
              <a:gd name="connsiteX19" fmla="*/ 59576 w 1012696"/>
              <a:gd name="connsiteY19" fmla="*/ 250222 h 1370139"/>
              <a:gd name="connsiteX20" fmla="*/ 62554 w 1012696"/>
              <a:gd name="connsiteY20" fmla="*/ 259158 h 1370139"/>
              <a:gd name="connsiteX21" fmla="*/ 80425 w 1012696"/>
              <a:gd name="connsiteY21" fmla="*/ 268093 h 1370139"/>
              <a:gd name="connsiteX22" fmla="*/ 89361 w 1012696"/>
              <a:gd name="connsiteY22" fmla="*/ 277029 h 1370139"/>
              <a:gd name="connsiteX23" fmla="*/ 98296 w 1012696"/>
              <a:gd name="connsiteY23" fmla="*/ 280007 h 1370139"/>
              <a:gd name="connsiteX24" fmla="*/ 101275 w 1012696"/>
              <a:gd name="connsiteY24" fmla="*/ 288943 h 1370139"/>
              <a:gd name="connsiteX25" fmla="*/ 116167 w 1012696"/>
              <a:gd name="connsiteY25" fmla="*/ 309792 h 1370139"/>
              <a:gd name="connsiteX26" fmla="*/ 128081 w 1012696"/>
              <a:gd name="connsiteY26" fmla="*/ 336599 h 1370139"/>
              <a:gd name="connsiteX27" fmla="*/ 137017 w 1012696"/>
              <a:gd name="connsiteY27" fmla="*/ 345534 h 1370139"/>
              <a:gd name="connsiteX28" fmla="*/ 145952 w 1012696"/>
              <a:gd name="connsiteY28" fmla="*/ 363405 h 1370139"/>
              <a:gd name="connsiteX29" fmla="*/ 154888 w 1012696"/>
              <a:gd name="connsiteY29" fmla="*/ 381276 h 1370139"/>
              <a:gd name="connsiteX30" fmla="*/ 163823 w 1012696"/>
              <a:gd name="connsiteY30" fmla="*/ 408083 h 1370139"/>
              <a:gd name="connsiteX31" fmla="*/ 166802 w 1012696"/>
              <a:gd name="connsiteY31" fmla="*/ 417018 h 1370139"/>
              <a:gd name="connsiteX32" fmla="*/ 172759 w 1012696"/>
              <a:gd name="connsiteY32" fmla="*/ 425954 h 1370139"/>
              <a:gd name="connsiteX33" fmla="*/ 178716 w 1012696"/>
              <a:gd name="connsiteY33" fmla="*/ 449782 h 1370139"/>
              <a:gd name="connsiteX34" fmla="*/ 190630 w 1012696"/>
              <a:gd name="connsiteY34" fmla="*/ 500416 h 1370139"/>
              <a:gd name="connsiteX35" fmla="*/ 193609 w 1012696"/>
              <a:gd name="connsiteY35" fmla="*/ 530201 h 1370139"/>
              <a:gd name="connsiteX36" fmla="*/ 199566 w 1012696"/>
              <a:gd name="connsiteY36" fmla="*/ 551051 h 1370139"/>
              <a:gd name="connsiteX37" fmla="*/ 202544 w 1012696"/>
              <a:gd name="connsiteY37" fmla="*/ 589772 h 1370139"/>
              <a:gd name="connsiteX38" fmla="*/ 205523 w 1012696"/>
              <a:gd name="connsiteY38" fmla="*/ 604664 h 1370139"/>
              <a:gd name="connsiteX39" fmla="*/ 208501 w 1012696"/>
              <a:gd name="connsiteY39" fmla="*/ 622535 h 1370139"/>
              <a:gd name="connsiteX40" fmla="*/ 214458 w 1012696"/>
              <a:gd name="connsiteY40" fmla="*/ 676148 h 1370139"/>
              <a:gd name="connsiteX41" fmla="*/ 220415 w 1012696"/>
              <a:gd name="connsiteY41" fmla="*/ 694019 h 1370139"/>
              <a:gd name="connsiteX42" fmla="*/ 223394 w 1012696"/>
              <a:gd name="connsiteY42" fmla="*/ 702955 h 1370139"/>
              <a:gd name="connsiteX43" fmla="*/ 235308 w 1012696"/>
              <a:gd name="connsiteY43" fmla="*/ 720826 h 1370139"/>
              <a:gd name="connsiteX44" fmla="*/ 247222 w 1012696"/>
              <a:gd name="connsiteY44" fmla="*/ 741675 h 1370139"/>
              <a:gd name="connsiteX45" fmla="*/ 253179 w 1012696"/>
              <a:gd name="connsiteY45" fmla="*/ 753589 h 1370139"/>
              <a:gd name="connsiteX46" fmla="*/ 262114 w 1012696"/>
              <a:gd name="connsiteY46" fmla="*/ 777417 h 1370139"/>
              <a:gd name="connsiteX47" fmla="*/ 265093 w 1012696"/>
              <a:gd name="connsiteY47" fmla="*/ 786353 h 1370139"/>
              <a:gd name="connsiteX48" fmla="*/ 271050 w 1012696"/>
              <a:gd name="connsiteY48" fmla="*/ 795288 h 1370139"/>
              <a:gd name="connsiteX49" fmla="*/ 277007 w 1012696"/>
              <a:gd name="connsiteY49" fmla="*/ 807202 h 1370139"/>
              <a:gd name="connsiteX50" fmla="*/ 285942 w 1012696"/>
              <a:gd name="connsiteY50" fmla="*/ 813159 h 1370139"/>
              <a:gd name="connsiteX51" fmla="*/ 288921 w 1012696"/>
              <a:gd name="connsiteY51" fmla="*/ 831030 h 1370139"/>
              <a:gd name="connsiteX52" fmla="*/ 300835 w 1012696"/>
              <a:gd name="connsiteY52" fmla="*/ 848901 h 1370139"/>
              <a:gd name="connsiteX53" fmla="*/ 327641 w 1012696"/>
              <a:gd name="connsiteY53" fmla="*/ 878686 h 1370139"/>
              <a:gd name="connsiteX54" fmla="*/ 345512 w 1012696"/>
              <a:gd name="connsiteY54" fmla="*/ 887622 h 1370139"/>
              <a:gd name="connsiteX55" fmla="*/ 354448 w 1012696"/>
              <a:gd name="connsiteY55" fmla="*/ 890600 h 1370139"/>
              <a:gd name="connsiteX56" fmla="*/ 363383 w 1012696"/>
              <a:gd name="connsiteY56" fmla="*/ 896557 h 1370139"/>
              <a:gd name="connsiteX57" fmla="*/ 375297 w 1012696"/>
              <a:gd name="connsiteY57" fmla="*/ 899536 h 1370139"/>
              <a:gd name="connsiteX58" fmla="*/ 425932 w 1012696"/>
              <a:gd name="connsiteY58" fmla="*/ 902514 h 1370139"/>
              <a:gd name="connsiteX59" fmla="*/ 446781 w 1012696"/>
              <a:gd name="connsiteY59" fmla="*/ 908471 h 1370139"/>
              <a:gd name="connsiteX60" fmla="*/ 455717 w 1012696"/>
              <a:gd name="connsiteY60" fmla="*/ 917407 h 1370139"/>
              <a:gd name="connsiteX61" fmla="*/ 464652 w 1012696"/>
              <a:gd name="connsiteY61" fmla="*/ 923364 h 1370139"/>
              <a:gd name="connsiteX62" fmla="*/ 476566 w 1012696"/>
              <a:gd name="connsiteY62" fmla="*/ 941235 h 1370139"/>
              <a:gd name="connsiteX63" fmla="*/ 485502 w 1012696"/>
              <a:gd name="connsiteY63" fmla="*/ 950170 h 1370139"/>
              <a:gd name="connsiteX64" fmla="*/ 506351 w 1012696"/>
              <a:gd name="connsiteY64" fmla="*/ 979955 h 1370139"/>
              <a:gd name="connsiteX65" fmla="*/ 524222 w 1012696"/>
              <a:gd name="connsiteY65" fmla="*/ 997826 h 1370139"/>
              <a:gd name="connsiteX66" fmla="*/ 533158 w 1012696"/>
              <a:gd name="connsiteY66" fmla="*/ 1006762 h 1370139"/>
              <a:gd name="connsiteX67" fmla="*/ 556986 w 1012696"/>
              <a:gd name="connsiteY67" fmla="*/ 1033568 h 1370139"/>
              <a:gd name="connsiteX68" fmla="*/ 565921 w 1012696"/>
              <a:gd name="connsiteY68" fmla="*/ 1042504 h 1370139"/>
              <a:gd name="connsiteX69" fmla="*/ 586771 w 1012696"/>
              <a:gd name="connsiteY69" fmla="*/ 1057396 h 1370139"/>
              <a:gd name="connsiteX70" fmla="*/ 595706 w 1012696"/>
              <a:gd name="connsiteY70" fmla="*/ 1066332 h 1370139"/>
              <a:gd name="connsiteX71" fmla="*/ 604642 w 1012696"/>
              <a:gd name="connsiteY71" fmla="*/ 1072289 h 1370139"/>
              <a:gd name="connsiteX72" fmla="*/ 631448 w 1012696"/>
              <a:gd name="connsiteY72" fmla="*/ 1096117 h 1370139"/>
              <a:gd name="connsiteX73" fmla="*/ 643362 w 1012696"/>
              <a:gd name="connsiteY73" fmla="*/ 1113988 h 1370139"/>
              <a:gd name="connsiteX74" fmla="*/ 658255 w 1012696"/>
              <a:gd name="connsiteY74" fmla="*/ 1140794 h 1370139"/>
              <a:gd name="connsiteX75" fmla="*/ 664212 w 1012696"/>
              <a:gd name="connsiteY75" fmla="*/ 1149730 h 1370139"/>
              <a:gd name="connsiteX76" fmla="*/ 673147 w 1012696"/>
              <a:gd name="connsiteY76" fmla="*/ 1155687 h 1370139"/>
              <a:gd name="connsiteX77" fmla="*/ 679104 w 1012696"/>
              <a:gd name="connsiteY77" fmla="*/ 1164622 h 1370139"/>
              <a:gd name="connsiteX78" fmla="*/ 696975 w 1012696"/>
              <a:gd name="connsiteY78" fmla="*/ 1173558 h 1370139"/>
              <a:gd name="connsiteX79" fmla="*/ 717825 w 1012696"/>
              <a:gd name="connsiteY79" fmla="*/ 1188450 h 1370139"/>
              <a:gd name="connsiteX80" fmla="*/ 735696 w 1012696"/>
              <a:gd name="connsiteY80" fmla="*/ 1209300 h 1370139"/>
              <a:gd name="connsiteX81" fmla="*/ 741653 w 1012696"/>
              <a:gd name="connsiteY81" fmla="*/ 1218235 h 1370139"/>
              <a:gd name="connsiteX82" fmla="*/ 756545 w 1012696"/>
              <a:gd name="connsiteY82" fmla="*/ 1221214 h 1370139"/>
              <a:gd name="connsiteX83" fmla="*/ 762502 w 1012696"/>
              <a:gd name="connsiteY83" fmla="*/ 1230149 h 1370139"/>
              <a:gd name="connsiteX84" fmla="*/ 768459 w 1012696"/>
              <a:gd name="connsiteY84" fmla="*/ 1271848 h 1370139"/>
              <a:gd name="connsiteX85" fmla="*/ 771438 w 1012696"/>
              <a:gd name="connsiteY85" fmla="*/ 1280784 h 1370139"/>
              <a:gd name="connsiteX86" fmla="*/ 780373 w 1012696"/>
              <a:gd name="connsiteY86" fmla="*/ 1316526 h 1370139"/>
              <a:gd name="connsiteX87" fmla="*/ 789309 w 1012696"/>
              <a:gd name="connsiteY87" fmla="*/ 1346311 h 1370139"/>
              <a:gd name="connsiteX88" fmla="*/ 792287 w 1012696"/>
              <a:gd name="connsiteY88" fmla="*/ 1355246 h 1370139"/>
              <a:gd name="connsiteX89" fmla="*/ 813137 w 1012696"/>
              <a:gd name="connsiteY89" fmla="*/ 1364182 h 1370139"/>
              <a:gd name="connsiteX90" fmla="*/ 875685 w 1012696"/>
              <a:gd name="connsiteY90" fmla="*/ 1367160 h 1370139"/>
              <a:gd name="connsiteX91" fmla="*/ 926320 w 1012696"/>
              <a:gd name="connsiteY91" fmla="*/ 1370139 h 1370139"/>
              <a:gd name="connsiteX92" fmla="*/ 985890 w 1012696"/>
              <a:gd name="connsiteY92" fmla="*/ 1367160 h 1370139"/>
              <a:gd name="connsiteX93" fmla="*/ 994825 w 1012696"/>
              <a:gd name="connsiteY93" fmla="*/ 1364182 h 1370139"/>
              <a:gd name="connsiteX94" fmla="*/ 1006739 w 1012696"/>
              <a:gd name="connsiteY94" fmla="*/ 1337375 h 1370139"/>
              <a:gd name="connsiteX95" fmla="*/ 1012696 w 1012696"/>
              <a:gd name="connsiteY95" fmla="*/ 1328440 h 1370139"/>
              <a:gd name="connsiteX96" fmla="*/ 1012696 w 1012696"/>
              <a:gd name="connsiteY96" fmla="*/ 1164622 h 1370139"/>
              <a:gd name="connsiteX97" fmla="*/ 1009718 w 1012696"/>
              <a:gd name="connsiteY97" fmla="*/ 1116966 h 1370139"/>
              <a:gd name="connsiteX98" fmla="*/ 1006739 w 1012696"/>
              <a:gd name="connsiteY98" fmla="*/ 1099095 h 1370139"/>
              <a:gd name="connsiteX99" fmla="*/ 1000782 w 1012696"/>
              <a:gd name="connsiteY99" fmla="*/ 1081224 h 1370139"/>
              <a:gd name="connsiteX100" fmla="*/ 1003761 w 1012696"/>
              <a:gd name="connsiteY100" fmla="*/ 1060375 h 1370139"/>
              <a:gd name="connsiteX101" fmla="*/ 1009718 w 1012696"/>
              <a:gd name="connsiteY101" fmla="*/ 1012719 h 1370139"/>
              <a:gd name="connsiteX102" fmla="*/ 1012696 w 1012696"/>
              <a:gd name="connsiteY102" fmla="*/ 997826 h 1370139"/>
              <a:gd name="connsiteX103" fmla="*/ 1009718 w 1012696"/>
              <a:gd name="connsiteY103" fmla="*/ 914428 h 1370139"/>
              <a:gd name="connsiteX104" fmla="*/ 1006739 w 1012696"/>
              <a:gd name="connsiteY104" fmla="*/ 899536 h 1370139"/>
              <a:gd name="connsiteX105" fmla="*/ 1000782 w 1012696"/>
              <a:gd name="connsiteY105" fmla="*/ 878686 h 1370139"/>
              <a:gd name="connsiteX106" fmla="*/ 991847 w 1012696"/>
              <a:gd name="connsiteY106" fmla="*/ 869751 h 1370139"/>
              <a:gd name="connsiteX107" fmla="*/ 973976 w 1012696"/>
              <a:gd name="connsiteY107" fmla="*/ 857837 h 1370139"/>
              <a:gd name="connsiteX108" fmla="*/ 965040 w 1012696"/>
              <a:gd name="connsiteY108" fmla="*/ 851880 h 1370139"/>
              <a:gd name="connsiteX109" fmla="*/ 956105 w 1012696"/>
              <a:gd name="connsiteY109" fmla="*/ 842944 h 1370139"/>
              <a:gd name="connsiteX110" fmla="*/ 938234 w 1012696"/>
              <a:gd name="connsiteY110" fmla="*/ 834009 h 1370139"/>
              <a:gd name="connsiteX111" fmla="*/ 902492 w 1012696"/>
              <a:gd name="connsiteY111" fmla="*/ 831030 h 1370139"/>
              <a:gd name="connsiteX112" fmla="*/ 878664 w 1012696"/>
              <a:gd name="connsiteY112" fmla="*/ 828052 h 1370139"/>
              <a:gd name="connsiteX113" fmla="*/ 869728 w 1012696"/>
              <a:gd name="connsiteY113" fmla="*/ 825073 h 1370139"/>
              <a:gd name="connsiteX114" fmla="*/ 848879 w 1012696"/>
              <a:gd name="connsiteY114" fmla="*/ 819116 h 1370139"/>
              <a:gd name="connsiteX115" fmla="*/ 831008 w 1012696"/>
              <a:gd name="connsiteY115" fmla="*/ 810181 h 1370139"/>
              <a:gd name="connsiteX116" fmla="*/ 822072 w 1012696"/>
              <a:gd name="connsiteY116" fmla="*/ 804224 h 1370139"/>
              <a:gd name="connsiteX117" fmla="*/ 813137 w 1012696"/>
              <a:gd name="connsiteY117" fmla="*/ 801245 h 1370139"/>
              <a:gd name="connsiteX118" fmla="*/ 804201 w 1012696"/>
              <a:gd name="connsiteY118" fmla="*/ 792310 h 1370139"/>
              <a:gd name="connsiteX119" fmla="*/ 795266 w 1012696"/>
              <a:gd name="connsiteY119" fmla="*/ 789331 h 1370139"/>
              <a:gd name="connsiteX120" fmla="*/ 777395 w 1012696"/>
              <a:gd name="connsiteY120" fmla="*/ 777417 h 1370139"/>
              <a:gd name="connsiteX121" fmla="*/ 762502 w 1012696"/>
              <a:gd name="connsiteY121" fmla="*/ 750611 h 1370139"/>
              <a:gd name="connsiteX122" fmla="*/ 756545 w 1012696"/>
              <a:gd name="connsiteY122" fmla="*/ 741675 h 1370139"/>
              <a:gd name="connsiteX123" fmla="*/ 750588 w 1012696"/>
              <a:gd name="connsiteY123" fmla="*/ 732740 h 1370139"/>
              <a:gd name="connsiteX124" fmla="*/ 741653 w 1012696"/>
              <a:gd name="connsiteY124" fmla="*/ 705933 h 1370139"/>
              <a:gd name="connsiteX125" fmla="*/ 738674 w 1012696"/>
              <a:gd name="connsiteY125" fmla="*/ 696998 h 1370139"/>
              <a:gd name="connsiteX126" fmla="*/ 732717 w 1012696"/>
              <a:gd name="connsiteY126" fmla="*/ 688062 h 1370139"/>
              <a:gd name="connsiteX127" fmla="*/ 723782 w 1012696"/>
              <a:gd name="connsiteY127" fmla="*/ 670191 h 1370139"/>
              <a:gd name="connsiteX128" fmla="*/ 717825 w 1012696"/>
              <a:gd name="connsiteY128" fmla="*/ 652320 h 1370139"/>
              <a:gd name="connsiteX129" fmla="*/ 711868 w 1012696"/>
              <a:gd name="connsiteY129" fmla="*/ 634449 h 1370139"/>
              <a:gd name="connsiteX130" fmla="*/ 705911 w 1012696"/>
              <a:gd name="connsiteY130" fmla="*/ 613600 h 1370139"/>
              <a:gd name="connsiteX131" fmla="*/ 699954 w 1012696"/>
              <a:gd name="connsiteY131" fmla="*/ 604664 h 1370139"/>
              <a:gd name="connsiteX132" fmla="*/ 696975 w 1012696"/>
              <a:gd name="connsiteY132" fmla="*/ 506373 h 1370139"/>
              <a:gd name="connsiteX133" fmla="*/ 693997 w 1012696"/>
              <a:gd name="connsiteY133" fmla="*/ 497438 h 1370139"/>
              <a:gd name="connsiteX134" fmla="*/ 691018 w 1012696"/>
              <a:gd name="connsiteY134" fmla="*/ 479567 h 1370139"/>
              <a:gd name="connsiteX135" fmla="*/ 688040 w 1012696"/>
              <a:gd name="connsiteY135" fmla="*/ 470631 h 1370139"/>
              <a:gd name="connsiteX136" fmla="*/ 679104 w 1012696"/>
              <a:gd name="connsiteY136" fmla="*/ 437868 h 1370139"/>
              <a:gd name="connsiteX137" fmla="*/ 676126 w 1012696"/>
              <a:gd name="connsiteY137" fmla="*/ 428932 h 1370139"/>
              <a:gd name="connsiteX138" fmla="*/ 673147 w 1012696"/>
              <a:gd name="connsiteY138" fmla="*/ 399147 h 1370139"/>
              <a:gd name="connsiteX139" fmla="*/ 670169 w 1012696"/>
              <a:gd name="connsiteY139" fmla="*/ 390212 h 1370139"/>
              <a:gd name="connsiteX140" fmla="*/ 661233 w 1012696"/>
              <a:gd name="connsiteY140" fmla="*/ 381276 h 1370139"/>
              <a:gd name="connsiteX141" fmla="*/ 655276 w 1012696"/>
              <a:gd name="connsiteY141" fmla="*/ 363405 h 1370139"/>
              <a:gd name="connsiteX142" fmla="*/ 646341 w 1012696"/>
              <a:gd name="connsiteY142" fmla="*/ 357448 h 1370139"/>
              <a:gd name="connsiteX143" fmla="*/ 625491 w 1012696"/>
              <a:gd name="connsiteY143" fmla="*/ 336599 h 1370139"/>
              <a:gd name="connsiteX144" fmla="*/ 595706 w 1012696"/>
              <a:gd name="connsiteY144" fmla="*/ 321706 h 1370139"/>
              <a:gd name="connsiteX145" fmla="*/ 586771 w 1012696"/>
              <a:gd name="connsiteY145" fmla="*/ 318728 h 1370139"/>
              <a:gd name="connsiteX146" fmla="*/ 574857 w 1012696"/>
              <a:gd name="connsiteY146" fmla="*/ 312771 h 1370139"/>
              <a:gd name="connsiteX147" fmla="*/ 565921 w 1012696"/>
              <a:gd name="connsiteY147" fmla="*/ 306814 h 1370139"/>
              <a:gd name="connsiteX148" fmla="*/ 545072 w 1012696"/>
              <a:gd name="connsiteY148" fmla="*/ 300857 h 1370139"/>
              <a:gd name="connsiteX149" fmla="*/ 542093 w 1012696"/>
              <a:gd name="connsiteY149" fmla="*/ 291921 h 1370139"/>
              <a:gd name="connsiteX150" fmla="*/ 515287 w 1012696"/>
              <a:gd name="connsiteY150" fmla="*/ 271072 h 1370139"/>
              <a:gd name="connsiteX151" fmla="*/ 497416 w 1012696"/>
              <a:gd name="connsiteY151" fmla="*/ 244265 h 1370139"/>
              <a:gd name="connsiteX152" fmla="*/ 491459 w 1012696"/>
              <a:gd name="connsiteY152" fmla="*/ 235330 h 1370139"/>
              <a:gd name="connsiteX153" fmla="*/ 485502 w 1012696"/>
              <a:gd name="connsiteY153" fmla="*/ 226394 h 1370139"/>
              <a:gd name="connsiteX154" fmla="*/ 467631 w 1012696"/>
              <a:gd name="connsiteY154" fmla="*/ 208523 h 1370139"/>
              <a:gd name="connsiteX155" fmla="*/ 455717 w 1012696"/>
              <a:gd name="connsiteY155" fmla="*/ 190652 h 1370139"/>
              <a:gd name="connsiteX156" fmla="*/ 449760 w 1012696"/>
              <a:gd name="connsiteY156" fmla="*/ 181717 h 1370139"/>
              <a:gd name="connsiteX157" fmla="*/ 440824 w 1012696"/>
              <a:gd name="connsiteY157" fmla="*/ 172781 h 1370139"/>
              <a:gd name="connsiteX158" fmla="*/ 434867 w 1012696"/>
              <a:gd name="connsiteY158" fmla="*/ 163846 h 1370139"/>
              <a:gd name="connsiteX159" fmla="*/ 422953 w 1012696"/>
              <a:gd name="connsiteY159" fmla="*/ 154910 h 1370139"/>
              <a:gd name="connsiteX160" fmla="*/ 416996 w 1012696"/>
              <a:gd name="connsiteY160" fmla="*/ 140018 h 1370139"/>
              <a:gd name="connsiteX161" fmla="*/ 396147 w 1012696"/>
              <a:gd name="connsiteY161" fmla="*/ 113211 h 1370139"/>
              <a:gd name="connsiteX162" fmla="*/ 393168 w 1012696"/>
              <a:gd name="connsiteY162" fmla="*/ 104276 h 1370139"/>
              <a:gd name="connsiteX163" fmla="*/ 387211 w 1012696"/>
              <a:gd name="connsiteY163" fmla="*/ 83426 h 1370139"/>
              <a:gd name="connsiteX164" fmla="*/ 384233 w 1012696"/>
              <a:gd name="connsiteY164" fmla="*/ 53641 h 1370139"/>
              <a:gd name="connsiteX165" fmla="*/ 381254 w 1012696"/>
              <a:gd name="connsiteY165" fmla="*/ 8964 h 1370139"/>
              <a:gd name="connsiteX166" fmla="*/ 357426 w 1012696"/>
              <a:gd name="connsiteY166" fmla="*/ 11942 h 1370139"/>
              <a:gd name="connsiteX167" fmla="*/ 336577 w 1012696"/>
              <a:gd name="connsiteY167" fmla="*/ 17899 h 1370139"/>
              <a:gd name="connsiteX168" fmla="*/ 282964 w 1012696"/>
              <a:gd name="connsiteY168" fmla="*/ 14921 h 1370139"/>
              <a:gd name="connsiteX169" fmla="*/ 244243 w 1012696"/>
              <a:gd name="connsiteY169" fmla="*/ 11942 h 1370139"/>
              <a:gd name="connsiteX170" fmla="*/ 145952 w 1012696"/>
              <a:gd name="connsiteY170" fmla="*/ 28 h 137013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 ang="0">
                <a:pos x="connsiteX136" y="connsiteY136"/>
              </a:cxn>
              <a:cxn ang="0">
                <a:pos x="connsiteX137" y="connsiteY137"/>
              </a:cxn>
              <a:cxn ang="0">
                <a:pos x="connsiteX138" y="connsiteY138"/>
              </a:cxn>
              <a:cxn ang="0">
                <a:pos x="connsiteX139" y="connsiteY139"/>
              </a:cxn>
              <a:cxn ang="0">
                <a:pos x="connsiteX140" y="connsiteY140"/>
              </a:cxn>
              <a:cxn ang="0">
                <a:pos x="connsiteX141" y="connsiteY141"/>
              </a:cxn>
              <a:cxn ang="0">
                <a:pos x="connsiteX142" y="connsiteY142"/>
              </a:cxn>
              <a:cxn ang="0">
                <a:pos x="connsiteX143" y="connsiteY143"/>
              </a:cxn>
              <a:cxn ang="0">
                <a:pos x="connsiteX144" y="connsiteY144"/>
              </a:cxn>
              <a:cxn ang="0">
                <a:pos x="connsiteX145" y="connsiteY145"/>
              </a:cxn>
              <a:cxn ang="0">
                <a:pos x="connsiteX146" y="connsiteY146"/>
              </a:cxn>
              <a:cxn ang="0">
                <a:pos x="connsiteX147" y="connsiteY147"/>
              </a:cxn>
              <a:cxn ang="0">
                <a:pos x="connsiteX148" y="connsiteY148"/>
              </a:cxn>
              <a:cxn ang="0">
                <a:pos x="connsiteX149" y="connsiteY149"/>
              </a:cxn>
              <a:cxn ang="0">
                <a:pos x="connsiteX150" y="connsiteY150"/>
              </a:cxn>
              <a:cxn ang="0">
                <a:pos x="connsiteX151" y="connsiteY151"/>
              </a:cxn>
              <a:cxn ang="0">
                <a:pos x="connsiteX152" y="connsiteY152"/>
              </a:cxn>
              <a:cxn ang="0">
                <a:pos x="connsiteX153" y="connsiteY153"/>
              </a:cxn>
              <a:cxn ang="0">
                <a:pos x="connsiteX154" y="connsiteY154"/>
              </a:cxn>
              <a:cxn ang="0">
                <a:pos x="connsiteX155" y="connsiteY155"/>
              </a:cxn>
              <a:cxn ang="0">
                <a:pos x="connsiteX156" y="connsiteY156"/>
              </a:cxn>
              <a:cxn ang="0">
                <a:pos x="connsiteX157" y="connsiteY157"/>
              </a:cxn>
              <a:cxn ang="0">
                <a:pos x="connsiteX158" y="connsiteY158"/>
              </a:cxn>
              <a:cxn ang="0">
                <a:pos x="connsiteX159" y="connsiteY159"/>
              </a:cxn>
              <a:cxn ang="0">
                <a:pos x="connsiteX160" y="connsiteY160"/>
              </a:cxn>
              <a:cxn ang="0">
                <a:pos x="connsiteX161" y="connsiteY161"/>
              </a:cxn>
              <a:cxn ang="0">
                <a:pos x="connsiteX162" y="connsiteY162"/>
              </a:cxn>
              <a:cxn ang="0">
                <a:pos x="connsiteX163" y="connsiteY163"/>
              </a:cxn>
              <a:cxn ang="0">
                <a:pos x="connsiteX164" y="connsiteY164"/>
              </a:cxn>
              <a:cxn ang="0">
                <a:pos x="connsiteX165" y="connsiteY165"/>
              </a:cxn>
              <a:cxn ang="0">
                <a:pos x="connsiteX166" y="connsiteY166"/>
              </a:cxn>
              <a:cxn ang="0">
                <a:pos x="connsiteX167" y="connsiteY167"/>
              </a:cxn>
              <a:cxn ang="0">
                <a:pos x="connsiteX168" y="connsiteY168"/>
              </a:cxn>
              <a:cxn ang="0">
                <a:pos x="connsiteX169" y="connsiteY169"/>
              </a:cxn>
              <a:cxn ang="0">
                <a:pos x="connsiteX170" y="connsiteY170"/>
              </a:cxn>
            </a:cxnLst>
            <a:rect l="l" t="t" r="r" b="b"/>
            <a:pathLst>
              <a:path w="1012696" h="1370139">
                <a:moveTo>
                  <a:pt x="145952" y="28"/>
                </a:moveTo>
                <a:cubicBezTo>
                  <a:pt x="127088" y="524"/>
                  <a:pt x="136343" y="10298"/>
                  <a:pt x="131060" y="14921"/>
                </a:cubicBezTo>
                <a:cubicBezTo>
                  <a:pt x="128366" y="17278"/>
                  <a:pt x="124655" y="18347"/>
                  <a:pt x="122124" y="20878"/>
                </a:cubicBezTo>
                <a:cubicBezTo>
                  <a:pt x="119593" y="23409"/>
                  <a:pt x="118861" y="27456"/>
                  <a:pt x="116167" y="29813"/>
                </a:cubicBezTo>
                <a:cubicBezTo>
                  <a:pt x="102450" y="41815"/>
                  <a:pt x="99832" y="39998"/>
                  <a:pt x="86382" y="47684"/>
                </a:cubicBezTo>
                <a:cubicBezTo>
                  <a:pt x="83274" y="49460"/>
                  <a:pt x="80649" y="52040"/>
                  <a:pt x="77447" y="53641"/>
                </a:cubicBezTo>
                <a:cubicBezTo>
                  <a:pt x="74639" y="55045"/>
                  <a:pt x="71319" y="55216"/>
                  <a:pt x="68511" y="56620"/>
                </a:cubicBezTo>
                <a:cubicBezTo>
                  <a:pt x="65309" y="58221"/>
                  <a:pt x="62489" y="60496"/>
                  <a:pt x="59576" y="62577"/>
                </a:cubicBezTo>
                <a:cubicBezTo>
                  <a:pt x="55537" y="65462"/>
                  <a:pt x="52102" y="69292"/>
                  <a:pt x="47662" y="71512"/>
                </a:cubicBezTo>
                <a:cubicBezTo>
                  <a:pt x="44001" y="73343"/>
                  <a:pt x="39719" y="73498"/>
                  <a:pt x="35748" y="74491"/>
                </a:cubicBezTo>
                <a:cubicBezTo>
                  <a:pt x="33762" y="77469"/>
                  <a:pt x="32322" y="80895"/>
                  <a:pt x="29791" y="83426"/>
                </a:cubicBezTo>
                <a:cubicBezTo>
                  <a:pt x="23843" y="89374"/>
                  <a:pt x="13073" y="92496"/>
                  <a:pt x="5963" y="95340"/>
                </a:cubicBezTo>
                <a:cubicBezTo>
                  <a:pt x="-5414" y="118094"/>
                  <a:pt x="2984" y="95647"/>
                  <a:pt x="2984" y="128104"/>
                </a:cubicBezTo>
                <a:cubicBezTo>
                  <a:pt x="2984" y="142039"/>
                  <a:pt x="999" y="155903"/>
                  <a:pt x="6" y="169803"/>
                </a:cubicBezTo>
                <a:cubicBezTo>
                  <a:pt x="3996" y="197739"/>
                  <a:pt x="-910" y="184811"/>
                  <a:pt x="14898" y="208523"/>
                </a:cubicBezTo>
                <a:lnTo>
                  <a:pt x="14898" y="208523"/>
                </a:lnTo>
                <a:cubicBezTo>
                  <a:pt x="16860" y="214410"/>
                  <a:pt x="18585" y="222195"/>
                  <a:pt x="23834" y="226394"/>
                </a:cubicBezTo>
                <a:cubicBezTo>
                  <a:pt x="26286" y="228355"/>
                  <a:pt x="29961" y="227969"/>
                  <a:pt x="32769" y="229373"/>
                </a:cubicBezTo>
                <a:cubicBezTo>
                  <a:pt x="43865" y="234921"/>
                  <a:pt x="40756" y="236028"/>
                  <a:pt x="50640" y="244265"/>
                </a:cubicBezTo>
                <a:cubicBezTo>
                  <a:pt x="53390" y="246557"/>
                  <a:pt x="56597" y="248236"/>
                  <a:pt x="59576" y="250222"/>
                </a:cubicBezTo>
                <a:cubicBezTo>
                  <a:pt x="60569" y="253201"/>
                  <a:pt x="60593" y="256706"/>
                  <a:pt x="62554" y="259158"/>
                </a:cubicBezTo>
                <a:cubicBezTo>
                  <a:pt x="66753" y="264407"/>
                  <a:pt x="74539" y="266131"/>
                  <a:pt x="80425" y="268093"/>
                </a:cubicBezTo>
                <a:cubicBezTo>
                  <a:pt x="83404" y="271072"/>
                  <a:pt x="85856" y="274692"/>
                  <a:pt x="89361" y="277029"/>
                </a:cubicBezTo>
                <a:cubicBezTo>
                  <a:pt x="91973" y="278770"/>
                  <a:pt x="96076" y="277787"/>
                  <a:pt x="98296" y="280007"/>
                </a:cubicBezTo>
                <a:cubicBezTo>
                  <a:pt x="100516" y="282227"/>
                  <a:pt x="99871" y="286135"/>
                  <a:pt x="101275" y="288943"/>
                </a:cubicBezTo>
                <a:cubicBezTo>
                  <a:pt x="103451" y="293295"/>
                  <a:pt x="114146" y="307097"/>
                  <a:pt x="116167" y="309792"/>
                </a:cubicBezTo>
                <a:cubicBezTo>
                  <a:pt x="120495" y="322777"/>
                  <a:pt x="120215" y="327160"/>
                  <a:pt x="128081" y="336599"/>
                </a:cubicBezTo>
                <a:cubicBezTo>
                  <a:pt x="130778" y="339835"/>
                  <a:pt x="134038" y="342556"/>
                  <a:pt x="137017" y="345534"/>
                </a:cubicBezTo>
                <a:cubicBezTo>
                  <a:pt x="144500" y="367989"/>
                  <a:pt x="134407" y="340317"/>
                  <a:pt x="145952" y="363405"/>
                </a:cubicBezTo>
                <a:cubicBezTo>
                  <a:pt x="158284" y="388067"/>
                  <a:pt x="137817" y="355671"/>
                  <a:pt x="154888" y="381276"/>
                </a:cubicBezTo>
                <a:lnTo>
                  <a:pt x="163823" y="408083"/>
                </a:lnTo>
                <a:cubicBezTo>
                  <a:pt x="164816" y="411061"/>
                  <a:pt x="165061" y="414406"/>
                  <a:pt x="166802" y="417018"/>
                </a:cubicBezTo>
                <a:lnTo>
                  <a:pt x="172759" y="425954"/>
                </a:lnTo>
                <a:cubicBezTo>
                  <a:pt x="181798" y="453073"/>
                  <a:pt x="167929" y="410232"/>
                  <a:pt x="178716" y="449782"/>
                </a:cubicBezTo>
                <a:cubicBezTo>
                  <a:pt x="188274" y="484827"/>
                  <a:pt x="183389" y="449730"/>
                  <a:pt x="190630" y="500416"/>
                </a:cubicBezTo>
                <a:cubicBezTo>
                  <a:pt x="192041" y="510294"/>
                  <a:pt x="192198" y="520323"/>
                  <a:pt x="193609" y="530201"/>
                </a:cubicBezTo>
                <a:cubicBezTo>
                  <a:pt x="194545" y="536751"/>
                  <a:pt x="197443" y="544682"/>
                  <a:pt x="199566" y="551051"/>
                </a:cubicBezTo>
                <a:cubicBezTo>
                  <a:pt x="200559" y="563958"/>
                  <a:pt x="201114" y="576906"/>
                  <a:pt x="202544" y="589772"/>
                </a:cubicBezTo>
                <a:cubicBezTo>
                  <a:pt x="203103" y="594803"/>
                  <a:pt x="204617" y="599683"/>
                  <a:pt x="205523" y="604664"/>
                </a:cubicBezTo>
                <a:cubicBezTo>
                  <a:pt x="206603" y="610606"/>
                  <a:pt x="207834" y="616533"/>
                  <a:pt x="208501" y="622535"/>
                </a:cubicBezTo>
                <a:cubicBezTo>
                  <a:pt x="210153" y="637400"/>
                  <a:pt x="210439" y="660070"/>
                  <a:pt x="214458" y="676148"/>
                </a:cubicBezTo>
                <a:cubicBezTo>
                  <a:pt x="215981" y="682240"/>
                  <a:pt x="218429" y="688062"/>
                  <a:pt x="220415" y="694019"/>
                </a:cubicBezTo>
                <a:cubicBezTo>
                  <a:pt x="221408" y="696998"/>
                  <a:pt x="221652" y="700343"/>
                  <a:pt x="223394" y="702955"/>
                </a:cubicBezTo>
                <a:lnTo>
                  <a:pt x="235308" y="720826"/>
                </a:lnTo>
                <a:cubicBezTo>
                  <a:pt x="241159" y="738380"/>
                  <a:pt x="234342" y="721067"/>
                  <a:pt x="247222" y="741675"/>
                </a:cubicBezTo>
                <a:cubicBezTo>
                  <a:pt x="249575" y="745440"/>
                  <a:pt x="251193" y="749618"/>
                  <a:pt x="253179" y="753589"/>
                </a:cubicBezTo>
                <a:cubicBezTo>
                  <a:pt x="258669" y="775552"/>
                  <a:pt x="252770" y="755615"/>
                  <a:pt x="262114" y="777417"/>
                </a:cubicBezTo>
                <a:cubicBezTo>
                  <a:pt x="263351" y="780303"/>
                  <a:pt x="263689" y="783545"/>
                  <a:pt x="265093" y="786353"/>
                </a:cubicBezTo>
                <a:cubicBezTo>
                  <a:pt x="266694" y="789555"/>
                  <a:pt x="269274" y="792180"/>
                  <a:pt x="271050" y="795288"/>
                </a:cubicBezTo>
                <a:cubicBezTo>
                  <a:pt x="273253" y="799143"/>
                  <a:pt x="274165" y="803791"/>
                  <a:pt x="277007" y="807202"/>
                </a:cubicBezTo>
                <a:cubicBezTo>
                  <a:pt x="279299" y="809952"/>
                  <a:pt x="282964" y="811173"/>
                  <a:pt x="285942" y="813159"/>
                </a:cubicBezTo>
                <a:cubicBezTo>
                  <a:pt x="286935" y="819116"/>
                  <a:pt x="286598" y="825455"/>
                  <a:pt x="288921" y="831030"/>
                </a:cubicBezTo>
                <a:cubicBezTo>
                  <a:pt x="291675" y="837639"/>
                  <a:pt x="296864" y="842944"/>
                  <a:pt x="300835" y="848901"/>
                </a:cubicBezTo>
                <a:cubicBezTo>
                  <a:pt x="307378" y="858716"/>
                  <a:pt x="317619" y="875345"/>
                  <a:pt x="327641" y="878686"/>
                </a:cubicBezTo>
                <a:cubicBezTo>
                  <a:pt x="350110" y="886176"/>
                  <a:pt x="322408" y="876071"/>
                  <a:pt x="345512" y="887622"/>
                </a:cubicBezTo>
                <a:cubicBezTo>
                  <a:pt x="348320" y="889026"/>
                  <a:pt x="351469" y="889607"/>
                  <a:pt x="354448" y="890600"/>
                </a:cubicBezTo>
                <a:cubicBezTo>
                  <a:pt x="357426" y="892586"/>
                  <a:pt x="360093" y="895147"/>
                  <a:pt x="363383" y="896557"/>
                </a:cubicBezTo>
                <a:cubicBezTo>
                  <a:pt x="367146" y="898170"/>
                  <a:pt x="371222" y="899148"/>
                  <a:pt x="375297" y="899536"/>
                </a:cubicBezTo>
                <a:cubicBezTo>
                  <a:pt x="392128" y="901139"/>
                  <a:pt x="409054" y="901521"/>
                  <a:pt x="425932" y="902514"/>
                </a:cubicBezTo>
                <a:cubicBezTo>
                  <a:pt x="427517" y="902910"/>
                  <a:pt x="444219" y="906763"/>
                  <a:pt x="446781" y="908471"/>
                </a:cubicBezTo>
                <a:cubicBezTo>
                  <a:pt x="450286" y="910808"/>
                  <a:pt x="452481" y="914710"/>
                  <a:pt x="455717" y="917407"/>
                </a:cubicBezTo>
                <a:cubicBezTo>
                  <a:pt x="458467" y="919699"/>
                  <a:pt x="461674" y="921378"/>
                  <a:pt x="464652" y="923364"/>
                </a:cubicBezTo>
                <a:cubicBezTo>
                  <a:pt x="468623" y="929321"/>
                  <a:pt x="471503" y="936173"/>
                  <a:pt x="476566" y="941235"/>
                </a:cubicBezTo>
                <a:cubicBezTo>
                  <a:pt x="479545" y="944213"/>
                  <a:pt x="482916" y="946845"/>
                  <a:pt x="485502" y="950170"/>
                </a:cubicBezTo>
                <a:cubicBezTo>
                  <a:pt x="493881" y="960942"/>
                  <a:pt x="497481" y="970099"/>
                  <a:pt x="506351" y="979955"/>
                </a:cubicBezTo>
                <a:cubicBezTo>
                  <a:pt x="511987" y="986217"/>
                  <a:pt x="518265" y="991869"/>
                  <a:pt x="524222" y="997826"/>
                </a:cubicBezTo>
                <a:cubicBezTo>
                  <a:pt x="527201" y="1000805"/>
                  <a:pt x="530821" y="1003257"/>
                  <a:pt x="533158" y="1006762"/>
                </a:cubicBezTo>
                <a:cubicBezTo>
                  <a:pt x="543789" y="1022707"/>
                  <a:pt x="536582" y="1013164"/>
                  <a:pt x="556986" y="1033568"/>
                </a:cubicBezTo>
                <a:cubicBezTo>
                  <a:pt x="559964" y="1036547"/>
                  <a:pt x="562416" y="1040168"/>
                  <a:pt x="565921" y="1042504"/>
                </a:cubicBezTo>
                <a:cubicBezTo>
                  <a:pt x="572991" y="1047217"/>
                  <a:pt x="580308" y="1051856"/>
                  <a:pt x="586771" y="1057396"/>
                </a:cubicBezTo>
                <a:cubicBezTo>
                  <a:pt x="589969" y="1060137"/>
                  <a:pt x="592470" y="1063635"/>
                  <a:pt x="595706" y="1066332"/>
                </a:cubicBezTo>
                <a:cubicBezTo>
                  <a:pt x="598456" y="1068624"/>
                  <a:pt x="601966" y="1069911"/>
                  <a:pt x="604642" y="1072289"/>
                </a:cubicBezTo>
                <a:cubicBezTo>
                  <a:pt x="635249" y="1099495"/>
                  <a:pt x="611167" y="1082596"/>
                  <a:pt x="631448" y="1096117"/>
                </a:cubicBezTo>
                <a:cubicBezTo>
                  <a:pt x="635419" y="1102074"/>
                  <a:pt x="641098" y="1107196"/>
                  <a:pt x="643362" y="1113988"/>
                </a:cubicBezTo>
                <a:cubicBezTo>
                  <a:pt x="648606" y="1129715"/>
                  <a:pt x="644599" y="1120310"/>
                  <a:pt x="658255" y="1140794"/>
                </a:cubicBezTo>
                <a:cubicBezTo>
                  <a:pt x="660241" y="1143773"/>
                  <a:pt x="661233" y="1147744"/>
                  <a:pt x="664212" y="1149730"/>
                </a:cubicBezTo>
                <a:lnTo>
                  <a:pt x="673147" y="1155687"/>
                </a:lnTo>
                <a:cubicBezTo>
                  <a:pt x="675133" y="1158665"/>
                  <a:pt x="676573" y="1162091"/>
                  <a:pt x="679104" y="1164622"/>
                </a:cubicBezTo>
                <a:cubicBezTo>
                  <a:pt x="687639" y="1173157"/>
                  <a:pt x="687286" y="1168713"/>
                  <a:pt x="696975" y="1173558"/>
                </a:cubicBezTo>
                <a:cubicBezTo>
                  <a:pt x="700747" y="1175444"/>
                  <a:pt x="715935" y="1186830"/>
                  <a:pt x="717825" y="1188450"/>
                </a:cubicBezTo>
                <a:cubicBezTo>
                  <a:pt x="725798" y="1195284"/>
                  <a:pt x="729503" y="1200631"/>
                  <a:pt x="735696" y="1209300"/>
                </a:cubicBezTo>
                <a:cubicBezTo>
                  <a:pt x="737777" y="1212213"/>
                  <a:pt x="738545" y="1216459"/>
                  <a:pt x="741653" y="1218235"/>
                </a:cubicBezTo>
                <a:cubicBezTo>
                  <a:pt x="746048" y="1220747"/>
                  <a:pt x="751581" y="1220221"/>
                  <a:pt x="756545" y="1221214"/>
                </a:cubicBezTo>
                <a:cubicBezTo>
                  <a:pt x="758531" y="1224192"/>
                  <a:pt x="761245" y="1226797"/>
                  <a:pt x="762502" y="1230149"/>
                </a:cubicBezTo>
                <a:cubicBezTo>
                  <a:pt x="765719" y="1238727"/>
                  <a:pt x="767631" y="1266879"/>
                  <a:pt x="768459" y="1271848"/>
                </a:cubicBezTo>
                <a:cubicBezTo>
                  <a:pt x="768975" y="1274945"/>
                  <a:pt x="770445" y="1277805"/>
                  <a:pt x="771438" y="1280784"/>
                </a:cubicBezTo>
                <a:cubicBezTo>
                  <a:pt x="781495" y="1341135"/>
                  <a:pt x="766219" y="1255197"/>
                  <a:pt x="780373" y="1316526"/>
                </a:cubicBezTo>
                <a:cubicBezTo>
                  <a:pt x="787138" y="1345838"/>
                  <a:pt x="777786" y="1329025"/>
                  <a:pt x="789309" y="1346311"/>
                </a:cubicBezTo>
                <a:cubicBezTo>
                  <a:pt x="790302" y="1349289"/>
                  <a:pt x="790067" y="1353026"/>
                  <a:pt x="792287" y="1355246"/>
                </a:cubicBezTo>
                <a:cubicBezTo>
                  <a:pt x="793907" y="1356866"/>
                  <a:pt x="809254" y="1363858"/>
                  <a:pt x="813137" y="1364182"/>
                </a:cubicBezTo>
                <a:cubicBezTo>
                  <a:pt x="833938" y="1365915"/>
                  <a:pt x="854841" y="1366063"/>
                  <a:pt x="875685" y="1367160"/>
                </a:cubicBezTo>
                <a:lnTo>
                  <a:pt x="926320" y="1370139"/>
                </a:lnTo>
                <a:cubicBezTo>
                  <a:pt x="946177" y="1369146"/>
                  <a:pt x="966083" y="1368882"/>
                  <a:pt x="985890" y="1367160"/>
                </a:cubicBezTo>
                <a:cubicBezTo>
                  <a:pt x="989018" y="1366888"/>
                  <a:pt x="992374" y="1366143"/>
                  <a:pt x="994825" y="1364182"/>
                </a:cubicBezTo>
                <a:cubicBezTo>
                  <a:pt x="1003485" y="1357254"/>
                  <a:pt x="1001018" y="1345956"/>
                  <a:pt x="1006739" y="1337375"/>
                </a:cubicBezTo>
                <a:lnTo>
                  <a:pt x="1012696" y="1328440"/>
                </a:lnTo>
                <a:cubicBezTo>
                  <a:pt x="997190" y="1266404"/>
                  <a:pt x="1012696" y="1332854"/>
                  <a:pt x="1012696" y="1164622"/>
                </a:cubicBezTo>
                <a:cubicBezTo>
                  <a:pt x="1012696" y="1148706"/>
                  <a:pt x="1011159" y="1132817"/>
                  <a:pt x="1009718" y="1116966"/>
                </a:cubicBezTo>
                <a:cubicBezTo>
                  <a:pt x="1009171" y="1110952"/>
                  <a:pt x="1008204" y="1104954"/>
                  <a:pt x="1006739" y="1099095"/>
                </a:cubicBezTo>
                <a:cubicBezTo>
                  <a:pt x="1005216" y="1093003"/>
                  <a:pt x="1000782" y="1081224"/>
                  <a:pt x="1000782" y="1081224"/>
                </a:cubicBezTo>
                <a:cubicBezTo>
                  <a:pt x="1001775" y="1074274"/>
                  <a:pt x="1002853" y="1067336"/>
                  <a:pt x="1003761" y="1060375"/>
                </a:cubicBezTo>
                <a:cubicBezTo>
                  <a:pt x="1005832" y="1044501"/>
                  <a:pt x="1006579" y="1028417"/>
                  <a:pt x="1009718" y="1012719"/>
                </a:cubicBezTo>
                <a:lnTo>
                  <a:pt x="1012696" y="997826"/>
                </a:lnTo>
                <a:cubicBezTo>
                  <a:pt x="1011703" y="970027"/>
                  <a:pt x="1011401" y="942194"/>
                  <a:pt x="1009718" y="914428"/>
                </a:cubicBezTo>
                <a:cubicBezTo>
                  <a:pt x="1009412" y="909375"/>
                  <a:pt x="1007837" y="904478"/>
                  <a:pt x="1006739" y="899536"/>
                </a:cubicBezTo>
                <a:cubicBezTo>
                  <a:pt x="1006407" y="898043"/>
                  <a:pt x="1002442" y="881176"/>
                  <a:pt x="1000782" y="878686"/>
                </a:cubicBezTo>
                <a:cubicBezTo>
                  <a:pt x="998446" y="875181"/>
                  <a:pt x="995172" y="872337"/>
                  <a:pt x="991847" y="869751"/>
                </a:cubicBezTo>
                <a:cubicBezTo>
                  <a:pt x="986196" y="865356"/>
                  <a:pt x="979933" y="861808"/>
                  <a:pt x="973976" y="857837"/>
                </a:cubicBezTo>
                <a:cubicBezTo>
                  <a:pt x="970997" y="855851"/>
                  <a:pt x="967571" y="854411"/>
                  <a:pt x="965040" y="851880"/>
                </a:cubicBezTo>
                <a:cubicBezTo>
                  <a:pt x="962062" y="848901"/>
                  <a:pt x="959341" y="845641"/>
                  <a:pt x="956105" y="842944"/>
                </a:cubicBezTo>
                <a:cubicBezTo>
                  <a:pt x="951324" y="838960"/>
                  <a:pt x="944631" y="834862"/>
                  <a:pt x="938234" y="834009"/>
                </a:cubicBezTo>
                <a:cubicBezTo>
                  <a:pt x="926384" y="832429"/>
                  <a:pt x="914388" y="832220"/>
                  <a:pt x="902492" y="831030"/>
                </a:cubicBezTo>
                <a:cubicBezTo>
                  <a:pt x="894527" y="830234"/>
                  <a:pt x="886607" y="829045"/>
                  <a:pt x="878664" y="828052"/>
                </a:cubicBezTo>
                <a:cubicBezTo>
                  <a:pt x="875685" y="827059"/>
                  <a:pt x="872747" y="825936"/>
                  <a:pt x="869728" y="825073"/>
                </a:cubicBezTo>
                <a:cubicBezTo>
                  <a:pt x="865266" y="823798"/>
                  <a:pt x="853646" y="821499"/>
                  <a:pt x="848879" y="819116"/>
                </a:cubicBezTo>
                <a:cubicBezTo>
                  <a:pt x="825792" y="807572"/>
                  <a:pt x="853459" y="817664"/>
                  <a:pt x="831008" y="810181"/>
                </a:cubicBezTo>
                <a:cubicBezTo>
                  <a:pt x="828029" y="808195"/>
                  <a:pt x="825274" y="805825"/>
                  <a:pt x="822072" y="804224"/>
                </a:cubicBezTo>
                <a:cubicBezTo>
                  <a:pt x="819264" y="802820"/>
                  <a:pt x="815749" y="802986"/>
                  <a:pt x="813137" y="801245"/>
                </a:cubicBezTo>
                <a:cubicBezTo>
                  <a:pt x="809632" y="798908"/>
                  <a:pt x="807706" y="794647"/>
                  <a:pt x="804201" y="792310"/>
                </a:cubicBezTo>
                <a:cubicBezTo>
                  <a:pt x="801589" y="790569"/>
                  <a:pt x="798010" y="790856"/>
                  <a:pt x="795266" y="789331"/>
                </a:cubicBezTo>
                <a:cubicBezTo>
                  <a:pt x="789008" y="785854"/>
                  <a:pt x="777395" y="777417"/>
                  <a:pt x="777395" y="777417"/>
                </a:cubicBezTo>
                <a:cubicBezTo>
                  <a:pt x="772151" y="761690"/>
                  <a:pt x="776158" y="771095"/>
                  <a:pt x="762502" y="750611"/>
                </a:cubicBezTo>
                <a:lnTo>
                  <a:pt x="756545" y="741675"/>
                </a:lnTo>
                <a:lnTo>
                  <a:pt x="750588" y="732740"/>
                </a:lnTo>
                <a:lnTo>
                  <a:pt x="741653" y="705933"/>
                </a:lnTo>
                <a:cubicBezTo>
                  <a:pt x="740660" y="702955"/>
                  <a:pt x="740415" y="699610"/>
                  <a:pt x="738674" y="696998"/>
                </a:cubicBezTo>
                <a:lnTo>
                  <a:pt x="732717" y="688062"/>
                </a:lnTo>
                <a:cubicBezTo>
                  <a:pt x="721859" y="655484"/>
                  <a:pt x="739175" y="704827"/>
                  <a:pt x="723782" y="670191"/>
                </a:cubicBezTo>
                <a:cubicBezTo>
                  <a:pt x="721232" y="664453"/>
                  <a:pt x="719811" y="658277"/>
                  <a:pt x="717825" y="652320"/>
                </a:cubicBezTo>
                <a:lnTo>
                  <a:pt x="711868" y="634449"/>
                </a:lnTo>
                <a:cubicBezTo>
                  <a:pt x="710915" y="630636"/>
                  <a:pt x="708046" y="617870"/>
                  <a:pt x="705911" y="613600"/>
                </a:cubicBezTo>
                <a:cubicBezTo>
                  <a:pt x="704310" y="610398"/>
                  <a:pt x="701940" y="607643"/>
                  <a:pt x="699954" y="604664"/>
                </a:cubicBezTo>
                <a:cubicBezTo>
                  <a:pt x="698961" y="571900"/>
                  <a:pt x="698793" y="539101"/>
                  <a:pt x="696975" y="506373"/>
                </a:cubicBezTo>
                <a:cubicBezTo>
                  <a:pt x="696801" y="503238"/>
                  <a:pt x="694678" y="500503"/>
                  <a:pt x="693997" y="497438"/>
                </a:cubicBezTo>
                <a:cubicBezTo>
                  <a:pt x="692687" y="491543"/>
                  <a:pt x="692328" y="485462"/>
                  <a:pt x="691018" y="479567"/>
                </a:cubicBezTo>
                <a:cubicBezTo>
                  <a:pt x="690337" y="476502"/>
                  <a:pt x="688801" y="473677"/>
                  <a:pt x="688040" y="470631"/>
                </a:cubicBezTo>
                <a:cubicBezTo>
                  <a:pt x="679621" y="436953"/>
                  <a:pt x="691882" y="476206"/>
                  <a:pt x="679104" y="437868"/>
                </a:cubicBezTo>
                <a:lnTo>
                  <a:pt x="676126" y="428932"/>
                </a:lnTo>
                <a:cubicBezTo>
                  <a:pt x="675133" y="419004"/>
                  <a:pt x="674664" y="409009"/>
                  <a:pt x="673147" y="399147"/>
                </a:cubicBezTo>
                <a:cubicBezTo>
                  <a:pt x="672670" y="396044"/>
                  <a:pt x="671910" y="392824"/>
                  <a:pt x="670169" y="390212"/>
                </a:cubicBezTo>
                <a:cubicBezTo>
                  <a:pt x="667832" y="386707"/>
                  <a:pt x="664212" y="384255"/>
                  <a:pt x="661233" y="381276"/>
                </a:cubicBezTo>
                <a:cubicBezTo>
                  <a:pt x="659247" y="375319"/>
                  <a:pt x="660501" y="366888"/>
                  <a:pt x="655276" y="363405"/>
                </a:cubicBezTo>
                <a:cubicBezTo>
                  <a:pt x="652298" y="361419"/>
                  <a:pt x="649002" y="359843"/>
                  <a:pt x="646341" y="357448"/>
                </a:cubicBezTo>
                <a:cubicBezTo>
                  <a:pt x="639035" y="350873"/>
                  <a:pt x="634617" y="340249"/>
                  <a:pt x="625491" y="336599"/>
                </a:cubicBezTo>
                <a:cubicBezTo>
                  <a:pt x="587232" y="321295"/>
                  <a:pt x="634666" y="341186"/>
                  <a:pt x="595706" y="321706"/>
                </a:cubicBezTo>
                <a:cubicBezTo>
                  <a:pt x="592898" y="320302"/>
                  <a:pt x="589657" y="319965"/>
                  <a:pt x="586771" y="318728"/>
                </a:cubicBezTo>
                <a:cubicBezTo>
                  <a:pt x="582690" y="316979"/>
                  <a:pt x="578712" y="314974"/>
                  <a:pt x="574857" y="312771"/>
                </a:cubicBezTo>
                <a:cubicBezTo>
                  <a:pt x="571749" y="310995"/>
                  <a:pt x="569245" y="308144"/>
                  <a:pt x="565921" y="306814"/>
                </a:cubicBezTo>
                <a:cubicBezTo>
                  <a:pt x="559210" y="304130"/>
                  <a:pt x="552022" y="302843"/>
                  <a:pt x="545072" y="300857"/>
                </a:cubicBezTo>
                <a:cubicBezTo>
                  <a:pt x="544079" y="297878"/>
                  <a:pt x="544021" y="294399"/>
                  <a:pt x="542093" y="291921"/>
                </a:cubicBezTo>
                <a:cubicBezTo>
                  <a:pt x="528029" y="273839"/>
                  <a:pt x="529968" y="275965"/>
                  <a:pt x="515287" y="271072"/>
                </a:cubicBezTo>
                <a:lnTo>
                  <a:pt x="497416" y="244265"/>
                </a:lnTo>
                <a:lnTo>
                  <a:pt x="491459" y="235330"/>
                </a:lnTo>
                <a:cubicBezTo>
                  <a:pt x="489473" y="232351"/>
                  <a:pt x="488033" y="228925"/>
                  <a:pt x="485502" y="226394"/>
                </a:cubicBezTo>
                <a:lnTo>
                  <a:pt x="467631" y="208523"/>
                </a:lnTo>
                <a:cubicBezTo>
                  <a:pt x="462396" y="192821"/>
                  <a:pt x="468111" y="205526"/>
                  <a:pt x="455717" y="190652"/>
                </a:cubicBezTo>
                <a:cubicBezTo>
                  <a:pt x="453425" y="187902"/>
                  <a:pt x="452052" y="184467"/>
                  <a:pt x="449760" y="181717"/>
                </a:cubicBezTo>
                <a:cubicBezTo>
                  <a:pt x="447063" y="178481"/>
                  <a:pt x="443521" y="176017"/>
                  <a:pt x="440824" y="172781"/>
                </a:cubicBezTo>
                <a:cubicBezTo>
                  <a:pt x="438532" y="170031"/>
                  <a:pt x="437398" y="166377"/>
                  <a:pt x="434867" y="163846"/>
                </a:cubicBezTo>
                <a:cubicBezTo>
                  <a:pt x="431357" y="160336"/>
                  <a:pt x="426924" y="157889"/>
                  <a:pt x="422953" y="154910"/>
                </a:cubicBezTo>
                <a:cubicBezTo>
                  <a:pt x="420967" y="149946"/>
                  <a:pt x="419830" y="144552"/>
                  <a:pt x="416996" y="140018"/>
                </a:cubicBezTo>
                <a:cubicBezTo>
                  <a:pt x="405981" y="122394"/>
                  <a:pt x="405328" y="140749"/>
                  <a:pt x="396147" y="113211"/>
                </a:cubicBezTo>
                <a:cubicBezTo>
                  <a:pt x="395154" y="110233"/>
                  <a:pt x="394031" y="107295"/>
                  <a:pt x="393168" y="104276"/>
                </a:cubicBezTo>
                <a:cubicBezTo>
                  <a:pt x="385685" y="78088"/>
                  <a:pt x="394356" y="104858"/>
                  <a:pt x="387211" y="83426"/>
                </a:cubicBezTo>
                <a:cubicBezTo>
                  <a:pt x="386218" y="73498"/>
                  <a:pt x="385029" y="63587"/>
                  <a:pt x="384233" y="53641"/>
                </a:cubicBezTo>
                <a:cubicBezTo>
                  <a:pt x="383043" y="38763"/>
                  <a:pt x="389325" y="21519"/>
                  <a:pt x="381254" y="8964"/>
                </a:cubicBezTo>
                <a:cubicBezTo>
                  <a:pt x="376925" y="2231"/>
                  <a:pt x="365369" y="10949"/>
                  <a:pt x="357426" y="11942"/>
                </a:cubicBezTo>
                <a:cubicBezTo>
                  <a:pt x="353209" y="13348"/>
                  <a:pt x="340321" y="17899"/>
                  <a:pt x="336577" y="17899"/>
                </a:cubicBezTo>
                <a:cubicBezTo>
                  <a:pt x="318678" y="17899"/>
                  <a:pt x="300825" y="16073"/>
                  <a:pt x="282964" y="14921"/>
                </a:cubicBezTo>
                <a:cubicBezTo>
                  <a:pt x="270046" y="14088"/>
                  <a:pt x="257132" y="13150"/>
                  <a:pt x="244243" y="11942"/>
                </a:cubicBezTo>
                <a:cubicBezTo>
                  <a:pt x="176271" y="5569"/>
                  <a:pt x="164816" y="-468"/>
                  <a:pt x="145952" y="28"/>
                </a:cubicBezTo>
                <a:close/>
              </a:path>
            </a:pathLst>
          </a:custGeom>
          <a:noFill/>
          <a:ln w="9525">
            <a:solidFill>
              <a:srgbClr val="FFFF0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39" name="Figura a mano libera 38"/>
          <p:cNvSpPr/>
          <p:nvPr/>
        </p:nvSpPr>
        <p:spPr>
          <a:xfrm>
            <a:off x="3560139" y="2192149"/>
            <a:ext cx="1012696" cy="1370139"/>
          </a:xfrm>
          <a:custGeom>
            <a:avLst/>
            <a:gdLst>
              <a:gd name="connsiteX0" fmla="*/ 145952 w 1012696"/>
              <a:gd name="connsiteY0" fmla="*/ 28 h 1370139"/>
              <a:gd name="connsiteX1" fmla="*/ 131060 w 1012696"/>
              <a:gd name="connsiteY1" fmla="*/ 14921 h 1370139"/>
              <a:gd name="connsiteX2" fmla="*/ 122124 w 1012696"/>
              <a:gd name="connsiteY2" fmla="*/ 20878 h 1370139"/>
              <a:gd name="connsiteX3" fmla="*/ 116167 w 1012696"/>
              <a:gd name="connsiteY3" fmla="*/ 29813 h 1370139"/>
              <a:gd name="connsiteX4" fmla="*/ 86382 w 1012696"/>
              <a:gd name="connsiteY4" fmla="*/ 47684 h 1370139"/>
              <a:gd name="connsiteX5" fmla="*/ 77447 w 1012696"/>
              <a:gd name="connsiteY5" fmla="*/ 53641 h 1370139"/>
              <a:gd name="connsiteX6" fmla="*/ 68511 w 1012696"/>
              <a:gd name="connsiteY6" fmla="*/ 56620 h 1370139"/>
              <a:gd name="connsiteX7" fmla="*/ 59576 w 1012696"/>
              <a:gd name="connsiteY7" fmla="*/ 62577 h 1370139"/>
              <a:gd name="connsiteX8" fmla="*/ 47662 w 1012696"/>
              <a:gd name="connsiteY8" fmla="*/ 71512 h 1370139"/>
              <a:gd name="connsiteX9" fmla="*/ 35748 w 1012696"/>
              <a:gd name="connsiteY9" fmla="*/ 74491 h 1370139"/>
              <a:gd name="connsiteX10" fmla="*/ 29791 w 1012696"/>
              <a:gd name="connsiteY10" fmla="*/ 83426 h 1370139"/>
              <a:gd name="connsiteX11" fmla="*/ 5963 w 1012696"/>
              <a:gd name="connsiteY11" fmla="*/ 95340 h 1370139"/>
              <a:gd name="connsiteX12" fmla="*/ 2984 w 1012696"/>
              <a:gd name="connsiteY12" fmla="*/ 128104 h 1370139"/>
              <a:gd name="connsiteX13" fmla="*/ 6 w 1012696"/>
              <a:gd name="connsiteY13" fmla="*/ 169803 h 1370139"/>
              <a:gd name="connsiteX14" fmla="*/ 14898 w 1012696"/>
              <a:gd name="connsiteY14" fmla="*/ 208523 h 1370139"/>
              <a:gd name="connsiteX15" fmla="*/ 14898 w 1012696"/>
              <a:gd name="connsiteY15" fmla="*/ 208523 h 1370139"/>
              <a:gd name="connsiteX16" fmla="*/ 23834 w 1012696"/>
              <a:gd name="connsiteY16" fmla="*/ 226394 h 1370139"/>
              <a:gd name="connsiteX17" fmla="*/ 32769 w 1012696"/>
              <a:gd name="connsiteY17" fmla="*/ 229373 h 1370139"/>
              <a:gd name="connsiteX18" fmla="*/ 50640 w 1012696"/>
              <a:gd name="connsiteY18" fmla="*/ 244265 h 1370139"/>
              <a:gd name="connsiteX19" fmla="*/ 59576 w 1012696"/>
              <a:gd name="connsiteY19" fmla="*/ 250222 h 1370139"/>
              <a:gd name="connsiteX20" fmla="*/ 62554 w 1012696"/>
              <a:gd name="connsiteY20" fmla="*/ 259158 h 1370139"/>
              <a:gd name="connsiteX21" fmla="*/ 80425 w 1012696"/>
              <a:gd name="connsiteY21" fmla="*/ 268093 h 1370139"/>
              <a:gd name="connsiteX22" fmla="*/ 89361 w 1012696"/>
              <a:gd name="connsiteY22" fmla="*/ 277029 h 1370139"/>
              <a:gd name="connsiteX23" fmla="*/ 98296 w 1012696"/>
              <a:gd name="connsiteY23" fmla="*/ 280007 h 1370139"/>
              <a:gd name="connsiteX24" fmla="*/ 101275 w 1012696"/>
              <a:gd name="connsiteY24" fmla="*/ 288943 h 1370139"/>
              <a:gd name="connsiteX25" fmla="*/ 116167 w 1012696"/>
              <a:gd name="connsiteY25" fmla="*/ 309792 h 1370139"/>
              <a:gd name="connsiteX26" fmla="*/ 128081 w 1012696"/>
              <a:gd name="connsiteY26" fmla="*/ 336599 h 1370139"/>
              <a:gd name="connsiteX27" fmla="*/ 137017 w 1012696"/>
              <a:gd name="connsiteY27" fmla="*/ 345534 h 1370139"/>
              <a:gd name="connsiteX28" fmla="*/ 145952 w 1012696"/>
              <a:gd name="connsiteY28" fmla="*/ 363405 h 1370139"/>
              <a:gd name="connsiteX29" fmla="*/ 154888 w 1012696"/>
              <a:gd name="connsiteY29" fmla="*/ 381276 h 1370139"/>
              <a:gd name="connsiteX30" fmla="*/ 163823 w 1012696"/>
              <a:gd name="connsiteY30" fmla="*/ 408083 h 1370139"/>
              <a:gd name="connsiteX31" fmla="*/ 166802 w 1012696"/>
              <a:gd name="connsiteY31" fmla="*/ 417018 h 1370139"/>
              <a:gd name="connsiteX32" fmla="*/ 172759 w 1012696"/>
              <a:gd name="connsiteY32" fmla="*/ 425954 h 1370139"/>
              <a:gd name="connsiteX33" fmla="*/ 178716 w 1012696"/>
              <a:gd name="connsiteY33" fmla="*/ 449782 h 1370139"/>
              <a:gd name="connsiteX34" fmla="*/ 190630 w 1012696"/>
              <a:gd name="connsiteY34" fmla="*/ 500416 h 1370139"/>
              <a:gd name="connsiteX35" fmla="*/ 193609 w 1012696"/>
              <a:gd name="connsiteY35" fmla="*/ 530201 h 1370139"/>
              <a:gd name="connsiteX36" fmla="*/ 199566 w 1012696"/>
              <a:gd name="connsiteY36" fmla="*/ 551051 h 1370139"/>
              <a:gd name="connsiteX37" fmla="*/ 202544 w 1012696"/>
              <a:gd name="connsiteY37" fmla="*/ 589772 h 1370139"/>
              <a:gd name="connsiteX38" fmla="*/ 205523 w 1012696"/>
              <a:gd name="connsiteY38" fmla="*/ 604664 h 1370139"/>
              <a:gd name="connsiteX39" fmla="*/ 208501 w 1012696"/>
              <a:gd name="connsiteY39" fmla="*/ 622535 h 1370139"/>
              <a:gd name="connsiteX40" fmla="*/ 214458 w 1012696"/>
              <a:gd name="connsiteY40" fmla="*/ 676148 h 1370139"/>
              <a:gd name="connsiteX41" fmla="*/ 220415 w 1012696"/>
              <a:gd name="connsiteY41" fmla="*/ 694019 h 1370139"/>
              <a:gd name="connsiteX42" fmla="*/ 223394 w 1012696"/>
              <a:gd name="connsiteY42" fmla="*/ 702955 h 1370139"/>
              <a:gd name="connsiteX43" fmla="*/ 235308 w 1012696"/>
              <a:gd name="connsiteY43" fmla="*/ 720826 h 1370139"/>
              <a:gd name="connsiteX44" fmla="*/ 247222 w 1012696"/>
              <a:gd name="connsiteY44" fmla="*/ 741675 h 1370139"/>
              <a:gd name="connsiteX45" fmla="*/ 253179 w 1012696"/>
              <a:gd name="connsiteY45" fmla="*/ 753589 h 1370139"/>
              <a:gd name="connsiteX46" fmla="*/ 262114 w 1012696"/>
              <a:gd name="connsiteY46" fmla="*/ 777417 h 1370139"/>
              <a:gd name="connsiteX47" fmla="*/ 265093 w 1012696"/>
              <a:gd name="connsiteY47" fmla="*/ 786353 h 1370139"/>
              <a:gd name="connsiteX48" fmla="*/ 271050 w 1012696"/>
              <a:gd name="connsiteY48" fmla="*/ 795288 h 1370139"/>
              <a:gd name="connsiteX49" fmla="*/ 277007 w 1012696"/>
              <a:gd name="connsiteY49" fmla="*/ 807202 h 1370139"/>
              <a:gd name="connsiteX50" fmla="*/ 285942 w 1012696"/>
              <a:gd name="connsiteY50" fmla="*/ 813159 h 1370139"/>
              <a:gd name="connsiteX51" fmla="*/ 288921 w 1012696"/>
              <a:gd name="connsiteY51" fmla="*/ 831030 h 1370139"/>
              <a:gd name="connsiteX52" fmla="*/ 300835 w 1012696"/>
              <a:gd name="connsiteY52" fmla="*/ 848901 h 1370139"/>
              <a:gd name="connsiteX53" fmla="*/ 327641 w 1012696"/>
              <a:gd name="connsiteY53" fmla="*/ 878686 h 1370139"/>
              <a:gd name="connsiteX54" fmla="*/ 345512 w 1012696"/>
              <a:gd name="connsiteY54" fmla="*/ 887622 h 1370139"/>
              <a:gd name="connsiteX55" fmla="*/ 354448 w 1012696"/>
              <a:gd name="connsiteY55" fmla="*/ 890600 h 1370139"/>
              <a:gd name="connsiteX56" fmla="*/ 363383 w 1012696"/>
              <a:gd name="connsiteY56" fmla="*/ 896557 h 1370139"/>
              <a:gd name="connsiteX57" fmla="*/ 375297 w 1012696"/>
              <a:gd name="connsiteY57" fmla="*/ 899536 h 1370139"/>
              <a:gd name="connsiteX58" fmla="*/ 425932 w 1012696"/>
              <a:gd name="connsiteY58" fmla="*/ 902514 h 1370139"/>
              <a:gd name="connsiteX59" fmla="*/ 446781 w 1012696"/>
              <a:gd name="connsiteY59" fmla="*/ 908471 h 1370139"/>
              <a:gd name="connsiteX60" fmla="*/ 455717 w 1012696"/>
              <a:gd name="connsiteY60" fmla="*/ 917407 h 1370139"/>
              <a:gd name="connsiteX61" fmla="*/ 464652 w 1012696"/>
              <a:gd name="connsiteY61" fmla="*/ 923364 h 1370139"/>
              <a:gd name="connsiteX62" fmla="*/ 476566 w 1012696"/>
              <a:gd name="connsiteY62" fmla="*/ 941235 h 1370139"/>
              <a:gd name="connsiteX63" fmla="*/ 485502 w 1012696"/>
              <a:gd name="connsiteY63" fmla="*/ 950170 h 1370139"/>
              <a:gd name="connsiteX64" fmla="*/ 506351 w 1012696"/>
              <a:gd name="connsiteY64" fmla="*/ 979955 h 1370139"/>
              <a:gd name="connsiteX65" fmla="*/ 524222 w 1012696"/>
              <a:gd name="connsiteY65" fmla="*/ 997826 h 1370139"/>
              <a:gd name="connsiteX66" fmla="*/ 533158 w 1012696"/>
              <a:gd name="connsiteY66" fmla="*/ 1006762 h 1370139"/>
              <a:gd name="connsiteX67" fmla="*/ 556986 w 1012696"/>
              <a:gd name="connsiteY67" fmla="*/ 1033568 h 1370139"/>
              <a:gd name="connsiteX68" fmla="*/ 565921 w 1012696"/>
              <a:gd name="connsiteY68" fmla="*/ 1042504 h 1370139"/>
              <a:gd name="connsiteX69" fmla="*/ 586771 w 1012696"/>
              <a:gd name="connsiteY69" fmla="*/ 1057396 h 1370139"/>
              <a:gd name="connsiteX70" fmla="*/ 595706 w 1012696"/>
              <a:gd name="connsiteY70" fmla="*/ 1066332 h 1370139"/>
              <a:gd name="connsiteX71" fmla="*/ 604642 w 1012696"/>
              <a:gd name="connsiteY71" fmla="*/ 1072289 h 1370139"/>
              <a:gd name="connsiteX72" fmla="*/ 631448 w 1012696"/>
              <a:gd name="connsiteY72" fmla="*/ 1096117 h 1370139"/>
              <a:gd name="connsiteX73" fmla="*/ 643362 w 1012696"/>
              <a:gd name="connsiteY73" fmla="*/ 1113988 h 1370139"/>
              <a:gd name="connsiteX74" fmla="*/ 658255 w 1012696"/>
              <a:gd name="connsiteY74" fmla="*/ 1140794 h 1370139"/>
              <a:gd name="connsiteX75" fmla="*/ 664212 w 1012696"/>
              <a:gd name="connsiteY75" fmla="*/ 1149730 h 1370139"/>
              <a:gd name="connsiteX76" fmla="*/ 673147 w 1012696"/>
              <a:gd name="connsiteY76" fmla="*/ 1155687 h 1370139"/>
              <a:gd name="connsiteX77" fmla="*/ 679104 w 1012696"/>
              <a:gd name="connsiteY77" fmla="*/ 1164622 h 1370139"/>
              <a:gd name="connsiteX78" fmla="*/ 696975 w 1012696"/>
              <a:gd name="connsiteY78" fmla="*/ 1173558 h 1370139"/>
              <a:gd name="connsiteX79" fmla="*/ 717825 w 1012696"/>
              <a:gd name="connsiteY79" fmla="*/ 1188450 h 1370139"/>
              <a:gd name="connsiteX80" fmla="*/ 735696 w 1012696"/>
              <a:gd name="connsiteY80" fmla="*/ 1209300 h 1370139"/>
              <a:gd name="connsiteX81" fmla="*/ 741653 w 1012696"/>
              <a:gd name="connsiteY81" fmla="*/ 1218235 h 1370139"/>
              <a:gd name="connsiteX82" fmla="*/ 756545 w 1012696"/>
              <a:gd name="connsiteY82" fmla="*/ 1221214 h 1370139"/>
              <a:gd name="connsiteX83" fmla="*/ 762502 w 1012696"/>
              <a:gd name="connsiteY83" fmla="*/ 1230149 h 1370139"/>
              <a:gd name="connsiteX84" fmla="*/ 768459 w 1012696"/>
              <a:gd name="connsiteY84" fmla="*/ 1271848 h 1370139"/>
              <a:gd name="connsiteX85" fmla="*/ 771438 w 1012696"/>
              <a:gd name="connsiteY85" fmla="*/ 1280784 h 1370139"/>
              <a:gd name="connsiteX86" fmla="*/ 780373 w 1012696"/>
              <a:gd name="connsiteY86" fmla="*/ 1316526 h 1370139"/>
              <a:gd name="connsiteX87" fmla="*/ 789309 w 1012696"/>
              <a:gd name="connsiteY87" fmla="*/ 1346311 h 1370139"/>
              <a:gd name="connsiteX88" fmla="*/ 792287 w 1012696"/>
              <a:gd name="connsiteY88" fmla="*/ 1355246 h 1370139"/>
              <a:gd name="connsiteX89" fmla="*/ 813137 w 1012696"/>
              <a:gd name="connsiteY89" fmla="*/ 1364182 h 1370139"/>
              <a:gd name="connsiteX90" fmla="*/ 875685 w 1012696"/>
              <a:gd name="connsiteY90" fmla="*/ 1367160 h 1370139"/>
              <a:gd name="connsiteX91" fmla="*/ 926320 w 1012696"/>
              <a:gd name="connsiteY91" fmla="*/ 1370139 h 1370139"/>
              <a:gd name="connsiteX92" fmla="*/ 985890 w 1012696"/>
              <a:gd name="connsiteY92" fmla="*/ 1367160 h 1370139"/>
              <a:gd name="connsiteX93" fmla="*/ 994825 w 1012696"/>
              <a:gd name="connsiteY93" fmla="*/ 1364182 h 1370139"/>
              <a:gd name="connsiteX94" fmla="*/ 1006739 w 1012696"/>
              <a:gd name="connsiteY94" fmla="*/ 1337375 h 1370139"/>
              <a:gd name="connsiteX95" fmla="*/ 1012696 w 1012696"/>
              <a:gd name="connsiteY95" fmla="*/ 1328440 h 1370139"/>
              <a:gd name="connsiteX96" fmla="*/ 1012696 w 1012696"/>
              <a:gd name="connsiteY96" fmla="*/ 1164622 h 1370139"/>
              <a:gd name="connsiteX97" fmla="*/ 1009718 w 1012696"/>
              <a:gd name="connsiteY97" fmla="*/ 1116966 h 1370139"/>
              <a:gd name="connsiteX98" fmla="*/ 1006739 w 1012696"/>
              <a:gd name="connsiteY98" fmla="*/ 1099095 h 1370139"/>
              <a:gd name="connsiteX99" fmla="*/ 1000782 w 1012696"/>
              <a:gd name="connsiteY99" fmla="*/ 1081224 h 1370139"/>
              <a:gd name="connsiteX100" fmla="*/ 1003761 w 1012696"/>
              <a:gd name="connsiteY100" fmla="*/ 1060375 h 1370139"/>
              <a:gd name="connsiteX101" fmla="*/ 1009718 w 1012696"/>
              <a:gd name="connsiteY101" fmla="*/ 1012719 h 1370139"/>
              <a:gd name="connsiteX102" fmla="*/ 1012696 w 1012696"/>
              <a:gd name="connsiteY102" fmla="*/ 997826 h 1370139"/>
              <a:gd name="connsiteX103" fmla="*/ 1009718 w 1012696"/>
              <a:gd name="connsiteY103" fmla="*/ 914428 h 1370139"/>
              <a:gd name="connsiteX104" fmla="*/ 1006739 w 1012696"/>
              <a:gd name="connsiteY104" fmla="*/ 899536 h 1370139"/>
              <a:gd name="connsiteX105" fmla="*/ 1000782 w 1012696"/>
              <a:gd name="connsiteY105" fmla="*/ 878686 h 1370139"/>
              <a:gd name="connsiteX106" fmla="*/ 991847 w 1012696"/>
              <a:gd name="connsiteY106" fmla="*/ 869751 h 1370139"/>
              <a:gd name="connsiteX107" fmla="*/ 973976 w 1012696"/>
              <a:gd name="connsiteY107" fmla="*/ 857837 h 1370139"/>
              <a:gd name="connsiteX108" fmla="*/ 965040 w 1012696"/>
              <a:gd name="connsiteY108" fmla="*/ 851880 h 1370139"/>
              <a:gd name="connsiteX109" fmla="*/ 956105 w 1012696"/>
              <a:gd name="connsiteY109" fmla="*/ 842944 h 1370139"/>
              <a:gd name="connsiteX110" fmla="*/ 938234 w 1012696"/>
              <a:gd name="connsiteY110" fmla="*/ 834009 h 1370139"/>
              <a:gd name="connsiteX111" fmla="*/ 902492 w 1012696"/>
              <a:gd name="connsiteY111" fmla="*/ 831030 h 1370139"/>
              <a:gd name="connsiteX112" fmla="*/ 878664 w 1012696"/>
              <a:gd name="connsiteY112" fmla="*/ 828052 h 1370139"/>
              <a:gd name="connsiteX113" fmla="*/ 869728 w 1012696"/>
              <a:gd name="connsiteY113" fmla="*/ 825073 h 1370139"/>
              <a:gd name="connsiteX114" fmla="*/ 848879 w 1012696"/>
              <a:gd name="connsiteY114" fmla="*/ 819116 h 1370139"/>
              <a:gd name="connsiteX115" fmla="*/ 831008 w 1012696"/>
              <a:gd name="connsiteY115" fmla="*/ 810181 h 1370139"/>
              <a:gd name="connsiteX116" fmla="*/ 822072 w 1012696"/>
              <a:gd name="connsiteY116" fmla="*/ 804224 h 1370139"/>
              <a:gd name="connsiteX117" fmla="*/ 813137 w 1012696"/>
              <a:gd name="connsiteY117" fmla="*/ 801245 h 1370139"/>
              <a:gd name="connsiteX118" fmla="*/ 804201 w 1012696"/>
              <a:gd name="connsiteY118" fmla="*/ 792310 h 1370139"/>
              <a:gd name="connsiteX119" fmla="*/ 795266 w 1012696"/>
              <a:gd name="connsiteY119" fmla="*/ 789331 h 1370139"/>
              <a:gd name="connsiteX120" fmla="*/ 777395 w 1012696"/>
              <a:gd name="connsiteY120" fmla="*/ 777417 h 1370139"/>
              <a:gd name="connsiteX121" fmla="*/ 762502 w 1012696"/>
              <a:gd name="connsiteY121" fmla="*/ 750611 h 1370139"/>
              <a:gd name="connsiteX122" fmla="*/ 756545 w 1012696"/>
              <a:gd name="connsiteY122" fmla="*/ 741675 h 1370139"/>
              <a:gd name="connsiteX123" fmla="*/ 750588 w 1012696"/>
              <a:gd name="connsiteY123" fmla="*/ 732740 h 1370139"/>
              <a:gd name="connsiteX124" fmla="*/ 741653 w 1012696"/>
              <a:gd name="connsiteY124" fmla="*/ 705933 h 1370139"/>
              <a:gd name="connsiteX125" fmla="*/ 738674 w 1012696"/>
              <a:gd name="connsiteY125" fmla="*/ 696998 h 1370139"/>
              <a:gd name="connsiteX126" fmla="*/ 732717 w 1012696"/>
              <a:gd name="connsiteY126" fmla="*/ 688062 h 1370139"/>
              <a:gd name="connsiteX127" fmla="*/ 723782 w 1012696"/>
              <a:gd name="connsiteY127" fmla="*/ 670191 h 1370139"/>
              <a:gd name="connsiteX128" fmla="*/ 717825 w 1012696"/>
              <a:gd name="connsiteY128" fmla="*/ 652320 h 1370139"/>
              <a:gd name="connsiteX129" fmla="*/ 711868 w 1012696"/>
              <a:gd name="connsiteY129" fmla="*/ 634449 h 1370139"/>
              <a:gd name="connsiteX130" fmla="*/ 705911 w 1012696"/>
              <a:gd name="connsiteY130" fmla="*/ 613600 h 1370139"/>
              <a:gd name="connsiteX131" fmla="*/ 699954 w 1012696"/>
              <a:gd name="connsiteY131" fmla="*/ 604664 h 1370139"/>
              <a:gd name="connsiteX132" fmla="*/ 696975 w 1012696"/>
              <a:gd name="connsiteY132" fmla="*/ 506373 h 1370139"/>
              <a:gd name="connsiteX133" fmla="*/ 693997 w 1012696"/>
              <a:gd name="connsiteY133" fmla="*/ 497438 h 1370139"/>
              <a:gd name="connsiteX134" fmla="*/ 691018 w 1012696"/>
              <a:gd name="connsiteY134" fmla="*/ 479567 h 1370139"/>
              <a:gd name="connsiteX135" fmla="*/ 688040 w 1012696"/>
              <a:gd name="connsiteY135" fmla="*/ 470631 h 1370139"/>
              <a:gd name="connsiteX136" fmla="*/ 679104 w 1012696"/>
              <a:gd name="connsiteY136" fmla="*/ 437868 h 1370139"/>
              <a:gd name="connsiteX137" fmla="*/ 676126 w 1012696"/>
              <a:gd name="connsiteY137" fmla="*/ 428932 h 1370139"/>
              <a:gd name="connsiteX138" fmla="*/ 673147 w 1012696"/>
              <a:gd name="connsiteY138" fmla="*/ 399147 h 1370139"/>
              <a:gd name="connsiteX139" fmla="*/ 670169 w 1012696"/>
              <a:gd name="connsiteY139" fmla="*/ 390212 h 1370139"/>
              <a:gd name="connsiteX140" fmla="*/ 661233 w 1012696"/>
              <a:gd name="connsiteY140" fmla="*/ 381276 h 1370139"/>
              <a:gd name="connsiteX141" fmla="*/ 655276 w 1012696"/>
              <a:gd name="connsiteY141" fmla="*/ 363405 h 1370139"/>
              <a:gd name="connsiteX142" fmla="*/ 646341 w 1012696"/>
              <a:gd name="connsiteY142" fmla="*/ 357448 h 1370139"/>
              <a:gd name="connsiteX143" fmla="*/ 625491 w 1012696"/>
              <a:gd name="connsiteY143" fmla="*/ 336599 h 1370139"/>
              <a:gd name="connsiteX144" fmla="*/ 595706 w 1012696"/>
              <a:gd name="connsiteY144" fmla="*/ 321706 h 1370139"/>
              <a:gd name="connsiteX145" fmla="*/ 586771 w 1012696"/>
              <a:gd name="connsiteY145" fmla="*/ 318728 h 1370139"/>
              <a:gd name="connsiteX146" fmla="*/ 574857 w 1012696"/>
              <a:gd name="connsiteY146" fmla="*/ 312771 h 1370139"/>
              <a:gd name="connsiteX147" fmla="*/ 565921 w 1012696"/>
              <a:gd name="connsiteY147" fmla="*/ 306814 h 1370139"/>
              <a:gd name="connsiteX148" fmla="*/ 545072 w 1012696"/>
              <a:gd name="connsiteY148" fmla="*/ 300857 h 1370139"/>
              <a:gd name="connsiteX149" fmla="*/ 542093 w 1012696"/>
              <a:gd name="connsiteY149" fmla="*/ 291921 h 1370139"/>
              <a:gd name="connsiteX150" fmla="*/ 515287 w 1012696"/>
              <a:gd name="connsiteY150" fmla="*/ 271072 h 1370139"/>
              <a:gd name="connsiteX151" fmla="*/ 497416 w 1012696"/>
              <a:gd name="connsiteY151" fmla="*/ 244265 h 1370139"/>
              <a:gd name="connsiteX152" fmla="*/ 491459 w 1012696"/>
              <a:gd name="connsiteY152" fmla="*/ 235330 h 1370139"/>
              <a:gd name="connsiteX153" fmla="*/ 485502 w 1012696"/>
              <a:gd name="connsiteY153" fmla="*/ 226394 h 1370139"/>
              <a:gd name="connsiteX154" fmla="*/ 467631 w 1012696"/>
              <a:gd name="connsiteY154" fmla="*/ 208523 h 1370139"/>
              <a:gd name="connsiteX155" fmla="*/ 455717 w 1012696"/>
              <a:gd name="connsiteY155" fmla="*/ 190652 h 1370139"/>
              <a:gd name="connsiteX156" fmla="*/ 449760 w 1012696"/>
              <a:gd name="connsiteY156" fmla="*/ 181717 h 1370139"/>
              <a:gd name="connsiteX157" fmla="*/ 440824 w 1012696"/>
              <a:gd name="connsiteY157" fmla="*/ 172781 h 1370139"/>
              <a:gd name="connsiteX158" fmla="*/ 434867 w 1012696"/>
              <a:gd name="connsiteY158" fmla="*/ 163846 h 1370139"/>
              <a:gd name="connsiteX159" fmla="*/ 422953 w 1012696"/>
              <a:gd name="connsiteY159" fmla="*/ 154910 h 1370139"/>
              <a:gd name="connsiteX160" fmla="*/ 416996 w 1012696"/>
              <a:gd name="connsiteY160" fmla="*/ 140018 h 1370139"/>
              <a:gd name="connsiteX161" fmla="*/ 396147 w 1012696"/>
              <a:gd name="connsiteY161" fmla="*/ 113211 h 1370139"/>
              <a:gd name="connsiteX162" fmla="*/ 393168 w 1012696"/>
              <a:gd name="connsiteY162" fmla="*/ 104276 h 1370139"/>
              <a:gd name="connsiteX163" fmla="*/ 387211 w 1012696"/>
              <a:gd name="connsiteY163" fmla="*/ 83426 h 1370139"/>
              <a:gd name="connsiteX164" fmla="*/ 384233 w 1012696"/>
              <a:gd name="connsiteY164" fmla="*/ 53641 h 1370139"/>
              <a:gd name="connsiteX165" fmla="*/ 381254 w 1012696"/>
              <a:gd name="connsiteY165" fmla="*/ 8964 h 1370139"/>
              <a:gd name="connsiteX166" fmla="*/ 357426 w 1012696"/>
              <a:gd name="connsiteY166" fmla="*/ 11942 h 1370139"/>
              <a:gd name="connsiteX167" fmla="*/ 336577 w 1012696"/>
              <a:gd name="connsiteY167" fmla="*/ 17899 h 1370139"/>
              <a:gd name="connsiteX168" fmla="*/ 282964 w 1012696"/>
              <a:gd name="connsiteY168" fmla="*/ 14921 h 1370139"/>
              <a:gd name="connsiteX169" fmla="*/ 244243 w 1012696"/>
              <a:gd name="connsiteY169" fmla="*/ 11942 h 1370139"/>
              <a:gd name="connsiteX170" fmla="*/ 145952 w 1012696"/>
              <a:gd name="connsiteY170" fmla="*/ 28 h 137013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 ang="0">
                <a:pos x="connsiteX136" y="connsiteY136"/>
              </a:cxn>
              <a:cxn ang="0">
                <a:pos x="connsiteX137" y="connsiteY137"/>
              </a:cxn>
              <a:cxn ang="0">
                <a:pos x="connsiteX138" y="connsiteY138"/>
              </a:cxn>
              <a:cxn ang="0">
                <a:pos x="connsiteX139" y="connsiteY139"/>
              </a:cxn>
              <a:cxn ang="0">
                <a:pos x="connsiteX140" y="connsiteY140"/>
              </a:cxn>
              <a:cxn ang="0">
                <a:pos x="connsiteX141" y="connsiteY141"/>
              </a:cxn>
              <a:cxn ang="0">
                <a:pos x="connsiteX142" y="connsiteY142"/>
              </a:cxn>
              <a:cxn ang="0">
                <a:pos x="connsiteX143" y="connsiteY143"/>
              </a:cxn>
              <a:cxn ang="0">
                <a:pos x="connsiteX144" y="connsiteY144"/>
              </a:cxn>
              <a:cxn ang="0">
                <a:pos x="connsiteX145" y="connsiteY145"/>
              </a:cxn>
              <a:cxn ang="0">
                <a:pos x="connsiteX146" y="connsiteY146"/>
              </a:cxn>
              <a:cxn ang="0">
                <a:pos x="connsiteX147" y="connsiteY147"/>
              </a:cxn>
              <a:cxn ang="0">
                <a:pos x="connsiteX148" y="connsiteY148"/>
              </a:cxn>
              <a:cxn ang="0">
                <a:pos x="connsiteX149" y="connsiteY149"/>
              </a:cxn>
              <a:cxn ang="0">
                <a:pos x="connsiteX150" y="connsiteY150"/>
              </a:cxn>
              <a:cxn ang="0">
                <a:pos x="connsiteX151" y="connsiteY151"/>
              </a:cxn>
              <a:cxn ang="0">
                <a:pos x="connsiteX152" y="connsiteY152"/>
              </a:cxn>
              <a:cxn ang="0">
                <a:pos x="connsiteX153" y="connsiteY153"/>
              </a:cxn>
              <a:cxn ang="0">
                <a:pos x="connsiteX154" y="connsiteY154"/>
              </a:cxn>
              <a:cxn ang="0">
                <a:pos x="connsiteX155" y="connsiteY155"/>
              </a:cxn>
              <a:cxn ang="0">
                <a:pos x="connsiteX156" y="connsiteY156"/>
              </a:cxn>
              <a:cxn ang="0">
                <a:pos x="connsiteX157" y="connsiteY157"/>
              </a:cxn>
              <a:cxn ang="0">
                <a:pos x="connsiteX158" y="connsiteY158"/>
              </a:cxn>
              <a:cxn ang="0">
                <a:pos x="connsiteX159" y="connsiteY159"/>
              </a:cxn>
              <a:cxn ang="0">
                <a:pos x="connsiteX160" y="connsiteY160"/>
              </a:cxn>
              <a:cxn ang="0">
                <a:pos x="connsiteX161" y="connsiteY161"/>
              </a:cxn>
              <a:cxn ang="0">
                <a:pos x="connsiteX162" y="connsiteY162"/>
              </a:cxn>
              <a:cxn ang="0">
                <a:pos x="connsiteX163" y="connsiteY163"/>
              </a:cxn>
              <a:cxn ang="0">
                <a:pos x="connsiteX164" y="connsiteY164"/>
              </a:cxn>
              <a:cxn ang="0">
                <a:pos x="connsiteX165" y="connsiteY165"/>
              </a:cxn>
              <a:cxn ang="0">
                <a:pos x="connsiteX166" y="connsiteY166"/>
              </a:cxn>
              <a:cxn ang="0">
                <a:pos x="connsiteX167" y="connsiteY167"/>
              </a:cxn>
              <a:cxn ang="0">
                <a:pos x="connsiteX168" y="connsiteY168"/>
              </a:cxn>
              <a:cxn ang="0">
                <a:pos x="connsiteX169" y="connsiteY169"/>
              </a:cxn>
              <a:cxn ang="0">
                <a:pos x="connsiteX170" y="connsiteY170"/>
              </a:cxn>
            </a:cxnLst>
            <a:rect l="l" t="t" r="r" b="b"/>
            <a:pathLst>
              <a:path w="1012696" h="1370139">
                <a:moveTo>
                  <a:pt x="145952" y="28"/>
                </a:moveTo>
                <a:cubicBezTo>
                  <a:pt x="127088" y="524"/>
                  <a:pt x="136343" y="10298"/>
                  <a:pt x="131060" y="14921"/>
                </a:cubicBezTo>
                <a:cubicBezTo>
                  <a:pt x="128366" y="17278"/>
                  <a:pt x="124655" y="18347"/>
                  <a:pt x="122124" y="20878"/>
                </a:cubicBezTo>
                <a:cubicBezTo>
                  <a:pt x="119593" y="23409"/>
                  <a:pt x="118861" y="27456"/>
                  <a:pt x="116167" y="29813"/>
                </a:cubicBezTo>
                <a:cubicBezTo>
                  <a:pt x="102450" y="41815"/>
                  <a:pt x="99832" y="39998"/>
                  <a:pt x="86382" y="47684"/>
                </a:cubicBezTo>
                <a:cubicBezTo>
                  <a:pt x="83274" y="49460"/>
                  <a:pt x="80649" y="52040"/>
                  <a:pt x="77447" y="53641"/>
                </a:cubicBezTo>
                <a:cubicBezTo>
                  <a:pt x="74639" y="55045"/>
                  <a:pt x="71319" y="55216"/>
                  <a:pt x="68511" y="56620"/>
                </a:cubicBezTo>
                <a:cubicBezTo>
                  <a:pt x="65309" y="58221"/>
                  <a:pt x="62489" y="60496"/>
                  <a:pt x="59576" y="62577"/>
                </a:cubicBezTo>
                <a:cubicBezTo>
                  <a:pt x="55537" y="65462"/>
                  <a:pt x="52102" y="69292"/>
                  <a:pt x="47662" y="71512"/>
                </a:cubicBezTo>
                <a:cubicBezTo>
                  <a:pt x="44001" y="73343"/>
                  <a:pt x="39719" y="73498"/>
                  <a:pt x="35748" y="74491"/>
                </a:cubicBezTo>
                <a:cubicBezTo>
                  <a:pt x="33762" y="77469"/>
                  <a:pt x="32322" y="80895"/>
                  <a:pt x="29791" y="83426"/>
                </a:cubicBezTo>
                <a:cubicBezTo>
                  <a:pt x="23843" y="89374"/>
                  <a:pt x="13073" y="92496"/>
                  <a:pt x="5963" y="95340"/>
                </a:cubicBezTo>
                <a:cubicBezTo>
                  <a:pt x="-5414" y="118094"/>
                  <a:pt x="2984" y="95647"/>
                  <a:pt x="2984" y="128104"/>
                </a:cubicBezTo>
                <a:cubicBezTo>
                  <a:pt x="2984" y="142039"/>
                  <a:pt x="999" y="155903"/>
                  <a:pt x="6" y="169803"/>
                </a:cubicBezTo>
                <a:cubicBezTo>
                  <a:pt x="3996" y="197739"/>
                  <a:pt x="-910" y="184811"/>
                  <a:pt x="14898" y="208523"/>
                </a:cubicBezTo>
                <a:lnTo>
                  <a:pt x="14898" y="208523"/>
                </a:lnTo>
                <a:cubicBezTo>
                  <a:pt x="16860" y="214410"/>
                  <a:pt x="18585" y="222195"/>
                  <a:pt x="23834" y="226394"/>
                </a:cubicBezTo>
                <a:cubicBezTo>
                  <a:pt x="26286" y="228355"/>
                  <a:pt x="29961" y="227969"/>
                  <a:pt x="32769" y="229373"/>
                </a:cubicBezTo>
                <a:cubicBezTo>
                  <a:pt x="43865" y="234921"/>
                  <a:pt x="40756" y="236028"/>
                  <a:pt x="50640" y="244265"/>
                </a:cubicBezTo>
                <a:cubicBezTo>
                  <a:pt x="53390" y="246557"/>
                  <a:pt x="56597" y="248236"/>
                  <a:pt x="59576" y="250222"/>
                </a:cubicBezTo>
                <a:cubicBezTo>
                  <a:pt x="60569" y="253201"/>
                  <a:pt x="60593" y="256706"/>
                  <a:pt x="62554" y="259158"/>
                </a:cubicBezTo>
                <a:cubicBezTo>
                  <a:pt x="66753" y="264407"/>
                  <a:pt x="74539" y="266131"/>
                  <a:pt x="80425" y="268093"/>
                </a:cubicBezTo>
                <a:cubicBezTo>
                  <a:pt x="83404" y="271072"/>
                  <a:pt x="85856" y="274692"/>
                  <a:pt x="89361" y="277029"/>
                </a:cubicBezTo>
                <a:cubicBezTo>
                  <a:pt x="91973" y="278770"/>
                  <a:pt x="96076" y="277787"/>
                  <a:pt x="98296" y="280007"/>
                </a:cubicBezTo>
                <a:cubicBezTo>
                  <a:pt x="100516" y="282227"/>
                  <a:pt x="99871" y="286135"/>
                  <a:pt x="101275" y="288943"/>
                </a:cubicBezTo>
                <a:cubicBezTo>
                  <a:pt x="103451" y="293295"/>
                  <a:pt x="114146" y="307097"/>
                  <a:pt x="116167" y="309792"/>
                </a:cubicBezTo>
                <a:cubicBezTo>
                  <a:pt x="120495" y="322777"/>
                  <a:pt x="120215" y="327160"/>
                  <a:pt x="128081" y="336599"/>
                </a:cubicBezTo>
                <a:cubicBezTo>
                  <a:pt x="130778" y="339835"/>
                  <a:pt x="134038" y="342556"/>
                  <a:pt x="137017" y="345534"/>
                </a:cubicBezTo>
                <a:cubicBezTo>
                  <a:pt x="144500" y="367989"/>
                  <a:pt x="134407" y="340317"/>
                  <a:pt x="145952" y="363405"/>
                </a:cubicBezTo>
                <a:cubicBezTo>
                  <a:pt x="158284" y="388067"/>
                  <a:pt x="137817" y="355671"/>
                  <a:pt x="154888" y="381276"/>
                </a:cubicBezTo>
                <a:lnTo>
                  <a:pt x="163823" y="408083"/>
                </a:lnTo>
                <a:cubicBezTo>
                  <a:pt x="164816" y="411061"/>
                  <a:pt x="165061" y="414406"/>
                  <a:pt x="166802" y="417018"/>
                </a:cubicBezTo>
                <a:lnTo>
                  <a:pt x="172759" y="425954"/>
                </a:lnTo>
                <a:cubicBezTo>
                  <a:pt x="181798" y="453073"/>
                  <a:pt x="167929" y="410232"/>
                  <a:pt x="178716" y="449782"/>
                </a:cubicBezTo>
                <a:cubicBezTo>
                  <a:pt x="188274" y="484827"/>
                  <a:pt x="183389" y="449730"/>
                  <a:pt x="190630" y="500416"/>
                </a:cubicBezTo>
                <a:cubicBezTo>
                  <a:pt x="192041" y="510294"/>
                  <a:pt x="192198" y="520323"/>
                  <a:pt x="193609" y="530201"/>
                </a:cubicBezTo>
                <a:cubicBezTo>
                  <a:pt x="194545" y="536751"/>
                  <a:pt x="197443" y="544682"/>
                  <a:pt x="199566" y="551051"/>
                </a:cubicBezTo>
                <a:cubicBezTo>
                  <a:pt x="200559" y="563958"/>
                  <a:pt x="201114" y="576906"/>
                  <a:pt x="202544" y="589772"/>
                </a:cubicBezTo>
                <a:cubicBezTo>
                  <a:pt x="203103" y="594803"/>
                  <a:pt x="204617" y="599683"/>
                  <a:pt x="205523" y="604664"/>
                </a:cubicBezTo>
                <a:cubicBezTo>
                  <a:pt x="206603" y="610606"/>
                  <a:pt x="207834" y="616533"/>
                  <a:pt x="208501" y="622535"/>
                </a:cubicBezTo>
                <a:cubicBezTo>
                  <a:pt x="210153" y="637400"/>
                  <a:pt x="210439" y="660070"/>
                  <a:pt x="214458" y="676148"/>
                </a:cubicBezTo>
                <a:cubicBezTo>
                  <a:pt x="215981" y="682240"/>
                  <a:pt x="218429" y="688062"/>
                  <a:pt x="220415" y="694019"/>
                </a:cubicBezTo>
                <a:cubicBezTo>
                  <a:pt x="221408" y="696998"/>
                  <a:pt x="221652" y="700343"/>
                  <a:pt x="223394" y="702955"/>
                </a:cubicBezTo>
                <a:lnTo>
                  <a:pt x="235308" y="720826"/>
                </a:lnTo>
                <a:cubicBezTo>
                  <a:pt x="241159" y="738380"/>
                  <a:pt x="234342" y="721067"/>
                  <a:pt x="247222" y="741675"/>
                </a:cubicBezTo>
                <a:cubicBezTo>
                  <a:pt x="249575" y="745440"/>
                  <a:pt x="251193" y="749618"/>
                  <a:pt x="253179" y="753589"/>
                </a:cubicBezTo>
                <a:cubicBezTo>
                  <a:pt x="258669" y="775552"/>
                  <a:pt x="252770" y="755615"/>
                  <a:pt x="262114" y="777417"/>
                </a:cubicBezTo>
                <a:cubicBezTo>
                  <a:pt x="263351" y="780303"/>
                  <a:pt x="263689" y="783545"/>
                  <a:pt x="265093" y="786353"/>
                </a:cubicBezTo>
                <a:cubicBezTo>
                  <a:pt x="266694" y="789555"/>
                  <a:pt x="269274" y="792180"/>
                  <a:pt x="271050" y="795288"/>
                </a:cubicBezTo>
                <a:cubicBezTo>
                  <a:pt x="273253" y="799143"/>
                  <a:pt x="274165" y="803791"/>
                  <a:pt x="277007" y="807202"/>
                </a:cubicBezTo>
                <a:cubicBezTo>
                  <a:pt x="279299" y="809952"/>
                  <a:pt x="282964" y="811173"/>
                  <a:pt x="285942" y="813159"/>
                </a:cubicBezTo>
                <a:cubicBezTo>
                  <a:pt x="286935" y="819116"/>
                  <a:pt x="286598" y="825455"/>
                  <a:pt x="288921" y="831030"/>
                </a:cubicBezTo>
                <a:cubicBezTo>
                  <a:pt x="291675" y="837639"/>
                  <a:pt x="296864" y="842944"/>
                  <a:pt x="300835" y="848901"/>
                </a:cubicBezTo>
                <a:cubicBezTo>
                  <a:pt x="307378" y="858716"/>
                  <a:pt x="317619" y="875345"/>
                  <a:pt x="327641" y="878686"/>
                </a:cubicBezTo>
                <a:cubicBezTo>
                  <a:pt x="350110" y="886176"/>
                  <a:pt x="322408" y="876071"/>
                  <a:pt x="345512" y="887622"/>
                </a:cubicBezTo>
                <a:cubicBezTo>
                  <a:pt x="348320" y="889026"/>
                  <a:pt x="351469" y="889607"/>
                  <a:pt x="354448" y="890600"/>
                </a:cubicBezTo>
                <a:cubicBezTo>
                  <a:pt x="357426" y="892586"/>
                  <a:pt x="360093" y="895147"/>
                  <a:pt x="363383" y="896557"/>
                </a:cubicBezTo>
                <a:cubicBezTo>
                  <a:pt x="367146" y="898170"/>
                  <a:pt x="371222" y="899148"/>
                  <a:pt x="375297" y="899536"/>
                </a:cubicBezTo>
                <a:cubicBezTo>
                  <a:pt x="392128" y="901139"/>
                  <a:pt x="409054" y="901521"/>
                  <a:pt x="425932" y="902514"/>
                </a:cubicBezTo>
                <a:cubicBezTo>
                  <a:pt x="427517" y="902910"/>
                  <a:pt x="444219" y="906763"/>
                  <a:pt x="446781" y="908471"/>
                </a:cubicBezTo>
                <a:cubicBezTo>
                  <a:pt x="450286" y="910808"/>
                  <a:pt x="452481" y="914710"/>
                  <a:pt x="455717" y="917407"/>
                </a:cubicBezTo>
                <a:cubicBezTo>
                  <a:pt x="458467" y="919699"/>
                  <a:pt x="461674" y="921378"/>
                  <a:pt x="464652" y="923364"/>
                </a:cubicBezTo>
                <a:cubicBezTo>
                  <a:pt x="468623" y="929321"/>
                  <a:pt x="471503" y="936173"/>
                  <a:pt x="476566" y="941235"/>
                </a:cubicBezTo>
                <a:cubicBezTo>
                  <a:pt x="479545" y="944213"/>
                  <a:pt x="482916" y="946845"/>
                  <a:pt x="485502" y="950170"/>
                </a:cubicBezTo>
                <a:cubicBezTo>
                  <a:pt x="493881" y="960942"/>
                  <a:pt x="497481" y="970099"/>
                  <a:pt x="506351" y="979955"/>
                </a:cubicBezTo>
                <a:cubicBezTo>
                  <a:pt x="511987" y="986217"/>
                  <a:pt x="518265" y="991869"/>
                  <a:pt x="524222" y="997826"/>
                </a:cubicBezTo>
                <a:cubicBezTo>
                  <a:pt x="527201" y="1000805"/>
                  <a:pt x="530821" y="1003257"/>
                  <a:pt x="533158" y="1006762"/>
                </a:cubicBezTo>
                <a:cubicBezTo>
                  <a:pt x="543789" y="1022707"/>
                  <a:pt x="536582" y="1013164"/>
                  <a:pt x="556986" y="1033568"/>
                </a:cubicBezTo>
                <a:cubicBezTo>
                  <a:pt x="559964" y="1036547"/>
                  <a:pt x="562416" y="1040168"/>
                  <a:pt x="565921" y="1042504"/>
                </a:cubicBezTo>
                <a:cubicBezTo>
                  <a:pt x="572991" y="1047217"/>
                  <a:pt x="580308" y="1051856"/>
                  <a:pt x="586771" y="1057396"/>
                </a:cubicBezTo>
                <a:cubicBezTo>
                  <a:pt x="589969" y="1060137"/>
                  <a:pt x="592470" y="1063635"/>
                  <a:pt x="595706" y="1066332"/>
                </a:cubicBezTo>
                <a:cubicBezTo>
                  <a:pt x="598456" y="1068624"/>
                  <a:pt x="601966" y="1069911"/>
                  <a:pt x="604642" y="1072289"/>
                </a:cubicBezTo>
                <a:cubicBezTo>
                  <a:pt x="635249" y="1099495"/>
                  <a:pt x="611167" y="1082596"/>
                  <a:pt x="631448" y="1096117"/>
                </a:cubicBezTo>
                <a:cubicBezTo>
                  <a:pt x="635419" y="1102074"/>
                  <a:pt x="641098" y="1107196"/>
                  <a:pt x="643362" y="1113988"/>
                </a:cubicBezTo>
                <a:cubicBezTo>
                  <a:pt x="648606" y="1129715"/>
                  <a:pt x="644599" y="1120310"/>
                  <a:pt x="658255" y="1140794"/>
                </a:cubicBezTo>
                <a:cubicBezTo>
                  <a:pt x="660241" y="1143773"/>
                  <a:pt x="661233" y="1147744"/>
                  <a:pt x="664212" y="1149730"/>
                </a:cubicBezTo>
                <a:lnTo>
                  <a:pt x="673147" y="1155687"/>
                </a:lnTo>
                <a:cubicBezTo>
                  <a:pt x="675133" y="1158665"/>
                  <a:pt x="676573" y="1162091"/>
                  <a:pt x="679104" y="1164622"/>
                </a:cubicBezTo>
                <a:cubicBezTo>
                  <a:pt x="687639" y="1173157"/>
                  <a:pt x="687286" y="1168713"/>
                  <a:pt x="696975" y="1173558"/>
                </a:cubicBezTo>
                <a:cubicBezTo>
                  <a:pt x="700747" y="1175444"/>
                  <a:pt x="715935" y="1186830"/>
                  <a:pt x="717825" y="1188450"/>
                </a:cubicBezTo>
                <a:cubicBezTo>
                  <a:pt x="725798" y="1195284"/>
                  <a:pt x="729503" y="1200631"/>
                  <a:pt x="735696" y="1209300"/>
                </a:cubicBezTo>
                <a:cubicBezTo>
                  <a:pt x="737777" y="1212213"/>
                  <a:pt x="738545" y="1216459"/>
                  <a:pt x="741653" y="1218235"/>
                </a:cubicBezTo>
                <a:cubicBezTo>
                  <a:pt x="746048" y="1220747"/>
                  <a:pt x="751581" y="1220221"/>
                  <a:pt x="756545" y="1221214"/>
                </a:cubicBezTo>
                <a:cubicBezTo>
                  <a:pt x="758531" y="1224192"/>
                  <a:pt x="761245" y="1226797"/>
                  <a:pt x="762502" y="1230149"/>
                </a:cubicBezTo>
                <a:cubicBezTo>
                  <a:pt x="765719" y="1238727"/>
                  <a:pt x="767631" y="1266879"/>
                  <a:pt x="768459" y="1271848"/>
                </a:cubicBezTo>
                <a:cubicBezTo>
                  <a:pt x="768975" y="1274945"/>
                  <a:pt x="770445" y="1277805"/>
                  <a:pt x="771438" y="1280784"/>
                </a:cubicBezTo>
                <a:cubicBezTo>
                  <a:pt x="781495" y="1341135"/>
                  <a:pt x="766219" y="1255197"/>
                  <a:pt x="780373" y="1316526"/>
                </a:cubicBezTo>
                <a:cubicBezTo>
                  <a:pt x="787138" y="1345838"/>
                  <a:pt x="777786" y="1329025"/>
                  <a:pt x="789309" y="1346311"/>
                </a:cubicBezTo>
                <a:cubicBezTo>
                  <a:pt x="790302" y="1349289"/>
                  <a:pt x="790067" y="1353026"/>
                  <a:pt x="792287" y="1355246"/>
                </a:cubicBezTo>
                <a:cubicBezTo>
                  <a:pt x="793907" y="1356866"/>
                  <a:pt x="809254" y="1363858"/>
                  <a:pt x="813137" y="1364182"/>
                </a:cubicBezTo>
                <a:cubicBezTo>
                  <a:pt x="833938" y="1365915"/>
                  <a:pt x="854841" y="1366063"/>
                  <a:pt x="875685" y="1367160"/>
                </a:cubicBezTo>
                <a:lnTo>
                  <a:pt x="926320" y="1370139"/>
                </a:lnTo>
                <a:cubicBezTo>
                  <a:pt x="946177" y="1369146"/>
                  <a:pt x="966083" y="1368882"/>
                  <a:pt x="985890" y="1367160"/>
                </a:cubicBezTo>
                <a:cubicBezTo>
                  <a:pt x="989018" y="1366888"/>
                  <a:pt x="992374" y="1366143"/>
                  <a:pt x="994825" y="1364182"/>
                </a:cubicBezTo>
                <a:cubicBezTo>
                  <a:pt x="1003485" y="1357254"/>
                  <a:pt x="1001018" y="1345956"/>
                  <a:pt x="1006739" y="1337375"/>
                </a:cubicBezTo>
                <a:lnTo>
                  <a:pt x="1012696" y="1328440"/>
                </a:lnTo>
                <a:cubicBezTo>
                  <a:pt x="997190" y="1266404"/>
                  <a:pt x="1012696" y="1332854"/>
                  <a:pt x="1012696" y="1164622"/>
                </a:cubicBezTo>
                <a:cubicBezTo>
                  <a:pt x="1012696" y="1148706"/>
                  <a:pt x="1011159" y="1132817"/>
                  <a:pt x="1009718" y="1116966"/>
                </a:cubicBezTo>
                <a:cubicBezTo>
                  <a:pt x="1009171" y="1110952"/>
                  <a:pt x="1008204" y="1104954"/>
                  <a:pt x="1006739" y="1099095"/>
                </a:cubicBezTo>
                <a:cubicBezTo>
                  <a:pt x="1005216" y="1093003"/>
                  <a:pt x="1000782" y="1081224"/>
                  <a:pt x="1000782" y="1081224"/>
                </a:cubicBezTo>
                <a:cubicBezTo>
                  <a:pt x="1001775" y="1074274"/>
                  <a:pt x="1002853" y="1067336"/>
                  <a:pt x="1003761" y="1060375"/>
                </a:cubicBezTo>
                <a:cubicBezTo>
                  <a:pt x="1005832" y="1044501"/>
                  <a:pt x="1006579" y="1028417"/>
                  <a:pt x="1009718" y="1012719"/>
                </a:cubicBezTo>
                <a:lnTo>
                  <a:pt x="1012696" y="997826"/>
                </a:lnTo>
                <a:cubicBezTo>
                  <a:pt x="1011703" y="970027"/>
                  <a:pt x="1011401" y="942194"/>
                  <a:pt x="1009718" y="914428"/>
                </a:cubicBezTo>
                <a:cubicBezTo>
                  <a:pt x="1009412" y="909375"/>
                  <a:pt x="1007837" y="904478"/>
                  <a:pt x="1006739" y="899536"/>
                </a:cubicBezTo>
                <a:cubicBezTo>
                  <a:pt x="1006407" y="898043"/>
                  <a:pt x="1002442" y="881176"/>
                  <a:pt x="1000782" y="878686"/>
                </a:cubicBezTo>
                <a:cubicBezTo>
                  <a:pt x="998446" y="875181"/>
                  <a:pt x="995172" y="872337"/>
                  <a:pt x="991847" y="869751"/>
                </a:cubicBezTo>
                <a:cubicBezTo>
                  <a:pt x="986196" y="865356"/>
                  <a:pt x="979933" y="861808"/>
                  <a:pt x="973976" y="857837"/>
                </a:cubicBezTo>
                <a:cubicBezTo>
                  <a:pt x="970997" y="855851"/>
                  <a:pt x="967571" y="854411"/>
                  <a:pt x="965040" y="851880"/>
                </a:cubicBezTo>
                <a:cubicBezTo>
                  <a:pt x="962062" y="848901"/>
                  <a:pt x="959341" y="845641"/>
                  <a:pt x="956105" y="842944"/>
                </a:cubicBezTo>
                <a:cubicBezTo>
                  <a:pt x="951324" y="838960"/>
                  <a:pt x="944631" y="834862"/>
                  <a:pt x="938234" y="834009"/>
                </a:cubicBezTo>
                <a:cubicBezTo>
                  <a:pt x="926384" y="832429"/>
                  <a:pt x="914388" y="832220"/>
                  <a:pt x="902492" y="831030"/>
                </a:cubicBezTo>
                <a:cubicBezTo>
                  <a:pt x="894527" y="830234"/>
                  <a:pt x="886607" y="829045"/>
                  <a:pt x="878664" y="828052"/>
                </a:cubicBezTo>
                <a:cubicBezTo>
                  <a:pt x="875685" y="827059"/>
                  <a:pt x="872747" y="825936"/>
                  <a:pt x="869728" y="825073"/>
                </a:cubicBezTo>
                <a:cubicBezTo>
                  <a:pt x="865266" y="823798"/>
                  <a:pt x="853646" y="821499"/>
                  <a:pt x="848879" y="819116"/>
                </a:cubicBezTo>
                <a:cubicBezTo>
                  <a:pt x="825792" y="807572"/>
                  <a:pt x="853459" y="817664"/>
                  <a:pt x="831008" y="810181"/>
                </a:cubicBezTo>
                <a:cubicBezTo>
                  <a:pt x="828029" y="808195"/>
                  <a:pt x="825274" y="805825"/>
                  <a:pt x="822072" y="804224"/>
                </a:cubicBezTo>
                <a:cubicBezTo>
                  <a:pt x="819264" y="802820"/>
                  <a:pt x="815749" y="802986"/>
                  <a:pt x="813137" y="801245"/>
                </a:cubicBezTo>
                <a:cubicBezTo>
                  <a:pt x="809632" y="798908"/>
                  <a:pt x="807706" y="794647"/>
                  <a:pt x="804201" y="792310"/>
                </a:cubicBezTo>
                <a:cubicBezTo>
                  <a:pt x="801589" y="790569"/>
                  <a:pt x="798010" y="790856"/>
                  <a:pt x="795266" y="789331"/>
                </a:cubicBezTo>
                <a:cubicBezTo>
                  <a:pt x="789008" y="785854"/>
                  <a:pt x="777395" y="777417"/>
                  <a:pt x="777395" y="777417"/>
                </a:cubicBezTo>
                <a:cubicBezTo>
                  <a:pt x="772151" y="761690"/>
                  <a:pt x="776158" y="771095"/>
                  <a:pt x="762502" y="750611"/>
                </a:cubicBezTo>
                <a:lnTo>
                  <a:pt x="756545" y="741675"/>
                </a:lnTo>
                <a:lnTo>
                  <a:pt x="750588" y="732740"/>
                </a:lnTo>
                <a:lnTo>
                  <a:pt x="741653" y="705933"/>
                </a:lnTo>
                <a:cubicBezTo>
                  <a:pt x="740660" y="702955"/>
                  <a:pt x="740415" y="699610"/>
                  <a:pt x="738674" y="696998"/>
                </a:cubicBezTo>
                <a:lnTo>
                  <a:pt x="732717" y="688062"/>
                </a:lnTo>
                <a:cubicBezTo>
                  <a:pt x="721859" y="655484"/>
                  <a:pt x="739175" y="704827"/>
                  <a:pt x="723782" y="670191"/>
                </a:cubicBezTo>
                <a:cubicBezTo>
                  <a:pt x="721232" y="664453"/>
                  <a:pt x="719811" y="658277"/>
                  <a:pt x="717825" y="652320"/>
                </a:cubicBezTo>
                <a:lnTo>
                  <a:pt x="711868" y="634449"/>
                </a:lnTo>
                <a:cubicBezTo>
                  <a:pt x="710915" y="630636"/>
                  <a:pt x="708046" y="617870"/>
                  <a:pt x="705911" y="613600"/>
                </a:cubicBezTo>
                <a:cubicBezTo>
                  <a:pt x="704310" y="610398"/>
                  <a:pt x="701940" y="607643"/>
                  <a:pt x="699954" y="604664"/>
                </a:cubicBezTo>
                <a:cubicBezTo>
                  <a:pt x="698961" y="571900"/>
                  <a:pt x="698793" y="539101"/>
                  <a:pt x="696975" y="506373"/>
                </a:cubicBezTo>
                <a:cubicBezTo>
                  <a:pt x="696801" y="503238"/>
                  <a:pt x="694678" y="500503"/>
                  <a:pt x="693997" y="497438"/>
                </a:cubicBezTo>
                <a:cubicBezTo>
                  <a:pt x="692687" y="491543"/>
                  <a:pt x="692328" y="485462"/>
                  <a:pt x="691018" y="479567"/>
                </a:cubicBezTo>
                <a:cubicBezTo>
                  <a:pt x="690337" y="476502"/>
                  <a:pt x="688801" y="473677"/>
                  <a:pt x="688040" y="470631"/>
                </a:cubicBezTo>
                <a:cubicBezTo>
                  <a:pt x="679621" y="436953"/>
                  <a:pt x="691882" y="476206"/>
                  <a:pt x="679104" y="437868"/>
                </a:cubicBezTo>
                <a:lnTo>
                  <a:pt x="676126" y="428932"/>
                </a:lnTo>
                <a:cubicBezTo>
                  <a:pt x="675133" y="419004"/>
                  <a:pt x="674664" y="409009"/>
                  <a:pt x="673147" y="399147"/>
                </a:cubicBezTo>
                <a:cubicBezTo>
                  <a:pt x="672670" y="396044"/>
                  <a:pt x="671910" y="392824"/>
                  <a:pt x="670169" y="390212"/>
                </a:cubicBezTo>
                <a:cubicBezTo>
                  <a:pt x="667832" y="386707"/>
                  <a:pt x="664212" y="384255"/>
                  <a:pt x="661233" y="381276"/>
                </a:cubicBezTo>
                <a:cubicBezTo>
                  <a:pt x="659247" y="375319"/>
                  <a:pt x="660501" y="366888"/>
                  <a:pt x="655276" y="363405"/>
                </a:cubicBezTo>
                <a:cubicBezTo>
                  <a:pt x="652298" y="361419"/>
                  <a:pt x="649002" y="359843"/>
                  <a:pt x="646341" y="357448"/>
                </a:cubicBezTo>
                <a:cubicBezTo>
                  <a:pt x="639035" y="350873"/>
                  <a:pt x="634617" y="340249"/>
                  <a:pt x="625491" y="336599"/>
                </a:cubicBezTo>
                <a:cubicBezTo>
                  <a:pt x="587232" y="321295"/>
                  <a:pt x="634666" y="341186"/>
                  <a:pt x="595706" y="321706"/>
                </a:cubicBezTo>
                <a:cubicBezTo>
                  <a:pt x="592898" y="320302"/>
                  <a:pt x="589657" y="319965"/>
                  <a:pt x="586771" y="318728"/>
                </a:cubicBezTo>
                <a:cubicBezTo>
                  <a:pt x="582690" y="316979"/>
                  <a:pt x="578712" y="314974"/>
                  <a:pt x="574857" y="312771"/>
                </a:cubicBezTo>
                <a:cubicBezTo>
                  <a:pt x="571749" y="310995"/>
                  <a:pt x="569245" y="308144"/>
                  <a:pt x="565921" y="306814"/>
                </a:cubicBezTo>
                <a:cubicBezTo>
                  <a:pt x="559210" y="304130"/>
                  <a:pt x="552022" y="302843"/>
                  <a:pt x="545072" y="300857"/>
                </a:cubicBezTo>
                <a:cubicBezTo>
                  <a:pt x="544079" y="297878"/>
                  <a:pt x="544021" y="294399"/>
                  <a:pt x="542093" y="291921"/>
                </a:cubicBezTo>
                <a:cubicBezTo>
                  <a:pt x="528029" y="273839"/>
                  <a:pt x="529968" y="275965"/>
                  <a:pt x="515287" y="271072"/>
                </a:cubicBezTo>
                <a:lnTo>
                  <a:pt x="497416" y="244265"/>
                </a:lnTo>
                <a:lnTo>
                  <a:pt x="491459" y="235330"/>
                </a:lnTo>
                <a:cubicBezTo>
                  <a:pt x="489473" y="232351"/>
                  <a:pt x="488033" y="228925"/>
                  <a:pt x="485502" y="226394"/>
                </a:cubicBezTo>
                <a:lnTo>
                  <a:pt x="467631" y="208523"/>
                </a:lnTo>
                <a:cubicBezTo>
                  <a:pt x="462396" y="192821"/>
                  <a:pt x="468111" y="205526"/>
                  <a:pt x="455717" y="190652"/>
                </a:cubicBezTo>
                <a:cubicBezTo>
                  <a:pt x="453425" y="187902"/>
                  <a:pt x="452052" y="184467"/>
                  <a:pt x="449760" y="181717"/>
                </a:cubicBezTo>
                <a:cubicBezTo>
                  <a:pt x="447063" y="178481"/>
                  <a:pt x="443521" y="176017"/>
                  <a:pt x="440824" y="172781"/>
                </a:cubicBezTo>
                <a:cubicBezTo>
                  <a:pt x="438532" y="170031"/>
                  <a:pt x="437398" y="166377"/>
                  <a:pt x="434867" y="163846"/>
                </a:cubicBezTo>
                <a:cubicBezTo>
                  <a:pt x="431357" y="160336"/>
                  <a:pt x="426924" y="157889"/>
                  <a:pt x="422953" y="154910"/>
                </a:cubicBezTo>
                <a:cubicBezTo>
                  <a:pt x="420967" y="149946"/>
                  <a:pt x="419830" y="144552"/>
                  <a:pt x="416996" y="140018"/>
                </a:cubicBezTo>
                <a:cubicBezTo>
                  <a:pt x="405981" y="122394"/>
                  <a:pt x="405328" y="140749"/>
                  <a:pt x="396147" y="113211"/>
                </a:cubicBezTo>
                <a:cubicBezTo>
                  <a:pt x="395154" y="110233"/>
                  <a:pt x="394031" y="107295"/>
                  <a:pt x="393168" y="104276"/>
                </a:cubicBezTo>
                <a:cubicBezTo>
                  <a:pt x="385685" y="78088"/>
                  <a:pt x="394356" y="104858"/>
                  <a:pt x="387211" y="83426"/>
                </a:cubicBezTo>
                <a:cubicBezTo>
                  <a:pt x="386218" y="73498"/>
                  <a:pt x="385029" y="63587"/>
                  <a:pt x="384233" y="53641"/>
                </a:cubicBezTo>
                <a:cubicBezTo>
                  <a:pt x="383043" y="38763"/>
                  <a:pt x="389325" y="21519"/>
                  <a:pt x="381254" y="8964"/>
                </a:cubicBezTo>
                <a:cubicBezTo>
                  <a:pt x="376925" y="2231"/>
                  <a:pt x="365369" y="10949"/>
                  <a:pt x="357426" y="11942"/>
                </a:cubicBezTo>
                <a:cubicBezTo>
                  <a:pt x="353209" y="13348"/>
                  <a:pt x="340321" y="17899"/>
                  <a:pt x="336577" y="17899"/>
                </a:cubicBezTo>
                <a:cubicBezTo>
                  <a:pt x="318678" y="17899"/>
                  <a:pt x="300825" y="16073"/>
                  <a:pt x="282964" y="14921"/>
                </a:cubicBezTo>
                <a:cubicBezTo>
                  <a:pt x="270046" y="14088"/>
                  <a:pt x="257132" y="13150"/>
                  <a:pt x="244243" y="11942"/>
                </a:cubicBezTo>
                <a:cubicBezTo>
                  <a:pt x="176271" y="5569"/>
                  <a:pt x="164816" y="-468"/>
                  <a:pt x="145952" y="28"/>
                </a:cubicBezTo>
                <a:close/>
              </a:path>
            </a:pathLst>
          </a:custGeom>
          <a:noFill/>
          <a:ln w="9525">
            <a:solidFill>
              <a:srgbClr val="FFFF0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40" name="Figura a mano libera 39"/>
          <p:cNvSpPr/>
          <p:nvPr/>
        </p:nvSpPr>
        <p:spPr>
          <a:xfrm>
            <a:off x="4967016" y="2192149"/>
            <a:ext cx="1012696" cy="1370139"/>
          </a:xfrm>
          <a:custGeom>
            <a:avLst/>
            <a:gdLst>
              <a:gd name="connsiteX0" fmla="*/ 145952 w 1012696"/>
              <a:gd name="connsiteY0" fmla="*/ 28 h 1370139"/>
              <a:gd name="connsiteX1" fmla="*/ 131060 w 1012696"/>
              <a:gd name="connsiteY1" fmla="*/ 14921 h 1370139"/>
              <a:gd name="connsiteX2" fmla="*/ 122124 w 1012696"/>
              <a:gd name="connsiteY2" fmla="*/ 20878 h 1370139"/>
              <a:gd name="connsiteX3" fmla="*/ 116167 w 1012696"/>
              <a:gd name="connsiteY3" fmla="*/ 29813 h 1370139"/>
              <a:gd name="connsiteX4" fmla="*/ 86382 w 1012696"/>
              <a:gd name="connsiteY4" fmla="*/ 47684 h 1370139"/>
              <a:gd name="connsiteX5" fmla="*/ 77447 w 1012696"/>
              <a:gd name="connsiteY5" fmla="*/ 53641 h 1370139"/>
              <a:gd name="connsiteX6" fmla="*/ 68511 w 1012696"/>
              <a:gd name="connsiteY6" fmla="*/ 56620 h 1370139"/>
              <a:gd name="connsiteX7" fmla="*/ 59576 w 1012696"/>
              <a:gd name="connsiteY7" fmla="*/ 62577 h 1370139"/>
              <a:gd name="connsiteX8" fmla="*/ 47662 w 1012696"/>
              <a:gd name="connsiteY8" fmla="*/ 71512 h 1370139"/>
              <a:gd name="connsiteX9" fmla="*/ 35748 w 1012696"/>
              <a:gd name="connsiteY9" fmla="*/ 74491 h 1370139"/>
              <a:gd name="connsiteX10" fmla="*/ 29791 w 1012696"/>
              <a:gd name="connsiteY10" fmla="*/ 83426 h 1370139"/>
              <a:gd name="connsiteX11" fmla="*/ 5963 w 1012696"/>
              <a:gd name="connsiteY11" fmla="*/ 95340 h 1370139"/>
              <a:gd name="connsiteX12" fmla="*/ 2984 w 1012696"/>
              <a:gd name="connsiteY12" fmla="*/ 128104 h 1370139"/>
              <a:gd name="connsiteX13" fmla="*/ 6 w 1012696"/>
              <a:gd name="connsiteY13" fmla="*/ 169803 h 1370139"/>
              <a:gd name="connsiteX14" fmla="*/ 14898 w 1012696"/>
              <a:gd name="connsiteY14" fmla="*/ 208523 h 1370139"/>
              <a:gd name="connsiteX15" fmla="*/ 14898 w 1012696"/>
              <a:gd name="connsiteY15" fmla="*/ 208523 h 1370139"/>
              <a:gd name="connsiteX16" fmla="*/ 23834 w 1012696"/>
              <a:gd name="connsiteY16" fmla="*/ 226394 h 1370139"/>
              <a:gd name="connsiteX17" fmla="*/ 32769 w 1012696"/>
              <a:gd name="connsiteY17" fmla="*/ 229373 h 1370139"/>
              <a:gd name="connsiteX18" fmla="*/ 50640 w 1012696"/>
              <a:gd name="connsiteY18" fmla="*/ 244265 h 1370139"/>
              <a:gd name="connsiteX19" fmla="*/ 59576 w 1012696"/>
              <a:gd name="connsiteY19" fmla="*/ 250222 h 1370139"/>
              <a:gd name="connsiteX20" fmla="*/ 62554 w 1012696"/>
              <a:gd name="connsiteY20" fmla="*/ 259158 h 1370139"/>
              <a:gd name="connsiteX21" fmla="*/ 80425 w 1012696"/>
              <a:gd name="connsiteY21" fmla="*/ 268093 h 1370139"/>
              <a:gd name="connsiteX22" fmla="*/ 89361 w 1012696"/>
              <a:gd name="connsiteY22" fmla="*/ 277029 h 1370139"/>
              <a:gd name="connsiteX23" fmla="*/ 98296 w 1012696"/>
              <a:gd name="connsiteY23" fmla="*/ 280007 h 1370139"/>
              <a:gd name="connsiteX24" fmla="*/ 101275 w 1012696"/>
              <a:gd name="connsiteY24" fmla="*/ 288943 h 1370139"/>
              <a:gd name="connsiteX25" fmla="*/ 116167 w 1012696"/>
              <a:gd name="connsiteY25" fmla="*/ 309792 h 1370139"/>
              <a:gd name="connsiteX26" fmla="*/ 128081 w 1012696"/>
              <a:gd name="connsiteY26" fmla="*/ 336599 h 1370139"/>
              <a:gd name="connsiteX27" fmla="*/ 137017 w 1012696"/>
              <a:gd name="connsiteY27" fmla="*/ 345534 h 1370139"/>
              <a:gd name="connsiteX28" fmla="*/ 145952 w 1012696"/>
              <a:gd name="connsiteY28" fmla="*/ 363405 h 1370139"/>
              <a:gd name="connsiteX29" fmla="*/ 154888 w 1012696"/>
              <a:gd name="connsiteY29" fmla="*/ 381276 h 1370139"/>
              <a:gd name="connsiteX30" fmla="*/ 163823 w 1012696"/>
              <a:gd name="connsiteY30" fmla="*/ 408083 h 1370139"/>
              <a:gd name="connsiteX31" fmla="*/ 166802 w 1012696"/>
              <a:gd name="connsiteY31" fmla="*/ 417018 h 1370139"/>
              <a:gd name="connsiteX32" fmla="*/ 172759 w 1012696"/>
              <a:gd name="connsiteY32" fmla="*/ 425954 h 1370139"/>
              <a:gd name="connsiteX33" fmla="*/ 178716 w 1012696"/>
              <a:gd name="connsiteY33" fmla="*/ 449782 h 1370139"/>
              <a:gd name="connsiteX34" fmla="*/ 190630 w 1012696"/>
              <a:gd name="connsiteY34" fmla="*/ 500416 h 1370139"/>
              <a:gd name="connsiteX35" fmla="*/ 193609 w 1012696"/>
              <a:gd name="connsiteY35" fmla="*/ 530201 h 1370139"/>
              <a:gd name="connsiteX36" fmla="*/ 199566 w 1012696"/>
              <a:gd name="connsiteY36" fmla="*/ 551051 h 1370139"/>
              <a:gd name="connsiteX37" fmla="*/ 202544 w 1012696"/>
              <a:gd name="connsiteY37" fmla="*/ 589772 h 1370139"/>
              <a:gd name="connsiteX38" fmla="*/ 205523 w 1012696"/>
              <a:gd name="connsiteY38" fmla="*/ 604664 h 1370139"/>
              <a:gd name="connsiteX39" fmla="*/ 208501 w 1012696"/>
              <a:gd name="connsiteY39" fmla="*/ 622535 h 1370139"/>
              <a:gd name="connsiteX40" fmla="*/ 214458 w 1012696"/>
              <a:gd name="connsiteY40" fmla="*/ 676148 h 1370139"/>
              <a:gd name="connsiteX41" fmla="*/ 220415 w 1012696"/>
              <a:gd name="connsiteY41" fmla="*/ 694019 h 1370139"/>
              <a:gd name="connsiteX42" fmla="*/ 223394 w 1012696"/>
              <a:gd name="connsiteY42" fmla="*/ 702955 h 1370139"/>
              <a:gd name="connsiteX43" fmla="*/ 235308 w 1012696"/>
              <a:gd name="connsiteY43" fmla="*/ 720826 h 1370139"/>
              <a:gd name="connsiteX44" fmla="*/ 247222 w 1012696"/>
              <a:gd name="connsiteY44" fmla="*/ 741675 h 1370139"/>
              <a:gd name="connsiteX45" fmla="*/ 253179 w 1012696"/>
              <a:gd name="connsiteY45" fmla="*/ 753589 h 1370139"/>
              <a:gd name="connsiteX46" fmla="*/ 262114 w 1012696"/>
              <a:gd name="connsiteY46" fmla="*/ 777417 h 1370139"/>
              <a:gd name="connsiteX47" fmla="*/ 265093 w 1012696"/>
              <a:gd name="connsiteY47" fmla="*/ 786353 h 1370139"/>
              <a:gd name="connsiteX48" fmla="*/ 271050 w 1012696"/>
              <a:gd name="connsiteY48" fmla="*/ 795288 h 1370139"/>
              <a:gd name="connsiteX49" fmla="*/ 277007 w 1012696"/>
              <a:gd name="connsiteY49" fmla="*/ 807202 h 1370139"/>
              <a:gd name="connsiteX50" fmla="*/ 285942 w 1012696"/>
              <a:gd name="connsiteY50" fmla="*/ 813159 h 1370139"/>
              <a:gd name="connsiteX51" fmla="*/ 288921 w 1012696"/>
              <a:gd name="connsiteY51" fmla="*/ 831030 h 1370139"/>
              <a:gd name="connsiteX52" fmla="*/ 300835 w 1012696"/>
              <a:gd name="connsiteY52" fmla="*/ 848901 h 1370139"/>
              <a:gd name="connsiteX53" fmla="*/ 327641 w 1012696"/>
              <a:gd name="connsiteY53" fmla="*/ 878686 h 1370139"/>
              <a:gd name="connsiteX54" fmla="*/ 345512 w 1012696"/>
              <a:gd name="connsiteY54" fmla="*/ 887622 h 1370139"/>
              <a:gd name="connsiteX55" fmla="*/ 354448 w 1012696"/>
              <a:gd name="connsiteY55" fmla="*/ 890600 h 1370139"/>
              <a:gd name="connsiteX56" fmla="*/ 363383 w 1012696"/>
              <a:gd name="connsiteY56" fmla="*/ 896557 h 1370139"/>
              <a:gd name="connsiteX57" fmla="*/ 375297 w 1012696"/>
              <a:gd name="connsiteY57" fmla="*/ 899536 h 1370139"/>
              <a:gd name="connsiteX58" fmla="*/ 425932 w 1012696"/>
              <a:gd name="connsiteY58" fmla="*/ 902514 h 1370139"/>
              <a:gd name="connsiteX59" fmla="*/ 446781 w 1012696"/>
              <a:gd name="connsiteY59" fmla="*/ 908471 h 1370139"/>
              <a:gd name="connsiteX60" fmla="*/ 455717 w 1012696"/>
              <a:gd name="connsiteY60" fmla="*/ 917407 h 1370139"/>
              <a:gd name="connsiteX61" fmla="*/ 464652 w 1012696"/>
              <a:gd name="connsiteY61" fmla="*/ 923364 h 1370139"/>
              <a:gd name="connsiteX62" fmla="*/ 476566 w 1012696"/>
              <a:gd name="connsiteY62" fmla="*/ 941235 h 1370139"/>
              <a:gd name="connsiteX63" fmla="*/ 485502 w 1012696"/>
              <a:gd name="connsiteY63" fmla="*/ 950170 h 1370139"/>
              <a:gd name="connsiteX64" fmla="*/ 506351 w 1012696"/>
              <a:gd name="connsiteY64" fmla="*/ 979955 h 1370139"/>
              <a:gd name="connsiteX65" fmla="*/ 524222 w 1012696"/>
              <a:gd name="connsiteY65" fmla="*/ 997826 h 1370139"/>
              <a:gd name="connsiteX66" fmla="*/ 533158 w 1012696"/>
              <a:gd name="connsiteY66" fmla="*/ 1006762 h 1370139"/>
              <a:gd name="connsiteX67" fmla="*/ 556986 w 1012696"/>
              <a:gd name="connsiteY67" fmla="*/ 1033568 h 1370139"/>
              <a:gd name="connsiteX68" fmla="*/ 565921 w 1012696"/>
              <a:gd name="connsiteY68" fmla="*/ 1042504 h 1370139"/>
              <a:gd name="connsiteX69" fmla="*/ 586771 w 1012696"/>
              <a:gd name="connsiteY69" fmla="*/ 1057396 h 1370139"/>
              <a:gd name="connsiteX70" fmla="*/ 595706 w 1012696"/>
              <a:gd name="connsiteY70" fmla="*/ 1066332 h 1370139"/>
              <a:gd name="connsiteX71" fmla="*/ 604642 w 1012696"/>
              <a:gd name="connsiteY71" fmla="*/ 1072289 h 1370139"/>
              <a:gd name="connsiteX72" fmla="*/ 631448 w 1012696"/>
              <a:gd name="connsiteY72" fmla="*/ 1096117 h 1370139"/>
              <a:gd name="connsiteX73" fmla="*/ 643362 w 1012696"/>
              <a:gd name="connsiteY73" fmla="*/ 1113988 h 1370139"/>
              <a:gd name="connsiteX74" fmla="*/ 658255 w 1012696"/>
              <a:gd name="connsiteY74" fmla="*/ 1140794 h 1370139"/>
              <a:gd name="connsiteX75" fmla="*/ 664212 w 1012696"/>
              <a:gd name="connsiteY75" fmla="*/ 1149730 h 1370139"/>
              <a:gd name="connsiteX76" fmla="*/ 673147 w 1012696"/>
              <a:gd name="connsiteY76" fmla="*/ 1155687 h 1370139"/>
              <a:gd name="connsiteX77" fmla="*/ 679104 w 1012696"/>
              <a:gd name="connsiteY77" fmla="*/ 1164622 h 1370139"/>
              <a:gd name="connsiteX78" fmla="*/ 696975 w 1012696"/>
              <a:gd name="connsiteY78" fmla="*/ 1173558 h 1370139"/>
              <a:gd name="connsiteX79" fmla="*/ 717825 w 1012696"/>
              <a:gd name="connsiteY79" fmla="*/ 1188450 h 1370139"/>
              <a:gd name="connsiteX80" fmla="*/ 735696 w 1012696"/>
              <a:gd name="connsiteY80" fmla="*/ 1209300 h 1370139"/>
              <a:gd name="connsiteX81" fmla="*/ 741653 w 1012696"/>
              <a:gd name="connsiteY81" fmla="*/ 1218235 h 1370139"/>
              <a:gd name="connsiteX82" fmla="*/ 756545 w 1012696"/>
              <a:gd name="connsiteY82" fmla="*/ 1221214 h 1370139"/>
              <a:gd name="connsiteX83" fmla="*/ 762502 w 1012696"/>
              <a:gd name="connsiteY83" fmla="*/ 1230149 h 1370139"/>
              <a:gd name="connsiteX84" fmla="*/ 768459 w 1012696"/>
              <a:gd name="connsiteY84" fmla="*/ 1271848 h 1370139"/>
              <a:gd name="connsiteX85" fmla="*/ 771438 w 1012696"/>
              <a:gd name="connsiteY85" fmla="*/ 1280784 h 1370139"/>
              <a:gd name="connsiteX86" fmla="*/ 780373 w 1012696"/>
              <a:gd name="connsiteY86" fmla="*/ 1316526 h 1370139"/>
              <a:gd name="connsiteX87" fmla="*/ 789309 w 1012696"/>
              <a:gd name="connsiteY87" fmla="*/ 1346311 h 1370139"/>
              <a:gd name="connsiteX88" fmla="*/ 792287 w 1012696"/>
              <a:gd name="connsiteY88" fmla="*/ 1355246 h 1370139"/>
              <a:gd name="connsiteX89" fmla="*/ 813137 w 1012696"/>
              <a:gd name="connsiteY89" fmla="*/ 1364182 h 1370139"/>
              <a:gd name="connsiteX90" fmla="*/ 875685 w 1012696"/>
              <a:gd name="connsiteY90" fmla="*/ 1367160 h 1370139"/>
              <a:gd name="connsiteX91" fmla="*/ 926320 w 1012696"/>
              <a:gd name="connsiteY91" fmla="*/ 1370139 h 1370139"/>
              <a:gd name="connsiteX92" fmla="*/ 985890 w 1012696"/>
              <a:gd name="connsiteY92" fmla="*/ 1367160 h 1370139"/>
              <a:gd name="connsiteX93" fmla="*/ 994825 w 1012696"/>
              <a:gd name="connsiteY93" fmla="*/ 1364182 h 1370139"/>
              <a:gd name="connsiteX94" fmla="*/ 1006739 w 1012696"/>
              <a:gd name="connsiteY94" fmla="*/ 1337375 h 1370139"/>
              <a:gd name="connsiteX95" fmla="*/ 1012696 w 1012696"/>
              <a:gd name="connsiteY95" fmla="*/ 1328440 h 1370139"/>
              <a:gd name="connsiteX96" fmla="*/ 1012696 w 1012696"/>
              <a:gd name="connsiteY96" fmla="*/ 1164622 h 1370139"/>
              <a:gd name="connsiteX97" fmla="*/ 1009718 w 1012696"/>
              <a:gd name="connsiteY97" fmla="*/ 1116966 h 1370139"/>
              <a:gd name="connsiteX98" fmla="*/ 1006739 w 1012696"/>
              <a:gd name="connsiteY98" fmla="*/ 1099095 h 1370139"/>
              <a:gd name="connsiteX99" fmla="*/ 1000782 w 1012696"/>
              <a:gd name="connsiteY99" fmla="*/ 1081224 h 1370139"/>
              <a:gd name="connsiteX100" fmla="*/ 1003761 w 1012696"/>
              <a:gd name="connsiteY100" fmla="*/ 1060375 h 1370139"/>
              <a:gd name="connsiteX101" fmla="*/ 1009718 w 1012696"/>
              <a:gd name="connsiteY101" fmla="*/ 1012719 h 1370139"/>
              <a:gd name="connsiteX102" fmla="*/ 1012696 w 1012696"/>
              <a:gd name="connsiteY102" fmla="*/ 997826 h 1370139"/>
              <a:gd name="connsiteX103" fmla="*/ 1009718 w 1012696"/>
              <a:gd name="connsiteY103" fmla="*/ 914428 h 1370139"/>
              <a:gd name="connsiteX104" fmla="*/ 1006739 w 1012696"/>
              <a:gd name="connsiteY104" fmla="*/ 899536 h 1370139"/>
              <a:gd name="connsiteX105" fmla="*/ 1000782 w 1012696"/>
              <a:gd name="connsiteY105" fmla="*/ 878686 h 1370139"/>
              <a:gd name="connsiteX106" fmla="*/ 991847 w 1012696"/>
              <a:gd name="connsiteY106" fmla="*/ 869751 h 1370139"/>
              <a:gd name="connsiteX107" fmla="*/ 973976 w 1012696"/>
              <a:gd name="connsiteY107" fmla="*/ 857837 h 1370139"/>
              <a:gd name="connsiteX108" fmla="*/ 965040 w 1012696"/>
              <a:gd name="connsiteY108" fmla="*/ 851880 h 1370139"/>
              <a:gd name="connsiteX109" fmla="*/ 956105 w 1012696"/>
              <a:gd name="connsiteY109" fmla="*/ 842944 h 1370139"/>
              <a:gd name="connsiteX110" fmla="*/ 938234 w 1012696"/>
              <a:gd name="connsiteY110" fmla="*/ 834009 h 1370139"/>
              <a:gd name="connsiteX111" fmla="*/ 902492 w 1012696"/>
              <a:gd name="connsiteY111" fmla="*/ 831030 h 1370139"/>
              <a:gd name="connsiteX112" fmla="*/ 878664 w 1012696"/>
              <a:gd name="connsiteY112" fmla="*/ 828052 h 1370139"/>
              <a:gd name="connsiteX113" fmla="*/ 869728 w 1012696"/>
              <a:gd name="connsiteY113" fmla="*/ 825073 h 1370139"/>
              <a:gd name="connsiteX114" fmla="*/ 848879 w 1012696"/>
              <a:gd name="connsiteY114" fmla="*/ 819116 h 1370139"/>
              <a:gd name="connsiteX115" fmla="*/ 831008 w 1012696"/>
              <a:gd name="connsiteY115" fmla="*/ 810181 h 1370139"/>
              <a:gd name="connsiteX116" fmla="*/ 822072 w 1012696"/>
              <a:gd name="connsiteY116" fmla="*/ 804224 h 1370139"/>
              <a:gd name="connsiteX117" fmla="*/ 813137 w 1012696"/>
              <a:gd name="connsiteY117" fmla="*/ 801245 h 1370139"/>
              <a:gd name="connsiteX118" fmla="*/ 804201 w 1012696"/>
              <a:gd name="connsiteY118" fmla="*/ 792310 h 1370139"/>
              <a:gd name="connsiteX119" fmla="*/ 795266 w 1012696"/>
              <a:gd name="connsiteY119" fmla="*/ 789331 h 1370139"/>
              <a:gd name="connsiteX120" fmla="*/ 777395 w 1012696"/>
              <a:gd name="connsiteY120" fmla="*/ 777417 h 1370139"/>
              <a:gd name="connsiteX121" fmla="*/ 762502 w 1012696"/>
              <a:gd name="connsiteY121" fmla="*/ 750611 h 1370139"/>
              <a:gd name="connsiteX122" fmla="*/ 756545 w 1012696"/>
              <a:gd name="connsiteY122" fmla="*/ 741675 h 1370139"/>
              <a:gd name="connsiteX123" fmla="*/ 750588 w 1012696"/>
              <a:gd name="connsiteY123" fmla="*/ 732740 h 1370139"/>
              <a:gd name="connsiteX124" fmla="*/ 741653 w 1012696"/>
              <a:gd name="connsiteY124" fmla="*/ 705933 h 1370139"/>
              <a:gd name="connsiteX125" fmla="*/ 738674 w 1012696"/>
              <a:gd name="connsiteY125" fmla="*/ 696998 h 1370139"/>
              <a:gd name="connsiteX126" fmla="*/ 732717 w 1012696"/>
              <a:gd name="connsiteY126" fmla="*/ 688062 h 1370139"/>
              <a:gd name="connsiteX127" fmla="*/ 723782 w 1012696"/>
              <a:gd name="connsiteY127" fmla="*/ 670191 h 1370139"/>
              <a:gd name="connsiteX128" fmla="*/ 717825 w 1012696"/>
              <a:gd name="connsiteY128" fmla="*/ 652320 h 1370139"/>
              <a:gd name="connsiteX129" fmla="*/ 711868 w 1012696"/>
              <a:gd name="connsiteY129" fmla="*/ 634449 h 1370139"/>
              <a:gd name="connsiteX130" fmla="*/ 705911 w 1012696"/>
              <a:gd name="connsiteY130" fmla="*/ 613600 h 1370139"/>
              <a:gd name="connsiteX131" fmla="*/ 699954 w 1012696"/>
              <a:gd name="connsiteY131" fmla="*/ 604664 h 1370139"/>
              <a:gd name="connsiteX132" fmla="*/ 696975 w 1012696"/>
              <a:gd name="connsiteY132" fmla="*/ 506373 h 1370139"/>
              <a:gd name="connsiteX133" fmla="*/ 693997 w 1012696"/>
              <a:gd name="connsiteY133" fmla="*/ 497438 h 1370139"/>
              <a:gd name="connsiteX134" fmla="*/ 691018 w 1012696"/>
              <a:gd name="connsiteY134" fmla="*/ 479567 h 1370139"/>
              <a:gd name="connsiteX135" fmla="*/ 688040 w 1012696"/>
              <a:gd name="connsiteY135" fmla="*/ 470631 h 1370139"/>
              <a:gd name="connsiteX136" fmla="*/ 679104 w 1012696"/>
              <a:gd name="connsiteY136" fmla="*/ 437868 h 1370139"/>
              <a:gd name="connsiteX137" fmla="*/ 676126 w 1012696"/>
              <a:gd name="connsiteY137" fmla="*/ 428932 h 1370139"/>
              <a:gd name="connsiteX138" fmla="*/ 673147 w 1012696"/>
              <a:gd name="connsiteY138" fmla="*/ 399147 h 1370139"/>
              <a:gd name="connsiteX139" fmla="*/ 670169 w 1012696"/>
              <a:gd name="connsiteY139" fmla="*/ 390212 h 1370139"/>
              <a:gd name="connsiteX140" fmla="*/ 661233 w 1012696"/>
              <a:gd name="connsiteY140" fmla="*/ 381276 h 1370139"/>
              <a:gd name="connsiteX141" fmla="*/ 655276 w 1012696"/>
              <a:gd name="connsiteY141" fmla="*/ 363405 h 1370139"/>
              <a:gd name="connsiteX142" fmla="*/ 646341 w 1012696"/>
              <a:gd name="connsiteY142" fmla="*/ 357448 h 1370139"/>
              <a:gd name="connsiteX143" fmla="*/ 625491 w 1012696"/>
              <a:gd name="connsiteY143" fmla="*/ 336599 h 1370139"/>
              <a:gd name="connsiteX144" fmla="*/ 595706 w 1012696"/>
              <a:gd name="connsiteY144" fmla="*/ 321706 h 1370139"/>
              <a:gd name="connsiteX145" fmla="*/ 586771 w 1012696"/>
              <a:gd name="connsiteY145" fmla="*/ 318728 h 1370139"/>
              <a:gd name="connsiteX146" fmla="*/ 574857 w 1012696"/>
              <a:gd name="connsiteY146" fmla="*/ 312771 h 1370139"/>
              <a:gd name="connsiteX147" fmla="*/ 565921 w 1012696"/>
              <a:gd name="connsiteY147" fmla="*/ 306814 h 1370139"/>
              <a:gd name="connsiteX148" fmla="*/ 545072 w 1012696"/>
              <a:gd name="connsiteY148" fmla="*/ 300857 h 1370139"/>
              <a:gd name="connsiteX149" fmla="*/ 542093 w 1012696"/>
              <a:gd name="connsiteY149" fmla="*/ 291921 h 1370139"/>
              <a:gd name="connsiteX150" fmla="*/ 515287 w 1012696"/>
              <a:gd name="connsiteY150" fmla="*/ 271072 h 1370139"/>
              <a:gd name="connsiteX151" fmla="*/ 497416 w 1012696"/>
              <a:gd name="connsiteY151" fmla="*/ 244265 h 1370139"/>
              <a:gd name="connsiteX152" fmla="*/ 491459 w 1012696"/>
              <a:gd name="connsiteY152" fmla="*/ 235330 h 1370139"/>
              <a:gd name="connsiteX153" fmla="*/ 485502 w 1012696"/>
              <a:gd name="connsiteY153" fmla="*/ 226394 h 1370139"/>
              <a:gd name="connsiteX154" fmla="*/ 467631 w 1012696"/>
              <a:gd name="connsiteY154" fmla="*/ 208523 h 1370139"/>
              <a:gd name="connsiteX155" fmla="*/ 455717 w 1012696"/>
              <a:gd name="connsiteY155" fmla="*/ 190652 h 1370139"/>
              <a:gd name="connsiteX156" fmla="*/ 449760 w 1012696"/>
              <a:gd name="connsiteY156" fmla="*/ 181717 h 1370139"/>
              <a:gd name="connsiteX157" fmla="*/ 440824 w 1012696"/>
              <a:gd name="connsiteY157" fmla="*/ 172781 h 1370139"/>
              <a:gd name="connsiteX158" fmla="*/ 434867 w 1012696"/>
              <a:gd name="connsiteY158" fmla="*/ 163846 h 1370139"/>
              <a:gd name="connsiteX159" fmla="*/ 422953 w 1012696"/>
              <a:gd name="connsiteY159" fmla="*/ 154910 h 1370139"/>
              <a:gd name="connsiteX160" fmla="*/ 416996 w 1012696"/>
              <a:gd name="connsiteY160" fmla="*/ 140018 h 1370139"/>
              <a:gd name="connsiteX161" fmla="*/ 396147 w 1012696"/>
              <a:gd name="connsiteY161" fmla="*/ 113211 h 1370139"/>
              <a:gd name="connsiteX162" fmla="*/ 393168 w 1012696"/>
              <a:gd name="connsiteY162" fmla="*/ 104276 h 1370139"/>
              <a:gd name="connsiteX163" fmla="*/ 387211 w 1012696"/>
              <a:gd name="connsiteY163" fmla="*/ 83426 h 1370139"/>
              <a:gd name="connsiteX164" fmla="*/ 384233 w 1012696"/>
              <a:gd name="connsiteY164" fmla="*/ 53641 h 1370139"/>
              <a:gd name="connsiteX165" fmla="*/ 381254 w 1012696"/>
              <a:gd name="connsiteY165" fmla="*/ 8964 h 1370139"/>
              <a:gd name="connsiteX166" fmla="*/ 357426 w 1012696"/>
              <a:gd name="connsiteY166" fmla="*/ 11942 h 1370139"/>
              <a:gd name="connsiteX167" fmla="*/ 336577 w 1012696"/>
              <a:gd name="connsiteY167" fmla="*/ 17899 h 1370139"/>
              <a:gd name="connsiteX168" fmla="*/ 282964 w 1012696"/>
              <a:gd name="connsiteY168" fmla="*/ 14921 h 1370139"/>
              <a:gd name="connsiteX169" fmla="*/ 244243 w 1012696"/>
              <a:gd name="connsiteY169" fmla="*/ 11942 h 1370139"/>
              <a:gd name="connsiteX170" fmla="*/ 145952 w 1012696"/>
              <a:gd name="connsiteY170" fmla="*/ 28 h 137013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 ang="0">
                <a:pos x="connsiteX136" y="connsiteY136"/>
              </a:cxn>
              <a:cxn ang="0">
                <a:pos x="connsiteX137" y="connsiteY137"/>
              </a:cxn>
              <a:cxn ang="0">
                <a:pos x="connsiteX138" y="connsiteY138"/>
              </a:cxn>
              <a:cxn ang="0">
                <a:pos x="connsiteX139" y="connsiteY139"/>
              </a:cxn>
              <a:cxn ang="0">
                <a:pos x="connsiteX140" y="connsiteY140"/>
              </a:cxn>
              <a:cxn ang="0">
                <a:pos x="connsiteX141" y="connsiteY141"/>
              </a:cxn>
              <a:cxn ang="0">
                <a:pos x="connsiteX142" y="connsiteY142"/>
              </a:cxn>
              <a:cxn ang="0">
                <a:pos x="connsiteX143" y="connsiteY143"/>
              </a:cxn>
              <a:cxn ang="0">
                <a:pos x="connsiteX144" y="connsiteY144"/>
              </a:cxn>
              <a:cxn ang="0">
                <a:pos x="connsiteX145" y="connsiteY145"/>
              </a:cxn>
              <a:cxn ang="0">
                <a:pos x="connsiteX146" y="connsiteY146"/>
              </a:cxn>
              <a:cxn ang="0">
                <a:pos x="connsiteX147" y="connsiteY147"/>
              </a:cxn>
              <a:cxn ang="0">
                <a:pos x="connsiteX148" y="connsiteY148"/>
              </a:cxn>
              <a:cxn ang="0">
                <a:pos x="connsiteX149" y="connsiteY149"/>
              </a:cxn>
              <a:cxn ang="0">
                <a:pos x="connsiteX150" y="connsiteY150"/>
              </a:cxn>
              <a:cxn ang="0">
                <a:pos x="connsiteX151" y="connsiteY151"/>
              </a:cxn>
              <a:cxn ang="0">
                <a:pos x="connsiteX152" y="connsiteY152"/>
              </a:cxn>
              <a:cxn ang="0">
                <a:pos x="connsiteX153" y="connsiteY153"/>
              </a:cxn>
              <a:cxn ang="0">
                <a:pos x="connsiteX154" y="connsiteY154"/>
              </a:cxn>
              <a:cxn ang="0">
                <a:pos x="connsiteX155" y="connsiteY155"/>
              </a:cxn>
              <a:cxn ang="0">
                <a:pos x="connsiteX156" y="connsiteY156"/>
              </a:cxn>
              <a:cxn ang="0">
                <a:pos x="connsiteX157" y="connsiteY157"/>
              </a:cxn>
              <a:cxn ang="0">
                <a:pos x="connsiteX158" y="connsiteY158"/>
              </a:cxn>
              <a:cxn ang="0">
                <a:pos x="connsiteX159" y="connsiteY159"/>
              </a:cxn>
              <a:cxn ang="0">
                <a:pos x="connsiteX160" y="connsiteY160"/>
              </a:cxn>
              <a:cxn ang="0">
                <a:pos x="connsiteX161" y="connsiteY161"/>
              </a:cxn>
              <a:cxn ang="0">
                <a:pos x="connsiteX162" y="connsiteY162"/>
              </a:cxn>
              <a:cxn ang="0">
                <a:pos x="connsiteX163" y="connsiteY163"/>
              </a:cxn>
              <a:cxn ang="0">
                <a:pos x="connsiteX164" y="connsiteY164"/>
              </a:cxn>
              <a:cxn ang="0">
                <a:pos x="connsiteX165" y="connsiteY165"/>
              </a:cxn>
              <a:cxn ang="0">
                <a:pos x="connsiteX166" y="connsiteY166"/>
              </a:cxn>
              <a:cxn ang="0">
                <a:pos x="connsiteX167" y="connsiteY167"/>
              </a:cxn>
              <a:cxn ang="0">
                <a:pos x="connsiteX168" y="connsiteY168"/>
              </a:cxn>
              <a:cxn ang="0">
                <a:pos x="connsiteX169" y="connsiteY169"/>
              </a:cxn>
              <a:cxn ang="0">
                <a:pos x="connsiteX170" y="connsiteY170"/>
              </a:cxn>
            </a:cxnLst>
            <a:rect l="l" t="t" r="r" b="b"/>
            <a:pathLst>
              <a:path w="1012696" h="1370139">
                <a:moveTo>
                  <a:pt x="145952" y="28"/>
                </a:moveTo>
                <a:cubicBezTo>
                  <a:pt x="127088" y="524"/>
                  <a:pt x="136343" y="10298"/>
                  <a:pt x="131060" y="14921"/>
                </a:cubicBezTo>
                <a:cubicBezTo>
                  <a:pt x="128366" y="17278"/>
                  <a:pt x="124655" y="18347"/>
                  <a:pt x="122124" y="20878"/>
                </a:cubicBezTo>
                <a:cubicBezTo>
                  <a:pt x="119593" y="23409"/>
                  <a:pt x="118861" y="27456"/>
                  <a:pt x="116167" y="29813"/>
                </a:cubicBezTo>
                <a:cubicBezTo>
                  <a:pt x="102450" y="41815"/>
                  <a:pt x="99832" y="39998"/>
                  <a:pt x="86382" y="47684"/>
                </a:cubicBezTo>
                <a:cubicBezTo>
                  <a:pt x="83274" y="49460"/>
                  <a:pt x="80649" y="52040"/>
                  <a:pt x="77447" y="53641"/>
                </a:cubicBezTo>
                <a:cubicBezTo>
                  <a:pt x="74639" y="55045"/>
                  <a:pt x="71319" y="55216"/>
                  <a:pt x="68511" y="56620"/>
                </a:cubicBezTo>
                <a:cubicBezTo>
                  <a:pt x="65309" y="58221"/>
                  <a:pt x="62489" y="60496"/>
                  <a:pt x="59576" y="62577"/>
                </a:cubicBezTo>
                <a:cubicBezTo>
                  <a:pt x="55537" y="65462"/>
                  <a:pt x="52102" y="69292"/>
                  <a:pt x="47662" y="71512"/>
                </a:cubicBezTo>
                <a:cubicBezTo>
                  <a:pt x="44001" y="73343"/>
                  <a:pt x="39719" y="73498"/>
                  <a:pt x="35748" y="74491"/>
                </a:cubicBezTo>
                <a:cubicBezTo>
                  <a:pt x="33762" y="77469"/>
                  <a:pt x="32322" y="80895"/>
                  <a:pt x="29791" y="83426"/>
                </a:cubicBezTo>
                <a:cubicBezTo>
                  <a:pt x="23843" y="89374"/>
                  <a:pt x="13073" y="92496"/>
                  <a:pt x="5963" y="95340"/>
                </a:cubicBezTo>
                <a:cubicBezTo>
                  <a:pt x="-5414" y="118094"/>
                  <a:pt x="2984" y="95647"/>
                  <a:pt x="2984" y="128104"/>
                </a:cubicBezTo>
                <a:cubicBezTo>
                  <a:pt x="2984" y="142039"/>
                  <a:pt x="999" y="155903"/>
                  <a:pt x="6" y="169803"/>
                </a:cubicBezTo>
                <a:cubicBezTo>
                  <a:pt x="3996" y="197739"/>
                  <a:pt x="-910" y="184811"/>
                  <a:pt x="14898" y="208523"/>
                </a:cubicBezTo>
                <a:lnTo>
                  <a:pt x="14898" y="208523"/>
                </a:lnTo>
                <a:cubicBezTo>
                  <a:pt x="16860" y="214410"/>
                  <a:pt x="18585" y="222195"/>
                  <a:pt x="23834" y="226394"/>
                </a:cubicBezTo>
                <a:cubicBezTo>
                  <a:pt x="26286" y="228355"/>
                  <a:pt x="29961" y="227969"/>
                  <a:pt x="32769" y="229373"/>
                </a:cubicBezTo>
                <a:cubicBezTo>
                  <a:pt x="43865" y="234921"/>
                  <a:pt x="40756" y="236028"/>
                  <a:pt x="50640" y="244265"/>
                </a:cubicBezTo>
                <a:cubicBezTo>
                  <a:pt x="53390" y="246557"/>
                  <a:pt x="56597" y="248236"/>
                  <a:pt x="59576" y="250222"/>
                </a:cubicBezTo>
                <a:cubicBezTo>
                  <a:pt x="60569" y="253201"/>
                  <a:pt x="60593" y="256706"/>
                  <a:pt x="62554" y="259158"/>
                </a:cubicBezTo>
                <a:cubicBezTo>
                  <a:pt x="66753" y="264407"/>
                  <a:pt x="74539" y="266131"/>
                  <a:pt x="80425" y="268093"/>
                </a:cubicBezTo>
                <a:cubicBezTo>
                  <a:pt x="83404" y="271072"/>
                  <a:pt x="85856" y="274692"/>
                  <a:pt x="89361" y="277029"/>
                </a:cubicBezTo>
                <a:cubicBezTo>
                  <a:pt x="91973" y="278770"/>
                  <a:pt x="96076" y="277787"/>
                  <a:pt x="98296" y="280007"/>
                </a:cubicBezTo>
                <a:cubicBezTo>
                  <a:pt x="100516" y="282227"/>
                  <a:pt x="99871" y="286135"/>
                  <a:pt x="101275" y="288943"/>
                </a:cubicBezTo>
                <a:cubicBezTo>
                  <a:pt x="103451" y="293295"/>
                  <a:pt x="114146" y="307097"/>
                  <a:pt x="116167" y="309792"/>
                </a:cubicBezTo>
                <a:cubicBezTo>
                  <a:pt x="120495" y="322777"/>
                  <a:pt x="120215" y="327160"/>
                  <a:pt x="128081" y="336599"/>
                </a:cubicBezTo>
                <a:cubicBezTo>
                  <a:pt x="130778" y="339835"/>
                  <a:pt x="134038" y="342556"/>
                  <a:pt x="137017" y="345534"/>
                </a:cubicBezTo>
                <a:cubicBezTo>
                  <a:pt x="144500" y="367989"/>
                  <a:pt x="134407" y="340317"/>
                  <a:pt x="145952" y="363405"/>
                </a:cubicBezTo>
                <a:cubicBezTo>
                  <a:pt x="158284" y="388067"/>
                  <a:pt x="137817" y="355671"/>
                  <a:pt x="154888" y="381276"/>
                </a:cubicBezTo>
                <a:lnTo>
                  <a:pt x="163823" y="408083"/>
                </a:lnTo>
                <a:cubicBezTo>
                  <a:pt x="164816" y="411061"/>
                  <a:pt x="165061" y="414406"/>
                  <a:pt x="166802" y="417018"/>
                </a:cubicBezTo>
                <a:lnTo>
                  <a:pt x="172759" y="425954"/>
                </a:lnTo>
                <a:cubicBezTo>
                  <a:pt x="181798" y="453073"/>
                  <a:pt x="167929" y="410232"/>
                  <a:pt x="178716" y="449782"/>
                </a:cubicBezTo>
                <a:cubicBezTo>
                  <a:pt x="188274" y="484827"/>
                  <a:pt x="183389" y="449730"/>
                  <a:pt x="190630" y="500416"/>
                </a:cubicBezTo>
                <a:cubicBezTo>
                  <a:pt x="192041" y="510294"/>
                  <a:pt x="192198" y="520323"/>
                  <a:pt x="193609" y="530201"/>
                </a:cubicBezTo>
                <a:cubicBezTo>
                  <a:pt x="194545" y="536751"/>
                  <a:pt x="197443" y="544682"/>
                  <a:pt x="199566" y="551051"/>
                </a:cubicBezTo>
                <a:cubicBezTo>
                  <a:pt x="200559" y="563958"/>
                  <a:pt x="201114" y="576906"/>
                  <a:pt x="202544" y="589772"/>
                </a:cubicBezTo>
                <a:cubicBezTo>
                  <a:pt x="203103" y="594803"/>
                  <a:pt x="204617" y="599683"/>
                  <a:pt x="205523" y="604664"/>
                </a:cubicBezTo>
                <a:cubicBezTo>
                  <a:pt x="206603" y="610606"/>
                  <a:pt x="207834" y="616533"/>
                  <a:pt x="208501" y="622535"/>
                </a:cubicBezTo>
                <a:cubicBezTo>
                  <a:pt x="210153" y="637400"/>
                  <a:pt x="210439" y="660070"/>
                  <a:pt x="214458" y="676148"/>
                </a:cubicBezTo>
                <a:cubicBezTo>
                  <a:pt x="215981" y="682240"/>
                  <a:pt x="218429" y="688062"/>
                  <a:pt x="220415" y="694019"/>
                </a:cubicBezTo>
                <a:cubicBezTo>
                  <a:pt x="221408" y="696998"/>
                  <a:pt x="221652" y="700343"/>
                  <a:pt x="223394" y="702955"/>
                </a:cubicBezTo>
                <a:lnTo>
                  <a:pt x="235308" y="720826"/>
                </a:lnTo>
                <a:cubicBezTo>
                  <a:pt x="241159" y="738380"/>
                  <a:pt x="234342" y="721067"/>
                  <a:pt x="247222" y="741675"/>
                </a:cubicBezTo>
                <a:cubicBezTo>
                  <a:pt x="249575" y="745440"/>
                  <a:pt x="251193" y="749618"/>
                  <a:pt x="253179" y="753589"/>
                </a:cubicBezTo>
                <a:cubicBezTo>
                  <a:pt x="258669" y="775552"/>
                  <a:pt x="252770" y="755615"/>
                  <a:pt x="262114" y="777417"/>
                </a:cubicBezTo>
                <a:cubicBezTo>
                  <a:pt x="263351" y="780303"/>
                  <a:pt x="263689" y="783545"/>
                  <a:pt x="265093" y="786353"/>
                </a:cubicBezTo>
                <a:cubicBezTo>
                  <a:pt x="266694" y="789555"/>
                  <a:pt x="269274" y="792180"/>
                  <a:pt x="271050" y="795288"/>
                </a:cubicBezTo>
                <a:cubicBezTo>
                  <a:pt x="273253" y="799143"/>
                  <a:pt x="274165" y="803791"/>
                  <a:pt x="277007" y="807202"/>
                </a:cubicBezTo>
                <a:cubicBezTo>
                  <a:pt x="279299" y="809952"/>
                  <a:pt x="282964" y="811173"/>
                  <a:pt x="285942" y="813159"/>
                </a:cubicBezTo>
                <a:cubicBezTo>
                  <a:pt x="286935" y="819116"/>
                  <a:pt x="286598" y="825455"/>
                  <a:pt x="288921" y="831030"/>
                </a:cubicBezTo>
                <a:cubicBezTo>
                  <a:pt x="291675" y="837639"/>
                  <a:pt x="296864" y="842944"/>
                  <a:pt x="300835" y="848901"/>
                </a:cubicBezTo>
                <a:cubicBezTo>
                  <a:pt x="307378" y="858716"/>
                  <a:pt x="317619" y="875345"/>
                  <a:pt x="327641" y="878686"/>
                </a:cubicBezTo>
                <a:cubicBezTo>
                  <a:pt x="350110" y="886176"/>
                  <a:pt x="322408" y="876071"/>
                  <a:pt x="345512" y="887622"/>
                </a:cubicBezTo>
                <a:cubicBezTo>
                  <a:pt x="348320" y="889026"/>
                  <a:pt x="351469" y="889607"/>
                  <a:pt x="354448" y="890600"/>
                </a:cubicBezTo>
                <a:cubicBezTo>
                  <a:pt x="357426" y="892586"/>
                  <a:pt x="360093" y="895147"/>
                  <a:pt x="363383" y="896557"/>
                </a:cubicBezTo>
                <a:cubicBezTo>
                  <a:pt x="367146" y="898170"/>
                  <a:pt x="371222" y="899148"/>
                  <a:pt x="375297" y="899536"/>
                </a:cubicBezTo>
                <a:cubicBezTo>
                  <a:pt x="392128" y="901139"/>
                  <a:pt x="409054" y="901521"/>
                  <a:pt x="425932" y="902514"/>
                </a:cubicBezTo>
                <a:cubicBezTo>
                  <a:pt x="427517" y="902910"/>
                  <a:pt x="444219" y="906763"/>
                  <a:pt x="446781" y="908471"/>
                </a:cubicBezTo>
                <a:cubicBezTo>
                  <a:pt x="450286" y="910808"/>
                  <a:pt x="452481" y="914710"/>
                  <a:pt x="455717" y="917407"/>
                </a:cubicBezTo>
                <a:cubicBezTo>
                  <a:pt x="458467" y="919699"/>
                  <a:pt x="461674" y="921378"/>
                  <a:pt x="464652" y="923364"/>
                </a:cubicBezTo>
                <a:cubicBezTo>
                  <a:pt x="468623" y="929321"/>
                  <a:pt x="471503" y="936173"/>
                  <a:pt x="476566" y="941235"/>
                </a:cubicBezTo>
                <a:cubicBezTo>
                  <a:pt x="479545" y="944213"/>
                  <a:pt x="482916" y="946845"/>
                  <a:pt x="485502" y="950170"/>
                </a:cubicBezTo>
                <a:cubicBezTo>
                  <a:pt x="493881" y="960942"/>
                  <a:pt x="497481" y="970099"/>
                  <a:pt x="506351" y="979955"/>
                </a:cubicBezTo>
                <a:cubicBezTo>
                  <a:pt x="511987" y="986217"/>
                  <a:pt x="518265" y="991869"/>
                  <a:pt x="524222" y="997826"/>
                </a:cubicBezTo>
                <a:cubicBezTo>
                  <a:pt x="527201" y="1000805"/>
                  <a:pt x="530821" y="1003257"/>
                  <a:pt x="533158" y="1006762"/>
                </a:cubicBezTo>
                <a:cubicBezTo>
                  <a:pt x="543789" y="1022707"/>
                  <a:pt x="536582" y="1013164"/>
                  <a:pt x="556986" y="1033568"/>
                </a:cubicBezTo>
                <a:cubicBezTo>
                  <a:pt x="559964" y="1036547"/>
                  <a:pt x="562416" y="1040168"/>
                  <a:pt x="565921" y="1042504"/>
                </a:cubicBezTo>
                <a:cubicBezTo>
                  <a:pt x="572991" y="1047217"/>
                  <a:pt x="580308" y="1051856"/>
                  <a:pt x="586771" y="1057396"/>
                </a:cubicBezTo>
                <a:cubicBezTo>
                  <a:pt x="589969" y="1060137"/>
                  <a:pt x="592470" y="1063635"/>
                  <a:pt x="595706" y="1066332"/>
                </a:cubicBezTo>
                <a:cubicBezTo>
                  <a:pt x="598456" y="1068624"/>
                  <a:pt x="601966" y="1069911"/>
                  <a:pt x="604642" y="1072289"/>
                </a:cubicBezTo>
                <a:cubicBezTo>
                  <a:pt x="635249" y="1099495"/>
                  <a:pt x="611167" y="1082596"/>
                  <a:pt x="631448" y="1096117"/>
                </a:cubicBezTo>
                <a:cubicBezTo>
                  <a:pt x="635419" y="1102074"/>
                  <a:pt x="641098" y="1107196"/>
                  <a:pt x="643362" y="1113988"/>
                </a:cubicBezTo>
                <a:cubicBezTo>
                  <a:pt x="648606" y="1129715"/>
                  <a:pt x="644599" y="1120310"/>
                  <a:pt x="658255" y="1140794"/>
                </a:cubicBezTo>
                <a:cubicBezTo>
                  <a:pt x="660241" y="1143773"/>
                  <a:pt x="661233" y="1147744"/>
                  <a:pt x="664212" y="1149730"/>
                </a:cubicBezTo>
                <a:lnTo>
                  <a:pt x="673147" y="1155687"/>
                </a:lnTo>
                <a:cubicBezTo>
                  <a:pt x="675133" y="1158665"/>
                  <a:pt x="676573" y="1162091"/>
                  <a:pt x="679104" y="1164622"/>
                </a:cubicBezTo>
                <a:cubicBezTo>
                  <a:pt x="687639" y="1173157"/>
                  <a:pt x="687286" y="1168713"/>
                  <a:pt x="696975" y="1173558"/>
                </a:cubicBezTo>
                <a:cubicBezTo>
                  <a:pt x="700747" y="1175444"/>
                  <a:pt x="715935" y="1186830"/>
                  <a:pt x="717825" y="1188450"/>
                </a:cubicBezTo>
                <a:cubicBezTo>
                  <a:pt x="725798" y="1195284"/>
                  <a:pt x="729503" y="1200631"/>
                  <a:pt x="735696" y="1209300"/>
                </a:cubicBezTo>
                <a:cubicBezTo>
                  <a:pt x="737777" y="1212213"/>
                  <a:pt x="738545" y="1216459"/>
                  <a:pt x="741653" y="1218235"/>
                </a:cubicBezTo>
                <a:cubicBezTo>
                  <a:pt x="746048" y="1220747"/>
                  <a:pt x="751581" y="1220221"/>
                  <a:pt x="756545" y="1221214"/>
                </a:cubicBezTo>
                <a:cubicBezTo>
                  <a:pt x="758531" y="1224192"/>
                  <a:pt x="761245" y="1226797"/>
                  <a:pt x="762502" y="1230149"/>
                </a:cubicBezTo>
                <a:cubicBezTo>
                  <a:pt x="765719" y="1238727"/>
                  <a:pt x="767631" y="1266879"/>
                  <a:pt x="768459" y="1271848"/>
                </a:cubicBezTo>
                <a:cubicBezTo>
                  <a:pt x="768975" y="1274945"/>
                  <a:pt x="770445" y="1277805"/>
                  <a:pt x="771438" y="1280784"/>
                </a:cubicBezTo>
                <a:cubicBezTo>
                  <a:pt x="781495" y="1341135"/>
                  <a:pt x="766219" y="1255197"/>
                  <a:pt x="780373" y="1316526"/>
                </a:cubicBezTo>
                <a:cubicBezTo>
                  <a:pt x="787138" y="1345838"/>
                  <a:pt x="777786" y="1329025"/>
                  <a:pt x="789309" y="1346311"/>
                </a:cubicBezTo>
                <a:cubicBezTo>
                  <a:pt x="790302" y="1349289"/>
                  <a:pt x="790067" y="1353026"/>
                  <a:pt x="792287" y="1355246"/>
                </a:cubicBezTo>
                <a:cubicBezTo>
                  <a:pt x="793907" y="1356866"/>
                  <a:pt x="809254" y="1363858"/>
                  <a:pt x="813137" y="1364182"/>
                </a:cubicBezTo>
                <a:cubicBezTo>
                  <a:pt x="833938" y="1365915"/>
                  <a:pt x="854841" y="1366063"/>
                  <a:pt x="875685" y="1367160"/>
                </a:cubicBezTo>
                <a:lnTo>
                  <a:pt x="926320" y="1370139"/>
                </a:lnTo>
                <a:cubicBezTo>
                  <a:pt x="946177" y="1369146"/>
                  <a:pt x="966083" y="1368882"/>
                  <a:pt x="985890" y="1367160"/>
                </a:cubicBezTo>
                <a:cubicBezTo>
                  <a:pt x="989018" y="1366888"/>
                  <a:pt x="992374" y="1366143"/>
                  <a:pt x="994825" y="1364182"/>
                </a:cubicBezTo>
                <a:cubicBezTo>
                  <a:pt x="1003485" y="1357254"/>
                  <a:pt x="1001018" y="1345956"/>
                  <a:pt x="1006739" y="1337375"/>
                </a:cubicBezTo>
                <a:lnTo>
                  <a:pt x="1012696" y="1328440"/>
                </a:lnTo>
                <a:cubicBezTo>
                  <a:pt x="997190" y="1266404"/>
                  <a:pt x="1012696" y="1332854"/>
                  <a:pt x="1012696" y="1164622"/>
                </a:cubicBezTo>
                <a:cubicBezTo>
                  <a:pt x="1012696" y="1148706"/>
                  <a:pt x="1011159" y="1132817"/>
                  <a:pt x="1009718" y="1116966"/>
                </a:cubicBezTo>
                <a:cubicBezTo>
                  <a:pt x="1009171" y="1110952"/>
                  <a:pt x="1008204" y="1104954"/>
                  <a:pt x="1006739" y="1099095"/>
                </a:cubicBezTo>
                <a:cubicBezTo>
                  <a:pt x="1005216" y="1093003"/>
                  <a:pt x="1000782" y="1081224"/>
                  <a:pt x="1000782" y="1081224"/>
                </a:cubicBezTo>
                <a:cubicBezTo>
                  <a:pt x="1001775" y="1074274"/>
                  <a:pt x="1002853" y="1067336"/>
                  <a:pt x="1003761" y="1060375"/>
                </a:cubicBezTo>
                <a:cubicBezTo>
                  <a:pt x="1005832" y="1044501"/>
                  <a:pt x="1006579" y="1028417"/>
                  <a:pt x="1009718" y="1012719"/>
                </a:cubicBezTo>
                <a:lnTo>
                  <a:pt x="1012696" y="997826"/>
                </a:lnTo>
                <a:cubicBezTo>
                  <a:pt x="1011703" y="970027"/>
                  <a:pt x="1011401" y="942194"/>
                  <a:pt x="1009718" y="914428"/>
                </a:cubicBezTo>
                <a:cubicBezTo>
                  <a:pt x="1009412" y="909375"/>
                  <a:pt x="1007837" y="904478"/>
                  <a:pt x="1006739" y="899536"/>
                </a:cubicBezTo>
                <a:cubicBezTo>
                  <a:pt x="1006407" y="898043"/>
                  <a:pt x="1002442" y="881176"/>
                  <a:pt x="1000782" y="878686"/>
                </a:cubicBezTo>
                <a:cubicBezTo>
                  <a:pt x="998446" y="875181"/>
                  <a:pt x="995172" y="872337"/>
                  <a:pt x="991847" y="869751"/>
                </a:cubicBezTo>
                <a:cubicBezTo>
                  <a:pt x="986196" y="865356"/>
                  <a:pt x="979933" y="861808"/>
                  <a:pt x="973976" y="857837"/>
                </a:cubicBezTo>
                <a:cubicBezTo>
                  <a:pt x="970997" y="855851"/>
                  <a:pt x="967571" y="854411"/>
                  <a:pt x="965040" y="851880"/>
                </a:cubicBezTo>
                <a:cubicBezTo>
                  <a:pt x="962062" y="848901"/>
                  <a:pt x="959341" y="845641"/>
                  <a:pt x="956105" y="842944"/>
                </a:cubicBezTo>
                <a:cubicBezTo>
                  <a:pt x="951324" y="838960"/>
                  <a:pt x="944631" y="834862"/>
                  <a:pt x="938234" y="834009"/>
                </a:cubicBezTo>
                <a:cubicBezTo>
                  <a:pt x="926384" y="832429"/>
                  <a:pt x="914388" y="832220"/>
                  <a:pt x="902492" y="831030"/>
                </a:cubicBezTo>
                <a:cubicBezTo>
                  <a:pt x="894527" y="830234"/>
                  <a:pt x="886607" y="829045"/>
                  <a:pt x="878664" y="828052"/>
                </a:cubicBezTo>
                <a:cubicBezTo>
                  <a:pt x="875685" y="827059"/>
                  <a:pt x="872747" y="825936"/>
                  <a:pt x="869728" y="825073"/>
                </a:cubicBezTo>
                <a:cubicBezTo>
                  <a:pt x="865266" y="823798"/>
                  <a:pt x="853646" y="821499"/>
                  <a:pt x="848879" y="819116"/>
                </a:cubicBezTo>
                <a:cubicBezTo>
                  <a:pt x="825792" y="807572"/>
                  <a:pt x="853459" y="817664"/>
                  <a:pt x="831008" y="810181"/>
                </a:cubicBezTo>
                <a:cubicBezTo>
                  <a:pt x="828029" y="808195"/>
                  <a:pt x="825274" y="805825"/>
                  <a:pt x="822072" y="804224"/>
                </a:cubicBezTo>
                <a:cubicBezTo>
                  <a:pt x="819264" y="802820"/>
                  <a:pt x="815749" y="802986"/>
                  <a:pt x="813137" y="801245"/>
                </a:cubicBezTo>
                <a:cubicBezTo>
                  <a:pt x="809632" y="798908"/>
                  <a:pt x="807706" y="794647"/>
                  <a:pt x="804201" y="792310"/>
                </a:cubicBezTo>
                <a:cubicBezTo>
                  <a:pt x="801589" y="790569"/>
                  <a:pt x="798010" y="790856"/>
                  <a:pt x="795266" y="789331"/>
                </a:cubicBezTo>
                <a:cubicBezTo>
                  <a:pt x="789008" y="785854"/>
                  <a:pt x="777395" y="777417"/>
                  <a:pt x="777395" y="777417"/>
                </a:cubicBezTo>
                <a:cubicBezTo>
                  <a:pt x="772151" y="761690"/>
                  <a:pt x="776158" y="771095"/>
                  <a:pt x="762502" y="750611"/>
                </a:cubicBezTo>
                <a:lnTo>
                  <a:pt x="756545" y="741675"/>
                </a:lnTo>
                <a:lnTo>
                  <a:pt x="750588" y="732740"/>
                </a:lnTo>
                <a:lnTo>
                  <a:pt x="741653" y="705933"/>
                </a:lnTo>
                <a:cubicBezTo>
                  <a:pt x="740660" y="702955"/>
                  <a:pt x="740415" y="699610"/>
                  <a:pt x="738674" y="696998"/>
                </a:cubicBezTo>
                <a:lnTo>
                  <a:pt x="732717" y="688062"/>
                </a:lnTo>
                <a:cubicBezTo>
                  <a:pt x="721859" y="655484"/>
                  <a:pt x="739175" y="704827"/>
                  <a:pt x="723782" y="670191"/>
                </a:cubicBezTo>
                <a:cubicBezTo>
                  <a:pt x="721232" y="664453"/>
                  <a:pt x="719811" y="658277"/>
                  <a:pt x="717825" y="652320"/>
                </a:cubicBezTo>
                <a:lnTo>
                  <a:pt x="711868" y="634449"/>
                </a:lnTo>
                <a:cubicBezTo>
                  <a:pt x="710915" y="630636"/>
                  <a:pt x="708046" y="617870"/>
                  <a:pt x="705911" y="613600"/>
                </a:cubicBezTo>
                <a:cubicBezTo>
                  <a:pt x="704310" y="610398"/>
                  <a:pt x="701940" y="607643"/>
                  <a:pt x="699954" y="604664"/>
                </a:cubicBezTo>
                <a:cubicBezTo>
                  <a:pt x="698961" y="571900"/>
                  <a:pt x="698793" y="539101"/>
                  <a:pt x="696975" y="506373"/>
                </a:cubicBezTo>
                <a:cubicBezTo>
                  <a:pt x="696801" y="503238"/>
                  <a:pt x="694678" y="500503"/>
                  <a:pt x="693997" y="497438"/>
                </a:cubicBezTo>
                <a:cubicBezTo>
                  <a:pt x="692687" y="491543"/>
                  <a:pt x="692328" y="485462"/>
                  <a:pt x="691018" y="479567"/>
                </a:cubicBezTo>
                <a:cubicBezTo>
                  <a:pt x="690337" y="476502"/>
                  <a:pt x="688801" y="473677"/>
                  <a:pt x="688040" y="470631"/>
                </a:cubicBezTo>
                <a:cubicBezTo>
                  <a:pt x="679621" y="436953"/>
                  <a:pt x="691882" y="476206"/>
                  <a:pt x="679104" y="437868"/>
                </a:cubicBezTo>
                <a:lnTo>
                  <a:pt x="676126" y="428932"/>
                </a:lnTo>
                <a:cubicBezTo>
                  <a:pt x="675133" y="419004"/>
                  <a:pt x="674664" y="409009"/>
                  <a:pt x="673147" y="399147"/>
                </a:cubicBezTo>
                <a:cubicBezTo>
                  <a:pt x="672670" y="396044"/>
                  <a:pt x="671910" y="392824"/>
                  <a:pt x="670169" y="390212"/>
                </a:cubicBezTo>
                <a:cubicBezTo>
                  <a:pt x="667832" y="386707"/>
                  <a:pt x="664212" y="384255"/>
                  <a:pt x="661233" y="381276"/>
                </a:cubicBezTo>
                <a:cubicBezTo>
                  <a:pt x="659247" y="375319"/>
                  <a:pt x="660501" y="366888"/>
                  <a:pt x="655276" y="363405"/>
                </a:cubicBezTo>
                <a:cubicBezTo>
                  <a:pt x="652298" y="361419"/>
                  <a:pt x="649002" y="359843"/>
                  <a:pt x="646341" y="357448"/>
                </a:cubicBezTo>
                <a:cubicBezTo>
                  <a:pt x="639035" y="350873"/>
                  <a:pt x="634617" y="340249"/>
                  <a:pt x="625491" y="336599"/>
                </a:cubicBezTo>
                <a:cubicBezTo>
                  <a:pt x="587232" y="321295"/>
                  <a:pt x="634666" y="341186"/>
                  <a:pt x="595706" y="321706"/>
                </a:cubicBezTo>
                <a:cubicBezTo>
                  <a:pt x="592898" y="320302"/>
                  <a:pt x="589657" y="319965"/>
                  <a:pt x="586771" y="318728"/>
                </a:cubicBezTo>
                <a:cubicBezTo>
                  <a:pt x="582690" y="316979"/>
                  <a:pt x="578712" y="314974"/>
                  <a:pt x="574857" y="312771"/>
                </a:cubicBezTo>
                <a:cubicBezTo>
                  <a:pt x="571749" y="310995"/>
                  <a:pt x="569245" y="308144"/>
                  <a:pt x="565921" y="306814"/>
                </a:cubicBezTo>
                <a:cubicBezTo>
                  <a:pt x="559210" y="304130"/>
                  <a:pt x="552022" y="302843"/>
                  <a:pt x="545072" y="300857"/>
                </a:cubicBezTo>
                <a:cubicBezTo>
                  <a:pt x="544079" y="297878"/>
                  <a:pt x="544021" y="294399"/>
                  <a:pt x="542093" y="291921"/>
                </a:cubicBezTo>
                <a:cubicBezTo>
                  <a:pt x="528029" y="273839"/>
                  <a:pt x="529968" y="275965"/>
                  <a:pt x="515287" y="271072"/>
                </a:cubicBezTo>
                <a:lnTo>
                  <a:pt x="497416" y="244265"/>
                </a:lnTo>
                <a:lnTo>
                  <a:pt x="491459" y="235330"/>
                </a:lnTo>
                <a:cubicBezTo>
                  <a:pt x="489473" y="232351"/>
                  <a:pt x="488033" y="228925"/>
                  <a:pt x="485502" y="226394"/>
                </a:cubicBezTo>
                <a:lnTo>
                  <a:pt x="467631" y="208523"/>
                </a:lnTo>
                <a:cubicBezTo>
                  <a:pt x="462396" y="192821"/>
                  <a:pt x="468111" y="205526"/>
                  <a:pt x="455717" y="190652"/>
                </a:cubicBezTo>
                <a:cubicBezTo>
                  <a:pt x="453425" y="187902"/>
                  <a:pt x="452052" y="184467"/>
                  <a:pt x="449760" y="181717"/>
                </a:cubicBezTo>
                <a:cubicBezTo>
                  <a:pt x="447063" y="178481"/>
                  <a:pt x="443521" y="176017"/>
                  <a:pt x="440824" y="172781"/>
                </a:cubicBezTo>
                <a:cubicBezTo>
                  <a:pt x="438532" y="170031"/>
                  <a:pt x="437398" y="166377"/>
                  <a:pt x="434867" y="163846"/>
                </a:cubicBezTo>
                <a:cubicBezTo>
                  <a:pt x="431357" y="160336"/>
                  <a:pt x="426924" y="157889"/>
                  <a:pt x="422953" y="154910"/>
                </a:cubicBezTo>
                <a:cubicBezTo>
                  <a:pt x="420967" y="149946"/>
                  <a:pt x="419830" y="144552"/>
                  <a:pt x="416996" y="140018"/>
                </a:cubicBezTo>
                <a:cubicBezTo>
                  <a:pt x="405981" y="122394"/>
                  <a:pt x="405328" y="140749"/>
                  <a:pt x="396147" y="113211"/>
                </a:cubicBezTo>
                <a:cubicBezTo>
                  <a:pt x="395154" y="110233"/>
                  <a:pt x="394031" y="107295"/>
                  <a:pt x="393168" y="104276"/>
                </a:cubicBezTo>
                <a:cubicBezTo>
                  <a:pt x="385685" y="78088"/>
                  <a:pt x="394356" y="104858"/>
                  <a:pt x="387211" y="83426"/>
                </a:cubicBezTo>
                <a:cubicBezTo>
                  <a:pt x="386218" y="73498"/>
                  <a:pt x="385029" y="63587"/>
                  <a:pt x="384233" y="53641"/>
                </a:cubicBezTo>
                <a:cubicBezTo>
                  <a:pt x="383043" y="38763"/>
                  <a:pt x="389325" y="21519"/>
                  <a:pt x="381254" y="8964"/>
                </a:cubicBezTo>
                <a:cubicBezTo>
                  <a:pt x="376925" y="2231"/>
                  <a:pt x="365369" y="10949"/>
                  <a:pt x="357426" y="11942"/>
                </a:cubicBezTo>
                <a:cubicBezTo>
                  <a:pt x="353209" y="13348"/>
                  <a:pt x="340321" y="17899"/>
                  <a:pt x="336577" y="17899"/>
                </a:cubicBezTo>
                <a:cubicBezTo>
                  <a:pt x="318678" y="17899"/>
                  <a:pt x="300825" y="16073"/>
                  <a:pt x="282964" y="14921"/>
                </a:cubicBezTo>
                <a:cubicBezTo>
                  <a:pt x="270046" y="14088"/>
                  <a:pt x="257132" y="13150"/>
                  <a:pt x="244243" y="11942"/>
                </a:cubicBezTo>
                <a:cubicBezTo>
                  <a:pt x="176271" y="5569"/>
                  <a:pt x="164816" y="-468"/>
                  <a:pt x="145952" y="28"/>
                </a:cubicBezTo>
                <a:close/>
              </a:path>
            </a:pathLst>
          </a:custGeom>
          <a:noFill/>
          <a:ln w="9525">
            <a:solidFill>
              <a:srgbClr val="FFFF0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14" name="Figura a mano libera 13"/>
          <p:cNvSpPr/>
          <p:nvPr/>
        </p:nvSpPr>
        <p:spPr>
          <a:xfrm>
            <a:off x="451884" y="3612018"/>
            <a:ext cx="1281223" cy="1379967"/>
          </a:xfrm>
          <a:custGeom>
            <a:avLst/>
            <a:gdLst>
              <a:gd name="connsiteX0" fmla="*/ 1281223 w 1281223"/>
              <a:gd name="connsiteY0" fmla="*/ 712439 h 1382290"/>
              <a:gd name="connsiteX1" fmla="*/ 1217428 w 1281223"/>
              <a:gd name="connsiteY1" fmla="*/ 707123 h 1382290"/>
              <a:gd name="connsiteX2" fmla="*/ 1169581 w 1281223"/>
              <a:gd name="connsiteY2" fmla="*/ 691174 h 1382290"/>
              <a:gd name="connsiteX3" fmla="*/ 1153633 w 1281223"/>
              <a:gd name="connsiteY3" fmla="*/ 685857 h 1382290"/>
              <a:gd name="connsiteX4" fmla="*/ 1111102 w 1281223"/>
              <a:gd name="connsiteY4" fmla="*/ 653960 h 1382290"/>
              <a:gd name="connsiteX5" fmla="*/ 1079205 w 1281223"/>
              <a:gd name="connsiteY5" fmla="*/ 632695 h 1382290"/>
              <a:gd name="connsiteX6" fmla="*/ 1057940 w 1281223"/>
              <a:gd name="connsiteY6" fmla="*/ 622062 h 1382290"/>
              <a:gd name="connsiteX7" fmla="*/ 1026042 w 1281223"/>
              <a:gd name="connsiteY7" fmla="*/ 595481 h 1382290"/>
              <a:gd name="connsiteX8" fmla="*/ 1015409 w 1281223"/>
              <a:gd name="connsiteY8" fmla="*/ 574216 h 1382290"/>
              <a:gd name="connsiteX9" fmla="*/ 994144 w 1281223"/>
              <a:gd name="connsiteY9" fmla="*/ 542318 h 1382290"/>
              <a:gd name="connsiteX10" fmla="*/ 983512 w 1281223"/>
              <a:gd name="connsiteY10" fmla="*/ 526369 h 1382290"/>
              <a:gd name="connsiteX11" fmla="*/ 972879 w 1281223"/>
              <a:gd name="connsiteY11" fmla="*/ 510420 h 1382290"/>
              <a:gd name="connsiteX12" fmla="*/ 962247 w 1281223"/>
              <a:gd name="connsiteY12" fmla="*/ 489155 h 1382290"/>
              <a:gd name="connsiteX13" fmla="*/ 956930 w 1281223"/>
              <a:gd name="connsiteY13" fmla="*/ 473206 h 1382290"/>
              <a:gd name="connsiteX14" fmla="*/ 930349 w 1281223"/>
              <a:gd name="connsiteY14" fmla="*/ 435992 h 1382290"/>
              <a:gd name="connsiteX15" fmla="*/ 893135 w 1281223"/>
              <a:gd name="connsiteY15" fmla="*/ 393462 h 1382290"/>
              <a:gd name="connsiteX16" fmla="*/ 861237 w 1281223"/>
              <a:gd name="connsiteY16" fmla="*/ 345616 h 1382290"/>
              <a:gd name="connsiteX17" fmla="*/ 839972 w 1281223"/>
              <a:gd name="connsiteY17" fmla="*/ 313718 h 1382290"/>
              <a:gd name="connsiteX18" fmla="*/ 824023 w 1281223"/>
              <a:gd name="connsiteY18" fmla="*/ 292453 h 1382290"/>
              <a:gd name="connsiteX19" fmla="*/ 813391 w 1281223"/>
              <a:gd name="connsiteY19" fmla="*/ 260555 h 1382290"/>
              <a:gd name="connsiteX20" fmla="*/ 808074 w 1281223"/>
              <a:gd name="connsiteY20" fmla="*/ 239290 h 1382290"/>
              <a:gd name="connsiteX21" fmla="*/ 797442 w 1281223"/>
              <a:gd name="connsiteY21" fmla="*/ 207392 h 1382290"/>
              <a:gd name="connsiteX22" fmla="*/ 781493 w 1281223"/>
              <a:gd name="connsiteY22" fmla="*/ 170178 h 1382290"/>
              <a:gd name="connsiteX23" fmla="*/ 776177 w 1281223"/>
              <a:gd name="connsiteY23" fmla="*/ 154230 h 1382290"/>
              <a:gd name="connsiteX24" fmla="*/ 770860 w 1281223"/>
              <a:gd name="connsiteY24" fmla="*/ 132964 h 1382290"/>
              <a:gd name="connsiteX25" fmla="*/ 749595 w 1281223"/>
              <a:gd name="connsiteY25" fmla="*/ 90434 h 1382290"/>
              <a:gd name="connsiteX26" fmla="*/ 754912 w 1281223"/>
              <a:gd name="connsiteY26" fmla="*/ 16006 h 1382290"/>
              <a:gd name="connsiteX27" fmla="*/ 760228 w 1281223"/>
              <a:gd name="connsiteY27" fmla="*/ 57 h 1382290"/>
              <a:gd name="connsiteX28" fmla="*/ 324293 w 1281223"/>
              <a:gd name="connsiteY28" fmla="*/ 10690 h 1382290"/>
              <a:gd name="connsiteX29" fmla="*/ 281763 w 1281223"/>
              <a:gd name="connsiteY29" fmla="*/ 21323 h 1382290"/>
              <a:gd name="connsiteX30" fmla="*/ 233916 w 1281223"/>
              <a:gd name="connsiteY30" fmla="*/ 37271 h 1382290"/>
              <a:gd name="connsiteX31" fmla="*/ 217967 w 1281223"/>
              <a:gd name="connsiteY31" fmla="*/ 47904 h 1382290"/>
              <a:gd name="connsiteX32" fmla="*/ 186070 w 1281223"/>
              <a:gd name="connsiteY32" fmla="*/ 58537 h 1382290"/>
              <a:gd name="connsiteX33" fmla="*/ 148856 w 1281223"/>
              <a:gd name="connsiteY33" fmla="*/ 74485 h 1382290"/>
              <a:gd name="connsiteX34" fmla="*/ 132907 w 1281223"/>
              <a:gd name="connsiteY34" fmla="*/ 90434 h 1382290"/>
              <a:gd name="connsiteX35" fmla="*/ 95693 w 1281223"/>
              <a:gd name="connsiteY35" fmla="*/ 106383 h 1382290"/>
              <a:gd name="connsiteX36" fmla="*/ 79744 w 1281223"/>
              <a:gd name="connsiteY36" fmla="*/ 122332 h 1382290"/>
              <a:gd name="connsiteX37" fmla="*/ 63795 w 1281223"/>
              <a:gd name="connsiteY37" fmla="*/ 132964 h 1382290"/>
              <a:gd name="connsiteX38" fmla="*/ 53163 w 1281223"/>
              <a:gd name="connsiteY38" fmla="*/ 148913 h 1382290"/>
              <a:gd name="connsiteX39" fmla="*/ 26581 w 1281223"/>
              <a:gd name="connsiteY39" fmla="*/ 186127 h 1382290"/>
              <a:gd name="connsiteX40" fmla="*/ 15949 w 1281223"/>
              <a:gd name="connsiteY40" fmla="*/ 218025 h 1382290"/>
              <a:gd name="connsiteX41" fmla="*/ 10633 w 1281223"/>
              <a:gd name="connsiteY41" fmla="*/ 233974 h 1382290"/>
              <a:gd name="connsiteX42" fmla="*/ 0 w 1281223"/>
              <a:gd name="connsiteY42" fmla="*/ 281820 h 1382290"/>
              <a:gd name="connsiteX43" fmla="*/ 5316 w 1281223"/>
              <a:gd name="connsiteY43" fmla="*/ 329667 h 1382290"/>
              <a:gd name="connsiteX44" fmla="*/ 10633 w 1281223"/>
              <a:gd name="connsiteY44" fmla="*/ 345616 h 1382290"/>
              <a:gd name="connsiteX45" fmla="*/ 42530 w 1281223"/>
              <a:gd name="connsiteY45" fmla="*/ 366881 h 1382290"/>
              <a:gd name="connsiteX46" fmla="*/ 63795 w 1281223"/>
              <a:gd name="connsiteY46" fmla="*/ 382830 h 1382290"/>
              <a:gd name="connsiteX47" fmla="*/ 95693 w 1281223"/>
              <a:gd name="connsiteY47" fmla="*/ 404095 h 1382290"/>
              <a:gd name="connsiteX48" fmla="*/ 127591 w 1281223"/>
              <a:gd name="connsiteY48" fmla="*/ 414727 h 1382290"/>
              <a:gd name="connsiteX49" fmla="*/ 154172 w 1281223"/>
              <a:gd name="connsiteY49" fmla="*/ 451941 h 1382290"/>
              <a:gd name="connsiteX50" fmla="*/ 164805 w 1281223"/>
              <a:gd name="connsiteY50" fmla="*/ 483839 h 1382290"/>
              <a:gd name="connsiteX51" fmla="*/ 170121 w 1281223"/>
              <a:gd name="connsiteY51" fmla="*/ 499788 h 1382290"/>
              <a:gd name="connsiteX52" fmla="*/ 191386 w 1281223"/>
              <a:gd name="connsiteY52" fmla="*/ 531685 h 1382290"/>
              <a:gd name="connsiteX53" fmla="*/ 207335 w 1281223"/>
              <a:gd name="connsiteY53" fmla="*/ 552951 h 1382290"/>
              <a:gd name="connsiteX54" fmla="*/ 239233 w 1281223"/>
              <a:gd name="connsiteY54" fmla="*/ 595481 h 1382290"/>
              <a:gd name="connsiteX55" fmla="*/ 249865 w 1281223"/>
              <a:gd name="connsiteY55" fmla="*/ 627378 h 1382290"/>
              <a:gd name="connsiteX56" fmla="*/ 271130 w 1281223"/>
              <a:gd name="connsiteY56" fmla="*/ 659276 h 1382290"/>
              <a:gd name="connsiteX57" fmla="*/ 287079 w 1281223"/>
              <a:gd name="connsiteY57" fmla="*/ 691174 h 1382290"/>
              <a:gd name="connsiteX58" fmla="*/ 297712 w 1281223"/>
              <a:gd name="connsiteY58" fmla="*/ 739020 h 1382290"/>
              <a:gd name="connsiteX59" fmla="*/ 303028 w 1281223"/>
              <a:gd name="connsiteY59" fmla="*/ 754969 h 1382290"/>
              <a:gd name="connsiteX60" fmla="*/ 313660 w 1281223"/>
              <a:gd name="connsiteY60" fmla="*/ 770918 h 1382290"/>
              <a:gd name="connsiteX61" fmla="*/ 324293 w 1281223"/>
              <a:gd name="connsiteY61" fmla="*/ 808132 h 1382290"/>
              <a:gd name="connsiteX62" fmla="*/ 334926 w 1281223"/>
              <a:gd name="connsiteY62" fmla="*/ 824081 h 1382290"/>
              <a:gd name="connsiteX63" fmla="*/ 345558 w 1281223"/>
              <a:gd name="connsiteY63" fmla="*/ 893192 h 1382290"/>
              <a:gd name="connsiteX64" fmla="*/ 350874 w 1281223"/>
              <a:gd name="connsiteY64" fmla="*/ 909141 h 1382290"/>
              <a:gd name="connsiteX65" fmla="*/ 356191 w 1281223"/>
              <a:gd name="connsiteY65" fmla="*/ 930406 h 1382290"/>
              <a:gd name="connsiteX66" fmla="*/ 366823 w 1281223"/>
              <a:gd name="connsiteY66" fmla="*/ 1010151 h 1382290"/>
              <a:gd name="connsiteX67" fmla="*/ 372140 w 1281223"/>
              <a:gd name="connsiteY67" fmla="*/ 1079262 h 1382290"/>
              <a:gd name="connsiteX68" fmla="*/ 382772 w 1281223"/>
              <a:gd name="connsiteY68" fmla="*/ 1116476 h 1382290"/>
              <a:gd name="connsiteX69" fmla="*/ 388088 w 1281223"/>
              <a:gd name="connsiteY69" fmla="*/ 1143057 h 1382290"/>
              <a:gd name="connsiteX70" fmla="*/ 398721 w 1281223"/>
              <a:gd name="connsiteY70" fmla="*/ 1174955 h 1382290"/>
              <a:gd name="connsiteX71" fmla="*/ 404037 w 1281223"/>
              <a:gd name="connsiteY71" fmla="*/ 1217485 h 1382290"/>
              <a:gd name="connsiteX72" fmla="*/ 409353 w 1281223"/>
              <a:gd name="connsiteY72" fmla="*/ 1291913 h 1382290"/>
              <a:gd name="connsiteX73" fmla="*/ 419986 w 1281223"/>
              <a:gd name="connsiteY73" fmla="*/ 1339760 h 1382290"/>
              <a:gd name="connsiteX74" fmla="*/ 425302 w 1281223"/>
              <a:gd name="connsiteY74" fmla="*/ 1366341 h 1382290"/>
              <a:gd name="connsiteX75" fmla="*/ 435935 w 1281223"/>
              <a:gd name="connsiteY75" fmla="*/ 1382290 h 138229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Lst>
            <a:rect l="l" t="t" r="r" b="b"/>
            <a:pathLst>
              <a:path w="1281223" h="1382290">
                <a:moveTo>
                  <a:pt x="1281223" y="712439"/>
                </a:moveTo>
                <a:cubicBezTo>
                  <a:pt x="1259958" y="710667"/>
                  <a:pt x="1238390" y="711116"/>
                  <a:pt x="1217428" y="707123"/>
                </a:cubicBezTo>
                <a:cubicBezTo>
                  <a:pt x="1200913" y="703977"/>
                  <a:pt x="1185530" y="696491"/>
                  <a:pt x="1169581" y="691174"/>
                </a:cubicBezTo>
                <a:lnTo>
                  <a:pt x="1153633" y="685857"/>
                </a:lnTo>
                <a:cubicBezTo>
                  <a:pt x="1127973" y="660199"/>
                  <a:pt x="1147435" y="677081"/>
                  <a:pt x="1111102" y="653960"/>
                </a:cubicBezTo>
                <a:cubicBezTo>
                  <a:pt x="1100321" y="647100"/>
                  <a:pt x="1090634" y="638410"/>
                  <a:pt x="1079205" y="632695"/>
                </a:cubicBezTo>
                <a:cubicBezTo>
                  <a:pt x="1072117" y="629151"/>
                  <a:pt x="1064821" y="625994"/>
                  <a:pt x="1057940" y="622062"/>
                </a:cubicBezTo>
                <a:cubicBezTo>
                  <a:pt x="1046683" y="615629"/>
                  <a:pt x="1033627" y="606099"/>
                  <a:pt x="1026042" y="595481"/>
                </a:cubicBezTo>
                <a:cubicBezTo>
                  <a:pt x="1021436" y="589032"/>
                  <a:pt x="1019486" y="581012"/>
                  <a:pt x="1015409" y="574216"/>
                </a:cubicBezTo>
                <a:cubicBezTo>
                  <a:pt x="1008834" y="563258"/>
                  <a:pt x="1001232" y="552951"/>
                  <a:pt x="994144" y="542318"/>
                </a:cubicBezTo>
                <a:lnTo>
                  <a:pt x="983512" y="526369"/>
                </a:lnTo>
                <a:cubicBezTo>
                  <a:pt x="979968" y="521053"/>
                  <a:pt x="975736" y="516135"/>
                  <a:pt x="972879" y="510420"/>
                </a:cubicBezTo>
                <a:cubicBezTo>
                  <a:pt x="969335" y="503332"/>
                  <a:pt x="965369" y="496439"/>
                  <a:pt x="962247" y="489155"/>
                </a:cubicBezTo>
                <a:cubicBezTo>
                  <a:pt x="960039" y="484004"/>
                  <a:pt x="959436" y="478218"/>
                  <a:pt x="956930" y="473206"/>
                </a:cubicBezTo>
                <a:cubicBezTo>
                  <a:pt x="952606" y="464558"/>
                  <a:pt x="934568" y="442019"/>
                  <a:pt x="930349" y="435992"/>
                </a:cubicBezTo>
                <a:cubicBezTo>
                  <a:pt x="903214" y="397228"/>
                  <a:pt x="920879" y="411959"/>
                  <a:pt x="893135" y="393462"/>
                </a:cubicBezTo>
                <a:lnTo>
                  <a:pt x="861237" y="345616"/>
                </a:lnTo>
                <a:cubicBezTo>
                  <a:pt x="861226" y="345599"/>
                  <a:pt x="839984" y="313734"/>
                  <a:pt x="839972" y="313718"/>
                </a:cubicBezTo>
                <a:lnTo>
                  <a:pt x="824023" y="292453"/>
                </a:lnTo>
                <a:cubicBezTo>
                  <a:pt x="820479" y="281820"/>
                  <a:pt x="816110" y="271428"/>
                  <a:pt x="813391" y="260555"/>
                </a:cubicBezTo>
                <a:cubicBezTo>
                  <a:pt x="811619" y="253467"/>
                  <a:pt x="810174" y="246288"/>
                  <a:pt x="808074" y="239290"/>
                </a:cubicBezTo>
                <a:cubicBezTo>
                  <a:pt x="804853" y="228555"/>
                  <a:pt x="800160" y="218265"/>
                  <a:pt x="797442" y="207392"/>
                </a:cubicBezTo>
                <a:cubicBezTo>
                  <a:pt x="790576" y="179928"/>
                  <a:pt x="796179" y="192206"/>
                  <a:pt x="781493" y="170178"/>
                </a:cubicBezTo>
                <a:cubicBezTo>
                  <a:pt x="779721" y="164862"/>
                  <a:pt x="777716" y="159618"/>
                  <a:pt x="776177" y="154230"/>
                </a:cubicBezTo>
                <a:cubicBezTo>
                  <a:pt x="774170" y="147204"/>
                  <a:pt x="773670" y="139709"/>
                  <a:pt x="770860" y="132964"/>
                </a:cubicBezTo>
                <a:cubicBezTo>
                  <a:pt x="764764" y="118333"/>
                  <a:pt x="749595" y="90434"/>
                  <a:pt x="749595" y="90434"/>
                </a:cubicBezTo>
                <a:cubicBezTo>
                  <a:pt x="751367" y="65625"/>
                  <a:pt x="752006" y="40708"/>
                  <a:pt x="754912" y="16006"/>
                </a:cubicBezTo>
                <a:cubicBezTo>
                  <a:pt x="755567" y="10441"/>
                  <a:pt x="765826" y="311"/>
                  <a:pt x="760228" y="57"/>
                </a:cubicBezTo>
                <a:cubicBezTo>
                  <a:pt x="740039" y="-861"/>
                  <a:pt x="366683" y="9544"/>
                  <a:pt x="324293" y="10690"/>
                </a:cubicBezTo>
                <a:cubicBezTo>
                  <a:pt x="270243" y="21500"/>
                  <a:pt x="319912" y="10423"/>
                  <a:pt x="281763" y="21323"/>
                </a:cubicBezTo>
                <a:cubicBezTo>
                  <a:pt x="258074" y="28092"/>
                  <a:pt x="258356" y="25051"/>
                  <a:pt x="233916" y="37271"/>
                </a:cubicBezTo>
                <a:cubicBezTo>
                  <a:pt x="228201" y="40128"/>
                  <a:pt x="223806" y="45309"/>
                  <a:pt x="217967" y="47904"/>
                </a:cubicBezTo>
                <a:cubicBezTo>
                  <a:pt x="207726" y="52456"/>
                  <a:pt x="195395" y="52320"/>
                  <a:pt x="186070" y="58537"/>
                </a:cubicBezTo>
                <a:cubicBezTo>
                  <a:pt x="164042" y="73222"/>
                  <a:pt x="176320" y="67619"/>
                  <a:pt x="148856" y="74485"/>
                </a:cubicBezTo>
                <a:cubicBezTo>
                  <a:pt x="143540" y="79801"/>
                  <a:pt x="139025" y="86064"/>
                  <a:pt x="132907" y="90434"/>
                </a:cubicBezTo>
                <a:cubicBezTo>
                  <a:pt x="121409" y="98647"/>
                  <a:pt x="108710" y="102044"/>
                  <a:pt x="95693" y="106383"/>
                </a:cubicBezTo>
                <a:cubicBezTo>
                  <a:pt x="90377" y="111699"/>
                  <a:pt x="85520" y="117519"/>
                  <a:pt x="79744" y="122332"/>
                </a:cubicBezTo>
                <a:cubicBezTo>
                  <a:pt x="74836" y="126422"/>
                  <a:pt x="68313" y="128446"/>
                  <a:pt x="63795" y="132964"/>
                </a:cubicBezTo>
                <a:cubicBezTo>
                  <a:pt x="59277" y="137482"/>
                  <a:pt x="56877" y="143714"/>
                  <a:pt x="53163" y="148913"/>
                </a:cubicBezTo>
                <a:cubicBezTo>
                  <a:pt x="20174" y="195098"/>
                  <a:pt x="51652" y="148521"/>
                  <a:pt x="26581" y="186127"/>
                </a:cubicBezTo>
                <a:lnTo>
                  <a:pt x="15949" y="218025"/>
                </a:lnTo>
                <a:cubicBezTo>
                  <a:pt x="14177" y="223341"/>
                  <a:pt x="11732" y="228479"/>
                  <a:pt x="10633" y="233974"/>
                </a:cubicBezTo>
                <a:cubicBezTo>
                  <a:pt x="3883" y="267720"/>
                  <a:pt x="7507" y="251789"/>
                  <a:pt x="0" y="281820"/>
                </a:cubicBezTo>
                <a:cubicBezTo>
                  <a:pt x="1772" y="297769"/>
                  <a:pt x="2678" y="313838"/>
                  <a:pt x="5316" y="329667"/>
                </a:cubicBezTo>
                <a:cubicBezTo>
                  <a:pt x="6237" y="335195"/>
                  <a:pt x="6670" y="341653"/>
                  <a:pt x="10633" y="345616"/>
                </a:cubicBezTo>
                <a:cubicBezTo>
                  <a:pt x="19669" y="354652"/>
                  <a:pt x="32307" y="359214"/>
                  <a:pt x="42530" y="366881"/>
                </a:cubicBezTo>
                <a:cubicBezTo>
                  <a:pt x="49618" y="372197"/>
                  <a:pt x="56536" y="377749"/>
                  <a:pt x="63795" y="382830"/>
                </a:cubicBezTo>
                <a:cubicBezTo>
                  <a:pt x="74264" y="390158"/>
                  <a:pt x="83570" y="400054"/>
                  <a:pt x="95693" y="404095"/>
                </a:cubicBezTo>
                <a:lnTo>
                  <a:pt x="127591" y="414727"/>
                </a:lnTo>
                <a:cubicBezTo>
                  <a:pt x="129736" y="417588"/>
                  <a:pt x="151344" y="445577"/>
                  <a:pt x="154172" y="451941"/>
                </a:cubicBezTo>
                <a:cubicBezTo>
                  <a:pt x="158724" y="462183"/>
                  <a:pt x="161261" y="473206"/>
                  <a:pt x="164805" y="483839"/>
                </a:cubicBezTo>
                <a:cubicBezTo>
                  <a:pt x="166577" y="489155"/>
                  <a:pt x="167012" y="495125"/>
                  <a:pt x="170121" y="499788"/>
                </a:cubicBezTo>
                <a:cubicBezTo>
                  <a:pt x="177209" y="510420"/>
                  <a:pt x="183719" y="521462"/>
                  <a:pt x="191386" y="531685"/>
                </a:cubicBezTo>
                <a:cubicBezTo>
                  <a:pt x="196702" y="538774"/>
                  <a:pt x="202639" y="545437"/>
                  <a:pt x="207335" y="552951"/>
                </a:cubicBezTo>
                <a:cubicBezTo>
                  <a:pt x="232526" y="593258"/>
                  <a:pt x="199617" y="555867"/>
                  <a:pt x="239233" y="595481"/>
                </a:cubicBezTo>
                <a:cubicBezTo>
                  <a:pt x="242777" y="606113"/>
                  <a:pt x="243648" y="618053"/>
                  <a:pt x="249865" y="627378"/>
                </a:cubicBezTo>
                <a:cubicBezTo>
                  <a:pt x="256953" y="638011"/>
                  <a:pt x="267089" y="647153"/>
                  <a:pt x="271130" y="659276"/>
                </a:cubicBezTo>
                <a:cubicBezTo>
                  <a:pt x="278468" y="681286"/>
                  <a:pt x="273339" y="670562"/>
                  <a:pt x="287079" y="691174"/>
                </a:cubicBezTo>
                <a:cubicBezTo>
                  <a:pt x="290736" y="709459"/>
                  <a:pt x="292703" y="721491"/>
                  <a:pt x="297712" y="739020"/>
                </a:cubicBezTo>
                <a:cubicBezTo>
                  <a:pt x="299252" y="744408"/>
                  <a:pt x="300522" y="749957"/>
                  <a:pt x="303028" y="754969"/>
                </a:cubicBezTo>
                <a:cubicBezTo>
                  <a:pt x="305885" y="760684"/>
                  <a:pt x="310116" y="765602"/>
                  <a:pt x="313660" y="770918"/>
                </a:cubicBezTo>
                <a:cubicBezTo>
                  <a:pt x="315362" y="777726"/>
                  <a:pt x="320482" y="800509"/>
                  <a:pt x="324293" y="808132"/>
                </a:cubicBezTo>
                <a:cubicBezTo>
                  <a:pt x="327150" y="813847"/>
                  <a:pt x="331382" y="818765"/>
                  <a:pt x="334926" y="824081"/>
                </a:cubicBezTo>
                <a:cubicBezTo>
                  <a:pt x="348315" y="877641"/>
                  <a:pt x="330251" y="801346"/>
                  <a:pt x="345558" y="893192"/>
                </a:cubicBezTo>
                <a:cubicBezTo>
                  <a:pt x="346479" y="898720"/>
                  <a:pt x="349334" y="903753"/>
                  <a:pt x="350874" y="909141"/>
                </a:cubicBezTo>
                <a:cubicBezTo>
                  <a:pt x="352881" y="916166"/>
                  <a:pt x="355051" y="923189"/>
                  <a:pt x="356191" y="930406"/>
                </a:cubicBezTo>
                <a:cubicBezTo>
                  <a:pt x="360373" y="956895"/>
                  <a:pt x="363966" y="983487"/>
                  <a:pt x="366823" y="1010151"/>
                </a:cubicBezTo>
                <a:cubicBezTo>
                  <a:pt x="369284" y="1033125"/>
                  <a:pt x="368713" y="1056413"/>
                  <a:pt x="372140" y="1079262"/>
                </a:cubicBezTo>
                <a:cubicBezTo>
                  <a:pt x="374054" y="1092020"/>
                  <a:pt x="379643" y="1103960"/>
                  <a:pt x="382772" y="1116476"/>
                </a:cubicBezTo>
                <a:cubicBezTo>
                  <a:pt x="384963" y="1125242"/>
                  <a:pt x="385711" y="1134340"/>
                  <a:pt x="388088" y="1143057"/>
                </a:cubicBezTo>
                <a:cubicBezTo>
                  <a:pt x="391037" y="1153870"/>
                  <a:pt x="398721" y="1174955"/>
                  <a:pt x="398721" y="1174955"/>
                </a:cubicBezTo>
                <a:cubicBezTo>
                  <a:pt x="400493" y="1189132"/>
                  <a:pt x="402744" y="1203257"/>
                  <a:pt x="404037" y="1217485"/>
                </a:cubicBezTo>
                <a:cubicBezTo>
                  <a:pt x="406289" y="1242255"/>
                  <a:pt x="406136" y="1267249"/>
                  <a:pt x="409353" y="1291913"/>
                </a:cubicBezTo>
                <a:cubicBezTo>
                  <a:pt x="411466" y="1308114"/>
                  <a:pt x="416563" y="1323785"/>
                  <a:pt x="419986" y="1339760"/>
                </a:cubicBezTo>
                <a:cubicBezTo>
                  <a:pt x="421879" y="1348595"/>
                  <a:pt x="422129" y="1357881"/>
                  <a:pt x="425302" y="1366341"/>
                </a:cubicBezTo>
                <a:cubicBezTo>
                  <a:pt x="427546" y="1372324"/>
                  <a:pt x="435935" y="1382290"/>
                  <a:pt x="435935" y="1382290"/>
                </a:cubicBezTo>
              </a:path>
            </a:pathLst>
          </a:custGeom>
          <a:noFill/>
          <a:ln w="9525">
            <a:solidFill>
              <a:srgbClr val="FFFF0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41" name="Figura a mano libera 40"/>
          <p:cNvSpPr/>
          <p:nvPr/>
        </p:nvSpPr>
        <p:spPr>
          <a:xfrm>
            <a:off x="4714853" y="3612018"/>
            <a:ext cx="1281223" cy="1379967"/>
          </a:xfrm>
          <a:custGeom>
            <a:avLst/>
            <a:gdLst>
              <a:gd name="connsiteX0" fmla="*/ 1281223 w 1281223"/>
              <a:gd name="connsiteY0" fmla="*/ 712439 h 1382290"/>
              <a:gd name="connsiteX1" fmla="*/ 1217428 w 1281223"/>
              <a:gd name="connsiteY1" fmla="*/ 707123 h 1382290"/>
              <a:gd name="connsiteX2" fmla="*/ 1169581 w 1281223"/>
              <a:gd name="connsiteY2" fmla="*/ 691174 h 1382290"/>
              <a:gd name="connsiteX3" fmla="*/ 1153633 w 1281223"/>
              <a:gd name="connsiteY3" fmla="*/ 685857 h 1382290"/>
              <a:gd name="connsiteX4" fmla="*/ 1111102 w 1281223"/>
              <a:gd name="connsiteY4" fmla="*/ 653960 h 1382290"/>
              <a:gd name="connsiteX5" fmla="*/ 1079205 w 1281223"/>
              <a:gd name="connsiteY5" fmla="*/ 632695 h 1382290"/>
              <a:gd name="connsiteX6" fmla="*/ 1057940 w 1281223"/>
              <a:gd name="connsiteY6" fmla="*/ 622062 h 1382290"/>
              <a:gd name="connsiteX7" fmla="*/ 1026042 w 1281223"/>
              <a:gd name="connsiteY7" fmla="*/ 595481 h 1382290"/>
              <a:gd name="connsiteX8" fmla="*/ 1015409 w 1281223"/>
              <a:gd name="connsiteY8" fmla="*/ 574216 h 1382290"/>
              <a:gd name="connsiteX9" fmla="*/ 994144 w 1281223"/>
              <a:gd name="connsiteY9" fmla="*/ 542318 h 1382290"/>
              <a:gd name="connsiteX10" fmla="*/ 983512 w 1281223"/>
              <a:gd name="connsiteY10" fmla="*/ 526369 h 1382290"/>
              <a:gd name="connsiteX11" fmla="*/ 972879 w 1281223"/>
              <a:gd name="connsiteY11" fmla="*/ 510420 h 1382290"/>
              <a:gd name="connsiteX12" fmla="*/ 962247 w 1281223"/>
              <a:gd name="connsiteY12" fmla="*/ 489155 h 1382290"/>
              <a:gd name="connsiteX13" fmla="*/ 956930 w 1281223"/>
              <a:gd name="connsiteY13" fmla="*/ 473206 h 1382290"/>
              <a:gd name="connsiteX14" fmla="*/ 930349 w 1281223"/>
              <a:gd name="connsiteY14" fmla="*/ 435992 h 1382290"/>
              <a:gd name="connsiteX15" fmla="*/ 893135 w 1281223"/>
              <a:gd name="connsiteY15" fmla="*/ 393462 h 1382290"/>
              <a:gd name="connsiteX16" fmla="*/ 861237 w 1281223"/>
              <a:gd name="connsiteY16" fmla="*/ 345616 h 1382290"/>
              <a:gd name="connsiteX17" fmla="*/ 839972 w 1281223"/>
              <a:gd name="connsiteY17" fmla="*/ 313718 h 1382290"/>
              <a:gd name="connsiteX18" fmla="*/ 824023 w 1281223"/>
              <a:gd name="connsiteY18" fmla="*/ 292453 h 1382290"/>
              <a:gd name="connsiteX19" fmla="*/ 813391 w 1281223"/>
              <a:gd name="connsiteY19" fmla="*/ 260555 h 1382290"/>
              <a:gd name="connsiteX20" fmla="*/ 808074 w 1281223"/>
              <a:gd name="connsiteY20" fmla="*/ 239290 h 1382290"/>
              <a:gd name="connsiteX21" fmla="*/ 797442 w 1281223"/>
              <a:gd name="connsiteY21" fmla="*/ 207392 h 1382290"/>
              <a:gd name="connsiteX22" fmla="*/ 781493 w 1281223"/>
              <a:gd name="connsiteY22" fmla="*/ 170178 h 1382290"/>
              <a:gd name="connsiteX23" fmla="*/ 776177 w 1281223"/>
              <a:gd name="connsiteY23" fmla="*/ 154230 h 1382290"/>
              <a:gd name="connsiteX24" fmla="*/ 770860 w 1281223"/>
              <a:gd name="connsiteY24" fmla="*/ 132964 h 1382290"/>
              <a:gd name="connsiteX25" fmla="*/ 749595 w 1281223"/>
              <a:gd name="connsiteY25" fmla="*/ 90434 h 1382290"/>
              <a:gd name="connsiteX26" fmla="*/ 754912 w 1281223"/>
              <a:gd name="connsiteY26" fmla="*/ 16006 h 1382290"/>
              <a:gd name="connsiteX27" fmla="*/ 760228 w 1281223"/>
              <a:gd name="connsiteY27" fmla="*/ 57 h 1382290"/>
              <a:gd name="connsiteX28" fmla="*/ 324293 w 1281223"/>
              <a:gd name="connsiteY28" fmla="*/ 10690 h 1382290"/>
              <a:gd name="connsiteX29" fmla="*/ 281763 w 1281223"/>
              <a:gd name="connsiteY29" fmla="*/ 21323 h 1382290"/>
              <a:gd name="connsiteX30" fmla="*/ 233916 w 1281223"/>
              <a:gd name="connsiteY30" fmla="*/ 37271 h 1382290"/>
              <a:gd name="connsiteX31" fmla="*/ 217967 w 1281223"/>
              <a:gd name="connsiteY31" fmla="*/ 47904 h 1382290"/>
              <a:gd name="connsiteX32" fmla="*/ 186070 w 1281223"/>
              <a:gd name="connsiteY32" fmla="*/ 58537 h 1382290"/>
              <a:gd name="connsiteX33" fmla="*/ 148856 w 1281223"/>
              <a:gd name="connsiteY33" fmla="*/ 74485 h 1382290"/>
              <a:gd name="connsiteX34" fmla="*/ 132907 w 1281223"/>
              <a:gd name="connsiteY34" fmla="*/ 90434 h 1382290"/>
              <a:gd name="connsiteX35" fmla="*/ 95693 w 1281223"/>
              <a:gd name="connsiteY35" fmla="*/ 106383 h 1382290"/>
              <a:gd name="connsiteX36" fmla="*/ 79744 w 1281223"/>
              <a:gd name="connsiteY36" fmla="*/ 122332 h 1382290"/>
              <a:gd name="connsiteX37" fmla="*/ 63795 w 1281223"/>
              <a:gd name="connsiteY37" fmla="*/ 132964 h 1382290"/>
              <a:gd name="connsiteX38" fmla="*/ 53163 w 1281223"/>
              <a:gd name="connsiteY38" fmla="*/ 148913 h 1382290"/>
              <a:gd name="connsiteX39" fmla="*/ 26581 w 1281223"/>
              <a:gd name="connsiteY39" fmla="*/ 186127 h 1382290"/>
              <a:gd name="connsiteX40" fmla="*/ 15949 w 1281223"/>
              <a:gd name="connsiteY40" fmla="*/ 218025 h 1382290"/>
              <a:gd name="connsiteX41" fmla="*/ 10633 w 1281223"/>
              <a:gd name="connsiteY41" fmla="*/ 233974 h 1382290"/>
              <a:gd name="connsiteX42" fmla="*/ 0 w 1281223"/>
              <a:gd name="connsiteY42" fmla="*/ 281820 h 1382290"/>
              <a:gd name="connsiteX43" fmla="*/ 5316 w 1281223"/>
              <a:gd name="connsiteY43" fmla="*/ 329667 h 1382290"/>
              <a:gd name="connsiteX44" fmla="*/ 10633 w 1281223"/>
              <a:gd name="connsiteY44" fmla="*/ 345616 h 1382290"/>
              <a:gd name="connsiteX45" fmla="*/ 42530 w 1281223"/>
              <a:gd name="connsiteY45" fmla="*/ 366881 h 1382290"/>
              <a:gd name="connsiteX46" fmla="*/ 63795 w 1281223"/>
              <a:gd name="connsiteY46" fmla="*/ 382830 h 1382290"/>
              <a:gd name="connsiteX47" fmla="*/ 95693 w 1281223"/>
              <a:gd name="connsiteY47" fmla="*/ 404095 h 1382290"/>
              <a:gd name="connsiteX48" fmla="*/ 127591 w 1281223"/>
              <a:gd name="connsiteY48" fmla="*/ 414727 h 1382290"/>
              <a:gd name="connsiteX49" fmla="*/ 154172 w 1281223"/>
              <a:gd name="connsiteY49" fmla="*/ 451941 h 1382290"/>
              <a:gd name="connsiteX50" fmla="*/ 164805 w 1281223"/>
              <a:gd name="connsiteY50" fmla="*/ 483839 h 1382290"/>
              <a:gd name="connsiteX51" fmla="*/ 170121 w 1281223"/>
              <a:gd name="connsiteY51" fmla="*/ 499788 h 1382290"/>
              <a:gd name="connsiteX52" fmla="*/ 191386 w 1281223"/>
              <a:gd name="connsiteY52" fmla="*/ 531685 h 1382290"/>
              <a:gd name="connsiteX53" fmla="*/ 207335 w 1281223"/>
              <a:gd name="connsiteY53" fmla="*/ 552951 h 1382290"/>
              <a:gd name="connsiteX54" fmla="*/ 239233 w 1281223"/>
              <a:gd name="connsiteY54" fmla="*/ 595481 h 1382290"/>
              <a:gd name="connsiteX55" fmla="*/ 249865 w 1281223"/>
              <a:gd name="connsiteY55" fmla="*/ 627378 h 1382290"/>
              <a:gd name="connsiteX56" fmla="*/ 271130 w 1281223"/>
              <a:gd name="connsiteY56" fmla="*/ 659276 h 1382290"/>
              <a:gd name="connsiteX57" fmla="*/ 287079 w 1281223"/>
              <a:gd name="connsiteY57" fmla="*/ 691174 h 1382290"/>
              <a:gd name="connsiteX58" fmla="*/ 297712 w 1281223"/>
              <a:gd name="connsiteY58" fmla="*/ 739020 h 1382290"/>
              <a:gd name="connsiteX59" fmla="*/ 303028 w 1281223"/>
              <a:gd name="connsiteY59" fmla="*/ 754969 h 1382290"/>
              <a:gd name="connsiteX60" fmla="*/ 313660 w 1281223"/>
              <a:gd name="connsiteY60" fmla="*/ 770918 h 1382290"/>
              <a:gd name="connsiteX61" fmla="*/ 324293 w 1281223"/>
              <a:gd name="connsiteY61" fmla="*/ 808132 h 1382290"/>
              <a:gd name="connsiteX62" fmla="*/ 334926 w 1281223"/>
              <a:gd name="connsiteY62" fmla="*/ 824081 h 1382290"/>
              <a:gd name="connsiteX63" fmla="*/ 345558 w 1281223"/>
              <a:gd name="connsiteY63" fmla="*/ 893192 h 1382290"/>
              <a:gd name="connsiteX64" fmla="*/ 350874 w 1281223"/>
              <a:gd name="connsiteY64" fmla="*/ 909141 h 1382290"/>
              <a:gd name="connsiteX65" fmla="*/ 356191 w 1281223"/>
              <a:gd name="connsiteY65" fmla="*/ 930406 h 1382290"/>
              <a:gd name="connsiteX66" fmla="*/ 366823 w 1281223"/>
              <a:gd name="connsiteY66" fmla="*/ 1010151 h 1382290"/>
              <a:gd name="connsiteX67" fmla="*/ 372140 w 1281223"/>
              <a:gd name="connsiteY67" fmla="*/ 1079262 h 1382290"/>
              <a:gd name="connsiteX68" fmla="*/ 382772 w 1281223"/>
              <a:gd name="connsiteY68" fmla="*/ 1116476 h 1382290"/>
              <a:gd name="connsiteX69" fmla="*/ 388088 w 1281223"/>
              <a:gd name="connsiteY69" fmla="*/ 1143057 h 1382290"/>
              <a:gd name="connsiteX70" fmla="*/ 398721 w 1281223"/>
              <a:gd name="connsiteY70" fmla="*/ 1174955 h 1382290"/>
              <a:gd name="connsiteX71" fmla="*/ 404037 w 1281223"/>
              <a:gd name="connsiteY71" fmla="*/ 1217485 h 1382290"/>
              <a:gd name="connsiteX72" fmla="*/ 409353 w 1281223"/>
              <a:gd name="connsiteY72" fmla="*/ 1291913 h 1382290"/>
              <a:gd name="connsiteX73" fmla="*/ 419986 w 1281223"/>
              <a:gd name="connsiteY73" fmla="*/ 1339760 h 1382290"/>
              <a:gd name="connsiteX74" fmla="*/ 425302 w 1281223"/>
              <a:gd name="connsiteY74" fmla="*/ 1366341 h 1382290"/>
              <a:gd name="connsiteX75" fmla="*/ 435935 w 1281223"/>
              <a:gd name="connsiteY75" fmla="*/ 1382290 h 138229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Lst>
            <a:rect l="l" t="t" r="r" b="b"/>
            <a:pathLst>
              <a:path w="1281223" h="1382290">
                <a:moveTo>
                  <a:pt x="1281223" y="712439"/>
                </a:moveTo>
                <a:cubicBezTo>
                  <a:pt x="1259958" y="710667"/>
                  <a:pt x="1238390" y="711116"/>
                  <a:pt x="1217428" y="707123"/>
                </a:cubicBezTo>
                <a:cubicBezTo>
                  <a:pt x="1200913" y="703977"/>
                  <a:pt x="1185530" y="696491"/>
                  <a:pt x="1169581" y="691174"/>
                </a:cubicBezTo>
                <a:lnTo>
                  <a:pt x="1153633" y="685857"/>
                </a:lnTo>
                <a:cubicBezTo>
                  <a:pt x="1127973" y="660199"/>
                  <a:pt x="1147435" y="677081"/>
                  <a:pt x="1111102" y="653960"/>
                </a:cubicBezTo>
                <a:cubicBezTo>
                  <a:pt x="1100321" y="647100"/>
                  <a:pt x="1090634" y="638410"/>
                  <a:pt x="1079205" y="632695"/>
                </a:cubicBezTo>
                <a:cubicBezTo>
                  <a:pt x="1072117" y="629151"/>
                  <a:pt x="1064821" y="625994"/>
                  <a:pt x="1057940" y="622062"/>
                </a:cubicBezTo>
                <a:cubicBezTo>
                  <a:pt x="1046683" y="615629"/>
                  <a:pt x="1033627" y="606099"/>
                  <a:pt x="1026042" y="595481"/>
                </a:cubicBezTo>
                <a:cubicBezTo>
                  <a:pt x="1021436" y="589032"/>
                  <a:pt x="1019486" y="581012"/>
                  <a:pt x="1015409" y="574216"/>
                </a:cubicBezTo>
                <a:cubicBezTo>
                  <a:pt x="1008834" y="563258"/>
                  <a:pt x="1001232" y="552951"/>
                  <a:pt x="994144" y="542318"/>
                </a:cubicBezTo>
                <a:lnTo>
                  <a:pt x="983512" y="526369"/>
                </a:lnTo>
                <a:cubicBezTo>
                  <a:pt x="979968" y="521053"/>
                  <a:pt x="975736" y="516135"/>
                  <a:pt x="972879" y="510420"/>
                </a:cubicBezTo>
                <a:cubicBezTo>
                  <a:pt x="969335" y="503332"/>
                  <a:pt x="965369" y="496439"/>
                  <a:pt x="962247" y="489155"/>
                </a:cubicBezTo>
                <a:cubicBezTo>
                  <a:pt x="960039" y="484004"/>
                  <a:pt x="959436" y="478218"/>
                  <a:pt x="956930" y="473206"/>
                </a:cubicBezTo>
                <a:cubicBezTo>
                  <a:pt x="952606" y="464558"/>
                  <a:pt x="934568" y="442019"/>
                  <a:pt x="930349" y="435992"/>
                </a:cubicBezTo>
                <a:cubicBezTo>
                  <a:pt x="903214" y="397228"/>
                  <a:pt x="920879" y="411959"/>
                  <a:pt x="893135" y="393462"/>
                </a:cubicBezTo>
                <a:lnTo>
                  <a:pt x="861237" y="345616"/>
                </a:lnTo>
                <a:cubicBezTo>
                  <a:pt x="861226" y="345599"/>
                  <a:pt x="839984" y="313734"/>
                  <a:pt x="839972" y="313718"/>
                </a:cubicBezTo>
                <a:lnTo>
                  <a:pt x="824023" y="292453"/>
                </a:lnTo>
                <a:cubicBezTo>
                  <a:pt x="820479" y="281820"/>
                  <a:pt x="816110" y="271428"/>
                  <a:pt x="813391" y="260555"/>
                </a:cubicBezTo>
                <a:cubicBezTo>
                  <a:pt x="811619" y="253467"/>
                  <a:pt x="810174" y="246288"/>
                  <a:pt x="808074" y="239290"/>
                </a:cubicBezTo>
                <a:cubicBezTo>
                  <a:pt x="804853" y="228555"/>
                  <a:pt x="800160" y="218265"/>
                  <a:pt x="797442" y="207392"/>
                </a:cubicBezTo>
                <a:cubicBezTo>
                  <a:pt x="790576" y="179928"/>
                  <a:pt x="796179" y="192206"/>
                  <a:pt x="781493" y="170178"/>
                </a:cubicBezTo>
                <a:cubicBezTo>
                  <a:pt x="779721" y="164862"/>
                  <a:pt x="777716" y="159618"/>
                  <a:pt x="776177" y="154230"/>
                </a:cubicBezTo>
                <a:cubicBezTo>
                  <a:pt x="774170" y="147204"/>
                  <a:pt x="773670" y="139709"/>
                  <a:pt x="770860" y="132964"/>
                </a:cubicBezTo>
                <a:cubicBezTo>
                  <a:pt x="764764" y="118333"/>
                  <a:pt x="749595" y="90434"/>
                  <a:pt x="749595" y="90434"/>
                </a:cubicBezTo>
                <a:cubicBezTo>
                  <a:pt x="751367" y="65625"/>
                  <a:pt x="752006" y="40708"/>
                  <a:pt x="754912" y="16006"/>
                </a:cubicBezTo>
                <a:cubicBezTo>
                  <a:pt x="755567" y="10441"/>
                  <a:pt x="765826" y="311"/>
                  <a:pt x="760228" y="57"/>
                </a:cubicBezTo>
                <a:cubicBezTo>
                  <a:pt x="740039" y="-861"/>
                  <a:pt x="366683" y="9544"/>
                  <a:pt x="324293" y="10690"/>
                </a:cubicBezTo>
                <a:cubicBezTo>
                  <a:pt x="270243" y="21500"/>
                  <a:pt x="319912" y="10423"/>
                  <a:pt x="281763" y="21323"/>
                </a:cubicBezTo>
                <a:cubicBezTo>
                  <a:pt x="258074" y="28092"/>
                  <a:pt x="258356" y="25051"/>
                  <a:pt x="233916" y="37271"/>
                </a:cubicBezTo>
                <a:cubicBezTo>
                  <a:pt x="228201" y="40128"/>
                  <a:pt x="223806" y="45309"/>
                  <a:pt x="217967" y="47904"/>
                </a:cubicBezTo>
                <a:cubicBezTo>
                  <a:pt x="207726" y="52456"/>
                  <a:pt x="195395" y="52320"/>
                  <a:pt x="186070" y="58537"/>
                </a:cubicBezTo>
                <a:cubicBezTo>
                  <a:pt x="164042" y="73222"/>
                  <a:pt x="176320" y="67619"/>
                  <a:pt x="148856" y="74485"/>
                </a:cubicBezTo>
                <a:cubicBezTo>
                  <a:pt x="143540" y="79801"/>
                  <a:pt x="139025" y="86064"/>
                  <a:pt x="132907" y="90434"/>
                </a:cubicBezTo>
                <a:cubicBezTo>
                  <a:pt x="121409" y="98647"/>
                  <a:pt x="108710" y="102044"/>
                  <a:pt x="95693" y="106383"/>
                </a:cubicBezTo>
                <a:cubicBezTo>
                  <a:pt x="90377" y="111699"/>
                  <a:pt x="85520" y="117519"/>
                  <a:pt x="79744" y="122332"/>
                </a:cubicBezTo>
                <a:cubicBezTo>
                  <a:pt x="74836" y="126422"/>
                  <a:pt x="68313" y="128446"/>
                  <a:pt x="63795" y="132964"/>
                </a:cubicBezTo>
                <a:cubicBezTo>
                  <a:pt x="59277" y="137482"/>
                  <a:pt x="56877" y="143714"/>
                  <a:pt x="53163" y="148913"/>
                </a:cubicBezTo>
                <a:cubicBezTo>
                  <a:pt x="20174" y="195098"/>
                  <a:pt x="51652" y="148521"/>
                  <a:pt x="26581" y="186127"/>
                </a:cubicBezTo>
                <a:lnTo>
                  <a:pt x="15949" y="218025"/>
                </a:lnTo>
                <a:cubicBezTo>
                  <a:pt x="14177" y="223341"/>
                  <a:pt x="11732" y="228479"/>
                  <a:pt x="10633" y="233974"/>
                </a:cubicBezTo>
                <a:cubicBezTo>
                  <a:pt x="3883" y="267720"/>
                  <a:pt x="7507" y="251789"/>
                  <a:pt x="0" y="281820"/>
                </a:cubicBezTo>
                <a:cubicBezTo>
                  <a:pt x="1772" y="297769"/>
                  <a:pt x="2678" y="313838"/>
                  <a:pt x="5316" y="329667"/>
                </a:cubicBezTo>
                <a:cubicBezTo>
                  <a:pt x="6237" y="335195"/>
                  <a:pt x="6670" y="341653"/>
                  <a:pt x="10633" y="345616"/>
                </a:cubicBezTo>
                <a:cubicBezTo>
                  <a:pt x="19669" y="354652"/>
                  <a:pt x="32307" y="359214"/>
                  <a:pt x="42530" y="366881"/>
                </a:cubicBezTo>
                <a:cubicBezTo>
                  <a:pt x="49618" y="372197"/>
                  <a:pt x="56536" y="377749"/>
                  <a:pt x="63795" y="382830"/>
                </a:cubicBezTo>
                <a:cubicBezTo>
                  <a:pt x="74264" y="390158"/>
                  <a:pt x="83570" y="400054"/>
                  <a:pt x="95693" y="404095"/>
                </a:cubicBezTo>
                <a:lnTo>
                  <a:pt x="127591" y="414727"/>
                </a:lnTo>
                <a:cubicBezTo>
                  <a:pt x="129736" y="417588"/>
                  <a:pt x="151344" y="445577"/>
                  <a:pt x="154172" y="451941"/>
                </a:cubicBezTo>
                <a:cubicBezTo>
                  <a:pt x="158724" y="462183"/>
                  <a:pt x="161261" y="473206"/>
                  <a:pt x="164805" y="483839"/>
                </a:cubicBezTo>
                <a:cubicBezTo>
                  <a:pt x="166577" y="489155"/>
                  <a:pt x="167012" y="495125"/>
                  <a:pt x="170121" y="499788"/>
                </a:cubicBezTo>
                <a:cubicBezTo>
                  <a:pt x="177209" y="510420"/>
                  <a:pt x="183719" y="521462"/>
                  <a:pt x="191386" y="531685"/>
                </a:cubicBezTo>
                <a:cubicBezTo>
                  <a:pt x="196702" y="538774"/>
                  <a:pt x="202639" y="545437"/>
                  <a:pt x="207335" y="552951"/>
                </a:cubicBezTo>
                <a:cubicBezTo>
                  <a:pt x="232526" y="593258"/>
                  <a:pt x="199617" y="555867"/>
                  <a:pt x="239233" y="595481"/>
                </a:cubicBezTo>
                <a:cubicBezTo>
                  <a:pt x="242777" y="606113"/>
                  <a:pt x="243648" y="618053"/>
                  <a:pt x="249865" y="627378"/>
                </a:cubicBezTo>
                <a:cubicBezTo>
                  <a:pt x="256953" y="638011"/>
                  <a:pt x="267089" y="647153"/>
                  <a:pt x="271130" y="659276"/>
                </a:cubicBezTo>
                <a:cubicBezTo>
                  <a:pt x="278468" y="681286"/>
                  <a:pt x="273339" y="670562"/>
                  <a:pt x="287079" y="691174"/>
                </a:cubicBezTo>
                <a:cubicBezTo>
                  <a:pt x="290736" y="709459"/>
                  <a:pt x="292703" y="721491"/>
                  <a:pt x="297712" y="739020"/>
                </a:cubicBezTo>
                <a:cubicBezTo>
                  <a:pt x="299252" y="744408"/>
                  <a:pt x="300522" y="749957"/>
                  <a:pt x="303028" y="754969"/>
                </a:cubicBezTo>
                <a:cubicBezTo>
                  <a:pt x="305885" y="760684"/>
                  <a:pt x="310116" y="765602"/>
                  <a:pt x="313660" y="770918"/>
                </a:cubicBezTo>
                <a:cubicBezTo>
                  <a:pt x="315362" y="777726"/>
                  <a:pt x="320482" y="800509"/>
                  <a:pt x="324293" y="808132"/>
                </a:cubicBezTo>
                <a:cubicBezTo>
                  <a:pt x="327150" y="813847"/>
                  <a:pt x="331382" y="818765"/>
                  <a:pt x="334926" y="824081"/>
                </a:cubicBezTo>
                <a:cubicBezTo>
                  <a:pt x="348315" y="877641"/>
                  <a:pt x="330251" y="801346"/>
                  <a:pt x="345558" y="893192"/>
                </a:cubicBezTo>
                <a:cubicBezTo>
                  <a:pt x="346479" y="898720"/>
                  <a:pt x="349334" y="903753"/>
                  <a:pt x="350874" y="909141"/>
                </a:cubicBezTo>
                <a:cubicBezTo>
                  <a:pt x="352881" y="916166"/>
                  <a:pt x="355051" y="923189"/>
                  <a:pt x="356191" y="930406"/>
                </a:cubicBezTo>
                <a:cubicBezTo>
                  <a:pt x="360373" y="956895"/>
                  <a:pt x="363966" y="983487"/>
                  <a:pt x="366823" y="1010151"/>
                </a:cubicBezTo>
                <a:cubicBezTo>
                  <a:pt x="369284" y="1033125"/>
                  <a:pt x="368713" y="1056413"/>
                  <a:pt x="372140" y="1079262"/>
                </a:cubicBezTo>
                <a:cubicBezTo>
                  <a:pt x="374054" y="1092020"/>
                  <a:pt x="379643" y="1103960"/>
                  <a:pt x="382772" y="1116476"/>
                </a:cubicBezTo>
                <a:cubicBezTo>
                  <a:pt x="384963" y="1125242"/>
                  <a:pt x="385711" y="1134340"/>
                  <a:pt x="388088" y="1143057"/>
                </a:cubicBezTo>
                <a:cubicBezTo>
                  <a:pt x="391037" y="1153870"/>
                  <a:pt x="398721" y="1174955"/>
                  <a:pt x="398721" y="1174955"/>
                </a:cubicBezTo>
                <a:cubicBezTo>
                  <a:pt x="400493" y="1189132"/>
                  <a:pt x="402744" y="1203257"/>
                  <a:pt x="404037" y="1217485"/>
                </a:cubicBezTo>
                <a:cubicBezTo>
                  <a:pt x="406289" y="1242255"/>
                  <a:pt x="406136" y="1267249"/>
                  <a:pt x="409353" y="1291913"/>
                </a:cubicBezTo>
                <a:cubicBezTo>
                  <a:pt x="411466" y="1308114"/>
                  <a:pt x="416563" y="1323785"/>
                  <a:pt x="419986" y="1339760"/>
                </a:cubicBezTo>
                <a:cubicBezTo>
                  <a:pt x="421879" y="1348595"/>
                  <a:pt x="422129" y="1357881"/>
                  <a:pt x="425302" y="1366341"/>
                </a:cubicBezTo>
                <a:cubicBezTo>
                  <a:pt x="427546" y="1372324"/>
                  <a:pt x="435935" y="1382290"/>
                  <a:pt x="435935" y="1382290"/>
                </a:cubicBezTo>
              </a:path>
            </a:pathLst>
          </a:custGeom>
          <a:noFill/>
          <a:ln w="9525">
            <a:solidFill>
              <a:srgbClr val="FFFF0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42" name="Figura a mano libera 41"/>
          <p:cNvSpPr/>
          <p:nvPr/>
        </p:nvSpPr>
        <p:spPr>
          <a:xfrm>
            <a:off x="1881202" y="3612018"/>
            <a:ext cx="1281223" cy="1379967"/>
          </a:xfrm>
          <a:custGeom>
            <a:avLst/>
            <a:gdLst>
              <a:gd name="connsiteX0" fmla="*/ 1281223 w 1281223"/>
              <a:gd name="connsiteY0" fmla="*/ 712439 h 1382290"/>
              <a:gd name="connsiteX1" fmla="*/ 1217428 w 1281223"/>
              <a:gd name="connsiteY1" fmla="*/ 707123 h 1382290"/>
              <a:gd name="connsiteX2" fmla="*/ 1169581 w 1281223"/>
              <a:gd name="connsiteY2" fmla="*/ 691174 h 1382290"/>
              <a:gd name="connsiteX3" fmla="*/ 1153633 w 1281223"/>
              <a:gd name="connsiteY3" fmla="*/ 685857 h 1382290"/>
              <a:gd name="connsiteX4" fmla="*/ 1111102 w 1281223"/>
              <a:gd name="connsiteY4" fmla="*/ 653960 h 1382290"/>
              <a:gd name="connsiteX5" fmla="*/ 1079205 w 1281223"/>
              <a:gd name="connsiteY5" fmla="*/ 632695 h 1382290"/>
              <a:gd name="connsiteX6" fmla="*/ 1057940 w 1281223"/>
              <a:gd name="connsiteY6" fmla="*/ 622062 h 1382290"/>
              <a:gd name="connsiteX7" fmla="*/ 1026042 w 1281223"/>
              <a:gd name="connsiteY7" fmla="*/ 595481 h 1382290"/>
              <a:gd name="connsiteX8" fmla="*/ 1015409 w 1281223"/>
              <a:gd name="connsiteY8" fmla="*/ 574216 h 1382290"/>
              <a:gd name="connsiteX9" fmla="*/ 994144 w 1281223"/>
              <a:gd name="connsiteY9" fmla="*/ 542318 h 1382290"/>
              <a:gd name="connsiteX10" fmla="*/ 983512 w 1281223"/>
              <a:gd name="connsiteY10" fmla="*/ 526369 h 1382290"/>
              <a:gd name="connsiteX11" fmla="*/ 972879 w 1281223"/>
              <a:gd name="connsiteY11" fmla="*/ 510420 h 1382290"/>
              <a:gd name="connsiteX12" fmla="*/ 962247 w 1281223"/>
              <a:gd name="connsiteY12" fmla="*/ 489155 h 1382290"/>
              <a:gd name="connsiteX13" fmla="*/ 956930 w 1281223"/>
              <a:gd name="connsiteY13" fmla="*/ 473206 h 1382290"/>
              <a:gd name="connsiteX14" fmla="*/ 930349 w 1281223"/>
              <a:gd name="connsiteY14" fmla="*/ 435992 h 1382290"/>
              <a:gd name="connsiteX15" fmla="*/ 893135 w 1281223"/>
              <a:gd name="connsiteY15" fmla="*/ 393462 h 1382290"/>
              <a:gd name="connsiteX16" fmla="*/ 861237 w 1281223"/>
              <a:gd name="connsiteY16" fmla="*/ 345616 h 1382290"/>
              <a:gd name="connsiteX17" fmla="*/ 839972 w 1281223"/>
              <a:gd name="connsiteY17" fmla="*/ 313718 h 1382290"/>
              <a:gd name="connsiteX18" fmla="*/ 824023 w 1281223"/>
              <a:gd name="connsiteY18" fmla="*/ 292453 h 1382290"/>
              <a:gd name="connsiteX19" fmla="*/ 813391 w 1281223"/>
              <a:gd name="connsiteY19" fmla="*/ 260555 h 1382290"/>
              <a:gd name="connsiteX20" fmla="*/ 808074 w 1281223"/>
              <a:gd name="connsiteY20" fmla="*/ 239290 h 1382290"/>
              <a:gd name="connsiteX21" fmla="*/ 797442 w 1281223"/>
              <a:gd name="connsiteY21" fmla="*/ 207392 h 1382290"/>
              <a:gd name="connsiteX22" fmla="*/ 781493 w 1281223"/>
              <a:gd name="connsiteY22" fmla="*/ 170178 h 1382290"/>
              <a:gd name="connsiteX23" fmla="*/ 776177 w 1281223"/>
              <a:gd name="connsiteY23" fmla="*/ 154230 h 1382290"/>
              <a:gd name="connsiteX24" fmla="*/ 770860 w 1281223"/>
              <a:gd name="connsiteY24" fmla="*/ 132964 h 1382290"/>
              <a:gd name="connsiteX25" fmla="*/ 749595 w 1281223"/>
              <a:gd name="connsiteY25" fmla="*/ 90434 h 1382290"/>
              <a:gd name="connsiteX26" fmla="*/ 754912 w 1281223"/>
              <a:gd name="connsiteY26" fmla="*/ 16006 h 1382290"/>
              <a:gd name="connsiteX27" fmla="*/ 760228 w 1281223"/>
              <a:gd name="connsiteY27" fmla="*/ 57 h 1382290"/>
              <a:gd name="connsiteX28" fmla="*/ 324293 w 1281223"/>
              <a:gd name="connsiteY28" fmla="*/ 10690 h 1382290"/>
              <a:gd name="connsiteX29" fmla="*/ 281763 w 1281223"/>
              <a:gd name="connsiteY29" fmla="*/ 21323 h 1382290"/>
              <a:gd name="connsiteX30" fmla="*/ 233916 w 1281223"/>
              <a:gd name="connsiteY30" fmla="*/ 37271 h 1382290"/>
              <a:gd name="connsiteX31" fmla="*/ 217967 w 1281223"/>
              <a:gd name="connsiteY31" fmla="*/ 47904 h 1382290"/>
              <a:gd name="connsiteX32" fmla="*/ 186070 w 1281223"/>
              <a:gd name="connsiteY32" fmla="*/ 58537 h 1382290"/>
              <a:gd name="connsiteX33" fmla="*/ 148856 w 1281223"/>
              <a:gd name="connsiteY33" fmla="*/ 74485 h 1382290"/>
              <a:gd name="connsiteX34" fmla="*/ 132907 w 1281223"/>
              <a:gd name="connsiteY34" fmla="*/ 90434 h 1382290"/>
              <a:gd name="connsiteX35" fmla="*/ 95693 w 1281223"/>
              <a:gd name="connsiteY35" fmla="*/ 106383 h 1382290"/>
              <a:gd name="connsiteX36" fmla="*/ 79744 w 1281223"/>
              <a:gd name="connsiteY36" fmla="*/ 122332 h 1382290"/>
              <a:gd name="connsiteX37" fmla="*/ 63795 w 1281223"/>
              <a:gd name="connsiteY37" fmla="*/ 132964 h 1382290"/>
              <a:gd name="connsiteX38" fmla="*/ 53163 w 1281223"/>
              <a:gd name="connsiteY38" fmla="*/ 148913 h 1382290"/>
              <a:gd name="connsiteX39" fmla="*/ 26581 w 1281223"/>
              <a:gd name="connsiteY39" fmla="*/ 186127 h 1382290"/>
              <a:gd name="connsiteX40" fmla="*/ 15949 w 1281223"/>
              <a:gd name="connsiteY40" fmla="*/ 218025 h 1382290"/>
              <a:gd name="connsiteX41" fmla="*/ 10633 w 1281223"/>
              <a:gd name="connsiteY41" fmla="*/ 233974 h 1382290"/>
              <a:gd name="connsiteX42" fmla="*/ 0 w 1281223"/>
              <a:gd name="connsiteY42" fmla="*/ 281820 h 1382290"/>
              <a:gd name="connsiteX43" fmla="*/ 5316 w 1281223"/>
              <a:gd name="connsiteY43" fmla="*/ 329667 h 1382290"/>
              <a:gd name="connsiteX44" fmla="*/ 10633 w 1281223"/>
              <a:gd name="connsiteY44" fmla="*/ 345616 h 1382290"/>
              <a:gd name="connsiteX45" fmla="*/ 42530 w 1281223"/>
              <a:gd name="connsiteY45" fmla="*/ 366881 h 1382290"/>
              <a:gd name="connsiteX46" fmla="*/ 63795 w 1281223"/>
              <a:gd name="connsiteY46" fmla="*/ 382830 h 1382290"/>
              <a:gd name="connsiteX47" fmla="*/ 95693 w 1281223"/>
              <a:gd name="connsiteY47" fmla="*/ 404095 h 1382290"/>
              <a:gd name="connsiteX48" fmla="*/ 127591 w 1281223"/>
              <a:gd name="connsiteY48" fmla="*/ 414727 h 1382290"/>
              <a:gd name="connsiteX49" fmla="*/ 154172 w 1281223"/>
              <a:gd name="connsiteY49" fmla="*/ 451941 h 1382290"/>
              <a:gd name="connsiteX50" fmla="*/ 164805 w 1281223"/>
              <a:gd name="connsiteY50" fmla="*/ 483839 h 1382290"/>
              <a:gd name="connsiteX51" fmla="*/ 170121 w 1281223"/>
              <a:gd name="connsiteY51" fmla="*/ 499788 h 1382290"/>
              <a:gd name="connsiteX52" fmla="*/ 191386 w 1281223"/>
              <a:gd name="connsiteY52" fmla="*/ 531685 h 1382290"/>
              <a:gd name="connsiteX53" fmla="*/ 207335 w 1281223"/>
              <a:gd name="connsiteY53" fmla="*/ 552951 h 1382290"/>
              <a:gd name="connsiteX54" fmla="*/ 239233 w 1281223"/>
              <a:gd name="connsiteY54" fmla="*/ 595481 h 1382290"/>
              <a:gd name="connsiteX55" fmla="*/ 249865 w 1281223"/>
              <a:gd name="connsiteY55" fmla="*/ 627378 h 1382290"/>
              <a:gd name="connsiteX56" fmla="*/ 271130 w 1281223"/>
              <a:gd name="connsiteY56" fmla="*/ 659276 h 1382290"/>
              <a:gd name="connsiteX57" fmla="*/ 287079 w 1281223"/>
              <a:gd name="connsiteY57" fmla="*/ 691174 h 1382290"/>
              <a:gd name="connsiteX58" fmla="*/ 297712 w 1281223"/>
              <a:gd name="connsiteY58" fmla="*/ 739020 h 1382290"/>
              <a:gd name="connsiteX59" fmla="*/ 303028 w 1281223"/>
              <a:gd name="connsiteY59" fmla="*/ 754969 h 1382290"/>
              <a:gd name="connsiteX60" fmla="*/ 313660 w 1281223"/>
              <a:gd name="connsiteY60" fmla="*/ 770918 h 1382290"/>
              <a:gd name="connsiteX61" fmla="*/ 324293 w 1281223"/>
              <a:gd name="connsiteY61" fmla="*/ 808132 h 1382290"/>
              <a:gd name="connsiteX62" fmla="*/ 334926 w 1281223"/>
              <a:gd name="connsiteY62" fmla="*/ 824081 h 1382290"/>
              <a:gd name="connsiteX63" fmla="*/ 345558 w 1281223"/>
              <a:gd name="connsiteY63" fmla="*/ 893192 h 1382290"/>
              <a:gd name="connsiteX64" fmla="*/ 350874 w 1281223"/>
              <a:gd name="connsiteY64" fmla="*/ 909141 h 1382290"/>
              <a:gd name="connsiteX65" fmla="*/ 356191 w 1281223"/>
              <a:gd name="connsiteY65" fmla="*/ 930406 h 1382290"/>
              <a:gd name="connsiteX66" fmla="*/ 366823 w 1281223"/>
              <a:gd name="connsiteY66" fmla="*/ 1010151 h 1382290"/>
              <a:gd name="connsiteX67" fmla="*/ 372140 w 1281223"/>
              <a:gd name="connsiteY67" fmla="*/ 1079262 h 1382290"/>
              <a:gd name="connsiteX68" fmla="*/ 382772 w 1281223"/>
              <a:gd name="connsiteY68" fmla="*/ 1116476 h 1382290"/>
              <a:gd name="connsiteX69" fmla="*/ 388088 w 1281223"/>
              <a:gd name="connsiteY69" fmla="*/ 1143057 h 1382290"/>
              <a:gd name="connsiteX70" fmla="*/ 398721 w 1281223"/>
              <a:gd name="connsiteY70" fmla="*/ 1174955 h 1382290"/>
              <a:gd name="connsiteX71" fmla="*/ 404037 w 1281223"/>
              <a:gd name="connsiteY71" fmla="*/ 1217485 h 1382290"/>
              <a:gd name="connsiteX72" fmla="*/ 409353 w 1281223"/>
              <a:gd name="connsiteY72" fmla="*/ 1291913 h 1382290"/>
              <a:gd name="connsiteX73" fmla="*/ 419986 w 1281223"/>
              <a:gd name="connsiteY73" fmla="*/ 1339760 h 1382290"/>
              <a:gd name="connsiteX74" fmla="*/ 425302 w 1281223"/>
              <a:gd name="connsiteY74" fmla="*/ 1366341 h 1382290"/>
              <a:gd name="connsiteX75" fmla="*/ 435935 w 1281223"/>
              <a:gd name="connsiteY75" fmla="*/ 1382290 h 138229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Lst>
            <a:rect l="l" t="t" r="r" b="b"/>
            <a:pathLst>
              <a:path w="1281223" h="1382290">
                <a:moveTo>
                  <a:pt x="1281223" y="712439"/>
                </a:moveTo>
                <a:cubicBezTo>
                  <a:pt x="1259958" y="710667"/>
                  <a:pt x="1238390" y="711116"/>
                  <a:pt x="1217428" y="707123"/>
                </a:cubicBezTo>
                <a:cubicBezTo>
                  <a:pt x="1200913" y="703977"/>
                  <a:pt x="1185530" y="696491"/>
                  <a:pt x="1169581" y="691174"/>
                </a:cubicBezTo>
                <a:lnTo>
                  <a:pt x="1153633" y="685857"/>
                </a:lnTo>
                <a:cubicBezTo>
                  <a:pt x="1127973" y="660199"/>
                  <a:pt x="1147435" y="677081"/>
                  <a:pt x="1111102" y="653960"/>
                </a:cubicBezTo>
                <a:cubicBezTo>
                  <a:pt x="1100321" y="647100"/>
                  <a:pt x="1090634" y="638410"/>
                  <a:pt x="1079205" y="632695"/>
                </a:cubicBezTo>
                <a:cubicBezTo>
                  <a:pt x="1072117" y="629151"/>
                  <a:pt x="1064821" y="625994"/>
                  <a:pt x="1057940" y="622062"/>
                </a:cubicBezTo>
                <a:cubicBezTo>
                  <a:pt x="1046683" y="615629"/>
                  <a:pt x="1033627" y="606099"/>
                  <a:pt x="1026042" y="595481"/>
                </a:cubicBezTo>
                <a:cubicBezTo>
                  <a:pt x="1021436" y="589032"/>
                  <a:pt x="1019486" y="581012"/>
                  <a:pt x="1015409" y="574216"/>
                </a:cubicBezTo>
                <a:cubicBezTo>
                  <a:pt x="1008834" y="563258"/>
                  <a:pt x="1001232" y="552951"/>
                  <a:pt x="994144" y="542318"/>
                </a:cubicBezTo>
                <a:lnTo>
                  <a:pt x="983512" y="526369"/>
                </a:lnTo>
                <a:cubicBezTo>
                  <a:pt x="979968" y="521053"/>
                  <a:pt x="975736" y="516135"/>
                  <a:pt x="972879" y="510420"/>
                </a:cubicBezTo>
                <a:cubicBezTo>
                  <a:pt x="969335" y="503332"/>
                  <a:pt x="965369" y="496439"/>
                  <a:pt x="962247" y="489155"/>
                </a:cubicBezTo>
                <a:cubicBezTo>
                  <a:pt x="960039" y="484004"/>
                  <a:pt x="959436" y="478218"/>
                  <a:pt x="956930" y="473206"/>
                </a:cubicBezTo>
                <a:cubicBezTo>
                  <a:pt x="952606" y="464558"/>
                  <a:pt x="934568" y="442019"/>
                  <a:pt x="930349" y="435992"/>
                </a:cubicBezTo>
                <a:cubicBezTo>
                  <a:pt x="903214" y="397228"/>
                  <a:pt x="920879" y="411959"/>
                  <a:pt x="893135" y="393462"/>
                </a:cubicBezTo>
                <a:lnTo>
                  <a:pt x="861237" y="345616"/>
                </a:lnTo>
                <a:cubicBezTo>
                  <a:pt x="861226" y="345599"/>
                  <a:pt x="839984" y="313734"/>
                  <a:pt x="839972" y="313718"/>
                </a:cubicBezTo>
                <a:lnTo>
                  <a:pt x="824023" y="292453"/>
                </a:lnTo>
                <a:cubicBezTo>
                  <a:pt x="820479" y="281820"/>
                  <a:pt x="816110" y="271428"/>
                  <a:pt x="813391" y="260555"/>
                </a:cubicBezTo>
                <a:cubicBezTo>
                  <a:pt x="811619" y="253467"/>
                  <a:pt x="810174" y="246288"/>
                  <a:pt x="808074" y="239290"/>
                </a:cubicBezTo>
                <a:cubicBezTo>
                  <a:pt x="804853" y="228555"/>
                  <a:pt x="800160" y="218265"/>
                  <a:pt x="797442" y="207392"/>
                </a:cubicBezTo>
                <a:cubicBezTo>
                  <a:pt x="790576" y="179928"/>
                  <a:pt x="796179" y="192206"/>
                  <a:pt x="781493" y="170178"/>
                </a:cubicBezTo>
                <a:cubicBezTo>
                  <a:pt x="779721" y="164862"/>
                  <a:pt x="777716" y="159618"/>
                  <a:pt x="776177" y="154230"/>
                </a:cubicBezTo>
                <a:cubicBezTo>
                  <a:pt x="774170" y="147204"/>
                  <a:pt x="773670" y="139709"/>
                  <a:pt x="770860" y="132964"/>
                </a:cubicBezTo>
                <a:cubicBezTo>
                  <a:pt x="764764" y="118333"/>
                  <a:pt x="749595" y="90434"/>
                  <a:pt x="749595" y="90434"/>
                </a:cubicBezTo>
                <a:cubicBezTo>
                  <a:pt x="751367" y="65625"/>
                  <a:pt x="752006" y="40708"/>
                  <a:pt x="754912" y="16006"/>
                </a:cubicBezTo>
                <a:cubicBezTo>
                  <a:pt x="755567" y="10441"/>
                  <a:pt x="765826" y="311"/>
                  <a:pt x="760228" y="57"/>
                </a:cubicBezTo>
                <a:cubicBezTo>
                  <a:pt x="740039" y="-861"/>
                  <a:pt x="366683" y="9544"/>
                  <a:pt x="324293" y="10690"/>
                </a:cubicBezTo>
                <a:cubicBezTo>
                  <a:pt x="270243" y="21500"/>
                  <a:pt x="319912" y="10423"/>
                  <a:pt x="281763" y="21323"/>
                </a:cubicBezTo>
                <a:cubicBezTo>
                  <a:pt x="258074" y="28092"/>
                  <a:pt x="258356" y="25051"/>
                  <a:pt x="233916" y="37271"/>
                </a:cubicBezTo>
                <a:cubicBezTo>
                  <a:pt x="228201" y="40128"/>
                  <a:pt x="223806" y="45309"/>
                  <a:pt x="217967" y="47904"/>
                </a:cubicBezTo>
                <a:cubicBezTo>
                  <a:pt x="207726" y="52456"/>
                  <a:pt x="195395" y="52320"/>
                  <a:pt x="186070" y="58537"/>
                </a:cubicBezTo>
                <a:cubicBezTo>
                  <a:pt x="164042" y="73222"/>
                  <a:pt x="176320" y="67619"/>
                  <a:pt x="148856" y="74485"/>
                </a:cubicBezTo>
                <a:cubicBezTo>
                  <a:pt x="143540" y="79801"/>
                  <a:pt x="139025" y="86064"/>
                  <a:pt x="132907" y="90434"/>
                </a:cubicBezTo>
                <a:cubicBezTo>
                  <a:pt x="121409" y="98647"/>
                  <a:pt x="108710" y="102044"/>
                  <a:pt x="95693" y="106383"/>
                </a:cubicBezTo>
                <a:cubicBezTo>
                  <a:pt x="90377" y="111699"/>
                  <a:pt x="85520" y="117519"/>
                  <a:pt x="79744" y="122332"/>
                </a:cubicBezTo>
                <a:cubicBezTo>
                  <a:pt x="74836" y="126422"/>
                  <a:pt x="68313" y="128446"/>
                  <a:pt x="63795" y="132964"/>
                </a:cubicBezTo>
                <a:cubicBezTo>
                  <a:pt x="59277" y="137482"/>
                  <a:pt x="56877" y="143714"/>
                  <a:pt x="53163" y="148913"/>
                </a:cubicBezTo>
                <a:cubicBezTo>
                  <a:pt x="20174" y="195098"/>
                  <a:pt x="51652" y="148521"/>
                  <a:pt x="26581" y="186127"/>
                </a:cubicBezTo>
                <a:lnTo>
                  <a:pt x="15949" y="218025"/>
                </a:lnTo>
                <a:cubicBezTo>
                  <a:pt x="14177" y="223341"/>
                  <a:pt x="11732" y="228479"/>
                  <a:pt x="10633" y="233974"/>
                </a:cubicBezTo>
                <a:cubicBezTo>
                  <a:pt x="3883" y="267720"/>
                  <a:pt x="7507" y="251789"/>
                  <a:pt x="0" y="281820"/>
                </a:cubicBezTo>
                <a:cubicBezTo>
                  <a:pt x="1772" y="297769"/>
                  <a:pt x="2678" y="313838"/>
                  <a:pt x="5316" y="329667"/>
                </a:cubicBezTo>
                <a:cubicBezTo>
                  <a:pt x="6237" y="335195"/>
                  <a:pt x="6670" y="341653"/>
                  <a:pt x="10633" y="345616"/>
                </a:cubicBezTo>
                <a:cubicBezTo>
                  <a:pt x="19669" y="354652"/>
                  <a:pt x="32307" y="359214"/>
                  <a:pt x="42530" y="366881"/>
                </a:cubicBezTo>
                <a:cubicBezTo>
                  <a:pt x="49618" y="372197"/>
                  <a:pt x="56536" y="377749"/>
                  <a:pt x="63795" y="382830"/>
                </a:cubicBezTo>
                <a:cubicBezTo>
                  <a:pt x="74264" y="390158"/>
                  <a:pt x="83570" y="400054"/>
                  <a:pt x="95693" y="404095"/>
                </a:cubicBezTo>
                <a:lnTo>
                  <a:pt x="127591" y="414727"/>
                </a:lnTo>
                <a:cubicBezTo>
                  <a:pt x="129736" y="417588"/>
                  <a:pt x="151344" y="445577"/>
                  <a:pt x="154172" y="451941"/>
                </a:cubicBezTo>
                <a:cubicBezTo>
                  <a:pt x="158724" y="462183"/>
                  <a:pt x="161261" y="473206"/>
                  <a:pt x="164805" y="483839"/>
                </a:cubicBezTo>
                <a:cubicBezTo>
                  <a:pt x="166577" y="489155"/>
                  <a:pt x="167012" y="495125"/>
                  <a:pt x="170121" y="499788"/>
                </a:cubicBezTo>
                <a:cubicBezTo>
                  <a:pt x="177209" y="510420"/>
                  <a:pt x="183719" y="521462"/>
                  <a:pt x="191386" y="531685"/>
                </a:cubicBezTo>
                <a:cubicBezTo>
                  <a:pt x="196702" y="538774"/>
                  <a:pt x="202639" y="545437"/>
                  <a:pt x="207335" y="552951"/>
                </a:cubicBezTo>
                <a:cubicBezTo>
                  <a:pt x="232526" y="593258"/>
                  <a:pt x="199617" y="555867"/>
                  <a:pt x="239233" y="595481"/>
                </a:cubicBezTo>
                <a:cubicBezTo>
                  <a:pt x="242777" y="606113"/>
                  <a:pt x="243648" y="618053"/>
                  <a:pt x="249865" y="627378"/>
                </a:cubicBezTo>
                <a:cubicBezTo>
                  <a:pt x="256953" y="638011"/>
                  <a:pt x="267089" y="647153"/>
                  <a:pt x="271130" y="659276"/>
                </a:cubicBezTo>
                <a:cubicBezTo>
                  <a:pt x="278468" y="681286"/>
                  <a:pt x="273339" y="670562"/>
                  <a:pt x="287079" y="691174"/>
                </a:cubicBezTo>
                <a:cubicBezTo>
                  <a:pt x="290736" y="709459"/>
                  <a:pt x="292703" y="721491"/>
                  <a:pt x="297712" y="739020"/>
                </a:cubicBezTo>
                <a:cubicBezTo>
                  <a:pt x="299252" y="744408"/>
                  <a:pt x="300522" y="749957"/>
                  <a:pt x="303028" y="754969"/>
                </a:cubicBezTo>
                <a:cubicBezTo>
                  <a:pt x="305885" y="760684"/>
                  <a:pt x="310116" y="765602"/>
                  <a:pt x="313660" y="770918"/>
                </a:cubicBezTo>
                <a:cubicBezTo>
                  <a:pt x="315362" y="777726"/>
                  <a:pt x="320482" y="800509"/>
                  <a:pt x="324293" y="808132"/>
                </a:cubicBezTo>
                <a:cubicBezTo>
                  <a:pt x="327150" y="813847"/>
                  <a:pt x="331382" y="818765"/>
                  <a:pt x="334926" y="824081"/>
                </a:cubicBezTo>
                <a:cubicBezTo>
                  <a:pt x="348315" y="877641"/>
                  <a:pt x="330251" y="801346"/>
                  <a:pt x="345558" y="893192"/>
                </a:cubicBezTo>
                <a:cubicBezTo>
                  <a:pt x="346479" y="898720"/>
                  <a:pt x="349334" y="903753"/>
                  <a:pt x="350874" y="909141"/>
                </a:cubicBezTo>
                <a:cubicBezTo>
                  <a:pt x="352881" y="916166"/>
                  <a:pt x="355051" y="923189"/>
                  <a:pt x="356191" y="930406"/>
                </a:cubicBezTo>
                <a:cubicBezTo>
                  <a:pt x="360373" y="956895"/>
                  <a:pt x="363966" y="983487"/>
                  <a:pt x="366823" y="1010151"/>
                </a:cubicBezTo>
                <a:cubicBezTo>
                  <a:pt x="369284" y="1033125"/>
                  <a:pt x="368713" y="1056413"/>
                  <a:pt x="372140" y="1079262"/>
                </a:cubicBezTo>
                <a:cubicBezTo>
                  <a:pt x="374054" y="1092020"/>
                  <a:pt x="379643" y="1103960"/>
                  <a:pt x="382772" y="1116476"/>
                </a:cubicBezTo>
                <a:cubicBezTo>
                  <a:pt x="384963" y="1125242"/>
                  <a:pt x="385711" y="1134340"/>
                  <a:pt x="388088" y="1143057"/>
                </a:cubicBezTo>
                <a:cubicBezTo>
                  <a:pt x="391037" y="1153870"/>
                  <a:pt x="398721" y="1174955"/>
                  <a:pt x="398721" y="1174955"/>
                </a:cubicBezTo>
                <a:cubicBezTo>
                  <a:pt x="400493" y="1189132"/>
                  <a:pt x="402744" y="1203257"/>
                  <a:pt x="404037" y="1217485"/>
                </a:cubicBezTo>
                <a:cubicBezTo>
                  <a:pt x="406289" y="1242255"/>
                  <a:pt x="406136" y="1267249"/>
                  <a:pt x="409353" y="1291913"/>
                </a:cubicBezTo>
                <a:cubicBezTo>
                  <a:pt x="411466" y="1308114"/>
                  <a:pt x="416563" y="1323785"/>
                  <a:pt x="419986" y="1339760"/>
                </a:cubicBezTo>
                <a:cubicBezTo>
                  <a:pt x="421879" y="1348595"/>
                  <a:pt x="422129" y="1357881"/>
                  <a:pt x="425302" y="1366341"/>
                </a:cubicBezTo>
                <a:cubicBezTo>
                  <a:pt x="427546" y="1372324"/>
                  <a:pt x="435935" y="1382290"/>
                  <a:pt x="435935" y="1382290"/>
                </a:cubicBezTo>
              </a:path>
            </a:pathLst>
          </a:custGeom>
          <a:noFill/>
          <a:ln w="9525">
            <a:solidFill>
              <a:srgbClr val="FFFF0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43" name="Figura a mano libera 42"/>
          <p:cNvSpPr/>
          <p:nvPr/>
        </p:nvSpPr>
        <p:spPr>
          <a:xfrm>
            <a:off x="3296673" y="3612018"/>
            <a:ext cx="1281223" cy="1379967"/>
          </a:xfrm>
          <a:custGeom>
            <a:avLst/>
            <a:gdLst>
              <a:gd name="connsiteX0" fmla="*/ 1281223 w 1281223"/>
              <a:gd name="connsiteY0" fmla="*/ 712439 h 1382290"/>
              <a:gd name="connsiteX1" fmla="*/ 1217428 w 1281223"/>
              <a:gd name="connsiteY1" fmla="*/ 707123 h 1382290"/>
              <a:gd name="connsiteX2" fmla="*/ 1169581 w 1281223"/>
              <a:gd name="connsiteY2" fmla="*/ 691174 h 1382290"/>
              <a:gd name="connsiteX3" fmla="*/ 1153633 w 1281223"/>
              <a:gd name="connsiteY3" fmla="*/ 685857 h 1382290"/>
              <a:gd name="connsiteX4" fmla="*/ 1111102 w 1281223"/>
              <a:gd name="connsiteY4" fmla="*/ 653960 h 1382290"/>
              <a:gd name="connsiteX5" fmla="*/ 1079205 w 1281223"/>
              <a:gd name="connsiteY5" fmla="*/ 632695 h 1382290"/>
              <a:gd name="connsiteX6" fmla="*/ 1057940 w 1281223"/>
              <a:gd name="connsiteY6" fmla="*/ 622062 h 1382290"/>
              <a:gd name="connsiteX7" fmla="*/ 1026042 w 1281223"/>
              <a:gd name="connsiteY7" fmla="*/ 595481 h 1382290"/>
              <a:gd name="connsiteX8" fmla="*/ 1015409 w 1281223"/>
              <a:gd name="connsiteY8" fmla="*/ 574216 h 1382290"/>
              <a:gd name="connsiteX9" fmla="*/ 994144 w 1281223"/>
              <a:gd name="connsiteY9" fmla="*/ 542318 h 1382290"/>
              <a:gd name="connsiteX10" fmla="*/ 983512 w 1281223"/>
              <a:gd name="connsiteY10" fmla="*/ 526369 h 1382290"/>
              <a:gd name="connsiteX11" fmla="*/ 972879 w 1281223"/>
              <a:gd name="connsiteY11" fmla="*/ 510420 h 1382290"/>
              <a:gd name="connsiteX12" fmla="*/ 962247 w 1281223"/>
              <a:gd name="connsiteY12" fmla="*/ 489155 h 1382290"/>
              <a:gd name="connsiteX13" fmla="*/ 956930 w 1281223"/>
              <a:gd name="connsiteY13" fmla="*/ 473206 h 1382290"/>
              <a:gd name="connsiteX14" fmla="*/ 930349 w 1281223"/>
              <a:gd name="connsiteY14" fmla="*/ 435992 h 1382290"/>
              <a:gd name="connsiteX15" fmla="*/ 893135 w 1281223"/>
              <a:gd name="connsiteY15" fmla="*/ 393462 h 1382290"/>
              <a:gd name="connsiteX16" fmla="*/ 861237 w 1281223"/>
              <a:gd name="connsiteY16" fmla="*/ 345616 h 1382290"/>
              <a:gd name="connsiteX17" fmla="*/ 839972 w 1281223"/>
              <a:gd name="connsiteY17" fmla="*/ 313718 h 1382290"/>
              <a:gd name="connsiteX18" fmla="*/ 824023 w 1281223"/>
              <a:gd name="connsiteY18" fmla="*/ 292453 h 1382290"/>
              <a:gd name="connsiteX19" fmla="*/ 813391 w 1281223"/>
              <a:gd name="connsiteY19" fmla="*/ 260555 h 1382290"/>
              <a:gd name="connsiteX20" fmla="*/ 808074 w 1281223"/>
              <a:gd name="connsiteY20" fmla="*/ 239290 h 1382290"/>
              <a:gd name="connsiteX21" fmla="*/ 797442 w 1281223"/>
              <a:gd name="connsiteY21" fmla="*/ 207392 h 1382290"/>
              <a:gd name="connsiteX22" fmla="*/ 781493 w 1281223"/>
              <a:gd name="connsiteY22" fmla="*/ 170178 h 1382290"/>
              <a:gd name="connsiteX23" fmla="*/ 776177 w 1281223"/>
              <a:gd name="connsiteY23" fmla="*/ 154230 h 1382290"/>
              <a:gd name="connsiteX24" fmla="*/ 770860 w 1281223"/>
              <a:gd name="connsiteY24" fmla="*/ 132964 h 1382290"/>
              <a:gd name="connsiteX25" fmla="*/ 749595 w 1281223"/>
              <a:gd name="connsiteY25" fmla="*/ 90434 h 1382290"/>
              <a:gd name="connsiteX26" fmla="*/ 754912 w 1281223"/>
              <a:gd name="connsiteY26" fmla="*/ 16006 h 1382290"/>
              <a:gd name="connsiteX27" fmla="*/ 760228 w 1281223"/>
              <a:gd name="connsiteY27" fmla="*/ 57 h 1382290"/>
              <a:gd name="connsiteX28" fmla="*/ 324293 w 1281223"/>
              <a:gd name="connsiteY28" fmla="*/ 10690 h 1382290"/>
              <a:gd name="connsiteX29" fmla="*/ 281763 w 1281223"/>
              <a:gd name="connsiteY29" fmla="*/ 21323 h 1382290"/>
              <a:gd name="connsiteX30" fmla="*/ 233916 w 1281223"/>
              <a:gd name="connsiteY30" fmla="*/ 37271 h 1382290"/>
              <a:gd name="connsiteX31" fmla="*/ 217967 w 1281223"/>
              <a:gd name="connsiteY31" fmla="*/ 47904 h 1382290"/>
              <a:gd name="connsiteX32" fmla="*/ 186070 w 1281223"/>
              <a:gd name="connsiteY32" fmla="*/ 58537 h 1382290"/>
              <a:gd name="connsiteX33" fmla="*/ 148856 w 1281223"/>
              <a:gd name="connsiteY33" fmla="*/ 74485 h 1382290"/>
              <a:gd name="connsiteX34" fmla="*/ 132907 w 1281223"/>
              <a:gd name="connsiteY34" fmla="*/ 90434 h 1382290"/>
              <a:gd name="connsiteX35" fmla="*/ 95693 w 1281223"/>
              <a:gd name="connsiteY35" fmla="*/ 106383 h 1382290"/>
              <a:gd name="connsiteX36" fmla="*/ 79744 w 1281223"/>
              <a:gd name="connsiteY36" fmla="*/ 122332 h 1382290"/>
              <a:gd name="connsiteX37" fmla="*/ 63795 w 1281223"/>
              <a:gd name="connsiteY37" fmla="*/ 132964 h 1382290"/>
              <a:gd name="connsiteX38" fmla="*/ 53163 w 1281223"/>
              <a:gd name="connsiteY38" fmla="*/ 148913 h 1382290"/>
              <a:gd name="connsiteX39" fmla="*/ 26581 w 1281223"/>
              <a:gd name="connsiteY39" fmla="*/ 186127 h 1382290"/>
              <a:gd name="connsiteX40" fmla="*/ 15949 w 1281223"/>
              <a:gd name="connsiteY40" fmla="*/ 218025 h 1382290"/>
              <a:gd name="connsiteX41" fmla="*/ 10633 w 1281223"/>
              <a:gd name="connsiteY41" fmla="*/ 233974 h 1382290"/>
              <a:gd name="connsiteX42" fmla="*/ 0 w 1281223"/>
              <a:gd name="connsiteY42" fmla="*/ 281820 h 1382290"/>
              <a:gd name="connsiteX43" fmla="*/ 5316 w 1281223"/>
              <a:gd name="connsiteY43" fmla="*/ 329667 h 1382290"/>
              <a:gd name="connsiteX44" fmla="*/ 10633 w 1281223"/>
              <a:gd name="connsiteY44" fmla="*/ 345616 h 1382290"/>
              <a:gd name="connsiteX45" fmla="*/ 42530 w 1281223"/>
              <a:gd name="connsiteY45" fmla="*/ 366881 h 1382290"/>
              <a:gd name="connsiteX46" fmla="*/ 63795 w 1281223"/>
              <a:gd name="connsiteY46" fmla="*/ 382830 h 1382290"/>
              <a:gd name="connsiteX47" fmla="*/ 95693 w 1281223"/>
              <a:gd name="connsiteY47" fmla="*/ 404095 h 1382290"/>
              <a:gd name="connsiteX48" fmla="*/ 127591 w 1281223"/>
              <a:gd name="connsiteY48" fmla="*/ 414727 h 1382290"/>
              <a:gd name="connsiteX49" fmla="*/ 154172 w 1281223"/>
              <a:gd name="connsiteY49" fmla="*/ 451941 h 1382290"/>
              <a:gd name="connsiteX50" fmla="*/ 164805 w 1281223"/>
              <a:gd name="connsiteY50" fmla="*/ 483839 h 1382290"/>
              <a:gd name="connsiteX51" fmla="*/ 170121 w 1281223"/>
              <a:gd name="connsiteY51" fmla="*/ 499788 h 1382290"/>
              <a:gd name="connsiteX52" fmla="*/ 191386 w 1281223"/>
              <a:gd name="connsiteY52" fmla="*/ 531685 h 1382290"/>
              <a:gd name="connsiteX53" fmla="*/ 207335 w 1281223"/>
              <a:gd name="connsiteY53" fmla="*/ 552951 h 1382290"/>
              <a:gd name="connsiteX54" fmla="*/ 239233 w 1281223"/>
              <a:gd name="connsiteY54" fmla="*/ 595481 h 1382290"/>
              <a:gd name="connsiteX55" fmla="*/ 249865 w 1281223"/>
              <a:gd name="connsiteY55" fmla="*/ 627378 h 1382290"/>
              <a:gd name="connsiteX56" fmla="*/ 271130 w 1281223"/>
              <a:gd name="connsiteY56" fmla="*/ 659276 h 1382290"/>
              <a:gd name="connsiteX57" fmla="*/ 287079 w 1281223"/>
              <a:gd name="connsiteY57" fmla="*/ 691174 h 1382290"/>
              <a:gd name="connsiteX58" fmla="*/ 297712 w 1281223"/>
              <a:gd name="connsiteY58" fmla="*/ 739020 h 1382290"/>
              <a:gd name="connsiteX59" fmla="*/ 303028 w 1281223"/>
              <a:gd name="connsiteY59" fmla="*/ 754969 h 1382290"/>
              <a:gd name="connsiteX60" fmla="*/ 313660 w 1281223"/>
              <a:gd name="connsiteY60" fmla="*/ 770918 h 1382290"/>
              <a:gd name="connsiteX61" fmla="*/ 324293 w 1281223"/>
              <a:gd name="connsiteY61" fmla="*/ 808132 h 1382290"/>
              <a:gd name="connsiteX62" fmla="*/ 334926 w 1281223"/>
              <a:gd name="connsiteY62" fmla="*/ 824081 h 1382290"/>
              <a:gd name="connsiteX63" fmla="*/ 345558 w 1281223"/>
              <a:gd name="connsiteY63" fmla="*/ 893192 h 1382290"/>
              <a:gd name="connsiteX64" fmla="*/ 350874 w 1281223"/>
              <a:gd name="connsiteY64" fmla="*/ 909141 h 1382290"/>
              <a:gd name="connsiteX65" fmla="*/ 356191 w 1281223"/>
              <a:gd name="connsiteY65" fmla="*/ 930406 h 1382290"/>
              <a:gd name="connsiteX66" fmla="*/ 366823 w 1281223"/>
              <a:gd name="connsiteY66" fmla="*/ 1010151 h 1382290"/>
              <a:gd name="connsiteX67" fmla="*/ 372140 w 1281223"/>
              <a:gd name="connsiteY67" fmla="*/ 1079262 h 1382290"/>
              <a:gd name="connsiteX68" fmla="*/ 382772 w 1281223"/>
              <a:gd name="connsiteY68" fmla="*/ 1116476 h 1382290"/>
              <a:gd name="connsiteX69" fmla="*/ 388088 w 1281223"/>
              <a:gd name="connsiteY69" fmla="*/ 1143057 h 1382290"/>
              <a:gd name="connsiteX70" fmla="*/ 398721 w 1281223"/>
              <a:gd name="connsiteY70" fmla="*/ 1174955 h 1382290"/>
              <a:gd name="connsiteX71" fmla="*/ 404037 w 1281223"/>
              <a:gd name="connsiteY71" fmla="*/ 1217485 h 1382290"/>
              <a:gd name="connsiteX72" fmla="*/ 409353 w 1281223"/>
              <a:gd name="connsiteY72" fmla="*/ 1291913 h 1382290"/>
              <a:gd name="connsiteX73" fmla="*/ 419986 w 1281223"/>
              <a:gd name="connsiteY73" fmla="*/ 1339760 h 1382290"/>
              <a:gd name="connsiteX74" fmla="*/ 425302 w 1281223"/>
              <a:gd name="connsiteY74" fmla="*/ 1366341 h 1382290"/>
              <a:gd name="connsiteX75" fmla="*/ 435935 w 1281223"/>
              <a:gd name="connsiteY75" fmla="*/ 1382290 h 138229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Lst>
            <a:rect l="l" t="t" r="r" b="b"/>
            <a:pathLst>
              <a:path w="1281223" h="1382290">
                <a:moveTo>
                  <a:pt x="1281223" y="712439"/>
                </a:moveTo>
                <a:cubicBezTo>
                  <a:pt x="1259958" y="710667"/>
                  <a:pt x="1238390" y="711116"/>
                  <a:pt x="1217428" y="707123"/>
                </a:cubicBezTo>
                <a:cubicBezTo>
                  <a:pt x="1200913" y="703977"/>
                  <a:pt x="1185530" y="696491"/>
                  <a:pt x="1169581" y="691174"/>
                </a:cubicBezTo>
                <a:lnTo>
                  <a:pt x="1153633" y="685857"/>
                </a:lnTo>
                <a:cubicBezTo>
                  <a:pt x="1127973" y="660199"/>
                  <a:pt x="1147435" y="677081"/>
                  <a:pt x="1111102" y="653960"/>
                </a:cubicBezTo>
                <a:cubicBezTo>
                  <a:pt x="1100321" y="647100"/>
                  <a:pt x="1090634" y="638410"/>
                  <a:pt x="1079205" y="632695"/>
                </a:cubicBezTo>
                <a:cubicBezTo>
                  <a:pt x="1072117" y="629151"/>
                  <a:pt x="1064821" y="625994"/>
                  <a:pt x="1057940" y="622062"/>
                </a:cubicBezTo>
                <a:cubicBezTo>
                  <a:pt x="1046683" y="615629"/>
                  <a:pt x="1033627" y="606099"/>
                  <a:pt x="1026042" y="595481"/>
                </a:cubicBezTo>
                <a:cubicBezTo>
                  <a:pt x="1021436" y="589032"/>
                  <a:pt x="1019486" y="581012"/>
                  <a:pt x="1015409" y="574216"/>
                </a:cubicBezTo>
                <a:cubicBezTo>
                  <a:pt x="1008834" y="563258"/>
                  <a:pt x="1001232" y="552951"/>
                  <a:pt x="994144" y="542318"/>
                </a:cubicBezTo>
                <a:lnTo>
                  <a:pt x="983512" y="526369"/>
                </a:lnTo>
                <a:cubicBezTo>
                  <a:pt x="979968" y="521053"/>
                  <a:pt x="975736" y="516135"/>
                  <a:pt x="972879" y="510420"/>
                </a:cubicBezTo>
                <a:cubicBezTo>
                  <a:pt x="969335" y="503332"/>
                  <a:pt x="965369" y="496439"/>
                  <a:pt x="962247" y="489155"/>
                </a:cubicBezTo>
                <a:cubicBezTo>
                  <a:pt x="960039" y="484004"/>
                  <a:pt x="959436" y="478218"/>
                  <a:pt x="956930" y="473206"/>
                </a:cubicBezTo>
                <a:cubicBezTo>
                  <a:pt x="952606" y="464558"/>
                  <a:pt x="934568" y="442019"/>
                  <a:pt x="930349" y="435992"/>
                </a:cubicBezTo>
                <a:cubicBezTo>
                  <a:pt x="903214" y="397228"/>
                  <a:pt x="920879" y="411959"/>
                  <a:pt x="893135" y="393462"/>
                </a:cubicBezTo>
                <a:lnTo>
                  <a:pt x="861237" y="345616"/>
                </a:lnTo>
                <a:cubicBezTo>
                  <a:pt x="861226" y="345599"/>
                  <a:pt x="839984" y="313734"/>
                  <a:pt x="839972" y="313718"/>
                </a:cubicBezTo>
                <a:lnTo>
                  <a:pt x="824023" y="292453"/>
                </a:lnTo>
                <a:cubicBezTo>
                  <a:pt x="820479" y="281820"/>
                  <a:pt x="816110" y="271428"/>
                  <a:pt x="813391" y="260555"/>
                </a:cubicBezTo>
                <a:cubicBezTo>
                  <a:pt x="811619" y="253467"/>
                  <a:pt x="810174" y="246288"/>
                  <a:pt x="808074" y="239290"/>
                </a:cubicBezTo>
                <a:cubicBezTo>
                  <a:pt x="804853" y="228555"/>
                  <a:pt x="800160" y="218265"/>
                  <a:pt x="797442" y="207392"/>
                </a:cubicBezTo>
                <a:cubicBezTo>
                  <a:pt x="790576" y="179928"/>
                  <a:pt x="796179" y="192206"/>
                  <a:pt x="781493" y="170178"/>
                </a:cubicBezTo>
                <a:cubicBezTo>
                  <a:pt x="779721" y="164862"/>
                  <a:pt x="777716" y="159618"/>
                  <a:pt x="776177" y="154230"/>
                </a:cubicBezTo>
                <a:cubicBezTo>
                  <a:pt x="774170" y="147204"/>
                  <a:pt x="773670" y="139709"/>
                  <a:pt x="770860" y="132964"/>
                </a:cubicBezTo>
                <a:cubicBezTo>
                  <a:pt x="764764" y="118333"/>
                  <a:pt x="749595" y="90434"/>
                  <a:pt x="749595" y="90434"/>
                </a:cubicBezTo>
                <a:cubicBezTo>
                  <a:pt x="751367" y="65625"/>
                  <a:pt x="752006" y="40708"/>
                  <a:pt x="754912" y="16006"/>
                </a:cubicBezTo>
                <a:cubicBezTo>
                  <a:pt x="755567" y="10441"/>
                  <a:pt x="765826" y="311"/>
                  <a:pt x="760228" y="57"/>
                </a:cubicBezTo>
                <a:cubicBezTo>
                  <a:pt x="740039" y="-861"/>
                  <a:pt x="366683" y="9544"/>
                  <a:pt x="324293" y="10690"/>
                </a:cubicBezTo>
                <a:cubicBezTo>
                  <a:pt x="270243" y="21500"/>
                  <a:pt x="319912" y="10423"/>
                  <a:pt x="281763" y="21323"/>
                </a:cubicBezTo>
                <a:cubicBezTo>
                  <a:pt x="258074" y="28092"/>
                  <a:pt x="258356" y="25051"/>
                  <a:pt x="233916" y="37271"/>
                </a:cubicBezTo>
                <a:cubicBezTo>
                  <a:pt x="228201" y="40128"/>
                  <a:pt x="223806" y="45309"/>
                  <a:pt x="217967" y="47904"/>
                </a:cubicBezTo>
                <a:cubicBezTo>
                  <a:pt x="207726" y="52456"/>
                  <a:pt x="195395" y="52320"/>
                  <a:pt x="186070" y="58537"/>
                </a:cubicBezTo>
                <a:cubicBezTo>
                  <a:pt x="164042" y="73222"/>
                  <a:pt x="176320" y="67619"/>
                  <a:pt x="148856" y="74485"/>
                </a:cubicBezTo>
                <a:cubicBezTo>
                  <a:pt x="143540" y="79801"/>
                  <a:pt x="139025" y="86064"/>
                  <a:pt x="132907" y="90434"/>
                </a:cubicBezTo>
                <a:cubicBezTo>
                  <a:pt x="121409" y="98647"/>
                  <a:pt x="108710" y="102044"/>
                  <a:pt x="95693" y="106383"/>
                </a:cubicBezTo>
                <a:cubicBezTo>
                  <a:pt x="90377" y="111699"/>
                  <a:pt x="85520" y="117519"/>
                  <a:pt x="79744" y="122332"/>
                </a:cubicBezTo>
                <a:cubicBezTo>
                  <a:pt x="74836" y="126422"/>
                  <a:pt x="68313" y="128446"/>
                  <a:pt x="63795" y="132964"/>
                </a:cubicBezTo>
                <a:cubicBezTo>
                  <a:pt x="59277" y="137482"/>
                  <a:pt x="56877" y="143714"/>
                  <a:pt x="53163" y="148913"/>
                </a:cubicBezTo>
                <a:cubicBezTo>
                  <a:pt x="20174" y="195098"/>
                  <a:pt x="51652" y="148521"/>
                  <a:pt x="26581" y="186127"/>
                </a:cubicBezTo>
                <a:lnTo>
                  <a:pt x="15949" y="218025"/>
                </a:lnTo>
                <a:cubicBezTo>
                  <a:pt x="14177" y="223341"/>
                  <a:pt x="11732" y="228479"/>
                  <a:pt x="10633" y="233974"/>
                </a:cubicBezTo>
                <a:cubicBezTo>
                  <a:pt x="3883" y="267720"/>
                  <a:pt x="7507" y="251789"/>
                  <a:pt x="0" y="281820"/>
                </a:cubicBezTo>
                <a:cubicBezTo>
                  <a:pt x="1772" y="297769"/>
                  <a:pt x="2678" y="313838"/>
                  <a:pt x="5316" y="329667"/>
                </a:cubicBezTo>
                <a:cubicBezTo>
                  <a:pt x="6237" y="335195"/>
                  <a:pt x="6670" y="341653"/>
                  <a:pt x="10633" y="345616"/>
                </a:cubicBezTo>
                <a:cubicBezTo>
                  <a:pt x="19669" y="354652"/>
                  <a:pt x="32307" y="359214"/>
                  <a:pt x="42530" y="366881"/>
                </a:cubicBezTo>
                <a:cubicBezTo>
                  <a:pt x="49618" y="372197"/>
                  <a:pt x="56536" y="377749"/>
                  <a:pt x="63795" y="382830"/>
                </a:cubicBezTo>
                <a:cubicBezTo>
                  <a:pt x="74264" y="390158"/>
                  <a:pt x="83570" y="400054"/>
                  <a:pt x="95693" y="404095"/>
                </a:cubicBezTo>
                <a:lnTo>
                  <a:pt x="127591" y="414727"/>
                </a:lnTo>
                <a:cubicBezTo>
                  <a:pt x="129736" y="417588"/>
                  <a:pt x="151344" y="445577"/>
                  <a:pt x="154172" y="451941"/>
                </a:cubicBezTo>
                <a:cubicBezTo>
                  <a:pt x="158724" y="462183"/>
                  <a:pt x="161261" y="473206"/>
                  <a:pt x="164805" y="483839"/>
                </a:cubicBezTo>
                <a:cubicBezTo>
                  <a:pt x="166577" y="489155"/>
                  <a:pt x="167012" y="495125"/>
                  <a:pt x="170121" y="499788"/>
                </a:cubicBezTo>
                <a:cubicBezTo>
                  <a:pt x="177209" y="510420"/>
                  <a:pt x="183719" y="521462"/>
                  <a:pt x="191386" y="531685"/>
                </a:cubicBezTo>
                <a:cubicBezTo>
                  <a:pt x="196702" y="538774"/>
                  <a:pt x="202639" y="545437"/>
                  <a:pt x="207335" y="552951"/>
                </a:cubicBezTo>
                <a:cubicBezTo>
                  <a:pt x="232526" y="593258"/>
                  <a:pt x="199617" y="555867"/>
                  <a:pt x="239233" y="595481"/>
                </a:cubicBezTo>
                <a:cubicBezTo>
                  <a:pt x="242777" y="606113"/>
                  <a:pt x="243648" y="618053"/>
                  <a:pt x="249865" y="627378"/>
                </a:cubicBezTo>
                <a:cubicBezTo>
                  <a:pt x="256953" y="638011"/>
                  <a:pt x="267089" y="647153"/>
                  <a:pt x="271130" y="659276"/>
                </a:cubicBezTo>
                <a:cubicBezTo>
                  <a:pt x="278468" y="681286"/>
                  <a:pt x="273339" y="670562"/>
                  <a:pt x="287079" y="691174"/>
                </a:cubicBezTo>
                <a:cubicBezTo>
                  <a:pt x="290736" y="709459"/>
                  <a:pt x="292703" y="721491"/>
                  <a:pt x="297712" y="739020"/>
                </a:cubicBezTo>
                <a:cubicBezTo>
                  <a:pt x="299252" y="744408"/>
                  <a:pt x="300522" y="749957"/>
                  <a:pt x="303028" y="754969"/>
                </a:cubicBezTo>
                <a:cubicBezTo>
                  <a:pt x="305885" y="760684"/>
                  <a:pt x="310116" y="765602"/>
                  <a:pt x="313660" y="770918"/>
                </a:cubicBezTo>
                <a:cubicBezTo>
                  <a:pt x="315362" y="777726"/>
                  <a:pt x="320482" y="800509"/>
                  <a:pt x="324293" y="808132"/>
                </a:cubicBezTo>
                <a:cubicBezTo>
                  <a:pt x="327150" y="813847"/>
                  <a:pt x="331382" y="818765"/>
                  <a:pt x="334926" y="824081"/>
                </a:cubicBezTo>
                <a:cubicBezTo>
                  <a:pt x="348315" y="877641"/>
                  <a:pt x="330251" y="801346"/>
                  <a:pt x="345558" y="893192"/>
                </a:cubicBezTo>
                <a:cubicBezTo>
                  <a:pt x="346479" y="898720"/>
                  <a:pt x="349334" y="903753"/>
                  <a:pt x="350874" y="909141"/>
                </a:cubicBezTo>
                <a:cubicBezTo>
                  <a:pt x="352881" y="916166"/>
                  <a:pt x="355051" y="923189"/>
                  <a:pt x="356191" y="930406"/>
                </a:cubicBezTo>
                <a:cubicBezTo>
                  <a:pt x="360373" y="956895"/>
                  <a:pt x="363966" y="983487"/>
                  <a:pt x="366823" y="1010151"/>
                </a:cubicBezTo>
                <a:cubicBezTo>
                  <a:pt x="369284" y="1033125"/>
                  <a:pt x="368713" y="1056413"/>
                  <a:pt x="372140" y="1079262"/>
                </a:cubicBezTo>
                <a:cubicBezTo>
                  <a:pt x="374054" y="1092020"/>
                  <a:pt x="379643" y="1103960"/>
                  <a:pt x="382772" y="1116476"/>
                </a:cubicBezTo>
                <a:cubicBezTo>
                  <a:pt x="384963" y="1125242"/>
                  <a:pt x="385711" y="1134340"/>
                  <a:pt x="388088" y="1143057"/>
                </a:cubicBezTo>
                <a:cubicBezTo>
                  <a:pt x="391037" y="1153870"/>
                  <a:pt x="398721" y="1174955"/>
                  <a:pt x="398721" y="1174955"/>
                </a:cubicBezTo>
                <a:cubicBezTo>
                  <a:pt x="400493" y="1189132"/>
                  <a:pt x="402744" y="1203257"/>
                  <a:pt x="404037" y="1217485"/>
                </a:cubicBezTo>
                <a:cubicBezTo>
                  <a:pt x="406289" y="1242255"/>
                  <a:pt x="406136" y="1267249"/>
                  <a:pt x="409353" y="1291913"/>
                </a:cubicBezTo>
                <a:cubicBezTo>
                  <a:pt x="411466" y="1308114"/>
                  <a:pt x="416563" y="1323785"/>
                  <a:pt x="419986" y="1339760"/>
                </a:cubicBezTo>
                <a:cubicBezTo>
                  <a:pt x="421879" y="1348595"/>
                  <a:pt x="422129" y="1357881"/>
                  <a:pt x="425302" y="1366341"/>
                </a:cubicBezTo>
                <a:cubicBezTo>
                  <a:pt x="427546" y="1372324"/>
                  <a:pt x="435935" y="1382290"/>
                  <a:pt x="435935" y="1382290"/>
                </a:cubicBezTo>
              </a:path>
            </a:pathLst>
          </a:custGeom>
          <a:noFill/>
          <a:ln w="9525">
            <a:solidFill>
              <a:srgbClr val="FFFF0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45" name="CasellaDiTesto 44"/>
          <p:cNvSpPr txBox="1"/>
          <p:nvPr/>
        </p:nvSpPr>
        <p:spPr>
          <a:xfrm>
            <a:off x="991795" y="2511999"/>
            <a:ext cx="277640" cy="246221"/>
          </a:xfrm>
          <a:prstGeom prst="rect">
            <a:avLst/>
          </a:prstGeom>
          <a:noFill/>
        </p:spPr>
        <p:txBody>
          <a:bodyPr wrap="none" rtlCol="0">
            <a:spAutoFit/>
          </a:bodyPr>
          <a:lstStyle/>
          <a:p>
            <a:pPr algn="ctr"/>
            <a:r>
              <a:rPr lang="it-IT" sz="1000" b="1" dirty="0" smtClean="0">
                <a:solidFill>
                  <a:srgbClr val="FFFF00"/>
                </a:solidFill>
              </a:rPr>
              <a:t>N</a:t>
            </a:r>
            <a:endParaRPr lang="it-IT" sz="1000" b="1" dirty="0">
              <a:solidFill>
                <a:srgbClr val="FFFF00"/>
              </a:solidFill>
            </a:endParaRPr>
          </a:p>
        </p:txBody>
      </p:sp>
      <p:sp>
        <p:nvSpPr>
          <p:cNvPr id="46" name="CasellaDiTesto 45"/>
          <p:cNvSpPr txBox="1"/>
          <p:nvPr/>
        </p:nvSpPr>
        <p:spPr>
          <a:xfrm>
            <a:off x="753041" y="3770202"/>
            <a:ext cx="277640" cy="246221"/>
          </a:xfrm>
          <a:prstGeom prst="rect">
            <a:avLst/>
          </a:prstGeom>
          <a:noFill/>
        </p:spPr>
        <p:txBody>
          <a:bodyPr wrap="none" rtlCol="0">
            <a:spAutoFit/>
          </a:bodyPr>
          <a:lstStyle/>
          <a:p>
            <a:pPr algn="ctr"/>
            <a:r>
              <a:rPr lang="it-IT" sz="1000" b="1" dirty="0" smtClean="0">
                <a:solidFill>
                  <a:srgbClr val="FFFF00"/>
                </a:solidFill>
              </a:rPr>
              <a:t>N</a:t>
            </a:r>
            <a:endParaRPr lang="it-IT" sz="1000" b="1" dirty="0">
              <a:solidFill>
                <a:srgbClr val="FFFF00"/>
              </a:solidFill>
            </a:endParaRPr>
          </a:p>
        </p:txBody>
      </p:sp>
      <p:sp>
        <p:nvSpPr>
          <p:cNvPr id="47" name="Figura a mano libera 46"/>
          <p:cNvSpPr>
            <a:spLocks noChangeAspect="1"/>
          </p:cNvSpPr>
          <p:nvPr/>
        </p:nvSpPr>
        <p:spPr>
          <a:xfrm>
            <a:off x="835423" y="1316986"/>
            <a:ext cx="924224" cy="837314"/>
          </a:xfrm>
          <a:custGeom>
            <a:avLst/>
            <a:gdLst>
              <a:gd name="connsiteX0" fmla="*/ 850604 w 850604"/>
              <a:gd name="connsiteY0" fmla="*/ 0 h 797442"/>
              <a:gd name="connsiteX1" fmla="*/ 792125 w 850604"/>
              <a:gd name="connsiteY1" fmla="*/ 37214 h 797442"/>
              <a:gd name="connsiteX2" fmla="*/ 776176 w 850604"/>
              <a:gd name="connsiteY2" fmla="*/ 47846 h 797442"/>
              <a:gd name="connsiteX3" fmla="*/ 744279 w 850604"/>
              <a:gd name="connsiteY3" fmla="*/ 69111 h 797442"/>
              <a:gd name="connsiteX4" fmla="*/ 723014 w 850604"/>
              <a:gd name="connsiteY4" fmla="*/ 79744 h 797442"/>
              <a:gd name="connsiteX5" fmla="*/ 680483 w 850604"/>
              <a:gd name="connsiteY5" fmla="*/ 90377 h 797442"/>
              <a:gd name="connsiteX6" fmla="*/ 622004 w 850604"/>
              <a:gd name="connsiteY6" fmla="*/ 106325 h 797442"/>
              <a:gd name="connsiteX7" fmla="*/ 584790 w 850604"/>
              <a:gd name="connsiteY7" fmla="*/ 122274 h 797442"/>
              <a:gd name="connsiteX8" fmla="*/ 568841 w 850604"/>
              <a:gd name="connsiteY8" fmla="*/ 132907 h 797442"/>
              <a:gd name="connsiteX9" fmla="*/ 552893 w 850604"/>
              <a:gd name="connsiteY9" fmla="*/ 138223 h 797442"/>
              <a:gd name="connsiteX10" fmla="*/ 520995 w 850604"/>
              <a:gd name="connsiteY10" fmla="*/ 159488 h 797442"/>
              <a:gd name="connsiteX11" fmla="*/ 505046 w 850604"/>
              <a:gd name="connsiteY11" fmla="*/ 170121 h 797442"/>
              <a:gd name="connsiteX12" fmla="*/ 473148 w 850604"/>
              <a:gd name="connsiteY12" fmla="*/ 196702 h 797442"/>
              <a:gd name="connsiteX13" fmla="*/ 462516 w 850604"/>
              <a:gd name="connsiteY13" fmla="*/ 212651 h 797442"/>
              <a:gd name="connsiteX14" fmla="*/ 425302 w 850604"/>
              <a:gd name="connsiteY14" fmla="*/ 244549 h 797442"/>
              <a:gd name="connsiteX15" fmla="*/ 419986 w 850604"/>
              <a:gd name="connsiteY15" fmla="*/ 260498 h 797442"/>
              <a:gd name="connsiteX16" fmla="*/ 404037 w 850604"/>
              <a:gd name="connsiteY16" fmla="*/ 271130 h 797442"/>
              <a:gd name="connsiteX17" fmla="*/ 350874 w 850604"/>
              <a:gd name="connsiteY17" fmla="*/ 287079 h 797442"/>
              <a:gd name="connsiteX18" fmla="*/ 318976 w 850604"/>
              <a:gd name="connsiteY18" fmla="*/ 297711 h 797442"/>
              <a:gd name="connsiteX19" fmla="*/ 303028 w 850604"/>
              <a:gd name="connsiteY19" fmla="*/ 308344 h 797442"/>
              <a:gd name="connsiteX20" fmla="*/ 281762 w 850604"/>
              <a:gd name="connsiteY20" fmla="*/ 356191 h 797442"/>
              <a:gd name="connsiteX21" fmla="*/ 271130 w 850604"/>
              <a:gd name="connsiteY21" fmla="*/ 382772 h 797442"/>
              <a:gd name="connsiteX22" fmla="*/ 239232 w 850604"/>
              <a:gd name="connsiteY22" fmla="*/ 419986 h 797442"/>
              <a:gd name="connsiteX23" fmla="*/ 228600 w 850604"/>
              <a:gd name="connsiteY23" fmla="*/ 435935 h 797442"/>
              <a:gd name="connsiteX24" fmla="*/ 212651 w 850604"/>
              <a:gd name="connsiteY24" fmla="*/ 451884 h 797442"/>
              <a:gd name="connsiteX25" fmla="*/ 202018 w 850604"/>
              <a:gd name="connsiteY25" fmla="*/ 467832 h 797442"/>
              <a:gd name="connsiteX26" fmla="*/ 186069 w 850604"/>
              <a:gd name="connsiteY26" fmla="*/ 483781 h 797442"/>
              <a:gd name="connsiteX27" fmla="*/ 164804 w 850604"/>
              <a:gd name="connsiteY27" fmla="*/ 510363 h 797442"/>
              <a:gd name="connsiteX28" fmla="*/ 148855 w 850604"/>
              <a:gd name="connsiteY28" fmla="*/ 526311 h 797442"/>
              <a:gd name="connsiteX29" fmla="*/ 127590 w 850604"/>
              <a:gd name="connsiteY29" fmla="*/ 558209 h 797442"/>
              <a:gd name="connsiteX30" fmla="*/ 122274 w 850604"/>
              <a:gd name="connsiteY30" fmla="*/ 606056 h 797442"/>
              <a:gd name="connsiteX31" fmla="*/ 106325 w 850604"/>
              <a:gd name="connsiteY31" fmla="*/ 627321 h 797442"/>
              <a:gd name="connsiteX32" fmla="*/ 95693 w 850604"/>
              <a:gd name="connsiteY32" fmla="*/ 643270 h 797442"/>
              <a:gd name="connsiteX33" fmla="*/ 79744 w 850604"/>
              <a:gd name="connsiteY33" fmla="*/ 653902 h 797442"/>
              <a:gd name="connsiteX34" fmla="*/ 47846 w 850604"/>
              <a:gd name="connsiteY34" fmla="*/ 685800 h 797442"/>
              <a:gd name="connsiteX35" fmla="*/ 42530 w 850604"/>
              <a:gd name="connsiteY35" fmla="*/ 701749 h 797442"/>
              <a:gd name="connsiteX36" fmla="*/ 37214 w 850604"/>
              <a:gd name="connsiteY36" fmla="*/ 749595 h 797442"/>
              <a:gd name="connsiteX37" fmla="*/ 15948 w 850604"/>
              <a:gd name="connsiteY37" fmla="*/ 765544 h 797442"/>
              <a:gd name="connsiteX38" fmla="*/ 5316 w 850604"/>
              <a:gd name="connsiteY38" fmla="*/ 781493 h 797442"/>
              <a:gd name="connsiteX39" fmla="*/ 0 w 850604"/>
              <a:gd name="connsiteY39" fmla="*/ 797442 h 79744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Lst>
            <a:rect l="l" t="t" r="r" b="b"/>
            <a:pathLst>
              <a:path w="850604" h="797442">
                <a:moveTo>
                  <a:pt x="850604" y="0"/>
                </a:moveTo>
                <a:cubicBezTo>
                  <a:pt x="813060" y="22527"/>
                  <a:pt x="832627" y="10214"/>
                  <a:pt x="792125" y="37214"/>
                </a:cubicBezTo>
                <a:lnTo>
                  <a:pt x="776176" y="47846"/>
                </a:lnTo>
                <a:cubicBezTo>
                  <a:pt x="758823" y="73878"/>
                  <a:pt x="774794" y="57668"/>
                  <a:pt x="744279" y="69111"/>
                </a:cubicBezTo>
                <a:cubicBezTo>
                  <a:pt x="736859" y="71894"/>
                  <a:pt x="730532" y="77238"/>
                  <a:pt x="723014" y="79744"/>
                </a:cubicBezTo>
                <a:cubicBezTo>
                  <a:pt x="709151" y="84365"/>
                  <a:pt x="694346" y="85756"/>
                  <a:pt x="680483" y="90377"/>
                </a:cubicBezTo>
                <a:cubicBezTo>
                  <a:pt x="640014" y="103866"/>
                  <a:pt x="659576" y="98811"/>
                  <a:pt x="622004" y="106325"/>
                </a:cubicBezTo>
                <a:cubicBezTo>
                  <a:pt x="581963" y="133020"/>
                  <a:pt x="632852" y="101676"/>
                  <a:pt x="584790" y="122274"/>
                </a:cubicBezTo>
                <a:cubicBezTo>
                  <a:pt x="578917" y="124791"/>
                  <a:pt x="574556" y="130049"/>
                  <a:pt x="568841" y="132907"/>
                </a:cubicBezTo>
                <a:cubicBezTo>
                  <a:pt x="563829" y="135413"/>
                  <a:pt x="558209" y="136451"/>
                  <a:pt x="552893" y="138223"/>
                </a:cubicBezTo>
                <a:lnTo>
                  <a:pt x="520995" y="159488"/>
                </a:lnTo>
                <a:cubicBezTo>
                  <a:pt x="515679" y="163032"/>
                  <a:pt x="509564" y="165603"/>
                  <a:pt x="505046" y="170121"/>
                </a:cubicBezTo>
                <a:cubicBezTo>
                  <a:pt x="484579" y="190588"/>
                  <a:pt x="495353" y="181900"/>
                  <a:pt x="473148" y="196702"/>
                </a:cubicBezTo>
                <a:cubicBezTo>
                  <a:pt x="469604" y="202018"/>
                  <a:pt x="466674" y="207800"/>
                  <a:pt x="462516" y="212651"/>
                </a:cubicBezTo>
                <a:cubicBezTo>
                  <a:pt x="445329" y="232703"/>
                  <a:pt x="444113" y="232008"/>
                  <a:pt x="425302" y="244549"/>
                </a:cubicBezTo>
                <a:cubicBezTo>
                  <a:pt x="423530" y="249865"/>
                  <a:pt x="423487" y="256122"/>
                  <a:pt x="419986" y="260498"/>
                </a:cubicBezTo>
                <a:cubicBezTo>
                  <a:pt x="415995" y="265487"/>
                  <a:pt x="409876" y="268535"/>
                  <a:pt x="404037" y="271130"/>
                </a:cubicBezTo>
                <a:cubicBezTo>
                  <a:pt x="378008" y="282698"/>
                  <a:pt x="374668" y="279941"/>
                  <a:pt x="350874" y="287079"/>
                </a:cubicBezTo>
                <a:cubicBezTo>
                  <a:pt x="340139" y="290299"/>
                  <a:pt x="318976" y="297711"/>
                  <a:pt x="318976" y="297711"/>
                </a:cubicBezTo>
                <a:cubicBezTo>
                  <a:pt x="313660" y="301255"/>
                  <a:pt x="307546" y="303826"/>
                  <a:pt x="303028" y="308344"/>
                </a:cubicBezTo>
                <a:cubicBezTo>
                  <a:pt x="289390" y="321983"/>
                  <a:pt x="288781" y="338642"/>
                  <a:pt x="281762" y="356191"/>
                </a:cubicBezTo>
                <a:cubicBezTo>
                  <a:pt x="278218" y="365051"/>
                  <a:pt x="275764" y="374430"/>
                  <a:pt x="271130" y="382772"/>
                </a:cubicBezTo>
                <a:cubicBezTo>
                  <a:pt x="257857" y="406664"/>
                  <a:pt x="255348" y="400646"/>
                  <a:pt x="239232" y="419986"/>
                </a:cubicBezTo>
                <a:cubicBezTo>
                  <a:pt x="235142" y="424894"/>
                  <a:pt x="232690" y="431027"/>
                  <a:pt x="228600" y="435935"/>
                </a:cubicBezTo>
                <a:cubicBezTo>
                  <a:pt x="223787" y="441711"/>
                  <a:pt x="217464" y="446108"/>
                  <a:pt x="212651" y="451884"/>
                </a:cubicBezTo>
                <a:cubicBezTo>
                  <a:pt x="208561" y="456792"/>
                  <a:pt x="206108" y="462924"/>
                  <a:pt x="202018" y="467832"/>
                </a:cubicBezTo>
                <a:cubicBezTo>
                  <a:pt x="197205" y="473608"/>
                  <a:pt x="191020" y="478123"/>
                  <a:pt x="186069" y="483781"/>
                </a:cubicBezTo>
                <a:cubicBezTo>
                  <a:pt x="178597" y="492321"/>
                  <a:pt x="172276" y="501823"/>
                  <a:pt x="164804" y="510363"/>
                </a:cubicBezTo>
                <a:cubicBezTo>
                  <a:pt x="159853" y="516021"/>
                  <a:pt x="153471" y="520377"/>
                  <a:pt x="148855" y="526311"/>
                </a:cubicBezTo>
                <a:cubicBezTo>
                  <a:pt x="141010" y="536398"/>
                  <a:pt x="127590" y="558209"/>
                  <a:pt x="127590" y="558209"/>
                </a:cubicBezTo>
                <a:cubicBezTo>
                  <a:pt x="125818" y="574158"/>
                  <a:pt x="126993" y="590718"/>
                  <a:pt x="122274" y="606056"/>
                </a:cubicBezTo>
                <a:cubicBezTo>
                  <a:pt x="119668" y="614525"/>
                  <a:pt x="111475" y="620111"/>
                  <a:pt x="106325" y="627321"/>
                </a:cubicBezTo>
                <a:cubicBezTo>
                  <a:pt x="102611" y="632520"/>
                  <a:pt x="100211" y="638752"/>
                  <a:pt x="95693" y="643270"/>
                </a:cubicBezTo>
                <a:cubicBezTo>
                  <a:pt x="91175" y="647788"/>
                  <a:pt x="84519" y="649657"/>
                  <a:pt x="79744" y="653902"/>
                </a:cubicBezTo>
                <a:cubicBezTo>
                  <a:pt x="68505" y="663892"/>
                  <a:pt x="47846" y="685800"/>
                  <a:pt x="47846" y="685800"/>
                </a:cubicBezTo>
                <a:cubicBezTo>
                  <a:pt x="46074" y="691116"/>
                  <a:pt x="43451" y="696221"/>
                  <a:pt x="42530" y="701749"/>
                </a:cubicBezTo>
                <a:cubicBezTo>
                  <a:pt x="39892" y="717577"/>
                  <a:pt x="43386" y="734783"/>
                  <a:pt x="37214" y="749595"/>
                </a:cubicBezTo>
                <a:cubicBezTo>
                  <a:pt x="33806" y="757774"/>
                  <a:pt x="23037" y="760228"/>
                  <a:pt x="15948" y="765544"/>
                </a:cubicBezTo>
                <a:cubicBezTo>
                  <a:pt x="12404" y="770860"/>
                  <a:pt x="8173" y="775778"/>
                  <a:pt x="5316" y="781493"/>
                </a:cubicBezTo>
                <a:cubicBezTo>
                  <a:pt x="2810" y="786505"/>
                  <a:pt x="0" y="797442"/>
                  <a:pt x="0" y="797442"/>
                </a:cubicBezTo>
              </a:path>
            </a:pathLst>
          </a:custGeom>
          <a:noFill/>
          <a:ln w="9525">
            <a:solidFill>
              <a:srgbClr val="FFFF0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48" name="Figura a mano libera 47"/>
          <p:cNvSpPr>
            <a:spLocks noChangeAspect="1"/>
          </p:cNvSpPr>
          <p:nvPr/>
        </p:nvSpPr>
        <p:spPr>
          <a:xfrm>
            <a:off x="2243517" y="1316986"/>
            <a:ext cx="924224" cy="837314"/>
          </a:xfrm>
          <a:custGeom>
            <a:avLst/>
            <a:gdLst>
              <a:gd name="connsiteX0" fmla="*/ 850604 w 850604"/>
              <a:gd name="connsiteY0" fmla="*/ 0 h 797442"/>
              <a:gd name="connsiteX1" fmla="*/ 792125 w 850604"/>
              <a:gd name="connsiteY1" fmla="*/ 37214 h 797442"/>
              <a:gd name="connsiteX2" fmla="*/ 776176 w 850604"/>
              <a:gd name="connsiteY2" fmla="*/ 47846 h 797442"/>
              <a:gd name="connsiteX3" fmla="*/ 744279 w 850604"/>
              <a:gd name="connsiteY3" fmla="*/ 69111 h 797442"/>
              <a:gd name="connsiteX4" fmla="*/ 723014 w 850604"/>
              <a:gd name="connsiteY4" fmla="*/ 79744 h 797442"/>
              <a:gd name="connsiteX5" fmla="*/ 680483 w 850604"/>
              <a:gd name="connsiteY5" fmla="*/ 90377 h 797442"/>
              <a:gd name="connsiteX6" fmla="*/ 622004 w 850604"/>
              <a:gd name="connsiteY6" fmla="*/ 106325 h 797442"/>
              <a:gd name="connsiteX7" fmla="*/ 584790 w 850604"/>
              <a:gd name="connsiteY7" fmla="*/ 122274 h 797442"/>
              <a:gd name="connsiteX8" fmla="*/ 568841 w 850604"/>
              <a:gd name="connsiteY8" fmla="*/ 132907 h 797442"/>
              <a:gd name="connsiteX9" fmla="*/ 552893 w 850604"/>
              <a:gd name="connsiteY9" fmla="*/ 138223 h 797442"/>
              <a:gd name="connsiteX10" fmla="*/ 520995 w 850604"/>
              <a:gd name="connsiteY10" fmla="*/ 159488 h 797442"/>
              <a:gd name="connsiteX11" fmla="*/ 505046 w 850604"/>
              <a:gd name="connsiteY11" fmla="*/ 170121 h 797442"/>
              <a:gd name="connsiteX12" fmla="*/ 473148 w 850604"/>
              <a:gd name="connsiteY12" fmla="*/ 196702 h 797442"/>
              <a:gd name="connsiteX13" fmla="*/ 462516 w 850604"/>
              <a:gd name="connsiteY13" fmla="*/ 212651 h 797442"/>
              <a:gd name="connsiteX14" fmla="*/ 425302 w 850604"/>
              <a:gd name="connsiteY14" fmla="*/ 244549 h 797442"/>
              <a:gd name="connsiteX15" fmla="*/ 419986 w 850604"/>
              <a:gd name="connsiteY15" fmla="*/ 260498 h 797442"/>
              <a:gd name="connsiteX16" fmla="*/ 404037 w 850604"/>
              <a:gd name="connsiteY16" fmla="*/ 271130 h 797442"/>
              <a:gd name="connsiteX17" fmla="*/ 350874 w 850604"/>
              <a:gd name="connsiteY17" fmla="*/ 287079 h 797442"/>
              <a:gd name="connsiteX18" fmla="*/ 318976 w 850604"/>
              <a:gd name="connsiteY18" fmla="*/ 297711 h 797442"/>
              <a:gd name="connsiteX19" fmla="*/ 303028 w 850604"/>
              <a:gd name="connsiteY19" fmla="*/ 308344 h 797442"/>
              <a:gd name="connsiteX20" fmla="*/ 281762 w 850604"/>
              <a:gd name="connsiteY20" fmla="*/ 356191 h 797442"/>
              <a:gd name="connsiteX21" fmla="*/ 271130 w 850604"/>
              <a:gd name="connsiteY21" fmla="*/ 382772 h 797442"/>
              <a:gd name="connsiteX22" fmla="*/ 239232 w 850604"/>
              <a:gd name="connsiteY22" fmla="*/ 419986 h 797442"/>
              <a:gd name="connsiteX23" fmla="*/ 228600 w 850604"/>
              <a:gd name="connsiteY23" fmla="*/ 435935 h 797442"/>
              <a:gd name="connsiteX24" fmla="*/ 212651 w 850604"/>
              <a:gd name="connsiteY24" fmla="*/ 451884 h 797442"/>
              <a:gd name="connsiteX25" fmla="*/ 202018 w 850604"/>
              <a:gd name="connsiteY25" fmla="*/ 467832 h 797442"/>
              <a:gd name="connsiteX26" fmla="*/ 186069 w 850604"/>
              <a:gd name="connsiteY26" fmla="*/ 483781 h 797442"/>
              <a:gd name="connsiteX27" fmla="*/ 164804 w 850604"/>
              <a:gd name="connsiteY27" fmla="*/ 510363 h 797442"/>
              <a:gd name="connsiteX28" fmla="*/ 148855 w 850604"/>
              <a:gd name="connsiteY28" fmla="*/ 526311 h 797442"/>
              <a:gd name="connsiteX29" fmla="*/ 127590 w 850604"/>
              <a:gd name="connsiteY29" fmla="*/ 558209 h 797442"/>
              <a:gd name="connsiteX30" fmla="*/ 122274 w 850604"/>
              <a:gd name="connsiteY30" fmla="*/ 606056 h 797442"/>
              <a:gd name="connsiteX31" fmla="*/ 106325 w 850604"/>
              <a:gd name="connsiteY31" fmla="*/ 627321 h 797442"/>
              <a:gd name="connsiteX32" fmla="*/ 95693 w 850604"/>
              <a:gd name="connsiteY32" fmla="*/ 643270 h 797442"/>
              <a:gd name="connsiteX33" fmla="*/ 79744 w 850604"/>
              <a:gd name="connsiteY33" fmla="*/ 653902 h 797442"/>
              <a:gd name="connsiteX34" fmla="*/ 47846 w 850604"/>
              <a:gd name="connsiteY34" fmla="*/ 685800 h 797442"/>
              <a:gd name="connsiteX35" fmla="*/ 42530 w 850604"/>
              <a:gd name="connsiteY35" fmla="*/ 701749 h 797442"/>
              <a:gd name="connsiteX36" fmla="*/ 37214 w 850604"/>
              <a:gd name="connsiteY36" fmla="*/ 749595 h 797442"/>
              <a:gd name="connsiteX37" fmla="*/ 15948 w 850604"/>
              <a:gd name="connsiteY37" fmla="*/ 765544 h 797442"/>
              <a:gd name="connsiteX38" fmla="*/ 5316 w 850604"/>
              <a:gd name="connsiteY38" fmla="*/ 781493 h 797442"/>
              <a:gd name="connsiteX39" fmla="*/ 0 w 850604"/>
              <a:gd name="connsiteY39" fmla="*/ 797442 h 79744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Lst>
            <a:rect l="l" t="t" r="r" b="b"/>
            <a:pathLst>
              <a:path w="850604" h="797442">
                <a:moveTo>
                  <a:pt x="850604" y="0"/>
                </a:moveTo>
                <a:cubicBezTo>
                  <a:pt x="813060" y="22527"/>
                  <a:pt x="832627" y="10214"/>
                  <a:pt x="792125" y="37214"/>
                </a:cubicBezTo>
                <a:lnTo>
                  <a:pt x="776176" y="47846"/>
                </a:lnTo>
                <a:cubicBezTo>
                  <a:pt x="758823" y="73878"/>
                  <a:pt x="774794" y="57668"/>
                  <a:pt x="744279" y="69111"/>
                </a:cubicBezTo>
                <a:cubicBezTo>
                  <a:pt x="736859" y="71894"/>
                  <a:pt x="730532" y="77238"/>
                  <a:pt x="723014" y="79744"/>
                </a:cubicBezTo>
                <a:cubicBezTo>
                  <a:pt x="709151" y="84365"/>
                  <a:pt x="694346" y="85756"/>
                  <a:pt x="680483" y="90377"/>
                </a:cubicBezTo>
                <a:cubicBezTo>
                  <a:pt x="640014" y="103866"/>
                  <a:pt x="659576" y="98811"/>
                  <a:pt x="622004" y="106325"/>
                </a:cubicBezTo>
                <a:cubicBezTo>
                  <a:pt x="581963" y="133020"/>
                  <a:pt x="632852" y="101676"/>
                  <a:pt x="584790" y="122274"/>
                </a:cubicBezTo>
                <a:cubicBezTo>
                  <a:pt x="578917" y="124791"/>
                  <a:pt x="574556" y="130049"/>
                  <a:pt x="568841" y="132907"/>
                </a:cubicBezTo>
                <a:cubicBezTo>
                  <a:pt x="563829" y="135413"/>
                  <a:pt x="558209" y="136451"/>
                  <a:pt x="552893" y="138223"/>
                </a:cubicBezTo>
                <a:lnTo>
                  <a:pt x="520995" y="159488"/>
                </a:lnTo>
                <a:cubicBezTo>
                  <a:pt x="515679" y="163032"/>
                  <a:pt x="509564" y="165603"/>
                  <a:pt x="505046" y="170121"/>
                </a:cubicBezTo>
                <a:cubicBezTo>
                  <a:pt x="484579" y="190588"/>
                  <a:pt x="495353" y="181900"/>
                  <a:pt x="473148" y="196702"/>
                </a:cubicBezTo>
                <a:cubicBezTo>
                  <a:pt x="469604" y="202018"/>
                  <a:pt x="466674" y="207800"/>
                  <a:pt x="462516" y="212651"/>
                </a:cubicBezTo>
                <a:cubicBezTo>
                  <a:pt x="445329" y="232703"/>
                  <a:pt x="444113" y="232008"/>
                  <a:pt x="425302" y="244549"/>
                </a:cubicBezTo>
                <a:cubicBezTo>
                  <a:pt x="423530" y="249865"/>
                  <a:pt x="423487" y="256122"/>
                  <a:pt x="419986" y="260498"/>
                </a:cubicBezTo>
                <a:cubicBezTo>
                  <a:pt x="415995" y="265487"/>
                  <a:pt x="409876" y="268535"/>
                  <a:pt x="404037" y="271130"/>
                </a:cubicBezTo>
                <a:cubicBezTo>
                  <a:pt x="378008" y="282698"/>
                  <a:pt x="374668" y="279941"/>
                  <a:pt x="350874" y="287079"/>
                </a:cubicBezTo>
                <a:cubicBezTo>
                  <a:pt x="340139" y="290299"/>
                  <a:pt x="318976" y="297711"/>
                  <a:pt x="318976" y="297711"/>
                </a:cubicBezTo>
                <a:cubicBezTo>
                  <a:pt x="313660" y="301255"/>
                  <a:pt x="307546" y="303826"/>
                  <a:pt x="303028" y="308344"/>
                </a:cubicBezTo>
                <a:cubicBezTo>
                  <a:pt x="289390" y="321983"/>
                  <a:pt x="288781" y="338642"/>
                  <a:pt x="281762" y="356191"/>
                </a:cubicBezTo>
                <a:cubicBezTo>
                  <a:pt x="278218" y="365051"/>
                  <a:pt x="275764" y="374430"/>
                  <a:pt x="271130" y="382772"/>
                </a:cubicBezTo>
                <a:cubicBezTo>
                  <a:pt x="257857" y="406664"/>
                  <a:pt x="255348" y="400646"/>
                  <a:pt x="239232" y="419986"/>
                </a:cubicBezTo>
                <a:cubicBezTo>
                  <a:pt x="235142" y="424894"/>
                  <a:pt x="232690" y="431027"/>
                  <a:pt x="228600" y="435935"/>
                </a:cubicBezTo>
                <a:cubicBezTo>
                  <a:pt x="223787" y="441711"/>
                  <a:pt x="217464" y="446108"/>
                  <a:pt x="212651" y="451884"/>
                </a:cubicBezTo>
                <a:cubicBezTo>
                  <a:pt x="208561" y="456792"/>
                  <a:pt x="206108" y="462924"/>
                  <a:pt x="202018" y="467832"/>
                </a:cubicBezTo>
                <a:cubicBezTo>
                  <a:pt x="197205" y="473608"/>
                  <a:pt x="191020" y="478123"/>
                  <a:pt x="186069" y="483781"/>
                </a:cubicBezTo>
                <a:cubicBezTo>
                  <a:pt x="178597" y="492321"/>
                  <a:pt x="172276" y="501823"/>
                  <a:pt x="164804" y="510363"/>
                </a:cubicBezTo>
                <a:cubicBezTo>
                  <a:pt x="159853" y="516021"/>
                  <a:pt x="153471" y="520377"/>
                  <a:pt x="148855" y="526311"/>
                </a:cubicBezTo>
                <a:cubicBezTo>
                  <a:pt x="141010" y="536398"/>
                  <a:pt x="127590" y="558209"/>
                  <a:pt x="127590" y="558209"/>
                </a:cubicBezTo>
                <a:cubicBezTo>
                  <a:pt x="125818" y="574158"/>
                  <a:pt x="126993" y="590718"/>
                  <a:pt x="122274" y="606056"/>
                </a:cubicBezTo>
                <a:cubicBezTo>
                  <a:pt x="119668" y="614525"/>
                  <a:pt x="111475" y="620111"/>
                  <a:pt x="106325" y="627321"/>
                </a:cubicBezTo>
                <a:cubicBezTo>
                  <a:pt x="102611" y="632520"/>
                  <a:pt x="100211" y="638752"/>
                  <a:pt x="95693" y="643270"/>
                </a:cubicBezTo>
                <a:cubicBezTo>
                  <a:pt x="91175" y="647788"/>
                  <a:pt x="84519" y="649657"/>
                  <a:pt x="79744" y="653902"/>
                </a:cubicBezTo>
                <a:cubicBezTo>
                  <a:pt x="68505" y="663892"/>
                  <a:pt x="47846" y="685800"/>
                  <a:pt x="47846" y="685800"/>
                </a:cubicBezTo>
                <a:cubicBezTo>
                  <a:pt x="46074" y="691116"/>
                  <a:pt x="43451" y="696221"/>
                  <a:pt x="42530" y="701749"/>
                </a:cubicBezTo>
                <a:cubicBezTo>
                  <a:pt x="39892" y="717577"/>
                  <a:pt x="43386" y="734783"/>
                  <a:pt x="37214" y="749595"/>
                </a:cubicBezTo>
                <a:cubicBezTo>
                  <a:pt x="33806" y="757774"/>
                  <a:pt x="23037" y="760228"/>
                  <a:pt x="15948" y="765544"/>
                </a:cubicBezTo>
                <a:cubicBezTo>
                  <a:pt x="12404" y="770860"/>
                  <a:pt x="8173" y="775778"/>
                  <a:pt x="5316" y="781493"/>
                </a:cubicBezTo>
                <a:cubicBezTo>
                  <a:pt x="2810" y="786505"/>
                  <a:pt x="0" y="797442"/>
                  <a:pt x="0" y="797442"/>
                </a:cubicBezTo>
              </a:path>
            </a:pathLst>
          </a:custGeom>
          <a:noFill/>
          <a:ln w="9525">
            <a:solidFill>
              <a:srgbClr val="FFFF0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49" name="Figura a mano libera 48"/>
          <p:cNvSpPr>
            <a:spLocks noChangeAspect="1"/>
          </p:cNvSpPr>
          <p:nvPr/>
        </p:nvSpPr>
        <p:spPr>
          <a:xfrm>
            <a:off x="3649213" y="1316986"/>
            <a:ext cx="924224" cy="837314"/>
          </a:xfrm>
          <a:custGeom>
            <a:avLst/>
            <a:gdLst>
              <a:gd name="connsiteX0" fmla="*/ 850604 w 850604"/>
              <a:gd name="connsiteY0" fmla="*/ 0 h 797442"/>
              <a:gd name="connsiteX1" fmla="*/ 792125 w 850604"/>
              <a:gd name="connsiteY1" fmla="*/ 37214 h 797442"/>
              <a:gd name="connsiteX2" fmla="*/ 776176 w 850604"/>
              <a:gd name="connsiteY2" fmla="*/ 47846 h 797442"/>
              <a:gd name="connsiteX3" fmla="*/ 744279 w 850604"/>
              <a:gd name="connsiteY3" fmla="*/ 69111 h 797442"/>
              <a:gd name="connsiteX4" fmla="*/ 723014 w 850604"/>
              <a:gd name="connsiteY4" fmla="*/ 79744 h 797442"/>
              <a:gd name="connsiteX5" fmla="*/ 680483 w 850604"/>
              <a:gd name="connsiteY5" fmla="*/ 90377 h 797442"/>
              <a:gd name="connsiteX6" fmla="*/ 622004 w 850604"/>
              <a:gd name="connsiteY6" fmla="*/ 106325 h 797442"/>
              <a:gd name="connsiteX7" fmla="*/ 584790 w 850604"/>
              <a:gd name="connsiteY7" fmla="*/ 122274 h 797442"/>
              <a:gd name="connsiteX8" fmla="*/ 568841 w 850604"/>
              <a:gd name="connsiteY8" fmla="*/ 132907 h 797442"/>
              <a:gd name="connsiteX9" fmla="*/ 552893 w 850604"/>
              <a:gd name="connsiteY9" fmla="*/ 138223 h 797442"/>
              <a:gd name="connsiteX10" fmla="*/ 520995 w 850604"/>
              <a:gd name="connsiteY10" fmla="*/ 159488 h 797442"/>
              <a:gd name="connsiteX11" fmla="*/ 505046 w 850604"/>
              <a:gd name="connsiteY11" fmla="*/ 170121 h 797442"/>
              <a:gd name="connsiteX12" fmla="*/ 473148 w 850604"/>
              <a:gd name="connsiteY12" fmla="*/ 196702 h 797442"/>
              <a:gd name="connsiteX13" fmla="*/ 462516 w 850604"/>
              <a:gd name="connsiteY13" fmla="*/ 212651 h 797442"/>
              <a:gd name="connsiteX14" fmla="*/ 425302 w 850604"/>
              <a:gd name="connsiteY14" fmla="*/ 244549 h 797442"/>
              <a:gd name="connsiteX15" fmla="*/ 419986 w 850604"/>
              <a:gd name="connsiteY15" fmla="*/ 260498 h 797442"/>
              <a:gd name="connsiteX16" fmla="*/ 404037 w 850604"/>
              <a:gd name="connsiteY16" fmla="*/ 271130 h 797442"/>
              <a:gd name="connsiteX17" fmla="*/ 350874 w 850604"/>
              <a:gd name="connsiteY17" fmla="*/ 287079 h 797442"/>
              <a:gd name="connsiteX18" fmla="*/ 318976 w 850604"/>
              <a:gd name="connsiteY18" fmla="*/ 297711 h 797442"/>
              <a:gd name="connsiteX19" fmla="*/ 303028 w 850604"/>
              <a:gd name="connsiteY19" fmla="*/ 308344 h 797442"/>
              <a:gd name="connsiteX20" fmla="*/ 281762 w 850604"/>
              <a:gd name="connsiteY20" fmla="*/ 356191 h 797442"/>
              <a:gd name="connsiteX21" fmla="*/ 271130 w 850604"/>
              <a:gd name="connsiteY21" fmla="*/ 382772 h 797442"/>
              <a:gd name="connsiteX22" fmla="*/ 239232 w 850604"/>
              <a:gd name="connsiteY22" fmla="*/ 419986 h 797442"/>
              <a:gd name="connsiteX23" fmla="*/ 228600 w 850604"/>
              <a:gd name="connsiteY23" fmla="*/ 435935 h 797442"/>
              <a:gd name="connsiteX24" fmla="*/ 212651 w 850604"/>
              <a:gd name="connsiteY24" fmla="*/ 451884 h 797442"/>
              <a:gd name="connsiteX25" fmla="*/ 202018 w 850604"/>
              <a:gd name="connsiteY25" fmla="*/ 467832 h 797442"/>
              <a:gd name="connsiteX26" fmla="*/ 186069 w 850604"/>
              <a:gd name="connsiteY26" fmla="*/ 483781 h 797442"/>
              <a:gd name="connsiteX27" fmla="*/ 164804 w 850604"/>
              <a:gd name="connsiteY27" fmla="*/ 510363 h 797442"/>
              <a:gd name="connsiteX28" fmla="*/ 148855 w 850604"/>
              <a:gd name="connsiteY28" fmla="*/ 526311 h 797442"/>
              <a:gd name="connsiteX29" fmla="*/ 127590 w 850604"/>
              <a:gd name="connsiteY29" fmla="*/ 558209 h 797442"/>
              <a:gd name="connsiteX30" fmla="*/ 122274 w 850604"/>
              <a:gd name="connsiteY30" fmla="*/ 606056 h 797442"/>
              <a:gd name="connsiteX31" fmla="*/ 106325 w 850604"/>
              <a:gd name="connsiteY31" fmla="*/ 627321 h 797442"/>
              <a:gd name="connsiteX32" fmla="*/ 95693 w 850604"/>
              <a:gd name="connsiteY32" fmla="*/ 643270 h 797442"/>
              <a:gd name="connsiteX33" fmla="*/ 79744 w 850604"/>
              <a:gd name="connsiteY33" fmla="*/ 653902 h 797442"/>
              <a:gd name="connsiteX34" fmla="*/ 47846 w 850604"/>
              <a:gd name="connsiteY34" fmla="*/ 685800 h 797442"/>
              <a:gd name="connsiteX35" fmla="*/ 42530 w 850604"/>
              <a:gd name="connsiteY35" fmla="*/ 701749 h 797442"/>
              <a:gd name="connsiteX36" fmla="*/ 37214 w 850604"/>
              <a:gd name="connsiteY36" fmla="*/ 749595 h 797442"/>
              <a:gd name="connsiteX37" fmla="*/ 15948 w 850604"/>
              <a:gd name="connsiteY37" fmla="*/ 765544 h 797442"/>
              <a:gd name="connsiteX38" fmla="*/ 5316 w 850604"/>
              <a:gd name="connsiteY38" fmla="*/ 781493 h 797442"/>
              <a:gd name="connsiteX39" fmla="*/ 0 w 850604"/>
              <a:gd name="connsiteY39" fmla="*/ 797442 h 79744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Lst>
            <a:rect l="l" t="t" r="r" b="b"/>
            <a:pathLst>
              <a:path w="850604" h="797442">
                <a:moveTo>
                  <a:pt x="850604" y="0"/>
                </a:moveTo>
                <a:cubicBezTo>
                  <a:pt x="813060" y="22527"/>
                  <a:pt x="832627" y="10214"/>
                  <a:pt x="792125" y="37214"/>
                </a:cubicBezTo>
                <a:lnTo>
                  <a:pt x="776176" y="47846"/>
                </a:lnTo>
                <a:cubicBezTo>
                  <a:pt x="758823" y="73878"/>
                  <a:pt x="774794" y="57668"/>
                  <a:pt x="744279" y="69111"/>
                </a:cubicBezTo>
                <a:cubicBezTo>
                  <a:pt x="736859" y="71894"/>
                  <a:pt x="730532" y="77238"/>
                  <a:pt x="723014" y="79744"/>
                </a:cubicBezTo>
                <a:cubicBezTo>
                  <a:pt x="709151" y="84365"/>
                  <a:pt x="694346" y="85756"/>
                  <a:pt x="680483" y="90377"/>
                </a:cubicBezTo>
                <a:cubicBezTo>
                  <a:pt x="640014" y="103866"/>
                  <a:pt x="659576" y="98811"/>
                  <a:pt x="622004" y="106325"/>
                </a:cubicBezTo>
                <a:cubicBezTo>
                  <a:pt x="581963" y="133020"/>
                  <a:pt x="632852" y="101676"/>
                  <a:pt x="584790" y="122274"/>
                </a:cubicBezTo>
                <a:cubicBezTo>
                  <a:pt x="578917" y="124791"/>
                  <a:pt x="574556" y="130049"/>
                  <a:pt x="568841" y="132907"/>
                </a:cubicBezTo>
                <a:cubicBezTo>
                  <a:pt x="563829" y="135413"/>
                  <a:pt x="558209" y="136451"/>
                  <a:pt x="552893" y="138223"/>
                </a:cubicBezTo>
                <a:lnTo>
                  <a:pt x="520995" y="159488"/>
                </a:lnTo>
                <a:cubicBezTo>
                  <a:pt x="515679" y="163032"/>
                  <a:pt x="509564" y="165603"/>
                  <a:pt x="505046" y="170121"/>
                </a:cubicBezTo>
                <a:cubicBezTo>
                  <a:pt x="484579" y="190588"/>
                  <a:pt x="495353" y="181900"/>
                  <a:pt x="473148" y="196702"/>
                </a:cubicBezTo>
                <a:cubicBezTo>
                  <a:pt x="469604" y="202018"/>
                  <a:pt x="466674" y="207800"/>
                  <a:pt x="462516" y="212651"/>
                </a:cubicBezTo>
                <a:cubicBezTo>
                  <a:pt x="445329" y="232703"/>
                  <a:pt x="444113" y="232008"/>
                  <a:pt x="425302" y="244549"/>
                </a:cubicBezTo>
                <a:cubicBezTo>
                  <a:pt x="423530" y="249865"/>
                  <a:pt x="423487" y="256122"/>
                  <a:pt x="419986" y="260498"/>
                </a:cubicBezTo>
                <a:cubicBezTo>
                  <a:pt x="415995" y="265487"/>
                  <a:pt x="409876" y="268535"/>
                  <a:pt x="404037" y="271130"/>
                </a:cubicBezTo>
                <a:cubicBezTo>
                  <a:pt x="378008" y="282698"/>
                  <a:pt x="374668" y="279941"/>
                  <a:pt x="350874" y="287079"/>
                </a:cubicBezTo>
                <a:cubicBezTo>
                  <a:pt x="340139" y="290299"/>
                  <a:pt x="318976" y="297711"/>
                  <a:pt x="318976" y="297711"/>
                </a:cubicBezTo>
                <a:cubicBezTo>
                  <a:pt x="313660" y="301255"/>
                  <a:pt x="307546" y="303826"/>
                  <a:pt x="303028" y="308344"/>
                </a:cubicBezTo>
                <a:cubicBezTo>
                  <a:pt x="289390" y="321983"/>
                  <a:pt x="288781" y="338642"/>
                  <a:pt x="281762" y="356191"/>
                </a:cubicBezTo>
                <a:cubicBezTo>
                  <a:pt x="278218" y="365051"/>
                  <a:pt x="275764" y="374430"/>
                  <a:pt x="271130" y="382772"/>
                </a:cubicBezTo>
                <a:cubicBezTo>
                  <a:pt x="257857" y="406664"/>
                  <a:pt x="255348" y="400646"/>
                  <a:pt x="239232" y="419986"/>
                </a:cubicBezTo>
                <a:cubicBezTo>
                  <a:pt x="235142" y="424894"/>
                  <a:pt x="232690" y="431027"/>
                  <a:pt x="228600" y="435935"/>
                </a:cubicBezTo>
                <a:cubicBezTo>
                  <a:pt x="223787" y="441711"/>
                  <a:pt x="217464" y="446108"/>
                  <a:pt x="212651" y="451884"/>
                </a:cubicBezTo>
                <a:cubicBezTo>
                  <a:pt x="208561" y="456792"/>
                  <a:pt x="206108" y="462924"/>
                  <a:pt x="202018" y="467832"/>
                </a:cubicBezTo>
                <a:cubicBezTo>
                  <a:pt x="197205" y="473608"/>
                  <a:pt x="191020" y="478123"/>
                  <a:pt x="186069" y="483781"/>
                </a:cubicBezTo>
                <a:cubicBezTo>
                  <a:pt x="178597" y="492321"/>
                  <a:pt x="172276" y="501823"/>
                  <a:pt x="164804" y="510363"/>
                </a:cubicBezTo>
                <a:cubicBezTo>
                  <a:pt x="159853" y="516021"/>
                  <a:pt x="153471" y="520377"/>
                  <a:pt x="148855" y="526311"/>
                </a:cubicBezTo>
                <a:cubicBezTo>
                  <a:pt x="141010" y="536398"/>
                  <a:pt x="127590" y="558209"/>
                  <a:pt x="127590" y="558209"/>
                </a:cubicBezTo>
                <a:cubicBezTo>
                  <a:pt x="125818" y="574158"/>
                  <a:pt x="126993" y="590718"/>
                  <a:pt x="122274" y="606056"/>
                </a:cubicBezTo>
                <a:cubicBezTo>
                  <a:pt x="119668" y="614525"/>
                  <a:pt x="111475" y="620111"/>
                  <a:pt x="106325" y="627321"/>
                </a:cubicBezTo>
                <a:cubicBezTo>
                  <a:pt x="102611" y="632520"/>
                  <a:pt x="100211" y="638752"/>
                  <a:pt x="95693" y="643270"/>
                </a:cubicBezTo>
                <a:cubicBezTo>
                  <a:pt x="91175" y="647788"/>
                  <a:pt x="84519" y="649657"/>
                  <a:pt x="79744" y="653902"/>
                </a:cubicBezTo>
                <a:cubicBezTo>
                  <a:pt x="68505" y="663892"/>
                  <a:pt x="47846" y="685800"/>
                  <a:pt x="47846" y="685800"/>
                </a:cubicBezTo>
                <a:cubicBezTo>
                  <a:pt x="46074" y="691116"/>
                  <a:pt x="43451" y="696221"/>
                  <a:pt x="42530" y="701749"/>
                </a:cubicBezTo>
                <a:cubicBezTo>
                  <a:pt x="39892" y="717577"/>
                  <a:pt x="43386" y="734783"/>
                  <a:pt x="37214" y="749595"/>
                </a:cubicBezTo>
                <a:cubicBezTo>
                  <a:pt x="33806" y="757774"/>
                  <a:pt x="23037" y="760228"/>
                  <a:pt x="15948" y="765544"/>
                </a:cubicBezTo>
                <a:cubicBezTo>
                  <a:pt x="12404" y="770860"/>
                  <a:pt x="8173" y="775778"/>
                  <a:pt x="5316" y="781493"/>
                </a:cubicBezTo>
                <a:cubicBezTo>
                  <a:pt x="2810" y="786505"/>
                  <a:pt x="0" y="797442"/>
                  <a:pt x="0" y="797442"/>
                </a:cubicBezTo>
              </a:path>
            </a:pathLst>
          </a:custGeom>
          <a:noFill/>
          <a:ln w="9525">
            <a:solidFill>
              <a:srgbClr val="FFFF0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50" name="Figura a mano libera 49"/>
          <p:cNvSpPr>
            <a:spLocks noChangeAspect="1"/>
          </p:cNvSpPr>
          <p:nvPr/>
        </p:nvSpPr>
        <p:spPr>
          <a:xfrm>
            <a:off x="5060804" y="1316986"/>
            <a:ext cx="924224" cy="837314"/>
          </a:xfrm>
          <a:custGeom>
            <a:avLst/>
            <a:gdLst>
              <a:gd name="connsiteX0" fmla="*/ 850604 w 850604"/>
              <a:gd name="connsiteY0" fmla="*/ 0 h 797442"/>
              <a:gd name="connsiteX1" fmla="*/ 792125 w 850604"/>
              <a:gd name="connsiteY1" fmla="*/ 37214 h 797442"/>
              <a:gd name="connsiteX2" fmla="*/ 776176 w 850604"/>
              <a:gd name="connsiteY2" fmla="*/ 47846 h 797442"/>
              <a:gd name="connsiteX3" fmla="*/ 744279 w 850604"/>
              <a:gd name="connsiteY3" fmla="*/ 69111 h 797442"/>
              <a:gd name="connsiteX4" fmla="*/ 723014 w 850604"/>
              <a:gd name="connsiteY4" fmla="*/ 79744 h 797442"/>
              <a:gd name="connsiteX5" fmla="*/ 680483 w 850604"/>
              <a:gd name="connsiteY5" fmla="*/ 90377 h 797442"/>
              <a:gd name="connsiteX6" fmla="*/ 622004 w 850604"/>
              <a:gd name="connsiteY6" fmla="*/ 106325 h 797442"/>
              <a:gd name="connsiteX7" fmla="*/ 584790 w 850604"/>
              <a:gd name="connsiteY7" fmla="*/ 122274 h 797442"/>
              <a:gd name="connsiteX8" fmla="*/ 568841 w 850604"/>
              <a:gd name="connsiteY8" fmla="*/ 132907 h 797442"/>
              <a:gd name="connsiteX9" fmla="*/ 552893 w 850604"/>
              <a:gd name="connsiteY9" fmla="*/ 138223 h 797442"/>
              <a:gd name="connsiteX10" fmla="*/ 520995 w 850604"/>
              <a:gd name="connsiteY10" fmla="*/ 159488 h 797442"/>
              <a:gd name="connsiteX11" fmla="*/ 505046 w 850604"/>
              <a:gd name="connsiteY11" fmla="*/ 170121 h 797442"/>
              <a:gd name="connsiteX12" fmla="*/ 473148 w 850604"/>
              <a:gd name="connsiteY12" fmla="*/ 196702 h 797442"/>
              <a:gd name="connsiteX13" fmla="*/ 462516 w 850604"/>
              <a:gd name="connsiteY13" fmla="*/ 212651 h 797442"/>
              <a:gd name="connsiteX14" fmla="*/ 425302 w 850604"/>
              <a:gd name="connsiteY14" fmla="*/ 244549 h 797442"/>
              <a:gd name="connsiteX15" fmla="*/ 419986 w 850604"/>
              <a:gd name="connsiteY15" fmla="*/ 260498 h 797442"/>
              <a:gd name="connsiteX16" fmla="*/ 404037 w 850604"/>
              <a:gd name="connsiteY16" fmla="*/ 271130 h 797442"/>
              <a:gd name="connsiteX17" fmla="*/ 350874 w 850604"/>
              <a:gd name="connsiteY17" fmla="*/ 287079 h 797442"/>
              <a:gd name="connsiteX18" fmla="*/ 318976 w 850604"/>
              <a:gd name="connsiteY18" fmla="*/ 297711 h 797442"/>
              <a:gd name="connsiteX19" fmla="*/ 303028 w 850604"/>
              <a:gd name="connsiteY19" fmla="*/ 308344 h 797442"/>
              <a:gd name="connsiteX20" fmla="*/ 281762 w 850604"/>
              <a:gd name="connsiteY20" fmla="*/ 356191 h 797442"/>
              <a:gd name="connsiteX21" fmla="*/ 271130 w 850604"/>
              <a:gd name="connsiteY21" fmla="*/ 382772 h 797442"/>
              <a:gd name="connsiteX22" fmla="*/ 239232 w 850604"/>
              <a:gd name="connsiteY22" fmla="*/ 419986 h 797442"/>
              <a:gd name="connsiteX23" fmla="*/ 228600 w 850604"/>
              <a:gd name="connsiteY23" fmla="*/ 435935 h 797442"/>
              <a:gd name="connsiteX24" fmla="*/ 212651 w 850604"/>
              <a:gd name="connsiteY24" fmla="*/ 451884 h 797442"/>
              <a:gd name="connsiteX25" fmla="*/ 202018 w 850604"/>
              <a:gd name="connsiteY25" fmla="*/ 467832 h 797442"/>
              <a:gd name="connsiteX26" fmla="*/ 186069 w 850604"/>
              <a:gd name="connsiteY26" fmla="*/ 483781 h 797442"/>
              <a:gd name="connsiteX27" fmla="*/ 164804 w 850604"/>
              <a:gd name="connsiteY27" fmla="*/ 510363 h 797442"/>
              <a:gd name="connsiteX28" fmla="*/ 148855 w 850604"/>
              <a:gd name="connsiteY28" fmla="*/ 526311 h 797442"/>
              <a:gd name="connsiteX29" fmla="*/ 127590 w 850604"/>
              <a:gd name="connsiteY29" fmla="*/ 558209 h 797442"/>
              <a:gd name="connsiteX30" fmla="*/ 122274 w 850604"/>
              <a:gd name="connsiteY30" fmla="*/ 606056 h 797442"/>
              <a:gd name="connsiteX31" fmla="*/ 106325 w 850604"/>
              <a:gd name="connsiteY31" fmla="*/ 627321 h 797442"/>
              <a:gd name="connsiteX32" fmla="*/ 95693 w 850604"/>
              <a:gd name="connsiteY32" fmla="*/ 643270 h 797442"/>
              <a:gd name="connsiteX33" fmla="*/ 79744 w 850604"/>
              <a:gd name="connsiteY33" fmla="*/ 653902 h 797442"/>
              <a:gd name="connsiteX34" fmla="*/ 47846 w 850604"/>
              <a:gd name="connsiteY34" fmla="*/ 685800 h 797442"/>
              <a:gd name="connsiteX35" fmla="*/ 42530 w 850604"/>
              <a:gd name="connsiteY35" fmla="*/ 701749 h 797442"/>
              <a:gd name="connsiteX36" fmla="*/ 37214 w 850604"/>
              <a:gd name="connsiteY36" fmla="*/ 749595 h 797442"/>
              <a:gd name="connsiteX37" fmla="*/ 15948 w 850604"/>
              <a:gd name="connsiteY37" fmla="*/ 765544 h 797442"/>
              <a:gd name="connsiteX38" fmla="*/ 5316 w 850604"/>
              <a:gd name="connsiteY38" fmla="*/ 781493 h 797442"/>
              <a:gd name="connsiteX39" fmla="*/ 0 w 850604"/>
              <a:gd name="connsiteY39" fmla="*/ 797442 h 79744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Lst>
            <a:rect l="l" t="t" r="r" b="b"/>
            <a:pathLst>
              <a:path w="850604" h="797442">
                <a:moveTo>
                  <a:pt x="850604" y="0"/>
                </a:moveTo>
                <a:cubicBezTo>
                  <a:pt x="813060" y="22527"/>
                  <a:pt x="832627" y="10214"/>
                  <a:pt x="792125" y="37214"/>
                </a:cubicBezTo>
                <a:lnTo>
                  <a:pt x="776176" y="47846"/>
                </a:lnTo>
                <a:cubicBezTo>
                  <a:pt x="758823" y="73878"/>
                  <a:pt x="774794" y="57668"/>
                  <a:pt x="744279" y="69111"/>
                </a:cubicBezTo>
                <a:cubicBezTo>
                  <a:pt x="736859" y="71894"/>
                  <a:pt x="730532" y="77238"/>
                  <a:pt x="723014" y="79744"/>
                </a:cubicBezTo>
                <a:cubicBezTo>
                  <a:pt x="709151" y="84365"/>
                  <a:pt x="694346" y="85756"/>
                  <a:pt x="680483" y="90377"/>
                </a:cubicBezTo>
                <a:cubicBezTo>
                  <a:pt x="640014" y="103866"/>
                  <a:pt x="659576" y="98811"/>
                  <a:pt x="622004" y="106325"/>
                </a:cubicBezTo>
                <a:cubicBezTo>
                  <a:pt x="581963" y="133020"/>
                  <a:pt x="632852" y="101676"/>
                  <a:pt x="584790" y="122274"/>
                </a:cubicBezTo>
                <a:cubicBezTo>
                  <a:pt x="578917" y="124791"/>
                  <a:pt x="574556" y="130049"/>
                  <a:pt x="568841" y="132907"/>
                </a:cubicBezTo>
                <a:cubicBezTo>
                  <a:pt x="563829" y="135413"/>
                  <a:pt x="558209" y="136451"/>
                  <a:pt x="552893" y="138223"/>
                </a:cubicBezTo>
                <a:lnTo>
                  <a:pt x="520995" y="159488"/>
                </a:lnTo>
                <a:cubicBezTo>
                  <a:pt x="515679" y="163032"/>
                  <a:pt x="509564" y="165603"/>
                  <a:pt x="505046" y="170121"/>
                </a:cubicBezTo>
                <a:cubicBezTo>
                  <a:pt x="484579" y="190588"/>
                  <a:pt x="495353" y="181900"/>
                  <a:pt x="473148" y="196702"/>
                </a:cubicBezTo>
                <a:cubicBezTo>
                  <a:pt x="469604" y="202018"/>
                  <a:pt x="466674" y="207800"/>
                  <a:pt x="462516" y="212651"/>
                </a:cubicBezTo>
                <a:cubicBezTo>
                  <a:pt x="445329" y="232703"/>
                  <a:pt x="444113" y="232008"/>
                  <a:pt x="425302" y="244549"/>
                </a:cubicBezTo>
                <a:cubicBezTo>
                  <a:pt x="423530" y="249865"/>
                  <a:pt x="423487" y="256122"/>
                  <a:pt x="419986" y="260498"/>
                </a:cubicBezTo>
                <a:cubicBezTo>
                  <a:pt x="415995" y="265487"/>
                  <a:pt x="409876" y="268535"/>
                  <a:pt x="404037" y="271130"/>
                </a:cubicBezTo>
                <a:cubicBezTo>
                  <a:pt x="378008" y="282698"/>
                  <a:pt x="374668" y="279941"/>
                  <a:pt x="350874" y="287079"/>
                </a:cubicBezTo>
                <a:cubicBezTo>
                  <a:pt x="340139" y="290299"/>
                  <a:pt x="318976" y="297711"/>
                  <a:pt x="318976" y="297711"/>
                </a:cubicBezTo>
                <a:cubicBezTo>
                  <a:pt x="313660" y="301255"/>
                  <a:pt x="307546" y="303826"/>
                  <a:pt x="303028" y="308344"/>
                </a:cubicBezTo>
                <a:cubicBezTo>
                  <a:pt x="289390" y="321983"/>
                  <a:pt x="288781" y="338642"/>
                  <a:pt x="281762" y="356191"/>
                </a:cubicBezTo>
                <a:cubicBezTo>
                  <a:pt x="278218" y="365051"/>
                  <a:pt x="275764" y="374430"/>
                  <a:pt x="271130" y="382772"/>
                </a:cubicBezTo>
                <a:cubicBezTo>
                  <a:pt x="257857" y="406664"/>
                  <a:pt x="255348" y="400646"/>
                  <a:pt x="239232" y="419986"/>
                </a:cubicBezTo>
                <a:cubicBezTo>
                  <a:pt x="235142" y="424894"/>
                  <a:pt x="232690" y="431027"/>
                  <a:pt x="228600" y="435935"/>
                </a:cubicBezTo>
                <a:cubicBezTo>
                  <a:pt x="223787" y="441711"/>
                  <a:pt x="217464" y="446108"/>
                  <a:pt x="212651" y="451884"/>
                </a:cubicBezTo>
                <a:cubicBezTo>
                  <a:pt x="208561" y="456792"/>
                  <a:pt x="206108" y="462924"/>
                  <a:pt x="202018" y="467832"/>
                </a:cubicBezTo>
                <a:cubicBezTo>
                  <a:pt x="197205" y="473608"/>
                  <a:pt x="191020" y="478123"/>
                  <a:pt x="186069" y="483781"/>
                </a:cubicBezTo>
                <a:cubicBezTo>
                  <a:pt x="178597" y="492321"/>
                  <a:pt x="172276" y="501823"/>
                  <a:pt x="164804" y="510363"/>
                </a:cubicBezTo>
                <a:cubicBezTo>
                  <a:pt x="159853" y="516021"/>
                  <a:pt x="153471" y="520377"/>
                  <a:pt x="148855" y="526311"/>
                </a:cubicBezTo>
                <a:cubicBezTo>
                  <a:pt x="141010" y="536398"/>
                  <a:pt x="127590" y="558209"/>
                  <a:pt x="127590" y="558209"/>
                </a:cubicBezTo>
                <a:cubicBezTo>
                  <a:pt x="125818" y="574158"/>
                  <a:pt x="126993" y="590718"/>
                  <a:pt x="122274" y="606056"/>
                </a:cubicBezTo>
                <a:cubicBezTo>
                  <a:pt x="119668" y="614525"/>
                  <a:pt x="111475" y="620111"/>
                  <a:pt x="106325" y="627321"/>
                </a:cubicBezTo>
                <a:cubicBezTo>
                  <a:pt x="102611" y="632520"/>
                  <a:pt x="100211" y="638752"/>
                  <a:pt x="95693" y="643270"/>
                </a:cubicBezTo>
                <a:cubicBezTo>
                  <a:pt x="91175" y="647788"/>
                  <a:pt x="84519" y="649657"/>
                  <a:pt x="79744" y="653902"/>
                </a:cubicBezTo>
                <a:cubicBezTo>
                  <a:pt x="68505" y="663892"/>
                  <a:pt x="47846" y="685800"/>
                  <a:pt x="47846" y="685800"/>
                </a:cubicBezTo>
                <a:cubicBezTo>
                  <a:pt x="46074" y="691116"/>
                  <a:pt x="43451" y="696221"/>
                  <a:pt x="42530" y="701749"/>
                </a:cubicBezTo>
                <a:cubicBezTo>
                  <a:pt x="39892" y="717577"/>
                  <a:pt x="43386" y="734783"/>
                  <a:pt x="37214" y="749595"/>
                </a:cubicBezTo>
                <a:cubicBezTo>
                  <a:pt x="33806" y="757774"/>
                  <a:pt x="23037" y="760228"/>
                  <a:pt x="15948" y="765544"/>
                </a:cubicBezTo>
                <a:cubicBezTo>
                  <a:pt x="12404" y="770860"/>
                  <a:pt x="8173" y="775778"/>
                  <a:pt x="5316" y="781493"/>
                </a:cubicBezTo>
                <a:cubicBezTo>
                  <a:pt x="2810" y="786505"/>
                  <a:pt x="0" y="797442"/>
                  <a:pt x="0" y="797442"/>
                </a:cubicBezTo>
              </a:path>
            </a:pathLst>
          </a:custGeom>
          <a:noFill/>
          <a:ln w="9525">
            <a:solidFill>
              <a:srgbClr val="FFFF00"/>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51" name="CasellaDiTesto 50"/>
          <p:cNvSpPr txBox="1"/>
          <p:nvPr/>
        </p:nvSpPr>
        <p:spPr>
          <a:xfrm>
            <a:off x="1351758" y="1789266"/>
            <a:ext cx="277640" cy="246221"/>
          </a:xfrm>
          <a:prstGeom prst="rect">
            <a:avLst/>
          </a:prstGeom>
          <a:noFill/>
        </p:spPr>
        <p:txBody>
          <a:bodyPr wrap="none" rtlCol="0">
            <a:spAutoFit/>
          </a:bodyPr>
          <a:lstStyle/>
          <a:p>
            <a:pPr algn="ctr"/>
            <a:r>
              <a:rPr lang="it-IT" sz="1000" b="1" dirty="0" smtClean="0">
                <a:solidFill>
                  <a:srgbClr val="FFFF00"/>
                </a:solidFill>
              </a:rPr>
              <a:t>N</a:t>
            </a:r>
            <a:endParaRPr lang="it-IT" sz="1000" b="1" dirty="0">
              <a:solidFill>
                <a:srgbClr val="FFFF00"/>
              </a:solidFill>
            </a:endParaRPr>
          </a:p>
        </p:txBody>
      </p:sp>
    </p:spTree>
    <p:extLst>
      <p:ext uri="{BB962C8B-B14F-4D97-AF65-F5344CB8AC3E}">
        <p14:creationId xmlns:p14="http://schemas.microsoft.com/office/powerpoint/2010/main" val="559093232"/>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4" name="Immagine 53"/>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96703" y="976381"/>
            <a:ext cx="1260000" cy="1260000"/>
          </a:xfrm>
          <a:prstGeom prst="rect">
            <a:avLst/>
          </a:prstGeom>
        </p:spPr>
      </p:pic>
      <p:pic>
        <p:nvPicPr>
          <p:cNvPr id="55" name="Immagine 54"/>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160676" y="978095"/>
            <a:ext cx="1260000" cy="1260000"/>
          </a:xfrm>
          <a:prstGeom prst="rect">
            <a:avLst/>
          </a:prstGeom>
        </p:spPr>
      </p:pic>
      <p:cxnSp>
        <p:nvCxnSpPr>
          <p:cNvPr id="57" name="Connettore 1 56"/>
          <p:cNvCxnSpPr/>
          <p:nvPr/>
        </p:nvCxnSpPr>
        <p:spPr>
          <a:xfrm>
            <a:off x="1734928" y="882225"/>
            <a:ext cx="414000"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58" name="Connettore 1 57"/>
          <p:cNvCxnSpPr/>
          <p:nvPr/>
        </p:nvCxnSpPr>
        <p:spPr>
          <a:xfrm>
            <a:off x="3707374" y="881939"/>
            <a:ext cx="396000"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sp>
        <p:nvSpPr>
          <p:cNvPr id="60" name="Text Box 20"/>
          <p:cNvSpPr txBox="1">
            <a:spLocks noChangeArrowheads="1"/>
          </p:cNvSpPr>
          <p:nvPr/>
        </p:nvSpPr>
        <p:spPr bwMode="auto">
          <a:xfrm>
            <a:off x="4098842" y="675609"/>
            <a:ext cx="702435"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pPr algn="ctr">
              <a:defRPr/>
            </a:pPr>
            <a:r>
              <a:rPr lang="it-IT" altLang="it-IT" sz="1000" dirty="0" smtClean="0">
                <a:latin typeface="Arial" panose="020B0604020202020204" pitchFamily="34" charset="0"/>
                <a:cs typeface="Arial" panose="020B0604020202020204" pitchFamily="34" charset="0"/>
              </a:rPr>
              <a:t>IL-33 EO</a:t>
            </a:r>
            <a:endParaRPr lang="it-IT" altLang="it-IT" sz="1000" dirty="0">
              <a:latin typeface="Arial" panose="020B0604020202020204" pitchFamily="34" charset="0"/>
              <a:cs typeface="Arial" panose="020B0604020202020204" pitchFamily="34" charset="0"/>
            </a:endParaRPr>
          </a:p>
        </p:txBody>
      </p:sp>
      <p:sp>
        <p:nvSpPr>
          <p:cNvPr id="61" name="Text Box 28"/>
          <p:cNvSpPr txBox="1">
            <a:spLocks noChangeArrowheads="1"/>
          </p:cNvSpPr>
          <p:nvPr/>
        </p:nvSpPr>
        <p:spPr bwMode="auto">
          <a:xfrm>
            <a:off x="1290463" y="673119"/>
            <a:ext cx="990892"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p>
            <a:pPr algn="ctr">
              <a:defRPr/>
            </a:pPr>
            <a:r>
              <a:rPr lang="it-IT" altLang="it-IT" sz="1000" dirty="0" smtClean="0">
                <a:latin typeface="Arial" panose="020B0604020202020204" pitchFamily="34" charset="0"/>
                <a:cs typeface="Arial" panose="020B0604020202020204" pitchFamily="34" charset="0"/>
              </a:rPr>
              <a:t>IL-5 EO</a:t>
            </a:r>
            <a:endParaRPr lang="it-IT" altLang="it-IT" sz="1000" dirty="0">
              <a:latin typeface="Arial" panose="020B0604020202020204" pitchFamily="34" charset="0"/>
              <a:cs typeface="Arial" panose="020B0604020202020204" pitchFamily="34" charset="0"/>
            </a:endParaRPr>
          </a:p>
        </p:txBody>
      </p:sp>
      <p:cxnSp>
        <p:nvCxnSpPr>
          <p:cNvPr id="62" name="Connettore 1 61"/>
          <p:cNvCxnSpPr/>
          <p:nvPr/>
        </p:nvCxnSpPr>
        <p:spPr>
          <a:xfrm>
            <a:off x="3618445" y="914467"/>
            <a:ext cx="16383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3" name="Connettore 1 62"/>
          <p:cNvCxnSpPr/>
          <p:nvPr/>
        </p:nvCxnSpPr>
        <p:spPr>
          <a:xfrm>
            <a:off x="957724" y="919331"/>
            <a:ext cx="16383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66" name="Text Box 28"/>
          <p:cNvSpPr txBox="1">
            <a:spLocks noChangeArrowheads="1"/>
          </p:cNvSpPr>
          <p:nvPr/>
        </p:nvSpPr>
        <p:spPr bwMode="auto">
          <a:xfrm rot="16200000">
            <a:off x="-125807" y="1509027"/>
            <a:ext cx="990892"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p>
            <a:pPr algn="ctr">
              <a:defRPr/>
            </a:pPr>
            <a:r>
              <a:rPr lang="it-IT" altLang="it-IT" sz="1000" dirty="0" smtClean="0">
                <a:latin typeface="Arial" panose="020B0604020202020204" pitchFamily="34" charset="0"/>
                <a:cs typeface="Arial" panose="020B0604020202020204" pitchFamily="34" charset="0"/>
              </a:rPr>
              <a:t>CD11b</a:t>
            </a:r>
            <a:endParaRPr lang="it-IT" altLang="it-IT" sz="1000" dirty="0">
              <a:latin typeface="Arial" panose="020B0604020202020204" pitchFamily="34" charset="0"/>
              <a:cs typeface="Arial" panose="020B0604020202020204" pitchFamily="34" charset="0"/>
            </a:endParaRPr>
          </a:p>
        </p:txBody>
      </p:sp>
      <p:pic>
        <p:nvPicPr>
          <p:cNvPr id="68" name="Immagine 67"/>
          <p:cNvPicPr>
            <a:picLocks/>
          </p:cNvPicPr>
          <p:nvPr/>
        </p:nvPicPr>
        <p:blipFill>
          <a:blip r:embed="rId5" cstate="print">
            <a:extLst>
              <a:ext uri="{BEBA8EAE-BF5A-486C-A8C5-ECC9F3942E4B}">
                <a14:imgProps xmlns:a14="http://schemas.microsoft.com/office/drawing/2010/main">
                  <a14:imgLayer r:embed="rId6">
                    <a14:imgEffect>
                      <a14:brightnessContrast bright="28000" contrast="9000"/>
                    </a14:imgEffect>
                  </a14:imgLayer>
                </a14:imgProps>
              </a:ext>
              <a:ext uri="{28A0092B-C50C-407E-A947-70E740481C1C}">
                <a14:useLocalDpi xmlns:a14="http://schemas.microsoft.com/office/drawing/2010/main" val="0"/>
              </a:ext>
            </a:extLst>
          </a:blip>
          <a:stretch>
            <a:fillRect/>
          </a:stretch>
        </p:blipFill>
        <p:spPr>
          <a:xfrm>
            <a:off x="496703" y="2277778"/>
            <a:ext cx="1260000" cy="1260000"/>
          </a:xfrm>
          <a:prstGeom prst="rect">
            <a:avLst/>
          </a:prstGeom>
        </p:spPr>
      </p:pic>
      <p:pic>
        <p:nvPicPr>
          <p:cNvPr id="71" name="Immagine 70"/>
          <p:cNvPicPr>
            <a:picLocks/>
          </p:cNvPicPr>
          <p:nvPr/>
        </p:nvPicPr>
        <p:blipFill>
          <a:blip r:embed="rId7" cstate="print">
            <a:extLst>
              <a:ext uri="{BEBA8EAE-BF5A-486C-A8C5-ECC9F3942E4B}">
                <a14:imgProps xmlns:a14="http://schemas.microsoft.com/office/drawing/2010/main">
                  <a14:imgLayer r:embed="rId8">
                    <a14:imgEffect>
                      <a14:brightnessContrast bright="8000" contrast="5000"/>
                    </a14:imgEffect>
                  </a14:imgLayer>
                </a14:imgProps>
              </a:ext>
              <a:ext uri="{28A0092B-C50C-407E-A947-70E740481C1C}">
                <a14:useLocalDpi xmlns:a14="http://schemas.microsoft.com/office/drawing/2010/main" val="0"/>
              </a:ext>
            </a:extLst>
          </a:blip>
          <a:stretch>
            <a:fillRect/>
          </a:stretch>
        </p:blipFill>
        <p:spPr>
          <a:xfrm>
            <a:off x="3164274" y="2277778"/>
            <a:ext cx="1260000" cy="1260000"/>
          </a:xfrm>
          <a:prstGeom prst="rect">
            <a:avLst/>
          </a:prstGeom>
        </p:spPr>
      </p:pic>
      <p:sp>
        <p:nvSpPr>
          <p:cNvPr id="72" name="Text Box 28"/>
          <p:cNvSpPr txBox="1">
            <a:spLocks noChangeArrowheads="1"/>
          </p:cNvSpPr>
          <p:nvPr/>
        </p:nvSpPr>
        <p:spPr bwMode="auto">
          <a:xfrm rot="16200000">
            <a:off x="-126250" y="2788974"/>
            <a:ext cx="990892"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p>
            <a:pPr algn="ctr">
              <a:defRPr/>
            </a:pPr>
            <a:r>
              <a:rPr lang="it-IT" altLang="it-IT" sz="1000" dirty="0" smtClean="0">
                <a:latin typeface="Arial" panose="020B0604020202020204" pitchFamily="34" charset="0"/>
                <a:cs typeface="Arial" panose="020B0604020202020204" pitchFamily="34" charset="0"/>
              </a:rPr>
              <a:t>ICAM-1</a:t>
            </a:r>
            <a:endParaRPr lang="it-IT" altLang="it-IT" sz="1000" dirty="0">
              <a:latin typeface="Arial" panose="020B0604020202020204" pitchFamily="34" charset="0"/>
              <a:cs typeface="Arial" panose="020B0604020202020204" pitchFamily="34" charset="0"/>
            </a:endParaRPr>
          </a:p>
        </p:txBody>
      </p:sp>
      <p:pic>
        <p:nvPicPr>
          <p:cNvPr id="53" name="Immagine 52"/>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1785526" y="976381"/>
            <a:ext cx="1260000" cy="1260000"/>
          </a:xfrm>
          <a:prstGeom prst="rect">
            <a:avLst/>
          </a:prstGeom>
        </p:spPr>
      </p:pic>
      <p:sp>
        <p:nvSpPr>
          <p:cNvPr id="59" name="CasellaDiTesto 42"/>
          <p:cNvSpPr txBox="1">
            <a:spLocks noChangeArrowheads="1"/>
          </p:cNvSpPr>
          <p:nvPr/>
        </p:nvSpPr>
        <p:spPr bwMode="auto">
          <a:xfrm>
            <a:off x="1761382" y="963495"/>
            <a:ext cx="78419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it-IT" altLang="it-IT" sz="800" b="1" dirty="0" smtClean="0">
                <a:solidFill>
                  <a:srgbClr val="FF0000"/>
                </a:solidFill>
              </a:rPr>
              <a:t>CD11b</a:t>
            </a:r>
            <a:r>
              <a:rPr lang="it-IT" altLang="it-IT" sz="800" b="1" dirty="0" smtClean="0">
                <a:solidFill>
                  <a:srgbClr val="00B050"/>
                </a:solidFill>
              </a:rPr>
              <a:t> </a:t>
            </a:r>
            <a:r>
              <a:rPr lang="it-IT" altLang="it-IT" sz="800" b="1" dirty="0" smtClean="0">
                <a:solidFill>
                  <a:srgbClr val="0070C0"/>
                </a:solidFill>
              </a:rPr>
              <a:t>DAPI</a:t>
            </a:r>
            <a:endParaRPr lang="it-IT" altLang="it-IT" sz="800" b="1" dirty="0">
              <a:solidFill>
                <a:srgbClr val="0070C0"/>
              </a:solidFill>
            </a:endParaRPr>
          </a:p>
        </p:txBody>
      </p:sp>
      <p:cxnSp>
        <p:nvCxnSpPr>
          <p:cNvPr id="85" name="Connettore 1 84"/>
          <p:cNvCxnSpPr/>
          <p:nvPr/>
        </p:nvCxnSpPr>
        <p:spPr>
          <a:xfrm>
            <a:off x="2651093" y="2195789"/>
            <a:ext cx="334800"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pic>
        <p:nvPicPr>
          <p:cNvPr id="56" name="Immagine 55"/>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4452991" y="976381"/>
            <a:ext cx="1260000" cy="1260000"/>
          </a:xfrm>
          <a:prstGeom prst="rect">
            <a:avLst/>
          </a:prstGeom>
        </p:spPr>
      </p:pic>
      <p:sp>
        <p:nvSpPr>
          <p:cNvPr id="65" name="CasellaDiTesto 42"/>
          <p:cNvSpPr txBox="1">
            <a:spLocks noChangeArrowheads="1"/>
          </p:cNvSpPr>
          <p:nvPr/>
        </p:nvSpPr>
        <p:spPr bwMode="auto">
          <a:xfrm>
            <a:off x="4416881" y="955732"/>
            <a:ext cx="784190"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it-IT" altLang="it-IT" sz="800" b="1" dirty="0" smtClean="0">
                <a:solidFill>
                  <a:srgbClr val="FF0000"/>
                </a:solidFill>
              </a:rPr>
              <a:t>CD11b</a:t>
            </a:r>
            <a:r>
              <a:rPr lang="it-IT" altLang="it-IT" sz="800" b="1" dirty="0" smtClean="0">
                <a:solidFill>
                  <a:srgbClr val="00B050"/>
                </a:solidFill>
              </a:rPr>
              <a:t> </a:t>
            </a:r>
            <a:r>
              <a:rPr lang="it-IT" altLang="it-IT" sz="800" b="1" dirty="0" smtClean="0">
                <a:solidFill>
                  <a:srgbClr val="0070C0"/>
                </a:solidFill>
              </a:rPr>
              <a:t>DAPI</a:t>
            </a:r>
            <a:endParaRPr lang="it-IT" altLang="it-IT" sz="800" b="1" dirty="0">
              <a:solidFill>
                <a:srgbClr val="0070C0"/>
              </a:solidFill>
            </a:endParaRPr>
          </a:p>
        </p:txBody>
      </p:sp>
      <p:cxnSp>
        <p:nvCxnSpPr>
          <p:cNvPr id="89" name="Connettore 1 88"/>
          <p:cNvCxnSpPr/>
          <p:nvPr/>
        </p:nvCxnSpPr>
        <p:spPr>
          <a:xfrm>
            <a:off x="5321429" y="2195789"/>
            <a:ext cx="334800"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pic>
        <p:nvPicPr>
          <p:cNvPr id="67" name="Immagine 66"/>
          <p:cNvPicPr>
            <a:picLocks/>
          </p:cNvPicPr>
          <p:nvPr/>
        </p:nvPicPr>
        <p:blipFill>
          <a:blip r:embed="rId11" cstate="print">
            <a:extLst>
              <a:ext uri="{BEBA8EAE-BF5A-486C-A8C5-ECC9F3942E4B}">
                <a14:imgProps xmlns:a14="http://schemas.microsoft.com/office/drawing/2010/main">
                  <a14:imgLayer r:embed="rId12">
                    <a14:imgEffect>
                      <a14:brightnessContrast bright="9000" contrast="8000"/>
                    </a14:imgEffect>
                  </a14:imgLayer>
                </a14:imgProps>
              </a:ext>
              <a:ext uri="{28A0092B-C50C-407E-A947-70E740481C1C}">
                <a14:useLocalDpi xmlns:a14="http://schemas.microsoft.com/office/drawing/2010/main" val="0"/>
              </a:ext>
            </a:extLst>
          </a:blip>
          <a:stretch>
            <a:fillRect/>
          </a:stretch>
        </p:blipFill>
        <p:spPr>
          <a:xfrm>
            <a:off x="1785014" y="2277778"/>
            <a:ext cx="1260000" cy="1260000"/>
          </a:xfrm>
          <a:prstGeom prst="rect">
            <a:avLst/>
          </a:prstGeom>
        </p:spPr>
      </p:pic>
      <p:sp>
        <p:nvSpPr>
          <p:cNvPr id="73" name="CasellaDiTesto 42"/>
          <p:cNvSpPr txBox="1">
            <a:spLocks noChangeArrowheads="1"/>
          </p:cNvSpPr>
          <p:nvPr/>
        </p:nvSpPr>
        <p:spPr bwMode="auto">
          <a:xfrm>
            <a:off x="1725954" y="2254510"/>
            <a:ext cx="811441"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it-IT" altLang="it-IT" sz="800" b="1" dirty="0" smtClean="0">
                <a:solidFill>
                  <a:srgbClr val="FF0000"/>
                </a:solidFill>
              </a:rPr>
              <a:t>ICAM-1</a:t>
            </a:r>
            <a:r>
              <a:rPr lang="it-IT" altLang="it-IT" sz="800" b="1" dirty="0" smtClean="0">
                <a:solidFill>
                  <a:srgbClr val="00B050"/>
                </a:solidFill>
              </a:rPr>
              <a:t> </a:t>
            </a:r>
            <a:r>
              <a:rPr lang="it-IT" altLang="it-IT" sz="800" b="1" dirty="0" smtClean="0">
                <a:solidFill>
                  <a:srgbClr val="0070C0"/>
                </a:solidFill>
              </a:rPr>
              <a:t>DAPI</a:t>
            </a:r>
            <a:endParaRPr lang="it-IT" altLang="it-IT" sz="800" b="1" dirty="0">
              <a:solidFill>
                <a:srgbClr val="0070C0"/>
              </a:solidFill>
            </a:endParaRPr>
          </a:p>
        </p:txBody>
      </p:sp>
      <p:cxnSp>
        <p:nvCxnSpPr>
          <p:cNvPr id="90" name="Connettore 1 89"/>
          <p:cNvCxnSpPr/>
          <p:nvPr/>
        </p:nvCxnSpPr>
        <p:spPr>
          <a:xfrm>
            <a:off x="2701493" y="3486753"/>
            <a:ext cx="284400"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pic>
        <p:nvPicPr>
          <p:cNvPr id="70" name="Immagine 69"/>
          <p:cNvPicPr>
            <a:picLocks/>
          </p:cNvPicPr>
          <p:nvPr/>
        </p:nvPicPr>
        <p:blipFill>
          <a:blip r:embed="rId13" cstate="print">
            <a:extLst>
              <a:ext uri="{BEBA8EAE-BF5A-486C-A8C5-ECC9F3942E4B}">
                <a14:imgProps xmlns:a14="http://schemas.microsoft.com/office/drawing/2010/main">
                  <a14:imgLayer r:embed="rId14">
                    <a14:imgEffect>
                      <a14:brightnessContrast bright="8000" contrast="8000"/>
                    </a14:imgEffect>
                  </a14:imgLayer>
                </a14:imgProps>
              </a:ext>
              <a:ext uri="{28A0092B-C50C-407E-A947-70E740481C1C}">
                <a14:useLocalDpi xmlns:a14="http://schemas.microsoft.com/office/drawing/2010/main" val="0"/>
              </a:ext>
            </a:extLst>
          </a:blip>
          <a:stretch>
            <a:fillRect/>
          </a:stretch>
        </p:blipFill>
        <p:spPr>
          <a:xfrm>
            <a:off x="4452991" y="2277778"/>
            <a:ext cx="1260000" cy="1260000"/>
          </a:xfrm>
          <a:prstGeom prst="rect">
            <a:avLst/>
          </a:prstGeom>
        </p:spPr>
      </p:pic>
      <p:sp>
        <p:nvSpPr>
          <p:cNvPr id="74" name="CasellaDiTesto 42"/>
          <p:cNvSpPr txBox="1">
            <a:spLocks noChangeArrowheads="1"/>
          </p:cNvSpPr>
          <p:nvPr/>
        </p:nvSpPr>
        <p:spPr bwMode="auto">
          <a:xfrm>
            <a:off x="4481822" y="2268723"/>
            <a:ext cx="811441"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it-IT" altLang="it-IT" sz="800" b="1" dirty="0" smtClean="0">
                <a:solidFill>
                  <a:srgbClr val="FF0000"/>
                </a:solidFill>
              </a:rPr>
              <a:t>ICAM-1</a:t>
            </a:r>
            <a:r>
              <a:rPr lang="it-IT" altLang="it-IT" sz="800" b="1" dirty="0" smtClean="0">
                <a:solidFill>
                  <a:srgbClr val="00B050"/>
                </a:solidFill>
              </a:rPr>
              <a:t> </a:t>
            </a:r>
            <a:r>
              <a:rPr lang="it-IT" altLang="it-IT" sz="800" b="1" dirty="0" smtClean="0">
                <a:solidFill>
                  <a:srgbClr val="0070C0"/>
                </a:solidFill>
              </a:rPr>
              <a:t>DAPI</a:t>
            </a:r>
            <a:endParaRPr lang="it-IT" altLang="it-IT" sz="800" b="1" dirty="0">
              <a:solidFill>
                <a:srgbClr val="0070C0"/>
              </a:solidFill>
            </a:endParaRPr>
          </a:p>
        </p:txBody>
      </p:sp>
      <p:cxnSp>
        <p:nvCxnSpPr>
          <p:cNvPr id="91" name="Connettore 1 90"/>
          <p:cNvCxnSpPr/>
          <p:nvPr/>
        </p:nvCxnSpPr>
        <p:spPr>
          <a:xfrm>
            <a:off x="5371829" y="3486753"/>
            <a:ext cx="284400"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sp>
        <p:nvSpPr>
          <p:cNvPr id="28" name="Rettangolo 27"/>
          <p:cNvSpPr/>
          <p:nvPr/>
        </p:nvSpPr>
        <p:spPr>
          <a:xfrm>
            <a:off x="39448" y="3975016"/>
            <a:ext cx="6063569" cy="707886"/>
          </a:xfrm>
          <a:prstGeom prst="rect">
            <a:avLst/>
          </a:prstGeom>
        </p:spPr>
        <p:txBody>
          <a:bodyPr wrap="square">
            <a:spAutoFit/>
          </a:bodyPr>
          <a:lstStyle/>
          <a:p>
            <a:pPr algn="just"/>
            <a:r>
              <a:rPr lang="en-US" sz="1000" b="1" dirty="0" smtClean="0">
                <a:latin typeface="Arial" panose="020B0604020202020204" pitchFamily="34" charset="0"/>
                <a:cs typeface="Arial" panose="020B0604020202020204" pitchFamily="34" charset="0"/>
              </a:rPr>
              <a:t>Figure S8</a:t>
            </a:r>
            <a:r>
              <a:rPr lang="en-US" sz="1000" b="1" dirty="0" smtClean="0">
                <a:latin typeface="Arial" panose="020B0604020202020204" pitchFamily="34" charset="0"/>
                <a:cs typeface="Arial" panose="020B0604020202020204" pitchFamily="34" charset="0"/>
              </a:rPr>
              <a:t>.</a:t>
            </a:r>
            <a:r>
              <a:rPr lang="en-US" sz="1000" dirty="0" smtClean="0">
                <a:latin typeface="Arial" panose="020B0604020202020204" pitchFamily="34" charset="0"/>
                <a:cs typeface="Arial" panose="020B0604020202020204" pitchFamily="34" charset="0"/>
              </a:rPr>
              <a:t> </a:t>
            </a:r>
            <a:r>
              <a:rPr lang="en-US" sz="1000" b="1" dirty="0" smtClean="0">
                <a:latin typeface="Arial" panose="020B0604020202020204" pitchFamily="34" charset="0"/>
                <a:cs typeface="Arial" panose="020B0604020202020204" pitchFamily="34" charset="0"/>
              </a:rPr>
              <a:t>Detection of </a:t>
            </a:r>
            <a:r>
              <a:rPr lang="en-US" sz="1000" b="1" dirty="0">
                <a:latin typeface="Arial" panose="020B0604020202020204" pitchFamily="34" charset="0"/>
                <a:cs typeface="Arial" panose="020B0604020202020204" pitchFamily="34" charset="0"/>
              </a:rPr>
              <a:t>CD11b and ICAM-1 </a:t>
            </a:r>
            <a:r>
              <a:rPr lang="en-US" sz="1000" b="1" dirty="0" smtClean="0">
                <a:latin typeface="Arial" panose="020B0604020202020204" pitchFamily="34" charset="0"/>
                <a:cs typeface="Arial" panose="020B0604020202020204" pitchFamily="34" charset="0"/>
              </a:rPr>
              <a:t>expression in </a:t>
            </a:r>
            <a:r>
              <a:rPr lang="en-US" sz="1000" b="1" dirty="0" err="1" smtClean="0">
                <a:latin typeface="Arial" panose="020B0604020202020204" pitchFamily="34" charset="0"/>
                <a:cs typeface="Arial" panose="020B0604020202020204" pitchFamily="34" charset="0"/>
              </a:rPr>
              <a:t>eosinophils</a:t>
            </a:r>
            <a:r>
              <a:rPr lang="en-US" sz="1000" b="1" dirty="0" smtClean="0">
                <a:latin typeface="Arial" panose="020B0604020202020204" pitchFamily="34" charset="0"/>
                <a:cs typeface="Arial" panose="020B0604020202020204" pitchFamily="34" charset="0"/>
              </a:rPr>
              <a:t> by CLSM.</a:t>
            </a:r>
            <a:r>
              <a:rPr lang="en-US" sz="1000" dirty="0" smtClean="0">
                <a:latin typeface="Arial" panose="020B0604020202020204" pitchFamily="34" charset="0"/>
                <a:cs typeface="Arial" panose="020B0604020202020204" pitchFamily="34" charset="0"/>
              </a:rPr>
              <a:t> IL-5 EO and IL-33 EO were </a:t>
            </a:r>
            <a:r>
              <a:rPr lang="en-US" sz="1000" dirty="0">
                <a:latin typeface="Arial" panose="020B0604020202020204" pitchFamily="34" charset="0"/>
                <a:cs typeface="Arial" panose="020B0604020202020204" pitchFamily="34" charset="0"/>
              </a:rPr>
              <a:t>stained for CD11b or ICAM-1 expression on cell membrane (red). Cells were then fixed, </a:t>
            </a:r>
            <a:r>
              <a:rPr lang="en-US" sz="1000" dirty="0" err="1">
                <a:latin typeface="Arial" panose="020B0604020202020204" pitchFamily="34" charset="0"/>
                <a:cs typeface="Arial" panose="020B0604020202020204" pitchFamily="34" charset="0"/>
              </a:rPr>
              <a:t>permeabilized</a:t>
            </a:r>
            <a:r>
              <a:rPr lang="en-US" sz="1000" dirty="0">
                <a:latin typeface="Arial" panose="020B0604020202020204" pitchFamily="34" charset="0"/>
                <a:cs typeface="Arial" panose="020B0604020202020204" pitchFamily="34" charset="0"/>
              </a:rPr>
              <a:t> and labelled with DAPI to stain nuclei (blue). Scale bars, 20µm. Representative examples of 4 independent experiments are shown. </a:t>
            </a:r>
            <a:endParaRPr lang="it-IT"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994524887"/>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7" name="Immagine 96"/>
          <p:cNvPicPr>
            <a:picLocks/>
          </p:cNvPicPr>
          <p:nvPr/>
        </p:nvPicPr>
        <p:blipFill>
          <a:blip r:embed="rId3" cstate="print">
            <a:extLst>
              <a:ext uri="{28A0092B-C50C-407E-A947-70E740481C1C}">
                <a14:useLocalDpi xmlns:a14="http://schemas.microsoft.com/office/drawing/2010/main" val="0"/>
              </a:ext>
            </a:extLst>
          </a:blip>
          <a:stretch>
            <a:fillRect/>
          </a:stretch>
        </p:blipFill>
        <p:spPr>
          <a:xfrm>
            <a:off x="3142595" y="1402036"/>
            <a:ext cx="1260000" cy="1260000"/>
          </a:xfrm>
          <a:prstGeom prst="rect">
            <a:avLst/>
          </a:prstGeom>
        </p:spPr>
      </p:pic>
      <p:pic>
        <p:nvPicPr>
          <p:cNvPr id="87" name="Immagine 86"/>
          <p:cNvPicPr>
            <a:picLocks/>
          </p:cNvPicPr>
          <p:nvPr/>
        </p:nvPicPr>
        <p:blipFill>
          <a:blip r:embed="rId4" cstate="print">
            <a:extLst>
              <a:ext uri="{BEBA8EAE-BF5A-486C-A8C5-ECC9F3942E4B}">
                <a14:imgProps xmlns:a14="http://schemas.microsoft.com/office/drawing/2010/main">
                  <a14:imgLayer r:embed="rId5">
                    <a14:imgEffect>
                      <a14:brightnessContrast bright="14000" contrast="20000"/>
                    </a14:imgEffect>
                  </a14:imgLayer>
                </a14:imgProps>
              </a:ext>
              <a:ext uri="{28A0092B-C50C-407E-A947-70E740481C1C}">
                <a14:useLocalDpi xmlns:a14="http://schemas.microsoft.com/office/drawing/2010/main" val="0"/>
              </a:ext>
            </a:extLst>
          </a:blip>
          <a:stretch>
            <a:fillRect/>
          </a:stretch>
        </p:blipFill>
        <p:spPr>
          <a:xfrm>
            <a:off x="1061585" y="1402036"/>
            <a:ext cx="1260000" cy="1260000"/>
          </a:xfrm>
          <a:prstGeom prst="rect">
            <a:avLst/>
          </a:prstGeom>
        </p:spPr>
      </p:pic>
      <p:sp>
        <p:nvSpPr>
          <p:cNvPr id="44" name="Text Box 20"/>
          <p:cNvSpPr txBox="1">
            <a:spLocks noChangeArrowheads="1"/>
          </p:cNvSpPr>
          <p:nvPr/>
        </p:nvSpPr>
        <p:spPr bwMode="auto">
          <a:xfrm>
            <a:off x="3590112" y="1149385"/>
            <a:ext cx="979756"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pPr algn="ctr">
              <a:defRPr/>
            </a:pPr>
            <a:r>
              <a:rPr lang="it-IT" altLang="it-IT" sz="1000" dirty="0" smtClean="0">
                <a:latin typeface="Arial" panose="020B0604020202020204" pitchFamily="34" charset="0"/>
                <a:cs typeface="Arial" panose="020B0604020202020204" pitchFamily="34" charset="0"/>
              </a:rPr>
              <a:t>IL-33 EO:B16</a:t>
            </a:r>
            <a:endParaRPr lang="it-IT" altLang="it-IT" sz="1000" dirty="0">
              <a:latin typeface="Arial" panose="020B0604020202020204" pitchFamily="34" charset="0"/>
              <a:cs typeface="Arial" panose="020B0604020202020204" pitchFamily="34" charset="0"/>
            </a:endParaRPr>
          </a:p>
        </p:txBody>
      </p:sp>
      <p:sp>
        <p:nvSpPr>
          <p:cNvPr id="45" name="Text Box 28"/>
          <p:cNvSpPr txBox="1">
            <a:spLocks noChangeArrowheads="1"/>
          </p:cNvSpPr>
          <p:nvPr/>
        </p:nvSpPr>
        <p:spPr bwMode="auto">
          <a:xfrm>
            <a:off x="1516975" y="1149385"/>
            <a:ext cx="990892"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square">
            <a:spAutoFit/>
          </a:bodyPr>
          <a:lstStyle/>
          <a:p>
            <a:pPr algn="ctr">
              <a:defRPr/>
            </a:pPr>
            <a:r>
              <a:rPr lang="it-IT" altLang="it-IT" sz="1000" dirty="0" smtClean="0">
                <a:latin typeface="Arial" panose="020B0604020202020204" pitchFamily="34" charset="0"/>
                <a:cs typeface="Arial" panose="020B0604020202020204" pitchFamily="34" charset="0"/>
              </a:rPr>
              <a:t>IL-5 EO:B16</a:t>
            </a:r>
            <a:endParaRPr lang="it-IT" altLang="it-IT" sz="1000" dirty="0">
              <a:latin typeface="Arial" panose="020B0604020202020204" pitchFamily="34" charset="0"/>
              <a:cs typeface="Arial" panose="020B0604020202020204" pitchFamily="34" charset="0"/>
            </a:endParaRPr>
          </a:p>
        </p:txBody>
      </p:sp>
      <p:sp>
        <p:nvSpPr>
          <p:cNvPr id="69" name="CasellaDiTesto 42"/>
          <p:cNvSpPr txBox="1">
            <a:spLocks noChangeArrowheads="1"/>
          </p:cNvSpPr>
          <p:nvPr/>
        </p:nvSpPr>
        <p:spPr bwMode="auto">
          <a:xfrm>
            <a:off x="1008222" y="1402867"/>
            <a:ext cx="1064715"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it-IT" altLang="it-IT" sz="800" b="1" dirty="0" smtClean="0">
                <a:solidFill>
                  <a:srgbClr val="00B050"/>
                </a:solidFill>
              </a:rPr>
              <a:t>CD11a</a:t>
            </a:r>
            <a:r>
              <a:rPr lang="it-IT" altLang="it-IT" sz="800" b="1" dirty="0" smtClean="0"/>
              <a:t>/</a:t>
            </a:r>
            <a:r>
              <a:rPr lang="it-IT" altLang="it-IT" sz="800" b="1" dirty="0" err="1" smtClean="0">
                <a:solidFill>
                  <a:srgbClr val="FF0000"/>
                </a:solidFill>
              </a:rPr>
              <a:t>Actin</a:t>
            </a:r>
            <a:r>
              <a:rPr lang="it-IT" altLang="it-IT" sz="800" b="1" dirty="0" smtClean="0"/>
              <a:t>/</a:t>
            </a:r>
            <a:r>
              <a:rPr lang="it-IT" altLang="it-IT" sz="800" b="1" dirty="0" smtClean="0">
                <a:solidFill>
                  <a:srgbClr val="0070C0"/>
                </a:solidFill>
              </a:rPr>
              <a:t>DAPI</a:t>
            </a:r>
            <a:endParaRPr lang="it-IT" altLang="it-IT" sz="800" b="1" dirty="0">
              <a:solidFill>
                <a:srgbClr val="0070C0"/>
              </a:solidFill>
            </a:endParaRPr>
          </a:p>
        </p:txBody>
      </p:sp>
      <p:sp>
        <p:nvSpPr>
          <p:cNvPr id="179" name="CasellaDiTesto 42"/>
          <p:cNvSpPr txBox="1">
            <a:spLocks noChangeArrowheads="1"/>
          </p:cNvSpPr>
          <p:nvPr/>
        </p:nvSpPr>
        <p:spPr bwMode="auto">
          <a:xfrm>
            <a:off x="1203830" y="1777250"/>
            <a:ext cx="314509"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it-IT" altLang="it-IT" sz="700" b="1" dirty="0" smtClean="0">
                <a:solidFill>
                  <a:schemeClr val="bg1"/>
                </a:solidFill>
              </a:rPr>
              <a:t>EO</a:t>
            </a:r>
            <a:endParaRPr lang="it-IT" altLang="it-IT" sz="700" b="1" dirty="0">
              <a:solidFill>
                <a:schemeClr val="bg1"/>
              </a:solidFill>
            </a:endParaRPr>
          </a:p>
        </p:txBody>
      </p:sp>
      <p:sp>
        <p:nvSpPr>
          <p:cNvPr id="180" name="CasellaDiTesto 42"/>
          <p:cNvSpPr txBox="1">
            <a:spLocks noChangeArrowheads="1"/>
          </p:cNvSpPr>
          <p:nvPr/>
        </p:nvSpPr>
        <p:spPr bwMode="auto">
          <a:xfrm>
            <a:off x="1621000" y="1957004"/>
            <a:ext cx="239168"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it-IT" altLang="it-IT" sz="700" b="1" dirty="0" smtClean="0">
                <a:solidFill>
                  <a:schemeClr val="bg1"/>
                </a:solidFill>
              </a:rPr>
              <a:t>T</a:t>
            </a:r>
            <a:endParaRPr lang="it-IT" altLang="it-IT" sz="700" b="1" dirty="0">
              <a:solidFill>
                <a:schemeClr val="bg1"/>
              </a:solidFill>
            </a:endParaRPr>
          </a:p>
        </p:txBody>
      </p:sp>
      <p:sp>
        <p:nvSpPr>
          <p:cNvPr id="181" name="CasellaDiTesto 42"/>
          <p:cNvSpPr txBox="1">
            <a:spLocks noChangeArrowheads="1"/>
          </p:cNvSpPr>
          <p:nvPr/>
        </p:nvSpPr>
        <p:spPr bwMode="auto">
          <a:xfrm>
            <a:off x="3790765" y="2047788"/>
            <a:ext cx="314509"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it-IT" altLang="it-IT" sz="700" b="1" dirty="0" smtClean="0">
                <a:solidFill>
                  <a:schemeClr val="bg1"/>
                </a:solidFill>
              </a:rPr>
              <a:t>EO</a:t>
            </a:r>
            <a:endParaRPr lang="it-IT" altLang="it-IT" sz="700" b="1" dirty="0">
              <a:solidFill>
                <a:schemeClr val="bg1"/>
              </a:solidFill>
            </a:endParaRPr>
          </a:p>
        </p:txBody>
      </p:sp>
      <p:sp>
        <p:nvSpPr>
          <p:cNvPr id="194" name="CasellaDiTesto 42"/>
          <p:cNvSpPr txBox="1">
            <a:spLocks noChangeArrowheads="1"/>
          </p:cNvSpPr>
          <p:nvPr/>
        </p:nvSpPr>
        <p:spPr bwMode="auto">
          <a:xfrm>
            <a:off x="3475697" y="1932008"/>
            <a:ext cx="239168"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it-IT" altLang="it-IT" sz="700" b="1" dirty="0" smtClean="0">
                <a:solidFill>
                  <a:schemeClr val="bg1"/>
                </a:solidFill>
              </a:rPr>
              <a:t>T</a:t>
            </a:r>
            <a:endParaRPr lang="it-IT" altLang="it-IT" sz="700" b="1" dirty="0">
              <a:solidFill>
                <a:schemeClr val="bg1"/>
              </a:solidFill>
            </a:endParaRPr>
          </a:p>
        </p:txBody>
      </p:sp>
      <p:sp>
        <p:nvSpPr>
          <p:cNvPr id="111" name="CasellaDiTesto 42"/>
          <p:cNvSpPr txBox="1">
            <a:spLocks noChangeArrowheads="1"/>
          </p:cNvSpPr>
          <p:nvPr/>
        </p:nvSpPr>
        <p:spPr bwMode="auto">
          <a:xfrm>
            <a:off x="3091566" y="1406655"/>
            <a:ext cx="1064715" cy="2154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it-IT" altLang="it-IT" sz="800" b="1" dirty="0" smtClean="0">
                <a:solidFill>
                  <a:srgbClr val="00B050"/>
                </a:solidFill>
              </a:rPr>
              <a:t>CD11a</a:t>
            </a:r>
            <a:r>
              <a:rPr lang="it-IT" altLang="it-IT" sz="800" b="1" dirty="0" smtClean="0"/>
              <a:t>/</a:t>
            </a:r>
            <a:r>
              <a:rPr lang="it-IT" altLang="it-IT" sz="800" b="1" dirty="0" err="1" smtClean="0">
                <a:solidFill>
                  <a:srgbClr val="FF0000"/>
                </a:solidFill>
              </a:rPr>
              <a:t>Actin</a:t>
            </a:r>
            <a:r>
              <a:rPr lang="it-IT" altLang="it-IT" sz="800" b="1" dirty="0" smtClean="0"/>
              <a:t>/</a:t>
            </a:r>
            <a:r>
              <a:rPr lang="it-IT" altLang="it-IT" sz="800" b="1" dirty="0" smtClean="0">
                <a:solidFill>
                  <a:srgbClr val="0070C0"/>
                </a:solidFill>
              </a:rPr>
              <a:t>DAPI</a:t>
            </a:r>
            <a:endParaRPr lang="it-IT" altLang="it-IT" sz="800" b="1" dirty="0">
              <a:solidFill>
                <a:srgbClr val="0070C0"/>
              </a:solidFill>
            </a:endParaRPr>
          </a:p>
        </p:txBody>
      </p:sp>
      <p:cxnSp>
        <p:nvCxnSpPr>
          <p:cNvPr id="83" name="Connettore 1 82"/>
          <p:cNvCxnSpPr/>
          <p:nvPr/>
        </p:nvCxnSpPr>
        <p:spPr>
          <a:xfrm>
            <a:off x="1793536" y="2567497"/>
            <a:ext cx="432000"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88" name="Connettore 1 87"/>
          <p:cNvCxnSpPr/>
          <p:nvPr/>
        </p:nvCxnSpPr>
        <p:spPr>
          <a:xfrm>
            <a:off x="3923327" y="2558875"/>
            <a:ext cx="370800" cy="0"/>
          </a:xfrm>
          <a:prstGeom prst="line">
            <a:avLst/>
          </a:prstGeom>
          <a:ln w="12700">
            <a:solidFill>
              <a:schemeClr val="bg1"/>
            </a:solidFill>
          </a:ln>
        </p:spPr>
        <p:style>
          <a:lnRef idx="1">
            <a:schemeClr val="accent1"/>
          </a:lnRef>
          <a:fillRef idx="0">
            <a:schemeClr val="accent1"/>
          </a:fillRef>
          <a:effectRef idx="0">
            <a:schemeClr val="accent1"/>
          </a:effectRef>
          <a:fontRef idx="minor">
            <a:schemeClr val="tx1"/>
          </a:fontRef>
        </p:style>
      </p:cxnSp>
      <p:pic>
        <p:nvPicPr>
          <p:cNvPr id="92" name="Immagine 91"/>
          <p:cNvPicPr>
            <a:picLocks/>
          </p:cNvPicPr>
          <p:nvPr/>
        </p:nvPicPr>
        <p:blipFill>
          <a:blip r:embed="rId6" cstate="print">
            <a:extLst>
              <a:ext uri="{BEBA8EAE-BF5A-486C-A8C5-ECC9F3942E4B}">
                <a14:imgProps xmlns:a14="http://schemas.microsoft.com/office/drawing/2010/main">
                  <a14:imgLayer r:embed="rId7">
                    <a14:imgEffect>
                      <a14:brightnessContrast bright="16000" contrast="4000"/>
                    </a14:imgEffect>
                  </a14:imgLayer>
                </a14:imgProps>
              </a:ext>
              <a:ext uri="{28A0092B-C50C-407E-A947-70E740481C1C}">
                <a14:useLocalDpi xmlns:a14="http://schemas.microsoft.com/office/drawing/2010/main" val="0"/>
              </a:ext>
            </a:extLst>
          </a:blip>
          <a:stretch>
            <a:fillRect/>
          </a:stretch>
        </p:blipFill>
        <p:spPr>
          <a:xfrm>
            <a:off x="2357755" y="2050036"/>
            <a:ext cx="612000" cy="612000"/>
          </a:xfrm>
          <a:prstGeom prst="rect">
            <a:avLst/>
          </a:prstGeom>
        </p:spPr>
      </p:pic>
      <p:pic>
        <p:nvPicPr>
          <p:cNvPr id="93" name="Immagine 92"/>
          <p:cNvPicPr>
            <a:picLocks/>
          </p:cNvPicPr>
          <p:nvPr/>
        </p:nvPicPr>
        <p:blipFill>
          <a:blip r:embed="rId8" cstate="print">
            <a:extLst>
              <a:ext uri="{BEBA8EAE-BF5A-486C-A8C5-ECC9F3942E4B}">
                <a14:imgProps xmlns:a14="http://schemas.microsoft.com/office/drawing/2010/main">
                  <a14:imgLayer r:embed="rId9">
                    <a14:imgEffect>
                      <a14:brightnessContrast bright="45000" contrast="25000"/>
                    </a14:imgEffect>
                  </a14:imgLayer>
                </a14:imgProps>
              </a:ext>
              <a:ext uri="{28A0092B-C50C-407E-A947-70E740481C1C}">
                <a14:useLocalDpi xmlns:a14="http://schemas.microsoft.com/office/drawing/2010/main" val="0"/>
              </a:ext>
            </a:extLst>
          </a:blip>
          <a:stretch>
            <a:fillRect/>
          </a:stretch>
        </p:blipFill>
        <p:spPr>
          <a:xfrm>
            <a:off x="2356585" y="1405094"/>
            <a:ext cx="612000" cy="612000"/>
          </a:xfrm>
          <a:prstGeom prst="rect">
            <a:avLst/>
          </a:prstGeom>
        </p:spPr>
      </p:pic>
      <p:sp>
        <p:nvSpPr>
          <p:cNvPr id="94" name="CasellaDiTesto 42"/>
          <p:cNvSpPr txBox="1">
            <a:spLocks noChangeArrowheads="1"/>
          </p:cNvSpPr>
          <p:nvPr/>
        </p:nvSpPr>
        <p:spPr bwMode="auto">
          <a:xfrm>
            <a:off x="1839024" y="1614530"/>
            <a:ext cx="314509" cy="20005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spcBef>
                <a:spcPct val="20000"/>
              </a:spcBef>
              <a:buChar char="•"/>
              <a:defRPr sz="3200">
                <a:solidFill>
                  <a:schemeClr val="tx1"/>
                </a:solidFill>
                <a:latin typeface="Arial" panose="020B0604020202020204" pitchFamily="34" charset="0"/>
              </a:defRPr>
            </a:lvl1pPr>
            <a:lvl2pPr marL="742950" indent="-285750">
              <a:spcBef>
                <a:spcPct val="20000"/>
              </a:spcBef>
              <a:buChar char="–"/>
              <a:defRPr sz="2800">
                <a:solidFill>
                  <a:schemeClr val="tx1"/>
                </a:solidFill>
                <a:latin typeface="Arial" panose="020B0604020202020204" pitchFamily="34" charset="0"/>
              </a:defRPr>
            </a:lvl2pPr>
            <a:lvl3pPr marL="1143000" indent="-228600">
              <a:spcBef>
                <a:spcPct val="20000"/>
              </a:spcBef>
              <a:buChar char="•"/>
              <a:defRPr sz="2400">
                <a:solidFill>
                  <a:schemeClr val="tx1"/>
                </a:solidFill>
                <a:latin typeface="Arial" panose="020B0604020202020204" pitchFamily="34" charset="0"/>
              </a:defRPr>
            </a:lvl3pPr>
            <a:lvl4pPr marL="1600200" indent="-228600">
              <a:spcBef>
                <a:spcPct val="20000"/>
              </a:spcBef>
              <a:buChar char="–"/>
              <a:defRPr sz="2000">
                <a:solidFill>
                  <a:schemeClr val="tx1"/>
                </a:solidFill>
                <a:latin typeface="Arial" panose="020B0604020202020204" pitchFamily="34" charset="0"/>
              </a:defRPr>
            </a:lvl4pPr>
            <a:lvl5pPr marL="2057400" indent="-228600">
              <a:spcBef>
                <a:spcPct val="20000"/>
              </a:spcBef>
              <a:buChar char="»"/>
              <a:defRPr sz="2000">
                <a:solidFill>
                  <a:schemeClr val="tx1"/>
                </a:solidFill>
                <a:latin typeface="Arial" panose="020B0604020202020204" pitchFamily="34" charset="0"/>
              </a:defRPr>
            </a:lvl5pPr>
            <a:lvl6pPr marL="2514600" indent="-228600" eaLnBrk="0" fontAlgn="base" hangingPunct="0">
              <a:spcBef>
                <a:spcPct val="20000"/>
              </a:spcBef>
              <a:spcAft>
                <a:spcPct val="0"/>
              </a:spcAft>
              <a:buChar char="»"/>
              <a:defRPr sz="2000">
                <a:solidFill>
                  <a:schemeClr val="tx1"/>
                </a:solidFill>
                <a:latin typeface="Arial" panose="020B0604020202020204" pitchFamily="34" charset="0"/>
              </a:defRPr>
            </a:lvl6pPr>
            <a:lvl7pPr marL="2971800" indent="-228600" eaLnBrk="0" fontAlgn="base" hangingPunct="0">
              <a:spcBef>
                <a:spcPct val="20000"/>
              </a:spcBef>
              <a:spcAft>
                <a:spcPct val="0"/>
              </a:spcAft>
              <a:buChar char="»"/>
              <a:defRPr sz="2000">
                <a:solidFill>
                  <a:schemeClr val="tx1"/>
                </a:solidFill>
                <a:latin typeface="Arial" panose="020B0604020202020204" pitchFamily="34" charset="0"/>
              </a:defRPr>
            </a:lvl7pPr>
            <a:lvl8pPr marL="3429000" indent="-228600" eaLnBrk="0" fontAlgn="base" hangingPunct="0">
              <a:spcBef>
                <a:spcPct val="20000"/>
              </a:spcBef>
              <a:spcAft>
                <a:spcPct val="0"/>
              </a:spcAft>
              <a:buChar char="»"/>
              <a:defRPr sz="2000">
                <a:solidFill>
                  <a:schemeClr val="tx1"/>
                </a:solidFill>
                <a:latin typeface="Arial" panose="020B0604020202020204" pitchFamily="34" charset="0"/>
              </a:defRPr>
            </a:lvl8pPr>
            <a:lvl9pPr marL="3886200" indent="-228600" eaLnBrk="0" fontAlgn="base" hangingPunct="0">
              <a:spcBef>
                <a:spcPct val="20000"/>
              </a:spcBef>
              <a:spcAft>
                <a:spcPct val="0"/>
              </a:spcAft>
              <a:buChar char="»"/>
              <a:defRPr sz="2000">
                <a:solidFill>
                  <a:schemeClr val="tx1"/>
                </a:solidFill>
                <a:latin typeface="Arial" panose="020B0604020202020204" pitchFamily="34" charset="0"/>
              </a:defRPr>
            </a:lvl9pPr>
          </a:lstStyle>
          <a:p>
            <a:pPr algn="ctr">
              <a:spcBef>
                <a:spcPct val="0"/>
              </a:spcBef>
              <a:buFontTx/>
              <a:buNone/>
            </a:pPr>
            <a:r>
              <a:rPr lang="it-IT" altLang="it-IT" sz="700" b="1" dirty="0" smtClean="0">
                <a:solidFill>
                  <a:schemeClr val="bg1"/>
                </a:solidFill>
              </a:rPr>
              <a:t>EO</a:t>
            </a:r>
            <a:endParaRPr lang="it-IT" altLang="it-IT" sz="700" b="1" dirty="0">
              <a:solidFill>
                <a:schemeClr val="bg1"/>
              </a:solidFill>
            </a:endParaRPr>
          </a:p>
        </p:txBody>
      </p:sp>
      <p:pic>
        <p:nvPicPr>
          <p:cNvPr id="95" name="Immagine 94"/>
          <p:cNvPicPr>
            <a:picLocks/>
          </p:cNvPicPr>
          <p:nvPr/>
        </p:nvPicPr>
        <p:blipFill>
          <a:blip r:embed="rId10" cstate="print">
            <a:extLst>
              <a:ext uri="{28A0092B-C50C-407E-A947-70E740481C1C}">
                <a14:useLocalDpi xmlns:a14="http://schemas.microsoft.com/office/drawing/2010/main" val="0"/>
              </a:ext>
            </a:extLst>
          </a:blip>
          <a:stretch>
            <a:fillRect/>
          </a:stretch>
        </p:blipFill>
        <p:spPr>
          <a:xfrm>
            <a:off x="4435932" y="2051970"/>
            <a:ext cx="612000" cy="612000"/>
          </a:xfrm>
          <a:prstGeom prst="rect">
            <a:avLst/>
          </a:prstGeom>
        </p:spPr>
      </p:pic>
      <p:pic>
        <p:nvPicPr>
          <p:cNvPr id="96" name="Immagine 95"/>
          <p:cNvPicPr>
            <a:picLocks/>
          </p:cNvPicPr>
          <p:nvPr/>
        </p:nvPicPr>
        <p:blipFill>
          <a:blip r:embed="rId11" cstate="print">
            <a:extLst>
              <a:ext uri="{BEBA8EAE-BF5A-486C-A8C5-ECC9F3942E4B}">
                <a14:imgProps xmlns:a14="http://schemas.microsoft.com/office/drawing/2010/main">
                  <a14:imgLayer r:embed="rId12">
                    <a14:imgEffect>
                      <a14:brightnessContrast bright="6000"/>
                    </a14:imgEffect>
                  </a14:imgLayer>
                </a14:imgProps>
              </a:ext>
              <a:ext uri="{28A0092B-C50C-407E-A947-70E740481C1C}">
                <a14:useLocalDpi xmlns:a14="http://schemas.microsoft.com/office/drawing/2010/main" val="0"/>
              </a:ext>
            </a:extLst>
          </a:blip>
          <a:stretch>
            <a:fillRect/>
          </a:stretch>
        </p:blipFill>
        <p:spPr>
          <a:xfrm>
            <a:off x="4434698" y="1402036"/>
            <a:ext cx="612000" cy="612000"/>
          </a:xfrm>
          <a:prstGeom prst="rect">
            <a:avLst/>
          </a:prstGeom>
        </p:spPr>
      </p:pic>
      <p:sp>
        <p:nvSpPr>
          <p:cNvPr id="21" name="Rettangolo 20"/>
          <p:cNvSpPr/>
          <p:nvPr/>
        </p:nvSpPr>
        <p:spPr>
          <a:xfrm>
            <a:off x="29923" y="3108616"/>
            <a:ext cx="6063569" cy="1169551"/>
          </a:xfrm>
          <a:prstGeom prst="rect">
            <a:avLst/>
          </a:prstGeom>
        </p:spPr>
        <p:txBody>
          <a:bodyPr wrap="square">
            <a:spAutoFit/>
          </a:bodyPr>
          <a:lstStyle/>
          <a:p>
            <a:pPr algn="just"/>
            <a:r>
              <a:rPr lang="en-US" sz="1000" b="1" dirty="0" smtClean="0">
                <a:latin typeface="Arial" panose="020B0604020202020204" pitchFamily="34" charset="0"/>
                <a:cs typeface="Arial" panose="020B0604020202020204" pitchFamily="34" charset="0"/>
              </a:rPr>
              <a:t>Figure S9</a:t>
            </a:r>
            <a:r>
              <a:rPr lang="en-US" sz="1000" b="1" dirty="0" smtClean="0">
                <a:latin typeface="Arial" panose="020B0604020202020204" pitchFamily="34" charset="0"/>
                <a:cs typeface="Arial" panose="020B0604020202020204" pitchFamily="34" charset="0"/>
              </a:rPr>
              <a:t>.</a:t>
            </a:r>
            <a:r>
              <a:rPr lang="en-US" sz="1000" dirty="0" smtClean="0">
                <a:latin typeface="Arial" panose="020B0604020202020204" pitchFamily="34" charset="0"/>
                <a:cs typeface="Arial" panose="020B0604020202020204" pitchFamily="34" charset="0"/>
              </a:rPr>
              <a:t> </a:t>
            </a:r>
            <a:r>
              <a:rPr lang="en-US" sz="1000" b="1" dirty="0" smtClean="0">
                <a:latin typeface="Arial" panose="020B0604020202020204" pitchFamily="34" charset="0"/>
                <a:cs typeface="Arial" panose="020B0604020202020204" pitchFamily="34" charset="0"/>
              </a:rPr>
              <a:t>CD11a does not polarize to </a:t>
            </a:r>
            <a:r>
              <a:rPr lang="en-US" sz="1000" b="1" dirty="0">
                <a:latin typeface="Arial" panose="020B0604020202020204" pitchFamily="34" charset="0"/>
                <a:cs typeface="Arial" panose="020B0604020202020204" pitchFamily="34" charset="0"/>
              </a:rPr>
              <a:t>the EO-tumor cell </a:t>
            </a:r>
            <a:r>
              <a:rPr lang="en-US" sz="1000" b="1" dirty="0" smtClean="0">
                <a:latin typeface="Arial" panose="020B0604020202020204" pitchFamily="34" charset="0"/>
                <a:cs typeface="Arial" panose="020B0604020202020204" pitchFamily="34" charset="0"/>
              </a:rPr>
              <a:t>synapses</a:t>
            </a:r>
            <a:r>
              <a:rPr lang="en-US" sz="1000" b="1"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 CLSM examinations of EO/target cell </a:t>
            </a:r>
            <a:r>
              <a:rPr lang="en-US" sz="1000" dirty="0" smtClean="0">
                <a:latin typeface="Arial" panose="020B0604020202020204" pitchFamily="34" charset="0"/>
                <a:cs typeface="Arial" panose="020B0604020202020204" pitchFamily="34" charset="0"/>
              </a:rPr>
              <a:t>conjugates. </a:t>
            </a:r>
            <a:r>
              <a:rPr lang="en-US" sz="1000" dirty="0">
                <a:latin typeface="Arial" panose="020B0604020202020204" pitchFamily="34" charset="0"/>
                <a:cs typeface="Arial" panose="020B0604020202020204" pitchFamily="34" charset="0"/>
              </a:rPr>
              <a:t>IL-5 or IL-33 EO were mixed to B16 </a:t>
            </a:r>
            <a:r>
              <a:rPr lang="en-US" sz="1000" dirty="0" smtClean="0">
                <a:latin typeface="Arial" panose="020B0604020202020204" pitchFamily="34" charset="0"/>
                <a:cs typeface="Arial" panose="020B0604020202020204" pitchFamily="34" charset="0"/>
              </a:rPr>
              <a:t>tumor </a:t>
            </a:r>
            <a:r>
              <a:rPr lang="en-US" sz="1000" dirty="0">
                <a:latin typeface="Arial" panose="020B0604020202020204" pitchFamily="34" charset="0"/>
                <a:cs typeface="Arial" panose="020B0604020202020204" pitchFamily="34" charset="0"/>
              </a:rPr>
              <a:t>cells and allowed to conjugate for 60 min at 37°C (5:1 ratio). Cell conjugates were transferred onto poly-L-lysine-coated coverslips and stained for CD11a expression, detected in green. Cells were then fixed, </a:t>
            </a:r>
            <a:r>
              <a:rPr lang="en-US" sz="1000" dirty="0" err="1">
                <a:latin typeface="Arial" panose="020B0604020202020204" pitchFamily="34" charset="0"/>
                <a:cs typeface="Arial" panose="020B0604020202020204" pitchFamily="34" charset="0"/>
              </a:rPr>
              <a:t>permeabilized</a:t>
            </a:r>
            <a:r>
              <a:rPr lang="en-US" sz="1000" dirty="0">
                <a:latin typeface="Arial" panose="020B0604020202020204" pitchFamily="34" charset="0"/>
                <a:cs typeface="Arial" panose="020B0604020202020204" pitchFamily="34" charset="0"/>
              </a:rPr>
              <a:t> and labelled with Alexa Fluor®-594 </a:t>
            </a:r>
            <a:r>
              <a:rPr lang="en-US" sz="1000" dirty="0" err="1">
                <a:latin typeface="Arial" panose="020B0604020202020204" pitchFamily="34" charset="0"/>
                <a:cs typeface="Arial" panose="020B0604020202020204" pitchFamily="34" charset="0"/>
              </a:rPr>
              <a:t>phalloidin</a:t>
            </a:r>
            <a:r>
              <a:rPr lang="en-US" sz="1000" dirty="0">
                <a:latin typeface="Arial" panose="020B0604020202020204" pitchFamily="34" charset="0"/>
                <a:cs typeface="Arial" panose="020B0604020202020204" pitchFamily="34" charset="0"/>
              </a:rPr>
              <a:t> for actin staining (red). DAPI was used to stain nuclei (blue). </a:t>
            </a:r>
            <a:r>
              <a:rPr lang="en-US" sz="1000" dirty="0" smtClean="0">
                <a:latin typeface="Arial" panose="020B0604020202020204" pitchFamily="34" charset="0"/>
                <a:cs typeface="Arial" panose="020B0604020202020204" pitchFamily="34" charset="0"/>
              </a:rPr>
              <a:t>Merged </a:t>
            </a:r>
            <a:r>
              <a:rPr lang="en-US" sz="1000" dirty="0">
                <a:latin typeface="Arial" panose="020B0604020202020204" pitchFamily="34" charset="0"/>
                <a:cs typeface="Arial" panose="020B0604020202020204" pitchFamily="34" charset="0"/>
              </a:rPr>
              <a:t>images are reported and insets represent separate channel images. Scale bars, 10µm. Panels are representative of 2 independent experiments. </a:t>
            </a:r>
            <a:endParaRPr lang="it-IT"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789362782"/>
      </p:ext>
    </p:extLst>
  </p:cSld>
  <p:clrMapOvr>
    <a:masterClrMapping/>
  </p:clrMapOvr>
  <p:timing>
    <p:tnLst>
      <p:par>
        <p:cTn id="1" dur="indefinite" restart="never" nodeType="tmRoot"/>
      </p:par>
    </p:tnLst>
  </p:timing>
</p:sld>
</file>

<file path=ppt/theme/theme1.xml><?xml version="1.0" encoding="utf-8"?>
<a:theme xmlns:a="http://schemas.openxmlformats.org/drawingml/2006/main" name="Tema di Office">
  <a:themeElements>
    <a:clrScheme name="Tema di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ema di 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i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ema di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Tema di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488</TotalTime>
  <Words>1783</Words>
  <Application>Microsoft Office PowerPoint</Application>
  <PresentationFormat>Personalizzato</PresentationFormat>
  <Paragraphs>179</Paragraphs>
  <Slides>12</Slides>
  <Notes>7</Notes>
  <HiddenSlides>0</HiddenSlides>
  <MMClips>0</MMClips>
  <ScaleCrop>false</ScaleCrop>
  <HeadingPairs>
    <vt:vector size="8" baseType="variant">
      <vt:variant>
        <vt:lpstr>Caratteri utilizzati</vt:lpstr>
      </vt:variant>
      <vt:variant>
        <vt:i4>6</vt:i4>
      </vt:variant>
      <vt:variant>
        <vt:lpstr>Tema</vt:lpstr>
      </vt:variant>
      <vt:variant>
        <vt:i4>1</vt:i4>
      </vt:variant>
      <vt:variant>
        <vt:lpstr>Server OLE incorporati</vt:lpstr>
      </vt:variant>
      <vt:variant>
        <vt:i4>1</vt:i4>
      </vt:variant>
      <vt:variant>
        <vt:lpstr>Titoli diapositive</vt:lpstr>
      </vt:variant>
      <vt:variant>
        <vt:i4>12</vt:i4>
      </vt:variant>
    </vt:vector>
  </HeadingPairs>
  <TitlesOfParts>
    <vt:vector size="20" baseType="lpstr">
      <vt:lpstr>Arial</vt:lpstr>
      <vt:lpstr>Calibri</vt:lpstr>
      <vt:lpstr>Calibri Light</vt:lpstr>
      <vt:lpstr>Cambria Math</vt:lpstr>
      <vt:lpstr>Symbol</vt:lpstr>
      <vt:lpstr>Times New Roman</vt:lpstr>
      <vt:lpstr>Tema di Office</vt:lpstr>
      <vt:lpstr>Prism Project</vt:lpstr>
      <vt:lpstr>Presentazione standard di PowerPoint</vt:lpstr>
      <vt:lpstr>Presentazione standard di PowerPoint</vt:lpstr>
      <vt:lpstr>Presentazione standard di PowerPoint</vt:lpstr>
      <vt:lpstr>Presentazione standard di PowerPoint</vt:lpstr>
      <vt:lpstr>Presentazione standard di PowerPoint</vt:lpstr>
      <vt:lpstr>Presentazione standard di PowerPoint</vt:lpstr>
      <vt:lpstr>Presentazione standard di PowerPoint</vt:lpstr>
      <vt:lpstr>Presentazione standard di PowerPoint</vt:lpstr>
      <vt:lpstr>Presentazione standard di PowerPoint</vt:lpstr>
      <vt:lpstr>Presentazione standard di PowerPoint</vt:lpstr>
      <vt:lpstr>Presentazione standard di PowerPoint</vt:lpstr>
      <vt:lpstr>Presentazione standard di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zione standard di PowerPoint</dc:title>
  <dc:creator>Spadaro</dc:creator>
  <cp:lastModifiedBy>Schiavoni Giovanna</cp:lastModifiedBy>
  <cp:revision>377</cp:revision>
  <cp:lastPrinted>2019-01-16T15:45:06Z</cp:lastPrinted>
  <dcterms:created xsi:type="dcterms:W3CDTF">2018-11-26T10:37:01Z</dcterms:created>
  <dcterms:modified xsi:type="dcterms:W3CDTF">2019-09-24T14:40:51Z</dcterms:modified>
</cp:coreProperties>
</file>